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svg" ContentType="image/svg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diagrams/data1.xml" ContentType="application/vnd.openxmlformats-officedocument.drawingml.diagramData+xml"/>
  <Override PartName="/ppt/diagrams/layout1.xml" ContentType="application/vnd.openxmlformats-officedocument.drawingml.diagramLayout+xml"/>
  <Override PartName="/ppt/diagrams/quickStyle1.xml" ContentType="application/vnd.openxmlformats-officedocument.drawingml.diagramStyle+xml"/>
  <Override PartName="/ppt/diagrams/colors1.xml" ContentType="application/vnd.openxmlformats-officedocument.drawingml.diagramColors+xml"/>
  <Override PartName="/ppt/diagrams/drawing1.xml" ContentType="application/vnd.ms-office.drawingml.diagramDrawing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diagrams/data2.xml" ContentType="application/vnd.openxmlformats-officedocument.drawingml.diagramData+xml"/>
  <Override PartName="/ppt/diagrams/layout2.xml" ContentType="application/vnd.openxmlformats-officedocument.drawingml.diagramLayout+xml"/>
  <Override PartName="/ppt/diagrams/quickStyle2.xml" ContentType="application/vnd.openxmlformats-officedocument.drawingml.diagramStyle+xml"/>
  <Override PartName="/ppt/diagrams/colors2.xml" ContentType="application/vnd.openxmlformats-officedocument.drawingml.diagramColors+xml"/>
  <Override PartName="/ppt/diagrams/drawing2.xml" ContentType="application/vnd.ms-office.drawingml.diagramDrawing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8"/>
  </p:notesMasterIdLst>
  <p:sldIdLst>
    <p:sldId id="262" r:id="rId2"/>
    <p:sldId id="258" r:id="rId3"/>
    <p:sldId id="256" r:id="rId4"/>
    <p:sldId id="261" r:id="rId5"/>
    <p:sldId id="260" r:id="rId6"/>
    <p:sldId id="259" r:id="rId7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C9688"/>
    <a:srgbClr val="FB725F"/>
    <a:srgbClr val="009242"/>
    <a:srgbClr val="F9270B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8088" autoAdjust="0"/>
    <p:restoredTop sz="83023"/>
  </p:normalViewPr>
  <p:slideViewPr>
    <p:cSldViewPr snapToGrid="0">
      <p:cViewPr varScale="1">
        <p:scale>
          <a:sx n="107" d="100"/>
          <a:sy n="107" d="100"/>
        </p:scale>
        <p:origin x="1120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diagrams/colors1.xml><?xml version="1.0" encoding="utf-8"?>
<dgm:colorsDef xmlns:dgm="http://schemas.openxmlformats.org/drawingml/2006/diagram" xmlns:a="http://schemas.openxmlformats.org/drawingml/2006/main" uniqueId="urn:microsoft.com/office/officeart/2005/8/colors/accent0_1">
  <dgm:title val=""/>
  <dgm:desc val=""/>
  <dgm:catLst>
    <dgm:cat type="mainScheme" pri="10100"/>
  </dgm:catLst>
  <dgm:styleLbl name="node0">
    <dgm:fillClrLst meth="repeat">
      <a:schemeClr val="lt1"/>
    </dgm:fillClrLst>
    <dgm:linClrLst meth="repeat">
      <a:schemeClr val="dk1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node1">
    <dgm:fillClrLst meth="repeat">
      <a:schemeClr val="lt1"/>
    </dgm:fillClrLst>
    <dgm:linClrLst meth="repeat">
      <a:schemeClr val="dk1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alignNode1">
    <dgm:fillClrLst meth="repeat">
      <a:schemeClr val="lt1"/>
    </dgm:fillClrLst>
    <dgm:linClrLst meth="repeat">
      <a:schemeClr val="dk1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lnNode1">
    <dgm:fillClrLst meth="repeat">
      <a:schemeClr val="lt1"/>
    </dgm:fillClrLst>
    <dgm:linClrLst meth="repeat">
      <a:schemeClr val="dk1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vennNode1">
    <dgm:fillClrLst meth="repeat">
      <a:schemeClr val="lt1">
        <a:alpha val="50000"/>
      </a:schemeClr>
    </dgm:fillClrLst>
    <dgm:linClrLst meth="repeat">
      <a:schemeClr val="dk1">
        <a:shade val="80000"/>
      </a:schemeClr>
    </dgm:linClrLst>
    <dgm:effectClrLst/>
    <dgm:txLinClrLst/>
    <dgm:txFillClrLst/>
    <dgm:txEffectClrLst/>
  </dgm:styleLbl>
  <dgm:styleLbl name="node2">
    <dgm:fillClrLst meth="repeat">
      <a:schemeClr val="lt1"/>
    </dgm:fillClrLst>
    <dgm:linClrLst meth="repeat">
      <a:schemeClr val="dk1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node3">
    <dgm:fillClrLst meth="repeat">
      <a:schemeClr val="lt1"/>
    </dgm:fillClrLst>
    <dgm:linClrLst meth="repeat">
      <a:schemeClr val="dk1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node4">
    <dgm:fillClrLst meth="repeat">
      <a:schemeClr val="lt1"/>
    </dgm:fillClrLst>
    <dgm:linClrLst meth="repeat">
      <a:schemeClr val="dk1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fgImgPlace1">
    <dgm:fillClrLst meth="repeat">
      <a:schemeClr val="dk1">
        <a:tint val="40000"/>
      </a:schemeClr>
    </dgm:fillClrLst>
    <dgm:linClrLst meth="repeat">
      <a:schemeClr val="dk1">
        <a:shade val="80000"/>
      </a:schemeClr>
    </dgm:linClrLst>
    <dgm:effectClrLst/>
    <dgm:txLinClrLst/>
    <dgm:txFillClrLst meth="repeat">
      <a:schemeClr val="lt1"/>
    </dgm:txFillClrLst>
    <dgm:txEffectClrLst/>
  </dgm:styleLbl>
  <dgm:styleLbl name="alignImgPlace1">
    <dgm:fillClrLst meth="repeat">
      <a:schemeClr val="dk1">
        <a:tint val="40000"/>
      </a:schemeClr>
    </dgm:fillClrLst>
    <dgm:linClrLst meth="repeat">
      <a:schemeClr val="dk1">
        <a:shade val="80000"/>
      </a:schemeClr>
    </dgm:linClrLst>
    <dgm:effectClrLst/>
    <dgm:txLinClrLst/>
    <dgm:txFillClrLst meth="repeat">
      <a:schemeClr val="lt1"/>
    </dgm:txFillClrLst>
    <dgm:txEffectClrLst/>
  </dgm:styleLbl>
  <dgm:styleLbl name="bgImgPlace1">
    <dgm:fillClrLst meth="repeat">
      <a:schemeClr val="dk1">
        <a:tint val="40000"/>
      </a:schemeClr>
    </dgm:fillClrLst>
    <dgm:linClrLst meth="repeat">
      <a:schemeClr val="dk1">
        <a:shade val="80000"/>
      </a:schemeClr>
    </dgm:linClrLst>
    <dgm:effectClrLst/>
    <dgm:txLinClrLst/>
    <dgm:txFillClrLst meth="repeat">
      <a:schemeClr val="lt1"/>
    </dgm:txFillClrLst>
    <dgm:txEffectClrLst/>
  </dgm:styleLbl>
  <dgm:styleLbl name="sibTrans2D1">
    <dgm:fillClrLst meth="repeat">
      <a:schemeClr val="dk1">
        <a:tint val="60000"/>
      </a:schemeClr>
    </dgm:fillClrLst>
    <dgm:linClrLst meth="repeat">
      <a:schemeClr val="dk1">
        <a:tint val="60000"/>
      </a:schemeClr>
    </dgm:linClrLst>
    <dgm:effectClrLst/>
    <dgm:txLinClrLst/>
    <dgm:txFillClrLst meth="repeat">
      <a:schemeClr val="dk1"/>
    </dgm:txFillClrLst>
    <dgm:txEffectClrLst/>
  </dgm:styleLbl>
  <dgm:styleLbl name="fgSibTrans2D1">
    <dgm:fillClrLst meth="repeat">
      <a:schemeClr val="dk1">
        <a:tint val="60000"/>
      </a:schemeClr>
    </dgm:fillClrLst>
    <dgm:linClrLst meth="repeat">
      <a:schemeClr val="dk1">
        <a:tint val="60000"/>
      </a:schemeClr>
    </dgm:linClrLst>
    <dgm:effectClrLst/>
    <dgm:txLinClrLst/>
    <dgm:txFillClrLst meth="repeat">
      <a:schemeClr val="dk1"/>
    </dgm:txFillClrLst>
    <dgm:txEffectClrLst/>
  </dgm:styleLbl>
  <dgm:styleLbl name="bgSibTrans2D1">
    <dgm:fillClrLst meth="repeat">
      <a:schemeClr val="dk1">
        <a:tint val="60000"/>
      </a:schemeClr>
    </dgm:fillClrLst>
    <dgm:linClrLst meth="repeat">
      <a:schemeClr val="dk1">
        <a:tint val="60000"/>
      </a:schemeClr>
    </dgm:linClrLst>
    <dgm:effectClrLst/>
    <dgm:txLinClrLst/>
    <dgm:txFillClrLst meth="repeat">
      <a:schemeClr val="dk1"/>
    </dgm:txFillClrLst>
    <dgm:txEffectClrLst/>
  </dgm:styleLbl>
  <dgm:styleLbl name="sibTrans1D1">
    <dgm:fillClrLst meth="repeat">
      <a:schemeClr val="dk1"/>
    </dgm:fillClrLst>
    <dgm:linClrLst meth="repeat">
      <a:schemeClr val="dk1"/>
    </dgm:linClrLst>
    <dgm:effectClrLst/>
    <dgm:txLinClrLst/>
    <dgm:txFillClrLst meth="repeat">
      <a:schemeClr val="tx1"/>
    </dgm:txFillClrLst>
    <dgm:txEffectClrLst/>
  </dgm:styleLbl>
  <dgm:styleLbl name="callout">
    <dgm:fillClrLst meth="repeat">
      <a:schemeClr val="dk1"/>
    </dgm:fillClrLst>
    <dgm:linClrLst meth="repeat">
      <a:schemeClr val="dk1"/>
    </dgm:linClrLst>
    <dgm:effectClrLst/>
    <dgm:txLinClrLst/>
    <dgm:txFillClrLst meth="repeat">
      <a:schemeClr val="tx1"/>
    </dgm:txFillClrLst>
    <dgm:txEffectClrLst/>
  </dgm:styleLbl>
  <dgm:styleLbl name="asst0">
    <dgm:fillClrLst meth="repeat">
      <a:schemeClr val="lt1"/>
    </dgm:fillClrLst>
    <dgm:linClrLst meth="repeat">
      <a:schemeClr val="dk1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asst1">
    <dgm:fillClrLst meth="repeat">
      <a:schemeClr val="lt1"/>
    </dgm:fillClrLst>
    <dgm:linClrLst meth="repeat">
      <a:schemeClr val="dk1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asst2">
    <dgm:fillClrLst meth="repeat">
      <a:schemeClr val="lt1"/>
    </dgm:fillClrLst>
    <dgm:linClrLst meth="repeat">
      <a:schemeClr val="dk1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asst3">
    <dgm:fillClrLst meth="repeat">
      <a:schemeClr val="lt1"/>
    </dgm:fillClrLst>
    <dgm:linClrLst meth="repeat">
      <a:schemeClr val="dk1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asst4">
    <dgm:fillClrLst meth="repeat">
      <a:schemeClr val="lt1"/>
    </dgm:fillClrLst>
    <dgm:linClrLst meth="repeat">
      <a:schemeClr val="dk1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parChTrans2D1">
    <dgm:fillClrLst meth="repeat">
      <a:schemeClr val="dk1">
        <a:tint val="60000"/>
      </a:schemeClr>
    </dgm:fillClrLst>
    <dgm:linClrLst meth="repeat">
      <a:schemeClr val="dk1">
        <a:tint val="60000"/>
      </a:schemeClr>
    </dgm:linClrLst>
    <dgm:effectClrLst/>
    <dgm:txLinClrLst/>
    <dgm:txFillClrLst/>
    <dgm:txEffectClrLst/>
  </dgm:styleLbl>
  <dgm:styleLbl name="parChTrans2D2">
    <dgm:fillClrLst meth="repeat">
      <a:schemeClr val="dk1"/>
    </dgm:fillClrLst>
    <dgm:linClrLst meth="repeat">
      <a:schemeClr val="dk1"/>
    </dgm:linClrLst>
    <dgm:effectClrLst/>
    <dgm:txLinClrLst/>
    <dgm:txFillClrLst/>
    <dgm:txEffectClrLst/>
  </dgm:styleLbl>
  <dgm:styleLbl name="parChTrans2D3">
    <dgm:fillClrLst meth="repeat">
      <a:schemeClr val="dk1"/>
    </dgm:fillClrLst>
    <dgm:linClrLst meth="repeat">
      <a:schemeClr val="dk1"/>
    </dgm:linClrLst>
    <dgm:effectClrLst/>
    <dgm:txLinClrLst/>
    <dgm:txFillClrLst/>
    <dgm:txEffectClrLst/>
  </dgm:styleLbl>
  <dgm:styleLbl name="parChTrans2D4">
    <dgm:fillClrLst meth="repeat">
      <a:schemeClr val="dk1"/>
    </dgm:fillClrLst>
    <dgm:linClrLst meth="repeat">
      <a:schemeClr val="dk1"/>
    </dgm:linClrLst>
    <dgm:effectClrLst/>
    <dgm:txLinClrLst/>
    <dgm:txFillClrLst meth="repeat">
      <a:schemeClr val="lt1"/>
    </dgm:txFillClrLst>
    <dgm:txEffectClrLst/>
  </dgm:styleLbl>
  <dgm:styleLbl name="parChTrans1D1">
    <dgm:fillClrLst meth="repeat">
      <a:schemeClr val="dk1"/>
    </dgm:fillClrLst>
    <dgm:linClrLst meth="repeat">
      <a:schemeClr val="dk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2">
    <dgm:fillClrLst meth="repeat">
      <a:schemeClr val="dk1"/>
    </dgm:fillClrLst>
    <dgm:linClrLst meth="repeat">
      <a:schemeClr val="dk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3">
    <dgm:fillClrLst meth="repeat">
      <a:schemeClr val="dk1"/>
    </dgm:fillClrLst>
    <dgm:linClrLst meth="repeat">
      <a:schemeClr val="dk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parChTrans1D4">
    <dgm:fillClrLst meth="repeat">
      <a:schemeClr val="dk1"/>
    </dgm:fillClrLst>
    <dgm:linClrLst meth="repeat">
      <a:schemeClr val="dk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fgAcc1">
    <dgm:fillClrLst meth="repeat">
      <a:schemeClr val="dk1">
        <a:alpha val="90000"/>
        <a:tint val="40000"/>
      </a:schemeClr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conFgAcc1">
    <dgm:fillClrLst meth="repeat">
      <a:schemeClr val="dk1">
        <a:alpha val="90000"/>
        <a:tint val="40000"/>
      </a:schemeClr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alignAcc1">
    <dgm:fillClrLst meth="repeat">
      <a:schemeClr val="dk1">
        <a:alpha val="90000"/>
        <a:tint val="40000"/>
      </a:schemeClr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trAlignAcc1">
    <dgm:fillClrLst meth="repeat">
      <a:schemeClr val="dk1">
        <a:alpha val="40000"/>
        <a:tint val="40000"/>
      </a:schemeClr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bgAcc1">
    <dgm:fillClrLst meth="repeat">
      <a:schemeClr val="dk1">
        <a:alpha val="90000"/>
        <a:tint val="40000"/>
      </a:schemeClr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solidFgAcc1">
    <dgm:fillClrLst meth="repeat">
      <a:schemeClr val="lt1"/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solidAlignAcc1">
    <dgm:fillClrLst meth="repeat">
      <a:schemeClr val="lt1"/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solidBgAcc1">
    <dgm:fillClrLst meth="repeat">
      <a:schemeClr val="lt1"/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fgAccFollowNode1">
    <dgm:fillClrLst meth="repeat">
      <a:schemeClr val="lt1">
        <a:alpha val="90000"/>
        <a:tint val="40000"/>
      </a:schemeClr>
    </dgm:fillClrLst>
    <dgm:linClrLst meth="repeat">
      <a:schemeClr val="dk1">
        <a:alpha val="90000"/>
      </a:schemeClr>
    </dgm:linClrLst>
    <dgm:effectClrLst/>
    <dgm:txLinClrLst/>
    <dgm:txFillClrLst meth="repeat">
      <a:schemeClr val="dk1"/>
    </dgm:txFillClrLst>
    <dgm:txEffectClrLst/>
  </dgm:styleLbl>
  <dgm:styleLbl name="alignAccFollowNode1">
    <dgm:fillClrLst meth="repeat">
      <a:schemeClr val="lt1">
        <a:alpha val="90000"/>
        <a:tint val="40000"/>
      </a:schemeClr>
    </dgm:fillClrLst>
    <dgm:linClrLst meth="repeat">
      <a:schemeClr val="dk1">
        <a:alpha val="90000"/>
      </a:schemeClr>
    </dgm:linClrLst>
    <dgm:effectClrLst/>
    <dgm:txLinClrLst/>
    <dgm:txFillClrLst meth="repeat">
      <a:schemeClr val="dk1"/>
    </dgm:txFillClrLst>
    <dgm:txEffectClrLst/>
  </dgm:styleLbl>
  <dgm:styleLbl name="bgAccFollowNode1">
    <dgm:fillClrLst meth="repeat">
      <a:schemeClr val="lt1">
        <a:alpha val="90000"/>
        <a:tint val="40000"/>
      </a:schemeClr>
    </dgm:fillClrLst>
    <dgm:linClrLst meth="repeat">
      <a:schemeClr val="dk1">
        <a:alpha val="90000"/>
      </a:schemeClr>
    </dgm:linClrLst>
    <dgm:effectClrLst/>
    <dgm:txLinClrLst/>
    <dgm:txFillClrLst meth="repeat">
      <a:schemeClr val="dk1"/>
    </dgm:txFillClrLst>
    <dgm:txEffectClrLst/>
  </dgm:styleLbl>
  <dgm:styleLbl name="fgAcc0">
    <dgm:fillClrLst meth="repeat">
      <a:schemeClr val="dk1">
        <a:alpha val="90000"/>
        <a:tint val="40000"/>
      </a:schemeClr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fgAcc2">
    <dgm:fillClrLst meth="repeat">
      <a:schemeClr val="dk1">
        <a:alpha val="90000"/>
        <a:tint val="40000"/>
      </a:schemeClr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fgAcc3">
    <dgm:fillClrLst meth="repeat">
      <a:schemeClr val="dk1">
        <a:alpha val="90000"/>
        <a:tint val="40000"/>
      </a:schemeClr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fgAcc4">
    <dgm:fillClrLst meth="repeat">
      <a:schemeClr val="dk1">
        <a:alpha val="90000"/>
        <a:tint val="40000"/>
      </a:schemeClr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bgShp">
    <dgm:fillClrLst meth="repeat">
      <a:schemeClr val="dk1">
        <a:tint val="40000"/>
      </a:schemeClr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dkBgShp">
    <dgm:fillClrLst meth="repeat">
      <a:schemeClr val="dk1">
        <a:shade val="80000"/>
      </a:schemeClr>
    </dgm:fillClrLst>
    <dgm:linClrLst meth="repeat">
      <a:schemeClr val="dk1"/>
    </dgm:linClrLst>
    <dgm:effectClrLst/>
    <dgm:txLinClrLst/>
    <dgm:txFillClrLst meth="repeat">
      <a:schemeClr val="lt1"/>
    </dgm:txFillClrLst>
    <dgm:txEffectClrLst/>
  </dgm:styleLbl>
  <dgm:styleLbl name="trBgShp">
    <dgm:fillClrLst meth="repeat">
      <a:schemeClr val="dk1">
        <a:tint val="50000"/>
        <a:alpha val="40000"/>
      </a:schemeClr>
    </dgm:fillClrLst>
    <dgm:linClrLst meth="repeat">
      <a:schemeClr val="dk1"/>
    </dgm:linClrLst>
    <dgm:effectClrLst/>
    <dgm:txLinClrLst/>
    <dgm:txFillClrLst meth="repeat">
      <a:schemeClr val="lt1"/>
    </dgm:txFillClrLst>
    <dgm:txEffectClrLst/>
  </dgm:styleLbl>
  <dgm:styleLbl name="fgShp">
    <dgm:fillClrLst meth="repeat">
      <a:schemeClr val="dk1">
        <a:tint val="60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revTx">
    <dgm:fillClrLst meth="repeat">
      <a:schemeClr val="lt1">
        <a:alpha val="0"/>
      </a:schemeClr>
    </dgm:fillClrLst>
    <dgm:linClrLst meth="repeat">
      <a:schemeClr val="dk1">
        <a:alpha val="0"/>
      </a:schemeClr>
    </dgm:linClrLst>
    <dgm:effectClrLst/>
    <dgm:txLinClrLst/>
    <dgm:txFillClrLst meth="repeat">
      <a:schemeClr val="tx1"/>
    </dgm:txFillClrLst>
    <dgm:txEffectClrLst/>
  </dgm:styleLbl>
</dgm:colorsDef>
</file>

<file path=ppt/diagrams/colors2.xml><?xml version="1.0" encoding="utf-8"?>
<dgm:colorsDef xmlns:dgm="http://schemas.openxmlformats.org/drawingml/2006/diagram" xmlns:a="http://schemas.openxmlformats.org/drawingml/2006/main" uniqueId="urn:microsoft.com/office/officeart/2005/8/colors/accent0_1">
  <dgm:title val=""/>
  <dgm:desc val=""/>
  <dgm:catLst>
    <dgm:cat type="mainScheme" pri="10100"/>
  </dgm:catLst>
  <dgm:styleLbl name="node0">
    <dgm:fillClrLst meth="repeat">
      <a:schemeClr val="lt1"/>
    </dgm:fillClrLst>
    <dgm:linClrLst meth="repeat">
      <a:schemeClr val="dk1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node1">
    <dgm:fillClrLst meth="repeat">
      <a:schemeClr val="lt1"/>
    </dgm:fillClrLst>
    <dgm:linClrLst meth="repeat">
      <a:schemeClr val="dk1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alignNode1">
    <dgm:fillClrLst meth="repeat">
      <a:schemeClr val="lt1"/>
    </dgm:fillClrLst>
    <dgm:linClrLst meth="repeat">
      <a:schemeClr val="dk1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lnNode1">
    <dgm:fillClrLst meth="repeat">
      <a:schemeClr val="lt1"/>
    </dgm:fillClrLst>
    <dgm:linClrLst meth="repeat">
      <a:schemeClr val="dk1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vennNode1">
    <dgm:fillClrLst meth="repeat">
      <a:schemeClr val="lt1">
        <a:alpha val="50000"/>
      </a:schemeClr>
    </dgm:fillClrLst>
    <dgm:linClrLst meth="repeat">
      <a:schemeClr val="dk1">
        <a:shade val="80000"/>
      </a:schemeClr>
    </dgm:linClrLst>
    <dgm:effectClrLst/>
    <dgm:txLinClrLst/>
    <dgm:txFillClrLst/>
    <dgm:txEffectClrLst/>
  </dgm:styleLbl>
  <dgm:styleLbl name="node2">
    <dgm:fillClrLst meth="repeat">
      <a:schemeClr val="lt1"/>
    </dgm:fillClrLst>
    <dgm:linClrLst meth="repeat">
      <a:schemeClr val="dk1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node3">
    <dgm:fillClrLst meth="repeat">
      <a:schemeClr val="lt1"/>
    </dgm:fillClrLst>
    <dgm:linClrLst meth="repeat">
      <a:schemeClr val="dk1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node4">
    <dgm:fillClrLst meth="repeat">
      <a:schemeClr val="lt1"/>
    </dgm:fillClrLst>
    <dgm:linClrLst meth="repeat">
      <a:schemeClr val="dk1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fgImgPlace1">
    <dgm:fillClrLst meth="repeat">
      <a:schemeClr val="dk1">
        <a:tint val="40000"/>
      </a:schemeClr>
    </dgm:fillClrLst>
    <dgm:linClrLst meth="repeat">
      <a:schemeClr val="dk1">
        <a:shade val="80000"/>
      </a:schemeClr>
    </dgm:linClrLst>
    <dgm:effectClrLst/>
    <dgm:txLinClrLst/>
    <dgm:txFillClrLst meth="repeat">
      <a:schemeClr val="lt1"/>
    </dgm:txFillClrLst>
    <dgm:txEffectClrLst/>
  </dgm:styleLbl>
  <dgm:styleLbl name="alignImgPlace1">
    <dgm:fillClrLst meth="repeat">
      <a:schemeClr val="dk1">
        <a:tint val="40000"/>
      </a:schemeClr>
    </dgm:fillClrLst>
    <dgm:linClrLst meth="repeat">
      <a:schemeClr val="dk1">
        <a:shade val="80000"/>
      </a:schemeClr>
    </dgm:linClrLst>
    <dgm:effectClrLst/>
    <dgm:txLinClrLst/>
    <dgm:txFillClrLst meth="repeat">
      <a:schemeClr val="lt1"/>
    </dgm:txFillClrLst>
    <dgm:txEffectClrLst/>
  </dgm:styleLbl>
  <dgm:styleLbl name="bgImgPlace1">
    <dgm:fillClrLst meth="repeat">
      <a:schemeClr val="dk1">
        <a:tint val="40000"/>
      </a:schemeClr>
    </dgm:fillClrLst>
    <dgm:linClrLst meth="repeat">
      <a:schemeClr val="dk1">
        <a:shade val="80000"/>
      </a:schemeClr>
    </dgm:linClrLst>
    <dgm:effectClrLst/>
    <dgm:txLinClrLst/>
    <dgm:txFillClrLst meth="repeat">
      <a:schemeClr val="lt1"/>
    </dgm:txFillClrLst>
    <dgm:txEffectClrLst/>
  </dgm:styleLbl>
  <dgm:styleLbl name="sibTrans2D1">
    <dgm:fillClrLst meth="repeat">
      <a:schemeClr val="dk1">
        <a:tint val="60000"/>
      </a:schemeClr>
    </dgm:fillClrLst>
    <dgm:linClrLst meth="repeat">
      <a:schemeClr val="dk1">
        <a:tint val="60000"/>
      </a:schemeClr>
    </dgm:linClrLst>
    <dgm:effectClrLst/>
    <dgm:txLinClrLst/>
    <dgm:txFillClrLst meth="repeat">
      <a:schemeClr val="dk1"/>
    </dgm:txFillClrLst>
    <dgm:txEffectClrLst/>
  </dgm:styleLbl>
  <dgm:styleLbl name="fgSibTrans2D1">
    <dgm:fillClrLst meth="repeat">
      <a:schemeClr val="dk1">
        <a:tint val="60000"/>
      </a:schemeClr>
    </dgm:fillClrLst>
    <dgm:linClrLst meth="repeat">
      <a:schemeClr val="dk1">
        <a:tint val="60000"/>
      </a:schemeClr>
    </dgm:linClrLst>
    <dgm:effectClrLst/>
    <dgm:txLinClrLst/>
    <dgm:txFillClrLst meth="repeat">
      <a:schemeClr val="dk1"/>
    </dgm:txFillClrLst>
    <dgm:txEffectClrLst/>
  </dgm:styleLbl>
  <dgm:styleLbl name="bgSibTrans2D1">
    <dgm:fillClrLst meth="repeat">
      <a:schemeClr val="dk1">
        <a:tint val="60000"/>
      </a:schemeClr>
    </dgm:fillClrLst>
    <dgm:linClrLst meth="repeat">
      <a:schemeClr val="dk1">
        <a:tint val="60000"/>
      </a:schemeClr>
    </dgm:linClrLst>
    <dgm:effectClrLst/>
    <dgm:txLinClrLst/>
    <dgm:txFillClrLst meth="repeat">
      <a:schemeClr val="dk1"/>
    </dgm:txFillClrLst>
    <dgm:txEffectClrLst/>
  </dgm:styleLbl>
  <dgm:styleLbl name="sibTrans1D1">
    <dgm:fillClrLst meth="repeat">
      <a:schemeClr val="dk1"/>
    </dgm:fillClrLst>
    <dgm:linClrLst meth="repeat">
      <a:schemeClr val="dk1"/>
    </dgm:linClrLst>
    <dgm:effectClrLst/>
    <dgm:txLinClrLst/>
    <dgm:txFillClrLst meth="repeat">
      <a:schemeClr val="tx1"/>
    </dgm:txFillClrLst>
    <dgm:txEffectClrLst/>
  </dgm:styleLbl>
  <dgm:styleLbl name="callout">
    <dgm:fillClrLst meth="repeat">
      <a:schemeClr val="dk1"/>
    </dgm:fillClrLst>
    <dgm:linClrLst meth="repeat">
      <a:schemeClr val="dk1"/>
    </dgm:linClrLst>
    <dgm:effectClrLst/>
    <dgm:txLinClrLst/>
    <dgm:txFillClrLst meth="repeat">
      <a:schemeClr val="tx1"/>
    </dgm:txFillClrLst>
    <dgm:txEffectClrLst/>
  </dgm:styleLbl>
  <dgm:styleLbl name="asst0">
    <dgm:fillClrLst meth="repeat">
      <a:schemeClr val="lt1"/>
    </dgm:fillClrLst>
    <dgm:linClrLst meth="repeat">
      <a:schemeClr val="dk1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asst1">
    <dgm:fillClrLst meth="repeat">
      <a:schemeClr val="lt1"/>
    </dgm:fillClrLst>
    <dgm:linClrLst meth="repeat">
      <a:schemeClr val="dk1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asst2">
    <dgm:fillClrLst meth="repeat">
      <a:schemeClr val="lt1"/>
    </dgm:fillClrLst>
    <dgm:linClrLst meth="repeat">
      <a:schemeClr val="dk1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asst3">
    <dgm:fillClrLst meth="repeat">
      <a:schemeClr val="lt1"/>
    </dgm:fillClrLst>
    <dgm:linClrLst meth="repeat">
      <a:schemeClr val="dk1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asst4">
    <dgm:fillClrLst meth="repeat">
      <a:schemeClr val="lt1"/>
    </dgm:fillClrLst>
    <dgm:linClrLst meth="repeat">
      <a:schemeClr val="dk1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parChTrans2D1">
    <dgm:fillClrLst meth="repeat">
      <a:schemeClr val="dk1">
        <a:tint val="60000"/>
      </a:schemeClr>
    </dgm:fillClrLst>
    <dgm:linClrLst meth="repeat">
      <a:schemeClr val="dk1">
        <a:tint val="60000"/>
      </a:schemeClr>
    </dgm:linClrLst>
    <dgm:effectClrLst/>
    <dgm:txLinClrLst/>
    <dgm:txFillClrLst/>
    <dgm:txEffectClrLst/>
  </dgm:styleLbl>
  <dgm:styleLbl name="parChTrans2D2">
    <dgm:fillClrLst meth="repeat">
      <a:schemeClr val="dk1"/>
    </dgm:fillClrLst>
    <dgm:linClrLst meth="repeat">
      <a:schemeClr val="dk1"/>
    </dgm:linClrLst>
    <dgm:effectClrLst/>
    <dgm:txLinClrLst/>
    <dgm:txFillClrLst/>
    <dgm:txEffectClrLst/>
  </dgm:styleLbl>
  <dgm:styleLbl name="parChTrans2D3">
    <dgm:fillClrLst meth="repeat">
      <a:schemeClr val="dk1"/>
    </dgm:fillClrLst>
    <dgm:linClrLst meth="repeat">
      <a:schemeClr val="dk1"/>
    </dgm:linClrLst>
    <dgm:effectClrLst/>
    <dgm:txLinClrLst/>
    <dgm:txFillClrLst/>
    <dgm:txEffectClrLst/>
  </dgm:styleLbl>
  <dgm:styleLbl name="parChTrans2D4">
    <dgm:fillClrLst meth="repeat">
      <a:schemeClr val="dk1"/>
    </dgm:fillClrLst>
    <dgm:linClrLst meth="repeat">
      <a:schemeClr val="dk1"/>
    </dgm:linClrLst>
    <dgm:effectClrLst/>
    <dgm:txLinClrLst/>
    <dgm:txFillClrLst meth="repeat">
      <a:schemeClr val="lt1"/>
    </dgm:txFillClrLst>
    <dgm:txEffectClrLst/>
  </dgm:styleLbl>
  <dgm:styleLbl name="parChTrans1D1">
    <dgm:fillClrLst meth="repeat">
      <a:schemeClr val="dk1"/>
    </dgm:fillClrLst>
    <dgm:linClrLst meth="repeat">
      <a:schemeClr val="dk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2">
    <dgm:fillClrLst meth="repeat">
      <a:schemeClr val="dk1"/>
    </dgm:fillClrLst>
    <dgm:linClrLst meth="repeat">
      <a:schemeClr val="dk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3">
    <dgm:fillClrLst meth="repeat">
      <a:schemeClr val="dk1"/>
    </dgm:fillClrLst>
    <dgm:linClrLst meth="repeat">
      <a:schemeClr val="dk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parChTrans1D4">
    <dgm:fillClrLst meth="repeat">
      <a:schemeClr val="dk1"/>
    </dgm:fillClrLst>
    <dgm:linClrLst meth="repeat">
      <a:schemeClr val="dk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fgAcc1">
    <dgm:fillClrLst meth="repeat">
      <a:schemeClr val="dk1">
        <a:alpha val="90000"/>
        <a:tint val="40000"/>
      </a:schemeClr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conFgAcc1">
    <dgm:fillClrLst meth="repeat">
      <a:schemeClr val="dk1">
        <a:alpha val="90000"/>
        <a:tint val="40000"/>
      </a:schemeClr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alignAcc1">
    <dgm:fillClrLst meth="repeat">
      <a:schemeClr val="dk1">
        <a:alpha val="90000"/>
        <a:tint val="40000"/>
      </a:schemeClr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trAlignAcc1">
    <dgm:fillClrLst meth="repeat">
      <a:schemeClr val="dk1">
        <a:alpha val="40000"/>
        <a:tint val="40000"/>
      </a:schemeClr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bgAcc1">
    <dgm:fillClrLst meth="repeat">
      <a:schemeClr val="dk1">
        <a:alpha val="90000"/>
        <a:tint val="40000"/>
      </a:schemeClr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solidFgAcc1">
    <dgm:fillClrLst meth="repeat">
      <a:schemeClr val="lt1"/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solidAlignAcc1">
    <dgm:fillClrLst meth="repeat">
      <a:schemeClr val="lt1"/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solidBgAcc1">
    <dgm:fillClrLst meth="repeat">
      <a:schemeClr val="lt1"/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fgAccFollowNode1">
    <dgm:fillClrLst meth="repeat">
      <a:schemeClr val="lt1">
        <a:alpha val="90000"/>
        <a:tint val="40000"/>
      </a:schemeClr>
    </dgm:fillClrLst>
    <dgm:linClrLst meth="repeat">
      <a:schemeClr val="dk1">
        <a:alpha val="90000"/>
      </a:schemeClr>
    </dgm:linClrLst>
    <dgm:effectClrLst/>
    <dgm:txLinClrLst/>
    <dgm:txFillClrLst meth="repeat">
      <a:schemeClr val="dk1"/>
    </dgm:txFillClrLst>
    <dgm:txEffectClrLst/>
  </dgm:styleLbl>
  <dgm:styleLbl name="alignAccFollowNode1">
    <dgm:fillClrLst meth="repeat">
      <a:schemeClr val="lt1">
        <a:alpha val="90000"/>
        <a:tint val="40000"/>
      </a:schemeClr>
    </dgm:fillClrLst>
    <dgm:linClrLst meth="repeat">
      <a:schemeClr val="dk1">
        <a:alpha val="90000"/>
      </a:schemeClr>
    </dgm:linClrLst>
    <dgm:effectClrLst/>
    <dgm:txLinClrLst/>
    <dgm:txFillClrLst meth="repeat">
      <a:schemeClr val="dk1"/>
    </dgm:txFillClrLst>
    <dgm:txEffectClrLst/>
  </dgm:styleLbl>
  <dgm:styleLbl name="bgAccFollowNode1">
    <dgm:fillClrLst meth="repeat">
      <a:schemeClr val="lt1">
        <a:alpha val="90000"/>
        <a:tint val="40000"/>
      </a:schemeClr>
    </dgm:fillClrLst>
    <dgm:linClrLst meth="repeat">
      <a:schemeClr val="dk1">
        <a:alpha val="90000"/>
      </a:schemeClr>
    </dgm:linClrLst>
    <dgm:effectClrLst/>
    <dgm:txLinClrLst/>
    <dgm:txFillClrLst meth="repeat">
      <a:schemeClr val="dk1"/>
    </dgm:txFillClrLst>
    <dgm:txEffectClrLst/>
  </dgm:styleLbl>
  <dgm:styleLbl name="fgAcc0">
    <dgm:fillClrLst meth="repeat">
      <a:schemeClr val="dk1">
        <a:alpha val="90000"/>
        <a:tint val="40000"/>
      </a:schemeClr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fgAcc2">
    <dgm:fillClrLst meth="repeat">
      <a:schemeClr val="dk1">
        <a:alpha val="90000"/>
        <a:tint val="40000"/>
      </a:schemeClr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fgAcc3">
    <dgm:fillClrLst meth="repeat">
      <a:schemeClr val="dk1">
        <a:alpha val="90000"/>
        <a:tint val="40000"/>
      </a:schemeClr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fgAcc4">
    <dgm:fillClrLst meth="repeat">
      <a:schemeClr val="dk1">
        <a:alpha val="90000"/>
        <a:tint val="40000"/>
      </a:schemeClr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bgShp">
    <dgm:fillClrLst meth="repeat">
      <a:schemeClr val="dk1">
        <a:tint val="40000"/>
      </a:schemeClr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dkBgShp">
    <dgm:fillClrLst meth="repeat">
      <a:schemeClr val="dk1">
        <a:shade val="80000"/>
      </a:schemeClr>
    </dgm:fillClrLst>
    <dgm:linClrLst meth="repeat">
      <a:schemeClr val="dk1"/>
    </dgm:linClrLst>
    <dgm:effectClrLst/>
    <dgm:txLinClrLst/>
    <dgm:txFillClrLst meth="repeat">
      <a:schemeClr val="lt1"/>
    </dgm:txFillClrLst>
    <dgm:txEffectClrLst/>
  </dgm:styleLbl>
  <dgm:styleLbl name="trBgShp">
    <dgm:fillClrLst meth="repeat">
      <a:schemeClr val="dk1">
        <a:tint val="50000"/>
        <a:alpha val="40000"/>
      </a:schemeClr>
    </dgm:fillClrLst>
    <dgm:linClrLst meth="repeat">
      <a:schemeClr val="dk1"/>
    </dgm:linClrLst>
    <dgm:effectClrLst/>
    <dgm:txLinClrLst/>
    <dgm:txFillClrLst meth="repeat">
      <a:schemeClr val="lt1"/>
    </dgm:txFillClrLst>
    <dgm:txEffectClrLst/>
  </dgm:styleLbl>
  <dgm:styleLbl name="fgShp">
    <dgm:fillClrLst meth="repeat">
      <a:schemeClr val="dk1">
        <a:tint val="60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revTx">
    <dgm:fillClrLst meth="repeat">
      <a:schemeClr val="lt1">
        <a:alpha val="0"/>
      </a:schemeClr>
    </dgm:fillClrLst>
    <dgm:linClrLst meth="repeat">
      <a:schemeClr val="dk1">
        <a:alpha val="0"/>
      </a:schemeClr>
    </dgm:linClrLst>
    <dgm:effectClrLst/>
    <dgm:txLinClrLst/>
    <dgm:txFillClrLst meth="repeat">
      <a:schemeClr val="tx1"/>
    </dgm:txFillClrLst>
    <dgm:txEffectClrLst/>
  </dgm:styleLbl>
</dgm:colorsDef>
</file>

<file path=ppt/diagrams/data1.xml><?xml version="1.0" encoding="utf-8"?>
<dgm:dataModel xmlns:dgm="http://schemas.openxmlformats.org/drawingml/2006/diagram" xmlns:a="http://schemas.openxmlformats.org/drawingml/2006/main">
  <dgm:ptLst>
    <dgm:pt modelId="{C256443A-5739-41C3-976C-086C241C3437}" type="doc">
      <dgm:prSet loTypeId="urn:microsoft.com/office/officeart/2005/8/layout/hierarchy2" loCatId="hierarchy" qsTypeId="urn:microsoft.com/office/officeart/2005/8/quickstyle/simple1" qsCatId="simple" csTypeId="urn:microsoft.com/office/officeart/2005/8/colors/accent0_1" csCatId="mainScheme" phldr="1"/>
      <dgm:spPr/>
      <dgm:t>
        <a:bodyPr/>
        <a:lstStyle/>
        <a:p>
          <a:endParaRPr lang="de-DE"/>
        </a:p>
      </dgm:t>
    </dgm:pt>
    <dgm:pt modelId="{353C6F70-9685-47CA-B6F4-8BAAB244C13E}">
      <dgm:prSet phldrT="[Text]" custT="1"/>
      <dgm:spPr/>
      <dgm:t>
        <a:bodyPr/>
        <a:lstStyle/>
        <a:p>
          <a:r>
            <a:rPr lang="de-DE" sz="1200" dirty="0">
              <a:latin typeface="Times New Roman" panose="02020603050405020304" pitchFamily="18" charset="0"/>
              <a:cs typeface="Times New Roman" panose="02020603050405020304" pitchFamily="18" charset="0"/>
            </a:rPr>
            <a:t>Conversations on public health issue – </a:t>
          </a:r>
          <a:r>
            <a:rPr lang="de-DE" sz="1200" i="1" dirty="0">
              <a:latin typeface="Times New Roman" panose="02020603050405020304" pitchFamily="18" charset="0"/>
              <a:cs typeface="Times New Roman" panose="02020603050405020304" pitchFamily="18" charset="0"/>
            </a:rPr>
            <a:t>health issue X</a:t>
          </a:r>
          <a:r>
            <a:rPr lang="de-DE" sz="1200" dirty="0">
              <a:latin typeface="Times New Roman" panose="02020603050405020304" pitchFamily="18" charset="0"/>
              <a:cs typeface="Times New Roman" panose="02020603050405020304" pitchFamily="18" charset="0"/>
            </a:rPr>
            <a:t> </a:t>
          </a:r>
        </a:p>
      </dgm:t>
    </dgm:pt>
    <dgm:pt modelId="{87404468-AF06-4D92-8599-AEA8859A7AA9}" type="parTrans" cxnId="{1A9D4DE3-4A37-4227-B403-A2ADA5B17FB0}">
      <dgm:prSet/>
      <dgm:spPr/>
      <dgm:t>
        <a:bodyPr/>
        <a:lstStyle/>
        <a:p>
          <a:endParaRPr lang="de-DE" sz="2000"/>
        </a:p>
      </dgm:t>
    </dgm:pt>
    <dgm:pt modelId="{68C29FC2-7381-479D-98A3-371A7F9C8B6D}" type="sibTrans" cxnId="{1A9D4DE3-4A37-4227-B403-A2ADA5B17FB0}">
      <dgm:prSet/>
      <dgm:spPr/>
      <dgm:t>
        <a:bodyPr/>
        <a:lstStyle/>
        <a:p>
          <a:endParaRPr lang="de-DE" sz="2000"/>
        </a:p>
      </dgm:t>
    </dgm:pt>
    <dgm:pt modelId="{5E805EC3-C58D-4BD5-A99E-B5CA51F30872}">
      <dgm:prSet phldrT="[Text]" custT="1"/>
      <dgm:spPr/>
      <dgm:t>
        <a:bodyPr/>
        <a:lstStyle/>
        <a:p>
          <a:r>
            <a:rPr lang="de-DE" sz="1200" dirty="0">
              <a:latin typeface="Times New Roman" panose="02020603050405020304" pitchFamily="18" charset="0"/>
              <a:cs typeface="Times New Roman" panose="02020603050405020304" pitchFamily="18" charset="0"/>
            </a:rPr>
            <a:t>The </a:t>
          </a:r>
          <a:r>
            <a:rPr lang="de-DE" sz="1200" dirty="0" err="1">
              <a:latin typeface="Times New Roman" panose="02020603050405020304" pitchFamily="18" charset="0"/>
              <a:cs typeface="Times New Roman" panose="02020603050405020304" pitchFamily="18" charset="0"/>
            </a:rPr>
            <a:t>Cause</a:t>
          </a:r>
          <a:endParaRPr lang="de-DE" sz="1200" dirty="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F855B30C-366F-4036-B5AE-48974C07A80E}" type="parTrans" cxnId="{7E741121-3465-4D04-BF60-56919F6F4B45}">
      <dgm:prSet custT="1"/>
      <dgm:spPr/>
      <dgm:t>
        <a:bodyPr/>
        <a:lstStyle/>
        <a:p>
          <a:endParaRPr lang="de-DE" sz="110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B59D055C-2884-474E-9D56-8022BD751C43}" type="sibTrans" cxnId="{7E741121-3465-4D04-BF60-56919F6F4B45}">
      <dgm:prSet/>
      <dgm:spPr/>
      <dgm:t>
        <a:bodyPr/>
        <a:lstStyle/>
        <a:p>
          <a:endParaRPr lang="de-DE" sz="2000"/>
        </a:p>
      </dgm:t>
    </dgm:pt>
    <dgm:pt modelId="{3A98E99E-5EB9-499E-9929-61172C5675F2}">
      <dgm:prSet phldrT="[Text]" custT="1"/>
      <dgm:spPr/>
      <dgm:t>
        <a:bodyPr/>
        <a:lstStyle/>
        <a:p>
          <a:r>
            <a:rPr lang="de-DE" sz="1200" dirty="0">
              <a:latin typeface="Times New Roman" panose="02020603050405020304" pitchFamily="18" charset="0"/>
              <a:cs typeface="Times New Roman" panose="02020603050405020304" pitchFamily="18" charset="0"/>
            </a:rPr>
            <a:t>The </a:t>
          </a:r>
          <a:r>
            <a:rPr lang="de-DE" sz="1200" dirty="0" err="1">
              <a:latin typeface="Times New Roman" panose="02020603050405020304" pitchFamily="18" charset="0"/>
              <a:cs typeface="Times New Roman" panose="02020603050405020304" pitchFamily="18" charset="0"/>
            </a:rPr>
            <a:t>cause</a:t>
          </a:r>
          <a:r>
            <a:rPr lang="de-DE" sz="1200" dirty="0">
              <a:latin typeface="Times New Roman" panose="02020603050405020304" pitchFamily="18" charset="0"/>
              <a:cs typeface="Times New Roman" panose="02020603050405020304" pitchFamily="18" charset="0"/>
            </a:rPr>
            <a:t> of the </a:t>
          </a:r>
          <a:r>
            <a:rPr lang="de-DE" sz="1200" dirty="0" err="1">
              <a:latin typeface="Times New Roman" panose="02020603050405020304" pitchFamily="18" charset="0"/>
              <a:cs typeface="Times New Roman" panose="02020603050405020304" pitchFamily="18" charset="0"/>
            </a:rPr>
            <a:t>virus</a:t>
          </a:r>
          <a:endParaRPr lang="de-DE" sz="1200" dirty="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C09B2D6A-14B0-4151-BFD3-E21110A5E135}" type="parTrans" cxnId="{4FFBF3E2-1522-42AF-BA23-014F92B921B3}">
      <dgm:prSet custT="1"/>
      <dgm:spPr/>
      <dgm:t>
        <a:bodyPr/>
        <a:lstStyle/>
        <a:p>
          <a:endParaRPr lang="de-DE" sz="110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E8089669-DCD2-4DB6-A714-273990695241}" type="sibTrans" cxnId="{4FFBF3E2-1522-42AF-BA23-014F92B921B3}">
      <dgm:prSet/>
      <dgm:spPr/>
      <dgm:t>
        <a:bodyPr/>
        <a:lstStyle/>
        <a:p>
          <a:endParaRPr lang="de-DE" sz="2000"/>
        </a:p>
      </dgm:t>
    </dgm:pt>
    <dgm:pt modelId="{5BEDA607-8DED-42F2-9BA0-692D403C0EC7}">
      <dgm:prSet phldrT="[Text]" custT="1"/>
      <dgm:spPr/>
      <dgm:t>
        <a:bodyPr/>
        <a:lstStyle/>
        <a:p>
          <a:r>
            <a:rPr lang="de-DE" sz="1200" dirty="0">
              <a:latin typeface="Times New Roman" panose="02020603050405020304" pitchFamily="18" charset="0"/>
              <a:cs typeface="Times New Roman" panose="02020603050405020304" pitchFamily="18" charset="0"/>
            </a:rPr>
            <a:t>The </a:t>
          </a:r>
          <a:r>
            <a:rPr lang="de-DE" sz="1200" dirty="0" err="1">
              <a:latin typeface="Times New Roman" panose="02020603050405020304" pitchFamily="18" charset="0"/>
              <a:cs typeface="Times New Roman" panose="02020603050405020304" pitchFamily="18" charset="0"/>
            </a:rPr>
            <a:t>Illness</a:t>
          </a:r>
          <a:endParaRPr lang="de-DE" sz="1200" dirty="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84547787-FAB0-4D90-A3B1-62ECE02E3768}" type="parTrans" cxnId="{F19D9763-6EC4-4C58-A212-4CB5C96C1C4B}">
      <dgm:prSet custT="1"/>
      <dgm:spPr/>
      <dgm:t>
        <a:bodyPr/>
        <a:lstStyle/>
        <a:p>
          <a:endParaRPr lang="de-DE" sz="110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85E28AF0-9D48-40FF-95C5-6BCCE65C1A96}" type="sibTrans" cxnId="{F19D9763-6EC4-4C58-A212-4CB5C96C1C4B}">
      <dgm:prSet/>
      <dgm:spPr/>
      <dgm:t>
        <a:bodyPr/>
        <a:lstStyle/>
        <a:p>
          <a:endParaRPr lang="de-DE" sz="2000"/>
        </a:p>
      </dgm:t>
    </dgm:pt>
    <dgm:pt modelId="{A7E59208-D8C8-472E-BF12-F8E4CF3114A2}">
      <dgm:prSet phldrT="[Text]" custT="1"/>
      <dgm:spPr/>
      <dgm:t>
        <a:bodyPr/>
        <a:lstStyle/>
        <a:p>
          <a:r>
            <a:rPr lang="de-DE" sz="1200" dirty="0">
              <a:latin typeface="Times New Roman" panose="02020603050405020304" pitchFamily="18" charset="0"/>
              <a:cs typeface="Times New Roman" panose="02020603050405020304" pitchFamily="18" charset="0"/>
            </a:rPr>
            <a:t>The Treatment</a:t>
          </a:r>
        </a:p>
      </dgm:t>
    </dgm:pt>
    <dgm:pt modelId="{A1B0E159-B1C8-4060-A4E0-14F2712C19F0}" type="parTrans" cxnId="{04D6DC77-F106-4C55-92DF-A7B3E0A59C0C}">
      <dgm:prSet custT="1"/>
      <dgm:spPr/>
      <dgm:t>
        <a:bodyPr/>
        <a:lstStyle/>
        <a:p>
          <a:endParaRPr lang="de-DE" sz="110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51A6C234-0D46-49B1-9152-315F121BE747}" type="sibTrans" cxnId="{04D6DC77-F106-4C55-92DF-A7B3E0A59C0C}">
      <dgm:prSet/>
      <dgm:spPr/>
      <dgm:t>
        <a:bodyPr/>
        <a:lstStyle/>
        <a:p>
          <a:endParaRPr lang="de-DE" sz="2000"/>
        </a:p>
      </dgm:t>
    </dgm:pt>
    <dgm:pt modelId="{4DCC093E-5118-4588-BF05-784A120C438E}">
      <dgm:prSet phldrT="[Text]" custT="1"/>
      <dgm:spPr/>
      <dgm:t>
        <a:bodyPr/>
        <a:lstStyle/>
        <a:p>
          <a:r>
            <a:rPr lang="de-DE" sz="1200" dirty="0">
              <a:latin typeface="Times New Roman" panose="02020603050405020304" pitchFamily="18" charset="0"/>
              <a:cs typeface="Times New Roman" panose="02020603050405020304" pitchFamily="18" charset="0"/>
            </a:rPr>
            <a:t>The</a:t>
          </a:r>
          <a:r>
            <a:rPr lang="de-DE" sz="1200" baseline="0" dirty="0">
              <a:latin typeface="Times New Roman" panose="02020603050405020304" pitchFamily="18" charset="0"/>
              <a:cs typeface="Times New Roman" panose="02020603050405020304" pitchFamily="18" charset="0"/>
            </a:rPr>
            <a:t> </a:t>
          </a:r>
          <a:r>
            <a:rPr lang="de-DE" sz="1200" baseline="0" dirty="0" err="1">
              <a:latin typeface="Times New Roman" panose="02020603050405020304" pitchFamily="18" charset="0"/>
              <a:cs typeface="Times New Roman" panose="02020603050405020304" pitchFamily="18" charset="0"/>
            </a:rPr>
            <a:t>Interventions</a:t>
          </a:r>
          <a:endParaRPr lang="de-DE" sz="1200" dirty="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579F7746-AF17-435C-A54C-9C6E6EE94B1D}" type="parTrans" cxnId="{21D2CBA7-4E8B-4913-B267-78660AC9127F}">
      <dgm:prSet custT="1"/>
      <dgm:spPr/>
      <dgm:t>
        <a:bodyPr/>
        <a:lstStyle/>
        <a:p>
          <a:endParaRPr lang="de-DE" sz="110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EA649D5B-149D-4781-A689-D23905969596}" type="sibTrans" cxnId="{21D2CBA7-4E8B-4913-B267-78660AC9127F}">
      <dgm:prSet/>
      <dgm:spPr/>
      <dgm:t>
        <a:bodyPr/>
        <a:lstStyle/>
        <a:p>
          <a:endParaRPr lang="de-DE" sz="2000"/>
        </a:p>
      </dgm:t>
    </dgm:pt>
    <dgm:pt modelId="{4E60B1B3-870B-4A1B-9517-73B33DCA2C20}">
      <dgm:prSet phldrT="[Text]" custT="1"/>
      <dgm:spPr/>
      <dgm:t>
        <a:bodyPr/>
        <a:lstStyle/>
        <a:p>
          <a:r>
            <a:rPr lang="de-DE" sz="1200" dirty="0">
              <a:latin typeface="Times New Roman" panose="02020603050405020304" pitchFamily="18" charset="0"/>
              <a:cs typeface="Times New Roman" panose="02020603050405020304" pitchFamily="18" charset="0"/>
            </a:rPr>
            <a:t>Information</a:t>
          </a:r>
        </a:p>
      </dgm:t>
    </dgm:pt>
    <dgm:pt modelId="{895AD288-8C3F-4FEF-8348-DE71D8D3CA8C}" type="parTrans" cxnId="{18B32BF9-C15D-49A4-94AE-9BE5B96D30B1}">
      <dgm:prSet custT="1"/>
      <dgm:spPr/>
      <dgm:t>
        <a:bodyPr/>
        <a:lstStyle/>
        <a:p>
          <a:endParaRPr lang="de-DE" sz="110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E66CBDB9-DF23-432A-9DE5-67E5508FEEDF}" type="sibTrans" cxnId="{18B32BF9-C15D-49A4-94AE-9BE5B96D30B1}">
      <dgm:prSet/>
      <dgm:spPr/>
      <dgm:t>
        <a:bodyPr/>
        <a:lstStyle/>
        <a:p>
          <a:endParaRPr lang="de-DE" sz="2000"/>
        </a:p>
      </dgm:t>
    </dgm:pt>
    <dgm:pt modelId="{358A984D-84A8-4882-B614-7818D9052477}">
      <dgm:prSet phldrT="[Text]" custT="1"/>
      <dgm:spPr/>
      <dgm:t>
        <a:bodyPr/>
        <a:lstStyle/>
        <a:p>
          <a:r>
            <a:rPr lang="de-DE" sz="1200">
              <a:latin typeface="Times New Roman" panose="02020603050405020304" pitchFamily="18" charset="0"/>
              <a:cs typeface="Times New Roman" panose="02020603050405020304" pitchFamily="18" charset="0"/>
            </a:rPr>
            <a:t>Stigma</a:t>
          </a:r>
        </a:p>
      </dgm:t>
    </dgm:pt>
    <dgm:pt modelId="{8C8C0F98-AF8B-47BC-ACBA-EC4EA96F1883}" type="parTrans" cxnId="{A4C9B23C-5196-4A21-9C6A-A300E70E09A3}">
      <dgm:prSet custT="1"/>
      <dgm:spPr/>
      <dgm:t>
        <a:bodyPr/>
        <a:lstStyle/>
        <a:p>
          <a:endParaRPr lang="de-DE" sz="110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FB721D93-4426-41AA-BDE6-2476D51C93FF}" type="sibTrans" cxnId="{A4C9B23C-5196-4A21-9C6A-A300E70E09A3}">
      <dgm:prSet/>
      <dgm:spPr/>
      <dgm:t>
        <a:bodyPr/>
        <a:lstStyle/>
        <a:p>
          <a:endParaRPr lang="de-DE" sz="2000"/>
        </a:p>
      </dgm:t>
    </dgm:pt>
    <dgm:pt modelId="{4C9D4A9F-DD4B-450F-BD60-CED00D3393A2}">
      <dgm:prSet phldrT="[Text]" custT="1"/>
      <dgm:spPr/>
      <dgm:t>
        <a:bodyPr/>
        <a:lstStyle/>
        <a:p>
          <a:r>
            <a:rPr lang="de-DE" sz="1200">
              <a:latin typeface="Times New Roman" panose="02020603050405020304" pitchFamily="18" charset="0"/>
              <a:cs typeface="Times New Roman" panose="02020603050405020304" pitchFamily="18" charset="0"/>
            </a:rPr>
            <a:t>Spread and </a:t>
          </a:r>
          <a:r>
            <a:rPr lang="de-DE" sz="1200" err="1">
              <a:latin typeface="Times New Roman" panose="02020603050405020304" pitchFamily="18" charset="0"/>
              <a:cs typeface="Times New Roman" panose="02020603050405020304" pitchFamily="18" charset="0"/>
            </a:rPr>
            <a:t>immunity</a:t>
          </a:r>
          <a:endParaRPr lang="de-DE" sz="120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1731A452-294D-4C69-97EA-ABFB841FA0AB}" type="parTrans" cxnId="{0A0CF701-79B2-47F2-8622-FC36046D2926}">
      <dgm:prSet custT="1"/>
      <dgm:spPr/>
      <dgm:t>
        <a:bodyPr/>
        <a:lstStyle/>
        <a:p>
          <a:endParaRPr lang="de-DE" sz="110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71D5611E-9C7C-4282-88EB-4D6B84C36EA4}" type="sibTrans" cxnId="{0A0CF701-79B2-47F2-8622-FC36046D2926}">
      <dgm:prSet/>
      <dgm:spPr/>
      <dgm:t>
        <a:bodyPr/>
        <a:lstStyle/>
        <a:p>
          <a:endParaRPr lang="de-DE" sz="2000"/>
        </a:p>
      </dgm:t>
    </dgm:pt>
    <dgm:pt modelId="{26FE1203-5ADF-4E90-A8D9-0247D9F49394}">
      <dgm:prSet phldrT="[Text]" custT="1"/>
      <dgm:spPr/>
      <dgm:t>
        <a:bodyPr/>
        <a:lstStyle/>
        <a:p>
          <a:r>
            <a:rPr lang="de-DE" sz="1200">
              <a:latin typeface="Times New Roman" panose="02020603050405020304" pitchFamily="18" charset="0"/>
              <a:cs typeface="Times New Roman" panose="02020603050405020304" pitchFamily="18" charset="0"/>
            </a:rPr>
            <a:t>Symptoms</a:t>
          </a:r>
        </a:p>
      </dgm:t>
    </dgm:pt>
    <dgm:pt modelId="{07D04FA9-5869-4D23-B691-B49B006E8BC9}" type="parTrans" cxnId="{36599623-182A-480E-BBAC-966ED1CF3002}">
      <dgm:prSet custT="1"/>
      <dgm:spPr/>
      <dgm:t>
        <a:bodyPr/>
        <a:lstStyle/>
        <a:p>
          <a:endParaRPr lang="de-DE" sz="110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A7D50C71-D674-4373-B823-7229A869B85A}" type="sibTrans" cxnId="{36599623-182A-480E-BBAC-966ED1CF3002}">
      <dgm:prSet/>
      <dgm:spPr/>
      <dgm:t>
        <a:bodyPr/>
        <a:lstStyle/>
        <a:p>
          <a:endParaRPr lang="de-DE" sz="2000"/>
        </a:p>
      </dgm:t>
    </dgm:pt>
    <dgm:pt modelId="{9EEC29B6-B262-48C2-8C7F-8D2337E7AA42}">
      <dgm:prSet phldrT="[Text]" custT="1"/>
      <dgm:spPr/>
      <dgm:t>
        <a:bodyPr/>
        <a:lstStyle/>
        <a:p>
          <a:r>
            <a:rPr lang="de-DE" sz="1200" err="1">
              <a:latin typeface="Times New Roman" panose="02020603050405020304" pitchFamily="18" charset="0"/>
              <a:cs typeface="Times New Roman" panose="02020603050405020304" pitchFamily="18" charset="0"/>
            </a:rPr>
            <a:t>Asymptomatic</a:t>
          </a:r>
          <a:endParaRPr lang="de-DE" sz="120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BE23815E-A548-4C9A-9302-6B0219BE53D6}" type="parTrans" cxnId="{9CEDC11C-136F-41B2-8B1A-7F65506AA089}">
      <dgm:prSet custT="1"/>
      <dgm:spPr/>
      <dgm:t>
        <a:bodyPr/>
        <a:lstStyle/>
        <a:p>
          <a:endParaRPr lang="de-DE" sz="110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41B53EC5-CB3D-457D-A5B5-3DED8454A648}" type="sibTrans" cxnId="{9CEDC11C-136F-41B2-8B1A-7F65506AA089}">
      <dgm:prSet/>
      <dgm:spPr/>
      <dgm:t>
        <a:bodyPr/>
        <a:lstStyle/>
        <a:p>
          <a:endParaRPr lang="de-DE" sz="2000"/>
        </a:p>
      </dgm:t>
    </dgm:pt>
    <dgm:pt modelId="{99F805CD-8B05-4B09-8106-E7D62662EFAB}">
      <dgm:prSet phldrT="[Text]" custT="1"/>
      <dgm:spPr/>
      <dgm:t>
        <a:bodyPr/>
        <a:lstStyle/>
        <a:p>
          <a:r>
            <a:rPr lang="de-DE" sz="1200" err="1">
              <a:latin typeface="Times New Roman" panose="02020603050405020304" pitchFamily="18" charset="0"/>
              <a:cs typeface="Times New Roman" panose="02020603050405020304" pitchFamily="18" charset="0"/>
            </a:rPr>
            <a:t>Presymptomatic</a:t>
          </a:r>
          <a:endParaRPr lang="de-DE" sz="120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E8E96543-F299-474B-9FCF-7801EFC57576}" type="parTrans" cxnId="{11A3DC8E-FF1F-4699-9A3B-B670663B4676}">
      <dgm:prSet custT="1"/>
      <dgm:spPr/>
      <dgm:t>
        <a:bodyPr/>
        <a:lstStyle/>
        <a:p>
          <a:endParaRPr lang="de-DE" sz="110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D7B2BED0-5F36-4662-A45B-3AF98D5317EC}" type="sibTrans" cxnId="{11A3DC8E-FF1F-4699-9A3B-B670663B4676}">
      <dgm:prSet/>
      <dgm:spPr/>
      <dgm:t>
        <a:bodyPr/>
        <a:lstStyle/>
        <a:p>
          <a:endParaRPr lang="de-DE" sz="2000"/>
        </a:p>
      </dgm:t>
    </dgm:pt>
    <dgm:pt modelId="{518E9C13-B9BA-4F04-A7EC-F36C8D246639}">
      <dgm:prSet phldrT="[Text]" custT="1"/>
      <dgm:spPr/>
      <dgm:t>
        <a:bodyPr/>
        <a:lstStyle/>
        <a:p>
          <a:r>
            <a:rPr lang="de-DE" sz="1200" dirty="0" err="1">
              <a:latin typeface="Times New Roman" panose="02020603050405020304" pitchFamily="18" charset="0"/>
              <a:cs typeface="Times New Roman" panose="02020603050405020304" pitchFamily="18" charset="0"/>
            </a:rPr>
            <a:t>Means</a:t>
          </a:r>
          <a:r>
            <a:rPr lang="de-DE" sz="1200" dirty="0">
              <a:latin typeface="Times New Roman" panose="02020603050405020304" pitchFamily="18" charset="0"/>
              <a:cs typeface="Times New Roman" panose="02020603050405020304" pitchFamily="18" charset="0"/>
            </a:rPr>
            <a:t> of </a:t>
          </a:r>
          <a:r>
            <a:rPr lang="de-DE" sz="1200" dirty="0" err="1">
              <a:latin typeface="Times New Roman" panose="02020603050405020304" pitchFamily="18" charset="0"/>
              <a:cs typeface="Times New Roman" panose="02020603050405020304" pitchFamily="18" charset="0"/>
            </a:rPr>
            <a:t>transmission</a:t>
          </a:r>
          <a:endParaRPr lang="de-DE" sz="1200" dirty="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FB410C4C-ACA6-43C1-94D1-C7A844E0F3B3}" type="parTrans" cxnId="{9386AE0E-2F7B-4B2D-A2A0-8ED89691D55E}">
      <dgm:prSet custT="1"/>
      <dgm:spPr/>
      <dgm:t>
        <a:bodyPr/>
        <a:lstStyle/>
        <a:p>
          <a:endParaRPr lang="de-DE" sz="110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5BB641B2-739A-4F95-9858-A0BD6DA4CF4F}" type="sibTrans" cxnId="{9386AE0E-2F7B-4B2D-A2A0-8ED89691D55E}">
      <dgm:prSet/>
      <dgm:spPr/>
      <dgm:t>
        <a:bodyPr/>
        <a:lstStyle/>
        <a:p>
          <a:endParaRPr lang="de-DE" sz="2000"/>
        </a:p>
      </dgm:t>
    </dgm:pt>
    <dgm:pt modelId="{109BE932-8DDB-46FE-93F1-0C28F0100D1E}">
      <dgm:prSet phldrT="[Text]" custT="1"/>
      <dgm:spPr/>
      <dgm:t>
        <a:bodyPr/>
        <a:lstStyle/>
        <a:p>
          <a:r>
            <a:rPr lang="de-DE" sz="1200" err="1">
              <a:latin typeface="Times New Roman" panose="02020603050405020304" pitchFamily="18" charset="0"/>
              <a:cs typeface="Times New Roman" panose="02020603050405020304" pitchFamily="18" charset="0"/>
            </a:rPr>
            <a:t>Protection</a:t>
          </a:r>
          <a:r>
            <a:rPr lang="de-DE" sz="1200">
              <a:latin typeface="Times New Roman" panose="02020603050405020304" pitchFamily="18" charset="0"/>
              <a:cs typeface="Times New Roman" panose="02020603050405020304" pitchFamily="18" charset="0"/>
            </a:rPr>
            <a:t> </a:t>
          </a:r>
          <a:r>
            <a:rPr lang="de-DE" sz="1200" err="1">
              <a:latin typeface="Times New Roman" panose="02020603050405020304" pitchFamily="18" charset="0"/>
              <a:cs typeface="Times New Roman" panose="02020603050405020304" pitchFamily="18" charset="0"/>
            </a:rPr>
            <a:t>from</a:t>
          </a:r>
          <a:r>
            <a:rPr lang="de-DE" sz="1200">
              <a:latin typeface="Times New Roman" panose="02020603050405020304" pitchFamily="18" charset="0"/>
              <a:cs typeface="Times New Roman" panose="02020603050405020304" pitchFamily="18" charset="0"/>
            </a:rPr>
            <a:t> </a:t>
          </a:r>
          <a:r>
            <a:rPr lang="de-DE" sz="1200" err="1">
              <a:latin typeface="Times New Roman" panose="02020603050405020304" pitchFamily="18" charset="0"/>
              <a:cs typeface="Times New Roman" panose="02020603050405020304" pitchFamily="18" charset="0"/>
            </a:rPr>
            <a:t>transmission</a:t>
          </a:r>
          <a:endParaRPr lang="de-DE" sz="120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6F25122C-9DC2-4635-960D-7ABCFA19A050}" type="parTrans" cxnId="{0292F002-650B-49D0-AE03-C8DDF4B97AC1}">
      <dgm:prSet custT="1"/>
      <dgm:spPr/>
      <dgm:t>
        <a:bodyPr/>
        <a:lstStyle/>
        <a:p>
          <a:endParaRPr lang="de-DE" sz="110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A744AE17-7DC2-4DEE-8DD3-48BA06300DB6}" type="sibTrans" cxnId="{0292F002-650B-49D0-AE03-C8DDF4B97AC1}">
      <dgm:prSet/>
      <dgm:spPr/>
      <dgm:t>
        <a:bodyPr/>
        <a:lstStyle/>
        <a:p>
          <a:endParaRPr lang="de-DE" sz="2000"/>
        </a:p>
      </dgm:t>
    </dgm:pt>
    <dgm:pt modelId="{F4B2B415-9F5D-4A5C-A517-33028F9EDE23}">
      <dgm:prSet phldrT="[Text]" custT="1"/>
      <dgm:spPr/>
      <dgm:t>
        <a:bodyPr/>
        <a:lstStyle/>
        <a:p>
          <a:r>
            <a:rPr lang="de-DE" sz="1200">
              <a:latin typeface="Times New Roman" panose="02020603050405020304" pitchFamily="18" charset="0"/>
              <a:cs typeface="Times New Roman" panose="02020603050405020304" pitchFamily="18" charset="0"/>
            </a:rPr>
            <a:t>Risk</a:t>
          </a:r>
        </a:p>
      </dgm:t>
    </dgm:pt>
    <dgm:pt modelId="{C6A0CEB6-9E0F-4493-8DE5-DBE1EBED4241}" type="parTrans" cxnId="{CFBC75B3-6B2D-492A-9E29-EDE294FDB12A}">
      <dgm:prSet custT="1"/>
      <dgm:spPr/>
      <dgm:t>
        <a:bodyPr/>
        <a:lstStyle/>
        <a:p>
          <a:endParaRPr lang="de-DE" sz="110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5F9517A7-3764-4E96-8F05-51C754E9941B}" type="sibTrans" cxnId="{CFBC75B3-6B2D-492A-9E29-EDE294FDB12A}">
      <dgm:prSet/>
      <dgm:spPr/>
      <dgm:t>
        <a:bodyPr/>
        <a:lstStyle/>
        <a:p>
          <a:endParaRPr lang="de-DE" sz="2000"/>
        </a:p>
      </dgm:t>
    </dgm:pt>
    <dgm:pt modelId="{1BB53B11-3670-415B-805A-CE32EE8357FF}">
      <dgm:prSet phldrT="[Text]" custT="1"/>
      <dgm:spPr/>
      <dgm:t>
        <a:bodyPr/>
        <a:lstStyle/>
        <a:p>
          <a:r>
            <a:rPr lang="de-DE" sz="1200">
              <a:latin typeface="Times New Roman" panose="02020603050405020304" pitchFamily="18" charset="0"/>
              <a:cs typeface="Times New Roman" panose="02020603050405020304" pitchFamily="18" charset="0"/>
            </a:rPr>
            <a:t>Underlying </a:t>
          </a:r>
          <a:r>
            <a:rPr lang="de-DE" sz="1200" err="1">
              <a:latin typeface="Times New Roman" panose="02020603050405020304" pitchFamily="18" charset="0"/>
              <a:cs typeface="Times New Roman" panose="02020603050405020304" pitchFamily="18" charset="0"/>
            </a:rPr>
            <a:t>conditions</a:t>
          </a:r>
          <a:endParaRPr lang="de-DE" sz="120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CA6A9C70-223C-4BA6-B22F-E7EE9FCEF901}" type="parTrans" cxnId="{E657CA68-7262-414C-8915-DA2904315788}">
      <dgm:prSet custT="1"/>
      <dgm:spPr/>
      <dgm:t>
        <a:bodyPr/>
        <a:lstStyle/>
        <a:p>
          <a:endParaRPr lang="de-DE" sz="110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15B10DEE-88A1-4399-88DF-14098CAE15AD}" type="sibTrans" cxnId="{E657CA68-7262-414C-8915-DA2904315788}">
      <dgm:prSet/>
      <dgm:spPr/>
      <dgm:t>
        <a:bodyPr/>
        <a:lstStyle/>
        <a:p>
          <a:endParaRPr lang="de-DE" sz="2000"/>
        </a:p>
      </dgm:t>
    </dgm:pt>
    <dgm:pt modelId="{E2EBA384-91D3-4018-9EF6-F6F2CD249D13}">
      <dgm:prSet phldrT="[Text]" custT="1"/>
      <dgm:spPr/>
      <dgm:t>
        <a:bodyPr/>
        <a:lstStyle/>
        <a:p>
          <a:r>
            <a:rPr lang="de-DE" sz="1200">
              <a:latin typeface="Times New Roman" panose="02020603050405020304" pitchFamily="18" charset="0"/>
              <a:cs typeface="Times New Roman" panose="02020603050405020304" pitchFamily="18" charset="0"/>
            </a:rPr>
            <a:t>Age</a:t>
          </a:r>
        </a:p>
      </dgm:t>
    </dgm:pt>
    <dgm:pt modelId="{6CF7CD4C-0917-44C0-B3FE-FDC2C5B2A919}" type="parTrans" cxnId="{BD8AFAFB-6827-47A4-BEE6-B7BD500A967C}">
      <dgm:prSet custT="1"/>
      <dgm:spPr/>
      <dgm:t>
        <a:bodyPr/>
        <a:lstStyle/>
        <a:p>
          <a:endParaRPr lang="de-DE" sz="110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DEA0B624-4869-47B4-804B-98EC11BA11B7}" type="sibTrans" cxnId="{BD8AFAFB-6827-47A4-BEE6-B7BD500A967C}">
      <dgm:prSet/>
      <dgm:spPr/>
      <dgm:t>
        <a:bodyPr/>
        <a:lstStyle/>
        <a:p>
          <a:endParaRPr lang="de-DE" sz="2000"/>
        </a:p>
      </dgm:t>
    </dgm:pt>
    <dgm:pt modelId="{CE4A4217-0410-4729-9337-C36C75DD601B}">
      <dgm:prSet phldrT="[Text]" custT="1"/>
      <dgm:spPr/>
      <dgm:t>
        <a:bodyPr/>
        <a:lstStyle/>
        <a:p>
          <a:r>
            <a:rPr lang="de-DE" sz="1200">
              <a:latin typeface="Times New Roman" panose="02020603050405020304" pitchFamily="18" charset="0"/>
              <a:cs typeface="Times New Roman" panose="02020603050405020304" pitchFamily="18" charset="0"/>
            </a:rPr>
            <a:t>Sex</a:t>
          </a:r>
        </a:p>
      </dgm:t>
    </dgm:pt>
    <dgm:pt modelId="{539788D9-F5CD-499B-8EFE-4BDF10193421}" type="parTrans" cxnId="{B3F5674A-4402-4EB3-AE33-BA190C5A46B8}">
      <dgm:prSet custT="1"/>
      <dgm:spPr/>
      <dgm:t>
        <a:bodyPr/>
        <a:lstStyle/>
        <a:p>
          <a:endParaRPr lang="de-DE" sz="110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1D71D8A5-0DC5-4C1F-8009-4A0D76746D08}" type="sibTrans" cxnId="{B3F5674A-4402-4EB3-AE33-BA190C5A46B8}">
      <dgm:prSet/>
      <dgm:spPr/>
      <dgm:t>
        <a:bodyPr/>
        <a:lstStyle/>
        <a:p>
          <a:endParaRPr lang="de-DE" sz="2000"/>
        </a:p>
      </dgm:t>
    </dgm:pt>
    <dgm:pt modelId="{359B501C-2EC2-4B8C-BD62-7A96D0CFC1AF}">
      <dgm:prSet phldrT="[Text]" custT="1"/>
      <dgm:spPr/>
      <dgm:t>
        <a:bodyPr/>
        <a:lstStyle/>
        <a:p>
          <a:r>
            <a:rPr lang="de-DE" sz="1200">
              <a:latin typeface="Times New Roman" panose="02020603050405020304" pitchFamily="18" charset="0"/>
              <a:cs typeface="Times New Roman" panose="02020603050405020304" pitchFamily="18" charset="0"/>
            </a:rPr>
            <a:t>Vulnerable </a:t>
          </a:r>
          <a:r>
            <a:rPr lang="de-DE" sz="1200" err="1">
              <a:latin typeface="Times New Roman" panose="02020603050405020304" pitchFamily="18" charset="0"/>
              <a:cs typeface="Times New Roman" panose="02020603050405020304" pitchFamily="18" charset="0"/>
            </a:rPr>
            <a:t>people</a:t>
          </a:r>
          <a:endParaRPr lang="de-DE" sz="120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8F1E2ECC-9C8C-4137-9CC2-148EC633E965}" type="parTrans" cxnId="{176A946C-5CA5-4F20-9515-6CFF3244107D}">
      <dgm:prSet custT="1"/>
      <dgm:spPr/>
      <dgm:t>
        <a:bodyPr/>
        <a:lstStyle/>
        <a:p>
          <a:endParaRPr lang="de-DE" sz="110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215BF104-439D-4F69-8669-82DF0A50A615}" type="sibTrans" cxnId="{176A946C-5CA5-4F20-9515-6CFF3244107D}">
      <dgm:prSet/>
      <dgm:spPr/>
      <dgm:t>
        <a:bodyPr/>
        <a:lstStyle/>
        <a:p>
          <a:endParaRPr lang="de-DE" sz="2000"/>
        </a:p>
      </dgm:t>
    </dgm:pt>
    <dgm:pt modelId="{9A5197BB-7B1D-4DC8-A917-46D969DA792E}">
      <dgm:prSet phldrT="[Text]" custT="1"/>
      <dgm:spPr/>
      <dgm:t>
        <a:bodyPr/>
        <a:lstStyle/>
        <a:p>
          <a:r>
            <a:rPr lang="de-DE" sz="1200" err="1">
              <a:latin typeface="Times New Roman" panose="02020603050405020304" pitchFamily="18" charset="0"/>
              <a:cs typeface="Times New Roman" panose="02020603050405020304" pitchFamily="18" charset="0"/>
            </a:rPr>
            <a:t>Confirmed</a:t>
          </a:r>
          <a:endParaRPr lang="de-DE" sz="120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03C2E030-813C-4887-94E5-82269C93F63C}" type="parTrans" cxnId="{94199405-C4AF-4981-BB8E-1CD2D5B12077}">
      <dgm:prSet custT="1"/>
      <dgm:spPr/>
      <dgm:t>
        <a:bodyPr/>
        <a:lstStyle/>
        <a:p>
          <a:endParaRPr lang="de-DE" sz="110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A996E5A6-72C3-45F3-B265-EB01532B76AD}" type="sibTrans" cxnId="{94199405-C4AF-4981-BB8E-1CD2D5B12077}">
      <dgm:prSet/>
      <dgm:spPr/>
      <dgm:t>
        <a:bodyPr/>
        <a:lstStyle/>
        <a:p>
          <a:endParaRPr lang="de-DE" sz="2000"/>
        </a:p>
      </dgm:t>
    </dgm:pt>
    <dgm:pt modelId="{2F02F2CE-1BCD-446E-BECB-6973E7ACA9E4}">
      <dgm:prSet phldrT="[Text]" custT="1"/>
      <dgm:spPr/>
      <dgm:t>
        <a:bodyPr/>
        <a:lstStyle/>
        <a:p>
          <a:r>
            <a:rPr lang="de-DE" sz="1200">
              <a:latin typeface="Times New Roman" panose="02020603050405020304" pitchFamily="18" charset="0"/>
              <a:cs typeface="Times New Roman" panose="02020603050405020304" pitchFamily="18" charset="0"/>
            </a:rPr>
            <a:t>Other</a:t>
          </a:r>
        </a:p>
      </dgm:t>
    </dgm:pt>
    <dgm:pt modelId="{D40E33C4-65A6-43F0-8A5A-668871AD40F3}" type="parTrans" cxnId="{DB66B812-E1E0-45FC-BB26-4974FD34809F}">
      <dgm:prSet custT="1"/>
      <dgm:spPr/>
      <dgm:t>
        <a:bodyPr/>
        <a:lstStyle/>
        <a:p>
          <a:endParaRPr lang="de-DE" sz="110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D22232FC-EFFC-4ED5-BFEA-E170EC048C0E}" type="sibTrans" cxnId="{DB66B812-E1E0-45FC-BB26-4974FD34809F}">
      <dgm:prSet/>
      <dgm:spPr/>
      <dgm:t>
        <a:bodyPr/>
        <a:lstStyle/>
        <a:p>
          <a:endParaRPr lang="de-DE" sz="2000"/>
        </a:p>
      </dgm:t>
    </dgm:pt>
    <dgm:pt modelId="{3CF53495-E7A9-4FFB-983F-8FC85A5AADF1}">
      <dgm:prSet phldrT="[Text]" custT="1"/>
      <dgm:spPr/>
      <dgm:t>
        <a:bodyPr/>
        <a:lstStyle/>
        <a:p>
          <a:r>
            <a:rPr lang="de-DE" sz="1200" err="1">
              <a:latin typeface="Times New Roman" panose="02020603050405020304" pitchFamily="18" charset="0"/>
              <a:cs typeface="Times New Roman" panose="02020603050405020304" pitchFamily="18" charset="0"/>
            </a:rPr>
            <a:t>Current</a:t>
          </a:r>
          <a:r>
            <a:rPr lang="de-DE" sz="1200">
              <a:latin typeface="Times New Roman" panose="02020603050405020304" pitchFamily="18" charset="0"/>
              <a:cs typeface="Times New Roman" panose="02020603050405020304" pitchFamily="18" charset="0"/>
            </a:rPr>
            <a:t> </a:t>
          </a:r>
          <a:r>
            <a:rPr lang="de-DE" sz="1200" err="1">
              <a:latin typeface="Times New Roman" panose="02020603050405020304" pitchFamily="18" charset="0"/>
              <a:cs typeface="Times New Roman" panose="02020603050405020304" pitchFamily="18" charset="0"/>
            </a:rPr>
            <a:t>treatment</a:t>
          </a:r>
          <a:endParaRPr lang="de-DE" sz="120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96C75850-7C10-4A02-8605-049A49CD2E2D}" type="parTrans" cxnId="{28926F01-4C50-42E8-B91C-EB4AB276390F}">
      <dgm:prSet custT="1"/>
      <dgm:spPr/>
      <dgm:t>
        <a:bodyPr/>
        <a:lstStyle/>
        <a:p>
          <a:endParaRPr lang="de-DE" sz="110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D9F24578-11A8-4686-B575-3BEBFF1584D9}" type="sibTrans" cxnId="{28926F01-4C50-42E8-B91C-EB4AB276390F}">
      <dgm:prSet/>
      <dgm:spPr/>
      <dgm:t>
        <a:bodyPr/>
        <a:lstStyle/>
        <a:p>
          <a:endParaRPr lang="de-DE" sz="2000"/>
        </a:p>
      </dgm:t>
    </dgm:pt>
    <dgm:pt modelId="{B9C65307-6730-4D84-A9EC-F5E07D061332}">
      <dgm:prSet phldrT="[Text]" custT="1"/>
      <dgm:spPr/>
      <dgm:t>
        <a:bodyPr/>
        <a:lstStyle/>
        <a:p>
          <a:r>
            <a:rPr lang="de-DE" sz="1200">
              <a:latin typeface="Times New Roman" panose="02020603050405020304" pitchFamily="18" charset="0"/>
              <a:cs typeface="Times New Roman" panose="02020603050405020304" pitchFamily="18" charset="0"/>
            </a:rPr>
            <a:t>Research and </a:t>
          </a:r>
          <a:r>
            <a:rPr lang="de-DE" sz="1200" err="1">
              <a:latin typeface="Times New Roman" panose="02020603050405020304" pitchFamily="18" charset="0"/>
              <a:cs typeface="Times New Roman" panose="02020603050405020304" pitchFamily="18" charset="0"/>
            </a:rPr>
            <a:t>development</a:t>
          </a:r>
          <a:endParaRPr lang="de-DE" sz="120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72696429-0052-4BF2-A3D6-BBDE6FE074F3}" type="parTrans" cxnId="{A348F95E-EC39-4B0A-B118-7067A75674BE}">
      <dgm:prSet custT="1"/>
      <dgm:spPr/>
      <dgm:t>
        <a:bodyPr/>
        <a:lstStyle/>
        <a:p>
          <a:endParaRPr lang="de-DE" sz="110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335D4C02-6620-4C99-B00C-8D1A5C8FA344}" type="sibTrans" cxnId="{A348F95E-EC39-4B0A-B118-7067A75674BE}">
      <dgm:prSet/>
      <dgm:spPr/>
      <dgm:t>
        <a:bodyPr/>
        <a:lstStyle/>
        <a:p>
          <a:endParaRPr lang="de-DE" sz="2000"/>
        </a:p>
      </dgm:t>
    </dgm:pt>
    <dgm:pt modelId="{3E305254-2A1B-4466-9716-16D92D48BD39}">
      <dgm:prSet phldrT="[Text]" custT="1"/>
      <dgm:spPr/>
      <dgm:t>
        <a:bodyPr/>
        <a:lstStyle/>
        <a:p>
          <a:r>
            <a:rPr lang="de-DE" sz="1200" err="1">
              <a:latin typeface="Times New Roman" panose="02020603050405020304" pitchFamily="18" charset="0"/>
              <a:cs typeface="Times New Roman" panose="02020603050405020304" pitchFamily="18" charset="0"/>
            </a:rPr>
            <a:t>Nonproven</a:t>
          </a:r>
          <a:r>
            <a:rPr lang="de-DE" sz="1200">
              <a:latin typeface="Times New Roman" panose="02020603050405020304" pitchFamily="18" charset="0"/>
              <a:cs typeface="Times New Roman" panose="02020603050405020304" pitchFamily="18" charset="0"/>
            </a:rPr>
            <a:t> </a:t>
          </a:r>
          <a:r>
            <a:rPr lang="de-DE" sz="1200" err="1">
              <a:latin typeface="Times New Roman" panose="02020603050405020304" pitchFamily="18" charset="0"/>
              <a:cs typeface="Times New Roman" panose="02020603050405020304" pitchFamily="18" charset="0"/>
            </a:rPr>
            <a:t>treatment</a:t>
          </a:r>
          <a:endParaRPr lang="de-DE" sz="120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5E84A072-2EA0-45DE-B57C-DA217CA13318}" type="parTrans" cxnId="{8E7AB9D7-5E84-44E1-B1AE-52F3EA136985}">
      <dgm:prSet custT="1"/>
      <dgm:spPr/>
      <dgm:t>
        <a:bodyPr/>
        <a:lstStyle/>
        <a:p>
          <a:endParaRPr lang="de-DE" sz="110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28E68593-7507-41E2-BA36-8D5C9263D978}" type="sibTrans" cxnId="{8E7AB9D7-5E84-44E1-B1AE-52F3EA136985}">
      <dgm:prSet/>
      <dgm:spPr/>
      <dgm:t>
        <a:bodyPr/>
        <a:lstStyle/>
        <a:p>
          <a:endParaRPr lang="de-DE" sz="2000"/>
        </a:p>
      </dgm:t>
    </dgm:pt>
    <dgm:pt modelId="{AB141E1E-8A47-473D-BDC9-A740AE0EA3F7}">
      <dgm:prSet phldrT="[Text]" custT="1"/>
      <dgm:spPr/>
      <dgm:t>
        <a:bodyPr/>
        <a:lstStyle/>
        <a:p>
          <a:r>
            <a:rPr lang="de-DE" sz="1200">
              <a:latin typeface="Times New Roman" panose="02020603050405020304" pitchFamily="18" charset="0"/>
              <a:cs typeface="Times New Roman" panose="02020603050405020304" pitchFamily="18" charset="0"/>
            </a:rPr>
            <a:t>Treatment </a:t>
          </a:r>
          <a:r>
            <a:rPr lang="de-DE" sz="1200" err="1">
              <a:latin typeface="Times New Roman" panose="02020603050405020304" pitchFamily="18" charset="0"/>
              <a:cs typeface="Times New Roman" panose="02020603050405020304" pitchFamily="18" charset="0"/>
            </a:rPr>
            <a:t>myths</a:t>
          </a:r>
          <a:endParaRPr lang="de-DE" sz="120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1930F7C4-5EB2-4BFC-B652-6F6645AD8029}" type="parTrans" cxnId="{1934D0CF-1E8D-4B17-B666-0C945913728B}">
      <dgm:prSet custT="1"/>
      <dgm:spPr/>
      <dgm:t>
        <a:bodyPr/>
        <a:lstStyle/>
        <a:p>
          <a:endParaRPr lang="de-DE" sz="110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91192A3F-4210-4580-A1AE-30F1DDACAD26}" type="sibTrans" cxnId="{1934D0CF-1E8D-4B17-B666-0C945913728B}">
      <dgm:prSet/>
      <dgm:spPr/>
      <dgm:t>
        <a:bodyPr/>
        <a:lstStyle/>
        <a:p>
          <a:endParaRPr lang="de-DE" sz="2000"/>
        </a:p>
      </dgm:t>
    </dgm:pt>
    <dgm:pt modelId="{B8C47AF5-72F4-4882-A03A-756E7DB0314D}">
      <dgm:prSet phldrT="[Text]" custT="1"/>
      <dgm:spPr/>
      <dgm:t>
        <a:bodyPr/>
        <a:lstStyle/>
        <a:p>
          <a:r>
            <a:rPr lang="de-DE" sz="1200" err="1">
              <a:latin typeface="Times New Roman" panose="02020603050405020304" pitchFamily="18" charset="0"/>
              <a:cs typeface="Times New Roman" panose="02020603050405020304" pitchFamily="18" charset="0"/>
            </a:rPr>
            <a:t>Testing</a:t>
          </a:r>
          <a:endParaRPr lang="de-DE" sz="120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CEA4C598-03BA-4196-8096-D8D9940A747B}" type="parTrans" cxnId="{4A2C5E67-8424-4571-BB23-BA2ECA3579FA}">
      <dgm:prSet custT="1"/>
      <dgm:spPr/>
      <dgm:t>
        <a:bodyPr/>
        <a:lstStyle/>
        <a:p>
          <a:endParaRPr lang="de-DE" sz="110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EC6E509A-E8EC-47FA-9CF3-59C646F77411}" type="sibTrans" cxnId="{4A2C5E67-8424-4571-BB23-BA2ECA3579FA}">
      <dgm:prSet/>
      <dgm:spPr/>
      <dgm:t>
        <a:bodyPr/>
        <a:lstStyle/>
        <a:p>
          <a:endParaRPr lang="de-DE" sz="2000"/>
        </a:p>
      </dgm:t>
    </dgm:pt>
    <dgm:pt modelId="{3B6E185B-6A1C-411C-B39C-F27A6010733C}">
      <dgm:prSet phldrT="[Text]" custT="1"/>
      <dgm:spPr/>
      <dgm:t>
        <a:bodyPr/>
        <a:lstStyle/>
        <a:p>
          <a:r>
            <a:rPr lang="de-DE" sz="1200">
              <a:latin typeface="Times New Roman" panose="02020603050405020304" pitchFamily="18" charset="0"/>
              <a:cs typeface="Times New Roman" panose="02020603050405020304" pitchFamily="18" charset="0"/>
            </a:rPr>
            <a:t>Supportive care</a:t>
          </a:r>
        </a:p>
      </dgm:t>
    </dgm:pt>
    <dgm:pt modelId="{C1EACDD7-D989-416D-9681-817FEB9BF90B}" type="parTrans" cxnId="{31AD32E1-C5F3-41E2-8A34-FBA4D83488DD}">
      <dgm:prSet custT="1"/>
      <dgm:spPr/>
      <dgm:t>
        <a:bodyPr/>
        <a:lstStyle/>
        <a:p>
          <a:endParaRPr lang="de-DE" sz="110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9A34BB95-B186-435B-AAA0-ED02B3A2EB5F}" type="sibTrans" cxnId="{31AD32E1-C5F3-41E2-8A34-FBA4D83488DD}">
      <dgm:prSet/>
      <dgm:spPr/>
      <dgm:t>
        <a:bodyPr/>
        <a:lstStyle/>
        <a:p>
          <a:endParaRPr lang="de-DE" sz="2000"/>
        </a:p>
      </dgm:t>
    </dgm:pt>
    <dgm:pt modelId="{0EF4F3AF-041E-4FDF-983F-FF187C733655}">
      <dgm:prSet phldrT="[Text]" custT="1"/>
      <dgm:spPr/>
      <dgm:t>
        <a:bodyPr/>
        <a:lstStyle/>
        <a:p>
          <a:r>
            <a:rPr lang="de-DE" sz="1200" dirty="0">
              <a:latin typeface="Times New Roman" panose="02020603050405020304" pitchFamily="18" charset="0"/>
              <a:cs typeface="Times New Roman" panose="02020603050405020304" pitchFamily="18" charset="0"/>
            </a:rPr>
            <a:t>Health care</a:t>
          </a:r>
        </a:p>
      </dgm:t>
    </dgm:pt>
    <dgm:pt modelId="{1A36E4A0-3C95-4A7E-8403-6FC00333987E}" type="parTrans" cxnId="{3160B13C-405E-4042-9A63-BD2CD7CB824F}">
      <dgm:prSet custT="1"/>
      <dgm:spPr/>
      <dgm:t>
        <a:bodyPr/>
        <a:lstStyle/>
        <a:p>
          <a:endParaRPr lang="de-DE" sz="110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F28EBEB7-D767-4F82-B6D2-883ABD1AD9BF}" type="sibTrans" cxnId="{3160B13C-405E-4042-9A63-BD2CD7CB824F}">
      <dgm:prSet/>
      <dgm:spPr/>
      <dgm:t>
        <a:bodyPr/>
        <a:lstStyle/>
        <a:p>
          <a:endParaRPr lang="de-DE" sz="2000"/>
        </a:p>
      </dgm:t>
    </dgm:pt>
    <dgm:pt modelId="{85CA1953-8DEE-44BB-BE58-B97A59C65C13}">
      <dgm:prSet phldrT="[Text]" custT="1"/>
      <dgm:spPr/>
      <dgm:t>
        <a:bodyPr/>
        <a:lstStyle/>
        <a:p>
          <a:r>
            <a:rPr lang="de-DE" sz="1200" dirty="0">
              <a:latin typeface="Times New Roman" panose="02020603050405020304" pitchFamily="18" charset="0"/>
              <a:cs typeface="Times New Roman" panose="02020603050405020304" pitchFamily="18" charset="0"/>
            </a:rPr>
            <a:t>Health care </a:t>
          </a:r>
          <a:r>
            <a:rPr lang="de-DE" sz="1200" dirty="0" err="1">
              <a:latin typeface="Times New Roman" panose="02020603050405020304" pitchFamily="18" charset="0"/>
              <a:cs typeface="Times New Roman" panose="02020603050405020304" pitchFamily="18" charset="0"/>
            </a:rPr>
            <a:t>equipment</a:t>
          </a:r>
          <a:endParaRPr lang="de-DE" sz="1200" dirty="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425A3179-1413-4460-9678-40448B2E5A42}" type="parTrans" cxnId="{A3337F8B-F6A7-4497-AF59-193A5BC380DA}">
      <dgm:prSet custT="1"/>
      <dgm:spPr/>
      <dgm:t>
        <a:bodyPr/>
        <a:lstStyle/>
        <a:p>
          <a:endParaRPr lang="de-DE" sz="110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80DB0B72-C4D4-4215-94FF-91C54AF93D83}" type="sibTrans" cxnId="{A3337F8B-F6A7-4497-AF59-193A5BC380DA}">
      <dgm:prSet/>
      <dgm:spPr/>
      <dgm:t>
        <a:bodyPr/>
        <a:lstStyle/>
        <a:p>
          <a:endParaRPr lang="de-DE" sz="2000"/>
        </a:p>
      </dgm:t>
    </dgm:pt>
    <dgm:pt modelId="{41D6EC2F-3103-40F0-AD9A-B96A94477A77}">
      <dgm:prSet phldrT="[Text]" custT="1"/>
      <dgm:spPr/>
      <dgm:t>
        <a:bodyPr/>
        <a:lstStyle/>
        <a:p>
          <a:r>
            <a:rPr lang="de-DE" sz="1200">
              <a:latin typeface="Times New Roman" panose="02020603050405020304" pitchFamily="18" charset="0"/>
              <a:cs typeface="Times New Roman" panose="02020603050405020304" pitchFamily="18" charset="0"/>
            </a:rPr>
            <a:t>Personal </a:t>
          </a:r>
          <a:r>
            <a:rPr lang="de-DE" sz="1200" err="1">
              <a:latin typeface="Times New Roman" panose="02020603050405020304" pitchFamily="18" charset="0"/>
              <a:cs typeface="Times New Roman" panose="02020603050405020304" pitchFamily="18" charset="0"/>
            </a:rPr>
            <a:t>measures</a:t>
          </a:r>
          <a:endParaRPr lang="de-DE" sz="120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21F29C5E-B439-428D-89D6-0B6C5058BC6D}" type="parTrans" cxnId="{4644454E-788A-4ECC-A1B6-1ECB4780A87E}">
      <dgm:prSet custT="1"/>
      <dgm:spPr/>
      <dgm:t>
        <a:bodyPr/>
        <a:lstStyle/>
        <a:p>
          <a:endParaRPr lang="de-DE" sz="110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6A310679-E6DA-4236-BE0A-D973336D0C61}" type="sibTrans" cxnId="{4644454E-788A-4ECC-A1B6-1ECB4780A87E}">
      <dgm:prSet/>
      <dgm:spPr/>
      <dgm:t>
        <a:bodyPr/>
        <a:lstStyle/>
        <a:p>
          <a:endParaRPr lang="de-DE" sz="2000"/>
        </a:p>
      </dgm:t>
    </dgm:pt>
    <dgm:pt modelId="{F576FE14-F223-4751-B256-BF313602C91E}">
      <dgm:prSet phldrT="[Text]" custT="1"/>
      <dgm:spPr/>
      <dgm:t>
        <a:bodyPr/>
        <a:lstStyle/>
        <a:p>
          <a:r>
            <a:rPr lang="de-DE" sz="1200" dirty="0" err="1">
              <a:latin typeface="Times New Roman" panose="02020603050405020304" pitchFamily="18" charset="0"/>
              <a:cs typeface="Times New Roman" panose="02020603050405020304" pitchFamily="18" charset="0"/>
            </a:rPr>
            <a:t>Measures</a:t>
          </a:r>
          <a:r>
            <a:rPr lang="de-DE" sz="1200" dirty="0">
              <a:latin typeface="Times New Roman" panose="02020603050405020304" pitchFamily="18" charset="0"/>
              <a:cs typeface="Times New Roman" panose="02020603050405020304" pitchFamily="18" charset="0"/>
            </a:rPr>
            <a:t> in public </a:t>
          </a:r>
          <a:r>
            <a:rPr lang="de-DE" sz="1200" dirty="0" err="1">
              <a:latin typeface="Times New Roman" panose="02020603050405020304" pitchFamily="18" charset="0"/>
              <a:cs typeface="Times New Roman" panose="02020603050405020304" pitchFamily="18" charset="0"/>
            </a:rPr>
            <a:t>settings</a:t>
          </a:r>
          <a:endParaRPr lang="de-DE" sz="1200" dirty="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760F7733-46EF-4539-A2FB-454CD8F95E50}" type="parTrans" cxnId="{22468D87-9E8B-4AC0-A1D8-F0624582D39C}">
      <dgm:prSet custT="1"/>
      <dgm:spPr/>
      <dgm:t>
        <a:bodyPr/>
        <a:lstStyle/>
        <a:p>
          <a:endParaRPr lang="de-DE" sz="110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014EF3D8-71ED-448E-95E6-C5CAB103F661}" type="sibTrans" cxnId="{22468D87-9E8B-4AC0-A1D8-F0624582D39C}">
      <dgm:prSet/>
      <dgm:spPr/>
      <dgm:t>
        <a:bodyPr/>
        <a:lstStyle/>
        <a:p>
          <a:endParaRPr lang="de-DE" sz="2000"/>
        </a:p>
      </dgm:t>
    </dgm:pt>
    <dgm:pt modelId="{B18AAAC7-07A3-44B8-A053-45D1FF816FFD}">
      <dgm:prSet phldrT="[Text]" custT="1"/>
      <dgm:spPr/>
      <dgm:t>
        <a:bodyPr/>
        <a:lstStyle/>
        <a:p>
          <a:r>
            <a:rPr lang="de-DE" sz="1200" dirty="0" err="1">
              <a:latin typeface="Times New Roman" panose="02020603050405020304" pitchFamily="18" charset="0"/>
              <a:cs typeface="Times New Roman" panose="02020603050405020304" pitchFamily="18" charset="0"/>
            </a:rPr>
            <a:t>Reduction</a:t>
          </a:r>
          <a:r>
            <a:rPr lang="de-DE" sz="1200" dirty="0">
              <a:latin typeface="Times New Roman" panose="02020603050405020304" pitchFamily="18" charset="0"/>
              <a:cs typeface="Times New Roman" panose="02020603050405020304" pitchFamily="18" charset="0"/>
            </a:rPr>
            <a:t> of </a:t>
          </a:r>
          <a:r>
            <a:rPr lang="de-DE" sz="1200" dirty="0" err="1">
              <a:latin typeface="Times New Roman" panose="02020603050405020304" pitchFamily="18" charset="0"/>
              <a:cs typeface="Times New Roman" panose="02020603050405020304" pitchFamily="18" charset="0"/>
            </a:rPr>
            <a:t>movement</a:t>
          </a:r>
          <a:endParaRPr lang="de-DE" sz="1200" dirty="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F79E2E4E-D09E-4761-9D42-D0B633170619}" type="parTrans" cxnId="{CF4E620A-9AD3-4C56-8996-7BC265D0C439}">
      <dgm:prSet custT="1"/>
      <dgm:spPr/>
      <dgm:t>
        <a:bodyPr/>
        <a:lstStyle/>
        <a:p>
          <a:endParaRPr lang="de-DE" sz="110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72E1387F-70BB-477C-B1AA-2ABCDA2AC2A1}" type="sibTrans" cxnId="{CF4E620A-9AD3-4C56-8996-7BC265D0C439}">
      <dgm:prSet/>
      <dgm:spPr/>
      <dgm:t>
        <a:bodyPr/>
        <a:lstStyle/>
        <a:p>
          <a:endParaRPr lang="de-DE" sz="2000"/>
        </a:p>
      </dgm:t>
    </dgm:pt>
    <dgm:pt modelId="{E7091F61-EB43-4F07-B67B-2EE2EED76652}">
      <dgm:prSet phldrT="[Text]" custT="1"/>
      <dgm:spPr/>
      <dgm:t>
        <a:bodyPr/>
        <a:lstStyle/>
        <a:p>
          <a:r>
            <a:rPr lang="de-DE" sz="1200" err="1">
              <a:latin typeface="Times New Roman" panose="02020603050405020304" pitchFamily="18" charset="0"/>
              <a:cs typeface="Times New Roman" panose="02020603050405020304" pitchFamily="18" charset="0"/>
            </a:rPr>
            <a:t>Protection</a:t>
          </a:r>
          <a:endParaRPr lang="de-DE" sz="120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010FD920-EA56-439A-976D-37845A8E9EE8}" type="parTrans" cxnId="{CAFAE303-3DC3-4537-9772-86B9E5063BC8}">
      <dgm:prSet custT="1"/>
      <dgm:spPr/>
      <dgm:t>
        <a:bodyPr/>
        <a:lstStyle/>
        <a:p>
          <a:endParaRPr lang="de-DE" sz="110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E9EE7CCA-3E70-4442-89A7-97C9D193AFA2}" type="sibTrans" cxnId="{CAFAE303-3DC3-4537-9772-86B9E5063BC8}">
      <dgm:prSet/>
      <dgm:spPr/>
      <dgm:t>
        <a:bodyPr/>
        <a:lstStyle/>
        <a:p>
          <a:endParaRPr lang="de-DE" sz="2000"/>
        </a:p>
      </dgm:t>
    </dgm:pt>
    <dgm:pt modelId="{8598F285-6469-41DF-8C80-D94935C42364}">
      <dgm:prSet phldrT="[Text]" custT="1"/>
      <dgm:spPr/>
      <dgm:t>
        <a:bodyPr/>
        <a:lstStyle/>
        <a:p>
          <a:r>
            <a:rPr lang="de-DE" sz="1200">
              <a:latin typeface="Times New Roman" panose="02020603050405020304" pitchFamily="18" charset="0"/>
              <a:cs typeface="Times New Roman" panose="02020603050405020304" pitchFamily="18" charset="0"/>
            </a:rPr>
            <a:t>Technology</a:t>
          </a:r>
        </a:p>
      </dgm:t>
    </dgm:pt>
    <dgm:pt modelId="{2F8F9AB3-8452-43EC-87B2-17B5891BF608}" type="parTrans" cxnId="{A6C878B9-EBF4-42CF-95ED-C5FEAC6D408F}">
      <dgm:prSet custT="1"/>
      <dgm:spPr/>
      <dgm:t>
        <a:bodyPr/>
        <a:lstStyle/>
        <a:p>
          <a:endParaRPr lang="de-DE" sz="110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9ED8CEDE-19AD-4186-9063-3C72CFA86202}" type="sibTrans" cxnId="{A6C878B9-EBF4-42CF-95ED-C5FEAC6D408F}">
      <dgm:prSet/>
      <dgm:spPr/>
      <dgm:t>
        <a:bodyPr/>
        <a:lstStyle/>
        <a:p>
          <a:endParaRPr lang="de-DE" sz="2000"/>
        </a:p>
      </dgm:t>
    </dgm:pt>
    <dgm:pt modelId="{C8881E16-4787-451C-81F6-A6E1C5F25824}">
      <dgm:prSet phldrT="[Text]" custT="1"/>
      <dgm:spPr/>
      <dgm:t>
        <a:bodyPr/>
        <a:lstStyle/>
        <a:p>
          <a:r>
            <a:rPr lang="de-DE" sz="1200">
              <a:latin typeface="Times New Roman" panose="02020603050405020304" pitchFamily="18" charset="0"/>
              <a:cs typeface="Times New Roman" panose="02020603050405020304" pitchFamily="18" charset="0"/>
            </a:rPr>
            <a:t>Faith</a:t>
          </a:r>
        </a:p>
      </dgm:t>
    </dgm:pt>
    <dgm:pt modelId="{AA6D12B2-DCA4-4A02-AF03-C8580B7BB7CB}" type="parTrans" cxnId="{05E2D8CA-3F04-43FA-A9A0-EFB380FF7C1A}">
      <dgm:prSet custT="1"/>
      <dgm:spPr/>
      <dgm:t>
        <a:bodyPr/>
        <a:lstStyle/>
        <a:p>
          <a:endParaRPr lang="de-DE" sz="110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69FD0CA8-8B7F-4C0A-B522-919D737E5030}" type="sibTrans" cxnId="{05E2D8CA-3F04-43FA-A9A0-EFB380FF7C1A}">
      <dgm:prSet/>
      <dgm:spPr/>
      <dgm:t>
        <a:bodyPr/>
        <a:lstStyle/>
        <a:p>
          <a:endParaRPr lang="de-DE" sz="2000"/>
        </a:p>
      </dgm:t>
    </dgm:pt>
    <dgm:pt modelId="{1AACD66D-838A-4857-A8DC-3EF6272EECE2}">
      <dgm:prSet phldrT="[Text]" custT="1"/>
      <dgm:spPr/>
      <dgm:t>
        <a:bodyPr/>
        <a:lstStyle/>
        <a:p>
          <a:r>
            <a:rPr lang="de-DE" sz="1200" err="1">
              <a:latin typeface="Times New Roman" panose="02020603050405020304" pitchFamily="18" charset="0"/>
              <a:cs typeface="Times New Roman" panose="02020603050405020304" pitchFamily="18" charset="0"/>
            </a:rPr>
            <a:t>Unions</a:t>
          </a:r>
          <a:r>
            <a:rPr lang="de-DE" sz="1200" baseline="0">
              <a:latin typeface="Times New Roman" panose="02020603050405020304" pitchFamily="18" charset="0"/>
              <a:cs typeface="Times New Roman" panose="02020603050405020304" pitchFamily="18" charset="0"/>
            </a:rPr>
            <a:t> and </a:t>
          </a:r>
          <a:r>
            <a:rPr lang="de-DE" sz="1200" baseline="0" err="1">
              <a:latin typeface="Times New Roman" panose="02020603050405020304" pitchFamily="18" charset="0"/>
              <a:cs typeface="Times New Roman" panose="02020603050405020304" pitchFamily="18" charset="0"/>
            </a:rPr>
            <a:t>industry</a:t>
          </a:r>
          <a:endParaRPr lang="de-DE" sz="120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A7EB2E53-A0F7-41F9-9F6A-A28410E699DB}" type="parTrans" cxnId="{EE4DD132-A251-4BA5-8356-494F3570E984}">
      <dgm:prSet custT="1"/>
      <dgm:spPr/>
      <dgm:t>
        <a:bodyPr/>
        <a:lstStyle/>
        <a:p>
          <a:endParaRPr lang="de-DE" sz="110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ACD72424-B859-42FC-AD95-05CBCCEC32EB}" type="sibTrans" cxnId="{EE4DD132-A251-4BA5-8356-494F3570E984}">
      <dgm:prSet/>
      <dgm:spPr/>
      <dgm:t>
        <a:bodyPr/>
        <a:lstStyle/>
        <a:p>
          <a:endParaRPr lang="de-DE" sz="2000"/>
        </a:p>
      </dgm:t>
    </dgm:pt>
    <dgm:pt modelId="{4C4B97E3-F5BD-4198-B4CF-00796D7DABC4}">
      <dgm:prSet phldrT="[Text]" custT="1"/>
      <dgm:spPr/>
      <dgm:t>
        <a:bodyPr/>
        <a:lstStyle/>
        <a:p>
          <a:r>
            <a:rPr lang="de-DE" sz="1200">
              <a:latin typeface="Times New Roman" panose="02020603050405020304" pitchFamily="18" charset="0"/>
              <a:cs typeface="Times New Roman" panose="02020603050405020304" pitchFamily="18" charset="0"/>
            </a:rPr>
            <a:t>Travel</a:t>
          </a:r>
        </a:p>
      </dgm:t>
    </dgm:pt>
    <dgm:pt modelId="{7D4974A8-D315-42CC-B9BB-A3A5CD5225A3}" type="parTrans" cxnId="{8B1F417C-D57E-4A5D-BE66-6CACFE4FD74B}">
      <dgm:prSet custT="1"/>
      <dgm:spPr/>
      <dgm:t>
        <a:bodyPr/>
        <a:lstStyle/>
        <a:p>
          <a:endParaRPr lang="de-DE" sz="110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2F5833B1-8B55-4651-83AB-AE1350EC55C1}" type="sibTrans" cxnId="{8B1F417C-D57E-4A5D-BE66-6CACFE4FD74B}">
      <dgm:prSet/>
      <dgm:spPr/>
      <dgm:t>
        <a:bodyPr/>
        <a:lstStyle/>
        <a:p>
          <a:endParaRPr lang="de-DE" sz="2000"/>
        </a:p>
      </dgm:t>
    </dgm:pt>
    <dgm:pt modelId="{139D31B5-E436-4EC0-97A7-7F66DB8AA5D7}">
      <dgm:prSet phldrT="[Text]" custT="1"/>
      <dgm:spPr/>
      <dgm:t>
        <a:bodyPr/>
        <a:lstStyle/>
        <a:p>
          <a:r>
            <a:rPr lang="de-DE" sz="1200" dirty="0">
              <a:latin typeface="Times New Roman" panose="02020603050405020304" pitchFamily="18" charset="0"/>
              <a:cs typeface="Times New Roman" panose="02020603050405020304" pitchFamily="18" charset="0"/>
            </a:rPr>
            <a:t>The </a:t>
          </a:r>
          <a:r>
            <a:rPr lang="de-DE" sz="1200" dirty="0" err="1">
              <a:latin typeface="Times New Roman" panose="02020603050405020304" pitchFamily="18" charset="0"/>
              <a:cs typeface="Times New Roman" panose="02020603050405020304" pitchFamily="18" charset="0"/>
            </a:rPr>
            <a:t>enviroment</a:t>
          </a:r>
          <a:endParaRPr lang="de-DE" sz="1200" dirty="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AF9EC442-AE64-421C-9DF3-0ED0B18D4EC6}" type="parTrans" cxnId="{291F772C-20F4-4C15-B3EC-1E4FEB7684CE}">
      <dgm:prSet custT="1"/>
      <dgm:spPr/>
      <dgm:t>
        <a:bodyPr/>
        <a:lstStyle/>
        <a:p>
          <a:endParaRPr lang="de-DE" sz="110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12528D3C-0831-4D11-8576-30D0B612443D}" type="sibTrans" cxnId="{291F772C-20F4-4C15-B3EC-1E4FEB7684CE}">
      <dgm:prSet/>
      <dgm:spPr/>
      <dgm:t>
        <a:bodyPr/>
        <a:lstStyle/>
        <a:p>
          <a:endParaRPr lang="de-DE" sz="2000"/>
        </a:p>
      </dgm:t>
    </dgm:pt>
    <dgm:pt modelId="{1526BD2C-5491-407F-8729-1EE2B6B3A855}">
      <dgm:prSet phldrT="[Text]" custT="1"/>
      <dgm:spPr/>
      <dgm:t>
        <a:bodyPr/>
        <a:lstStyle/>
        <a:p>
          <a:r>
            <a:rPr lang="de-DE" sz="1200" err="1">
              <a:latin typeface="Times New Roman" panose="02020603050405020304" pitchFamily="18" charset="0"/>
              <a:cs typeface="Times New Roman" panose="02020603050405020304" pitchFamily="18" charset="0"/>
            </a:rPr>
            <a:t>Inequalities</a:t>
          </a:r>
          <a:endParaRPr lang="de-DE" sz="120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493FD3B1-4C0C-4AB6-93B7-144BA121C706}" type="parTrans" cxnId="{ABAF072D-729E-4B57-9163-D0065AEE9336}">
      <dgm:prSet custT="1"/>
      <dgm:spPr/>
      <dgm:t>
        <a:bodyPr/>
        <a:lstStyle/>
        <a:p>
          <a:endParaRPr lang="de-DE" sz="110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43AD28CE-0CF1-43EF-A291-AAB3F34ECA2E}" type="sibTrans" cxnId="{ABAF072D-729E-4B57-9163-D0065AEE9336}">
      <dgm:prSet/>
      <dgm:spPr/>
      <dgm:t>
        <a:bodyPr/>
        <a:lstStyle/>
        <a:p>
          <a:endParaRPr lang="de-DE" sz="2000"/>
        </a:p>
      </dgm:t>
    </dgm:pt>
    <dgm:pt modelId="{0427F775-9407-4A06-A301-D22BFE5F9A2F}">
      <dgm:prSet phldrT="[Text]" custT="1"/>
      <dgm:spPr/>
      <dgm:t>
        <a:bodyPr/>
        <a:lstStyle/>
        <a:p>
          <a:r>
            <a:rPr lang="de-DE" sz="1200" err="1">
              <a:latin typeface="Times New Roman" panose="02020603050405020304" pitchFamily="18" charset="0"/>
              <a:cs typeface="Times New Roman" panose="02020603050405020304" pitchFamily="18" charset="0"/>
            </a:rPr>
            <a:t>Civil</a:t>
          </a:r>
          <a:r>
            <a:rPr lang="de-DE" sz="1200">
              <a:latin typeface="Times New Roman" panose="02020603050405020304" pitchFamily="18" charset="0"/>
              <a:cs typeface="Times New Roman" panose="02020603050405020304" pitchFamily="18" charset="0"/>
            </a:rPr>
            <a:t> </a:t>
          </a:r>
          <a:r>
            <a:rPr lang="de-DE" sz="1200" err="1">
              <a:latin typeface="Times New Roman" panose="02020603050405020304" pitchFamily="18" charset="0"/>
              <a:cs typeface="Times New Roman" panose="02020603050405020304" pitchFamily="18" charset="0"/>
            </a:rPr>
            <a:t>unrest</a:t>
          </a:r>
          <a:endParaRPr lang="de-DE" sz="120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064DB9D2-173A-4CFB-BE23-C2F5395E90CE}" type="parTrans" cxnId="{234F9010-5139-42E0-80F6-0F2D307A11F3}">
      <dgm:prSet custT="1"/>
      <dgm:spPr/>
      <dgm:t>
        <a:bodyPr/>
        <a:lstStyle/>
        <a:p>
          <a:endParaRPr lang="de-DE" sz="110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284BA064-CA16-40B8-ABB6-39297C736969}" type="sibTrans" cxnId="{234F9010-5139-42E0-80F6-0F2D307A11F3}">
      <dgm:prSet/>
      <dgm:spPr/>
      <dgm:t>
        <a:bodyPr/>
        <a:lstStyle/>
        <a:p>
          <a:endParaRPr lang="de-DE" sz="2000"/>
        </a:p>
      </dgm:t>
    </dgm:pt>
    <dgm:pt modelId="{89246641-77CD-487A-83F2-C7F1200B9CD3}">
      <dgm:prSet phldrT="[Text]" custT="1"/>
      <dgm:spPr/>
      <dgm:t>
        <a:bodyPr/>
        <a:lstStyle/>
        <a:p>
          <a:r>
            <a:rPr lang="de-DE" sz="1200" err="1">
              <a:latin typeface="Times New Roman" panose="02020603050405020304" pitchFamily="18" charset="0"/>
              <a:cs typeface="Times New Roman" panose="02020603050405020304" pitchFamily="18" charset="0"/>
            </a:rPr>
            <a:t>Statistics</a:t>
          </a:r>
          <a:r>
            <a:rPr lang="de-DE" sz="1200">
              <a:latin typeface="Times New Roman" panose="02020603050405020304" pitchFamily="18" charset="0"/>
              <a:cs typeface="Times New Roman" panose="02020603050405020304" pitchFamily="18" charset="0"/>
            </a:rPr>
            <a:t> and </a:t>
          </a:r>
          <a:r>
            <a:rPr lang="de-DE" sz="1200" err="1">
              <a:latin typeface="Times New Roman" panose="02020603050405020304" pitchFamily="18" charset="0"/>
              <a:cs typeface="Times New Roman" panose="02020603050405020304" pitchFamily="18" charset="0"/>
            </a:rPr>
            <a:t>data</a:t>
          </a:r>
          <a:endParaRPr lang="de-DE" sz="120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2A9BE497-61AC-492C-9E1D-96073DB72DE2}" type="parTrans" cxnId="{171C8B0C-881B-4B3B-894B-FD7D7E222816}">
      <dgm:prSet custT="1"/>
      <dgm:spPr/>
      <dgm:t>
        <a:bodyPr/>
        <a:lstStyle/>
        <a:p>
          <a:endParaRPr lang="de-DE" sz="110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8FE26FC0-4536-4E72-BA73-6E6DB87FDB86}" type="sibTrans" cxnId="{171C8B0C-881B-4B3B-894B-FD7D7E222816}">
      <dgm:prSet/>
      <dgm:spPr/>
      <dgm:t>
        <a:bodyPr/>
        <a:lstStyle/>
        <a:p>
          <a:endParaRPr lang="de-DE" sz="2000"/>
        </a:p>
      </dgm:t>
    </dgm:pt>
    <dgm:pt modelId="{6125DCFA-27DB-435B-BEA4-88B2190500A1}">
      <dgm:prSet phldrT="[Text]" custT="1"/>
      <dgm:spPr/>
      <dgm:t>
        <a:bodyPr/>
        <a:lstStyle/>
        <a:p>
          <a:r>
            <a:rPr lang="de-DE" sz="1200" err="1">
              <a:latin typeface="Times New Roman" panose="02020603050405020304" pitchFamily="18" charset="0"/>
              <a:cs typeface="Times New Roman" panose="02020603050405020304" pitchFamily="18" charset="0"/>
            </a:rPr>
            <a:t>Mis</a:t>
          </a:r>
          <a:r>
            <a:rPr lang="de-DE" sz="1200">
              <a:latin typeface="Times New Roman" panose="02020603050405020304" pitchFamily="18" charset="0"/>
              <a:cs typeface="Times New Roman" panose="02020603050405020304" pitchFamily="18" charset="0"/>
            </a:rPr>
            <a:t>- and </a:t>
          </a:r>
          <a:r>
            <a:rPr lang="de-DE" sz="1200" err="1">
              <a:latin typeface="Times New Roman" panose="02020603050405020304" pitchFamily="18" charset="0"/>
              <a:cs typeface="Times New Roman" panose="02020603050405020304" pitchFamily="18" charset="0"/>
            </a:rPr>
            <a:t>disinformation</a:t>
          </a:r>
          <a:endParaRPr lang="de-DE" sz="120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1A98DB96-17DF-475F-B57D-AA7AEC31238C}" type="parTrans" cxnId="{225F28E9-5723-4F77-9501-13923EB7D7AE}">
      <dgm:prSet custT="1"/>
      <dgm:spPr/>
      <dgm:t>
        <a:bodyPr/>
        <a:lstStyle/>
        <a:p>
          <a:endParaRPr lang="de-DE" sz="110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514F69F3-BA1B-4306-A43E-9B675BA1B5FC}" type="sibTrans" cxnId="{225F28E9-5723-4F77-9501-13923EB7D7AE}">
      <dgm:prSet/>
      <dgm:spPr/>
      <dgm:t>
        <a:bodyPr/>
        <a:lstStyle/>
        <a:p>
          <a:endParaRPr lang="de-DE" sz="2000"/>
        </a:p>
      </dgm:t>
    </dgm:pt>
    <dgm:pt modelId="{B87C2DC1-653F-4929-9260-6C6E30534E07}">
      <dgm:prSet phldrT="[Text]" custT="1"/>
      <dgm:spPr/>
      <dgm:t>
        <a:bodyPr/>
        <a:lstStyle/>
        <a:p>
          <a:r>
            <a:rPr lang="de-DE" sz="1200">
              <a:latin typeface="Times New Roman" panose="02020603050405020304" pitchFamily="18" charset="0"/>
              <a:cs typeface="Times New Roman" panose="02020603050405020304" pitchFamily="18" charset="0"/>
            </a:rPr>
            <a:t>Vulnerable </a:t>
          </a:r>
          <a:r>
            <a:rPr lang="de-DE" sz="1200" err="1">
              <a:latin typeface="Times New Roman" panose="02020603050405020304" pitchFamily="18" charset="0"/>
              <a:cs typeface="Times New Roman" panose="02020603050405020304" pitchFamily="18" charset="0"/>
            </a:rPr>
            <a:t>communities</a:t>
          </a:r>
          <a:endParaRPr lang="de-DE" sz="120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3B2039F4-2BA1-4802-A7AA-25308413273C}" type="parTrans" cxnId="{A9302518-6ADB-4EFD-9798-25FD8FC5D3C1}">
      <dgm:prSet custT="1"/>
      <dgm:spPr/>
      <dgm:t>
        <a:bodyPr/>
        <a:lstStyle/>
        <a:p>
          <a:endParaRPr lang="de-DE" sz="80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D969B3C1-13FB-4D01-8F61-046C91361577}" type="sibTrans" cxnId="{A9302518-6ADB-4EFD-9798-25FD8FC5D3C1}">
      <dgm:prSet/>
      <dgm:spPr/>
      <dgm:t>
        <a:bodyPr/>
        <a:lstStyle/>
        <a:p>
          <a:endParaRPr lang="de-DE" sz="2000"/>
        </a:p>
      </dgm:t>
    </dgm:pt>
    <dgm:pt modelId="{ECD62ED1-5D11-481E-9BBC-AB020A2EFAFF}">
      <dgm:prSet phldrT="[Text]" custT="1"/>
      <dgm:spPr/>
      <dgm:t>
        <a:bodyPr/>
        <a:lstStyle/>
        <a:p>
          <a:r>
            <a:rPr lang="de-DE" sz="1200" err="1">
              <a:latin typeface="Times New Roman" panose="02020603050405020304" pitchFamily="18" charset="0"/>
              <a:cs typeface="Times New Roman" panose="02020603050405020304" pitchFamily="18" charset="0"/>
            </a:rPr>
            <a:t>Vaccines</a:t>
          </a:r>
          <a:endParaRPr lang="de-DE" sz="120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0CC02BC8-A818-4832-81BB-32F3133B8621}" type="parTrans" cxnId="{3D343B8B-1248-4DFE-8A34-AF4186B05CDE}">
      <dgm:prSet custT="1"/>
      <dgm:spPr/>
      <dgm:t>
        <a:bodyPr/>
        <a:lstStyle/>
        <a:p>
          <a:endParaRPr lang="de-DE" sz="80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94E1BBA4-DAA9-4674-B28C-E8D1C76D9ED9}" type="sibTrans" cxnId="{3D343B8B-1248-4DFE-8A34-AF4186B05CDE}">
      <dgm:prSet/>
      <dgm:spPr/>
      <dgm:t>
        <a:bodyPr/>
        <a:lstStyle/>
        <a:p>
          <a:endParaRPr lang="de-DE" sz="2000"/>
        </a:p>
      </dgm:t>
    </dgm:pt>
    <dgm:pt modelId="{4A87926E-2F89-4541-AD41-F858508AC316}" type="pres">
      <dgm:prSet presAssocID="{C256443A-5739-41C3-976C-086C241C3437}" presName="diagram" presStyleCnt="0">
        <dgm:presLayoutVars>
          <dgm:chPref val="1"/>
          <dgm:dir/>
          <dgm:animOne val="branch"/>
          <dgm:animLvl val="lvl"/>
          <dgm:resizeHandles val="exact"/>
        </dgm:presLayoutVars>
      </dgm:prSet>
      <dgm:spPr/>
    </dgm:pt>
    <dgm:pt modelId="{D0337419-FCAE-4D52-B05C-516C20818889}" type="pres">
      <dgm:prSet presAssocID="{353C6F70-9685-47CA-B6F4-8BAAB244C13E}" presName="root1" presStyleCnt="0"/>
      <dgm:spPr/>
    </dgm:pt>
    <dgm:pt modelId="{F78A7B94-B816-41D1-873A-8D5A3EB8CC40}" type="pres">
      <dgm:prSet presAssocID="{353C6F70-9685-47CA-B6F4-8BAAB244C13E}" presName="LevelOneTextNode" presStyleLbl="node0" presStyleIdx="0" presStyleCnt="1" custScaleX="761268" custScaleY="1128439" custLinFactX="-700000" custLinFactNeighborX="-750747" custLinFactNeighborY="53428">
        <dgm:presLayoutVars>
          <dgm:chPref val="3"/>
        </dgm:presLayoutVars>
      </dgm:prSet>
      <dgm:spPr/>
    </dgm:pt>
    <dgm:pt modelId="{457B3FD6-8EF7-4A94-BB29-C9471CDE92CD}" type="pres">
      <dgm:prSet presAssocID="{353C6F70-9685-47CA-B6F4-8BAAB244C13E}" presName="level2hierChild" presStyleCnt="0"/>
      <dgm:spPr/>
    </dgm:pt>
    <dgm:pt modelId="{2F7D4346-F118-454B-9AAD-5BD4A706F402}" type="pres">
      <dgm:prSet presAssocID="{F855B30C-366F-4036-B5AE-48974C07A80E}" presName="conn2-1" presStyleLbl="parChTrans1D2" presStyleIdx="0" presStyleCnt="5" custSzX="14400010"/>
      <dgm:spPr/>
    </dgm:pt>
    <dgm:pt modelId="{8E782F7D-B5EB-45C3-8750-549909A533F3}" type="pres">
      <dgm:prSet presAssocID="{F855B30C-366F-4036-B5AE-48974C07A80E}" presName="connTx" presStyleLbl="parChTrans1D2" presStyleIdx="0" presStyleCnt="5"/>
      <dgm:spPr/>
    </dgm:pt>
    <dgm:pt modelId="{D988932E-C931-4512-A8F2-C38E4F67EB7D}" type="pres">
      <dgm:prSet presAssocID="{5E805EC3-C58D-4BD5-A99E-B5CA51F30872}" presName="root2" presStyleCnt="0"/>
      <dgm:spPr/>
    </dgm:pt>
    <dgm:pt modelId="{430F15C4-6A15-46B0-808C-1CBD7A4F9165}" type="pres">
      <dgm:prSet presAssocID="{5E805EC3-C58D-4BD5-A99E-B5CA51F30872}" presName="LevelTwoTextNode" presStyleLbl="node2" presStyleIdx="0" presStyleCnt="5" custScaleX="1120331" custScaleY="259713" custLinFactX="-556004" custLinFactY="100000" custLinFactNeighborX="-600000" custLinFactNeighborY="199687">
        <dgm:presLayoutVars>
          <dgm:chPref val="3"/>
        </dgm:presLayoutVars>
      </dgm:prSet>
      <dgm:spPr/>
    </dgm:pt>
    <dgm:pt modelId="{A62861FB-C1E1-4913-99BB-D18D0BA7EF62}" type="pres">
      <dgm:prSet presAssocID="{5E805EC3-C58D-4BD5-A99E-B5CA51F30872}" presName="level3hierChild" presStyleCnt="0"/>
      <dgm:spPr/>
    </dgm:pt>
    <dgm:pt modelId="{4838F315-A0EB-4974-8233-371CFFCC1CE4}" type="pres">
      <dgm:prSet presAssocID="{C09B2D6A-14B0-4151-BFD3-E21110A5E135}" presName="conn2-1" presStyleLbl="parChTrans1D3" presStyleIdx="0" presStyleCnt="29" custSzX="14400073"/>
      <dgm:spPr/>
    </dgm:pt>
    <dgm:pt modelId="{E36F28F1-4932-4D2B-B680-9D2F1B515793}" type="pres">
      <dgm:prSet presAssocID="{C09B2D6A-14B0-4151-BFD3-E21110A5E135}" presName="connTx" presStyleLbl="parChTrans1D3" presStyleIdx="0" presStyleCnt="29"/>
      <dgm:spPr/>
    </dgm:pt>
    <dgm:pt modelId="{DDFF5742-CF69-471F-841B-FF79B1E24A3C}" type="pres">
      <dgm:prSet presAssocID="{3A98E99E-5EB9-499E-9929-61172C5675F2}" presName="root2" presStyleCnt="0"/>
      <dgm:spPr/>
    </dgm:pt>
    <dgm:pt modelId="{0B80F301-D09A-4FB6-916E-CECF32B2F143}" type="pres">
      <dgm:prSet presAssocID="{3A98E99E-5EB9-499E-9929-61172C5675F2}" presName="LevelTwoTextNode" presStyleLbl="node3" presStyleIdx="0" presStyleCnt="29" custScaleX="1190352" custScaleY="259713" custLinFactX="-393678" custLinFactY="100000" custLinFactNeighborX="-400000" custLinFactNeighborY="170576">
        <dgm:presLayoutVars>
          <dgm:chPref val="3"/>
        </dgm:presLayoutVars>
      </dgm:prSet>
      <dgm:spPr/>
    </dgm:pt>
    <dgm:pt modelId="{01C225FF-8339-4AED-93A9-27AB32E3DF0B}" type="pres">
      <dgm:prSet presAssocID="{3A98E99E-5EB9-499E-9929-61172C5675F2}" presName="level3hierChild" presStyleCnt="0"/>
      <dgm:spPr/>
    </dgm:pt>
    <dgm:pt modelId="{750F2EA3-C6A2-49D8-A4E9-ECB36FFC366E}" type="pres">
      <dgm:prSet presAssocID="{8C8C0F98-AF8B-47BC-ACBA-EC4EA96F1883}" presName="conn2-1" presStyleLbl="parChTrans1D3" presStyleIdx="1" presStyleCnt="29" custSzX="14400096"/>
      <dgm:spPr/>
    </dgm:pt>
    <dgm:pt modelId="{066D82E6-DD7A-4789-BA1F-74B091D397C9}" type="pres">
      <dgm:prSet presAssocID="{8C8C0F98-AF8B-47BC-ACBA-EC4EA96F1883}" presName="connTx" presStyleLbl="parChTrans1D3" presStyleIdx="1" presStyleCnt="29"/>
      <dgm:spPr/>
    </dgm:pt>
    <dgm:pt modelId="{D3F69F3A-148E-4673-B1FF-6A8AC1FE2DCE}" type="pres">
      <dgm:prSet presAssocID="{358A984D-84A8-4882-B614-7818D9052477}" presName="root2" presStyleCnt="0"/>
      <dgm:spPr/>
    </dgm:pt>
    <dgm:pt modelId="{70A6C9AF-4497-49E2-8F6B-4022C002A32C}" type="pres">
      <dgm:prSet presAssocID="{358A984D-84A8-4882-B614-7818D9052477}" presName="LevelTwoTextNode" presStyleLbl="node3" presStyleIdx="1" presStyleCnt="29" custScaleX="1190352" custScaleY="259713" custLinFactX="-395127" custLinFactY="100000" custLinFactNeighborX="-400000" custLinFactNeighborY="188862">
        <dgm:presLayoutVars>
          <dgm:chPref val="3"/>
        </dgm:presLayoutVars>
      </dgm:prSet>
      <dgm:spPr/>
    </dgm:pt>
    <dgm:pt modelId="{75CD52C9-9125-48F6-9D99-712D3BC58122}" type="pres">
      <dgm:prSet presAssocID="{358A984D-84A8-4882-B614-7818D9052477}" presName="level3hierChild" presStyleCnt="0"/>
      <dgm:spPr/>
    </dgm:pt>
    <dgm:pt modelId="{B99573E9-A46B-4C67-A741-44E4FCB4FC8A}" type="pres">
      <dgm:prSet presAssocID="{1731A452-294D-4C69-97EA-ABFB841FA0AB}" presName="conn2-1" presStyleLbl="parChTrans1D3" presStyleIdx="2" presStyleCnt="29" custSzX="14400130"/>
      <dgm:spPr/>
    </dgm:pt>
    <dgm:pt modelId="{AAEF59AE-AA15-4AA2-AEAA-A4784793DDE5}" type="pres">
      <dgm:prSet presAssocID="{1731A452-294D-4C69-97EA-ABFB841FA0AB}" presName="connTx" presStyleLbl="parChTrans1D3" presStyleIdx="2" presStyleCnt="29"/>
      <dgm:spPr/>
    </dgm:pt>
    <dgm:pt modelId="{7019262D-F9E7-43D3-B6F1-BE5C8FC760AB}" type="pres">
      <dgm:prSet presAssocID="{4C9D4A9F-DD4B-450F-BD60-CED00D3393A2}" presName="root2" presStyleCnt="0"/>
      <dgm:spPr/>
    </dgm:pt>
    <dgm:pt modelId="{049F2968-73E2-4348-A8D7-E885F2B2F00E}" type="pres">
      <dgm:prSet presAssocID="{4C9D4A9F-DD4B-450F-BD60-CED00D3393A2}" presName="LevelTwoTextNode" presStyleLbl="node3" presStyleIdx="2" presStyleCnt="29" custAng="10800000" custFlipVert="1" custScaleX="1190352" custScaleY="259713" custLinFactX="-389608" custLinFactY="117200" custLinFactNeighborX="-400000" custLinFactNeighborY="200000">
        <dgm:presLayoutVars>
          <dgm:chPref val="3"/>
        </dgm:presLayoutVars>
      </dgm:prSet>
      <dgm:spPr/>
    </dgm:pt>
    <dgm:pt modelId="{9CD1B84C-59C7-4394-B671-9D4A34E2A244}" type="pres">
      <dgm:prSet presAssocID="{4C9D4A9F-DD4B-450F-BD60-CED00D3393A2}" presName="level3hierChild" presStyleCnt="0"/>
      <dgm:spPr/>
    </dgm:pt>
    <dgm:pt modelId="{6C074D18-1EA0-40FB-94A6-DD4C52B7D46C}" type="pres">
      <dgm:prSet presAssocID="{84547787-FAB0-4D90-A3B1-62ECE02E3768}" presName="conn2-1" presStyleLbl="parChTrans1D2" presStyleIdx="1" presStyleCnt="5" custSzX="14400019"/>
      <dgm:spPr/>
    </dgm:pt>
    <dgm:pt modelId="{740522B2-75E3-4986-BE71-6201CAF74879}" type="pres">
      <dgm:prSet presAssocID="{84547787-FAB0-4D90-A3B1-62ECE02E3768}" presName="connTx" presStyleLbl="parChTrans1D2" presStyleIdx="1" presStyleCnt="5"/>
      <dgm:spPr/>
    </dgm:pt>
    <dgm:pt modelId="{923ABA98-7991-407C-B596-10BA5F513C20}" type="pres">
      <dgm:prSet presAssocID="{5BEDA607-8DED-42F2-9BA0-692D403C0EC7}" presName="root2" presStyleCnt="0"/>
      <dgm:spPr/>
    </dgm:pt>
    <dgm:pt modelId="{3B5C04C0-1026-4BCC-B8D1-09CC708E27EF}" type="pres">
      <dgm:prSet presAssocID="{5BEDA607-8DED-42F2-9BA0-692D403C0EC7}" presName="LevelTwoTextNode" presStyleLbl="node2" presStyleIdx="1" presStyleCnt="5" custScaleX="1120331" custScaleY="259713" custLinFactX="-555745" custLinFactY="100000" custLinFactNeighborX="-600000" custLinFactNeighborY="154580">
        <dgm:presLayoutVars>
          <dgm:chPref val="3"/>
        </dgm:presLayoutVars>
      </dgm:prSet>
      <dgm:spPr/>
    </dgm:pt>
    <dgm:pt modelId="{63E65136-FB97-46CC-93F6-1E9121ADE6EE}" type="pres">
      <dgm:prSet presAssocID="{5BEDA607-8DED-42F2-9BA0-692D403C0EC7}" presName="level3hierChild" presStyleCnt="0"/>
      <dgm:spPr/>
    </dgm:pt>
    <dgm:pt modelId="{1933032C-D9EF-4E95-9447-72395E90BD3C}" type="pres">
      <dgm:prSet presAssocID="{07D04FA9-5869-4D23-B691-B49B006E8BC9}" presName="conn2-1" presStyleLbl="parChTrans1D3" presStyleIdx="3" presStyleCnt="29" custSzX="14400014"/>
      <dgm:spPr/>
    </dgm:pt>
    <dgm:pt modelId="{DDA1B4D0-DAFF-4A7B-B757-2D0EB38A13A7}" type="pres">
      <dgm:prSet presAssocID="{07D04FA9-5869-4D23-B691-B49B006E8BC9}" presName="connTx" presStyleLbl="parChTrans1D3" presStyleIdx="3" presStyleCnt="29"/>
      <dgm:spPr/>
    </dgm:pt>
    <dgm:pt modelId="{658C8869-04C9-4951-AD31-366FF613DDA0}" type="pres">
      <dgm:prSet presAssocID="{26FE1203-5ADF-4E90-A8D9-0247D9F49394}" presName="root2" presStyleCnt="0"/>
      <dgm:spPr/>
    </dgm:pt>
    <dgm:pt modelId="{85D196B6-063E-44EA-88B6-502D03441A95}" type="pres">
      <dgm:prSet presAssocID="{26FE1203-5ADF-4E90-A8D9-0247D9F49394}" presName="LevelTwoTextNode" presStyleLbl="node3" presStyleIdx="3" presStyleCnt="29" custScaleX="1190352" custScaleY="259713" custLinFactX="300000" custLinFactY="100000" custLinFactNeighborX="332789" custLinFactNeighborY="137560">
        <dgm:presLayoutVars>
          <dgm:chPref val="3"/>
        </dgm:presLayoutVars>
      </dgm:prSet>
      <dgm:spPr/>
    </dgm:pt>
    <dgm:pt modelId="{6631D1CF-F995-496A-B550-A56FC7462583}" type="pres">
      <dgm:prSet presAssocID="{26FE1203-5ADF-4E90-A8D9-0247D9F49394}" presName="level3hierChild" presStyleCnt="0"/>
      <dgm:spPr/>
    </dgm:pt>
    <dgm:pt modelId="{39A8889A-DFEF-4793-B12D-3BA4A3083E3E}" type="pres">
      <dgm:prSet presAssocID="{03C2E030-813C-4887-94E5-82269C93F63C}" presName="conn2-1" presStyleLbl="parChTrans1D4" presStyleIdx="0" presStyleCnt="9" custSzX="14400012"/>
      <dgm:spPr/>
    </dgm:pt>
    <dgm:pt modelId="{993A1D06-E7B1-4637-8296-1DEAAA23799F}" type="pres">
      <dgm:prSet presAssocID="{03C2E030-813C-4887-94E5-82269C93F63C}" presName="connTx" presStyleLbl="parChTrans1D4" presStyleIdx="0" presStyleCnt="9"/>
      <dgm:spPr/>
    </dgm:pt>
    <dgm:pt modelId="{70EDD1C1-63F0-4263-8036-027FA4CD0523}" type="pres">
      <dgm:prSet presAssocID="{9A5197BB-7B1D-4DC8-A917-46D969DA792E}" presName="root2" presStyleCnt="0"/>
      <dgm:spPr/>
    </dgm:pt>
    <dgm:pt modelId="{29B3ABBF-0291-41BA-9070-E0CB070E1723}" type="pres">
      <dgm:prSet presAssocID="{9A5197BB-7B1D-4DC8-A917-46D969DA792E}" presName="LevelTwoTextNode" presStyleLbl="node4" presStyleIdx="0" presStyleCnt="9" custScaleX="1277267" custScaleY="246596" custLinFactX="695752" custLinFactY="100000" custLinFactNeighborX="700000" custLinFactNeighborY="103086">
        <dgm:presLayoutVars>
          <dgm:chPref val="3"/>
        </dgm:presLayoutVars>
      </dgm:prSet>
      <dgm:spPr/>
    </dgm:pt>
    <dgm:pt modelId="{FAA504E9-7E4D-4F77-A140-2ECF8E058BD1}" type="pres">
      <dgm:prSet presAssocID="{9A5197BB-7B1D-4DC8-A917-46D969DA792E}" presName="level3hierChild" presStyleCnt="0"/>
      <dgm:spPr/>
    </dgm:pt>
    <dgm:pt modelId="{16EDC4EB-15B1-4BED-A913-C4910A592E43}" type="pres">
      <dgm:prSet presAssocID="{D40E33C4-65A6-43F0-8A5A-668871AD40F3}" presName="conn2-1" presStyleLbl="parChTrans1D4" presStyleIdx="1" presStyleCnt="9" custSzX="14400063"/>
      <dgm:spPr/>
    </dgm:pt>
    <dgm:pt modelId="{16FE4A7B-83F7-4D09-B9FE-7AABA7BB071E}" type="pres">
      <dgm:prSet presAssocID="{D40E33C4-65A6-43F0-8A5A-668871AD40F3}" presName="connTx" presStyleLbl="parChTrans1D4" presStyleIdx="1" presStyleCnt="9"/>
      <dgm:spPr/>
    </dgm:pt>
    <dgm:pt modelId="{682C3E9E-A664-4AEB-98FA-7A56B9FCB066}" type="pres">
      <dgm:prSet presAssocID="{2F02F2CE-1BCD-446E-BECB-6973E7ACA9E4}" presName="root2" presStyleCnt="0"/>
      <dgm:spPr/>
    </dgm:pt>
    <dgm:pt modelId="{3D93AA13-F9BF-4516-9343-01C4FE687B9F}" type="pres">
      <dgm:prSet presAssocID="{2F02F2CE-1BCD-446E-BECB-6973E7ACA9E4}" presName="LevelTwoTextNode" presStyleLbl="node4" presStyleIdx="1" presStyleCnt="9" custScaleX="1277267" custScaleY="246597" custLinFactX="690340" custLinFactY="100000" custLinFactNeighborX="700000" custLinFactNeighborY="147223">
        <dgm:presLayoutVars>
          <dgm:chPref val="3"/>
        </dgm:presLayoutVars>
      </dgm:prSet>
      <dgm:spPr/>
    </dgm:pt>
    <dgm:pt modelId="{FA14F626-8A10-4F1C-A2B9-289709A47DFF}" type="pres">
      <dgm:prSet presAssocID="{2F02F2CE-1BCD-446E-BECB-6973E7ACA9E4}" presName="level3hierChild" presStyleCnt="0"/>
      <dgm:spPr/>
    </dgm:pt>
    <dgm:pt modelId="{BE69F2C5-1F16-4884-B39F-EE6B06025848}" type="pres">
      <dgm:prSet presAssocID="{BE23815E-A548-4C9A-9302-6B0219BE53D6}" presName="conn2-1" presStyleLbl="parChTrans1D3" presStyleIdx="4" presStyleCnt="29" custSzX="14400005"/>
      <dgm:spPr/>
    </dgm:pt>
    <dgm:pt modelId="{7095C669-4F3E-4E90-960F-1302F717ACD3}" type="pres">
      <dgm:prSet presAssocID="{BE23815E-A548-4C9A-9302-6B0219BE53D6}" presName="connTx" presStyleLbl="parChTrans1D3" presStyleIdx="4" presStyleCnt="29"/>
      <dgm:spPr/>
    </dgm:pt>
    <dgm:pt modelId="{FB910F99-8F7B-4955-BA14-D3CBD5F0BE0B}" type="pres">
      <dgm:prSet presAssocID="{9EEC29B6-B262-48C2-8C7F-8D2337E7AA42}" presName="root2" presStyleCnt="0"/>
      <dgm:spPr/>
    </dgm:pt>
    <dgm:pt modelId="{C631F0D8-FAAD-405A-A21C-737F0EB151CA}" type="pres">
      <dgm:prSet presAssocID="{9EEC29B6-B262-48C2-8C7F-8D2337E7AA42}" presName="LevelTwoTextNode" presStyleLbl="node3" presStyleIdx="4" presStyleCnt="29" custScaleX="1190352" custScaleY="259713" custLinFactX="300000" custLinFactY="100000" custLinFactNeighborX="336536" custLinFactNeighborY="150924">
        <dgm:presLayoutVars>
          <dgm:chPref val="3"/>
        </dgm:presLayoutVars>
      </dgm:prSet>
      <dgm:spPr/>
    </dgm:pt>
    <dgm:pt modelId="{FBF4A851-80A7-4420-B39A-AFC31A510810}" type="pres">
      <dgm:prSet presAssocID="{9EEC29B6-B262-48C2-8C7F-8D2337E7AA42}" presName="level3hierChild" presStyleCnt="0"/>
      <dgm:spPr/>
    </dgm:pt>
    <dgm:pt modelId="{8D2BE030-0831-42B2-98C2-0F6E87AD5B7D}" type="pres">
      <dgm:prSet presAssocID="{E8E96543-F299-474B-9FCF-7801EFC57576}" presName="conn2-1" presStyleLbl="parChTrans1D3" presStyleIdx="5" presStyleCnt="29" custSzX="14400009"/>
      <dgm:spPr/>
    </dgm:pt>
    <dgm:pt modelId="{778A5A6C-5BCE-43A2-9985-988597C18905}" type="pres">
      <dgm:prSet presAssocID="{E8E96543-F299-474B-9FCF-7801EFC57576}" presName="connTx" presStyleLbl="parChTrans1D3" presStyleIdx="5" presStyleCnt="29"/>
      <dgm:spPr/>
    </dgm:pt>
    <dgm:pt modelId="{32EA519B-D3EF-457A-9C5B-9E4A9B562622}" type="pres">
      <dgm:prSet presAssocID="{99F805CD-8B05-4B09-8106-E7D62662EFAB}" presName="root2" presStyleCnt="0"/>
      <dgm:spPr/>
    </dgm:pt>
    <dgm:pt modelId="{29EF756E-ED73-4753-83B6-EFB27D8AB242}" type="pres">
      <dgm:prSet presAssocID="{99F805CD-8B05-4B09-8106-E7D62662EFAB}" presName="LevelTwoTextNode" presStyleLbl="node3" presStyleIdx="5" presStyleCnt="29" custScaleX="1190352" custScaleY="259713" custLinFactX="300000" custLinFactY="100000" custLinFactNeighborX="338523" custLinFactNeighborY="170024">
        <dgm:presLayoutVars>
          <dgm:chPref val="3"/>
        </dgm:presLayoutVars>
      </dgm:prSet>
      <dgm:spPr/>
    </dgm:pt>
    <dgm:pt modelId="{B580F2EF-10D1-43DE-86DA-65887B64442D}" type="pres">
      <dgm:prSet presAssocID="{99F805CD-8B05-4B09-8106-E7D62662EFAB}" presName="level3hierChild" presStyleCnt="0"/>
      <dgm:spPr/>
    </dgm:pt>
    <dgm:pt modelId="{A20C5029-8277-4F52-A215-36A9DA1AB52E}" type="pres">
      <dgm:prSet presAssocID="{FB410C4C-ACA6-43C1-94D1-C7A844E0F3B3}" presName="conn2-1" presStyleLbl="parChTrans1D3" presStyleIdx="6" presStyleCnt="29" custSzX="14400016"/>
      <dgm:spPr/>
    </dgm:pt>
    <dgm:pt modelId="{B80DAFEB-A4DF-442E-B7BA-955CB74D383A}" type="pres">
      <dgm:prSet presAssocID="{FB410C4C-ACA6-43C1-94D1-C7A844E0F3B3}" presName="connTx" presStyleLbl="parChTrans1D3" presStyleIdx="6" presStyleCnt="29"/>
      <dgm:spPr/>
    </dgm:pt>
    <dgm:pt modelId="{00239F36-7CCC-4EC4-8664-6CDB34CC30AA}" type="pres">
      <dgm:prSet presAssocID="{518E9C13-B9BA-4F04-A7EC-F36C8D246639}" presName="root2" presStyleCnt="0"/>
      <dgm:spPr/>
    </dgm:pt>
    <dgm:pt modelId="{EC3C7E9C-DE6F-4CF5-B8A3-EB96093DECF2}" type="pres">
      <dgm:prSet presAssocID="{518E9C13-B9BA-4F04-A7EC-F36C8D246639}" presName="LevelTwoTextNode" presStyleLbl="node3" presStyleIdx="6" presStyleCnt="29" custScaleX="1190352" custScaleY="259713" custLinFactX="300000" custLinFactY="100000" custLinFactNeighborX="343723" custLinFactNeighborY="190597">
        <dgm:presLayoutVars>
          <dgm:chPref val="3"/>
        </dgm:presLayoutVars>
      </dgm:prSet>
      <dgm:spPr/>
    </dgm:pt>
    <dgm:pt modelId="{9547E60A-4616-40DD-BB3B-048D8FF09B27}" type="pres">
      <dgm:prSet presAssocID="{518E9C13-B9BA-4F04-A7EC-F36C8D246639}" presName="level3hierChild" presStyleCnt="0"/>
      <dgm:spPr/>
    </dgm:pt>
    <dgm:pt modelId="{FCAF4F74-DA65-4B57-BED5-BD3F26CA3653}" type="pres">
      <dgm:prSet presAssocID="{6F25122C-9DC2-4635-960D-7ABCFA19A050}" presName="conn2-1" presStyleLbl="parChTrans1D3" presStyleIdx="7" presStyleCnt="29" custSzX="14400014"/>
      <dgm:spPr/>
    </dgm:pt>
    <dgm:pt modelId="{58DDB727-F29C-4C9B-AF2C-EA0167F90FF0}" type="pres">
      <dgm:prSet presAssocID="{6F25122C-9DC2-4635-960D-7ABCFA19A050}" presName="connTx" presStyleLbl="parChTrans1D3" presStyleIdx="7" presStyleCnt="29"/>
      <dgm:spPr/>
    </dgm:pt>
    <dgm:pt modelId="{91501DD1-CFE9-4FBA-823D-10880E2002A9}" type="pres">
      <dgm:prSet presAssocID="{109BE932-8DDB-46FE-93F1-0C28F0100D1E}" presName="root2" presStyleCnt="0"/>
      <dgm:spPr/>
    </dgm:pt>
    <dgm:pt modelId="{963787CF-28FB-43DF-98C2-C462DE3D4B6D}" type="pres">
      <dgm:prSet presAssocID="{109BE932-8DDB-46FE-93F1-0C28F0100D1E}" presName="LevelTwoTextNode" presStyleLbl="node3" presStyleIdx="7" presStyleCnt="29" custScaleX="1190352" custScaleY="259713" custLinFactX="300000" custLinFactY="109180" custLinFactNeighborX="343399" custLinFactNeighborY="200000">
        <dgm:presLayoutVars>
          <dgm:chPref val="3"/>
        </dgm:presLayoutVars>
      </dgm:prSet>
      <dgm:spPr/>
    </dgm:pt>
    <dgm:pt modelId="{793CF8CB-4DC0-4A07-8366-31517125F577}" type="pres">
      <dgm:prSet presAssocID="{109BE932-8DDB-46FE-93F1-0C28F0100D1E}" presName="level3hierChild" presStyleCnt="0"/>
      <dgm:spPr/>
    </dgm:pt>
    <dgm:pt modelId="{52995CFF-A2C0-41A9-B8F6-E167247A0F1E}" type="pres">
      <dgm:prSet presAssocID="{C6A0CEB6-9E0F-4493-8DE5-DBE1EBED4241}" presName="conn2-1" presStyleLbl="parChTrans1D3" presStyleIdx="8" presStyleCnt="29" custSzX="14400013"/>
      <dgm:spPr/>
    </dgm:pt>
    <dgm:pt modelId="{363F3F8F-4CCA-4730-9344-E43FC3582DD0}" type="pres">
      <dgm:prSet presAssocID="{C6A0CEB6-9E0F-4493-8DE5-DBE1EBED4241}" presName="connTx" presStyleLbl="parChTrans1D3" presStyleIdx="8" presStyleCnt="29"/>
      <dgm:spPr/>
    </dgm:pt>
    <dgm:pt modelId="{539280CC-7E34-4575-8E03-0EE6EBFD0B7C}" type="pres">
      <dgm:prSet presAssocID="{F4B2B415-9F5D-4A5C-A517-33028F9EDE23}" presName="root2" presStyleCnt="0"/>
      <dgm:spPr/>
    </dgm:pt>
    <dgm:pt modelId="{15869452-7DB1-4E38-961A-AD18E7BF97A4}" type="pres">
      <dgm:prSet presAssocID="{F4B2B415-9F5D-4A5C-A517-33028F9EDE23}" presName="LevelTwoTextNode" presStyleLbl="node3" presStyleIdx="8" presStyleCnt="29" custScaleX="1190352" custScaleY="259713" custLinFactX="300000" custLinFactY="117924" custLinFactNeighborX="343722" custLinFactNeighborY="200000">
        <dgm:presLayoutVars>
          <dgm:chPref val="3"/>
        </dgm:presLayoutVars>
      </dgm:prSet>
      <dgm:spPr/>
    </dgm:pt>
    <dgm:pt modelId="{A67F4D00-5318-48B1-8F6F-4C6D0840EE34}" type="pres">
      <dgm:prSet presAssocID="{F4B2B415-9F5D-4A5C-A517-33028F9EDE23}" presName="level3hierChild" presStyleCnt="0"/>
      <dgm:spPr/>
    </dgm:pt>
    <dgm:pt modelId="{6DE65224-3B60-4229-ACDA-981AA44CA426}" type="pres">
      <dgm:prSet presAssocID="{CA6A9C70-223C-4BA6-B22F-E7EE9FCEF901}" presName="conn2-1" presStyleLbl="parChTrans1D4" presStyleIdx="2" presStyleCnt="9" custSzX="14400023"/>
      <dgm:spPr/>
    </dgm:pt>
    <dgm:pt modelId="{30A5F9D5-7BBD-431C-88C3-CC070B8111E2}" type="pres">
      <dgm:prSet presAssocID="{CA6A9C70-223C-4BA6-B22F-E7EE9FCEF901}" presName="connTx" presStyleLbl="parChTrans1D4" presStyleIdx="2" presStyleCnt="9"/>
      <dgm:spPr/>
    </dgm:pt>
    <dgm:pt modelId="{4C27843F-B856-4330-96BA-255D39C16F9A}" type="pres">
      <dgm:prSet presAssocID="{1BB53B11-3670-415B-805A-CE32EE8357FF}" presName="root2" presStyleCnt="0"/>
      <dgm:spPr/>
    </dgm:pt>
    <dgm:pt modelId="{D2E49161-A7B6-4759-AC1C-493631AA99EA}" type="pres">
      <dgm:prSet presAssocID="{1BB53B11-3670-415B-805A-CE32EE8357FF}" presName="LevelTwoTextNode" presStyleLbl="node4" presStyleIdx="2" presStyleCnt="9" custScaleX="1277267" custScaleY="246598" custLinFactX="686398" custLinFactY="100000" custLinFactNeighborX="700000" custLinFactNeighborY="162619">
        <dgm:presLayoutVars>
          <dgm:chPref val="3"/>
        </dgm:presLayoutVars>
      </dgm:prSet>
      <dgm:spPr/>
    </dgm:pt>
    <dgm:pt modelId="{B34508A2-9F6C-4930-976B-93634811EA5F}" type="pres">
      <dgm:prSet presAssocID="{1BB53B11-3670-415B-805A-CE32EE8357FF}" presName="level3hierChild" presStyleCnt="0"/>
      <dgm:spPr/>
    </dgm:pt>
    <dgm:pt modelId="{D3655785-2D54-4F59-9234-66AFAA7E681A}" type="pres">
      <dgm:prSet presAssocID="{6CF7CD4C-0917-44C0-B3FE-FDC2C5B2A919}" presName="conn2-1" presStyleLbl="parChTrans1D4" presStyleIdx="3" presStyleCnt="9" custSzX="14400042"/>
      <dgm:spPr/>
    </dgm:pt>
    <dgm:pt modelId="{9698C83B-59AA-460C-B76E-A13EFE8BCD17}" type="pres">
      <dgm:prSet presAssocID="{6CF7CD4C-0917-44C0-B3FE-FDC2C5B2A919}" presName="connTx" presStyleLbl="parChTrans1D4" presStyleIdx="3" presStyleCnt="9"/>
      <dgm:spPr/>
    </dgm:pt>
    <dgm:pt modelId="{1C087AE5-74C3-48F7-9B1F-7643819D62F7}" type="pres">
      <dgm:prSet presAssocID="{E2EBA384-91D3-4018-9EF6-F6F2CD249D13}" presName="root2" presStyleCnt="0"/>
      <dgm:spPr/>
    </dgm:pt>
    <dgm:pt modelId="{A26EDAF6-44C8-4854-8F91-1F5749D4DC73}" type="pres">
      <dgm:prSet presAssocID="{E2EBA384-91D3-4018-9EF6-F6F2CD249D13}" presName="LevelTwoTextNode" presStyleLbl="node4" presStyleIdx="3" presStyleCnt="9" custScaleX="1277267" custScaleY="246596" custLinFactX="686398" custLinFactY="128357" custLinFactNeighborX="700000" custLinFactNeighborY="200000">
        <dgm:presLayoutVars>
          <dgm:chPref val="3"/>
        </dgm:presLayoutVars>
      </dgm:prSet>
      <dgm:spPr/>
    </dgm:pt>
    <dgm:pt modelId="{E9A748F2-229D-45E3-B7F0-1D7693EBB797}" type="pres">
      <dgm:prSet presAssocID="{E2EBA384-91D3-4018-9EF6-F6F2CD249D13}" presName="level3hierChild" presStyleCnt="0"/>
      <dgm:spPr/>
    </dgm:pt>
    <dgm:pt modelId="{FB2F6D88-F506-4847-B326-8EC15F62040F}" type="pres">
      <dgm:prSet presAssocID="{539788D9-F5CD-499B-8EFE-4BDF10193421}" presName="conn2-1" presStyleLbl="parChTrans1D4" presStyleIdx="4" presStyleCnt="9" custSzX="14400018"/>
      <dgm:spPr/>
    </dgm:pt>
    <dgm:pt modelId="{5BC45E89-1EAB-43BA-B311-8A95F182C2C2}" type="pres">
      <dgm:prSet presAssocID="{539788D9-F5CD-499B-8EFE-4BDF10193421}" presName="connTx" presStyleLbl="parChTrans1D4" presStyleIdx="4" presStyleCnt="9"/>
      <dgm:spPr/>
    </dgm:pt>
    <dgm:pt modelId="{66D7E067-5337-459E-866E-2A8CE9CD2228}" type="pres">
      <dgm:prSet presAssocID="{CE4A4217-0410-4729-9337-C36C75DD601B}" presName="root2" presStyleCnt="0"/>
      <dgm:spPr/>
    </dgm:pt>
    <dgm:pt modelId="{4364814E-1DC4-41D8-96F5-7FCAA16DA2B0}" type="pres">
      <dgm:prSet presAssocID="{CE4A4217-0410-4729-9337-C36C75DD601B}" presName="LevelTwoTextNode" presStyleLbl="node4" presStyleIdx="4" presStyleCnt="9" custScaleX="1277267" custScaleY="246596" custLinFactX="686398" custLinFactY="183172" custLinFactNeighborX="700000" custLinFactNeighborY="200000">
        <dgm:presLayoutVars>
          <dgm:chPref val="3"/>
        </dgm:presLayoutVars>
      </dgm:prSet>
      <dgm:spPr/>
    </dgm:pt>
    <dgm:pt modelId="{654D766E-39ED-4868-AAEF-1A28544B5F5D}" type="pres">
      <dgm:prSet presAssocID="{CE4A4217-0410-4729-9337-C36C75DD601B}" presName="level3hierChild" presStyleCnt="0"/>
      <dgm:spPr/>
    </dgm:pt>
    <dgm:pt modelId="{5BC2E700-F976-45E3-88A6-547D0BC5C286}" type="pres">
      <dgm:prSet presAssocID="{8F1E2ECC-9C8C-4137-9CC2-148EC633E965}" presName="conn2-1" presStyleLbl="parChTrans1D4" presStyleIdx="5" presStyleCnt="9" custSzX="14400031"/>
      <dgm:spPr/>
    </dgm:pt>
    <dgm:pt modelId="{5EE677E4-1C6E-4B89-9610-5064AAB1F7F5}" type="pres">
      <dgm:prSet presAssocID="{8F1E2ECC-9C8C-4137-9CC2-148EC633E965}" presName="connTx" presStyleLbl="parChTrans1D4" presStyleIdx="5" presStyleCnt="9"/>
      <dgm:spPr/>
    </dgm:pt>
    <dgm:pt modelId="{6A66418A-D546-46F7-87E7-DA1E687FB1FE}" type="pres">
      <dgm:prSet presAssocID="{359B501C-2EC2-4B8C-BD62-7A96D0CFC1AF}" presName="root2" presStyleCnt="0"/>
      <dgm:spPr/>
    </dgm:pt>
    <dgm:pt modelId="{677DE54C-6078-40B3-9FE8-CF37F7EF3F0C}" type="pres">
      <dgm:prSet presAssocID="{359B501C-2EC2-4B8C-BD62-7A96D0CFC1AF}" presName="LevelTwoTextNode" presStyleLbl="node4" presStyleIdx="5" presStyleCnt="9" custFlipVert="0" custScaleX="1277267" custScaleY="246595" custLinFactX="686398" custLinFactY="200000" custLinFactNeighborX="700000" custLinFactNeighborY="251244">
        <dgm:presLayoutVars>
          <dgm:chPref val="3"/>
        </dgm:presLayoutVars>
      </dgm:prSet>
      <dgm:spPr/>
    </dgm:pt>
    <dgm:pt modelId="{A887E327-8C38-4695-BD51-70185935A672}" type="pres">
      <dgm:prSet presAssocID="{359B501C-2EC2-4B8C-BD62-7A96D0CFC1AF}" presName="level3hierChild" presStyleCnt="0"/>
      <dgm:spPr/>
    </dgm:pt>
    <dgm:pt modelId="{007AF09B-7B63-4C84-BFB2-EF40ED79070D}" type="pres">
      <dgm:prSet presAssocID="{3B2039F4-2BA1-4802-A7AA-25308413273C}" presName="conn2-1" presStyleLbl="parChTrans1D4" presStyleIdx="6" presStyleCnt="9" custSzX="14400044"/>
      <dgm:spPr/>
    </dgm:pt>
    <dgm:pt modelId="{1C784E67-44D5-495B-BFB2-4C4FDB887CF2}" type="pres">
      <dgm:prSet presAssocID="{3B2039F4-2BA1-4802-A7AA-25308413273C}" presName="connTx" presStyleLbl="parChTrans1D4" presStyleIdx="6" presStyleCnt="9"/>
      <dgm:spPr/>
    </dgm:pt>
    <dgm:pt modelId="{DF9FF149-B0C6-4C8C-BC41-DF43A2913708}" type="pres">
      <dgm:prSet presAssocID="{B87C2DC1-653F-4929-9260-6C6E30534E07}" presName="root2" presStyleCnt="0"/>
      <dgm:spPr/>
    </dgm:pt>
    <dgm:pt modelId="{38194E2B-8C9B-446D-93B0-01D743C0AC69}" type="pres">
      <dgm:prSet presAssocID="{B87C2DC1-653F-4929-9260-6C6E30534E07}" presName="LevelTwoTextNode" presStyleLbl="node4" presStyleIdx="6" presStyleCnt="9" custScaleX="1277267" custScaleY="246596" custLinFactX="685467" custLinFactY="202904" custLinFactNeighborX="700000" custLinFactNeighborY="300000">
        <dgm:presLayoutVars>
          <dgm:chPref val="3"/>
        </dgm:presLayoutVars>
      </dgm:prSet>
      <dgm:spPr/>
    </dgm:pt>
    <dgm:pt modelId="{B2CF7225-C61E-43D9-B9C8-7DB119B5C411}" type="pres">
      <dgm:prSet presAssocID="{B87C2DC1-653F-4929-9260-6C6E30534E07}" presName="level3hierChild" presStyleCnt="0"/>
      <dgm:spPr/>
    </dgm:pt>
    <dgm:pt modelId="{925EDBFF-3D85-437B-9D22-40DBEB5AB8DA}" type="pres">
      <dgm:prSet presAssocID="{A1B0E159-B1C8-4060-A4E0-14F2712C19F0}" presName="conn2-1" presStyleLbl="parChTrans1D2" presStyleIdx="2" presStyleCnt="5" custSzX="14400001"/>
      <dgm:spPr/>
    </dgm:pt>
    <dgm:pt modelId="{B814C4C0-4FD5-42D0-888F-22B47EF7775E}" type="pres">
      <dgm:prSet presAssocID="{A1B0E159-B1C8-4060-A4E0-14F2712C19F0}" presName="connTx" presStyleLbl="parChTrans1D2" presStyleIdx="2" presStyleCnt="5"/>
      <dgm:spPr/>
    </dgm:pt>
    <dgm:pt modelId="{32813329-F5DE-4D43-9999-7021733058B4}" type="pres">
      <dgm:prSet presAssocID="{A7E59208-D8C8-472E-BF12-F8E4CF3114A2}" presName="root2" presStyleCnt="0"/>
      <dgm:spPr/>
    </dgm:pt>
    <dgm:pt modelId="{933E68AA-CF10-49A1-ABCC-DA114DDEAF2A}" type="pres">
      <dgm:prSet presAssocID="{A7E59208-D8C8-472E-BF12-F8E4CF3114A2}" presName="LevelTwoTextNode" presStyleLbl="node2" presStyleIdx="2" presStyleCnt="5" custScaleX="1120331" custScaleY="259713" custLinFactX="-554125" custLinFactY="170851" custLinFactNeighborX="-600000" custLinFactNeighborY="200000">
        <dgm:presLayoutVars>
          <dgm:chPref val="3"/>
        </dgm:presLayoutVars>
      </dgm:prSet>
      <dgm:spPr/>
    </dgm:pt>
    <dgm:pt modelId="{0BB7042D-0783-4AF0-A2AC-0560AE754DBB}" type="pres">
      <dgm:prSet presAssocID="{A7E59208-D8C8-472E-BF12-F8E4CF3114A2}" presName="level3hierChild" presStyleCnt="0"/>
      <dgm:spPr/>
    </dgm:pt>
    <dgm:pt modelId="{0E872D06-F66B-4811-92EA-E374B25899A2}" type="pres">
      <dgm:prSet presAssocID="{96C75850-7C10-4A02-8605-049A49CD2E2D}" presName="conn2-1" presStyleLbl="parChTrans1D3" presStyleIdx="9" presStyleCnt="29" custSzX="14400025"/>
      <dgm:spPr/>
    </dgm:pt>
    <dgm:pt modelId="{72B52D37-7D34-4ADE-968E-0497344DEB80}" type="pres">
      <dgm:prSet presAssocID="{96C75850-7C10-4A02-8605-049A49CD2E2D}" presName="connTx" presStyleLbl="parChTrans1D3" presStyleIdx="9" presStyleCnt="29"/>
      <dgm:spPr/>
    </dgm:pt>
    <dgm:pt modelId="{02CBB79E-92BB-43E9-BC76-EB3CA055D3F6}" type="pres">
      <dgm:prSet presAssocID="{3CF53495-E7A9-4FFB-983F-8FC85A5AADF1}" presName="root2" presStyleCnt="0"/>
      <dgm:spPr/>
    </dgm:pt>
    <dgm:pt modelId="{3F552C8C-859A-4030-A503-8872BA917E0A}" type="pres">
      <dgm:prSet presAssocID="{3CF53495-E7A9-4FFB-983F-8FC85A5AADF1}" presName="LevelTwoTextNode" presStyleLbl="node3" presStyleIdx="9" presStyleCnt="29" custScaleX="1130226" custScaleY="246837" custLinFactX="-399465" custLinFactY="121555" custLinFactNeighborX="-400000" custLinFactNeighborY="200000">
        <dgm:presLayoutVars>
          <dgm:chPref val="3"/>
        </dgm:presLayoutVars>
      </dgm:prSet>
      <dgm:spPr/>
    </dgm:pt>
    <dgm:pt modelId="{90941FE9-BA76-4E83-BB38-DFDC96B69634}" type="pres">
      <dgm:prSet presAssocID="{3CF53495-E7A9-4FFB-983F-8FC85A5AADF1}" presName="level3hierChild" presStyleCnt="0"/>
      <dgm:spPr/>
    </dgm:pt>
    <dgm:pt modelId="{168B63D6-E582-4001-8D06-4264135971C6}" type="pres">
      <dgm:prSet presAssocID="{0CC02BC8-A818-4832-81BB-32F3133B8621}" presName="conn2-1" presStyleLbl="parChTrans1D3" presStyleIdx="10" presStyleCnt="29" custSzX="14400008"/>
      <dgm:spPr/>
    </dgm:pt>
    <dgm:pt modelId="{1CC6C369-6E50-42DA-A881-F2FD7708779E}" type="pres">
      <dgm:prSet presAssocID="{0CC02BC8-A818-4832-81BB-32F3133B8621}" presName="connTx" presStyleLbl="parChTrans1D3" presStyleIdx="10" presStyleCnt="29"/>
      <dgm:spPr/>
    </dgm:pt>
    <dgm:pt modelId="{509B91C6-26BD-453B-AB33-E3A76B562994}" type="pres">
      <dgm:prSet presAssocID="{ECD62ED1-5D11-481E-9BBC-AB020A2EFAFF}" presName="root2" presStyleCnt="0"/>
      <dgm:spPr/>
    </dgm:pt>
    <dgm:pt modelId="{BF83AAD4-9518-47AA-835D-A40E2C49AF13}" type="pres">
      <dgm:prSet presAssocID="{ECD62ED1-5D11-481E-9BBC-AB020A2EFAFF}" presName="LevelTwoTextNode" presStyleLbl="node3" presStyleIdx="10" presStyleCnt="29" custScaleX="1130226" custScaleY="246836" custLinFactX="-400000" custLinFactY="141617" custLinFactNeighborX="-400170" custLinFactNeighborY="200000">
        <dgm:presLayoutVars>
          <dgm:chPref val="3"/>
        </dgm:presLayoutVars>
      </dgm:prSet>
      <dgm:spPr/>
    </dgm:pt>
    <dgm:pt modelId="{372B43B3-F831-4836-9D42-D22FD7E162E2}" type="pres">
      <dgm:prSet presAssocID="{ECD62ED1-5D11-481E-9BBC-AB020A2EFAFF}" presName="level3hierChild" presStyleCnt="0"/>
      <dgm:spPr/>
    </dgm:pt>
    <dgm:pt modelId="{12649787-8B1A-4097-B62E-BBC1879F2014}" type="pres">
      <dgm:prSet presAssocID="{72696429-0052-4BF2-A3D6-BBDE6FE074F3}" presName="conn2-1" presStyleLbl="parChTrans1D3" presStyleIdx="11" presStyleCnt="29" custSzX="14400016"/>
      <dgm:spPr/>
    </dgm:pt>
    <dgm:pt modelId="{D70BE76E-DF8A-41C7-B32C-B201D4602719}" type="pres">
      <dgm:prSet presAssocID="{72696429-0052-4BF2-A3D6-BBDE6FE074F3}" presName="connTx" presStyleLbl="parChTrans1D3" presStyleIdx="11" presStyleCnt="29"/>
      <dgm:spPr/>
    </dgm:pt>
    <dgm:pt modelId="{6FBA47E0-66A4-4DA5-A275-39BDD110ECB7}" type="pres">
      <dgm:prSet presAssocID="{B9C65307-6730-4D84-A9EC-F5E07D061332}" presName="root2" presStyleCnt="0"/>
      <dgm:spPr/>
    </dgm:pt>
    <dgm:pt modelId="{D4B8489D-29A0-450D-846E-6780D2436C16}" type="pres">
      <dgm:prSet presAssocID="{B9C65307-6730-4D84-A9EC-F5E07D061332}" presName="LevelTwoTextNode" presStyleLbl="node3" presStyleIdx="11" presStyleCnt="29" custScaleX="1130226" custScaleY="246598" custLinFactX="-400000" custLinFactY="164272" custLinFactNeighborX="-401532" custLinFactNeighborY="200000">
        <dgm:presLayoutVars>
          <dgm:chPref val="3"/>
        </dgm:presLayoutVars>
      </dgm:prSet>
      <dgm:spPr/>
    </dgm:pt>
    <dgm:pt modelId="{359345A4-19E5-49DB-8245-6F2492C61000}" type="pres">
      <dgm:prSet presAssocID="{B9C65307-6730-4D84-A9EC-F5E07D061332}" presName="level3hierChild" presStyleCnt="0"/>
      <dgm:spPr/>
    </dgm:pt>
    <dgm:pt modelId="{87A49760-64CE-4CBD-BF78-45B22D2A4949}" type="pres">
      <dgm:prSet presAssocID="{5E84A072-2EA0-45DE-B57C-DA217CA13318}" presName="conn2-1" presStyleLbl="parChTrans1D3" presStyleIdx="12" presStyleCnt="29" custSzX="14400032"/>
      <dgm:spPr/>
    </dgm:pt>
    <dgm:pt modelId="{894D3D26-1468-4F2C-88F6-01751D8C7D69}" type="pres">
      <dgm:prSet presAssocID="{5E84A072-2EA0-45DE-B57C-DA217CA13318}" presName="connTx" presStyleLbl="parChTrans1D3" presStyleIdx="12" presStyleCnt="29"/>
      <dgm:spPr/>
    </dgm:pt>
    <dgm:pt modelId="{0B54FA82-637D-47AA-AA43-07DF2CC550CF}" type="pres">
      <dgm:prSet presAssocID="{3E305254-2A1B-4466-9716-16D92D48BD39}" presName="root2" presStyleCnt="0"/>
      <dgm:spPr/>
    </dgm:pt>
    <dgm:pt modelId="{C50E5B3A-B9FE-43B9-85D2-DC2953853106}" type="pres">
      <dgm:prSet presAssocID="{3E305254-2A1B-4466-9716-16D92D48BD39}" presName="LevelTwoTextNode" presStyleLbl="node3" presStyleIdx="12" presStyleCnt="29" custScaleX="1130226" custScaleY="246839" custLinFactX="-400000" custLinFactY="176389" custLinFactNeighborX="-401532" custLinFactNeighborY="200000">
        <dgm:presLayoutVars>
          <dgm:chPref val="3"/>
        </dgm:presLayoutVars>
      </dgm:prSet>
      <dgm:spPr/>
    </dgm:pt>
    <dgm:pt modelId="{55980929-F735-4B98-A398-02108F7A9B12}" type="pres">
      <dgm:prSet presAssocID="{3E305254-2A1B-4466-9716-16D92D48BD39}" presName="level3hierChild" presStyleCnt="0"/>
      <dgm:spPr/>
    </dgm:pt>
    <dgm:pt modelId="{FC687F4F-95AF-4388-A390-2F0E64666848}" type="pres">
      <dgm:prSet presAssocID="{1930F7C4-5EB2-4BFC-B652-6F6645AD8029}" presName="conn2-1" presStyleLbl="parChTrans1D3" presStyleIdx="13" presStyleCnt="29" custSzX="14400056"/>
      <dgm:spPr/>
    </dgm:pt>
    <dgm:pt modelId="{94C13FA5-1561-4553-ADA9-69D482E5248A}" type="pres">
      <dgm:prSet presAssocID="{1930F7C4-5EB2-4BFC-B652-6F6645AD8029}" presName="connTx" presStyleLbl="parChTrans1D3" presStyleIdx="13" presStyleCnt="29"/>
      <dgm:spPr/>
    </dgm:pt>
    <dgm:pt modelId="{33E788E1-A069-4A13-98BB-73D866B82E71}" type="pres">
      <dgm:prSet presAssocID="{AB141E1E-8A47-473D-BDC9-A740AE0EA3F7}" presName="root2" presStyleCnt="0"/>
      <dgm:spPr/>
    </dgm:pt>
    <dgm:pt modelId="{D7C3B540-AAE3-47B6-8689-6F42331FBB0D}" type="pres">
      <dgm:prSet presAssocID="{AB141E1E-8A47-473D-BDC9-A740AE0EA3F7}" presName="LevelTwoTextNode" presStyleLbl="node3" presStyleIdx="13" presStyleCnt="29" custScaleX="1130226" custScaleY="246836" custLinFactX="-400000" custLinFactY="200000" custLinFactNeighborX="-401060" custLinFactNeighborY="200681">
        <dgm:presLayoutVars>
          <dgm:chPref val="3"/>
        </dgm:presLayoutVars>
      </dgm:prSet>
      <dgm:spPr/>
    </dgm:pt>
    <dgm:pt modelId="{85CD2B0D-0C87-4BEE-9E1C-E0A79E674051}" type="pres">
      <dgm:prSet presAssocID="{AB141E1E-8A47-473D-BDC9-A740AE0EA3F7}" presName="level3hierChild" presStyleCnt="0"/>
      <dgm:spPr/>
    </dgm:pt>
    <dgm:pt modelId="{91683DB7-5821-4F63-939D-8271AEDB1AC2}" type="pres">
      <dgm:prSet presAssocID="{579F7746-AF17-435C-A54C-9C6E6EE94B1D}" presName="conn2-1" presStyleLbl="parChTrans1D2" presStyleIdx="3" presStyleCnt="5" custSzX="14400002"/>
      <dgm:spPr/>
    </dgm:pt>
    <dgm:pt modelId="{D9B96937-FBE0-4586-A2C5-BC85D2155D05}" type="pres">
      <dgm:prSet presAssocID="{579F7746-AF17-435C-A54C-9C6E6EE94B1D}" presName="connTx" presStyleLbl="parChTrans1D2" presStyleIdx="3" presStyleCnt="5"/>
      <dgm:spPr/>
    </dgm:pt>
    <dgm:pt modelId="{EE01913B-A6F0-42CE-AF5A-9DEAF5D8DBB0}" type="pres">
      <dgm:prSet presAssocID="{4DCC093E-5118-4588-BF05-784A120C438E}" presName="root2" presStyleCnt="0"/>
      <dgm:spPr/>
    </dgm:pt>
    <dgm:pt modelId="{DDCB18A7-5217-498E-8109-AEC8891AEF63}" type="pres">
      <dgm:prSet presAssocID="{4DCC093E-5118-4588-BF05-784A120C438E}" presName="LevelTwoTextNode" presStyleLbl="node2" presStyleIdx="3" presStyleCnt="5" custScaleX="1120331" custScaleY="259713" custLinFactX="-554526" custLinFactY="-122905" custLinFactNeighborX="-600000" custLinFactNeighborY="-200000">
        <dgm:presLayoutVars>
          <dgm:chPref val="3"/>
        </dgm:presLayoutVars>
      </dgm:prSet>
      <dgm:spPr/>
    </dgm:pt>
    <dgm:pt modelId="{B02E7AF6-66DA-4252-B52D-833FA55306E0}" type="pres">
      <dgm:prSet presAssocID="{4DCC093E-5118-4588-BF05-784A120C438E}" presName="level3hierChild" presStyleCnt="0"/>
      <dgm:spPr/>
    </dgm:pt>
    <dgm:pt modelId="{87C9AC31-CDDE-4E1F-B79F-69064C460489}" type="pres">
      <dgm:prSet presAssocID="{CEA4C598-03BA-4196-8096-D8D9940A747B}" presName="conn2-1" presStyleLbl="parChTrans1D3" presStyleIdx="14" presStyleCnt="29" custSzX="14400004"/>
      <dgm:spPr/>
    </dgm:pt>
    <dgm:pt modelId="{EBD2F8EB-D76E-4ECE-AD86-C67210D41D3D}" type="pres">
      <dgm:prSet presAssocID="{CEA4C598-03BA-4196-8096-D8D9940A747B}" presName="connTx" presStyleLbl="parChTrans1D3" presStyleIdx="14" presStyleCnt="29"/>
      <dgm:spPr/>
    </dgm:pt>
    <dgm:pt modelId="{18B3E9C4-212E-4910-9E2D-34244862C8BF}" type="pres">
      <dgm:prSet presAssocID="{B8C47AF5-72F4-4882-A03A-756E7DB0314D}" presName="root2" presStyleCnt="0"/>
      <dgm:spPr/>
    </dgm:pt>
    <dgm:pt modelId="{BD9D8B61-1FCA-4DBF-95E6-59B9130798B9}" type="pres">
      <dgm:prSet presAssocID="{B8C47AF5-72F4-4882-A03A-756E7DB0314D}" presName="LevelTwoTextNode" presStyleLbl="node3" presStyleIdx="14" presStyleCnt="29" custScaleX="1277267" custScaleY="262772" custLinFactX="500000" custLinFactY="-50521" custLinFactNeighborX="583979" custLinFactNeighborY="-100000">
        <dgm:presLayoutVars>
          <dgm:chPref val="3"/>
        </dgm:presLayoutVars>
      </dgm:prSet>
      <dgm:spPr/>
    </dgm:pt>
    <dgm:pt modelId="{518C82D6-093F-4ABC-ABE5-99666F772EAD}" type="pres">
      <dgm:prSet presAssocID="{B8C47AF5-72F4-4882-A03A-756E7DB0314D}" presName="level3hierChild" presStyleCnt="0"/>
      <dgm:spPr/>
    </dgm:pt>
    <dgm:pt modelId="{56FAFC49-D0EA-4E25-8D48-7123A498BD9B}" type="pres">
      <dgm:prSet presAssocID="{C1EACDD7-D989-416D-9681-817FEB9BF90B}" presName="conn2-1" presStyleLbl="parChTrans1D3" presStyleIdx="15" presStyleCnt="29" custSzX="14400008"/>
      <dgm:spPr/>
    </dgm:pt>
    <dgm:pt modelId="{69674B81-12B1-4530-81E5-B46611BDEBD3}" type="pres">
      <dgm:prSet presAssocID="{C1EACDD7-D989-416D-9681-817FEB9BF90B}" presName="connTx" presStyleLbl="parChTrans1D3" presStyleIdx="15" presStyleCnt="29"/>
      <dgm:spPr/>
    </dgm:pt>
    <dgm:pt modelId="{AC80BB0E-C09A-4A3A-A6DC-68DD0D75747A}" type="pres">
      <dgm:prSet presAssocID="{3B6E185B-6A1C-411C-B39C-F27A6010733C}" presName="root2" presStyleCnt="0"/>
      <dgm:spPr/>
    </dgm:pt>
    <dgm:pt modelId="{E730F18F-48B0-4E0B-9A8D-D539E63CE9D4}" type="pres">
      <dgm:prSet presAssocID="{3B6E185B-6A1C-411C-B39C-F27A6010733C}" presName="LevelTwoTextNode" presStyleLbl="node3" presStyleIdx="15" presStyleCnt="29" custScaleX="1277267" custScaleY="278677" custLinFactX="500000" custLinFactY="-25549" custLinFactNeighborX="582437" custLinFactNeighborY="-100000">
        <dgm:presLayoutVars>
          <dgm:chPref val="3"/>
        </dgm:presLayoutVars>
      </dgm:prSet>
      <dgm:spPr/>
    </dgm:pt>
    <dgm:pt modelId="{360EA3B4-0F47-4D6B-A63D-BB2A4077DE52}" type="pres">
      <dgm:prSet presAssocID="{3B6E185B-6A1C-411C-B39C-F27A6010733C}" presName="level3hierChild" presStyleCnt="0"/>
      <dgm:spPr/>
    </dgm:pt>
    <dgm:pt modelId="{04B5A4E1-0824-444B-B0DF-49A3641E7799}" type="pres">
      <dgm:prSet presAssocID="{1A36E4A0-3C95-4A7E-8403-6FC00333987E}" presName="conn2-1" presStyleLbl="parChTrans1D4" presStyleIdx="7" presStyleCnt="9" custSzX="14400028"/>
      <dgm:spPr/>
    </dgm:pt>
    <dgm:pt modelId="{272D572E-5B26-4488-A75D-C75C5F075451}" type="pres">
      <dgm:prSet presAssocID="{1A36E4A0-3C95-4A7E-8403-6FC00333987E}" presName="connTx" presStyleLbl="parChTrans1D4" presStyleIdx="7" presStyleCnt="9"/>
      <dgm:spPr/>
    </dgm:pt>
    <dgm:pt modelId="{19108BD8-503D-4075-A1CF-53550D590BD4}" type="pres">
      <dgm:prSet presAssocID="{0EF4F3AF-041E-4FDF-983F-FF187C733655}" presName="root2" presStyleCnt="0"/>
      <dgm:spPr/>
    </dgm:pt>
    <dgm:pt modelId="{4DCF8B3D-4AC6-4BA4-83D6-71D9BD5CEED2}" type="pres">
      <dgm:prSet presAssocID="{0EF4F3AF-041E-4FDF-983F-FF187C733655}" presName="LevelTwoTextNode" presStyleLbl="node4" presStyleIdx="7" presStyleCnt="9" custScaleX="1277268" custScaleY="246718" custLinFactX="600000" custLinFactY="52554" custLinFactNeighborX="693931" custLinFactNeighborY="100000">
        <dgm:presLayoutVars>
          <dgm:chPref val="3"/>
        </dgm:presLayoutVars>
      </dgm:prSet>
      <dgm:spPr/>
    </dgm:pt>
    <dgm:pt modelId="{D35E8196-0F33-4D66-8A3D-9E7CA82C9867}" type="pres">
      <dgm:prSet presAssocID="{0EF4F3AF-041E-4FDF-983F-FF187C733655}" presName="level3hierChild" presStyleCnt="0"/>
      <dgm:spPr/>
    </dgm:pt>
    <dgm:pt modelId="{4422E06E-D77E-4F56-8840-95885C852043}" type="pres">
      <dgm:prSet presAssocID="{425A3179-1413-4460-9678-40448B2E5A42}" presName="conn2-1" presStyleLbl="parChTrans1D4" presStyleIdx="8" presStyleCnt="9" custSzX="14400023"/>
      <dgm:spPr/>
    </dgm:pt>
    <dgm:pt modelId="{78BB6245-6919-431D-8F6D-FEFDFE3AC3B2}" type="pres">
      <dgm:prSet presAssocID="{425A3179-1413-4460-9678-40448B2E5A42}" presName="connTx" presStyleLbl="parChTrans1D4" presStyleIdx="8" presStyleCnt="9"/>
      <dgm:spPr/>
    </dgm:pt>
    <dgm:pt modelId="{D65C5CDD-56AD-44ED-96AA-F28E3AD2C69B}" type="pres">
      <dgm:prSet presAssocID="{85CA1953-8DEE-44BB-BE58-B97A59C65C13}" presName="root2" presStyleCnt="0"/>
      <dgm:spPr/>
    </dgm:pt>
    <dgm:pt modelId="{63E06D80-B4DA-4AF5-B318-48676A80383C}" type="pres">
      <dgm:prSet presAssocID="{85CA1953-8DEE-44BB-BE58-B97A59C65C13}" presName="LevelTwoTextNode" presStyleLbl="node4" presStyleIdx="8" presStyleCnt="9" custScaleX="1277268" custScaleY="246720" custLinFactX="600000" custLinFactY="-200000" custLinFactNeighborX="693259" custLinFactNeighborY="-213594">
        <dgm:presLayoutVars>
          <dgm:chPref val="3"/>
        </dgm:presLayoutVars>
      </dgm:prSet>
      <dgm:spPr/>
    </dgm:pt>
    <dgm:pt modelId="{FF8F3D66-F4A7-4E59-9130-E75CEE01CEC5}" type="pres">
      <dgm:prSet presAssocID="{85CA1953-8DEE-44BB-BE58-B97A59C65C13}" presName="level3hierChild" presStyleCnt="0"/>
      <dgm:spPr/>
    </dgm:pt>
    <dgm:pt modelId="{82D2DBC9-D5F1-41B2-B475-FC62C3A7004B}" type="pres">
      <dgm:prSet presAssocID="{21F29C5E-B439-428D-89D6-0B6C5058BC6D}" presName="conn2-1" presStyleLbl="parChTrans1D3" presStyleIdx="16" presStyleCnt="29" custSzX="14400012"/>
      <dgm:spPr/>
    </dgm:pt>
    <dgm:pt modelId="{14C8F2DC-5402-4C02-AEC9-5324C6C4963A}" type="pres">
      <dgm:prSet presAssocID="{21F29C5E-B439-428D-89D6-0B6C5058BC6D}" presName="connTx" presStyleLbl="parChTrans1D3" presStyleIdx="16" presStyleCnt="29"/>
      <dgm:spPr/>
    </dgm:pt>
    <dgm:pt modelId="{939F4CFE-8C60-446F-BA29-9CB807C1727D}" type="pres">
      <dgm:prSet presAssocID="{41D6EC2F-3103-40F0-AD9A-B96A94477A77}" presName="root2" presStyleCnt="0"/>
      <dgm:spPr/>
    </dgm:pt>
    <dgm:pt modelId="{481798CD-BDE5-4B57-B01A-E2CEFF5196BF}" type="pres">
      <dgm:prSet presAssocID="{41D6EC2F-3103-40F0-AD9A-B96A94477A77}" presName="LevelTwoTextNode" presStyleLbl="node3" presStyleIdx="16" presStyleCnt="29" custScaleX="1277267" custScaleY="262770" custLinFactX="500000" custLinFactY="-9035" custLinFactNeighborX="581596" custLinFactNeighborY="-100000">
        <dgm:presLayoutVars>
          <dgm:chPref val="3"/>
        </dgm:presLayoutVars>
      </dgm:prSet>
      <dgm:spPr/>
    </dgm:pt>
    <dgm:pt modelId="{B42E1832-2937-4B92-8923-31358112F338}" type="pres">
      <dgm:prSet presAssocID="{41D6EC2F-3103-40F0-AD9A-B96A94477A77}" presName="level3hierChild" presStyleCnt="0"/>
      <dgm:spPr/>
    </dgm:pt>
    <dgm:pt modelId="{22457488-96D2-492A-A67D-1DA42B35C92F}" type="pres">
      <dgm:prSet presAssocID="{760F7733-46EF-4539-A2FB-454CD8F95E50}" presName="conn2-1" presStyleLbl="parChTrans1D3" presStyleIdx="17" presStyleCnt="29" custSzX="14400001"/>
      <dgm:spPr/>
    </dgm:pt>
    <dgm:pt modelId="{7E42A3E7-F188-48F4-99B5-B1F4D367F825}" type="pres">
      <dgm:prSet presAssocID="{760F7733-46EF-4539-A2FB-454CD8F95E50}" presName="connTx" presStyleLbl="parChTrans1D3" presStyleIdx="17" presStyleCnt="29"/>
      <dgm:spPr/>
    </dgm:pt>
    <dgm:pt modelId="{40E1F38D-F838-4B3A-8959-C57390990E61}" type="pres">
      <dgm:prSet presAssocID="{F576FE14-F223-4751-B256-BF313602C91E}" presName="root2" presStyleCnt="0"/>
      <dgm:spPr/>
    </dgm:pt>
    <dgm:pt modelId="{DC301E58-40D8-4D3D-9A40-BAA0C92BDE59}" type="pres">
      <dgm:prSet presAssocID="{F576FE14-F223-4751-B256-BF313602C91E}" presName="LevelTwoTextNode" presStyleLbl="node3" presStyleIdx="17" presStyleCnt="29" custScaleX="1277267" custScaleY="278677" custLinFactX="500000" custLinFactNeighborX="587880" custLinFactNeighborY="-91685">
        <dgm:presLayoutVars>
          <dgm:chPref val="3"/>
        </dgm:presLayoutVars>
      </dgm:prSet>
      <dgm:spPr/>
    </dgm:pt>
    <dgm:pt modelId="{F06368F7-EC0F-4A1D-9A8E-247D54BEDDBC}" type="pres">
      <dgm:prSet presAssocID="{F576FE14-F223-4751-B256-BF313602C91E}" presName="level3hierChild" presStyleCnt="0"/>
      <dgm:spPr/>
    </dgm:pt>
    <dgm:pt modelId="{2E231434-ED7F-44D1-8C73-4DA73C333BE6}" type="pres">
      <dgm:prSet presAssocID="{F79E2E4E-D09E-4761-9D42-D0B633170619}" presName="conn2-1" presStyleLbl="parChTrans1D3" presStyleIdx="18" presStyleCnt="29" custSzX="14400008"/>
      <dgm:spPr/>
    </dgm:pt>
    <dgm:pt modelId="{1DF7A0FE-D847-4A6C-886A-53CFFF4E83C7}" type="pres">
      <dgm:prSet presAssocID="{F79E2E4E-D09E-4761-9D42-D0B633170619}" presName="connTx" presStyleLbl="parChTrans1D3" presStyleIdx="18" presStyleCnt="29"/>
      <dgm:spPr/>
    </dgm:pt>
    <dgm:pt modelId="{BE8A502F-FC97-4D68-B5C8-EF15A6D273CA}" type="pres">
      <dgm:prSet presAssocID="{B18AAAC7-07A3-44B8-A053-45D1FF816FFD}" presName="root2" presStyleCnt="0"/>
      <dgm:spPr/>
    </dgm:pt>
    <dgm:pt modelId="{665072C3-8ADE-40C1-BDA5-4FAA68E4319F}" type="pres">
      <dgm:prSet presAssocID="{B18AAAC7-07A3-44B8-A053-45D1FF816FFD}" presName="LevelTwoTextNode" presStyleLbl="node3" presStyleIdx="18" presStyleCnt="29" custScaleX="1277267" custScaleY="262772" custLinFactX="500000" custLinFactNeighborX="582466" custLinFactNeighborY="-81307">
        <dgm:presLayoutVars>
          <dgm:chPref val="3"/>
        </dgm:presLayoutVars>
      </dgm:prSet>
      <dgm:spPr/>
    </dgm:pt>
    <dgm:pt modelId="{351C6D74-3715-400D-811D-2BFE8ADB6101}" type="pres">
      <dgm:prSet presAssocID="{B18AAAC7-07A3-44B8-A053-45D1FF816FFD}" presName="level3hierChild" presStyleCnt="0"/>
      <dgm:spPr/>
    </dgm:pt>
    <dgm:pt modelId="{134D7A88-2D4D-4FE0-A203-5D2DFDE9B8B0}" type="pres">
      <dgm:prSet presAssocID="{010FD920-EA56-439A-976D-37845A8E9EE8}" presName="conn2-1" presStyleLbl="parChTrans1D3" presStyleIdx="19" presStyleCnt="29" custSzX="14400004"/>
      <dgm:spPr/>
    </dgm:pt>
    <dgm:pt modelId="{E34F5E68-97F6-448B-93CC-7F50A4D760A8}" type="pres">
      <dgm:prSet presAssocID="{010FD920-EA56-439A-976D-37845A8E9EE8}" presName="connTx" presStyleLbl="parChTrans1D3" presStyleIdx="19" presStyleCnt="29"/>
      <dgm:spPr/>
    </dgm:pt>
    <dgm:pt modelId="{F778CF73-89A3-42BA-AB6F-C2C1BC63090E}" type="pres">
      <dgm:prSet presAssocID="{E7091F61-EB43-4F07-B67B-2EE2EED76652}" presName="root2" presStyleCnt="0"/>
      <dgm:spPr/>
    </dgm:pt>
    <dgm:pt modelId="{3E90B72A-F33B-4C19-AA15-D10953CC4340}" type="pres">
      <dgm:prSet presAssocID="{E7091F61-EB43-4F07-B67B-2EE2EED76652}" presName="LevelTwoTextNode" presStyleLbl="node3" presStyleIdx="19" presStyleCnt="29" custAng="10800000" custFlipVert="1" custScaleX="1277267" custScaleY="262773" custLinFactX="500000" custLinFactNeighborX="586252" custLinFactNeighborY="-51376">
        <dgm:presLayoutVars>
          <dgm:chPref val="3"/>
        </dgm:presLayoutVars>
      </dgm:prSet>
      <dgm:spPr/>
    </dgm:pt>
    <dgm:pt modelId="{D524E27F-D99E-41B2-BF90-B4E8FC5E68DB}" type="pres">
      <dgm:prSet presAssocID="{E7091F61-EB43-4F07-B67B-2EE2EED76652}" presName="level3hierChild" presStyleCnt="0"/>
      <dgm:spPr/>
    </dgm:pt>
    <dgm:pt modelId="{CBE2BF13-B4B2-4CCE-B9CD-9C2AE1DB9827}" type="pres">
      <dgm:prSet presAssocID="{2F8F9AB3-8452-43EC-87B2-17B5891BF608}" presName="conn2-1" presStyleLbl="parChTrans1D3" presStyleIdx="20" presStyleCnt="29" custSzX="14400007"/>
      <dgm:spPr/>
    </dgm:pt>
    <dgm:pt modelId="{BCDDDD5C-AFED-4205-A736-CCA5522531A5}" type="pres">
      <dgm:prSet presAssocID="{2F8F9AB3-8452-43EC-87B2-17B5891BF608}" presName="connTx" presStyleLbl="parChTrans1D3" presStyleIdx="20" presStyleCnt="29"/>
      <dgm:spPr/>
    </dgm:pt>
    <dgm:pt modelId="{D82F3EC8-11FE-44FB-A347-97A3FBA6D574}" type="pres">
      <dgm:prSet presAssocID="{8598F285-6469-41DF-8C80-D94935C42364}" presName="root2" presStyleCnt="0"/>
      <dgm:spPr/>
    </dgm:pt>
    <dgm:pt modelId="{48E4B145-A01E-4F97-9B06-6C33D2269A47}" type="pres">
      <dgm:prSet presAssocID="{8598F285-6469-41DF-8C80-D94935C42364}" presName="LevelTwoTextNode" presStyleLbl="node3" presStyleIdx="20" presStyleCnt="29" custScaleX="1277267" custScaleY="262770" custLinFactX="500000" custLinFactNeighborX="582469" custLinFactNeighborY="-28253">
        <dgm:presLayoutVars>
          <dgm:chPref val="3"/>
        </dgm:presLayoutVars>
      </dgm:prSet>
      <dgm:spPr/>
    </dgm:pt>
    <dgm:pt modelId="{47268DB0-FBEE-4541-9325-FAEE019D20F8}" type="pres">
      <dgm:prSet presAssocID="{8598F285-6469-41DF-8C80-D94935C42364}" presName="level3hierChild" presStyleCnt="0"/>
      <dgm:spPr/>
    </dgm:pt>
    <dgm:pt modelId="{92D0DEB7-F9E3-4085-A056-1B4AA5D907F0}" type="pres">
      <dgm:prSet presAssocID="{7D4974A8-D315-42CC-B9BB-A3A5CD5225A3}" presName="conn2-1" presStyleLbl="parChTrans1D3" presStyleIdx="21" presStyleCnt="29" custSzX="14400007"/>
      <dgm:spPr/>
    </dgm:pt>
    <dgm:pt modelId="{D5CD040A-B516-438A-972F-8ED8CDC5F1F6}" type="pres">
      <dgm:prSet presAssocID="{7D4974A8-D315-42CC-B9BB-A3A5CD5225A3}" presName="connTx" presStyleLbl="parChTrans1D3" presStyleIdx="21" presStyleCnt="29"/>
      <dgm:spPr/>
    </dgm:pt>
    <dgm:pt modelId="{53EE630F-B50A-4E44-9F26-7A437E403F30}" type="pres">
      <dgm:prSet presAssocID="{4C4B97E3-F5BD-4198-B4CF-00796D7DABC4}" presName="root2" presStyleCnt="0"/>
      <dgm:spPr/>
    </dgm:pt>
    <dgm:pt modelId="{0F72C090-6894-4EAC-91C9-4AB4F7819088}" type="pres">
      <dgm:prSet presAssocID="{4C4B97E3-F5BD-4198-B4CF-00796D7DABC4}" presName="LevelTwoTextNode" presStyleLbl="node3" presStyleIdx="21" presStyleCnt="29" custScaleX="1277267" custScaleY="262772" custLinFactX="500000" custLinFactNeighborX="580844" custLinFactNeighborY="2346">
        <dgm:presLayoutVars>
          <dgm:chPref val="3"/>
        </dgm:presLayoutVars>
      </dgm:prSet>
      <dgm:spPr/>
    </dgm:pt>
    <dgm:pt modelId="{29CFB243-3B0B-48A1-BA31-68AEECA8538E}" type="pres">
      <dgm:prSet presAssocID="{4C4B97E3-F5BD-4198-B4CF-00796D7DABC4}" presName="level3hierChild" presStyleCnt="0"/>
      <dgm:spPr/>
    </dgm:pt>
    <dgm:pt modelId="{6AB18905-010D-4722-AD52-A8029684E429}" type="pres">
      <dgm:prSet presAssocID="{AA6D12B2-DCA4-4A02-AF03-C8580B7BB7CB}" presName="conn2-1" presStyleLbl="parChTrans1D3" presStyleIdx="22" presStyleCnt="29" custSzX="14400001"/>
      <dgm:spPr/>
    </dgm:pt>
    <dgm:pt modelId="{029D14F4-73D5-48A5-9409-1B7CD1A98ED4}" type="pres">
      <dgm:prSet presAssocID="{AA6D12B2-DCA4-4A02-AF03-C8580B7BB7CB}" presName="connTx" presStyleLbl="parChTrans1D3" presStyleIdx="22" presStyleCnt="29"/>
      <dgm:spPr/>
    </dgm:pt>
    <dgm:pt modelId="{7543E19F-1B2D-40F5-8A03-204EE3BF2B6C}" type="pres">
      <dgm:prSet presAssocID="{C8881E16-4787-451C-81F6-A6E1C5F25824}" presName="root2" presStyleCnt="0"/>
      <dgm:spPr/>
    </dgm:pt>
    <dgm:pt modelId="{93ED179E-6CE9-427B-AFAE-295FB95A4083}" type="pres">
      <dgm:prSet presAssocID="{C8881E16-4787-451C-81F6-A6E1C5F25824}" presName="LevelTwoTextNode" presStyleLbl="node3" presStyleIdx="22" presStyleCnt="29" custScaleX="1277267" custScaleY="262770" custLinFactX="500000" custLinFactNeighborX="582256" custLinFactNeighborY="37772">
        <dgm:presLayoutVars>
          <dgm:chPref val="3"/>
        </dgm:presLayoutVars>
      </dgm:prSet>
      <dgm:spPr/>
    </dgm:pt>
    <dgm:pt modelId="{2A0D38E4-EC3B-4BAE-ADB2-23C127B643DB}" type="pres">
      <dgm:prSet presAssocID="{C8881E16-4787-451C-81F6-A6E1C5F25824}" presName="level3hierChild" presStyleCnt="0"/>
      <dgm:spPr/>
    </dgm:pt>
    <dgm:pt modelId="{B3990D9E-965A-4A87-9024-A31D8C18D9AC}" type="pres">
      <dgm:prSet presAssocID="{A7EB2E53-A0F7-41F9-9F6A-A28410E699DB}" presName="conn2-1" presStyleLbl="parChTrans1D3" presStyleIdx="23" presStyleCnt="29" custSzX="14400005"/>
      <dgm:spPr/>
    </dgm:pt>
    <dgm:pt modelId="{C4665A5D-7A69-4FC2-9029-35B5452AAAD6}" type="pres">
      <dgm:prSet presAssocID="{A7EB2E53-A0F7-41F9-9F6A-A28410E699DB}" presName="connTx" presStyleLbl="parChTrans1D3" presStyleIdx="23" presStyleCnt="29"/>
      <dgm:spPr/>
    </dgm:pt>
    <dgm:pt modelId="{F5AD516C-03B4-44A2-8D7F-A01D980EC8F6}" type="pres">
      <dgm:prSet presAssocID="{1AACD66D-838A-4857-A8DC-3EF6272EECE2}" presName="root2" presStyleCnt="0"/>
      <dgm:spPr/>
    </dgm:pt>
    <dgm:pt modelId="{55C48720-204C-4364-9D3A-54C5764186B5}" type="pres">
      <dgm:prSet presAssocID="{1AACD66D-838A-4857-A8DC-3EF6272EECE2}" presName="LevelTwoTextNode" presStyleLbl="node3" presStyleIdx="23" presStyleCnt="29" custScaleX="1277267" custScaleY="262770" custLinFactX="500000" custLinFactNeighborX="580647" custLinFactNeighborY="67622">
        <dgm:presLayoutVars>
          <dgm:chPref val="3"/>
        </dgm:presLayoutVars>
      </dgm:prSet>
      <dgm:spPr/>
    </dgm:pt>
    <dgm:pt modelId="{6F03AD0E-EAEA-491F-81D8-AED0C9D56D57}" type="pres">
      <dgm:prSet presAssocID="{1AACD66D-838A-4857-A8DC-3EF6272EECE2}" presName="level3hierChild" presStyleCnt="0"/>
      <dgm:spPr/>
    </dgm:pt>
    <dgm:pt modelId="{77548836-C3C7-4F26-AB2C-7B9D48F92339}" type="pres">
      <dgm:prSet presAssocID="{AF9EC442-AE64-421C-9DF3-0ED0B18D4EC6}" presName="conn2-1" presStyleLbl="parChTrans1D3" presStyleIdx="24" presStyleCnt="29" custSzX="14400004"/>
      <dgm:spPr/>
    </dgm:pt>
    <dgm:pt modelId="{D315BFC2-F4AA-453C-BEEE-7A8513151049}" type="pres">
      <dgm:prSet presAssocID="{AF9EC442-AE64-421C-9DF3-0ED0B18D4EC6}" presName="connTx" presStyleLbl="parChTrans1D3" presStyleIdx="24" presStyleCnt="29"/>
      <dgm:spPr/>
    </dgm:pt>
    <dgm:pt modelId="{5C1C1437-237B-4D2F-972C-182C150A65D7}" type="pres">
      <dgm:prSet presAssocID="{139D31B5-E436-4EC0-97A7-7F66DB8AA5D7}" presName="root2" presStyleCnt="0"/>
      <dgm:spPr/>
    </dgm:pt>
    <dgm:pt modelId="{58A40D43-4424-4837-A5A1-19217FD9A569}" type="pres">
      <dgm:prSet presAssocID="{139D31B5-E436-4EC0-97A7-7F66DB8AA5D7}" presName="LevelTwoTextNode" presStyleLbl="node3" presStyleIdx="24" presStyleCnt="29" custScaleX="1277267" custScaleY="262772" custLinFactX="500000" custLinFactNeighborX="583432" custLinFactNeighborY="94245">
        <dgm:presLayoutVars>
          <dgm:chPref val="3"/>
        </dgm:presLayoutVars>
      </dgm:prSet>
      <dgm:spPr/>
    </dgm:pt>
    <dgm:pt modelId="{1CD09DDF-64D1-4B28-B2BA-D1CA4F7E8EBD}" type="pres">
      <dgm:prSet presAssocID="{139D31B5-E436-4EC0-97A7-7F66DB8AA5D7}" presName="level3hierChild" presStyleCnt="0"/>
      <dgm:spPr/>
    </dgm:pt>
    <dgm:pt modelId="{616D48F1-5BF9-475C-A680-5A4648439758}" type="pres">
      <dgm:prSet presAssocID="{493FD3B1-4C0C-4AB6-93B7-144BA121C706}" presName="conn2-1" presStyleLbl="parChTrans1D3" presStyleIdx="25" presStyleCnt="29" custSzX="14400001"/>
      <dgm:spPr/>
    </dgm:pt>
    <dgm:pt modelId="{6A5659FF-62AA-4A8C-B658-A072CD59A9AB}" type="pres">
      <dgm:prSet presAssocID="{493FD3B1-4C0C-4AB6-93B7-144BA121C706}" presName="connTx" presStyleLbl="parChTrans1D3" presStyleIdx="25" presStyleCnt="29"/>
      <dgm:spPr/>
    </dgm:pt>
    <dgm:pt modelId="{B46B9E47-28AB-4556-93A1-61511E051437}" type="pres">
      <dgm:prSet presAssocID="{1526BD2C-5491-407F-8729-1EE2B6B3A855}" presName="root2" presStyleCnt="0"/>
      <dgm:spPr/>
    </dgm:pt>
    <dgm:pt modelId="{AC865C7C-D34F-4978-B07D-384D670F1E47}" type="pres">
      <dgm:prSet presAssocID="{1526BD2C-5491-407F-8729-1EE2B6B3A855}" presName="LevelTwoTextNode" presStyleLbl="node3" presStyleIdx="25" presStyleCnt="29" custScaleX="1277267" custScaleY="262772" custLinFactX="500000" custLinFactY="19940" custLinFactNeighborX="580653" custLinFactNeighborY="100000">
        <dgm:presLayoutVars>
          <dgm:chPref val="3"/>
        </dgm:presLayoutVars>
      </dgm:prSet>
      <dgm:spPr/>
    </dgm:pt>
    <dgm:pt modelId="{4636BF3F-FB11-41F8-AD53-27057F815E44}" type="pres">
      <dgm:prSet presAssocID="{1526BD2C-5491-407F-8729-1EE2B6B3A855}" presName="level3hierChild" presStyleCnt="0"/>
      <dgm:spPr/>
    </dgm:pt>
    <dgm:pt modelId="{0534A5B7-9C7A-4B37-8658-B389BC363051}" type="pres">
      <dgm:prSet presAssocID="{064DB9D2-173A-4CFB-BE23-C2F5395E90CE}" presName="conn2-1" presStyleLbl="parChTrans1D3" presStyleIdx="26" presStyleCnt="29" custSzX="14400001"/>
      <dgm:spPr/>
    </dgm:pt>
    <dgm:pt modelId="{57096B24-8CD4-406B-927F-3FABEDAA0D69}" type="pres">
      <dgm:prSet presAssocID="{064DB9D2-173A-4CFB-BE23-C2F5395E90CE}" presName="connTx" presStyleLbl="parChTrans1D3" presStyleIdx="26" presStyleCnt="29"/>
      <dgm:spPr/>
    </dgm:pt>
    <dgm:pt modelId="{1DE5FA74-54E7-473E-99BC-89B7AB6B71BE}" type="pres">
      <dgm:prSet presAssocID="{0427F775-9407-4A06-A301-D22BFE5F9A2F}" presName="root2" presStyleCnt="0"/>
      <dgm:spPr/>
    </dgm:pt>
    <dgm:pt modelId="{4B059EDE-FDEA-4C68-BB44-42AF88AE4840}" type="pres">
      <dgm:prSet presAssocID="{0427F775-9407-4A06-A301-D22BFE5F9A2F}" presName="LevelTwoTextNode" presStyleLbl="node3" presStyleIdx="26" presStyleCnt="29" custScaleX="1277267" custScaleY="262772" custLinFactX="500000" custLinFactY="46654" custLinFactNeighborX="579619" custLinFactNeighborY="100000">
        <dgm:presLayoutVars>
          <dgm:chPref val="3"/>
        </dgm:presLayoutVars>
      </dgm:prSet>
      <dgm:spPr/>
    </dgm:pt>
    <dgm:pt modelId="{C7AC535D-4EF6-4344-BDD7-25229982B388}" type="pres">
      <dgm:prSet presAssocID="{0427F775-9407-4A06-A301-D22BFE5F9A2F}" presName="level3hierChild" presStyleCnt="0"/>
      <dgm:spPr/>
    </dgm:pt>
    <dgm:pt modelId="{06162D70-667D-4321-A2A5-50E71EC54502}" type="pres">
      <dgm:prSet presAssocID="{895AD288-8C3F-4FEF-8348-DE71D8D3CA8C}" presName="conn2-1" presStyleLbl="parChTrans1D2" presStyleIdx="4" presStyleCnt="5" custSzX="14400010"/>
      <dgm:spPr/>
    </dgm:pt>
    <dgm:pt modelId="{9EDF16DF-0468-41C5-93DA-122D14D8465F}" type="pres">
      <dgm:prSet presAssocID="{895AD288-8C3F-4FEF-8348-DE71D8D3CA8C}" presName="connTx" presStyleLbl="parChTrans1D2" presStyleIdx="4" presStyleCnt="5"/>
      <dgm:spPr/>
    </dgm:pt>
    <dgm:pt modelId="{4E419202-E138-4240-93A2-456AC2B2742F}" type="pres">
      <dgm:prSet presAssocID="{4E60B1B3-870B-4A1B-9517-73B33DCA2C20}" presName="root2" presStyleCnt="0"/>
      <dgm:spPr/>
    </dgm:pt>
    <dgm:pt modelId="{DDF72957-287B-449A-A1C9-C4F10755C0F8}" type="pres">
      <dgm:prSet presAssocID="{4E60B1B3-870B-4A1B-9517-73B33DCA2C20}" presName="LevelTwoTextNode" presStyleLbl="node2" presStyleIdx="4" presStyleCnt="5" custScaleX="1120331" custScaleY="259713" custLinFactX="-542612" custLinFactY="-300000" custLinFactNeighborX="-600000" custLinFactNeighborY="-346569">
        <dgm:presLayoutVars>
          <dgm:chPref val="3"/>
        </dgm:presLayoutVars>
      </dgm:prSet>
      <dgm:spPr/>
    </dgm:pt>
    <dgm:pt modelId="{05ECC4B5-9675-4F0D-8C38-19D9BB077CA3}" type="pres">
      <dgm:prSet presAssocID="{4E60B1B3-870B-4A1B-9517-73B33DCA2C20}" presName="level3hierChild" presStyleCnt="0"/>
      <dgm:spPr/>
    </dgm:pt>
    <dgm:pt modelId="{39CD6B7A-D9CD-49C5-B1C3-2BF6CA65E035}" type="pres">
      <dgm:prSet presAssocID="{2A9BE497-61AC-492C-9E1D-96073DB72DE2}" presName="conn2-1" presStyleLbl="parChTrans1D3" presStyleIdx="27" presStyleCnt="29" custSzX="14400152"/>
      <dgm:spPr/>
    </dgm:pt>
    <dgm:pt modelId="{B84FD6DC-6F83-483B-A6F6-D1143D7FCD3D}" type="pres">
      <dgm:prSet presAssocID="{2A9BE497-61AC-492C-9E1D-96073DB72DE2}" presName="connTx" presStyleLbl="parChTrans1D3" presStyleIdx="27" presStyleCnt="29"/>
      <dgm:spPr/>
    </dgm:pt>
    <dgm:pt modelId="{40BB6ACB-057D-4260-AB2B-BDED580401D0}" type="pres">
      <dgm:prSet presAssocID="{89246641-77CD-487A-83F2-C7F1200B9CD3}" presName="root2" presStyleCnt="0"/>
      <dgm:spPr/>
    </dgm:pt>
    <dgm:pt modelId="{800253CE-BB59-4266-9CEA-CEBDA03E4027}" type="pres">
      <dgm:prSet presAssocID="{89246641-77CD-487A-83F2-C7F1200B9CD3}" presName="LevelTwoTextNode" presStyleLbl="node3" presStyleIdx="27" presStyleCnt="29" custScaleX="1130785" custScaleY="246719" custLinFactX="-400000" custLinFactY="-300000" custLinFactNeighborX="-433283" custLinFactNeighborY="-359027">
        <dgm:presLayoutVars>
          <dgm:chPref val="3"/>
        </dgm:presLayoutVars>
      </dgm:prSet>
      <dgm:spPr/>
    </dgm:pt>
    <dgm:pt modelId="{F411FA26-74A1-460C-ABAE-D2DD5B610286}" type="pres">
      <dgm:prSet presAssocID="{89246641-77CD-487A-83F2-C7F1200B9CD3}" presName="level3hierChild" presStyleCnt="0"/>
      <dgm:spPr/>
    </dgm:pt>
    <dgm:pt modelId="{83DAAF3F-DBF1-49B0-8604-B525FB5C908A}" type="pres">
      <dgm:prSet presAssocID="{1A98DB96-17DF-475F-B57D-AA7AEC31238C}" presName="conn2-1" presStyleLbl="parChTrans1D3" presStyleIdx="28" presStyleCnt="29" custSzX="14400131"/>
      <dgm:spPr/>
    </dgm:pt>
    <dgm:pt modelId="{3CA6E368-4B5A-4A8C-BA3F-B3AD90C9E9E9}" type="pres">
      <dgm:prSet presAssocID="{1A98DB96-17DF-475F-B57D-AA7AEC31238C}" presName="connTx" presStyleLbl="parChTrans1D3" presStyleIdx="28" presStyleCnt="29"/>
      <dgm:spPr/>
    </dgm:pt>
    <dgm:pt modelId="{7C15682E-E524-46DA-82C6-F952A81CACA0}" type="pres">
      <dgm:prSet presAssocID="{6125DCFA-27DB-435B-BEA4-88B2190500A1}" presName="root2" presStyleCnt="0"/>
      <dgm:spPr/>
    </dgm:pt>
    <dgm:pt modelId="{914215F8-CB99-49A5-92BE-A5364C5EF1A5}" type="pres">
      <dgm:prSet presAssocID="{6125DCFA-27DB-435B-BEA4-88B2190500A1}" presName="LevelTwoTextNode" presStyleLbl="node3" presStyleIdx="28" presStyleCnt="29" custScaleX="1130785" custScaleY="246718" custLinFactX="-400000" custLinFactY="-300000" custLinFactNeighborX="-433283" custLinFactNeighborY="-327747">
        <dgm:presLayoutVars>
          <dgm:chPref val="3"/>
        </dgm:presLayoutVars>
      </dgm:prSet>
      <dgm:spPr/>
    </dgm:pt>
    <dgm:pt modelId="{F6AF657D-F445-4FBE-AA16-B88EE08E3861}" type="pres">
      <dgm:prSet presAssocID="{6125DCFA-27DB-435B-BEA4-88B2190500A1}" presName="level3hierChild" presStyleCnt="0"/>
      <dgm:spPr/>
    </dgm:pt>
  </dgm:ptLst>
  <dgm:cxnLst>
    <dgm:cxn modelId="{28926F01-4C50-42E8-B91C-EB4AB276390F}" srcId="{A7E59208-D8C8-472E-BF12-F8E4CF3114A2}" destId="{3CF53495-E7A9-4FFB-983F-8FC85A5AADF1}" srcOrd="0" destOrd="0" parTransId="{96C75850-7C10-4A02-8605-049A49CD2E2D}" sibTransId="{D9F24578-11A8-4686-B575-3BEBFF1584D9}"/>
    <dgm:cxn modelId="{0A0CF701-79B2-47F2-8622-FC36046D2926}" srcId="{5E805EC3-C58D-4BD5-A99E-B5CA51F30872}" destId="{4C9D4A9F-DD4B-450F-BD60-CED00D3393A2}" srcOrd="2" destOrd="0" parTransId="{1731A452-294D-4C69-97EA-ABFB841FA0AB}" sibTransId="{71D5611E-9C7C-4282-88EB-4D6B84C36EA4}"/>
    <dgm:cxn modelId="{795F5A02-DA6A-42B0-9552-BF91B1BAF7C4}" type="presOf" srcId="{26FE1203-5ADF-4E90-A8D9-0247D9F49394}" destId="{85D196B6-063E-44EA-88B6-502D03441A95}" srcOrd="0" destOrd="0" presId="urn:microsoft.com/office/officeart/2005/8/layout/hierarchy2"/>
    <dgm:cxn modelId="{0292F002-650B-49D0-AE03-C8DDF4B97AC1}" srcId="{5BEDA607-8DED-42F2-9BA0-692D403C0EC7}" destId="{109BE932-8DDB-46FE-93F1-0C28F0100D1E}" srcOrd="4" destOrd="0" parTransId="{6F25122C-9DC2-4635-960D-7ABCFA19A050}" sibTransId="{A744AE17-7DC2-4DEE-8DD3-48BA06300DB6}"/>
    <dgm:cxn modelId="{CAFAE303-3DC3-4537-9772-86B9E5063BC8}" srcId="{4DCC093E-5118-4588-BF05-784A120C438E}" destId="{E7091F61-EB43-4F07-B67B-2EE2EED76652}" srcOrd="5" destOrd="0" parTransId="{010FD920-EA56-439A-976D-37845A8E9EE8}" sibTransId="{E9EE7CCA-3E70-4442-89A7-97C9D193AFA2}"/>
    <dgm:cxn modelId="{10E7BB04-8034-4A73-BDED-663C3B2D9FEB}" type="presOf" srcId="{84547787-FAB0-4D90-A3B1-62ECE02E3768}" destId="{740522B2-75E3-4986-BE71-6201CAF74879}" srcOrd="1" destOrd="0" presId="urn:microsoft.com/office/officeart/2005/8/layout/hierarchy2"/>
    <dgm:cxn modelId="{94199405-C4AF-4981-BB8E-1CD2D5B12077}" srcId="{26FE1203-5ADF-4E90-A8D9-0247D9F49394}" destId="{9A5197BB-7B1D-4DC8-A917-46D969DA792E}" srcOrd="0" destOrd="0" parTransId="{03C2E030-813C-4887-94E5-82269C93F63C}" sibTransId="{A996E5A6-72C3-45F3-B265-EB01532B76AD}"/>
    <dgm:cxn modelId="{CF4E620A-9AD3-4C56-8996-7BC265D0C439}" srcId="{4DCC093E-5118-4588-BF05-784A120C438E}" destId="{B18AAAC7-07A3-44B8-A053-45D1FF816FFD}" srcOrd="4" destOrd="0" parTransId="{F79E2E4E-D09E-4761-9D42-D0B633170619}" sibTransId="{72E1387F-70BB-477C-B1AA-2ABCDA2AC2A1}"/>
    <dgm:cxn modelId="{C387F40B-DFA9-474A-9874-C47292BE7553}" type="presOf" srcId="{84547787-FAB0-4D90-A3B1-62ECE02E3768}" destId="{6C074D18-1EA0-40FB-94A6-DD4C52B7D46C}" srcOrd="0" destOrd="0" presId="urn:microsoft.com/office/officeart/2005/8/layout/hierarchy2"/>
    <dgm:cxn modelId="{171C8B0C-881B-4B3B-894B-FD7D7E222816}" srcId="{4E60B1B3-870B-4A1B-9517-73B33DCA2C20}" destId="{89246641-77CD-487A-83F2-C7F1200B9CD3}" srcOrd="0" destOrd="0" parTransId="{2A9BE497-61AC-492C-9E1D-96073DB72DE2}" sibTransId="{8FE26FC0-4536-4E72-BA73-6E6DB87FDB86}"/>
    <dgm:cxn modelId="{993E970D-AEB1-4F79-A5D6-442CCF3116C7}" type="presOf" srcId="{6F25122C-9DC2-4635-960D-7ABCFA19A050}" destId="{FCAF4F74-DA65-4B57-BED5-BD3F26CA3653}" srcOrd="0" destOrd="0" presId="urn:microsoft.com/office/officeart/2005/8/layout/hierarchy2"/>
    <dgm:cxn modelId="{9386AE0E-2F7B-4B2D-A2A0-8ED89691D55E}" srcId="{5BEDA607-8DED-42F2-9BA0-692D403C0EC7}" destId="{518E9C13-B9BA-4F04-A7EC-F36C8D246639}" srcOrd="3" destOrd="0" parTransId="{FB410C4C-ACA6-43C1-94D1-C7A844E0F3B3}" sibTransId="{5BB641B2-739A-4F95-9858-A0BD6DA4CF4F}"/>
    <dgm:cxn modelId="{234F9010-5139-42E0-80F6-0F2D307A11F3}" srcId="{4DCC093E-5118-4588-BF05-784A120C438E}" destId="{0427F775-9407-4A06-A301-D22BFE5F9A2F}" srcOrd="12" destOrd="0" parTransId="{064DB9D2-173A-4CFB-BE23-C2F5395E90CE}" sibTransId="{284BA064-CA16-40B8-ABB6-39297C736969}"/>
    <dgm:cxn modelId="{DB66B812-E1E0-45FC-BB26-4974FD34809F}" srcId="{26FE1203-5ADF-4E90-A8D9-0247D9F49394}" destId="{2F02F2CE-1BCD-446E-BECB-6973E7ACA9E4}" srcOrd="1" destOrd="0" parTransId="{D40E33C4-65A6-43F0-8A5A-668871AD40F3}" sibTransId="{D22232FC-EFFC-4ED5-BFEA-E170EC048C0E}"/>
    <dgm:cxn modelId="{D8292315-BD87-4142-A496-C8850E8504B4}" type="presOf" srcId="{4C9D4A9F-DD4B-450F-BD60-CED00D3393A2}" destId="{049F2968-73E2-4348-A8D7-E885F2B2F00E}" srcOrd="0" destOrd="0" presId="urn:microsoft.com/office/officeart/2005/8/layout/hierarchy2"/>
    <dgm:cxn modelId="{A9302518-6ADB-4EFD-9798-25FD8FC5D3C1}" srcId="{F4B2B415-9F5D-4A5C-A517-33028F9EDE23}" destId="{B87C2DC1-653F-4929-9260-6C6E30534E07}" srcOrd="4" destOrd="0" parTransId="{3B2039F4-2BA1-4802-A7AA-25308413273C}" sibTransId="{D969B3C1-13FB-4D01-8F61-046C91361577}"/>
    <dgm:cxn modelId="{1714F218-14F6-4E9E-B0F3-59D39F508675}" type="presOf" srcId="{1AACD66D-838A-4857-A8DC-3EF6272EECE2}" destId="{55C48720-204C-4364-9D3A-54C5764186B5}" srcOrd="0" destOrd="0" presId="urn:microsoft.com/office/officeart/2005/8/layout/hierarchy2"/>
    <dgm:cxn modelId="{58F3D619-C819-4165-9832-15B8B47FAB73}" type="presOf" srcId="{1930F7C4-5EB2-4BFC-B652-6F6645AD8029}" destId="{FC687F4F-95AF-4388-A390-2F0E64666848}" srcOrd="0" destOrd="0" presId="urn:microsoft.com/office/officeart/2005/8/layout/hierarchy2"/>
    <dgm:cxn modelId="{53DBED19-15A7-46E9-973A-9D264D591D01}" type="presOf" srcId="{064DB9D2-173A-4CFB-BE23-C2F5395E90CE}" destId="{0534A5B7-9C7A-4B37-8658-B389BC363051}" srcOrd="0" destOrd="0" presId="urn:microsoft.com/office/officeart/2005/8/layout/hierarchy2"/>
    <dgm:cxn modelId="{05F6961A-A220-4985-B2C8-B5A6245F70D8}" type="presOf" srcId="{D40E33C4-65A6-43F0-8A5A-668871AD40F3}" destId="{16EDC4EB-15B1-4BED-A913-C4910A592E43}" srcOrd="0" destOrd="0" presId="urn:microsoft.com/office/officeart/2005/8/layout/hierarchy2"/>
    <dgm:cxn modelId="{C9F2961B-5CC2-48E5-BAEE-534D951C12BF}" type="presOf" srcId="{2F8F9AB3-8452-43EC-87B2-17B5891BF608}" destId="{CBE2BF13-B4B2-4CCE-B9CD-9C2AE1DB9827}" srcOrd="0" destOrd="0" presId="urn:microsoft.com/office/officeart/2005/8/layout/hierarchy2"/>
    <dgm:cxn modelId="{B622461C-ABE9-40E4-898D-4C86EA57E67A}" type="presOf" srcId="{425A3179-1413-4460-9678-40448B2E5A42}" destId="{4422E06E-D77E-4F56-8840-95885C852043}" srcOrd="0" destOrd="0" presId="urn:microsoft.com/office/officeart/2005/8/layout/hierarchy2"/>
    <dgm:cxn modelId="{9CEDC11C-136F-41B2-8B1A-7F65506AA089}" srcId="{5BEDA607-8DED-42F2-9BA0-692D403C0EC7}" destId="{9EEC29B6-B262-48C2-8C7F-8D2337E7AA42}" srcOrd="1" destOrd="0" parTransId="{BE23815E-A548-4C9A-9302-6B0219BE53D6}" sibTransId="{41B53EC5-CB3D-457D-A5B5-3DED8454A648}"/>
    <dgm:cxn modelId="{7E741121-3465-4D04-BF60-56919F6F4B45}" srcId="{353C6F70-9685-47CA-B6F4-8BAAB244C13E}" destId="{5E805EC3-C58D-4BD5-A99E-B5CA51F30872}" srcOrd="0" destOrd="0" parTransId="{F855B30C-366F-4036-B5AE-48974C07A80E}" sibTransId="{B59D055C-2884-474E-9D56-8022BD751C43}"/>
    <dgm:cxn modelId="{36599623-182A-480E-BBAC-966ED1CF3002}" srcId="{5BEDA607-8DED-42F2-9BA0-692D403C0EC7}" destId="{26FE1203-5ADF-4E90-A8D9-0247D9F49394}" srcOrd="0" destOrd="0" parTransId="{07D04FA9-5869-4D23-B691-B49B006E8BC9}" sibTransId="{A7D50C71-D674-4373-B823-7229A869B85A}"/>
    <dgm:cxn modelId="{83FD3924-D776-40C1-BC51-6CDC49E47891}" type="presOf" srcId="{518E9C13-B9BA-4F04-A7EC-F36C8D246639}" destId="{EC3C7E9C-DE6F-4CF5-B8A3-EB96093DECF2}" srcOrd="0" destOrd="0" presId="urn:microsoft.com/office/officeart/2005/8/layout/hierarchy2"/>
    <dgm:cxn modelId="{66014825-61F1-476E-BD5A-9231CDFD9B14}" type="presOf" srcId="{1731A452-294D-4C69-97EA-ABFB841FA0AB}" destId="{B99573E9-A46B-4C67-A741-44E4FCB4FC8A}" srcOrd="0" destOrd="0" presId="urn:microsoft.com/office/officeart/2005/8/layout/hierarchy2"/>
    <dgm:cxn modelId="{5AC37025-FB0C-494E-AC6F-47ECD5EFB559}" type="presOf" srcId="{9A5197BB-7B1D-4DC8-A917-46D969DA792E}" destId="{29B3ABBF-0291-41BA-9070-E0CB070E1723}" srcOrd="0" destOrd="0" presId="urn:microsoft.com/office/officeart/2005/8/layout/hierarchy2"/>
    <dgm:cxn modelId="{804E502C-F68B-43F0-B577-A94326A81C84}" type="presOf" srcId="{72696429-0052-4BF2-A3D6-BBDE6FE074F3}" destId="{D70BE76E-DF8A-41C7-B32C-B201D4602719}" srcOrd="1" destOrd="0" presId="urn:microsoft.com/office/officeart/2005/8/layout/hierarchy2"/>
    <dgm:cxn modelId="{291F772C-20F4-4C15-B3EC-1E4FEB7684CE}" srcId="{4DCC093E-5118-4588-BF05-784A120C438E}" destId="{139D31B5-E436-4EC0-97A7-7F66DB8AA5D7}" srcOrd="10" destOrd="0" parTransId="{AF9EC442-AE64-421C-9DF3-0ED0B18D4EC6}" sibTransId="{12528D3C-0831-4D11-8576-30D0B612443D}"/>
    <dgm:cxn modelId="{5C2DB32C-93DB-4F68-9A52-C26952AA7C63}" type="presOf" srcId="{F79E2E4E-D09E-4761-9D42-D0B633170619}" destId="{1DF7A0FE-D847-4A6C-886A-53CFFF4E83C7}" srcOrd="1" destOrd="0" presId="urn:microsoft.com/office/officeart/2005/8/layout/hierarchy2"/>
    <dgm:cxn modelId="{7FF0D72C-8256-4CB0-BD43-E3D69ACE2203}" type="presOf" srcId="{B87C2DC1-653F-4929-9260-6C6E30534E07}" destId="{38194E2B-8C9B-446D-93B0-01D743C0AC69}" srcOrd="0" destOrd="0" presId="urn:microsoft.com/office/officeart/2005/8/layout/hierarchy2"/>
    <dgm:cxn modelId="{ABAF072D-729E-4B57-9163-D0065AEE9336}" srcId="{4DCC093E-5118-4588-BF05-784A120C438E}" destId="{1526BD2C-5491-407F-8729-1EE2B6B3A855}" srcOrd="11" destOrd="0" parTransId="{493FD3B1-4C0C-4AB6-93B7-144BA121C706}" sibTransId="{43AD28CE-0CF1-43EF-A291-AAB3F34ECA2E}"/>
    <dgm:cxn modelId="{4A81E52E-C0B7-4257-8F3C-DB8656B79E86}" type="presOf" srcId="{5BEDA607-8DED-42F2-9BA0-692D403C0EC7}" destId="{3B5C04C0-1026-4BCC-B8D1-09CC708E27EF}" srcOrd="0" destOrd="0" presId="urn:microsoft.com/office/officeart/2005/8/layout/hierarchy2"/>
    <dgm:cxn modelId="{C2652932-C5C1-48E8-9908-A85A6B4A4AFA}" type="presOf" srcId="{96C75850-7C10-4A02-8605-049A49CD2E2D}" destId="{72B52D37-7D34-4ADE-968E-0497344DEB80}" srcOrd="1" destOrd="0" presId="urn:microsoft.com/office/officeart/2005/8/layout/hierarchy2"/>
    <dgm:cxn modelId="{EE4DD132-A251-4BA5-8356-494F3570E984}" srcId="{4DCC093E-5118-4588-BF05-784A120C438E}" destId="{1AACD66D-838A-4857-A8DC-3EF6272EECE2}" srcOrd="9" destOrd="0" parTransId="{A7EB2E53-A0F7-41F9-9F6A-A28410E699DB}" sibTransId="{ACD72424-B859-42FC-AD95-05CBCCEC32EB}"/>
    <dgm:cxn modelId="{E5FFF033-92C3-46BF-A8FF-F0AD3390E504}" type="presOf" srcId="{A7EB2E53-A0F7-41F9-9F6A-A28410E699DB}" destId="{C4665A5D-7A69-4FC2-9029-35B5452AAAD6}" srcOrd="1" destOrd="0" presId="urn:microsoft.com/office/officeart/2005/8/layout/hierarchy2"/>
    <dgm:cxn modelId="{90F35834-B666-4104-88F3-BB9F2FA3E632}" type="presOf" srcId="{FB410C4C-ACA6-43C1-94D1-C7A844E0F3B3}" destId="{B80DAFEB-A4DF-442E-B7BA-955CB74D383A}" srcOrd="1" destOrd="0" presId="urn:microsoft.com/office/officeart/2005/8/layout/hierarchy2"/>
    <dgm:cxn modelId="{BABCA734-F03C-4004-822D-5C6C262DD56D}" type="presOf" srcId="{109BE932-8DDB-46FE-93F1-0C28F0100D1E}" destId="{963787CF-28FB-43DF-98C2-C462DE3D4B6D}" srcOrd="0" destOrd="0" presId="urn:microsoft.com/office/officeart/2005/8/layout/hierarchy2"/>
    <dgm:cxn modelId="{4D21EB35-58D2-4366-9D1B-32DF647D51E6}" type="presOf" srcId="{07D04FA9-5869-4D23-B691-B49B006E8BC9}" destId="{1933032C-D9EF-4E95-9447-72395E90BD3C}" srcOrd="0" destOrd="0" presId="urn:microsoft.com/office/officeart/2005/8/layout/hierarchy2"/>
    <dgm:cxn modelId="{49466C37-4BE8-46AD-A372-9BD08D8C1F3E}" type="presOf" srcId="{AB141E1E-8A47-473D-BDC9-A740AE0EA3F7}" destId="{D7C3B540-AAE3-47B6-8689-6F42331FBB0D}" srcOrd="0" destOrd="0" presId="urn:microsoft.com/office/officeart/2005/8/layout/hierarchy2"/>
    <dgm:cxn modelId="{D3611739-A676-412C-BEA5-41831881B894}" type="presOf" srcId="{B9C65307-6730-4D84-A9EC-F5E07D061332}" destId="{D4B8489D-29A0-450D-846E-6780D2436C16}" srcOrd="0" destOrd="0" presId="urn:microsoft.com/office/officeart/2005/8/layout/hierarchy2"/>
    <dgm:cxn modelId="{E1EECC3A-612D-4A36-9D5E-657AC950EA7D}" type="presOf" srcId="{010FD920-EA56-439A-976D-37845A8E9EE8}" destId="{134D7A88-2D4D-4FE0-A203-5D2DFDE9B8B0}" srcOrd="0" destOrd="0" presId="urn:microsoft.com/office/officeart/2005/8/layout/hierarchy2"/>
    <dgm:cxn modelId="{FE22743B-5CE1-4587-B152-F07517BB420D}" type="presOf" srcId="{760F7733-46EF-4539-A2FB-454CD8F95E50}" destId="{22457488-96D2-492A-A67D-1DA42B35C92F}" srcOrd="0" destOrd="0" presId="urn:microsoft.com/office/officeart/2005/8/layout/hierarchy2"/>
    <dgm:cxn modelId="{3160B13C-405E-4042-9A63-BD2CD7CB824F}" srcId="{3B6E185B-6A1C-411C-B39C-F27A6010733C}" destId="{0EF4F3AF-041E-4FDF-983F-FF187C733655}" srcOrd="0" destOrd="0" parTransId="{1A36E4A0-3C95-4A7E-8403-6FC00333987E}" sibTransId="{F28EBEB7-D767-4F82-B6D2-883ABD1AD9BF}"/>
    <dgm:cxn modelId="{A4C9B23C-5196-4A21-9C6A-A300E70E09A3}" srcId="{5E805EC3-C58D-4BD5-A99E-B5CA51F30872}" destId="{358A984D-84A8-4882-B614-7818D9052477}" srcOrd="1" destOrd="0" parTransId="{8C8C0F98-AF8B-47BC-ACBA-EC4EA96F1883}" sibTransId="{FB721D93-4426-41AA-BDE6-2476D51C93FF}"/>
    <dgm:cxn modelId="{B9DE823E-B6E7-42D2-8A94-444038183F86}" type="presOf" srcId="{C6A0CEB6-9E0F-4493-8DE5-DBE1EBED4241}" destId="{363F3F8F-4CCA-4730-9344-E43FC3582DD0}" srcOrd="1" destOrd="0" presId="urn:microsoft.com/office/officeart/2005/8/layout/hierarchy2"/>
    <dgm:cxn modelId="{6DE0893F-B247-4E43-8300-4268C1AE9B97}" type="presOf" srcId="{3CF53495-E7A9-4FFB-983F-8FC85A5AADF1}" destId="{3F552C8C-859A-4030-A503-8872BA917E0A}" srcOrd="0" destOrd="0" presId="urn:microsoft.com/office/officeart/2005/8/layout/hierarchy2"/>
    <dgm:cxn modelId="{599C7741-D5A5-42DF-BD8C-6782D1ABCBC9}" type="presOf" srcId="{21F29C5E-B439-428D-89D6-0B6C5058BC6D}" destId="{14C8F2DC-5402-4C02-AEC9-5324C6C4963A}" srcOrd="1" destOrd="0" presId="urn:microsoft.com/office/officeart/2005/8/layout/hierarchy2"/>
    <dgm:cxn modelId="{0EDAB841-CCEC-4A76-ABF4-E427F12CBF77}" type="presOf" srcId="{A1B0E159-B1C8-4060-A4E0-14F2712C19F0}" destId="{B814C4C0-4FD5-42D0-888F-22B47EF7775E}" srcOrd="1" destOrd="0" presId="urn:microsoft.com/office/officeart/2005/8/layout/hierarchy2"/>
    <dgm:cxn modelId="{1B735042-1CE9-4380-9204-33A4EF828EA4}" type="presOf" srcId="{E7091F61-EB43-4F07-B67B-2EE2EED76652}" destId="{3E90B72A-F33B-4C19-AA15-D10953CC4340}" srcOrd="0" destOrd="0" presId="urn:microsoft.com/office/officeart/2005/8/layout/hierarchy2"/>
    <dgm:cxn modelId="{DEEA8D42-3607-4DE8-9F8C-1FBBAC4983DE}" type="presOf" srcId="{4C4B97E3-F5BD-4198-B4CF-00796D7DABC4}" destId="{0F72C090-6894-4EAC-91C9-4AB4F7819088}" srcOrd="0" destOrd="0" presId="urn:microsoft.com/office/officeart/2005/8/layout/hierarchy2"/>
    <dgm:cxn modelId="{1998B242-00F1-4CEC-93EF-0F4D48861C0E}" type="presOf" srcId="{6CF7CD4C-0917-44C0-B3FE-FDC2C5B2A919}" destId="{9698C83B-59AA-460C-B76E-A13EFE8BCD17}" srcOrd="1" destOrd="0" presId="urn:microsoft.com/office/officeart/2005/8/layout/hierarchy2"/>
    <dgm:cxn modelId="{9BE90D45-2873-4BF4-B9CF-0178F530F060}" type="presOf" srcId="{895AD288-8C3F-4FEF-8348-DE71D8D3CA8C}" destId="{06162D70-667D-4321-A2A5-50E71EC54502}" srcOrd="0" destOrd="0" presId="urn:microsoft.com/office/officeart/2005/8/layout/hierarchy2"/>
    <dgm:cxn modelId="{B3F5674A-4402-4EB3-AE33-BA190C5A46B8}" srcId="{F4B2B415-9F5D-4A5C-A517-33028F9EDE23}" destId="{CE4A4217-0410-4729-9337-C36C75DD601B}" srcOrd="2" destOrd="0" parTransId="{539788D9-F5CD-499B-8EFE-4BDF10193421}" sibTransId="{1D71D8A5-0DC5-4C1F-8009-4A0D76746D08}"/>
    <dgm:cxn modelId="{320BDA4A-A0EB-4EC8-ADAD-5E8F5C924BB2}" type="presOf" srcId="{AF9EC442-AE64-421C-9DF3-0ED0B18D4EC6}" destId="{77548836-C3C7-4F26-AB2C-7B9D48F92339}" srcOrd="0" destOrd="0" presId="urn:microsoft.com/office/officeart/2005/8/layout/hierarchy2"/>
    <dgm:cxn modelId="{FDECB74C-72D9-4396-8CE6-848F8C3F1C3E}" type="presOf" srcId="{3B2039F4-2BA1-4802-A7AA-25308413273C}" destId="{007AF09B-7B63-4C84-BFB2-EF40ED79070D}" srcOrd="0" destOrd="0" presId="urn:microsoft.com/office/officeart/2005/8/layout/hierarchy2"/>
    <dgm:cxn modelId="{7365E84C-E0AB-49BB-AE7B-184CF01D4001}" type="presOf" srcId="{8C8C0F98-AF8B-47BC-ACBA-EC4EA96F1883}" destId="{750F2EA3-C6A2-49D8-A4E9-ECB36FFC366E}" srcOrd="0" destOrd="0" presId="urn:microsoft.com/office/officeart/2005/8/layout/hierarchy2"/>
    <dgm:cxn modelId="{F84FF34D-9027-4496-8DDA-E28AA1A98EC2}" type="presOf" srcId="{C09B2D6A-14B0-4151-BFD3-E21110A5E135}" destId="{4838F315-A0EB-4974-8233-371CFFCC1CE4}" srcOrd="0" destOrd="0" presId="urn:microsoft.com/office/officeart/2005/8/layout/hierarchy2"/>
    <dgm:cxn modelId="{4644454E-788A-4ECC-A1B6-1ECB4780A87E}" srcId="{4DCC093E-5118-4588-BF05-784A120C438E}" destId="{41D6EC2F-3103-40F0-AD9A-B96A94477A77}" srcOrd="2" destOrd="0" parTransId="{21F29C5E-B439-428D-89D6-0B6C5058BC6D}" sibTransId="{6A310679-E6DA-4236-BE0A-D973336D0C61}"/>
    <dgm:cxn modelId="{6124E14E-C616-45E8-9E06-77ADDF868362}" type="presOf" srcId="{0CC02BC8-A818-4832-81BB-32F3133B8621}" destId="{1CC6C369-6E50-42DA-A881-F2FD7708779E}" srcOrd="1" destOrd="0" presId="urn:microsoft.com/office/officeart/2005/8/layout/hierarchy2"/>
    <dgm:cxn modelId="{6EDC0D4F-EA1E-466B-BEB7-E24BB973A5FC}" type="presOf" srcId="{2F8F9AB3-8452-43EC-87B2-17B5891BF608}" destId="{BCDDDD5C-AFED-4205-A736-CCA5522531A5}" srcOrd="1" destOrd="0" presId="urn:microsoft.com/office/officeart/2005/8/layout/hierarchy2"/>
    <dgm:cxn modelId="{A0FB7E4F-44FD-4DBA-A042-6A79F97D56F4}" type="presOf" srcId="{E8E96543-F299-474B-9FCF-7801EFC57576}" destId="{8D2BE030-0831-42B2-98C2-0F6E87AD5B7D}" srcOrd="0" destOrd="0" presId="urn:microsoft.com/office/officeart/2005/8/layout/hierarchy2"/>
    <dgm:cxn modelId="{55DB3554-19B4-4F3D-83DA-D4752F78CF7E}" type="presOf" srcId="{BE23815E-A548-4C9A-9302-6B0219BE53D6}" destId="{BE69F2C5-1F16-4884-B39F-EE6B06025848}" srcOrd="0" destOrd="0" presId="urn:microsoft.com/office/officeart/2005/8/layout/hierarchy2"/>
    <dgm:cxn modelId="{810A5A54-637D-49F4-B0F1-8C07E5DA090E}" type="presOf" srcId="{6125DCFA-27DB-435B-BEA4-88B2190500A1}" destId="{914215F8-CB99-49A5-92BE-A5364C5EF1A5}" srcOrd="0" destOrd="0" presId="urn:microsoft.com/office/officeart/2005/8/layout/hierarchy2"/>
    <dgm:cxn modelId="{0CD93C55-BD44-4E41-9B56-54AAA16609B5}" type="presOf" srcId="{0427F775-9407-4A06-A301-D22BFE5F9A2F}" destId="{4B059EDE-FDEA-4C68-BB44-42AF88AE4840}" srcOrd="0" destOrd="0" presId="urn:microsoft.com/office/officeart/2005/8/layout/hierarchy2"/>
    <dgm:cxn modelId="{DA8B6458-9A29-407D-847C-4015D64F4774}" type="presOf" srcId="{AA6D12B2-DCA4-4A02-AF03-C8580B7BB7CB}" destId="{029D14F4-73D5-48A5-9409-1B7CD1A98ED4}" srcOrd="1" destOrd="0" presId="urn:microsoft.com/office/officeart/2005/8/layout/hierarchy2"/>
    <dgm:cxn modelId="{416CBB58-49CA-48D3-AD71-87B640D30FD3}" type="presOf" srcId="{F79E2E4E-D09E-4761-9D42-D0B633170619}" destId="{2E231434-ED7F-44D1-8C73-4DA73C333BE6}" srcOrd="0" destOrd="0" presId="urn:microsoft.com/office/officeart/2005/8/layout/hierarchy2"/>
    <dgm:cxn modelId="{9DED155D-6C53-47A3-B87C-8EA66F399A88}" type="presOf" srcId="{539788D9-F5CD-499B-8EFE-4BDF10193421}" destId="{FB2F6D88-F506-4847-B326-8EC15F62040F}" srcOrd="0" destOrd="0" presId="urn:microsoft.com/office/officeart/2005/8/layout/hierarchy2"/>
    <dgm:cxn modelId="{88AFD95D-4989-42FB-9A69-E7CF03E1B6E3}" type="presOf" srcId="{21F29C5E-B439-428D-89D6-0B6C5058BC6D}" destId="{82D2DBC9-D5F1-41B2-B475-FC62C3A7004B}" srcOrd="0" destOrd="0" presId="urn:microsoft.com/office/officeart/2005/8/layout/hierarchy2"/>
    <dgm:cxn modelId="{A348F95E-EC39-4B0A-B118-7067A75674BE}" srcId="{A7E59208-D8C8-472E-BF12-F8E4CF3114A2}" destId="{B9C65307-6730-4D84-A9EC-F5E07D061332}" srcOrd="2" destOrd="0" parTransId="{72696429-0052-4BF2-A3D6-BBDE6FE074F3}" sibTransId="{335D4C02-6620-4C99-B00C-8D1A5C8FA344}"/>
    <dgm:cxn modelId="{72A27E5F-70CA-465A-BF34-DE7508F5C4E0}" type="presOf" srcId="{D40E33C4-65A6-43F0-8A5A-668871AD40F3}" destId="{16FE4A7B-83F7-4D09-B9FE-7AABA7BB071E}" srcOrd="1" destOrd="0" presId="urn:microsoft.com/office/officeart/2005/8/layout/hierarchy2"/>
    <dgm:cxn modelId="{E2C6DA5F-B36D-4F88-BA3D-ED062640B494}" type="presOf" srcId="{359B501C-2EC2-4B8C-BD62-7A96D0CFC1AF}" destId="{677DE54C-6078-40B3-9FE8-CF37F7EF3F0C}" srcOrd="0" destOrd="0" presId="urn:microsoft.com/office/officeart/2005/8/layout/hierarchy2"/>
    <dgm:cxn modelId="{E9D9EE5F-B2E5-4165-9CF2-9A68B627E740}" type="presOf" srcId="{3B2039F4-2BA1-4802-A7AA-25308413273C}" destId="{1C784E67-44D5-495B-BFB2-4C4FDB887CF2}" srcOrd="1" destOrd="0" presId="urn:microsoft.com/office/officeart/2005/8/layout/hierarchy2"/>
    <dgm:cxn modelId="{0DA5FE60-70BB-4371-8D5E-DCBCF04D22FD}" type="presOf" srcId="{03C2E030-813C-4887-94E5-82269C93F63C}" destId="{39A8889A-DFEF-4793-B12D-3BA4A3083E3E}" srcOrd="0" destOrd="0" presId="urn:microsoft.com/office/officeart/2005/8/layout/hierarchy2"/>
    <dgm:cxn modelId="{89B24861-AA4B-427B-8B00-CFDBBECF146E}" type="presOf" srcId="{CEA4C598-03BA-4196-8096-D8D9940A747B}" destId="{EBD2F8EB-D76E-4ECE-AD86-C67210D41D3D}" srcOrd="1" destOrd="0" presId="urn:microsoft.com/office/officeart/2005/8/layout/hierarchy2"/>
    <dgm:cxn modelId="{F19D9763-6EC4-4C58-A212-4CB5C96C1C4B}" srcId="{353C6F70-9685-47CA-B6F4-8BAAB244C13E}" destId="{5BEDA607-8DED-42F2-9BA0-692D403C0EC7}" srcOrd="1" destOrd="0" parTransId="{84547787-FAB0-4D90-A3B1-62ECE02E3768}" sibTransId="{85E28AF0-9D48-40FF-95C5-6BCCE65C1A96}"/>
    <dgm:cxn modelId="{4A2C5E67-8424-4571-BB23-BA2ECA3579FA}" srcId="{4DCC093E-5118-4588-BF05-784A120C438E}" destId="{B8C47AF5-72F4-4882-A03A-756E7DB0314D}" srcOrd="0" destOrd="0" parTransId="{CEA4C598-03BA-4196-8096-D8D9940A747B}" sibTransId="{EC6E509A-E8EC-47FA-9CF3-59C646F77411}"/>
    <dgm:cxn modelId="{AB333D68-3F92-4449-A44F-D972443E467B}" type="presOf" srcId="{3A98E99E-5EB9-499E-9929-61172C5675F2}" destId="{0B80F301-D09A-4FB6-916E-CECF32B2F143}" srcOrd="0" destOrd="0" presId="urn:microsoft.com/office/officeart/2005/8/layout/hierarchy2"/>
    <dgm:cxn modelId="{E657CA68-7262-414C-8915-DA2904315788}" srcId="{F4B2B415-9F5D-4A5C-A517-33028F9EDE23}" destId="{1BB53B11-3670-415B-805A-CE32EE8357FF}" srcOrd="0" destOrd="0" parTransId="{CA6A9C70-223C-4BA6-B22F-E7EE9FCEF901}" sibTransId="{15B10DEE-88A1-4399-88DF-14098CAE15AD}"/>
    <dgm:cxn modelId="{9A7A4469-6431-4785-A88E-CE5D88D36955}" type="presOf" srcId="{C6A0CEB6-9E0F-4493-8DE5-DBE1EBED4241}" destId="{52995CFF-A2C0-41A9-B8F6-E167247A0F1E}" srcOrd="0" destOrd="0" presId="urn:microsoft.com/office/officeart/2005/8/layout/hierarchy2"/>
    <dgm:cxn modelId="{F03E4F69-6CE6-4C30-8469-8E8928E70355}" type="presOf" srcId="{895AD288-8C3F-4FEF-8348-DE71D8D3CA8C}" destId="{9EDF16DF-0468-41C5-93DA-122D14D8465F}" srcOrd="1" destOrd="0" presId="urn:microsoft.com/office/officeart/2005/8/layout/hierarchy2"/>
    <dgm:cxn modelId="{67948D6B-0256-4B3B-A7B3-49660316C4F2}" type="presOf" srcId="{425A3179-1413-4460-9678-40448B2E5A42}" destId="{78BB6245-6919-431D-8F6D-FEFDFE3AC3B2}" srcOrd="1" destOrd="0" presId="urn:microsoft.com/office/officeart/2005/8/layout/hierarchy2"/>
    <dgm:cxn modelId="{176A946C-5CA5-4F20-9515-6CFF3244107D}" srcId="{F4B2B415-9F5D-4A5C-A517-33028F9EDE23}" destId="{359B501C-2EC2-4B8C-BD62-7A96D0CFC1AF}" srcOrd="3" destOrd="0" parTransId="{8F1E2ECC-9C8C-4137-9CC2-148EC633E965}" sibTransId="{215BF104-439D-4F69-8669-82DF0A50A615}"/>
    <dgm:cxn modelId="{DFF9B770-3709-4E2F-8117-8D886A23F450}" type="presOf" srcId="{C09B2D6A-14B0-4151-BFD3-E21110A5E135}" destId="{E36F28F1-4932-4D2B-B680-9D2F1B515793}" srcOrd="1" destOrd="0" presId="urn:microsoft.com/office/officeart/2005/8/layout/hierarchy2"/>
    <dgm:cxn modelId="{572A4773-DAF7-49C5-BBA4-FE93C4756DDB}" type="presOf" srcId="{139D31B5-E436-4EC0-97A7-7F66DB8AA5D7}" destId="{58A40D43-4424-4837-A5A1-19217FD9A569}" srcOrd="0" destOrd="0" presId="urn:microsoft.com/office/officeart/2005/8/layout/hierarchy2"/>
    <dgm:cxn modelId="{7FAC6E76-7F26-4E09-B406-9502FCA84A7C}" type="presOf" srcId="{FB410C4C-ACA6-43C1-94D1-C7A844E0F3B3}" destId="{A20C5029-8277-4F52-A215-36A9DA1AB52E}" srcOrd="0" destOrd="0" presId="urn:microsoft.com/office/officeart/2005/8/layout/hierarchy2"/>
    <dgm:cxn modelId="{04D6DC77-F106-4C55-92DF-A7B3E0A59C0C}" srcId="{353C6F70-9685-47CA-B6F4-8BAAB244C13E}" destId="{A7E59208-D8C8-472E-BF12-F8E4CF3114A2}" srcOrd="2" destOrd="0" parTransId="{A1B0E159-B1C8-4060-A4E0-14F2712C19F0}" sibTransId="{51A6C234-0D46-49B1-9152-315F121BE747}"/>
    <dgm:cxn modelId="{A126AB78-FF01-4734-9D4B-02922D146EAB}" type="presOf" srcId="{F4B2B415-9F5D-4A5C-A517-33028F9EDE23}" destId="{15869452-7DB1-4E38-961A-AD18E7BF97A4}" srcOrd="0" destOrd="0" presId="urn:microsoft.com/office/officeart/2005/8/layout/hierarchy2"/>
    <dgm:cxn modelId="{9AA7707A-539E-4889-89B5-1389033F4728}" type="presOf" srcId="{5E84A072-2EA0-45DE-B57C-DA217CA13318}" destId="{87A49760-64CE-4CBD-BF78-45B22D2A4949}" srcOrd="0" destOrd="0" presId="urn:microsoft.com/office/officeart/2005/8/layout/hierarchy2"/>
    <dgm:cxn modelId="{B17F247B-DE53-473E-AE7F-E3D046AECE17}" type="presOf" srcId="{1A36E4A0-3C95-4A7E-8403-6FC00333987E}" destId="{04B5A4E1-0824-444B-B0DF-49A3641E7799}" srcOrd="0" destOrd="0" presId="urn:microsoft.com/office/officeart/2005/8/layout/hierarchy2"/>
    <dgm:cxn modelId="{0689377C-1BBE-430D-8305-DB6340B9BEBE}" type="presOf" srcId="{AA6D12B2-DCA4-4A02-AF03-C8580B7BB7CB}" destId="{6AB18905-010D-4722-AD52-A8029684E429}" srcOrd="0" destOrd="0" presId="urn:microsoft.com/office/officeart/2005/8/layout/hierarchy2"/>
    <dgm:cxn modelId="{8B1F417C-D57E-4A5D-BE66-6CACFE4FD74B}" srcId="{4DCC093E-5118-4588-BF05-784A120C438E}" destId="{4C4B97E3-F5BD-4198-B4CF-00796D7DABC4}" srcOrd="7" destOrd="0" parTransId="{7D4974A8-D315-42CC-B9BB-A3A5CD5225A3}" sibTransId="{2F5833B1-8B55-4651-83AB-AE1350EC55C1}"/>
    <dgm:cxn modelId="{AE20747C-286D-4E12-BE4A-F487C0D2B4F3}" type="presOf" srcId="{6F25122C-9DC2-4635-960D-7ABCFA19A050}" destId="{58DDB727-F29C-4C9B-AF2C-EA0167F90FF0}" srcOrd="1" destOrd="0" presId="urn:microsoft.com/office/officeart/2005/8/layout/hierarchy2"/>
    <dgm:cxn modelId="{908C8E7E-1A8E-4117-9A9A-5795A60ABDF5}" type="presOf" srcId="{1A98DB96-17DF-475F-B57D-AA7AEC31238C}" destId="{3CA6E368-4B5A-4A8C-BA3F-B3AD90C9E9E9}" srcOrd="1" destOrd="0" presId="urn:microsoft.com/office/officeart/2005/8/layout/hierarchy2"/>
    <dgm:cxn modelId="{85253C84-89B8-44D2-B134-7BDB6F14AA69}" type="presOf" srcId="{493FD3B1-4C0C-4AB6-93B7-144BA121C706}" destId="{616D48F1-5BF9-475C-A680-5A4648439758}" srcOrd="0" destOrd="0" presId="urn:microsoft.com/office/officeart/2005/8/layout/hierarchy2"/>
    <dgm:cxn modelId="{22468D87-9E8B-4AC0-A1D8-F0624582D39C}" srcId="{4DCC093E-5118-4588-BF05-784A120C438E}" destId="{F576FE14-F223-4751-B256-BF313602C91E}" srcOrd="3" destOrd="0" parTransId="{760F7733-46EF-4539-A2FB-454CD8F95E50}" sibTransId="{014EF3D8-71ED-448E-95E6-C5CAB103F661}"/>
    <dgm:cxn modelId="{5EE1DB87-1E1C-4EB4-B955-5E302A28EF82}" type="presOf" srcId="{4DCC093E-5118-4588-BF05-784A120C438E}" destId="{DDCB18A7-5217-498E-8109-AEC8891AEF63}" srcOrd="0" destOrd="0" presId="urn:microsoft.com/office/officeart/2005/8/layout/hierarchy2"/>
    <dgm:cxn modelId="{FD35F389-DEE8-421A-8AD7-7D577F5CFC02}" type="presOf" srcId="{72696429-0052-4BF2-A3D6-BBDE6FE074F3}" destId="{12649787-8B1A-4097-B62E-BBC1879F2014}" srcOrd="0" destOrd="0" presId="urn:microsoft.com/office/officeart/2005/8/layout/hierarchy2"/>
    <dgm:cxn modelId="{8726108A-CBAB-490D-9A18-E96240C38C81}" type="presOf" srcId="{493FD3B1-4C0C-4AB6-93B7-144BA121C706}" destId="{6A5659FF-62AA-4A8C-B658-A072CD59A9AB}" srcOrd="1" destOrd="0" presId="urn:microsoft.com/office/officeart/2005/8/layout/hierarchy2"/>
    <dgm:cxn modelId="{5147278B-3E0B-49CB-8D2F-890F5AEC30A8}" type="presOf" srcId="{2F02F2CE-1BCD-446E-BECB-6973E7ACA9E4}" destId="{3D93AA13-F9BF-4516-9343-01C4FE687B9F}" srcOrd="0" destOrd="0" presId="urn:microsoft.com/office/officeart/2005/8/layout/hierarchy2"/>
    <dgm:cxn modelId="{3D343B8B-1248-4DFE-8A34-AF4186B05CDE}" srcId="{A7E59208-D8C8-472E-BF12-F8E4CF3114A2}" destId="{ECD62ED1-5D11-481E-9BBC-AB020A2EFAFF}" srcOrd="1" destOrd="0" parTransId="{0CC02BC8-A818-4832-81BB-32F3133B8621}" sibTransId="{94E1BBA4-DAA9-4674-B28C-E8D1C76D9ED9}"/>
    <dgm:cxn modelId="{A3337F8B-F6A7-4497-AF59-193A5BC380DA}" srcId="{3B6E185B-6A1C-411C-B39C-F27A6010733C}" destId="{85CA1953-8DEE-44BB-BE58-B97A59C65C13}" srcOrd="1" destOrd="0" parTransId="{425A3179-1413-4460-9678-40448B2E5A42}" sibTransId="{80DB0B72-C4D4-4215-94FF-91C54AF93D83}"/>
    <dgm:cxn modelId="{F0A9C28B-8E03-4C11-AFB9-D16E408B23F6}" type="presOf" srcId="{0CC02BC8-A818-4832-81BB-32F3133B8621}" destId="{168B63D6-E582-4001-8D06-4264135971C6}" srcOrd="0" destOrd="0" presId="urn:microsoft.com/office/officeart/2005/8/layout/hierarchy2"/>
    <dgm:cxn modelId="{A9259A8C-6AA1-48F1-871B-6A2B9CCA10FF}" type="presOf" srcId="{3B6E185B-6A1C-411C-B39C-F27A6010733C}" destId="{E730F18F-48B0-4E0B-9A8D-D539E63CE9D4}" srcOrd="0" destOrd="0" presId="urn:microsoft.com/office/officeart/2005/8/layout/hierarchy2"/>
    <dgm:cxn modelId="{6A60D78C-E8EE-4DB3-A9CB-F6E2A46628B6}" type="presOf" srcId="{0EF4F3AF-041E-4FDF-983F-FF187C733655}" destId="{4DCF8B3D-4AC6-4BA4-83D6-71D9BD5CEED2}" srcOrd="0" destOrd="0" presId="urn:microsoft.com/office/officeart/2005/8/layout/hierarchy2"/>
    <dgm:cxn modelId="{11A3DC8E-FF1F-4699-9A3B-B670663B4676}" srcId="{5BEDA607-8DED-42F2-9BA0-692D403C0EC7}" destId="{99F805CD-8B05-4B09-8106-E7D62662EFAB}" srcOrd="2" destOrd="0" parTransId="{E8E96543-F299-474B-9FCF-7801EFC57576}" sibTransId="{D7B2BED0-5F36-4662-A45B-3AF98D5317EC}"/>
    <dgm:cxn modelId="{2A530990-1895-45DD-BDA1-70DF94728E35}" type="presOf" srcId="{1BB53B11-3670-415B-805A-CE32EE8357FF}" destId="{D2E49161-A7B6-4759-AC1C-493631AA99EA}" srcOrd="0" destOrd="0" presId="urn:microsoft.com/office/officeart/2005/8/layout/hierarchy2"/>
    <dgm:cxn modelId="{63C95192-7E8F-4E66-912B-8934733F0E2D}" type="presOf" srcId="{358A984D-84A8-4882-B614-7818D9052477}" destId="{70A6C9AF-4497-49E2-8F6B-4022C002A32C}" srcOrd="0" destOrd="0" presId="urn:microsoft.com/office/officeart/2005/8/layout/hierarchy2"/>
    <dgm:cxn modelId="{7CBA8D92-C34A-4774-915C-38C0363A598A}" type="presOf" srcId="{3E305254-2A1B-4466-9716-16D92D48BD39}" destId="{C50E5B3A-B9FE-43B9-85D2-DC2953853106}" srcOrd="0" destOrd="0" presId="urn:microsoft.com/office/officeart/2005/8/layout/hierarchy2"/>
    <dgm:cxn modelId="{15319A92-C074-4977-B5E9-2263A96B15AA}" type="presOf" srcId="{8598F285-6469-41DF-8C80-D94935C42364}" destId="{48E4B145-A01E-4F97-9B06-6C33D2269A47}" srcOrd="0" destOrd="0" presId="urn:microsoft.com/office/officeart/2005/8/layout/hierarchy2"/>
    <dgm:cxn modelId="{AB7F0793-DC3B-4A16-8D2C-145B72045198}" type="presOf" srcId="{5E805EC3-C58D-4BD5-A99E-B5CA51F30872}" destId="{430F15C4-6A15-46B0-808C-1CBD7A4F9165}" srcOrd="0" destOrd="0" presId="urn:microsoft.com/office/officeart/2005/8/layout/hierarchy2"/>
    <dgm:cxn modelId="{21C65893-33D8-4049-82B7-95D567D3FD44}" type="presOf" srcId="{8F1E2ECC-9C8C-4137-9CC2-148EC633E965}" destId="{5BC2E700-F976-45E3-88A6-547D0BC5C286}" srcOrd="0" destOrd="0" presId="urn:microsoft.com/office/officeart/2005/8/layout/hierarchy2"/>
    <dgm:cxn modelId="{3FB75F94-347C-4CCA-BCC7-DF4DE208FB2D}" type="presOf" srcId="{E8E96543-F299-474B-9FCF-7801EFC57576}" destId="{778A5A6C-5BCE-43A2-9985-988597C18905}" srcOrd="1" destOrd="0" presId="urn:microsoft.com/office/officeart/2005/8/layout/hierarchy2"/>
    <dgm:cxn modelId="{6C9BCC96-83CA-4C49-BD33-5E28962C6972}" type="presOf" srcId="{C8881E16-4787-451C-81F6-A6E1C5F25824}" destId="{93ED179E-6CE9-427B-AFAE-295FB95A4083}" srcOrd="0" destOrd="0" presId="urn:microsoft.com/office/officeart/2005/8/layout/hierarchy2"/>
    <dgm:cxn modelId="{3AB27197-1CBC-487D-907C-3FC6A3044E4F}" type="presOf" srcId="{C1EACDD7-D989-416D-9681-817FEB9BF90B}" destId="{69674B81-12B1-4530-81E5-B46611BDEBD3}" srcOrd="1" destOrd="0" presId="urn:microsoft.com/office/officeart/2005/8/layout/hierarchy2"/>
    <dgm:cxn modelId="{D4295A9A-3E2B-4444-BDA3-FAE29D08EC17}" type="presOf" srcId="{A7E59208-D8C8-472E-BF12-F8E4CF3114A2}" destId="{933E68AA-CF10-49A1-ABCC-DA114DDEAF2A}" srcOrd="0" destOrd="0" presId="urn:microsoft.com/office/officeart/2005/8/layout/hierarchy2"/>
    <dgm:cxn modelId="{23C9F99B-9986-43C9-B8F5-C6B41AEBFF0A}" type="presOf" srcId="{2A9BE497-61AC-492C-9E1D-96073DB72DE2}" destId="{B84FD6DC-6F83-483B-A6F6-D1143D7FCD3D}" srcOrd="1" destOrd="0" presId="urn:microsoft.com/office/officeart/2005/8/layout/hierarchy2"/>
    <dgm:cxn modelId="{ABD331A0-37D6-4A12-874A-064E3C212C9C}" type="presOf" srcId="{4E60B1B3-870B-4A1B-9517-73B33DCA2C20}" destId="{DDF72957-287B-449A-A1C9-C4F10755C0F8}" srcOrd="0" destOrd="0" presId="urn:microsoft.com/office/officeart/2005/8/layout/hierarchy2"/>
    <dgm:cxn modelId="{9C023FA6-3F9E-4DAC-AF18-7A43F20ED9AF}" type="presOf" srcId="{6CF7CD4C-0917-44C0-B3FE-FDC2C5B2A919}" destId="{D3655785-2D54-4F59-9234-66AFAA7E681A}" srcOrd="0" destOrd="0" presId="urn:microsoft.com/office/officeart/2005/8/layout/hierarchy2"/>
    <dgm:cxn modelId="{21D2CBA7-4E8B-4913-B267-78660AC9127F}" srcId="{353C6F70-9685-47CA-B6F4-8BAAB244C13E}" destId="{4DCC093E-5118-4588-BF05-784A120C438E}" srcOrd="3" destOrd="0" parTransId="{579F7746-AF17-435C-A54C-9C6E6EE94B1D}" sibTransId="{EA649D5B-149D-4781-A689-D23905969596}"/>
    <dgm:cxn modelId="{AFA80EAB-D299-4224-8AAB-599701A4B9AB}" type="presOf" srcId="{F855B30C-366F-4036-B5AE-48974C07A80E}" destId="{8E782F7D-B5EB-45C3-8750-549909A533F3}" srcOrd="1" destOrd="0" presId="urn:microsoft.com/office/officeart/2005/8/layout/hierarchy2"/>
    <dgm:cxn modelId="{69BB00B2-945D-43B6-B677-33EA6648970F}" type="presOf" srcId="{8C8C0F98-AF8B-47BC-ACBA-EC4EA96F1883}" destId="{066D82E6-DD7A-4789-BA1F-74B091D397C9}" srcOrd="1" destOrd="0" presId="urn:microsoft.com/office/officeart/2005/8/layout/hierarchy2"/>
    <dgm:cxn modelId="{CFBC75B3-6B2D-492A-9E29-EDE294FDB12A}" srcId="{5BEDA607-8DED-42F2-9BA0-692D403C0EC7}" destId="{F4B2B415-9F5D-4A5C-A517-33028F9EDE23}" srcOrd="5" destOrd="0" parTransId="{C6A0CEB6-9E0F-4493-8DE5-DBE1EBED4241}" sibTransId="{5F9517A7-3764-4E96-8F05-51C754E9941B}"/>
    <dgm:cxn modelId="{0079F2B4-2BA0-4985-89AA-1AE40E7F6DD8}" type="presOf" srcId="{B18AAAC7-07A3-44B8-A053-45D1FF816FFD}" destId="{665072C3-8ADE-40C1-BDA5-4FAA68E4319F}" srcOrd="0" destOrd="0" presId="urn:microsoft.com/office/officeart/2005/8/layout/hierarchy2"/>
    <dgm:cxn modelId="{4F33CEB7-B766-459F-BAFF-8AB2BF17B87E}" type="presOf" srcId="{96C75850-7C10-4A02-8605-049A49CD2E2D}" destId="{0E872D06-F66B-4811-92EA-E374B25899A2}" srcOrd="0" destOrd="0" presId="urn:microsoft.com/office/officeart/2005/8/layout/hierarchy2"/>
    <dgm:cxn modelId="{02CC0FB9-47A9-4EB3-A846-97F4167ED513}" type="presOf" srcId="{9EEC29B6-B262-48C2-8C7F-8D2337E7AA42}" destId="{C631F0D8-FAAD-405A-A21C-737F0EB151CA}" srcOrd="0" destOrd="0" presId="urn:microsoft.com/office/officeart/2005/8/layout/hierarchy2"/>
    <dgm:cxn modelId="{A6C878B9-EBF4-42CF-95ED-C5FEAC6D408F}" srcId="{4DCC093E-5118-4588-BF05-784A120C438E}" destId="{8598F285-6469-41DF-8C80-D94935C42364}" srcOrd="6" destOrd="0" parTransId="{2F8F9AB3-8452-43EC-87B2-17B5891BF608}" sibTransId="{9ED8CEDE-19AD-4186-9063-3C72CFA86202}"/>
    <dgm:cxn modelId="{2FF5E2B9-2F3E-4955-A3BA-2277D18944EF}" type="presOf" srcId="{8F1E2ECC-9C8C-4137-9CC2-148EC633E965}" destId="{5EE677E4-1C6E-4B89-9610-5064AAB1F7F5}" srcOrd="1" destOrd="0" presId="urn:microsoft.com/office/officeart/2005/8/layout/hierarchy2"/>
    <dgm:cxn modelId="{BE9FC8BC-30C8-4F47-89AB-AE0CFBC29094}" type="presOf" srcId="{353C6F70-9685-47CA-B6F4-8BAAB244C13E}" destId="{F78A7B94-B816-41D1-873A-8D5A3EB8CC40}" srcOrd="0" destOrd="0" presId="urn:microsoft.com/office/officeart/2005/8/layout/hierarchy2"/>
    <dgm:cxn modelId="{72E4F6BF-B93D-485F-9F94-4A18A0DBC316}" type="presOf" srcId="{BE23815E-A548-4C9A-9302-6B0219BE53D6}" destId="{7095C669-4F3E-4E90-960F-1302F717ACD3}" srcOrd="1" destOrd="0" presId="urn:microsoft.com/office/officeart/2005/8/layout/hierarchy2"/>
    <dgm:cxn modelId="{9CC962C0-6FB0-4EAC-9823-CB6EEDB8B9A3}" type="presOf" srcId="{B8C47AF5-72F4-4882-A03A-756E7DB0314D}" destId="{BD9D8B61-1FCA-4DBF-95E6-59B9130798B9}" srcOrd="0" destOrd="0" presId="urn:microsoft.com/office/officeart/2005/8/layout/hierarchy2"/>
    <dgm:cxn modelId="{792252C4-467B-4BE7-86A3-C7F1EB8EA99D}" type="presOf" srcId="{1930F7C4-5EB2-4BFC-B652-6F6645AD8029}" destId="{94C13FA5-1561-4553-ADA9-69D482E5248A}" srcOrd="1" destOrd="0" presId="urn:microsoft.com/office/officeart/2005/8/layout/hierarchy2"/>
    <dgm:cxn modelId="{DDCC96C5-BE0B-41E9-A0E8-ECFF717BAD76}" type="presOf" srcId="{07D04FA9-5869-4D23-B691-B49B006E8BC9}" destId="{DDA1B4D0-DAFF-4A7B-B757-2D0EB38A13A7}" srcOrd="1" destOrd="0" presId="urn:microsoft.com/office/officeart/2005/8/layout/hierarchy2"/>
    <dgm:cxn modelId="{22C919C7-7D34-4C3F-A8B9-F14CC53A801F}" type="presOf" srcId="{C256443A-5739-41C3-976C-086C241C3437}" destId="{4A87926E-2F89-4541-AD41-F858508AC316}" srcOrd="0" destOrd="0" presId="urn:microsoft.com/office/officeart/2005/8/layout/hierarchy2"/>
    <dgm:cxn modelId="{AF913AC7-4944-4AC8-B610-F40FED6AE744}" type="presOf" srcId="{5E84A072-2EA0-45DE-B57C-DA217CA13318}" destId="{894D3D26-1468-4F2C-88F6-01751D8C7D69}" srcOrd="1" destOrd="0" presId="urn:microsoft.com/office/officeart/2005/8/layout/hierarchy2"/>
    <dgm:cxn modelId="{DF94F1C7-920F-4CE4-AABF-D5D98F7AF32C}" type="presOf" srcId="{99F805CD-8B05-4B09-8106-E7D62662EFAB}" destId="{29EF756E-ED73-4753-83B6-EFB27D8AB242}" srcOrd="0" destOrd="0" presId="urn:microsoft.com/office/officeart/2005/8/layout/hierarchy2"/>
    <dgm:cxn modelId="{390CBAC9-7EDF-4013-9577-DF3CBEFB668D}" type="presOf" srcId="{CA6A9C70-223C-4BA6-B22F-E7EE9FCEF901}" destId="{30A5F9D5-7BBD-431C-88C3-CC070B8111E2}" srcOrd="1" destOrd="0" presId="urn:microsoft.com/office/officeart/2005/8/layout/hierarchy2"/>
    <dgm:cxn modelId="{05E2D8CA-3F04-43FA-A9A0-EFB380FF7C1A}" srcId="{4DCC093E-5118-4588-BF05-784A120C438E}" destId="{C8881E16-4787-451C-81F6-A6E1C5F25824}" srcOrd="8" destOrd="0" parTransId="{AA6D12B2-DCA4-4A02-AF03-C8580B7BB7CB}" sibTransId="{69FD0CA8-8B7F-4C0A-B522-919D737E5030}"/>
    <dgm:cxn modelId="{26DE23CD-1483-4CD3-969A-481532799F85}" type="presOf" srcId="{A7EB2E53-A0F7-41F9-9F6A-A28410E699DB}" destId="{B3990D9E-965A-4A87-9024-A31D8C18D9AC}" srcOrd="0" destOrd="0" presId="urn:microsoft.com/office/officeart/2005/8/layout/hierarchy2"/>
    <dgm:cxn modelId="{1D4F00CE-66E9-4243-9837-69CFA11D23D7}" type="presOf" srcId="{2A9BE497-61AC-492C-9E1D-96073DB72DE2}" destId="{39CD6B7A-D9CD-49C5-B1C3-2BF6CA65E035}" srcOrd="0" destOrd="0" presId="urn:microsoft.com/office/officeart/2005/8/layout/hierarchy2"/>
    <dgm:cxn modelId="{5239AFCF-DFE0-4396-84E6-5D57AE412BB8}" type="presOf" srcId="{CA6A9C70-223C-4BA6-B22F-E7EE9FCEF901}" destId="{6DE65224-3B60-4229-ACDA-981AA44CA426}" srcOrd="0" destOrd="0" presId="urn:microsoft.com/office/officeart/2005/8/layout/hierarchy2"/>
    <dgm:cxn modelId="{1934D0CF-1E8D-4B17-B666-0C945913728B}" srcId="{A7E59208-D8C8-472E-BF12-F8E4CF3114A2}" destId="{AB141E1E-8A47-473D-BDC9-A740AE0EA3F7}" srcOrd="4" destOrd="0" parTransId="{1930F7C4-5EB2-4BFC-B652-6F6645AD8029}" sibTransId="{91192A3F-4210-4580-A1AE-30F1DDACAD26}"/>
    <dgm:cxn modelId="{95B1A6D3-4246-4BED-8605-9D006627188E}" type="presOf" srcId="{1731A452-294D-4C69-97EA-ABFB841FA0AB}" destId="{AAEF59AE-AA15-4AA2-AEAA-A4784793DDE5}" srcOrd="1" destOrd="0" presId="urn:microsoft.com/office/officeart/2005/8/layout/hierarchy2"/>
    <dgm:cxn modelId="{3A31ACD3-1034-4409-80B6-14C943FE7441}" type="presOf" srcId="{1A98DB96-17DF-475F-B57D-AA7AEC31238C}" destId="{83DAAF3F-DBF1-49B0-8604-B525FB5C908A}" srcOrd="0" destOrd="0" presId="urn:microsoft.com/office/officeart/2005/8/layout/hierarchy2"/>
    <dgm:cxn modelId="{5BDED2D5-1FA4-41FE-B3D2-D464DA59B622}" type="presOf" srcId="{CE4A4217-0410-4729-9337-C36C75DD601B}" destId="{4364814E-1DC4-41D8-96F5-7FCAA16DA2B0}" srcOrd="0" destOrd="0" presId="urn:microsoft.com/office/officeart/2005/8/layout/hierarchy2"/>
    <dgm:cxn modelId="{AB214ED7-45AF-4038-88E6-13DE66C5A0CF}" type="presOf" srcId="{85CA1953-8DEE-44BB-BE58-B97A59C65C13}" destId="{63E06D80-B4DA-4AF5-B318-48676A80383C}" srcOrd="0" destOrd="0" presId="urn:microsoft.com/office/officeart/2005/8/layout/hierarchy2"/>
    <dgm:cxn modelId="{8E7AB9D7-5E84-44E1-B1AE-52F3EA136985}" srcId="{A7E59208-D8C8-472E-BF12-F8E4CF3114A2}" destId="{3E305254-2A1B-4466-9716-16D92D48BD39}" srcOrd="3" destOrd="0" parTransId="{5E84A072-2EA0-45DE-B57C-DA217CA13318}" sibTransId="{28E68593-7507-41E2-BA36-8D5C9263D978}"/>
    <dgm:cxn modelId="{1BA694DA-CAFA-477B-A6D7-2E1B3C64B243}" type="presOf" srcId="{579F7746-AF17-435C-A54C-9C6E6EE94B1D}" destId="{91683DB7-5821-4F63-939D-8271AEDB1AC2}" srcOrd="0" destOrd="0" presId="urn:microsoft.com/office/officeart/2005/8/layout/hierarchy2"/>
    <dgm:cxn modelId="{6C2929DE-5EE4-4902-988F-020CE1D11A52}" type="presOf" srcId="{AF9EC442-AE64-421C-9DF3-0ED0B18D4EC6}" destId="{D315BFC2-F4AA-453C-BEEE-7A8513151049}" srcOrd="1" destOrd="0" presId="urn:microsoft.com/office/officeart/2005/8/layout/hierarchy2"/>
    <dgm:cxn modelId="{95E83BDF-0A7C-4D79-BD1D-E2C11EB1BDB8}" type="presOf" srcId="{CEA4C598-03BA-4196-8096-D8D9940A747B}" destId="{87C9AC31-CDDE-4E1F-B79F-69064C460489}" srcOrd="0" destOrd="0" presId="urn:microsoft.com/office/officeart/2005/8/layout/hierarchy2"/>
    <dgm:cxn modelId="{CB998EE0-00FC-46E7-9404-8446AAA43148}" type="presOf" srcId="{1526BD2C-5491-407F-8729-1EE2B6B3A855}" destId="{AC865C7C-D34F-4978-B07D-384D670F1E47}" srcOrd="0" destOrd="0" presId="urn:microsoft.com/office/officeart/2005/8/layout/hierarchy2"/>
    <dgm:cxn modelId="{31AD32E1-C5F3-41E2-8A34-FBA4D83488DD}" srcId="{4DCC093E-5118-4588-BF05-784A120C438E}" destId="{3B6E185B-6A1C-411C-B39C-F27A6010733C}" srcOrd="1" destOrd="0" parTransId="{C1EACDD7-D989-416D-9681-817FEB9BF90B}" sibTransId="{9A34BB95-B186-435B-AAA0-ED02B3A2EB5F}"/>
    <dgm:cxn modelId="{48228AE2-96F1-4374-9289-F4ACD72A6E17}" type="presOf" srcId="{064DB9D2-173A-4CFB-BE23-C2F5395E90CE}" destId="{57096B24-8CD4-406B-927F-3FABEDAA0D69}" srcOrd="1" destOrd="0" presId="urn:microsoft.com/office/officeart/2005/8/layout/hierarchy2"/>
    <dgm:cxn modelId="{4FFBF3E2-1522-42AF-BA23-014F92B921B3}" srcId="{5E805EC3-C58D-4BD5-A99E-B5CA51F30872}" destId="{3A98E99E-5EB9-499E-9929-61172C5675F2}" srcOrd="0" destOrd="0" parTransId="{C09B2D6A-14B0-4151-BFD3-E21110A5E135}" sibTransId="{E8089669-DCD2-4DB6-A714-273990695241}"/>
    <dgm:cxn modelId="{1A9D4DE3-4A37-4227-B403-A2ADA5B17FB0}" srcId="{C256443A-5739-41C3-976C-086C241C3437}" destId="{353C6F70-9685-47CA-B6F4-8BAAB244C13E}" srcOrd="0" destOrd="0" parTransId="{87404468-AF06-4D92-8599-AEA8859A7AA9}" sibTransId="{68C29FC2-7381-479D-98A3-371A7F9C8B6D}"/>
    <dgm:cxn modelId="{F0C939E4-74A5-4310-86AA-06D23BDBB5AE}" type="presOf" srcId="{1A36E4A0-3C95-4A7E-8403-6FC00333987E}" destId="{272D572E-5B26-4488-A75D-C75C5F075451}" srcOrd="1" destOrd="0" presId="urn:microsoft.com/office/officeart/2005/8/layout/hierarchy2"/>
    <dgm:cxn modelId="{28EAC9E6-7EC9-4452-B6B3-92A0B14CC2D2}" type="presOf" srcId="{F576FE14-F223-4751-B256-BF313602C91E}" destId="{DC301E58-40D8-4D3D-9A40-BAA0C92BDE59}" srcOrd="0" destOrd="0" presId="urn:microsoft.com/office/officeart/2005/8/layout/hierarchy2"/>
    <dgm:cxn modelId="{691788E7-7748-4341-A1AA-2A20B2EF1010}" type="presOf" srcId="{7D4974A8-D315-42CC-B9BB-A3A5CD5225A3}" destId="{D5CD040A-B516-438A-972F-8ED8CDC5F1F6}" srcOrd="1" destOrd="0" presId="urn:microsoft.com/office/officeart/2005/8/layout/hierarchy2"/>
    <dgm:cxn modelId="{225F28E9-5723-4F77-9501-13923EB7D7AE}" srcId="{4E60B1B3-870B-4A1B-9517-73B33DCA2C20}" destId="{6125DCFA-27DB-435B-BEA4-88B2190500A1}" srcOrd="1" destOrd="0" parTransId="{1A98DB96-17DF-475F-B57D-AA7AEC31238C}" sibTransId="{514F69F3-BA1B-4306-A43E-9B675BA1B5FC}"/>
    <dgm:cxn modelId="{5B586EEA-A9C3-484F-86A0-2980FBD7EC53}" type="presOf" srcId="{539788D9-F5CD-499B-8EFE-4BDF10193421}" destId="{5BC45E89-1EAB-43BA-B311-8A95F182C2C2}" srcOrd="1" destOrd="0" presId="urn:microsoft.com/office/officeart/2005/8/layout/hierarchy2"/>
    <dgm:cxn modelId="{8BBCB2EA-1678-4140-B004-E6CBBFA88A2B}" type="presOf" srcId="{E2EBA384-91D3-4018-9EF6-F6F2CD249D13}" destId="{A26EDAF6-44C8-4854-8F91-1F5749D4DC73}" srcOrd="0" destOrd="0" presId="urn:microsoft.com/office/officeart/2005/8/layout/hierarchy2"/>
    <dgm:cxn modelId="{13AF42EF-7EB9-455A-BEE7-083526220C66}" type="presOf" srcId="{A1B0E159-B1C8-4060-A4E0-14F2712C19F0}" destId="{925EDBFF-3D85-437B-9D22-40DBEB5AB8DA}" srcOrd="0" destOrd="0" presId="urn:microsoft.com/office/officeart/2005/8/layout/hierarchy2"/>
    <dgm:cxn modelId="{FE7B8CEF-0BE8-440B-8FE6-48CFBE9258AA}" type="presOf" srcId="{C1EACDD7-D989-416D-9681-817FEB9BF90B}" destId="{56FAFC49-D0EA-4E25-8D48-7123A498BD9B}" srcOrd="0" destOrd="0" presId="urn:microsoft.com/office/officeart/2005/8/layout/hierarchy2"/>
    <dgm:cxn modelId="{F2CE26F0-8DF5-4A14-9C9D-59EFE771385C}" type="presOf" srcId="{89246641-77CD-487A-83F2-C7F1200B9CD3}" destId="{800253CE-BB59-4266-9CEA-CEBDA03E4027}" srcOrd="0" destOrd="0" presId="urn:microsoft.com/office/officeart/2005/8/layout/hierarchy2"/>
    <dgm:cxn modelId="{7ED40CF1-28FB-4983-B533-E0D9648A74B7}" type="presOf" srcId="{03C2E030-813C-4887-94E5-82269C93F63C}" destId="{993A1D06-E7B1-4637-8296-1DEAAA23799F}" srcOrd="1" destOrd="0" presId="urn:microsoft.com/office/officeart/2005/8/layout/hierarchy2"/>
    <dgm:cxn modelId="{7FBB60F2-1783-4DD1-8C7C-AD1030F81ED4}" type="presOf" srcId="{760F7733-46EF-4539-A2FB-454CD8F95E50}" destId="{7E42A3E7-F188-48F4-99B5-B1F4D367F825}" srcOrd="1" destOrd="0" presId="urn:microsoft.com/office/officeart/2005/8/layout/hierarchy2"/>
    <dgm:cxn modelId="{3EBA66F2-A18B-4041-B671-9C6537054F25}" type="presOf" srcId="{579F7746-AF17-435C-A54C-9C6E6EE94B1D}" destId="{D9B96937-FBE0-4586-A2C5-BC85D2155D05}" srcOrd="1" destOrd="0" presId="urn:microsoft.com/office/officeart/2005/8/layout/hierarchy2"/>
    <dgm:cxn modelId="{31FAE4F2-0198-4611-B83E-E9222506DDF1}" type="presOf" srcId="{F855B30C-366F-4036-B5AE-48974C07A80E}" destId="{2F7D4346-F118-454B-9AAD-5BD4A706F402}" srcOrd="0" destOrd="0" presId="urn:microsoft.com/office/officeart/2005/8/layout/hierarchy2"/>
    <dgm:cxn modelId="{52F3EFF6-AE34-4DE1-A420-9A1FB0E5A6E8}" type="presOf" srcId="{41D6EC2F-3103-40F0-AD9A-B96A94477A77}" destId="{481798CD-BDE5-4B57-B01A-E2CEFF5196BF}" srcOrd="0" destOrd="0" presId="urn:microsoft.com/office/officeart/2005/8/layout/hierarchy2"/>
    <dgm:cxn modelId="{9F5227F9-C539-43B5-A269-FBDD076C8049}" type="presOf" srcId="{ECD62ED1-5D11-481E-9BBC-AB020A2EFAFF}" destId="{BF83AAD4-9518-47AA-835D-A40E2C49AF13}" srcOrd="0" destOrd="0" presId="urn:microsoft.com/office/officeart/2005/8/layout/hierarchy2"/>
    <dgm:cxn modelId="{18B32BF9-C15D-49A4-94AE-9BE5B96D30B1}" srcId="{353C6F70-9685-47CA-B6F4-8BAAB244C13E}" destId="{4E60B1B3-870B-4A1B-9517-73B33DCA2C20}" srcOrd="4" destOrd="0" parTransId="{895AD288-8C3F-4FEF-8348-DE71D8D3CA8C}" sibTransId="{E66CBDB9-DF23-432A-9DE5-67E5508FEEDF}"/>
    <dgm:cxn modelId="{BD8AFAFB-6827-47A4-BEE6-B7BD500A967C}" srcId="{F4B2B415-9F5D-4A5C-A517-33028F9EDE23}" destId="{E2EBA384-91D3-4018-9EF6-F6F2CD249D13}" srcOrd="1" destOrd="0" parTransId="{6CF7CD4C-0917-44C0-B3FE-FDC2C5B2A919}" sibTransId="{DEA0B624-4869-47B4-804B-98EC11BA11B7}"/>
    <dgm:cxn modelId="{D337F7FC-93A6-4C86-B264-5AD157D24BFE}" type="presOf" srcId="{010FD920-EA56-439A-976D-37845A8E9EE8}" destId="{E34F5E68-97F6-448B-93CC-7F50A4D760A8}" srcOrd="1" destOrd="0" presId="urn:microsoft.com/office/officeart/2005/8/layout/hierarchy2"/>
    <dgm:cxn modelId="{7E06C4FF-C4C0-473E-B740-F3D69BDDDEEE}" type="presOf" srcId="{7D4974A8-D315-42CC-B9BB-A3A5CD5225A3}" destId="{92D0DEB7-F9E3-4085-A056-1B4AA5D907F0}" srcOrd="0" destOrd="0" presId="urn:microsoft.com/office/officeart/2005/8/layout/hierarchy2"/>
    <dgm:cxn modelId="{597F06D3-B575-465D-B676-B0F722FB30BE}" type="presParOf" srcId="{4A87926E-2F89-4541-AD41-F858508AC316}" destId="{D0337419-FCAE-4D52-B05C-516C20818889}" srcOrd="0" destOrd="0" presId="urn:microsoft.com/office/officeart/2005/8/layout/hierarchy2"/>
    <dgm:cxn modelId="{1F24460F-0471-46BE-BA03-288B7DF16AA9}" type="presParOf" srcId="{D0337419-FCAE-4D52-B05C-516C20818889}" destId="{F78A7B94-B816-41D1-873A-8D5A3EB8CC40}" srcOrd="0" destOrd="0" presId="urn:microsoft.com/office/officeart/2005/8/layout/hierarchy2"/>
    <dgm:cxn modelId="{743AA5F4-CE3B-4B5B-8CEE-481703E525FD}" type="presParOf" srcId="{D0337419-FCAE-4D52-B05C-516C20818889}" destId="{457B3FD6-8EF7-4A94-BB29-C9471CDE92CD}" srcOrd="1" destOrd="0" presId="urn:microsoft.com/office/officeart/2005/8/layout/hierarchy2"/>
    <dgm:cxn modelId="{BD059158-A805-4DC5-90B2-7843B32CEB7E}" type="presParOf" srcId="{457B3FD6-8EF7-4A94-BB29-C9471CDE92CD}" destId="{2F7D4346-F118-454B-9AAD-5BD4A706F402}" srcOrd="0" destOrd="0" presId="urn:microsoft.com/office/officeart/2005/8/layout/hierarchy2"/>
    <dgm:cxn modelId="{E9C42014-BB56-4DF6-A4D5-8B643B58546B}" type="presParOf" srcId="{2F7D4346-F118-454B-9AAD-5BD4A706F402}" destId="{8E782F7D-B5EB-45C3-8750-549909A533F3}" srcOrd="0" destOrd="0" presId="urn:microsoft.com/office/officeart/2005/8/layout/hierarchy2"/>
    <dgm:cxn modelId="{15C6BAC7-CC53-4C13-92ED-C434044C7832}" type="presParOf" srcId="{457B3FD6-8EF7-4A94-BB29-C9471CDE92CD}" destId="{D988932E-C931-4512-A8F2-C38E4F67EB7D}" srcOrd="1" destOrd="0" presId="urn:microsoft.com/office/officeart/2005/8/layout/hierarchy2"/>
    <dgm:cxn modelId="{AD375933-167D-4601-A024-5576B5020DC1}" type="presParOf" srcId="{D988932E-C931-4512-A8F2-C38E4F67EB7D}" destId="{430F15C4-6A15-46B0-808C-1CBD7A4F9165}" srcOrd="0" destOrd="0" presId="urn:microsoft.com/office/officeart/2005/8/layout/hierarchy2"/>
    <dgm:cxn modelId="{F890348F-EE5D-4E90-A3F7-9AD8D90F07B5}" type="presParOf" srcId="{D988932E-C931-4512-A8F2-C38E4F67EB7D}" destId="{A62861FB-C1E1-4913-99BB-D18D0BA7EF62}" srcOrd="1" destOrd="0" presId="urn:microsoft.com/office/officeart/2005/8/layout/hierarchy2"/>
    <dgm:cxn modelId="{678A64AF-7BC9-445E-92CC-B519135F6398}" type="presParOf" srcId="{A62861FB-C1E1-4913-99BB-D18D0BA7EF62}" destId="{4838F315-A0EB-4974-8233-371CFFCC1CE4}" srcOrd="0" destOrd="0" presId="urn:microsoft.com/office/officeart/2005/8/layout/hierarchy2"/>
    <dgm:cxn modelId="{3B98B53A-3FFC-4F7E-BE10-6D68A92C0513}" type="presParOf" srcId="{4838F315-A0EB-4974-8233-371CFFCC1CE4}" destId="{E36F28F1-4932-4D2B-B680-9D2F1B515793}" srcOrd="0" destOrd="0" presId="urn:microsoft.com/office/officeart/2005/8/layout/hierarchy2"/>
    <dgm:cxn modelId="{1D351115-D6A0-4CE4-9696-89C536797AC6}" type="presParOf" srcId="{A62861FB-C1E1-4913-99BB-D18D0BA7EF62}" destId="{DDFF5742-CF69-471F-841B-FF79B1E24A3C}" srcOrd="1" destOrd="0" presId="urn:microsoft.com/office/officeart/2005/8/layout/hierarchy2"/>
    <dgm:cxn modelId="{28022EF5-8C2F-46A0-9000-9C262A34A1D3}" type="presParOf" srcId="{DDFF5742-CF69-471F-841B-FF79B1E24A3C}" destId="{0B80F301-D09A-4FB6-916E-CECF32B2F143}" srcOrd="0" destOrd="0" presId="urn:microsoft.com/office/officeart/2005/8/layout/hierarchy2"/>
    <dgm:cxn modelId="{68AD8F80-EF68-480D-AA85-5D5602110B0E}" type="presParOf" srcId="{DDFF5742-CF69-471F-841B-FF79B1E24A3C}" destId="{01C225FF-8339-4AED-93A9-27AB32E3DF0B}" srcOrd="1" destOrd="0" presId="urn:microsoft.com/office/officeart/2005/8/layout/hierarchy2"/>
    <dgm:cxn modelId="{03BAA165-9A4C-4098-A664-306688DCE6BE}" type="presParOf" srcId="{A62861FB-C1E1-4913-99BB-D18D0BA7EF62}" destId="{750F2EA3-C6A2-49D8-A4E9-ECB36FFC366E}" srcOrd="2" destOrd="0" presId="urn:microsoft.com/office/officeart/2005/8/layout/hierarchy2"/>
    <dgm:cxn modelId="{24A098B6-C80D-44CD-8A26-C20028D01058}" type="presParOf" srcId="{750F2EA3-C6A2-49D8-A4E9-ECB36FFC366E}" destId="{066D82E6-DD7A-4789-BA1F-74B091D397C9}" srcOrd="0" destOrd="0" presId="urn:microsoft.com/office/officeart/2005/8/layout/hierarchy2"/>
    <dgm:cxn modelId="{DA5073F8-B0FE-4FA8-B647-668DF28A9DFE}" type="presParOf" srcId="{A62861FB-C1E1-4913-99BB-D18D0BA7EF62}" destId="{D3F69F3A-148E-4673-B1FF-6A8AC1FE2DCE}" srcOrd="3" destOrd="0" presId="urn:microsoft.com/office/officeart/2005/8/layout/hierarchy2"/>
    <dgm:cxn modelId="{3C3B564C-5064-436C-9F5D-0F9D2581EF21}" type="presParOf" srcId="{D3F69F3A-148E-4673-B1FF-6A8AC1FE2DCE}" destId="{70A6C9AF-4497-49E2-8F6B-4022C002A32C}" srcOrd="0" destOrd="0" presId="urn:microsoft.com/office/officeart/2005/8/layout/hierarchy2"/>
    <dgm:cxn modelId="{CF1CE5E8-B994-4993-90A2-DB6E02897FA7}" type="presParOf" srcId="{D3F69F3A-148E-4673-B1FF-6A8AC1FE2DCE}" destId="{75CD52C9-9125-48F6-9D99-712D3BC58122}" srcOrd="1" destOrd="0" presId="urn:microsoft.com/office/officeart/2005/8/layout/hierarchy2"/>
    <dgm:cxn modelId="{3465795E-55B9-42EF-BC29-D2E506D67FDE}" type="presParOf" srcId="{A62861FB-C1E1-4913-99BB-D18D0BA7EF62}" destId="{B99573E9-A46B-4C67-A741-44E4FCB4FC8A}" srcOrd="4" destOrd="0" presId="urn:microsoft.com/office/officeart/2005/8/layout/hierarchy2"/>
    <dgm:cxn modelId="{1D4B3EFE-7129-49B7-A4BE-65C05A19A1F1}" type="presParOf" srcId="{B99573E9-A46B-4C67-A741-44E4FCB4FC8A}" destId="{AAEF59AE-AA15-4AA2-AEAA-A4784793DDE5}" srcOrd="0" destOrd="0" presId="urn:microsoft.com/office/officeart/2005/8/layout/hierarchy2"/>
    <dgm:cxn modelId="{5226A0E2-2609-4953-8D10-AB4528A6C2E2}" type="presParOf" srcId="{A62861FB-C1E1-4913-99BB-D18D0BA7EF62}" destId="{7019262D-F9E7-43D3-B6F1-BE5C8FC760AB}" srcOrd="5" destOrd="0" presId="urn:microsoft.com/office/officeart/2005/8/layout/hierarchy2"/>
    <dgm:cxn modelId="{A7A58A64-A5BE-4AC5-8D7E-3C54174EB9BC}" type="presParOf" srcId="{7019262D-F9E7-43D3-B6F1-BE5C8FC760AB}" destId="{049F2968-73E2-4348-A8D7-E885F2B2F00E}" srcOrd="0" destOrd="0" presId="urn:microsoft.com/office/officeart/2005/8/layout/hierarchy2"/>
    <dgm:cxn modelId="{62E60BA4-19F8-4BE5-9CA4-4782AFC0BDAB}" type="presParOf" srcId="{7019262D-F9E7-43D3-B6F1-BE5C8FC760AB}" destId="{9CD1B84C-59C7-4394-B671-9D4A34E2A244}" srcOrd="1" destOrd="0" presId="urn:microsoft.com/office/officeart/2005/8/layout/hierarchy2"/>
    <dgm:cxn modelId="{3C6E73A1-AD49-4BE9-81A8-24A7E4B91F6C}" type="presParOf" srcId="{457B3FD6-8EF7-4A94-BB29-C9471CDE92CD}" destId="{6C074D18-1EA0-40FB-94A6-DD4C52B7D46C}" srcOrd="2" destOrd="0" presId="urn:microsoft.com/office/officeart/2005/8/layout/hierarchy2"/>
    <dgm:cxn modelId="{19938980-7021-4114-8956-A9626061AFF6}" type="presParOf" srcId="{6C074D18-1EA0-40FB-94A6-DD4C52B7D46C}" destId="{740522B2-75E3-4986-BE71-6201CAF74879}" srcOrd="0" destOrd="0" presId="urn:microsoft.com/office/officeart/2005/8/layout/hierarchy2"/>
    <dgm:cxn modelId="{F5883D1D-4C9C-4F12-87C6-CD9BF270EDF9}" type="presParOf" srcId="{457B3FD6-8EF7-4A94-BB29-C9471CDE92CD}" destId="{923ABA98-7991-407C-B596-10BA5F513C20}" srcOrd="3" destOrd="0" presId="urn:microsoft.com/office/officeart/2005/8/layout/hierarchy2"/>
    <dgm:cxn modelId="{1D5DB772-BB59-452A-9751-AA2DC9225FF3}" type="presParOf" srcId="{923ABA98-7991-407C-B596-10BA5F513C20}" destId="{3B5C04C0-1026-4BCC-B8D1-09CC708E27EF}" srcOrd="0" destOrd="0" presId="urn:microsoft.com/office/officeart/2005/8/layout/hierarchy2"/>
    <dgm:cxn modelId="{4620C55A-B514-4F7B-BC09-1A60334F55B2}" type="presParOf" srcId="{923ABA98-7991-407C-B596-10BA5F513C20}" destId="{63E65136-FB97-46CC-93F6-1E9121ADE6EE}" srcOrd="1" destOrd="0" presId="urn:microsoft.com/office/officeart/2005/8/layout/hierarchy2"/>
    <dgm:cxn modelId="{60418301-86D3-4D2D-92E0-2303337C7CAD}" type="presParOf" srcId="{63E65136-FB97-46CC-93F6-1E9121ADE6EE}" destId="{1933032C-D9EF-4E95-9447-72395E90BD3C}" srcOrd="0" destOrd="0" presId="urn:microsoft.com/office/officeart/2005/8/layout/hierarchy2"/>
    <dgm:cxn modelId="{925D5D40-D67B-4703-A1F2-E698ECD90017}" type="presParOf" srcId="{1933032C-D9EF-4E95-9447-72395E90BD3C}" destId="{DDA1B4D0-DAFF-4A7B-B757-2D0EB38A13A7}" srcOrd="0" destOrd="0" presId="urn:microsoft.com/office/officeart/2005/8/layout/hierarchy2"/>
    <dgm:cxn modelId="{FFDAD2E4-6B8E-4DEE-9F59-443AEC4A4B89}" type="presParOf" srcId="{63E65136-FB97-46CC-93F6-1E9121ADE6EE}" destId="{658C8869-04C9-4951-AD31-366FF613DDA0}" srcOrd="1" destOrd="0" presId="urn:microsoft.com/office/officeart/2005/8/layout/hierarchy2"/>
    <dgm:cxn modelId="{BA7D15FC-240B-4E86-BA77-4E02E65347F8}" type="presParOf" srcId="{658C8869-04C9-4951-AD31-366FF613DDA0}" destId="{85D196B6-063E-44EA-88B6-502D03441A95}" srcOrd="0" destOrd="0" presId="urn:microsoft.com/office/officeart/2005/8/layout/hierarchy2"/>
    <dgm:cxn modelId="{41DDCFA7-8E3D-44F4-AD23-F7A20F734B2A}" type="presParOf" srcId="{658C8869-04C9-4951-AD31-366FF613DDA0}" destId="{6631D1CF-F995-496A-B550-A56FC7462583}" srcOrd="1" destOrd="0" presId="urn:microsoft.com/office/officeart/2005/8/layout/hierarchy2"/>
    <dgm:cxn modelId="{2B2BCCB1-A94B-46A8-9505-554BFED7CA00}" type="presParOf" srcId="{6631D1CF-F995-496A-B550-A56FC7462583}" destId="{39A8889A-DFEF-4793-B12D-3BA4A3083E3E}" srcOrd="0" destOrd="0" presId="urn:microsoft.com/office/officeart/2005/8/layout/hierarchy2"/>
    <dgm:cxn modelId="{809A581F-BE5C-4903-8808-5C31E944FF5B}" type="presParOf" srcId="{39A8889A-DFEF-4793-B12D-3BA4A3083E3E}" destId="{993A1D06-E7B1-4637-8296-1DEAAA23799F}" srcOrd="0" destOrd="0" presId="urn:microsoft.com/office/officeart/2005/8/layout/hierarchy2"/>
    <dgm:cxn modelId="{FB819964-57DD-455F-93C0-80D347B8D81D}" type="presParOf" srcId="{6631D1CF-F995-496A-B550-A56FC7462583}" destId="{70EDD1C1-63F0-4263-8036-027FA4CD0523}" srcOrd="1" destOrd="0" presId="urn:microsoft.com/office/officeart/2005/8/layout/hierarchy2"/>
    <dgm:cxn modelId="{3B8D2B87-2B6E-4EBF-A32E-BE4737759471}" type="presParOf" srcId="{70EDD1C1-63F0-4263-8036-027FA4CD0523}" destId="{29B3ABBF-0291-41BA-9070-E0CB070E1723}" srcOrd="0" destOrd="0" presId="urn:microsoft.com/office/officeart/2005/8/layout/hierarchy2"/>
    <dgm:cxn modelId="{F8080303-9DDE-409E-88AD-2A0B70B21C82}" type="presParOf" srcId="{70EDD1C1-63F0-4263-8036-027FA4CD0523}" destId="{FAA504E9-7E4D-4F77-A140-2ECF8E058BD1}" srcOrd="1" destOrd="0" presId="urn:microsoft.com/office/officeart/2005/8/layout/hierarchy2"/>
    <dgm:cxn modelId="{22FD1C93-0C9B-4A3C-B796-4FB5F079B9B2}" type="presParOf" srcId="{6631D1CF-F995-496A-B550-A56FC7462583}" destId="{16EDC4EB-15B1-4BED-A913-C4910A592E43}" srcOrd="2" destOrd="0" presId="urn:microsoft.com/office/officeart/2005/8/layout/hierarchy2"/>
    <dgm:cxn modelId="{2170520A-E0EE-4CD9-9AA2-62E8B800CAC2}" type="presParOf" srcId="{16EDC4EB-15B1-4BED-A913-C4910A592E43}" destId="{16FE4A7B-83F7-4D09-B9FE-7AABA7BB071E}" srcOrd="0" destOrd="0" presId="urn:microsoft.com/office/officeart/2005/8/layout/hierarchy2"/>
    <dgm:cxn modelId="{AC712E41-161D-4E27-82D1-504F40B0353F}" type="presParOf" srcId="{6631D1CF-F995-496A-B550-A56FC7462583}" destId="{682C3E9E-A664-4AEB-98FA-7A56B9FCB066}" srcOrd="3" destOrd="0" presId="urn:microsoft.com/office/officeart/2005/8/layout/hierarchy2"/>
    <dgm:cxn modelId="{54983000-5356-4AE5-A207-2BA92A53D99B}" type="presParOf" srcId="{682C3E9E-A664-4AEB-98FA-7A56B9FCB066}" destId="{3D93AA13-F9BF-4516-9343-01C4FE687B9F}" srcOrd="0" destOrd="0" presId="urn:microsoft.com/office/officeart/2005/8/layout/hierarchy2"/>
    <dgm:cxn modelId="{477E67DA-EE18-494B-88E4-4AB5D524ECBC}" type="presParOf" srcId="{682C3E9E-A664-4AEB-98FA-7A56B9FCB066}" destId="{FA14F626-8A10-4F1C-A2B9-289709A47DFF}" srcOrd="1" destOrd="0" presId="urn:microsoft.com/office/officeart/2005/8/layout/hierarchy2"/>
    <dgm:cxn modelId="{0061186C-9F00-4A54-94B7-4B68BE7A2D13}" type="presParOf" srcId="{63E65136-FB97-46CC-93F6-1E9121ADE6EE}" destId="{BE69F2C5-1F16-4884-B39F-EE6B06025848}" srcOrd="2" destOrd="0" presId="urn:microsoft.com/office/officeart/2005/8/layout/hierarchy2"/>
    <dgm:cxn modelId="{0E4D0548-5519-4FCA-8FDA-0367C505242C}" type="presParOf" srcId="{BE69F2C5-1F16-4884-B39F-EE6B06025848}" destId="{7095C669-4F3E-4E90-960F-1302F717ACD3}" srcOrd="0" destOrd="0" presId="urn:microsoft.com/office/officeart/2005/8/layout/hierarchy2"/>
    <dgm:cxn modelId="{9BC4DC1F-71BE-41AB-B6D5-A8E87E3D0C9D}" type="presParOf" srcId="{63E65136-FB97-46CC-93F6-1E9121ADE6EE}" destId="{FB910F99-8F7B-4955-BA14-D3CBD5F0BE0B}" srcOrd="3" destOrd="0" presId="urn:microsoft.com/office/officeart/2005/8/layout/hierarchy2"/>
    <dgm:cxn modelId="{CE4C4482-BA09-4F35-AF28-345F8879B05A}" type="presParOf" srcId="{FB910F99-8F7B-4955-BA14-D3CBD5F0BE0B}" destId="{C631F0D8-FAAD-405A-A21C-737F0EB151CA}" srcOrd="0" destOrd="0" presId="urn:microsoft.com/office/officeart/2005/8/layout/hierarchy2"/>
    <dgm:cxn modelId="{E85D544F-0A0D-49D9-9834-45CD2A0A44D3}" type="presParOf" srcId="{FB910F99-8F7B-4955-BA14-D3CBD5F0BE0B}" destId="{FBF4A851-80A7-4420-B39A-AFC31A510810}" srcOrd="1" destOrd="0" presId="urn:microsoft.com/office/officeart/2005/8/layout/hierarchy2"/>
    <dgm:cxn modelId="{536E1237-813C-4E34-8A3F-689FAD71F483}" type="presParOf" srcId="{63E65136-FB97-46CC-93F6-1E9121ADE6EE}" destId="{8D2BE030-0831-42B2-98C2-0F6E87AD5B7D}" srcOrd="4" destOrd="0" presId="urn:microsoft.com/office/officeart/2005/8/layout/hierarchy2"/>
    <dgm:cxn modelId="{D4FEFEEA-BC90-4BA0-B70B-B64139842084}" type="presParOf" srcId="{8D2BE030-0831-42B2-98C2-0F6E87AD5B7D}" destId="{778A5A6C-5BCE-43A2-9985-988597C18905}" srcOrd="0" destOrd="0" presId="urn:microsoft.com/office/officeart/2005/8/layout/hierarchy2"/>
    <dgm:cxn modelId="{32DBB28F-63FA-423F-9351-0D740436839A}" type="presParOf" srcId="{63E65136-FB97-46CC-93F6-1E9121ADE6EE}" destId="{32EA519B-D3EF-457A-9C5B-9E4A9B562622}" srcOrd="5" destOrd="0" presId="urn:microsoft.com/office/officeart/2005/8/layout/hierarchy2"/>
    <dgm:cxn modelId="{DFC0D8A7-0998-49F6-A00D-77B38273FB66}" type="presParOf" srcId="{32EA519B-D3EF-457A-9C5B-9E4A9B562622}" destId="{29EF756E-ED73-4753-83B6-EFB27D8AB242}" srcOrd="0" destOrd="0" presId="urn:microsoft.com/office/officeart/2005/8/layout/hierarchy2"/>
    <dgm:cxn modelId="{36968C25-30D5-45D3-B432-AC71B71DB041}" type="presParOf" srcId="{32EA519B-D3EF-457A-9C5B-9E4A9B562622}" destId="{B580F2EF-10D1-43DE-86DA-65887B64442D}" srcOrd="1" destOrd="0" presId="urn:microsoft.com/office/officeart/2005/8/layout/hierarchy2"/>
    <dgm:cxn modelId="{EA057276-E93F-41C5-8811-E8EAC0000EB7}" type="presParOf" srcId="{63E65136-FB97-46CC-93F6-1E9121ADE6EE}" destId="{A20C5029-8277-4F52-A215-36A9DA1AB52E}" srcOrd="6" destOrd="0" presId="urn:microsoft.com/office/officeart/2005/8/layout/hierarchy2"/>
    <dgm:cxn modelId="{1F5E7CDC-A434-4087-BF5A-702A773F9C84}" type="presParOf" srcId="{A20C5029-8277-4F52-A215-36A9DA1AB52E}" destId="{B80DAFEB-A4DF-442E-B7BA-955CB74D383A}" srcOrd="0" destOrd="0" presId="urn:microsoft.com/office/officeart/2005/8/layout/hierarchy2"/>
    <dgm:cxn modelId="{A702F75C-64B5-432C-B6D3-042BD3CADA8F}" type="presParOf" srcId="{63E65136-FB97-46CC-93F6-1E9121ADE6EE}" destId="{00239F36-7CCC-4EC4-8664-6CDB34CC30AA}" srcOrd="7" destOrd="0" presId="urn:microsoft.com/office/officeart/2005/8/layout/hierarchy2"/>
    <dgm:cxn modelId="{99F43357-8D08-4AF0-B3AD-0FAEC35E540F}" type="presParOf" srcId="{00239F36-7CCC-4EC4-8664-6CDB34CC30AA}" destId="{EC3C7E9C-DE6F-4CF5-B8A3-EB96093DECF2}" srcOrd="0" destOrd="0" presId="urn:microsoft.com/office/officeart/2005/8/layout/hierarchy2"/>
    <dgm:cxn modelId="{9299794E-1D9F-4C48-83D4-4AC972801EEB}" type="presParOf" srcId="{00239F36-7CCC-4EC4-8664-6CDB34CC30AA}" destId="{9547E60A-4616-40DD-BB3B-048D8FF09B27}" srcOrd="1" destOrd="0" presId="urn:microsoft.com/office/officeart/2005/8/layout/hierarchy2"/>
    <dgm:cxn modelId="{48EEA27C-2564-460C-A5AC-8B7B0475FB61}" type="presParOf" srcId="{63E65136-FB97-46CC-93F6-1E9121ADE6EE}" destId="{FCAF4F74-DA65-4B57-BED5-BD3F26CA3653}" srcOrd="8" destOrd="0" presId="urn:microsoft.com/office/officeart/2005/8/layout/hierarchy2"/>
    <dgm:cxn modelId="{D6D5780E-CA0E-4A88-B8F7-C5125F68F4BB}" type="presParOf" srcId="{FCAF4F74-DA65-4B57-BED5-BD3F26CA3653}" destId="{58DDB727-F29C-4C9B-AF2C-EA0167F90FF0}" srcOrd="0" destOrd="0" presId="urn:microsoft.com/office/officeart/2005/8/layout/hierarchy2"/>
    <dgm:cxn modelId="{9D5208E0-3292-464F-BD75-077B9B810ED8}" type="presParOf" srcId="{63E65136-FB97-46CC-93F6-1E9121ADE6EE}" destId="{91501DD1-CFE9-4FBA-823D-10880E2002A9}" srcOrd="9" destOrd="0" presId="urn:microsoft.com/office/officeart/2005/8/layout/hierarchy2"/>
    <dgm:cxn modelId="{91F1DC3C-926C-4FD6-B67E-78392CBD503C}" type="presParOf" srcId="{91501DD1-CFE9-4FBA-823D-10880E2002A9}" destId="{963787CF-28FB-43DF-98C2-C462DE3D4B6D}" srcOrd="0" destOrd="0" presId="urn:microsoft.com/office/officeart/2005/8/layout/hierarchy2"/>
    <dgm:cxn modelId="{30B821F8-F6CC-421C-BA8D-AA3B0183CD06}" type="presParOf" srcId="{91501DD1-CFE9-4FBA-823D-10880E2002A9}" destId="{793CF8CB-4DC0-4A07-8366-31517125F577}" srcOrd="1" destOrd="0" presId="urn:microsoft.com/office/officeart/2005/8/layout/hierarchy2"/>
    <dgm:cxn modelId="{ABF2E6C8-2019-45CA-896E-4529A88515C7}" type="presParOf" srcId="{63E65136-FB97-46CC-93F6-1E9121ADE6EE}" destId="{52995CFF-A2C0-41A9-B8F6-E167247A0F1E}" srcOrd="10" destOrd="0" presId="urn:microsoft.com/office/officeart/2005/8/layout/hierarchy2"/>
    <dgm:cxn modelId="{A9224AB5-E523-4331-A327-B5A9534DA474}" type="presParOf" srcId="{52995CFF-A2C0-41A9-B8F6-E167247A0F1E}" destId="{363F3F8F-4CCA-4730-9344-E43FC3582DD0}" srcOrd="0" destOrd="0" presId="urn:microsoft.com/office/officeart/2005/8/layout/hierarchy2"/>
    <dgm:cxn modelId="{EBEFF2E9-D311-40A5-9A17-15EF1745C2E6}" type="presParOf" srcId="{63E65136-FB97-46CC-93F6-1E9121ADE6EE}" destId="{539280CC-7E34-4575-8E03-0EE6EBFD0B7C}" srcOrd="11" destOrd="0" presId="urn:microsoft.com/office/officeart/2005/8/layout/hierarchy2"/>
    <dgm:cxn modelId="{57422252-288C-48FA-B935-985DF04028FC}" type="presParOf" srcId="{539280CC-7E34-4575-8E03-0EE6EBFD0B7C}" destId="{15869452-7DB1-4E38-961A-AD18E7BF97A4}" srcOrd="0" destOrd="0" presId="urn:microsoft.com/office/officeart/2005/8/layout/hierarchy2"/>
    <dgm:cxn modelId="{ED4039E8-6923-4C41-B1E3-10F7BF3D3F34}" type="presParOf" srcId="{539280CC-7E34-4575-8E03-0EE6EBFD0B7C}" destId="{A67F4D00-5318-48B1-8F6F-4C6D0840EE34}" srcOrd="1" destOrd="0" presId="urn:microsoft.com/office/officeart/2005/8/layout/hierarchy2"/>
    <dgm:cxn modelId="{06717F61-43E2-4F69-925A-14AADC8270E2}" type="presParOf" srcId="{A67F4D00-5318-48B1-8F6F-4C6D0840EE34}" destId="{6DE65224-3B60-4229-ACDA-981AA44CA426}" srcOrd="0" destOrd="0" presId="urn:microsoft.com/office/officeart/2005/8/layout/hierarchy2"/>
    <dgm:cxn modelId="{DA0CCBD6-8447-4106-B082-BA8A7007C677}" type="presParOf" srcId="{6DE65224-3B60-4229-ACDA-981AA44CA426}" destId="{30A5F9D5-7BBD-431C-88C3-CC070B8111E2}" srcOrd="0" destOrd="0" presId="urn:microsoft.com/office/officeart/2005/8/layout/hierarchy2"/>
    <dgm:cxn modelId="{0097F2C7-AC29-4F24-80C3-6D0BA014875B}" type="presParOf" srcId="{A67F4D00-5318-48B1-8F6F-4C6D0840EE34}" destId="{4C27843F-B856-4330-96BA-255D39C16F9A}" srcOrd="1" destOrd="0" presId="urn:microsoft.com/office/officeart/2005/8/layout/hierarchy2"/>
    <dgm:cxn modelId="{052E1475-5936-4A09-AD9A-DDA2B66D9A31}" type="presParOf" srcId="{4C27843F-B856-4330-96BA-255D39C16F9A}" destId="{D2E49161-A7B6-4759-AC1C-493631AA99EA}" srcOrd="0" destOrd="0" presId="urn:microsoft.com/office/officeart/2005/8/layout/hierarchy2"/>
    <dgm:cxn modelId="{52773B41-F33C-4E77-B63B-22E0902091C2}" type="presParOf" srcId="{4C27843F-B856-4330-96BA-255D39C16F9A}" destId="{B34508A2-9F6C-4930-976B-93634811EA5F}" srcOrd="1" destOrd="0" presId="urn:microsoft.com/office/officeart/2005/8/layout/hierarchy2"/>
    <dgm:cxn modelId="{5D4DDC7A-5010-42C8-9AD3-8FE3A96A4F42}" type="presParOf" srcId="{A67F4D00-5318-48B1-8F6F-4C6D0840EE34}" destId="{D3655785-2D54-4F59-9234-66AFAA7E681A}" srcOrd="2" destOrd="0" presId="urn:microsoft.com/office/officeart/2005/8/layout/hierarchy2"/>
    <dgm:cxn modelId="{6BEBB540-1D6C-4EAE-AF7E-5DDEDC211AD1}" type="presParOf" srcId="{D3655785-2D54-4F59-9234-66AFAA7E681A}" destId="{9698C83B-59AA-460C-B76E-A13EFE8BCD17}" srcOrd="0" destOrd="0" presId="urn:microsoft.com/office/officeart/2005/8/layout/hierarchy2"/>
    <dgm:cxn modelId="{FA91B72A-3038-4A54-8ABE-87EA853FCC3C}" type="presParOf" srcId="{A67F4D00-5318-48B1-8F6F-4C6D0840EE34}" destId="{1C087AE5-74C3-48F7-9B1F-7643819D62F7}" srcOrd="3" destOrd="0" presId="urn:microsoft.com/office/officeart/2005/8/layout/hierarchy2"/>
    <dgm:cxn modelId="{87F84FEF-638F-4E90-8E6F-51BD504A70F2}" type="presParOf" srcId="{1C087AE5-74C3-48F7-9B1F-7643819D62F7}" destId="{A26EDAF6-44C8-4854-8F91-1F5749D4DC73}" srcOrd="0" destOrd="0" presId="urn:microsoft.com/office/officeart/2005/8/layout/hierarchy2"/>
    <dgm:cxn modelId="{CBCFE522-6DE8-4B1D-B88A-B9D50D85D2AD}" type="presParOf" srcId="{1C087AE5-74C3-48F7-9B1F-7643819D62F7}" destId="{E9A748F2-229D-45E3-B7F0-1D7693EBB797}" srcOrd="1" destOrd="0" presId="urn:microsoft.com/office/officeart/2005/8/layout/hierarchy2"/>
    <dgm:cxn modelId="{AC2EB3FF-6A64-4773-B986-35FE29F6FAF2}" type="presParOf" srcId="{A67F4D00-5318-48B1-8F6F-4C6D0840EE34}" destId="{FB2F6D88-F506-4847-B326-8EC15F62040F}" srcOrd="4" destOrd="0" presId="urn:microsoft.com/office/officeart/2005/8/layout/hierarchy2"/>
    <dgm:cxn modelId="{7BA27F37-18B8-4459-9FD4-013034FEC5DB}" type="presParOf" srcId="{FB2F6D88-F506-4847-B326-8EC15F62040F}" destId="{5BC45E89-1EAB-43BA-B311-8A95F182C2C2}" srcOrd="0" destOrd="0" presId="urn:microsoft.com/office/officeart/2005/8/layout/hierarchy2"/>
    <dgm:cxn modelId="{576F151C-5255-4F08-B925-D0C6BC4D6947}" type="presParOf" srcId="{A67F4D00-5318-48B1-8F6F-4C6D0840EE34}" destId="{66D7E067-5337-459E-866E-2A8CE9CD2228}" srcOrd="5" destOrd="0" presId="urn:microsoft.com/office/officeart/2005/8/layout/hierarchy2"/>
    <dgm:cxn modelId="{321B38E5-EE1B-4B1D-A3BF-8DE416A88537}" type="presParOf" srcId="{66D7E067-5337-459E-866E-2A8CE9CD2228}" destId="{4364814E-1DC4-41D8-96F5-7FCAA16DA2B0}" srcOrd="0" destOrd="0" presId="urn:microsoft.com/office/officeart/2005/8/layout/hierarchy2"/>
    <dgm:cxn modelId="{4A25102A-972A-4233-805F-16BEA3514E79}" type="presParOf" srcId="{66D7E067-5337-459E-866E-2A8CE9CD2228}" destId="{654D766E-39ED-4868-AAEF-1A28544B5F5D}" srcOrd="1" destOrd="0" presId="urn:microsoft.com/office/officeart/2005/8/layout/hierarchy2"/>
    <dgm:cxn modelId="{7CA94465-80EB-4D5B-9580-DBF783C6FB6A}" type="presParOf" srcId="{A67F4D00-5318-48B1-8F6F-4C6D0840EE34}" destId="{5BC2E700-F976-45E3-88A6-547D0BC5C286}" srcOrd="6" destOrd="0" presId="urn:microsoft.com/office/officeart/2005/8/layout/hierarchy2"/>
    <dgm:cxn modelId="{0ECCEF91-D189-45D6-9A4F-E9BD3D65BE69}" type="presParOf" srcId="{5BC2E700-F976-45E3-88A6-547D0BC5C286}" destId="{5EE677E4-1C6E-4B89-9610-5064AAB1F7F5}" srcOrd="0" destOrd="0" presId="urn:microsoft.com/office/officeart/2005/8/layout/hierarchy2"/>
    <dgm:cxn modelId="{A67EB32F-7804-4F4E-BE80-96593AD330CF}" type="presParOf" srcId="{A67F4D00-5318-48B1-8F6F-4C6D0840EE34}" destId="{6A66418A-D546-46F7-87E7-DA1E687FB1FE}" srcOrd="7" destOrd="0" presId="urn:microsoft.com/office/officeart/2005/8/layout/hierarchy2"/>
    <dgm:cxn modelId="{3A9388F7-7C21-451D-99C2-633FDE439124}" type="presParOf" srcId="{6A66418A-D546-46F7-87E7-DA1E687FB1FE}" destId="{677DE54C-6078-40B3-9FE8-CF37F7EF3F0C}" srcOrd="0" destOrd="0" presId="urn:microsoft.com/office/officeart/2005/8/layout/hierarchy2"/>
    <dgm:cxn modelId="{F60C5AC0-8147-4907-8379-FF40B5FFA4BC}" type="presParOf" srcId="{6A66418A-D546-46F7-87E7-DA1E687FB1FE}" destId="{A887E327-8C38-4695-BD51-70185935A672}" srcOrd="1" destOrd="0" presId="urn:microsoft.com/office/officeart/2005/8/layout/hierarchy2"/>
    <dgm:cxn modelId="{288CCAA8-2435-4DCC-B56B-1F8D72EA1CC4}" type="presParOf" srcId="{A67F4D00-5318-48B1-8F6F-4C6D0840EE34}" destId="{007AF09B-7B63-4C84-BFB2-EF40ED79070D}" srcOrd="8" destOrd="0" presId="urn:microsoft.com/office/officeart/2005/8/layout/hierarchy2"/>
    <dgm:cxn modelId="{0942A9B8-9920-49B7-A73C-33E094C171FC}" type="presParOf" srcId="{007AF09B-7B63-4C84-BFB2-EF40ED79070D}" destId="{1C784E67-44D5-495B-BFB2-4C4FDB887CF2}" srcOrd="0" destOrd="0" presId="urn:microsoft.com/office/officeart/2005/8/layout/hierarchy2"/>
    <dgm:cxn modelId="{11DD04B2-587F-498E-8E59-9A861DC11A03}" type="presParOf" srcId="{A67F4D00-5318-48B1-8F6F-4C6D0840EE34}" destId="{DF9FF149-B0C6-4C8C-BC41-DF43A2913708}" srcOrd="9" destOrd="0" presId="urn:microsoft.com/office/officeart/2005/8/layout/hierarchy2"/>
    <dgm:cxn modelId="{A60DB433-9F51-4C68-8039-B5FE027626C8}" type="presParOf" srcId="{DF9FF149-B0C6-4C8C-BC41-DF43A2913708}" destId="{38194E2B-8C9B-446D-93B0-01D743C0AC69}" srcOrd="0" destOrd="0" presId="urn:microsoft.com/office/officeart/2005/8/layout/hierarchy2"/>
    <dgm:cxn modelId="{2D2767F6-5904-466F-822B-4C189A526FC2}" type="presParOf" srcId="{DF9FF149-B0C6-4C8C-BC41-DF43A2913708}" destId="{B2CF7225-C61E-43D9-B9C8-7DB119B5C411}" srcOrd="1" destOrd="0" presId="urn:microsoft.com/office/officeart/2005/8/layout/hierarchy2"/>
    <dgm:cxn modelId="{64B399DA-9B0F-4C56-A3F2-F07CE951986F}" type="presParOf" srcId="{457B3FD6-8EF7-4A94-BB29-C9471CDE92CD}" destId="{925EDBFF-3D85-437B-9D22-40DBEB5AB8DA}" srcOrd="4" destOrd="0" presId="urn:microsoft.com/office/officeart/2005/8/layout/hierarchy2"/>
    <dgm:cxn modelId="{4CB8633B-5455-490C-B9BE-B085B68E2591}" type="presParOf" srcId="{925EDBFF-3D85-437B-9D22-40DBEB5AB8DA}" destId="{B814C4C0-4FD5-42D0-888F-22B47EF7775E}" srcOrd="0" destOrd="0" presId="urn:microsoft.com/office/officeart/2005/8/layout/hierarchy2"/>
    <dgm:cxn modelId="{51F9543F-E56B-43AA-A1A5-9161EF023FAF}" type="presParOf" srcId="{457B3FD6-8EF7-4A94-BB29-C9471CDE92CD}" destId="{32813329-F5DE-4D43-9999-7021733058B4}" srcOrd="5" destOrd="0" presId="urn:microsoft.com/office/officeart/2005/8/layout/hierarchy2"/>
    <dgm:cxn modelId="{E691172E-A2A1-4ED8-9433-4E89B03CA2F3}" type="presParOf" srcId="{32813329-F5DE-4D43-9999-7021733058B4}" destId="{933E68AA-CF10-49A1-ABCC-DA114DDEAF2A}" srcOrd="0" destOrd="0" presId="urn:microsoft.com/office/officeart/2005/8/layout/hierarchy2"/>
    <dgm:cxn modelId="{040C7049-E196-4D1B-AD9D-BB3C6BA87370}" type="presParOf" srcId="{32813329-F5DE-4D43-9999-7021733058B4}" destId="{0BB7042D-0783-4AF0-A2AC-0560AE754DBB}" srcOrd="1" destOrd="0" presId="urn:microsoft.com/office/officeart/2005/8/layout/hierarchy2"/>
    <dgm:cxn modelId="{9DD4D88E-25B8-49C5-ABD0-5F5385177ACC}" type="presParOf" srcId="{0BB7042D-0783-4AF0-A2AC-0560AE754DBB}" destId="{0E872D06-F66B-4811-92EA-E374B25899A2}" srcOrd="0" destOrd="0" presId="urn:microsoft.com/office/officeart/2005/8/layout/hierarchy2"/>
    <dgm:cxn modelId="{ACE64050-B8AE-444A-B9BA-D2FEFFDC35AA}" type="presParOf" srcId="{0E872D06-F66B-4811-92EA-E374B25899A2}" destId="{72B52D37-7D34-4ADE-968E-0497344DEB80}" srcOrd="0" destOrd="0" presId="urn:microsoft.com/office/officeart/2005/8/layout/hierarchy2"/>
    <dgm:cxn modelId="{9094CD33-D848-4AE5-844A-5E0AF49A8A3D}" type="presParOf" srcId="{0BB7042D-0783-4AF0-A2AC-0560AE754DBB}" destId="{02CBB79E-92BB-43E9-BC76-EB3CA055D3F6}" srcOrd="1" destOrd="0" presId="urn:microsoft.com/office/officeart/2005/8/layout/hierarchy2"/>
    <dgm:cxn modelId="{E1629CE1-086B-4C61-8969-C90947BC4685}" type="presParOf" srcId="{02CBB79E-92BB-43E9-BC76-EB3CA055D3F6}" destId="{3F552C8C-859A-4030-A503-8872BA917E0A}" srcOrd="0" destOrd="0" presId="urn:microsoft.com/office/officeart/2005/8/layout/hierarchy2"/>
    <dgm:cxn modelId="{11A62BF8-4D7C-4911-97EE-B3F43D79ABAE}" type="presParOf" srcId="{02CBB79E-92BB-43E9-BC76-EB3CA055D3F6}" destId="{90941FE9-BA76-4E83-BB38-DFDC96B69634}" srcOrd="1" destOrd="0" presId="urn:microsoft.com/office/officeart/2005/8/layout/hierarchy2"/>
    <dgm:cxn modelId="{DC966E1F-910C-4CE7-9572-85DCE2170180}" type="presParOf" srcId="{0BB7042D-0783-4AF0-A2AC-0560AE754DBB}" destId="{168B63D6-E582-4001-8D06-4264135971C6}" srcOrd="2" destOrd="0" presId="urn:microsoft.com/office/officeart/2005/8/layout/hierarchy2"/>
    <dgm:cxn modelId="{295D804C-1CAB-4BE7-8779-040C5D60448B}" type="presParOf" srcId="{168B63D6-E582-4001-8D06-4264135971C6}" destId="{1CC6C369-6E50-42DA-A881-F2FD7708779E}" srcOrd="0" destOrd="0" presId="urn:microsoft.com/office/officeart/2005/8/layout/hierarchy2"/>
    <dgm:cxn modelId="{BE6B2F30-7AC9-405E-ACA9-9F3CFA33C526}" type="presParOf" srcId="{0BB7042D-0783-4AF0-A2AC-0560AE754DBB}" destId="{509B91C6-26BD-453B-AB33-E3A76B562994}" srcOrd="3" destOrd="0" presId="urn:microsoft.com/office/officeart/2005/8/layout/hierarchy2"/>
    <dgm:cxn modelId="{D9CBE557-F63A-40DC-A7B1-26841874A930}" type="presParOf" srcId="{509B91C6-26BD-453B-AB33-E3A76B562994}" destId="{BF83AAD4-9518-47AA-835D-A40E2C49AF13}" srcOrd="0" destOrd="0" presId="urn:microsoft.com/office/officeart/2005/8/layout/hierarchy2"/>
    <dgm:cxn modelId="{E3C02B0F-9CDD-456D-B6F5-91A97FDEAC58}" type="presParOf" srcId="{509B91C6-26BD-453B-AB33-E3A76B562994}" destId="{372B43B3-F831-4836-9D42-D22FD7E162E2}" srcOrd="1" destOrd="0" presId="urn:microsoft.com/office/officeart/2005/8/layout/hierarchy2"/>
    <dgm:cxn modelId="{3C1D07DE-91EA-4CE0-8E02-94F5D82C28F9}" type="presParOf" srcId="{0BB7042D-0783-4AF0-A2AC-0560AE754DBB}" destId="{12649787-8B1A-4097-B62E-BBC1879F2014}" srcOrd="4" destOrd="0" presId="urn:microsoft.com/office/officeart/2005/8/layout/hierarchy2"/>
    <dgm:cxn modelId="{FA3ED925-22A7-4EFC-975B-2F203FA8250C}" type="presParOf" srcId="{12649787-8B1A-4097-B62E-BBC1879F2014}" destId="{D70BE76E-DF8A-41C7-B32C-B201D4602719}" srcOrd="0" destOrd="0" presId="urn:microsoft.com/office/officeart/2005/8/layout/hierarchy2"/>
    <dgm:cxn modelId="{6509DE06-AE6C-46FE-BB51-AE67BEAF0925}" type="presParOf" srcId="{0BB7042D-0783-4AF0-A2AC-0560AE754DBB}" destId="{6FBA47E0-66A4-4DA5-A275-39BDD110ECB7}" srcOrd="5" destOrd="0" presId="urn:microsoft.com/office/officeart/2005/8/layout/hierarchy2"/>
    <dgm:cxn modelId="{57763950-B10B-4A81-B5EE-B58320A0BC06}" type="presParOf" srcId="{6FBA47E0-66A4-4DA5-A275-39BDD110ECB7}" destId="{D4B8489D-29A0-450D-846E-6780D2436C16}" srcOrd="0" destOrd="0" presId="urn:microsoft.com/office/officeart/2005/8/layout/hierarchy2"/>
    <dgm:cxn modelId="{E736CB94-B675-4F32-899B-A24F5D3665C1}" type="presParOf" srcId="{6FBA47E0-66A4-4DA5-A275-39BDD110ECB7}" destId="{359345A4-19E5-49DB-8245-6F2492C61000}" srcOrd="1" destOrd="0" presId="urn:microsoft.com/office/officeart/2005/8/layout/hierarchy2"/>
    <dgm:cxn modelId="{13B21A5D-2141-4630-8C0C-5BB6BB642B8A}" type="presParOf" srcId="{0BB7042D-0783-4AF0-A2AC-0560AE754DBB}" destId="{87A49760-64CE-4CBD-BF78-45B22D2A4949}" srcOrd="6" destOrd="0" presId="urn:microsoft.com/office/officeart/2005/8/layout/hierarchy2"/>
    <dgm:cxn modelId="{C568A2B5-9ED7-4CD7-8B4E-B9B8DC91BAAF}" type="presParOf" srcId="{87A49760-64CE-4CBD-BF78-45B22D2A4949}" destId="{894D3D26-1468-4F2C-88F6-01751D8C7D69}" srcOrd="0" destOrd="0" presId="urn:microsoft.com/office/officeart/2005/8/layout/hierarchy2"/>
    <dgm:cxn modelId="{82BD302C-BDA5-4CE2-8B1F-D71D150EEB4B}" type="presParOf" srcId="{0BB7042D-0783-4AF0-A2AC-0560AE754DBB}" destId="{0B54FA82-637D-47AA-AA43-07DF2CC550CF}" srcOrd="7" destOrd="0" presId="urn:microsoft.com/office/officeart/2005/8/layout/hierarchy2"/>
    <dgm:cxn modelId="{2E482FBD-973B-4F76-A52B-BC0D4152D5FE}" type="presParOf" srcId="{0B54FA82-637D-47AA-AA43-07DF2CC550CF}" destId="{C50E5B3A-B9FE-43B9-85D2-DC2953853106}" srcOrd="0" destOrd="0" presId="urn:microsoft.com/office/officeart/2005/8/layout/hierarchy2"/>
    <dgm:cxn modelId="{B285FA97-85AD-4303-9608-28F0B8BE1F7C}" type="presParOf" srcId="{0B54FA82-637D-47AA-AA43-07DF2CC550CF}" destId="{55980929-F735-4B98-A398-02108F7A9B12}" srcOrd="1" destOrd="0" presId="urn:microsoft.com/office/officeart/2005/8/layout/hierarchy2"/>
    <dgm:cxn modelId="{52341875-A59B-41C4-AD2A-74124AA03C90}" type="presParOf" srcId="{0BB7042D-0783-4AF0-A2AC-0560AE754DBB}" destId="{FC687F4F-95AF-4388-A390-2F0E64666848}" srcOrd="8" destOrd="0" presId="urn:microsoft.com/office/officeart/2005/8/layout/hierarchy2"/>
    <dgm:cxn modelId="{6F821025-9F47-41D4-8EEF-EFE49574530A}" type="presParOf" srcId="{FC687F4F-95AF-4388-A390-2F0E64666848}" destId="{94C13FA5-1561-4553-ADA9-69D482E5248A}" srcOrd="0" destOrd="0" presId="urn:microsoft.com/office/officeart/2005/8/layout/hierarchy2"/>
    <dgm:cxn modelId="{FE2C469A-3240-42ED-912D-300C267CB894}" type="presParOf" srcId="{0BB7042D-0783-4AF0-A2AC-0560AE754DBB}" destId="{33E788E1-A069-4A13-98BB-73D866B82E71}" srcOrd="9" destOrd="0" presId="urn:microsoft.com/office/officeart/2005/8/layout/hierarchy2"/>
    <dgm:cxn modelId="{8CA05B30-D4F5-43DA-8CA5-EDA64B056DF1}" type="presParOf" srcId="{33E788E1-A069-4A13-98BB-73D866B82E71}" destId="{D7C3B540-AAE3-47B6-8689-6F42331FBB0D}" srcOrd="0" destOrd="0" presId="urn:microsoft.com/office/officeart/2005/8/layout/hierarchy2"/>
    <dgm:cxn modelId="{DE2AB737-659A-4C0D-80C6-83B0D8F40570}" type="presParOf" srcId="{33E788E1-A069-4A13-98BB-73D866B82E71}" destId="{85CD2B0D-0C87-4BEE-9E1C-E0A79E674051}" srcOrd="1" destOrd="0" presId="urn:microsoft.com/office/officeart/2005/8/layout/hierarchy2"/>
    <dgm:cxn modelId="{44762066-E709-4D23-B0C5-F6A4AB93BC28}" type="presParOf" srcId="{457B3FD6-8EF7-4A94-BB29-C9471CDE92CD}" destId="{91683DB7-5821-4F63-939D-8271AEDB1AC2}" srcOrd="6" destOrd="0" presId="urn:microsoft.com/office/officeart/2005/8/layout/hierarchy2"/>
    <dgm:cxn modelId="{8F278349-4E03-46B2-81B9-042A5FEFB738}" type="presParOf" srcId="{91683DB7-5821-4F63-939D-8271AEDB1AC2}" destId="{D9B96937-FBE0-4586-A2C5-BC85D2155D05}" srcOrd="0" destOrd="0" presId="urn:microsoft.com/office/officeart/2005/8/layout/hierarchy2"/>
    <dgm:cxn modelId="{A7C75217-9777-4AEF-89A8-A26CA7E648D1}" type="presParOf" srcId="{457B3FD6-8EF7-4A94-BB29-C9471CDE92CD}" destId="{EE01913B-A6F0-42CE-AF5A-9DEAF5D8DBB0}" srcOrd="7" destOrd="0" presId="urn:microsoft.com/office/officeart/2005/8/layout/hierarchy2"/>
    <dgm:cxn modelId="{1C9D34A8-28FB-4796-BA30-BBE94AF7AC7B}" type="presParOf" srcId="{EE01913B-A6F0-42CE-AF5A-9DEAF5D8DBB0}" destId="{DDCB18A7-5217-498E-8109-AEC8891AEF63}" srcOrd="0" destOrd="0" presId="urn:microsoft.com/office/officeart/2005/8/layout/hierarchy2"/>
    <dgm:cxn modelId="{47D89B06-8875-413D-BF36-1A1556995BB1}" type="presParOf" srcId="{EE01913B-A6F0-42CE-AF5A-9DEAF5D8DBB0}" destId="{B02E7AF6-66DA-4252-B52D-833FA55306E0}" srcOrd="1" destOrd="0" presId="urn:microsoft.com/office/officeart/2005/8/layout/hierarchy2"/>
    <dgm:cxn modelId="{CE5161CC-0B65-4F18-9E52-93216F483609}" type="presParOf" srcId="{B02E7AF6-66DA-4252-B52D-833FA55306E0}" destId="{87C9AC31-CDDE-4E1F-B79F-69064C460489}" srcOrd="0" destOrd="0" presId="urn:microsoft.com/office/officeart/2005/8/layout/hierarchy2"/>
    <dgm:cxn modelId="{B48AA77D-169E-44B1-ABFD-65D61AD3742C}" type="presParOf" srcId="{87C9AC31-CDDE-4E1F-B79F-69064C460489}" destId="{EBD2F8EB-D76E-4ECE-AD86-C67210D41D3D}" srcOrd="0" destOrd="0" presId="urn:microsoft.com/office/officeart/2005/8/layout/hierarchy2"/>
    <dgm:cxn modelId="{7E6D547F-7095-4886-B75B-09E398A48620}" type="presParOf" srcId="{B02E7AF6-66DA-4252-B52D-833FA55306E0}" destId="{18B3E9C4-212E-4910-9E2D-34244862C8BF}" srcOrd="1" destOrd="0" presId="urn:microsoft.com/office/officeart/2005/8/layout/hierarchy2"/>
    <dgm:cxn modelId="{0F30C815-9587-459D-ADBC-9850B140A832}" type="presParOf" srcId="{18B3E9C4-212E-4910-9E2D-34244862C8BF}" destId="{BD9D8B61-1FCA-4DBF-95E6-59B9130798B9}" srcOrd="0" destOrd="0" presId="urn:microsoft.com/office/officeart/2005/8/layout/hierarchy2"/>
    <dgm:cxn modelId="{E25CD250-8A58-40E0-9094-9D8531FFFF44}" type="presParOf" srcId="{18B3E9C4-212E-4910-9E2D-34244862C8BF}" destId="{518C82D6-093F-4ABC-ABE5-99666F772EAD}" srcOrd="1" destOrd="0" presId="urn:microsoft.com/office/officeart/2005/8/layout/hierarchy2"/>
    <dgm:cxn modelId="{EA1892D2-95D5-4ED5-8658-2022C89B295D}" type="presParOf" srcId="{B02E7AF6-66DA-4252-B52D-833FA55306E0}" destId="{56FAFC49-D0EA-4E25-8D48-7123A498BD9B}" srcOrd="2" destOrd="0" presId="urn:microsoft.com/office/officeart/2005/8/layout/hierarchy2"/>
    <dgm:cxn modelId="{9B64216F-A830-4172-9928-D7740C8C3243}" type="presParOf" srcId="{56FAFC49-D0EA-4E25-8D48-7123A498BD9B}" destId="{69674B81-12B1-4530-81E5-B46611BDEBD3}" srcOrd="0" destOrd="0" presId="urn:microsoft.com/office/officeart/2005/8/layout/hierarchy2"/>
    <dgm:cxn modelId="{DE49BE2B-082B-4DDE-B3ED-E76126F6075E}" type="presParOf" srcId="{B02E7AF6-66DA-4252-B52D-833FA55306E0}" destId="{AC80BB0E-C09A-4A3A-A6DC-68DD0D75747A}" srcOrd="3" destOrd="0" presId="urn:microsoft.com/office/officeart/2005/8/layout/hierarchy2"/>
    <dgm:cxn modelId="{2640A66A-1D0B-4DCB-A5EC-F2BDA45CBE80}" type="presParOf" srcId="{AC80BB0E-C09A-4A3A-A6DC-68DD0D75747A}" destId="{E730F18F-48B0-4E0B-9A8D-D539E63CE9D4}" srcOrd="0" destOrd="0" presId="urn:microsoft.com/office/officeart/2005/8/layout/hierarchy2"/>
    <dgm:cxn modelId="{9935A020-F756-41F7-BEA0-A98E196AD2E9}" type="presParOf" srcId="{AC80BB0E-C09A-4A3A-A6DC-68DD0D75747A}" destId="{360EA3B4-0F47-4D6B-A63D-BB2A4077DE52}" srcOrd="1" destOrd="0" presId="urn:microsoft.com/office/officeart/2005/8/layout/hierarchy2"/>
    <dgm:cxn modelId="{818251BF-A941-4F13-9E32-540F48D8DDC9}" type="presParOf" srcId="{360EA3B4-0F47-4D6B-A63D-BB2A4077DE52}" destId="{04B5A4E1-0824-444B-B0DF-49A3641E7799}" srcOrd="0" destOrd="0" presId="urn:microsoft.com/office/officeart/2005/8/layout/hierarchy2"/>
    <dgm:cxn modelId="{25EA96E6-0434-4A0A-8576-DE47791ACE9A}" type="presParOf" srcId="{04B5A4E1-0824-444B-B0DF-49A3641E7799}" destId="{272D572E-5B26-4488-A75D-C75C5F075451}" srcOrd="0" destOrd="0" presId="urn:microsoft.com/office/officeart/2005/8/layout/hierarchy2"/>
    <dgm:cxn modelId="{42282F3A-D510-4D42-8D26-542B8C0B23F2}" type="presParOf" srcId="{360EA3B4-0F47-4D6B-A63D-BB2A4077DE52}" destId="{19108BD8-503D-4075-A1CF-53550D590BD4}" srcOrd="1" destOrd="0" presId="urn:microsoft.com/office/officeart/2005/8/layout/hierarchy2"/>
    <dgm:cxn modelId="{27C00C35-1119-466D-A9F7-A496549AFB97}" type="presParOf" srcId="{19108BD8-503D-4075-A1CF-53550D590BD4}" destId="{4DCF8B3D-4AC6-4BA4-83D6-71D9BD5CEED2}" srcOrd="0" destOrd="0" presId="urn:microsoft.com/office/officeart/2005/8/layout/hierarchy2"/>
    <dgm:cxn modelId="{B7C86938-078E-4DB6-AE20-FB0524252785}" type="presParOf" srcId="{19108BD8-503D-4075-A1CF-53550D590BD4}" destId="{D35E8196-0F33-4D66-8A3D-9E7CA82C9867}" srcOrd="1" destOrd="0" presId="urn:microsoft.com/office/officeart/2005/8/layout/hierarchy2"/>
    <dgm:cxn modelId="{06148604-44D5-4AF6-BCDE-7D887C3FEFB7}" type="presParOf" srcId="{360EA3B4-0F47-4D6B-A63D-BB2A4077DE52}" destId="{4422E06E-D77E-4F56-8840-95885C852043}" srcOrd="2" destOrd="0" presId="urn:microsoft.com/office/officeart/2005/8/layout/hierarchy2"/>
    <dgm:cxn modelId="{EC258D87-0611-47E4-B663-C60749C8949A}" type="presParOf" srcId="{4422E06E-D77E-4F56-8840-95885C852043}" destId="{78BB6245-6919-431D-8F6D-FEFDFE3AC3B2}" srcOrd="0" destOrd="0" presId="urn:microsoft.com/office/officeart/2005/8/layout/hierarchy2"/>
    <dgm:cxn modelId="{972B387F-DB03-4F29-995C-ED70F07680EC}" type="presParOf" srcId="{360EA3B4-0F47-4D6B-A63D-BB2A4077DE52}" destId="{D65C5CDD-56AD-44ED-96AA-F28E3AD2C69B}" srcOrd="3" destOrd="0" presId="urn:microsoft.com/office/officeart/2005/8/layout/hierarchy2"/>
    <dgm:cxn modelId="{935CC4BE-DFEB-4797-9B67-95BA3718EE81}" type="presParOf" srcId="{D65C5CDD-56AD-44ED-96AA-F28E3AD2C69B}" destId="{63E06D80-B4DA-4AF5-B318-48676A80383C}" srcOrd="0" destOrd="0" presId="urn:microsoft.com/office/officeart/2005/8/layout/hierarchy2"/>
    <dgm:cxn modelId="{0D61875E-510B-49C4-968A-9492B8BC6543}" type="presParOf" srcId="{D65C5CDD-56AD-44ED-96AA-F28E3AD2C69B}" destId="{FF8F3D66-F4A7-4E59-9130-E75CEE01CEC5}" srcOrd="1" destOrd="0" presId="urn:microsoft.com/office/officeart/2005/8/layout/hierarchy2"/>
    <dgm:cxn modelId="{4AA42FEB-2061-4344-9DC6-7960868B2F16}" type="presParOf" srcId="{B02E7AF6-66DA-4252-B52D-833FA55306E0}" destId="{82D2DBC9-D5F1-41B2-B475-FC62C3A7004B}" srcOrd="4" destOrd="0" presId="urn:microsoft.com/office/officeart/2005/8/layout/hierarchy2"/>
    <dgm:cxn modelId="{1F4C73C5-461C-4000-B3EF-81B961517303}" type="presParOf" srcId="{82D2DBC9-D5F1-41B2-B475-FC62C3A7004B}" destId="{14C8F2DC-5402-4C02-AEC9-5324C6C4963A}" srcOrd="0" destOrd="0" presId="urn:microsoft.com/office/officeart/2005/8/layout/hierarchy2"/>
    <dgm:cxn modelId="{4C68B7D9-FDA5-4EFE-8DB0-027A47F52894}" type="presParOf" srcId="{B02E7AF6-66DA-4252-B52D-833FA55306E0}" destId="{939F4CFE-8C60-446F-BA29-9CB807C1727D}" srcOrd="5" destOrd="0" presId="urn:microsoft.com/office/officeart/2005/8/layout/hierarchy2"/>
    <dgm:cxn modelId="{4A6BB811-27C2-4E56-BCC8-CD272A3AB184}" type="presParOf" srcId="{939F4CFE-8C60-446F-BA29-9CB807C1727D}" destId="{481798CD-BDE5-4B57-B01A-E2CEFF5196BF}" srcOrd="0" destOrd="0" presId="urn:microsoft.com/office/officeart/2005/8/layout/hierarchy2"/>
    <dgm:cxn modelId="{C58BBC9F-FCFE-4EC8-A4FC-04FFD0876FAC}" type="presParOf" srcId="{939F4CFE-8C60-446F-BA29-9CB807C1727D}" destId="{B42E1832-2937-4B92-8923-31358112F338}" srcOrd="1" destOrd="0" presId="urn:microsoft.com/office/officeart/2005/8/layout/hierarchy2"/>
    <dgm:cxn modelId="{AD632E8B-A693-4C2B-86F4-B40B7DF85027}" type="presParOf" srcId="{B02E7AF6-66DA-4252-B52D-833FA55306E0}" destId="{22457488-96D2-492A-A67D-1DA42B35C92F}" srcOrd="6" destOrd="0" presId="urn:microsoft.com/office/officeart/2005/8/layout/hierarchy2"/>
    <dgm:cxn modelId="{3ED1A33A-D4F2-4129-8724-58752E1EE3A3}" type="presParOf" srcId="{22457488-96D2-492A-A67D-1DA42B35C92F}" destId="{7E42A3E7-F188-48F4-99B5-B1F4D367F825}" srcOrd="0" destOrd="0" presId="urn:microsoft.com/office/officeart/2005/8/layout/hierarchy2"/>
    <dgm:cxn modelId="{9EC0CA5F-1049-4967-817A-BD4A696D5579}" type="presParOf" srcId="{B02E7AF6-66DA-4252-B52D-833FA55306E0}" destId="{40E1F38D-F838-4B3A-8959-C57390990E61}" srcOrd="7" destOrd="0" presId="urn:microsoft.com/office/officeart/2005/8/layout/hierarchy2"/>
    <dgm:cxn modelId="{A05D6F94-59A3-48CC-998D-46457398F056}" type="presParOf" srcId="{40E1F38D-F838-4B3A-8959-C57390990E61}" destId="{DC301E58-40D8-4D3D-9A40-BAA0C92BDE59}" srcOrd="0" destOrd="0" presId="urn:microsoft.com/office/officeart/2005/8/layout/hierarchy2"/>
    <dgm:cxn modelId="{D2AC992A-3010-4A5E-A3C4-82C284D9D699}" type="presParOf" srcId="{40E1F38D-F838-4B3A-8959-C57390990E61}" destId="{F06368F7-EC0F-4A1D-9A8E-247D54BEDDBC}" srcOrd="1" destOrd="0" presId="urn:microsoft.com/office/officeart/2005/8/layout/hierarchy2"/>
    <dgm:cxn modelId="{4D8E657E-4E42-4457-B0FF-9849F7410392}" type="presParOf" srcId="{B02E7AF6-66DA-4252-B52D-833FA55306E0}" destId="{2E231434-ED7F-44D1-8C73-4DA73C333BE6}" srcOrd="8" destOrd="0" presId="urn:microsoft.com/office/officeart/2005/8/layout/hierarchy2"/>
    <dgm:cxn modelId="{21E6F8B5-D09B-4DC3-9B99-584A82D29644}" type="presParOf" srcId="{2E231434-ED7F-44D1-8C73-4DA73C333BE6}" destId="{1DF7A0FE-D847-4A6C-886A-53CFFF4E83C7}" srcOrd="0" destOrd="0" presId="urn:microsoft.com/office/officeart/2005/8/layout/hierarchy2"/>
    <dgm:cxn modelId="{AC8B39D1-3353-4CC3-A15A-60C5D076CEA0}" type="presParOf" srcId="{B02E7AF6-66DA-4252-B52D-833FA55306E0}" destId="{BE8A502F-FC97-4D68-B5C8-EF15A6D273CA}" srcOrd="9" destOrd="0" presId="urn:microsoft.com/office/officeart/2005/8/layout/hierarchy2"/>
    <dgm:cxn modelId="{4DE378C2-FFBF-46D3-A70C-5A20A6FECC69}" type="presParOf" srcId="{BE8A502F-FC97-4D68-B5C8-EF15A6D273CA}" destId="{665072C3-8ADE-40C1-BDA5-4FAA68E4319F}" srcOrd="0" destOrd="0" presId="urn:microsoft.com/office/officeart/2005/8/layout/hierarchy2"/>
    <dgm:cxn modelId="{7362117A-C29A-4045-BB09-85A8BE660275}" type="presParOf" srcId="{BE8A502F-FC97-4D68-B5C8-EF15A6D273CA}" destId="{351C6D74-3715-400D-811D-2BFE8ADB6101}" srcOrd="1" destOrd="0" presId="urn:microsoft.com/office/officeart/2005/8/layout/hierarchy2"/>
    <dgm:cxn modelId="{FF5DF936-8891-4C3A-AA5B-4017BBB9299A}" type="presParOf" srcId="{B02E7AF6-66DA-4252-B52D-833FA55306E0}" destId="{134D7A88-2D4D-4FE0-A203-5D2DFDE9B8B0}" srcOrd="10" destOrd="0" presId="urn:microsoft.com/office/officeart/2005/8/layout/hierarchy2"/>
    <dgm:cxn modelId="{BD46A77C-A169-424A-8918-85257FB0E4DF}" type="presParOf" srcId="{134D7A88-2D4D-4FE0-A203-5D2DFDE9B8B0}" destId="{E34F5E68-97F6-448B-93CC-7F50A4D760A8}" srcOrd="0" destOrd="0" presId="urn:microsoft.com/office/officeart/2005/8/layout/hierarchy2"/>
    <dgm:cxn modelId="{504DCDC5-B203-4050-B300-BD5D8E47DC4E}" type="presParOf" srcId="{B02E7AF6-66DA-4252-B52D-833FA55306E0}" destId="{F778CF73-89A3-42BA-AB6F-C2C1BC63090E}" srcOrd="11" destOrd="0" presId="urn:microsoft.com/office/officeart/2005/8/layout/hierarchy2"/>
    <dgm:cxn modelId="{E454AE1C-B4EB-40E6-B808-79CB984EAEC5}" type="presParOf" srcId="{F778CF73-89A3-42BA-AB6F-C2C1BC63090E}" destId="{3E90B72A-F33B-4C19-AA15-D10953CC4340}" srcOrd="0" destOrd="0" presId="urn:microsoft.com/office/officeart/2005/8/layout/hierarchy2"/>
    <dgm:cxn modelId="{363D4AB3-F5EA-4EB8-9059-EDF365BF5E31}" type="presParOf" srcId="{F778CF73-89A3-42BA-AB6F-C2C1BC63090E}" destId="{D524E27F-D99E-41B2-BF90-B4E8FC5E68DB}" srcOrd="1" destOrd="0" presId="urn:microsoft.com/office/officeart/2005/8/layout/hierarchy2"/>
    <dgm:cxn modelId="{EEB67A15-9290-4843-967C-189B91A4BB19}" type="presParOf" srcId="{B02E7AF6-66DA-4252-B52D-833FA55306E0}" destId="{CBE2BF13-B4B2-4CCE-B9CD-9C2AE1DB9827}" srcOrd="12" destOrd="0" presId="urn:microsoft.com/office/officeart/2005/8/layout/hierarchy2"/>
    <dgm:cxn modelId="{4ED6EDA7-8B4D-4EE0-AAA5-1075E91A6289}" type="presParOf" srcId="{CBE2BF13-B4B2-4CCE-B9CD-9C2AE1DB9827}" destId="{BCDDDD5C-AFED-4205-A736-CCA5522531A5}" srcOrd="0" destOrd="0" presId="urn:microsoft.com/office/officeart/2005/8/layout/hierarchy2"/>
    <dgm:cxn modelId="{0BF7967A-8710-41B4-9519-17CC05724561}" type="presParOf" srcId="{B02E7AF6-66DA-4252-B52D-833FA55306E0}" destId="{D82F3EC8-11FE-44FB-A347-97A3FBA6D574}" srcOrd="13" destOrd="0" presId="urn:microsoft.com/office/officeart/2005/8/layout/hierarchy2"/>
    <dgm:cxn modelId="{82D6CA74-8187-4C98-BA26-B4DE6B22FC54}" type="presParOf" srcId="{D82F3EC8-11FE-44FB-A347-97A3FBA6D574}" destId="{48E4B145-A01E-4F97-9B06-6C33D2269A47}" srcOrd="0" destOrd="0" presId="urn:microsoft.com/office/officeart/2005/8/layout/hierarchy2"/>
    <dgm:cxn modelId="{588EA4D5-9213-4BBE-9454-2F5814EC7CF1}" type="presParOf" srcId="{D82F3EC8-11FE-44FB-A347-97A3FBA6D574}" destId="{47268DB0-FBEE-4541-9325-FAEE019D20F8}" srcOrd="1" destOrd="0" presId="urn:microsoft.com/office/officeart/2005/8/layout/hierarchy2"/>
    <dgm:cxn modelId="{51021CF5-DD2A-4982-BF30-DE72ED234BA1}" type="presParOf" srcId="{B02E7AF6-66DA-4252-B52D-833FA55306E0}" destId="{92D0DEB7-F9E3-4085-A056-1B4AA5D907F0}" srcOrd="14" destOrd="0" presId="urn:microsoft.com/office/officeart/2005/8/layout/hierarchy2"/>
    <dgm:cxn modelId="{FAD12376-5B9D-4022-829E-3EA478D3EE9C}" type="presParOf" srcId="{92D0DEB7-F9E3-4085-A056-1B4AA5D907F0}" destId="{D5CD040A-B516-438A-972F-8ED8CDC5F1F6}" srcOrd="0" destOrd="0" presId="urn:microsoft.com/office/officeart/2005/8/layout/hierarchy2"/>
    <dgm:cxn modelId="{CA7374B0-9A8A-4A31-BB58-0DD5739F0544}" type="presParOf" srcId="{B02E7AF6-66DA-4252-B52D-833FA55306E0}" destId="{53EE630F-B50A-4E44-9F26-7A437E403F30}" srcOrd="15" destOrd="0" presId="urn:microsoft.com/office/officeart/2005/8/layout/hierarchy2"/>
    <dgm:cxn modelId="{22F128DB-E5C9-4D21-879B-55F651A934A6}" type="presParOf" srcId="{53EE630F-B50A-4E44-9F26-7A437E403F30}" destId="{0F72C090-6894-4EAC-91C9-4AB4F7819088}" srcOrd="0" destOrd="0" presId="urn:microsoft.com/office/officeart/2005/8/layout/hierarchy2"/>
    <dgm:cxn modelId="{CEB23374-DE9A-43BC-A02F-158C1DB6471E}" type="presParOf" srcId="{53EE630F-B50A-4E44-9F26-7A437E403F30}" destId="{29CFB243-3B0B-48A1-BA31-68AEECA8538E}" srcOrd="1" destOrd="0" presId="urn:microsoft.com/office/officeart/2005/8/layout/hierarchy2"/>
    <dgm:cxn modelId="{10BD7537-52C9-4CA1-BF29-988F1C9B39F5}" type="presParOf" srcId="{B02E7AF6-66DA-4252-B52D-833FA55306E0}" destId="{6AB18905-010D-4722-AD52-A8029684E429}" srcOrd="16" destOrd="0" presId="urn:microsoft.com/office/officeart/2005/8/layout/hierarchy2"/>
    <dgm:cxn modelId="{72B529EE-CDC1-492F-8213-479353F31DA3}" type="presParOf" srcId="{6AB18905-010D-4722-AD52-A8029684E429}" destId="{029D14F4-73D5-48A5-9409-1B7CD1A98ED4}" srcOrd="0" destOrd="0" presId="urn:microsoft.com/office/officeart/2005/8/layout/hierarchy2"/>
    <dgm:cxn modelId="{C9B34063-B3F9-49D4-8BFF-F23C444D7459}" type="presParOf" srcId="{B02E7AF6-66DA-4252-B52D-833FA55306E0}" destId="{7543E19F-1B2D-40F5-8A03-204EE3BF2B6C}" srcOrd="17" destOrd="0" presId="urn:microsoft.com/office/officeart/2005/8/layout/hierarchy2"/>
    <dgm:cxn modelId="{CFE3BECB-A03B-4E31-84C3-EAE33C659861}" type="presParOf" srcId="{7543E19F-1B2D-40F5-8A03-204EE3BF2B6C}" destId="{93ED179E-6CE9-427B-AFAE-295FB95A4083}" srcOrd="0" destOrd="0" presId="urn:microsoft.com/office/officeart/2005/8/layout/hierarchy2"/>
    <dgm:cxn modelId="{838EC3E9-0106-4363-8438-9C7B9C7C0AD0}" type="presParOf" srcId="{7543E19F-1B2D-40F5-8A03-204EE3BF2B6C}" destId="{2A0D38E4-EC3B-4BAE-ADB2-23C127B643DB}" srcOrd="1" destOrd="0" presId="urn:microsoft.com/office/officeart/2005/8/layout/hierarchy2"/>
    <dgm:cxn modelId="{AD788A59-BAE6-428F-80F6-989561482B4D}" type="presParOf" srcId="{B02E7AF6-66DA-4252-B52D-833FA55306E0}" destId="{B3990D9E-965A-4A87-9024-A31D8C18D9AC}" srcOrd="18" destOrd="0" presId="urn:microsoft.com/office/officeart/2005/8/layout/hierarchy2"/>
    <dgm:cxn modelId="{E8A0E7E5-061B-4943-A78A-0912FD54A97E}" type="presParOf" srcId="{B3990D9E-965A-4A87-9024-A31D8C18D9AC}" destId="{C4665A5D-7A69-4FC2-9029-35B5452AAAD6}" srcOrd="0" destOrd="0" presId="urn:microsoft.com/office/officeart/2005/8/layout/hierarchy2"/>
    <dgm:cxn modelId="{24671901-F289-40F2-ABA7-1BAFA3394C64}" type="presParOf" srcId="{B02E7AF6-66DA-4252-B52D-833FA55306E0}" destId="{F5AD516C-03B4-44A2-8D7F-A01D980EC8F6}" srcOrd="19" destOrd="0" presId="urn:microsoft.com/office/officeart/2005/8/layout/hierarchy2"/>
    <dgm:cxn modelId="{EB5EF4C8-62C1-4136-B192-3184991A66D3}" type="presParOf" srcId="{F5AD516C-03B4-44A2-8D7F-A01D980EC8F6}" destId="{55C48720-204C-4364-9D3A-54C5764186B5}" srcOrd="0" destOrd="0" presId="urn:microsoft.com/office/officeart/2005/8/layout/hierarchy2"/>
    <dgm:cxn modelId="{14D053FC-F1FE-4DE2-A768-89F7C363E9B5}" type="presParOf" srcId="{F5AD516C-03B4-44A2-8D7F-A01D980EC8F6}" destId="{6F03AD0E-EAEA-491F-81D8-AED0C9D56D57}" srcOrd="1" destOrd="0" presId="urn:microsoft.com/office/officeart/2005/8/layout/hierarchy2"/>
    <dgm:cxn modelId="{ABDC8553-9C20-4602-A9BE-42B364643DF3}" type="presParOf" srcId="{B02E7AF6-66DA-4252-B52D-833FA55306E0}" destId="{77548836-C3C7-4F26-AB2C-7B9D48F92339}" srcOrd="20" destOrd="0" presId="urn:microsoft.com/office/officeart/2005/8/layout/hierarchy2"/>
    <dgm:cxn modelId="{D6C81276-86AE-4498-A837-BC8D79BAE853}" type="presParOf" srcId="{77548836-C3C7-4F26-AB2C-7B9D48F92339}" destId="{D315BFC2-F4AA-453C-BEEE-7A8513151049}" srcOrd="0" destOrd="0" presId="urn:microsoft.com/office/officeart/2005/8/layout/hierarchy2"/>
    <dgm:cxn modelId="{BA094617-7CE0-42A0-A84D-93A8A2928B70}" type="presParOf" srcId="{B02E7AF6-66DA-4252-B52D-833FA55306E0}" destId="{5C1C1437-237B-4D2F-972C-182C150A65D7}" srcOrd="21" destOrd="0" presId="urn:microsoft.com/office/officeart/2005/8/layout/hierarchy2"/>
    <dgm:cxn modelId="{884917A3-F37A-4CC3-AB71-CFFE2B0D1467}" type="presParOf" srcId="{5C1C1437-237B-4D2F-972C-182C150A65D7}" destId="{58A40D43-4424-4837-A5A1-19217FD9A569}" srcOrd="0" destOrd="0" presId="urn:microsoft.com/office/officeart/2005/8/layout/hierarchy2"/>
    <dgm:cxn modelId="{5C7D234A-814E-489F-A57E-7901FF7EAC10}" type="presParOf" srcId="{5C1C1437-237B-4D2F-972C-182C150A65D7}" destId="{1CD09DDF-64D1-4B28-B2BA-D1CA4F7E8EBD}" srcOrd="1" destOrd="0" presId="urn:microsoft.com/office/officeart/2005/8/layout/hierarchy2"/>
    <dgm:cxn modelId="{A9222C2B-1AA4-4050-BD3E-CC99977117FE}" type="presParOf" srcId="{B02E7AF6-66DA-4252-B52D-833FA55306E0}" destId="{616D48F1-5BF9-475C-A680-5A4648439758}" srcOrd="22" destOrd="0" presId="urn:microsoft.com/office/officeart/2005/8/layout/hierarchy2"/>
    <dgm:cxn modelId="{90F993AF-CD71-4045-9E90-8F48FA74D707}" type="presParOf" srcId="{616D48F1-5BF9-475C-A680-5A4648439758}" destId="{6A5659FF-62AA-4A8C-B658-A072CD59A9AB}" srcOrd="0" destOrd="0" presId="urn:microsoft.com/office/officeart/2005/8/layout/hierarchy2"/>
    <dgm:cxn modelId="{96C0D876-3B7D-404F-AED2-D34160F45FCE}" type="presParOf" srcId="{B02E7AF6-66DA-4252-B52D-833FA55306E0}" destId="{B46B9E47-28AB-4556-93A1-61511E051437}" srcOrd="23" destOrd="0" presId="urn:microsoft.com/office/officeart/2005/8/layout/hierarchy2"/>
    <dgm:cxn modelId="{0A1A67A8-DFD1-42C1-84F8-2EB67948A9BF}" type="presParOf" srcId="{B46B9E47-28AB-4556-93A1-61511E051437}" destId="{AC865C7C-D34F-4978-B07D-384D670F1E47}" srcOrd="0" destOrd="0" presId="urn:microsoft.com/office/officeart/2005/8/layout/hierarchy2"/>
    <dgm:cxn modelId="{B3A9BF38-6B54-4429-88D5-901A38FEC00F}" type="presParOf" srcId="{B46B9E47-28AB-4556-93A1-61511E051437}" destId="{4636BF3F-FB11-41F8-AD53-27057F815E44}" srcOrd="1" destOrd="0" presId="urn:microsoft.com/office/officeart/2005/8/layout/hierarchy2"/>
    <dgm:cxn modelId="{F79E7A86-8BC7-45B2-BFEE-751EAF5606BC}" type="presParOf" srcId="{B02E7AF6-66DA-4252-B52D-833FA55306E0}" destId="{0534A5B7-9C7A-4B37-8658-B389BC363051}" srcOrd="24" destOrd="0" presId="urn:microsoft.com/office/officeart/2005/8/layout/hierarchy2"/>
    <dgm:cxn modelId="{898C2AC9-E8ED-4C2B-B278-B0000E1ADAD3}" type="presParOf" srcId="{0534A5B7-9C7A-4B37-8658-B389BC363051}" destId="{57096B24-8CD4-406B-927F-3FABEDAA0D69}" srcOrd="0" destOrd="0" presId="urn:microsoft.com/office/officeart/2005/8/layout/hierarchy2"/>
    <dgm:cxn modelId="{60995C5A-BC99-40E5-A7D9-F595FF8BB4A9}" type="presParOf" srcId="{B02E7AF6-66DA-4252-B52D-833FA55306E0}" destId="{1DE5FA74-54E7-473E-99BC-89B7AB6B71BE}" srcOrd="25" destOrd="0" presId="urn:microsoft.com/office/officeart/2005/8/layout/hierarchy2"/>
    <dgm:cxn modelId="{935857A9-CC06-4EDF-8B9A-27E825ADACBB}" type="presParOf" srcId="{1DE5FA74-54E7-473E-99BC-89B7AB6B71BE}" destId="{4B059EDE-FDEA-4C68-BB44-42AF88AE4840}" srcOrd="0" destOrd="0" presId="urn:microsoft.com/office/officeart/2005/8/layout/hierarchy2"/>
    <dgm:cxn modelId="{8CEA1123-2A14-4FCC-8A0B-024A4738C14B}" type="presParOf" srcId="{1DE5FA74-54E7-473E-99BC-89B7AB6B71BE}" destId="{C7AC535D-4EF6-4344-BDD7-25229982B388}" srcOrd="1" destOrd="0" presId="urn:microsoft.com/office/officeart/2005/8/layout/hierarchy2"/>
    <dgm:cxn modelId="{AB9E0AF3-DFE9-4B39-A18D-261CF6B7A02D}" type="presParOf" srcId="{457B3FD6-8EF7-4A94-BB29-C9471CDE92CD}" destId="{06162D70-667D-4321-A2A5-50E71EC54502}" srcOrd="8" destOrd="0" presId="urn:microsoft.com/office/officeart/2005/8/layout/hierarchy2"/>
    <dgm:cxn modelId="{AC829303-DF58-49D2-98C5-7B5CA7076D53}" type="presParOf" srcId="{06162D70-667D-4321-A2A5-50E71EC54502}" destId="{9EDF16DF-0468-41C5-93DA-122D14D8465F}" srcOrd="0" destOrd="0" presId="urn:microsoft.com/office/officeart/2005/8/layout/hierarchy2"/>
    <dgm:cxn modelId="{E807A686-C71B-4586-A6ED-BA7A485CE9D5}" type="presParOf" srcId="{457B3FD6-8EF7-4A94-BB29-C9471CDE92CD}" destId="{4E419202-E138-4240-93A2-456AC2B2742F}" srcOrd="9" destOrd="0" presId="urn:microsoft.com/office/officeart/2005/8/layout/hierarchy2"/>
    <dgm:cxn modelId="{FBB397FF-2942-43DF-B3A7-5887642406F7}" type="presParOf" srcId="{4E419202-E138-4240-93A2-456AC2B2742F}" destId="{DDF72957-287B-449A-A1C9-C4F10755C0F8}" srcOrd="0" destOrd="0" presId="urn:microsoft.com/office/officeart/2005/8/layout/hierarchy2"/>
    <dgm:cxn modelId="{D37C845E-1018-4FD3-96F1-5C1F87BA149E}" type="presParOf" srcId="{4E419202-E138-4240-93A2-456AC2B2742F}" destId="{05ECC4B5-9675-4F0D-8C38-19D9BB077CA3}" srcOrd="1" destOrd="0" presId="urn:microsoft.com/office/officeart/2005/8/layout/hierarchy2"/>
    <dgm:cxn modelId="{E5BCC4B5-ABAC-4C1F-9DEA-7B138BDA621D}" type="presParOf" srcId="{05ECC4B5-9675-4F0D-8C38-19D9BB077CA3}" destId="{39CD6B7A-D9CD-49C5-B1C3-2BF6CA65E035}" srcOrd="0" destOrd="0" presId="urn:microsoft.com/office/officeart/2005/8/layout/hierarchy2"/>
    <dgm:cxn modelId="{469FC08E-9BA2-403E-8013-9D2326BB79E4}" type="presParOf" srcId="{39CD6B7A-D9CD-49C5-B1C3-2BF6CA65E035}" destId="{B84FD6DC-6F83-483B-A6F6-D1143D7FCD3D}" srcOrd="0" destOrd="0" presId="urn:microsoft.com/office/officeart/2005/8/layout/hierarchy2"/>
    <dgm:cxn modelId="{A7D2200F-C79D-4453-AEDA-91A7EDF89196}" type="presParOf" srcId="{05ECC4B5-9675-4F0D-8C38-19D9BB077CA3}" destId="{40BB6ACB-057D-4260-AB2B-BDED580401D0}" srcOrd="1" destOrd="0" presId="urn:microsoft.com/office/officeart/2005/8/layout/hierarchy2"/>
    <dgm:cxn modelId="{9F4BB03C-5A14-44A8-B64D-62FBB746E717}" type="presParOf" srcId="{40BB6ACB-057D-4260-AB2B-BDED580401D0}" destId="{800253CE-BB59-4266-9CEA-CEBDA03E4027}" srcOrd="0" destOrd="0" presId="urn:microsoft.com/office/officeart/2005/8/layout/hierarchy2"/>
    <dgm:cxn modelId="{D2072DE8-3E3B-4E7A-964A-511E69A099C2}" type="presParOf" srcId="{40BB6ACB-057D-4260-AB2B-BDED580401D0}" destId="{F411FA26-74A1-460C-ABAE-D2DD5B610286}" srcOrd="1" destOrd="0" presId="urn:microsoft.com/office/officeart/2005/8/layout/hierarchy2"/>
    <dgm:cxn modelId="{3281458D-6639-4B14-B4B6-65464DB574DA}" type="presParOf" srcId="{05ECC4B5-9675-4F0D-8C38-19D9BB077CA3}" destId="{83DAAF3F-DBF1-49B0-8604-B525FB5C908A}" srcOrd="2" destOrd="0" presId="urn:microsoft.com/office/officeart/2005/8/layout/hierarchy2"/>
    <dgm:cxn modelId="{FC51DEA8-810F-4FC1-AA8F-728C381D3CB5}" type="presParOf" srcId="{83DAAF3F-DBF1-49B0-8604-B525FB5C908A}" destId="{3CA6E368-4B5A-4A8C-BA3F-B3AD90C9E9E9}" srcOrd="0" destOrd="0" presId="urn:microsoft.com/office/officeart/2005/8/layout/hierarchy2"/>
    <dgm:cxn modelId="{C161834E-700F-4C5C-A5DD-105164D97471}" type="presParOf" srcId="{05ECC4B5-9675-4F0D-8C38-19D9BB077CA3}" destId="{7C15682E-E524-46DA-82C6-F952A81CACA0}" srcOrd="3" destOrd="0" presId="urn:microsoft.com/office/officeart/2005/8/layout/hierarchy2"/>
    <dgm:cxn modelId="{FD0A6097-8661-438F-8D79-65725D30870D}" type="presParOf" srcId="{7C15682E-E524-46DA-82C6-F952A81CACA0}" destId="{914215F8-CB99-49A5-92BE-A5364C5EF1A5}" srcOrd="0" destOrd="0" presId="urn:microsoft.com/office/officeart/2005/8/layout/hierarchy2"/>
    <dgm:cxn modelId="{E089B151-0A1C-4ECB-BDC1-14816743F41B}" type="presParOf" srcId="{7C15682E-E524-46DA-82C6-F952A81CACA0}" destId="{F6AF657D-F445-4FBE-AA16-B88EE08E3861}" srcOrd="1" destOrd="0" presId="urn:microsoft.com/office/officeart/2005/8/layout/hierarchy2"/>
  </dgm:cxnLst>
  <dgm:bg/>
  <dgm:whole/>
  <dgm:extLst>
    <a:ext uri="http://schemas.microsoft.com/office/drawing/2008/diagram">
      <dsp:dataModelExt xmlns:dsp="http://schemas.microsoft.com/office/drawing/2008/diagram" relId="rId7" minVer="http://schemas.openxmlformats.org/drawingml/2006/diagram"/>
    </a:ext>
  </dgm:extLst>
</dgm:dataModel>
</file>

<file path=ppt/diagrams/data2.xml><?xml version="1.0" encoding="utf-8"?>
<dgm:dataModel xmlns:dgm="http://schemas.openxmlformats.org/drawingml/2006/diagram" xmlns:a="http://schemas.openxmlformats.org/drawingml/2006/main">
  <dgm:ptLst>
    <dgm:pt modelId="{C256443A-5739-41C3-976C-086C241C3437}" type="doc">
      <dgm:prSet loTypeId="urn:microsoft.com/office/officeart/2005/8/layout/hierarchy2" loCatId="hierarchy" qsTypeId="urn:microsoft.com/office/officeart/2005/8/quickstyle/simple1" qsCatId="simple" csTypeId="urn:microsoft.com/office/officeart/2005/8/colors/accent0_1" csCatId="mainScheme" phldr="1"/>
      <dgm:spPr/>
      <dgm:t>
        <a:bodyPr/>
        <a:lstStyle/>
        <a:p>
          <a:endParaRPr lang="de-DE"/>
        </a:p>
      </dgm:t>
    </dgm:pt>
    <dgm:pt modelId="{353C6F70-9685-47CA-B6F4-8BAAB244C13E}">
      <dgm:prSet phldrT="[Text]" custT="1"/>
      <dgm:spPr/>
      <dgm:t>
        <a:bodyPr/>
        <a:lstStyle/>
        <a:p>
          <a:r>
            <a:rPr lang="de-DE" sz="1200" dirty="0">
              <a:latin typeface="Times New Roman" panose="02020603050405020304" pitchFamily="18" charset="0"/>
              <a:cs typeface="Times New Roman" panose="02020603050405020304" pitchFamily="18" charset="0"/>
            </a:rPr>
            <a:t>Themen in Public Health:</a:t>
          </a:r>
          <a:r>
            <a:rPr lang="de-DE" sz="1200" i="1" dirty="0">
              <a:latin typeface="Times New Roman" panose="02020603050405020304" pitchFamily="18" charset="0"/>
              <a:cs typeface="Times New Roman" panose="02020603050405020304" pitchFamily="18" charset="0"/>
            </a:rPr>
            <a:t> Gesund-</a:t>
          </a:r>
          <a:r>
            <a:rPr lang="de-DE" sz="1200" i="1" dirty="0" err="1">
              <a:latin typeface="Times New Roman" panose="02020603050405020304" pitchFamily="18" charset="0"/>
              <a:cs typeface="Times New Roman" panose="02020603050405020304" pitchFamily="18" charset="0"/>
            </a:rPr>
            <a:t>heitspro</a:t>
          </a:r>
          <a:r>
            <a:rPr lang="de-DE" sz="1200" i="1" dirty="0">
              <a:latin typeface="Times New Roman" panose="02020603050405020304" pitchFamily="18" charset="0"/>
              <a:cs typeface="Times New Roman" panose="02020603050405020304" pitchFamily="18" charset="0"/>
            </a:rPr>
            <a:t>-</a:t>
          </a:r>
          <a:r>
            <a:rPr lang="de-DE" sz="1200" i="1" dirty="0" err="1">
              <a:latin typeface="Times New Roman" panose="02020603050405020304" pitchFamily="18" charset="0"/>
              <a:cs typeface="Times New Roman" panose="02020603050405020304" pitchFamily="18" charset="0"/>
            </a:rPr>
            <a:t>blem</a:t>
          </a:r>
          <a:r>
            <a:rPr lang="de-DE" sz="1200" i="1" dirty="0">
              <a:latin typeface="Times New Roman" panose="02020603050405020304" pitchFamily="18" charset="0"/>
              <a:cs typeface="Times New Roman" panose="02020603050405020304" pitchFamily="18" charset="0"/>
            </a:rPr>
            <a:t> X </a:t>
          </a:r>
        </a:p>
      </dgm:t>
    </dgm:pt>
    <dgm:pt modelId="{87404468-AF06-4D92-8599-AEA8859A7AA9}" type="parTrans" cxnId="{1A9D4DE3-4A37-4227-B403-A2ADA5B17FB0}">
      <dgm:prSet/>
      <dgm:spPr/>
      <dgm:t>
        <a:bodyPr/>
        <a:lstStyle/>
        <a:p>
          <a:endParaRPr lang="de-DE" sz="2000"/>
        </a:p>
      </dgm:t>
    </dgm:pt>
    <dgm:pt modelId="{68C29FC2-7381-479D-98A3-371A7F9C8B6D}" type="sibTrans" cxnId="{1A9D4DE3-4A37-4227-B403-A2ADA5B17FB0}">
      <dgm:prSet/>
      <dgm:spPr/>
      <dgm:t>
        <a:bodyPr/>
        <a:lstStyle/>
        <a:p>
          <a:endParaRPr lang="de-DE" sz="2000"/>
        </a:p>
      </dgm:t>
    </dgm:pt>
    <dgm:pt modelId="{5E805EC3-C58D-4BD5-A99E-B5CA51F30872}">
      <dgm:prSet phldrT="[Text]" custT="1"/>
      <dgm:spPr/>
      <dgm:t>
        <a:bodyPr/>
        <a:lstStyle/>
        <a:p>
          <a:r>
            <a:rPr lang="de-DE" sz="1050">
              <a:latin typeface="Times New Roman" panose="02020603050405020304" pitchFamily="18" charset="0"/>
              <a:cs typeface="Times New Roman" panose="02020603050405020304" pitchFamily="18" charset="0"/>
            </a:rPr>
            <a:t>Ursprung</a:t>
          </a:r>
        </a:p>
      </dgm:t>
    </dgm:pt>
    <dgm:pt modelId="{F855B30C-366F-4036-B5AE-48974C07A80E}" type="parTrans" cxnId="{7E741121-3465-4D04-BF60-56919F6F4B45}">
      <dgm:prSet custT="1"/>
      <dgm:spPr/>
      <dgm:t>
        <a:bodyPr/>
        <a:lstStyle/>
        <a:p>
          <a:endParaRPr lang="de-DE" sz="110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B59D055C-2884-474E-9D56-8022BD751C43}" type="sibTrans" cxnId="{7E741121-3465-4D04-BF60-56919F6F4B45}">
      <dgm:prSet/>
      <dgm:spPr/>
      <dgm:t>
        <a:bodyPr/>
        <a:lstStyle/>
        <a:p>
          <a:endParaRPr lang="de-DE" sz="2000"/>
        </a:p>
      </dgm:t>
    </dgm:pt>
    <dgm:pt modelId="{3A98E99E-5EB9-499E-9929-61172C5675F2}">
      <dgm:prSet phldrT="[Text]" custT="1"/>
      <dgm:spPr/>
      <dgm:t>
        <a:bodyPr/>
        <a:lstStyle/>
        <a:p>
          <a:r>
            <a:rPr lang="de-DE" sz="1050">
              <a:latin typeface="Times New Roman" panose="02020603050405020304" pitchFamily="18" charset="0"/>
              <a:cs typeface="Times New Roman" panose="02020603050405020304" pitchFamily="18" charset="0"/>
            </a:rPr>
            <a:t>Herkunft des Virus</a:t>
          </a:r>
        </a:p>
      </dgm:t>
    </dgm:pt>
    <dgm:pt modelId="{C09B2D6A-14B0-4151-BFD3-E21110A5E135}" type="parTrans" cxnId="{4FFBF3E2-1522-42AF-BA23-014F92B921B3}">
      <dgm:prSet custT="1"/>
      <dgm:spPr/>
      <dgm:t>
        <a:bodyPr/>
        <a:lstStyle/>
        <a:p>
          <a:endParaRPr lang="de-DE" sz="110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E8089669-DCD2-4DB6-A714-273990695241}" type="sibTrans" cxnId="{4FFBF3E2-1522-42AF-BA23-014F92B921B3}">
      <dgm:prSet/>
      <dgm:spPr/>
      <dgm:t>
        <a:bodyPr/>
        <a:lstStyle/>
        <a:p>
          <a:endParaRPr lang="de-DE" sz="2000"/>
        </a:p>
      </dgm:t>
    </dgm:pt>
    <dgm:pt modelId="{5BEDA607-8DED-42F2-9BA0-692D403C0EC7}">
      <dgm:prSet phldrT="[Text]" custT="1"/>
      <dgm:spPr/>
      <dgm:t>
        <a:bodyPr/>
        <a:lstStyle/>
        <a:p>
          <a:r>
            <a:rPr lang="de-DE" sz="1050">
              <a:latin typeface="Times New Roman" panose="02020603050405020304" pitchFamily="18" charset="0"/>
              <a:cs typeface="Times New Roman" panose="02020603050405020304" pitchFamily="18" charset="0"/>
            </a:rPr>
            <a:t>Krankheit</a:t>
          </a:r>
        </a:p>
      </dgm:t>
    </dgm:pt>
    <dgm:pt modelId="{84547787-FAB0-4D90-A3B1-62ECE02E3768}" type="parTrans" cxnId="{F19D9763-6EC4-4C58-A212-4CB5C96C1C4B}">
      <dgm:prSet custT="1"/>
      <dgm:spPr/>
      <dgm:t>
        <a:bodyPr/>
        <a:lstStyle/>
        <a:p>
          <a:endParaRPr lang="de-DE" sz="110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85E28AF0-9D48-40FF-95C5-6BCCE65C1A96}" type="sibTrans" cxnId="{F19D9763-6EC4-4C58-A212-4CB5C96C1C4B}">
      <dgm:prSet/>
      <dgm:spPr/>
      <dgm:t>
        <a:bodyPr/>
        <a:lstStyle/>
        <a:p>
          <a:endParaRPr lang="de-DE" sz="2000"/>
        </a:p>
      </dgm:t>
    </dgm:pt>
    <dgm:pt modelId="{A7E59208-D8C8-472E-BF12-F8E4CF3114A2}">
      <dgm:prSet phldrT="[Text]" custT="1"/>
      <dgm:spPr/>
      <dgm:t>
        <a:bodyPr/>
        <a:lstStyle/>
        <a:p>
          <a:r>
            <a:rPr lang="de-DE" sz="1050">
              <a:latin typeface="Times New Roman" panose="02020603050405020304" pitchFamily="18" charset="0"/>
              <a:cs typeface="Times New Roman" panose="02020603050405020304" pitchFamily="18" charset="0"/>
            </a:rPr>
            <a:t>Behandlung</a:t>
          </a:r>
        </a:p>
      </dgm:t>
    </dgm:pt>
    <dgm:pt modelId="{A1B0E159-B1C8-4060-A4E0-14F2712C19F0}" type="parTrans" cxnId="{04D6DC77-F106-4C55-92DF-A7B3E0A59C0C}">
      <dgm:prSet custT="1"/>
      <dgm:spPr/>
      <dgm:t>
        <a:bodyPr/>
        <a:lstStyle/>
        <a:p>
          <a:endParaRPr lang="de-DE" sz="110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51A6C234-0D46-49B1-9152-315F121BE747}" type="sibTrans" cxnId="{04D6DC77-F106-4C55-92DF-A7B3E0A59C0C}">
      <dgm:prSet/>
      <dgm:spPr/>
      <dgm:t>
        <a:bodyPr/>
        <a:lstStyle/>
        <a:p>
          <a:endParaRPr lang="de-DE" sz="2000"/>
        </a:p>
      </dgm:t>
    </dgm:pt>
    <dgm:pt modelId="{4DCC093E-5118-4588-BF05-784A120C438E}">
      <dgm:prSet phldrT="[Text]" custT="1"/>
      <dgm:spPr/>
      <dgm:t>
        <a:bodyPr/>
        <a:lstStyle/>
        <a:p>
          <a:pPr>
            <a:lnSpc>
              <a:spcPct val="100000"/>
            </a:lnSpc>
          </a:pPr>
          <a:r>
            <a:rPr lang="de-DE" sz="1050">
              <a:latin typeface="Times New Roman" panose="02020603050405020304" pitchFamily="18" charset="0"/>
              <a:cs typeface="Times New Roman" panose="02020603050405020304" pitchFamily="18" charset="0"/>
            </a:rPr>
            <a:t>Interventionen/</a:t>
          </a:r>
        </a:p>
        <a:p>
          <a:pPr>
            <a:lnSpc>
              <a:spcPct val="100000"/>
            </a:lnSpc>
          </a:pPr>
          <a:r>
            <a:rPr lang="de-DE" sz="1050">
              <a:latin typeface="Times New Roman" panose="02020603050405020304" pitchFamily="18" charset="0"/>
              <a:cs typeface="Times New Roman" panose="02020603050405020304" pitchFamily="18" charset="0"/>
            </a:rPr>
            <a:t>Maßnahmen</a:t>
          </a:r>
        </a:p>
      </dgm:t>
    </dgm:pt>
    <dgm:pt modelId="{579F7746-AF17-435C-A54C-9C6E6EE94B1D}" type="parTrans" cxnId="{21D2CBA7-4E8B-4913-B267-78660AC9127F}">
      <dgm:prSet custT="1"/>
      <dgm:spPr/>
      <dgm:t>
        <a:bodyPr/>
        <a:lstStyle/>
        <a:p>
          <a:endParaRPr lang="de-DE" sz="110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EA649D5B-149D-4781-A689-D23905969596}" type="sibTrans" cxnId="{21D2CBA7-4E8B-4913-B267-78660AC9127F}">
      <dgm:prSet/>
      <dgm:spPr/>
      <dgm:t>
        <a:bodyPr/>
        <a:lstStyle/>
        <a:p>
          <a:endParaRPr lang="de-DE" sz="2000"/>
        </a:p>
      </dgm:t>
    </dgm:pt>
    <dgm:pt modelId="{4E60B1B3-870B-4A1B-9517-73B33DCA2C20}">
      <dgm:prSet phldrT="[Text]" custT="1"/>
      <dgm:spPr/>
      <dgm:t>
        <a:bodyPr/>
        <a:lstStyle/>
        <a:p>
          <a:r>
            <a:rPr lang="de-DE" sz="1050">
              <a:latin typeface="Times New Roman" panose="02020603050405020304" pitchFamily="18" charset="0"/>
              <a:cs typeface="Times New Roman" panose="02020603050405020304" pitchFamily="18" charset="0"/>
            </a:rPr>
            <a:t>Informationen</a:t>
          </a:r>
        </a:p>
      </dgm:t>
    </dgm:pt>
    <dgm:pt modelId="{895AD288-8C3F-4FEF-8348-DE71D8D3CA8C}" type="parTrans" cxnId="{18B32BF9-C15D-49A4-94AE-9BE5B96D30B1}">
      <dgm:prSet custT="1"/>
      <dgm:spPr/>
      <dgm:t>
        <a:bodyPr/>
        <a:lstStyle/>
        <a:p>
          <a:endParaRPr lang="de-DE" sz="110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E66CBDB9-DF23-432A-9DE5-67E5508FEEDF}" type="sibTrans" cxnId="{18B32BF9-C15D-49A4-94AE-9BE5B96D30B1}">
      <dgm:prSet/>
      <dgm:spPr/>
      <dgm:t>
        <a:bodyPr/>
        <a:lstStyle/>
        <a:p>
          <a:endParaRPr lang="de-DE" sz="2000"/>
        </a:p>
      </dgm:t>
    </dgm:pt>
    <dgm:pt modelId="{358A984D-84A8-4882-B614-7818D9052477}">
      <dgm:prSet phldrT="[Text]" custT="1"/>
      <dgm:spPr/>
      <dgm:t>
        <a:bodyPr/>
        <a:lstStyle/>
        <a:p>
          <a:r>
            <a:rPr lang="de-DE" sz="1050">
              <a:latin typeface="Times New Roman" panose="02020603050405020304" pitchFamily="18" charset="0"/>
              <a:cs typeface="Times New Roman" panose="02020603050405020304" pitchFamily="18" charset="0"/>
            </a:rPr>
            <a:t>Stigmatisierung</a:t>
          </a:r>
        </a:p>
      </dgm:t>
    </dgm:pt>
    <dgm:pt modelId="{8C8C0F98-AF8B-47BC-ACBA-EC4EA96F1883}" type="parTrans" cxnId="{A4C9B23C-5196-4A21-9C6A-A300E70E09A3}">
      <dgm:prSet custT="1"/>
      <dgm:spPr/>
      <dgm:t>
        <a:bodyPr/>
        <a:lstStyle/>
        <a:p>
          <a:endParaRPr lang="de-DE" sz="110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FB721D93-4426-41AA-BDE6-2476D51C93FF}" type="sibTrans" cxnId="{A4C9B23C-5196-4A21-9C6A-A300E70E09A3}">
      <dgm:prSet/>
      <dgm:spPr/>
      <dgm:t>
        <a:bodyPr/>
        <a:lstStyle/>
        <a:p>
          <a:endParaRPr lang="de-DE" sz="2000"/>
        </a:p>
      </dgm:t>
    </dgm:pt>
    <dgm:pt modelId="{4C9D4A9F-DD4B-450F-BD60-CED00D3393A2}">
      <dgm:prSet phldrT="[Text]" custT="1"/>
      <dgm:spPr/>
      <dgm:t>
        <a:bodyPr/>
        <a:lstStyle/>
        <a:p>
          <a:r>
            <a:rPr lang="de-DE" sz="1050">
              <a:latin typeface="Times New Roman" panose="02020603050405020304" pitchFamily="18" charset="0"/>
              <a:cs typeface="Times New Roman" panose="02020603050405020304" pitchFamily="18" charset="0"/>
            </a:rPr>
            <a:t>Verbreitung und Immunität</a:t>
          </a:r>
        </a:p>
      </dgm:t>
    </dgm:pt>
    <dgm:pt modelId="{1731A452-294D-4C69-97EA-ABFB841FA0AB}" type="parTrans" cxnId="{0A0CF701-79B2-47F2-8622-FC36046D2926}">
      <dgm:prSet custT="1"/>
      <dgm:spPr/>
      <dgm:t>
        <a:bodyPr/>
        <a:lstStyle/>
        <a:p>
          <a:endParaRPr lang="de-DE" sz="110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71D5611E-9C7C-4282-88EB-4D6B84C36EA4}" type="sibTrans" cxnId="{0A0CF701-79B2-47F2-8622-FC36046D2926}">
      <dgm:prSet/>
      <dgm:spPr/>
      <dgm:t>
        <a:bodyPr/>
        <a:lstStyle/>
        <a:p>
          <a:endParaRPr lang="de-DE" sz="2000"/>
        </a:p>
      </dgm:t>
    </dgm:pt>
    <dgm:pt modelId="{26FE1203-5ADF-4E90-A8D9-0247D9F49394}">
      <dgm:prSet phldrT="[Text]" custT="1"/>
      <dgm:spPr/>
      <dgm:t>
        <a:bodyPr/>
        <a:lstStyle/>
        <a:p>
          <a:r>
            <a:rPr lang="de-DE" sz="1050">
              <a:latin typeface="Times New Roman" panose="02020603050405020304" pitchFamily="18" charset="0"/>
              <a:cs typeface="Times New Roman" panose="02020603050405020304" pitchFamily="18" charset="0"/>
            </a:rPr>
            <a:t>Symptome</a:t>
          </a:r>
        </a:p>
      </dgm:t>
    </dgm:pt>
    <dgm:pt modelId="{07D04FA9-5869-4D23-B691-B49B006E8BC9}" type="parTrans" cxnId="{36599623-182A-480E-BBAC-966ED1CF3002}">
      <dgm:prSet custT="1"/>
      <dgm:spPr/>
      <dgm:t>
        <a:bodyPr/>
        <a:lstStyle/>
        <a:p>
          <a:endParaRPr lang="de-DE" sz="110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A7D50C71-D674-4373-B823-7229A869B85A}" type="sibTrans" cxnId="{36599623-182A-480E-BBAC-966ED1CF3002}">
      <dgm:prSet/>
      <dgm:spPr/>
      <dgm:t>
        <a:bodyPr/>
        <a:lstStyle/>
        <a:p>
          <a:endParaRPr lang="de-DE" sz="2000"/>
        </a:p>
      </dgm:t>
    </dgm:pt>
    <dgm:pt modelId="{9EEC29B6-B262-48C2-8C7F-8D2337E7AA42}">
      <dgm:prSet phldrT="[Text]" custT="1"/>
      <dgm:spPr/>
      <dgm:t>
        <a:bodyPr/>
        <a:lstStyle/>
        <a:p>
          <a:r>
            <a:rPr lang="de-DE" sz="1050">
              <a:latin typeface="Times New Roman" panose="02020603050405020304" pitchFamily="18" charset="0"/>
              <a:cs typeface="Times New Roman" panose="02020603050405020304" pitchFamily="18" charset="0"/>
            </a:rPr>
            <a:t>Asymptomatisch</a:t>
          </a:r>
        </a:p>
      </dgm:t>
    </dgm:pt>
    <dgm:pt modelId="{BE23815E-A548-4C9A-9302-6B0219BE53D6}" type="parTrans" cxnId="{9CEDC11C-136F-41B2-8B1A-7F65506AA089}">
      <dgm:prSet custT="1"/>
      <dgm:spPr/>
      <dgm:t>
        <a:bodyPr/>
        <a:lstStyle/>
        <a:p>
          <a:endParaRPr lang="de-DE" sz="110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41B53EC5-CB3D-457D-A5B5-3DED8454A648}" type="sibTrans" cxnId="{9CEDC11C-136F-41B2-8B1A-7F65506AA089}">
      <dgm:prSet/>
      <dgm:spPr/>
      <dgm:t>
        <a:bodyPr/>
        <a:lstStyle/>
        <a:p>
          <a:endParaRPr lang="de-DE" sz="2000"/>
        </a:p>
      </dgm:t>
    </dgm:pt>
    <dgm:pt modelId="{99F805CD-8B05-4B09-8106-E7D62662EFAB}">
      <dgm:prSet phldrT="[Text]" custT="1"/>
      <dgm:spPr/>
      <dgm:t>
        <a:bodyPr/>
        <a:lstStyle/>
        <a:p>
          <a:r>
            <a:rPr lang="de-DE" sz="1050">
              <a:latin typeface="Times New Roman" panose="02020603050405020304" pitchFamily="18" charset="0"/>
              <a:cs typeface="Times New Roman" panose="02020603050405020304" pitchFamily="18" charset="0"/>
            </a:rPr>
            <a:t>Präsymptomatisch</a:t>
          </a:r>
        </a:p>
      </dgm:t>
    </dgm:pt>
    <dgm:pt modelId="{E8E96543-F299-474B-9FCF-7801EFC57576}" type="parTrans" cxnId="{11A3DC8E-FF1F-4699-9A3B-B670663B4676}">
      <dgm:prSet custT="1"/>
      <dgm:spPr/>
      <dgm:t>
        <a:bodyPr/>
        <a:lstStyle/>
        <a:p>
          <a:endParaRPr lang="de-DE" sz="110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D7B2BED0-5F36-4662-A45B-3AF98D5317EC}" type="sibTrans" cxnId="{11A3DC8E-FF1F-4699-9A3B-B670663B4676}">
      <dgm:prSet/>
      <dgm:spPr/>
      <dgm:t>
        <a:bodyPr/>
        <a:lstStyle/>
        <a:p>
          <a:endParaRPr lang="de-DE" sz="2000"/>
        </a:p>
      </dgm:t>
    </dgm:pt>
    <dgm:pt modelId="{518E9C13-B9BA-4F04-A7EC-F36C8D246639}">
      <dgm:prSet phldrT="[Text]" custT="1"/>
      <dgm:spPr/>
      <dgm:t>
        <a:bodyPr/>
        <a:lstStyle/>
        <a:p>
          <a:r>
            <a:rPr lang="de-DE" sz="1050">
              <a:latin typeface="Times New Roman" panose="02020603050405020304" pitchFamily="18" charset="0"/>
              <a:cs typeface="Times New Roman" panose="02020603050405020304" pitchFamily="18" charset="0"/>
            </a:rPr>
            <a:t>Übertragungswege</a:t>
          </a:r>
        </a:p>
      </dgm:t>
    </dgm:pt>
    <dgm:pt modelId="{FB410C4C-ACA6-43C1-94D1-C7A844E0F3B3}" type="parTrans" cxnId="{9386AE0E-2F7B-4B2D-A2A0-8ED89691D55E}">
      <dgm:prSet custT="1"/>
      <dgm:spPr/>
      <dgm:t>
        <a:bodyPr/>
        <a:lstStyle/>
        <a:p>
          <a:endParaRPr lang="de-DE" sz="110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5BB641B2-739A-4F95-9858-A0BD6DA4CF4F}" type="sibTrans" cxnId="{9386AE0E-2F7B-4B2D-A2A0-8ED89691D55E}">
      <dgm:prSet/>
      <dgm:spPr/>
      <dgm:t>
        <a:bodyPr/>
        <a:lstStyle/>
        <a:p>
          <a:endParaRPr lang="de-DE" sz="2000"/>
        </a:p>
      </dgm:t>
    </dgm:pt>
    <dgm:pt modelId="{109BE932-8DDB-46FE-93F1-0C28F0100D1E}">
      <dgm:prSet phldrT="[Text]" custT="1"/>
      <dgm:spPr/>
      <dgm:t>
        <a:bodyPr/>
        <a:lstStyle/>
        <a:p>
          <a:r>
            <a:rPr lang="de-DE" sz="1050">
              <a:latin typeface="Times New Roman" panose="02020603050405020304" pitchFamily="18" charset="0"/>
              <a:cs typeface="Times New Roman" panose="02020603050405020304" pitchFamily="18" charset="0"/>
            </a:rPr>
            <a:t>Schutz vor Übertragung</a:t>
          </a:r>
        </a:p>
      </dgm:t>
    </dgm:pt>
    <dgm:pt modelId="{6F25122C-9DC2-4635-960D-7ABCFA19A050}" type="parTrans" cxnId="{0292F002-650B-49D0-AE03-C8DDF4B97AC1}">
      <dgm:prSet custT="1"/>
      <dgm:spPr/>
      <dgm:t>
        <a:bodyPr/>
        <a:lstStyle/>
        <a:p>
          <a:endParaRPr lang="de-DE" sz="110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A744AE17-7DC2-4DEE-8DD3-48BA06300DB6}" type="sibTrans" cxnId="{0292F002-650B-49D0-AE03-C8DDF4B97AC1}">
      <dgm:prSet/>
      <dgm:spPr/>
      <dgm:t>
        <a:bodyPr/>
        <a:lstStyle/>
        <a:p>
          <a:endParaRPr lang="de-DE" sz="2000"/>
        </a:p>
      </dgm:t>
    </dgm:pt>
    <dgm:pt modelId="{F4B2B415-9F5D-4A5C-A517-33028F9EDE23}">
      <dgm:prSet phldrT="[Text]" custT="1"/>
      <dgm:spPr/>
      <dgm:t>
        <a:bodyPr/>
        <a:lstStyle/>
        <a:p>
          <a:r>
            <a:rPr lang="de-DE" sz="1050">
              <a:latin typeface="Times New Roman" panose="02020603050405020304" pitchFamily="18" charset="0"/>
              <a:cs typeface="Times New Roman" panose="02020603050405020304" pitchFamily="18" charset="0"/>
            </a:rPr>
            <a:t>Risiken</a:t>
          </a:r>
        </a:p>
      </dgm:t>
    </dgm:pt>
    <dgm:pt modelId="{C6A0CEB6-9E0F-4493-8DE5-DBE1EBED4241}" type="parTrans" cxnId="{CFBC75B3-6B2D-492A-9E29-EDE294FDB12A}">
      <dgm:prSet custT="1"/>
      <dgm:spPr/>
      <dgm:t>
        <a:bodyPr/>
        <a:lstStyle/>
        <a:p>
          <a:endParaRPr lang="de-DE" sz="110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5F9517A7-3764-4E96-8F05-51C754E9941B}" type="sibTrans" cxnId="{CFBC75B3-6B2D-492A-9E29-EDE294FDB12A}">
      <dgm:prSet/>
      <dgm:spPr/>
      <dgm:t>
        <a:bodyPr/>
        <a:lstStyle/>
        <a:p>
          <a:endParaRPr lang="de-DE" sz="2000"/>
        </a:p>
      </dgm:t>
    </dgm:pt>
    <dgm:pt modelId="{1BB53B11-3670-415B-805A-CE32EE8357FF}">
      <dgm:prSet phldrT="[Text]" custT="1"/>
      <dgm:spPr/>
      <dgm:t>
        <a:bodyPr/>
        <a:lstStyle/>
        <a:p>
          <a:r>
            <a:rPr lang="de-DE" sz="1050">
              <a:latin typeface="Times New Roman" panose="02020603050405020304" pitchFamily="18" charset="0"/>
              <a:cs typeface="Times New Roman" panose="02020603050405020304" pitchFamily="18" charset="0"/>
            </a:rPr>
            <a:t>Grundlegende Bedingungen</a:t>
          </a:r>
        </a:p>
      </dgm:t>
    </dgm:pt>
    <dgm:pt modelId="{CA6A9C70-223C-4BA6-B22F-E7EE9FCEF901}" type="parTrans" cxnId="{E657CA68-7262-414C-8915-DA2904315788}">
      <dgm:prSet custT="1"/>
      <dgm:spPr/>
      <dgm:t>
        <a:bodyPr/>
        <a:lstStyle/>
        <a:p>
          <a:endParaRPr lang="de-DE" sz="110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15B10DEE-88A1-4399-88DF-14098CAE15AD}" type="sibTrans" cxnId="{E657CA68-7262-414C-8915-DA2904315788}">
      <dgm:prSet/>
      <dgm:spPr/>
      <dgm:t>
        <a:bodyPr/>
        <a:lstStyle/>
        <a:p>
          <a:endParaRPr lang="de-DE" sz="2000"/>
        </a:p>
      </dgm:t>
    </dgm:pt>
    <dgm:pt modelId="{E2EBA384-91D3-4018-9EF6-F6F2CD249D13}">
      <dgm:prSet phldrT="[Text]" custT="1"/>
      <dgm:spPr/>
      <dgm:t>
        <a:bodyPr/>
        <a:lstStyle/>
        <a:p>
          <a:r>
            <a:rPr lang="de-DE" sz="1050">
              <a:latin typeface="Times New Roman" panose="02020603050405020304" pitchFamily="18" charset="0"/>
              <a:cs typeface="Times New Roman" panose="02020603050405020304" pitchFamily="18" charset="0"/>
            </a:rPr>
            <a:t>Alter</a:t>
          </a:r>
        </a:p>
      </dgm:t>
    </dgm:pt>
    <dgm:pt modelId="{6CF7CD4C-0917-44C0-B3FE-FDC2C5B2A919}" type="parTrans" cxnId="{BD8AFAFB-6827-47A4-BEE6-B7BD500A967C}">
      <dgm:prSet custT="1"/>
      <dgm:spPr/>
      <dgm:t>
        <a:bodyPr/>
        <a:lstStyle/>
        <a:p>
          <a:endParaRPr lang="de-DE" sz="110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DEA0B624-4869-47B4-804B-98EC11BA11B7}" type="sibTrans" cxnId="{BD8AFAFB-6827-47A4-BEE6-B7BD500A967C}">
      <dgm:prSet/>
      <dgm:spPr/>
      <dgm:t>
        <a:bodyPr/>
        <a:lstStyle/>
        <a:p>
          <a:endParaRPr lang="de-DE" sz="2000"/>
        </a:p>
      </dgm:t>
    </dgm:pt>
    <dgm:pt modelId="{CE4A4217-0410-4729-9337-C36C75DD601B}">
      <dgm:prSet phldrT="[Text]" custT="1"/>
      <dgm:spPr/>
      <dgm:t>
        <a:bodyPr/>
        <a:lstStyle/>
        <a:p>
          <a:r>
            <a:rPr lang="de-DE" sz="1050">
              <a:latin typeface="Times New Roman" panose="02020603050405020304" pitchFamily="18" charset="0"/>
              <a:cs typeface="Times New Roman" panose="02020603050405020304" pitchFamily="18" charset="0"/>
            </a:rPr>
            <a:t>Geschlecht</a:t>
          </a:r>
        </a:p>
      </dgm:t>
    </dgm:pt>
    <dgm:pt modelId="{539788D9-F5CD-499B-8EFE-4BDF10193421}" type="parTrans" cxnId="{B3F5674A-4402-4EB3-AE33-BA190C5A46B8}">
      <dgm:prSet custT="1"/>
      <dgm:spPr/>
      <dgm:t>
        <a:bodyPr/>
        <a:lstStyle/>
        <a:p>
          <a:endParaRPr lang="de-DE" sz="110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1D71D8A5-0DC5-4C1F-8009-4A0D76746D08}" type="sibTrans" cxnId="{B3F5674A-4402-4EB3-AE33-BA190C5A46B8}">
      <dgm:prSet/>
      <dgm:spPr/>
      <dgm:t>
        <a:bodyPr/>
        <a:lstStyle/>
        <a:p>
          <a:endParaRPr lang="de-DE" sz="2000"/>
        </a:p>
      </dgm:t>
    </dgm:pt>
    <dgm:pt modelId="{359B501C-2EC2-4B8C-BD62-7A96D0CFC1AF}">
      <dgm:prSet phldrT="[Text]" custT="1"/>
      <dgm:spPr/>
      <dgm:t>
        <a:bodyPr/>
        <a:lstStyle/>
        <a:p>
          <a:r>
            <a:rPr lang="de-DE" sz="1050">
              <a:latin typeface="Times New Roman" panose="02020603050405020304" pitchFamily="18" charset="0"/>
              <a:cs typeface="Times New Roman" panose="02020603050405020304" pitchFamily="18" charset="0"/>
            </a:rPr>
            <a:t>Vulnerable Gruppen</a:t>
          </a:r>
        </a:p>
      </dgm:t>
    </dgm:pt>
    <dgm:pt modelId="{8F1E2ECC-9C8C-4137-9CC2-148EC633E965}" type="parTrans" cxnId="{176A946C-5CA5-4F20-9515-6CFF3244107D}">
      <dgm:prSet custT="1"/>
      <dgm:spPr/>
      <dgm:t>
        <a:bodyPr/>
        <a:lstStyle/>
        <a:p>
          <a:endParaRPr lang="de-DE" sz="110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215BF104-439D-4F69-8669-82DF0A50A615}" type="sibTrans" cxnId="{176A946C-5CA5-4F20-9515-6CFF3244107D}">
      <dgm:prSet/>
      <dgm:spPr/>
      <dgm:t>
        <a:bodyPr/>
        <a:lstStyle/>
        <a:p>
          <a:endParaRPr lang="de-DE" sz="2000"/>
        </a:p>
      </dgm:t>
    </dgm:pt>
    <dgm:pt modelId="{9A5197BB-7B1D-4DC8-A917-46D969DA792E}">
      <dgm:prSet phldrT="[Text]" custT="1"/>
      <dgm:spPr/>
      <dgm:t>
        <a:bodyPr/>
        <a:lstStyle/>
        <a:p>
          <a:r>
            <a:rPr lang="de-DE" sz="1050">
              <a:latin typeface="Times New Roman" panose="02020603050405020304" pitchFamily="18" charset="0"/>
              <a:cs typeface="Times New Roman" panose="02020603050405020304" pitchFamily="18" charset="0"/>
            </a:rPr>
            <a:t>Bestätigt</a:t>
          </a:r>
        </a:p>
      </dgm:t>
    </dgm:pt>
    <dgm:pt modelId="{03C2E030-813C-4887-94E5-82269C93F63C}" type="parTrans" cxnId="{94199405-C4AF-4981-BB8E-1CD2D5B12077}">
      <dgm:prSet custT="1"/>
      <dgm:spPr/>
      <dgm:t>
        <a:bodyPr/>
        <a:lstStyle/>
        <a:p>
          <a:endParaRPr lang="de-DE" sz="110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A996E5A6-72C3-45F3-B265-EB01532B76AD}" type="sibTrans" cxnId="{94199405-C4AF-4981-BB8E-1CD2D5B12077}">
      <dgm:prSet/>
      <dgm:spPr/>
      <dgm:t>
        <a:bodyPr/>
        <a:lstStyle/>
        <a:p>
          <a:endParaRPr lang="de-DE" sz="2000"/>
        </a:p>
      </dgm:t>
    </dgm:pt>
    <dgm:pt modelId="{2F02F2CE-1BCD-446E-BECB-6973E7ACA9E4}">
      <dgm:prSet phldrT="[Text]" custT="1"/>
      <dgm:spPr/>
      <dgm:t>
        <a:bodyPr/>
        <a:lstStyle/>
        <a:p>
          <a:r>
            <a:rPr lang="de-DE" sz="1050">
              <a:latin typeface="Times New Roman" panose="02020603050405020304" pitchFamily="18" charset="0"/>
              <a:cs typeface="Times New Roman" panose="02020603050405020304" pitchFamily="18" charset="0"/>
            </a:rPr>
            <a:t>Andere</a:t>
          </a:r>
        </a:p>
      </dgm:t>
    </dgm:pt>
    <dgm:pt modelId="{D40E33C4-65A6-43F0-8A5A-668871AD40F3}" type="parTrans" cxnId="{DB66B812-E1E0-45FC-BB26-4974FD34809F}">
      <dgm:prSet custT="1"/>
      <dgm:spPr/>
      <dgm:t>
        <a:bodyPr/>
        <a:lstStyle/>
        <a:p>
          <a:endParaRPr lang="de-DE" sz="110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D22232FC-EFFC-4ED5-BFEA-E170EC048C0E}" type="sibTrans" cxnId="{DB66B812-E1E0-45FC-BB26-4974FD34809F}">
      <dgm:prSet/>
      <dgm:spPr/>
      <dgm:t>
        <a:bodyPr/>
        <a:lstStyle/>
        <a:p>
          <a:endParaRPr lang="de-DE" sz="2000"/>
        </a:p>
      </dgm:t>
    </dgm:pt>
    <dgm:pt modelId="{3CF53495-E7A9-4FFB-983F-8FC85A5AADF1}">
      <dgm:prSet phldrT="[Text]" custT="1"/>
      <dgm:spPr/>
      <dgm:t>
        <a:bodyPr/>
        <a:lstStyle/>
        <a:p>
          <a:r>
            <a:rPr lang="de-DE" sz="1050">
              <a:latin typeface="Times New Roman" panose="02020603050405020304" pitchFamily="18" charset="0"/>
              <a:cs typeface="Times New Roman" panose="02020603050405020304" pitchFamily="18" charset="0"/>
            </a:rPr>
            <a:t>Aktuelle Behandlung</a:t>
          </a:r>
        </a:p>
      </dgm:t>
    </dgm:pt>
    <dgm:pt modelId="{96C75850-7C10-4A02-8605-049A49CD2E2D}" type="parTrans" cxnId="{28926F01-4C50-42E8-B91C-EB4AB276390F}">
      <dgm:prSet custT="1"/>
      <dgm:spPr/>
      <dgm:t>
        <a:bodyPr/>
        <a:lstStyle/>
        <a:p>
          <a:endParaRPr lang="de-DE" sz="110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D9F24578-11A8-4686-B575-3BEBFF1584D9}" type="sibTrans" cxnId="{28926F01-4C50-42E8-B91C-EB4AB276390F}">
      <dgm:prSet/>
      <dgm:spPr/>
      <dgm:t>
        <a:bodyPr/>
        <a:lstStyle/>
        <a:p>
          <a:endParaRPr lang="de-DE" sz="2000"/>
        </a:p>
      </dgm:t>
    </dgm:pt>
    <dgm:pt modelId="{B9C65307-6730-4D84-A9EC-F5E07D061332}">
      <dgm:prSet phldrT="[Text]" custT="1"/>
      <dgm:spPr/>
      <dgm:t>
        <a:bodyPr/>
        <a:lstStyle/>
        <a:p>
          <a:r>
            <a:rPr lang="de-DE" sz="1050">
              <a:latin typeface="Times New Roman" panose="02020603050405020304" pitchFamily="18" charset="0"/>
              <a:cs typeface="Times New Roman" panose="02020603050405020304" pitchFamily="18" charset="0"/>
            </a:rPr>
            <a:t>Forschung und Entwicklung</a:t>
          </a:r>
        </a:p>
      </dgm:t>
    </dgm:pt>
    <dgm:pt modelId="{72696429-0052-4BF2-A3D6-BBDE6FE074F3}" type="parTrans" cxnId="{A348F95E-EC39-4B0A-B118-7067A75674BE}">
      <dgm:prSet custT="1"/>
      <dgm:spPr/>
      <dgm:t>
        <a:bodyPr/>
        <a:lstStyle/>
        <a:p>
          <a:endParaRPr lang="de-DE" sz="110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335D4C02-6620-4C99-B00C-8D1A5C8FA344}" type="sibTrans" cxnId="{A348F95E-EC39-4B0A-B118-7067A75674BE}">
      <dgm:prSet/>
      <dgm:spPr/>
      <dgm:t>
        <a:bodyPr/>
        <a:lstStyle/>
        <a:p>
          <a:endParaRPr lang="de-DE" sz="2000"/>
        </a:p>
      </dgm:t>
    </dgm:pt>
    <dgm:pt modelId="{3E305254-2A1B-4466-9716-16D92D48BD39}">
      <dgm:prSet phldrT="[Text]" custT="1"/>
      <dgm:spPr/>
      <dgm:t>
        <a:bodyPr/>
        <a:lstStyle/>
        <a:p>
          <a:r>
            <a:rPr lang="de-DE" sz="1050">
              <a:latin typeface="Times New Roman" panose="02020603050405020304" pitchFamily="18" charset="0"/>
              <a:cs typeface="Times New Roman" panose="02020603050405020304" pitchFamily="18" charset="0"/>
            </a:rPr>
            <a:t>Ungeprüfte Behandlungsweisen</a:t>
          </a:r>
        </a:p>
      </dgm:t>
    </dgm:pt>
    <dgm:pt modelId="{5E84A072-2EA0-45DE-B57C-DA217CA13318}" type="parTrans" cxnId="{8E7AB9D7-5E84-44E1-B1AE-52F3EA136985}">
      <dgm:prSet custT="1"/>
      <dgm:spPr/>
      <dgm:t>
        <a:bodyPr/>
        <a:lstStyle/>
        <a:p>
          <a:endParaRPr lang="de-DE" sz="110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28E68593-7507-41E2-BA36-8D5C9263D978}" type="sibTrans" cxnId="{8E7AB9D7-5E84-44E1-B1AE-52F3EA136985}">
      <dgm:prSet/>
      <dgm:spPr/>
      <dgm:t>
        <a:bodyPr/>
        <a:lstStyle/>
        <a:p>
          <a:endParaRPr lang="de-DE" sz="2000"/>
        </a:p>
      </dgm:t>
    </dgm:pt>
    <dgm:pt modelId="{AB141E1E-8A47-473D-BDC9-A740AE0EA3F7}">
      <dgm:prSet phldrT="[Text]" custT="1"/>
      <dgm:spPr/>
      <dgm:t>
        <a:bodyPr/>
        <a:lstStyle/>
        <a:p>
          <a:r>
            <a:rPr lang="de-DE" sz="1050">
              <a:latin typeface="Times New Roman" panose="02020603050405020304" pitchFamily="18" charset="0"/>
              <a:cs typeface="Times New Roman" panose="02020603050405020304" pitchFamily="18" charset="0"/>
            </a:rPr>
            <a:t>Mythen</a:t>
          </a:r>
        </a:p>
      </dgm:t>
    </dgm:pt>
    <dgm:pt modelId="{1930F7C4-5EB2-4BFC-B652-6F6645AD8029}" type="parTrans" cxnId="{1934D0CF-1E8D-4B17-B666-0C945913728B}">
      <dgm:prSet custT="1"/>
      <dgm:spPr/>
      <dgm:t>
        <a:bodyPr/>
        <a:lstStyle/>
        <a:p>
          <a:endParaRPr lang="de-DE" sz="110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91192A3F-4210-4580-A1AE-30F1DDACAD26}" type="sibTrans" cxnId="{1934D0CF-1E8D-4B17-B666-0C945913728B}">
      <dgm:prSet/>
      <dgm:spPr/>
      <dgm:t>
        <a:bodyPr/>
        <a:lstStyle/>
        <a:p>
          <a:endParaRPr lang="de-DE" sz="2000"/>
        </a:p>
      </dgm:t>
    </dgm:pt>
    <dgm:pt modelId="{B8C47AF5-72F4-4882-A03A-756E7DB0314D}">
      <dgm:prSet phldrT="[Text]" custT="1"/>
      <dgm:spPr/>
      <dgm:t>
        <a:bodyPr/>
        <a:lstStyle/>
        <a:p>
          <a:r>
            <a:rPr lang="de-DE" sz="1050">
              <a:latin typeface="Times New Roman" panose="02020603050405020304" pitchFamily="18" charset="0"/>
              <a:cs typeface="Times New Roman" panose="02020603050405020304" pitchFamily="18" charset="0"/>
            </a:rPr>
            <a:t>Tests</a:t>
          </a:r>
        </a:p>
      </dgm:t>
    </dgm:pt>
    <dgm:pt modelId="{CEA4C598-03BA-4196-8096-D8D9940A747B}" type="parTrans" cxnId="{4A2C5E67-8424-4571-BB23-BA2ECA3579FA}">
      <dgm:prSet custT="1"/>
      <dgm:spPr/>
      <dgm:t>
        <a:bodyPr/>
        <a:lstStyle/>
        <a:p>
          <a:endParaRPr lang="de-DE" sz="110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EC6E509A-E8EC-47FA-9CF3-59C646F77411}" type="sibTrans" cxnId="{4A2C5E67-8424-4571-BB23-BA2ECA3579FA}">
      <dgm:prSet/>
      <dgm:spPr/>
      <dgm:t>
        <a:bodyPr/>
        <a:lstStyle/>
        <a:p>
          <a:endParaRPr lang="de-DE" sz="2000"/>
        </a:p>
      </dgm:t>
    </dgm:pt>
    <dgm:pt modelId="{3B6E185B-6A1C-411C-B39C-F27A6010733C}">
      <dgm:prSet phldrT="[Text]" custT="1"/>
      <dgm:spPr/>
      <dgm:t>
        <a:bodyPr/>
        <a:lstStyle/>
        <a:p>
          <a:r>
            <a:rPr lang="de-DE" sz="1050">
              <a:latin typeface="Times New Roman" panose="02020603050405020304" pitchFamily="18" charset="0"/>
              <a:cs typeface="Times New Roman" panose="02020603050405020304" pitchFamily="18" charset="0"/>
            </a:rPr>
            <a:t>Unterstützende Maßnahmen</a:t>
          </a:r>
        </a:p>
      </dgm:t>
    </dgm:pt>
    <dgm:pt modelId="{C1EACDD7-D989-416D-9681-817FEB9BF90B}" type="parTrans" cxnId="{31AD32E1-C5F3-41E2-8A34-FBA4D83488DD}">
      <dgm:prSet custT="1"/>
      <dgm:spPr/>
      <dgm:t>
        <a:bodyPr/>
        <a:lstStyle/>
        <a:p>
          <a:endParaRPr lang="de-DE" sz="110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9A34BB95-B186-435B-AAA0-ED02B3A2EB5F}" type="sibTrans" cxnId="{31AD32E1-C5F3-41E2-8A34-FBA4D83488DD}">
      <dgm:prSet/>
      <dgm:spPr/>
      <dgm:t>
        <a:bodyPr/>
        <a:lstStyle/>
        <a:p>
          <a:endParaRPr lang="de-DE" sz="2000"/>
        </a:p>
      </dgm:t>
    </dgm:pt>
    <dgm:pt modelId="{0EF4F3AF-041E-4FDF-983F-FF187C733655}">
      <dgm:prSet phldrT="[Text]" custT="1"/>
      <dgm:spPr/>
      <dgm:t>
        <a:bodyPr/>
        <a:lstStyle/>
        <a:p>
          <a:r>
            <a:rPr lang="de-DE" sz="1050">
              <a:latin typeface="Times New Roman" panose="02020603050405020304" pitchFamily="18" charset="0"/>
              <a:cs typeface="Times New Roman" panose="02020603050405020304" pitchFamily="18" charset="0"/>
            </a:rPr>
            <a:t>Gesundheitssystem/-versorgung</a:t>
          </a:r>
        </a:p>
      </dgm:t>
    </dgm:pt>
    <dgm:pt modelId="{1A36E4A0-3C95-4A7E-8403-6FC00333987E}" type="parTrans" cxnId="{3160B13C-405E-4042-9A63-BD2CD7CB824F}">
      <dgm:prSet custT="1"/>
      <dgm:spPr/>
      <dgm:t>
        <a:bodyPr/>
        <a:lstStyle/>
        <a:p>
          <a:endParaRPr lang="de-DE" sz="110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F28EBEB7-D767-4F82-B6D2-883ABD1AD9BF}" type="sibTrans" cxnId="{3160B13C-405E-4042-9A63-BD2CD7CB824F}">
      <dgm:prSet/>
      <dgm:spPr/>
      <dgm:t>
        <a:bodyPr/>
        <a:lstStyle/>
        <a:p>
          <a:endParaRPr lang="de-DE" sz="2000"/>
        </a:p>
      </dgm:t>
    </dgm:pt>
    <dgm:pt modelId="{85CA1953-8DEE-44BB-BE58-B97A59C65C13}">
      <dgm:prSet phldrT="[Text]" custT="1"/>
      <dgm:spPr/>
      <dgm:t>
        <a:bodyPr/>
        <a:lstStyle/>
        <a:p>
          <a:r>
            <a:rPr lang="de-DE" sz="1050">
              <a:latin typeface="Times New Roman" panose="02020603050405020304" pitchFamily="18" charset="0"/>
              <a:cs typeface="Times New Roman" panose="02020603050405020304" pitchFamily="18" charset="0"/>
            </a:rPr>
            <a:t>Ausstattung des Gesundheitssystems</a:t>
          </a:r>
        </a:p>
      </dgm:t>
    </dgm:pt>
    <dgm:pt modelId="{425A3179-1413-4460-9678-40448B2E5A42}" type="parTrans" cxnId="{A3337F8B-F6A7-4497-AF59-193A5BC380DA}">
      <dgm:prSet custT="1"/>
      <dgm:spPr/>
      <dgm:t>
        <a:bodyPr/>
        <a:lstStyle/>
        <a:p>
          <a:endParaRPr lang="de-DE" sz="110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80DB0B72-C4D4-4215-94FF-91C54AF93D83}" type="sibTrans" cxnId="{A3337F8B-F6A7-4497-AF59-193A5BC380DA}">
      <dgm:prSet/>
      <dgm:spPr/>
      <dgm:t>
        <a:bodyPr/>
        <a:lstStyle/>
        <a:p>
          <a:endParaRPr lang="de-DE" sz="2000"/>
        </a:p>
      </dgm:t>
    </dgm:pt>
    <dgm:pt modelId="{41D6EC2F-3103-40F0-AD9A-B96A94477A77}">
      <dgm:prSet phldrT="[Text]" custT="1"/>
      <dgm:spPr/>
      <dgm:t>
        <a:bodyPr/>
        <a:lstStyle/>
        <a:p>
          <a:r>
            <a:rPr lang="de-DE" sz="1050">
              <a:latin typeface="Times New Roman" panose="02020603050405020304" pitchFamily="18" charset="0"/>
              <a:cs typeface="Times New Roman" panose="02020603050405020304" pitchFamily="18" charset="0"/>
            </a:rPr>
            <a:t>Personenbezogene Maßnahmen</a:t>
          </a:r>
        </a:p>
      </dgm:t>
    </dgm:pt>
    <dgm:pt modelId="{21F29C5E-B439-428D-89D6-0B6C5058BC6D}" type="parTrans" cxnId="{4644454E-788A-4ECC-A1B6-1ECB4780A87E}">
      <dgm:prSet custT="1"/>
      <dgm:spPr/>
      <dgm:t>
        <a:bodyPr/>
        <a:lstStyle/>
        <a:p>
          <a:endParaRPr lang="de-DE" sz="110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6A310679-E6DA-4236-BE0A-D973336D0C61}" type="sibTrans" cxnId="{4644454E-788A-4ECC-A1B6-1ECB4780A87E}">
      <dgm:prSet/>
      <dgm:spPr/>
      <dgm:t>
        <a:bodyPr/>
        <a:lstStyle/>
        <a:p>
          <a:endParaRPr lang="de-DE" sz="2000"/>
        </a:p>
      </dgm:t>
    </dgm:pt>
    <dgm:pt modelId="{F576FE14-F223-4751-B256-BF313602C91E}">
      <dgm:prSet phldrT="[Text]" custT="1"/>
      <dgm:spPr/>
      <dgm:t>
        <a:bodyPr/>
        <a:lstStyle/>
        <a:p>
          <a:r>
            <a:rPr lang="de-DE" sz="1050">
              <a:latin typeface="Times New Roman" panose="02020603050405020304" pitchFamily="18" charset="0"/>
              <a:cs typeface="Times New Roman" panose="02020603050405020304" pitchFamily="18" charset="0"/>
            </a:rPr>
            <a:t>Maßnahmen im öffentlichen Bereich</a:t>
          </a:r>
        </a:p>
      </dgm:t>
    </dgm:pt>
    <dgm:pt modelId="{760F7733-46EF-4539-A2FB-454CD8F95E50}" type="parTrans" cxnId="{22468D87-9E8B-4AC0-A1D8-F0624582D39C}">
      <dgm:prSet custT="1"/>
      <dgm:spPr/>
      <dgm:t>
        <a:bodyPr/>
        <a:lstStyle/>
        <a:p>
          <a:endParaRPr lang="de-DE" sz="110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014EF3D8-71ED-448E-95E6-C5CAB103F661}" type="sibTrans" cxnId="{22468D87-9E8B-4AC0-A1D8-F0624582D39C}">
      <dgm:prSet/>
      <dgm:spPr/>
      <dgm:t>
        <a:bodyPr/>
        <a:lstStyle/>
        <a:p>
          <a:endParaRPr lang="de-DE" sz="2000"/>
        </a:p>
      </dgm:t>
    </dgm:pt>
    <dgm:pt modelId="{B18AAAC7-07A3-44B8-A053-45D1FF816FFD}">
      <dgm:prSet phldrT="[Text]" custT="1"/>
      <dgm:spPr/>
      <dgm:t>
        <a:bodyPr/>
        <a:lstStyle/>
        <a:p>
          <a:r>
            <a:rPr lang="de-DE" sz="1050">
              <a:latin typeface="Times New Roman" panose="02020603050405020304" pitchFamily="18" charset="0"/>
              <a:cs typeface="Times New Roman" panose="02020603050405020304" pitchFamily="18" charset="0"/>
            </a:rPr>
            <a:t>Einschränkung der Bewegungsfreiheit</a:t>
          </a:r>
        </a:p>
      </dgm:t>
    </dgm:pt>
    <dgm:pt modelId="{F79E2E4E-D09E-4761-9D42-D0B633170619}" type="parTrans" cxnId="{CF4E620A-9AD3-4C56-8996-7BC265D0C439}">
      <dgm:prSet custT="1"/>
      <dgm:spPr/>
      <dgm:t>
        <a:bodyPr/>
        <a:lstStyle/>
        <a:p>
          <a:endParaRPr lang="de-DE" sz="110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72E1387F-70BB-477C-B1AA-2ABCDA2AC2A1}" type="sibTrans" cxnId="{CF4E620A-9AD3-4C56-8996-7BC265D0C439}">
      <dgm:prSet/>
      <dgm:spPr/>
      <dgm:t>
        <a:bodyPr/>
        <a:lstStyle/>
        <a:p>
          <a:endParaRPr lang="de-DE" sz="2000"/>
        </a:p>
      </dgm:t>
    </dgm:pt>
    <dgm:pt modelId="{E7091F61-EB43-4F07-B67B-2EE2EED76652}">
      <dgm:prSet phldrT="[Text]" custT="1"/>
      <dgm:spPr/>
      <dgm:t>
        <a:bodyPr/>
        <a:lstStyle/>
        <a:p>
          <a:r>
            <a:rPr lang="de-DE" sz="1050">
              <a:latin typeface="Times New Roman" panose="02020603050405020304" pitchFamily="18" charset="0"/>
              <a:cs typeface="Times New Roman" panose="02020603050405020304" pitchFamily="18" charset="0"/>
            </a:rPr>
            <a:t>Schutz</a:t>
          </a:r>
        </a:p>
      </dgm:t>
    </dgm:pt>
    <dgm:pt modelId="{010FD920-EA56-439A-976D-37845A8E9EE8}" type="parTrans" cxnId="{CAFAE303-3DC3-4537-9772-86B9E5063BC8}">
      <dgm:prSet custT="1"/>
      <dgm:spPr/>
      <dgm:t>
        <a:bodyPr/>
        <a:lstStyle/>
        <a:p>
          <a:endParaRPr lang="de-DE" sz="110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E9EE7CCA-3E70-4442-89A7-97C9D193AFA2}" type="sibTrans" cxnId="{CAFAE303-3DC3-4537-9772-86B9E5063BC8}">
      <dgm:prSet/>
      <dgm:spPr/>
      <dgm:t>
        <a:bodyPr/>
        <a:lstStyle/>
        <a:p>
          <a:endParaRPr lang="de-DE" sz="2000"/>
        </a:p>
      </dgm:t>
    </dgm:pt>
    <dgm:pt modelId="{8598F285-6469-41DF-8C80-D94935C42364}">
      <dgm:prSet phldrT="[Text]" custT="1"/>
      <dgm:spPr/>
      <dgm:t>
        <a:bodyPr/>
        <a:lstStyle/>
        <a:p>
          <a:r>
            <a:rPr lang="de-DE" sz="1050">
              <a:latin typeface="Times New Roman" panose="02020603050405020304" pitchFamily="18" charset="0"/>
              <a:cs typeface="Times New Roman" panose="02020603050405020304" pitchFamily="18" charset="0"/>
            </a:rPr>
            <a:t>Technologie</a:t>
          </a:r>
        </a:p>
      </dgm:t>
    </dgm:pt>
    <dgm:pt modelId="{2F8F9AB3-8452-43EC-87B2-17B5891BF608}" type="parTrans" cxnId="{A6C878B9-EBF4-42CF-95ED-C5FEAC6D408F}">
      <dgm:prSet custT="1"/>
      <dgm:spPr/>
      <dgm:t>
        <a:bodyPr/>
        <a:lstStyle/>
        <a:p>
          <a:endParaRPr lang="de-DE" sz="110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9ED8CEDE-19AD-4186-9063-3C72CFA86202}" type="sibTrans" cxnId="{A6C878B9-EBF4-42CF-95ED-C5FEAC6D408F}">
      <dgm:prSet/>
      <dgm:spPr/>
      <dgm:t>
        <a:bodyPr/>
        <a:lstStyle/>
        <a:p>
          <a:endParaRPr lang="de-DE" sz="2000"/>
        </a:p>
      </dgm:t>
    </dgm:pt>
    <dgm:pt modelId="{C8881E16-4787-451C-81F6-A6E1C5F25824}">
      <dgm:prSet phldrT="[Text]" custT="1"/>
      <dgm:spPr/>
      <dgm:t>
        <a:bodyPr/>
        <a:lstStyle/>
        <a:p>
          <a:r>
            <a:rPr lang="de-DE" sz="1050">
              <a:latin typeface="Times New Roman" panose="02020603050405020304" pitchFamily="18" charset="0"/>
              <a:cs typeface="Times New Roman" panose="02020603050405020304" pitchFamily="18" charset="0"/>
            </a:rPr>
            <a:t>Vertrauen</a:t>
          </a:r>
        </a:p>
      </dgm:t>
    </dgm:pt>
    <dgm:pt modelId="{AA6D12B2-DCA4-4A02-AF03-C8580B7BB7CB}" type="parTrans" cxnId="{05E2D8CA-3F04-43FA-A9A0-EFB380FF7C1A}">
      <dgm:prSet custT="1"/>
      <dgm:spPr/>
      <dgm:t>
        <a:bodyPr/>
        <a:lstStyle/>
        <a:p>
          <a:endParaRPr lang="de-DE" sz="110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69FD0CA8-8B7F-4C0A-B522-919D737E5030}" type="sibTrans" cxnId="{05E2D8CA-3F04-43FA-A9A0-EFB380FF7C1A}">
      <dgm:prSet/>
      <dgm:spPr/>
      <dgm:t>
        <a:bodyPr/>
        <a:lstStyle/>
        <a:p>
          <a:endParaRPr lang="de-DE" sz="2000"/>
        </a:p>
      </dgm:t>
    </dgm:pt>
    <dgm:pt modelId="{1AACD66D-838A-4857-A8DC-3EF6272EECE2}">
      <dgm:prSet phldrT="[Text]" custT="1"/>
      <dgm:spPr/>
      <dgm:t>
        <a:bodyPr/>
        <a:lstStyle/>
        <a:p>
          <a:r>
            <a:rPr lang="de-DE" sz="1050">
              <a:latin typeface="Times New Roman" panose="02020603050405020304" pitchFamily="18" charset="0"/>
              <a:cs typeface="Times New Roman" panose="02020603050405020304" pitchFamily="18" charset="0"/>
            </a:rPr>
            <a:t>Gewerkschaften und Industrie</a:t>
          </a:r>
        </a:p>
      </dgm:t>
    </dgm:pt>
    <dgm:pt modelId="{A7EB2E53-A0F7-41F9-9F6A-A28410E699DB}" type="parTrans" cxnId="{EE4DD132-A251-4BA5-8356-494F3570E984}">
      <dgm:prSet custT="1"/>
      <dgm:spPr/>
      <dgm:t>
        <a:bodyPr/>
        <a:lstStyle/>
        <a:p>
          <a:endParaRPr lang="de-DE" sz="110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ACD72424-B859-42FC-AD95-05CBCCEC32EB}" type="sibTrans" cxnId="{EE4DD132-A251-4BA5-8356-494F3570E984}">
      <dgm:prSet/>
      <dgm:spPr/>
      <dgm:t>
        <a:bodyPr/>
        <a:lstStyle/>
        <a:p>
          <a:endParaRPr lang="de-DE" sz="2000"/>
        </a:p>
      </dgm:t>
    </dgm:pt>
    <dgm:pt modelId="{4C4B97E3-F5BD-4198-B4CF-00796D7DABC4}">
      <dgm:prSet phldrT="[Text]" custT="1"/>
      <dgm:spPr/>
      <dgm:t>
        <a:bodyPr/>
        <a:lstStyle/>
        <a:p>
          <a:r>
            <a:rPr lang="de-DE" sz="1050">
              <a:latin typeface="Times New Roman" panose="02020603050405020304" pitchFamily="18" charset="0"/>
              <a:cs typeface="Times New Roman" panose="02020603050405020304" pitchFamily="18" charset="0"/>
            </a:rPr>
            <a:t>Reisen</a:t>
          </a:r>
        </a:p>
      </dgm:t>
    </dgm:pt>
    <dgm:pt modelId="{7D4974A8-D315-42CC-B9BB-A3A5CD5225A3}" type="parTrans" cxnId="{8B1F417C-D57E-4A5D-BE66-6CACFE4FD74B}">
      <dgm:prSet custT="1"/>
      <dgm:spPr/>
      <dgm:t>
        <a:bodyPr/>
        <a:lstStyle/>
        <a:p>
          <a:endParaRPr lang="de-DE" sz="110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2F5833B1-8B55-4651-83AB-AE1350EC55C1}" type="sibTrans" cxnId="{8B1F417C-D57E-4A5D-BE66-6CACFE4FD74B}">
      <dgm:prSet/>
      <dgm:spPr/>
      <dgm:t>
        <a:bodyPr/>
        <a:lstStyle/>
        <a:p>
          <a:endParaRPr lang="de-DE" sz="2000"/>
        </a:p>
      </dgm:t>
    </dgm:pt>
    <dgm:pt modelId="{139D31B5-E436-4EC0-97A7-7F66DB8AA5D7}">
      <dgm:prSet phldrT="[Text]" custT="1"/>
      <dgm:spPr/>
      <dgm:t>
        <a:bodyPr/>
        <a:lstStyle/>
        <a:p>
          <a:r>
            <a:rPr lang="de-DE" sz="1050">
              <a:latin typeface="Times New Roman" panose="02020603050405020304" pitchFamily="18" charset="0"/>
              <a:cs typeface="Times New Roman" panose="02020603050405020304" pitchFamily="18" charset="0"/>
            </a:rPr>
            <a:t>Umwelt</a:t>
          </a:r>
        </a:p>
      </dgm:t>
    </dgm:pt>
    <dgm:pt modelId="{AF9EC442-AE64-421C-9DF3-0ED0B18D4EC6}" type="parTrans" cxnId="{291F772C-20F4-4C15-B3EC-1E4FEB7684CE}">
      <dgm:prSet custT="1"/>
      <dgm:spPr/>
      <dgm:t>
        <a:bodyPr/>
        <a:lstStyle/>
        <a:p>
          <a:endParaRPr lang="de-DE" sz="110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12528D3C-0831-4D11-8576-30D0B612443D}" type="sibTrans" cxnId="{291F772C-20F4-4C15-B3EC-1E4FEB7684CE}">
      <dgm:prSet/>
      <dgm:spPr/>
      <dgm:t>
        <a:bodyPr/>
        <a:lstStyle/>
        <a:p>
          <a:endParaRPr lang="de-DE" sz="2000"/>
        </a:p>
      </dgm:t>
    </dgm:pt>
    <dgm:pt modelId="{1526BD2C-5491-407F-8729-1EE2B6B3A855}">
      <dgm:prSet phldrT="[Text]" custT="1"/>
      <dgm:spPr/>
      <dgm:t>
        <a:bodyPr/>
        <a:lstStyle/>
        <a:p>
          <a:r>
            <a:rPr lang="de-DE" sz="1050">
              <a:latin typeface="Times New Roman" panose="02020603050405020304" pitchFamily="18" charset="0"/>
              <a:cs typeface="Times New Roman" panose="02020603050405020304" pitchFamily="18" charset="0"/>
            </a:rPr>
            <a:t>Ungerechtigkeiten</a:t>
          </a:r>
        </a:p>
      </dgm:t>
    </dgm:pt>
    <dgm:pt modelId="{493FD3B1-4C0C-4AB6-93B7-144BA121C706}" type="parTrans" cxnId="{ABAF072D-729E-4B57-9163-D0065AEE9336}">
      <dgm:prSet custT="1"/>
      <dgm:spPr/>
      <dgm:t>
        <a:bodyPr/>
        <a:lstStyle/>
        <a:p>
          <a:endParaRPr lang="de-DE" sz="110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43AD28CE-0CF1-43EF-A291-AAB3F34ECA2E}" type="sibTrans" cxnId="{ABAF072D-729E-4B57-9163-D0065AEE9336}">
      <dgm:prSet/>
      <dgm:spPr/>
      <dgm:t>
        <a:bodyPr/>
        <a:lstStyle/>
        <a:p>
          <a:endParaRPr lang="de-DE" sz="2000"/>
        </a:p>
      </dgm:t>
    </dgm:pt>
    <dgm:pt modelId="{0427F775-9407-4A06-A301-D22BFE5F9A2F}">
      <dgm:prSet phldrT="[Text]" custT="1"/>
      <dgm:spPr/>
      <dgm:t>
        <a:bodyPr/>
        <a:lstStyle/>
        <a:p>
          <a:r>
            <a:rPr lang="de-DE" sz="1050">
              <a:latin typeface="Times New Roman" panose="02020603050405020304" pitchFamily="18" charset="0"/>
              <a:cs typeface="Times New Roman" panose="02020603050405020304" pitchFamily="18" charset="0"/>
            </a:rPr>
            <a:t>Zivile Unruhen</a:t>
          </a:r>
        </a:p>
      </dgm:t>
    </dgm:pt>
    <dgm:pt modelId="{064DB9D2-173A-4CFB-BE23-C2F5395E90CE}" type="parTrans" cxnId="{234F9010-5139-42E0-80F6-0F2D307A11F3}">
      <dgm:prSet custT="1"/>
      <dgm:spPr/>
      <dgm:t>
        <a:bodyPr/>
        <a:lstStyle/>
        <a:p>
          <a:endParaRPr lang="de-DE" sz="110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284BA064-CA16-40B8-ABB6-39297C736969}" type="sibTrans" cxnId="{234F9010-5139-42E0-80F6-0F2D307A11F3}">
      <dgm:prSet/>
      <dgm:spPr/>
      <dgm:t>
        <a:bodyPr/>
        <a:lstStyle/>
        <a:p>
          <a:endParaRPr lang="de-DE" sz="2000"/>
        </a:p>
      </dgm:t>
    </dgm:pt>
    <dgm:pt modelId="{89246641-77CD-487A-83F2-C7F1200B9CD3}">
      <dgm:prSet phldrT="[Text]" custT="1"/>
      <dgm:spPr/>
      <dgm:t>
        <a:bodyPr/>
        <a:lstStyle/>
        <a:p>
          <a:r>
            <a:rPr lang="de-DE" sz="1050">
              <a:latin typeface="Times New Roman" panose="02020603050405020304" pitchFamily="18" charset="0"/>
              <a:cs typeface="Times New Roman" panose="02020603050405020304" pitchFamily="18" charset="0"/>
            </a:rPr>
            <a:t>Statistiken und Daten</a:t>
          </a:r>
        </a:p>
      </dgm:t>
    </dgm:pt>
    <dgm:pt modelId="{2A9BE497-61AC-492C-9E1D-96073DB72DE2}" type="parTrans" cxnId="{171C8B0C-881B-4B3B-894B-FD7D7E222816}">
      <dgm:prSet custT="1"/>
      <dgm:spPr/>
      <dgm:t>
        <a:bodyPr/>
        <a:lstStyle/>
        <a:p>
          <a:endParaRPr lang="de-DE" sz="110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8FE26FC0-4536-4E72-BA73-6E6DB87FDB86}" type="sibTrans" cxnId="{171C8B0C-881B-4B3B-894B-FD7D7E222816}">
      <dgm:prSet/>
      <dgm:spPr/>
      <dgm:t>
        <a:bodyPr/>
        <a:lstStyle/>
        <a:p>
          <a:endParaRPr lang="de-DE" sz="2000"/>
        </a:p>
      </dgm:t>
    </dgm:pt>
    <dgm:pt modelId="{6125DCFA-27DB-435B-BEA4-88B2190500A1}">
      <dgm:prSet phldrT="[Text]" custT="1"/>
      <dgm:spPr/>
      <dgm:t>
        <a:bodyPr/>
        <a:lstStyle/>
        <a:p>
          <a:r>
            <a:rPr lang="de-DE" sz="1050" err="1">
              <a:latin typeface="Times New Roman" panose="02020603050405020304" pitchFamily="18" charset="0"/>
              <a:cs typeface="Times New Roman" panose="02020603050405020304" pitchFamily="18" charset="0"/>
            </a:rPr>
            <a:t>Mis</a:t>
          </a:r>
          <a:r>
            <a:rPr lang="de-DE" sz="1050">
              <a:latin typeface="Times New Roman" panose="02020603050405020304" pitchFamily="18" charset="0"/>
              <a:cs typeface="Times New Roman" panose="02020603050405020304" pitchFamily="18" charset="0"/>
            </a:rPr>
            <a:t>- und </a:t>
          </a:r>
          <a:r>
            <a:rPr lang="de-DE" sz="1050" err="1">
              <a:latin typeface="Times New Roman" panose="02020603050405020304" pitchFamily="18" charset="0"/>
              <a:cs typeface="Times New Roman" panose="02020603050405020304" pitchFamily="18" charset="0"/>
            </a:rPr>
            <a:t>Disinformationen</a:t>
          </a:r>
          <a:endParaRPr lang="de-DE" sz="105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1A98DB96-17DF-475F-B57D-AA7AEC31238C}" type="parTrans" cxnId="{225F28E9-5723-4F77-9501-13923EB7D7AE}">
      <dgm:prSet custT="1"/>
      <dgm:spPr/>
      <dgm:t>
        <a:bodyPr/>
        <a:lstStyle/>
        <a:p>
          <a:endParaRPr lang="de-DE" sz="110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514F69F3-BA1B-4306-A43E-9B675BA1B5FC}" type="sibTrans" cxnId="{225F28E9-5723-4F77-9501-13923EB7D7AE}">
      <dgm:prSet/>
      <dgm:spPr/>
      <dgm:t>
        <a:bodyPr/>
        <a:lstStyle/>
        <a:p>
          <a:endParaRPr lang="de-DE" sz="2000"/>
        </a:p>
      </dgm:t>
    </dgm:pt>
    <dgm:pt modelId="{B87C2DC1-653F-4929-9260-6C6E30534E07}">
      <dgm:prSet phldrT="[Text]" custT="1"/>
      <dgm:spPr/>
      <dgm:t>
        <a:bodyPr/>
        <a:lstStyle/>
        <a:p>
          <a:r>
            <a:rPr lang="de-DE" sz="1050">
              <a:latin typeface="Times New Roman" panose="02020603050405020304" pitchFamily="18" charset="0"/>
              <a:cs typeface="Times New Roman" panose="02020603050405020304" pitchFamily="18" charset="0"/>
            </a:rPr>
            <a:t>Vulnerable Gemeinschaften</a:t>
          </a:r>
        </a:p>
      </dgm:t>
    </dgm:pt>
    <dgm:pt modelId="{3B2039F4-2BA1-4802-A7AA-25308413273C}" type="parTrans" cxnId="{A9302518-6ADB-4EFD-9798-25FD8FC5D3C1}">
      <dgm:prSet custT="1"/>
      <dgm:spPr/>
      <dgm:t>
        <a:bodyPr/>
        <a:lstStyle/>
        <a:p>
          <a:endParaRPr lang="de-DE" sz="80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D969B3C1-13FB-4D01-8F61-046C91361577}" type="sibTrans" cxnId="{A9302518-6ADB-4EFD-9798-25FD8FC5D3C1}">
      <dgm:prSet/>
      <dgm:spPr/>
      <dgm:t>
        <a:bodyPr/>
        <a:lstStyle/>
        <a:p>
          <a:endParaRPr lang="de-DE" sz="2000"/>
        </a:p>
      </dgm:t>
    </dgm:pt>
    <dgm:pt modelId="{ECD62ED1-5D11-481E-9BBC-AB020A2EFAFF}">
      <dgm:prSet phldrT="[Text]" custT="1"/>
      <dgm:spPr/>
      <dgm:t>
        <a:bodyPr/>
        <a:lstStyle/>
        <a:p>
          <a:r>
            <a:rPr lang="de-DE" sz="1050">
              <a:latin typeface="Times New Roman" panose="02020603050405020304" pitchFamily="18" charset="0"/>
              <a:cs typeface="Times New Roman" panose="02020603050405020304" pitchFamily="18" charset="0"/>
            </a:rPr>
            <a:t>Impfungen</a:t>
          </a:r>
        </a:p>
      </dgm:t>
    </dgm:pt>
    <dgm:pt modelId="{0CC02BC8-A818-4832-81BB-32F3133B8621}" type="parTrans" cxnId="{3D343B8B-1248-4DFE-8A34-AF4186B05CDE}">
      <dgm:prSet custT="1"/>
      <dgm:spPr/>
      <dgm:t>
        <a:bodyPr/>
        <a:lstStyle/>
        <a:p>
          <a:endParaRPr lang="de-DE" sz="80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94E1BBA4-DAA9-4674-B28C-E8D1C76D9ED9}" type="sibTrans" cxnId="{3D343B8B-1248-4DFE-8A34-AF4186B05CDE}">
      <dgm:prSet/>
      <dgm:spPr/>
      <dgm:t>
        <a:bodyPr/>
        <a:lstStyle/>
        <a:p>
          <a:endParaRPr lang="de-DE" sz="2000"/>
        </a:p>
      </dgm:t>
    </dgm:pt>
    <dgm:pt modelId="{4A87926E-2F89-4541-AD41-F858508AC316}" type="pres">
      <dgm:prSet presAssocID="{C256443A-5739-41C3-976C-086C241C3437}" presName="diagram" presStyleCnt="0">
        <dgm:presLayoutVars>
          <dgm:chPref val="1"/>
          <dgm:dir/>
          <dgm:animOne val="branch"/>
          <dgm:animLvl val="lvl"/>
          <dgm:resizeHandles val="exact"/>
        </dgm:presLayoutVars>
      </dgm:prSet>
      <dgm:spPr/>
    </dgm:pt>
    <dgm:pt modelId="{D0337419-FCAE-4D52-B05C-516C20818889}" type="pres">
      <dgm:prSet presAssocID="{353C6F70-9685-47CA-B6F4-8BAAB244C13E}" presName="root1" presStyleCnt="0"/>
      <dgm:spPr/>
    </dgm:pt>
    <dgm:pt modelId="{F78A7B94-B816-41D1-873A-8D5A3EB8CC40}" type="pres">
      <dgm:prSet presAssocID="{353C6F70-9685-47CA-B6F4-8BAAB244C13E}" presName="LevelOneTextNode" presStyleLbl="node0" presStyleIdx="0" presStyleCnt="1" custScaleX="761268" custScaleY="2000000" custLinFactX="-4345567" custLinFactY="63157" custLinFactNeighborX="-4400000" custLinFactNeighborY="100000">
        <dgm:presLayoutVars>
          <dgm:chPref val="3"/>
        </dgm:presLayoutVars>
      </dgm:prSet>
      <dgm:spPr/>
    </dgm:pt>
    <dgm:pt modelId="{457B3FD6-8EF7-4A94-BB29-C9471CDE92CD}" type="pres">
      <dgm:prSet presAssocID="{353C6F70-9685-47CA-B6F4-8BAAB244C13E}" presName="level2hierChild" presStyleCnt="0"/>
      <dgm:spPr/>
    </dgm:pt>
    <dgm:pt modelId="{2F7D4346-F118-454B-9AAD-5BD4A706F402}" type="pres">
      <dgm:prSet presAssocID="{F855B30C-366F-4036-B5AE-48974C07A80E}" presName="conn2-1" presStyleLbl="parChTrans1D2" presStyleIdx="0" presStyleCnt="5" custSzX="14400010"/>
      <dgm:spPr/>
    </dgm:pt>
    <dgm:pt modelId="{8E782F7D-B5EB-45C3-8750-549909A533F3}" type="pres">
      <dgm:prSet presAssocID="{F855B30C-366F-4036-B5AE-48974C07A80E}" presName="connTx" presStyleLbl="parChTrans1D2" presStyleIdx="0" presStyleCnt="5"/>
      <dgm:spPr/>
    </dgm:pt>
    <dgm:pt modelId="{D988932E-C931-4512-A8F2-C38E4F67EB7D}" type="pres">
      <dgm:prSet presAssocID="{5E805EC3-C58D-4BD5-A99E-B5CA51F30872}" presName="root2" presStyleCnt="0"/>
      <dgm:spPr/>
    </dgm:pt>
    <dgm:pt modelId="{430F15C4-6A15-46B0-808C-1CBD7A4F9165}" type="pres">
      <dgm:prSet presAssocID="{5E805EC3-C58D-4BD5-A99E-B5CA51F30872}" presName="LevelTwoTextNode" presStyleLbl="node2" presStyleIdx="0" presStyleCnt="5" custScaleX="1120331" custScaleY="716455" custLinFactX="-1100000" custLinFactY="230992" custLinFactNeighborX="-1100867" custLinFactNeighborY="300000">
        <dgm:presLayoutVars>
          <dgm:chPref val="3"/>
        </dgm:presLayoutVars>
      </dgm:prSet>
      <dgm:spPr/>
    </dgm:pt>
    <dgm:pt modelId="{A62861FB-C1E1-4913-99BB-D18D0BA7EF62}" type="pres">
      <dgm:prSet presAssocID="{5E805EC3-C58D-4BD5-A99E-B5CA51F30872}" presName="level3hierChild" presStyleCnt="0"/>
      <dgm:spPr/>
    </dgm:pt>
    <dgm:pt modelId="{4838F315-A0EB-4974-8233-371CFFCC1CE4}" type="pres">
      <dgm:prSet presAssocID="{C09B2D6A-14B0-4151-BFD3-E21110A5E135}" presName="conn2-1" presStyleLbl="parChTrans1D3" presStyleIdx="0" presStyleCnt="29" custSzX="14400073"/>
      <dgm:spPr/>
    </dgm:pt>
    <dgm:pt modelId="{E36F28F1-4932-4D2B-B680-9D2F1B515793}" type="pres">
      <dgm:prSet presAssocID="{C09B2D6A-14B0-4151-BFD3-E21110A5E135}" presName="connTx" presStyleLbl="parChTrans1D3" presStyleIdx="0" presStyleCnt="29"/>
      <dgm:spPr/>
    </dgm:pt>
    <dgm:pt modelId="{DDFF5742-CF69-471F-841B-FF79B1E24A3C}" type="pres">
      <dgm:prSet presAssocID="{3A98E99E-5EB9-499E-9929-61172C5675F2}" presName="root2" presStyleCnt="0"/>
      <dgm:spPr/>
    </dgm:pt>
    <dgm:pt modelId="{0B80F301-D09A-4FB6-916E-CECF32B2F143}" type="pres">
      <dgm:prSet presAssocID="{3A98E99E-5EB9-499E-9929-61172C5675F2}" presName="LevelTwoTextNode" presStyleLbl="node3" presStyleIdx="0" presStyleCnt="29" custScaleX="1556230" custScaleY="323249" custLinFactX="-727841" custLinFactY="199459" custLinFactNeighborX="-800000" custLinFactNeighborY="200000">
        <dgm:presLayoutVars>
          <dgm:chPref val="3"/>
        </dgm:presLayoutVars>
      </dgm:prSet>
      <dgm:spPr/>
    </dgm:pt>
    <dgm:pt modelId="{01C225FF-8339-4AED-93A9-27AB32E3DF0B}" type="pres">
      <dgm:prSet presAssocID="{3A98E99E-5EB9-499E-9929-61172C5675F2}" presName="level3hierChild" presStyleCnt="0"/>
      <dgm:spPr/>
    </dgm:pt>
    <dgm:pt modelId="{750F2EA3-C6A2-49D8-A4E9-ECB36FFC366E}" type="pres">
      <dgm:prSet presAssocID="{8C8C0F98-AF8B-47BC-ACBA-EC4EA96F1883}" presName="conn2-1" presStyleLbl="parChTrans1D3" presStyleIdx="1" presStyleCnt="29" custSzX="14400096"/>
      <dgm:spPr/>
    </dgm:pt>
    <dgm:pt modelId="{066D82E6-DD7A-4789-BA1F-74B091D397C9}" type="pres">
      <dgm:prSet presAssocID="{8C8C0F98-AF8B-47BC-ACBA-EC4EA96F1883}" presName="connTx" presStyleLbl="parChTrans1D3" presStyleIdx="1" presStyleCnt="29"/>
      <dgm:spPr/>
    </dgm:pt>
    <dgm:pt modelId="{D3F69F3A-148E-4673-B1FF-6A8AC1FE2DCE}" type="pres">
      <dgm:prSet presAssocID="{358A984D-84A8-4882-B614-7818D9052477}" presName="root2" presStyleCnt="0"/>
      <dgm:spPr/>
    </dgm:pt>
    <dgm:pt modelId="{70A6C9AF-4497-49E2-8F6B-4022C002A32C}" type="pres">
      <dgm:prSet presAssocID="{358A984D-84A8-4882-B614-7818D9052477}" presName="LevelTwoTextNode" presStyleLbl="node3" presStyleIdx="1" presStyleCnt="29" custScaleX="1556230" custScaleY="320238" custLinFactX="-736728" custLinFactY="200000" custLinFactNeighborX="-800000" custLinFactNeighborY="242503">
        <dgm:presLayoutVars>
          <dgm:chPref val="3"/>
        </dgm:presLayoutVars>
      </dgm:prSet>
      <dgm:spPr/>
    </dgm:pt>
    <dgm:pt modelId="{75CD52C9-9125-48F6-9D99-712D3BC58122}" type="pres">
      <dgm:prSet presAssocID="{358A984D-84A8-4882-B614-7818D9052477}" presName="level3hierChild" presStyleCnt="0"/>
      <dgm:spPr/>
    </dgm:pt>
    <dgm:pt modelId="{B99573E9-A46B-4C67-A741-44E4FCB4FC8A}" type="pres">
      <dgm:prSet presAssocID="{1731A452-294D-4C69-97EA-ABFB841FA0AB}" presName="conn2-1" presStyleLbl="parChTrans1D3" presStyleIdx="2" presStyleCnt="29" custSzX="14400130"/>
      <dgm:spPr/>
    </dgm:pt>
    <dgm:pt modelId="{AAEF59AE-AA15-4AA2-AEAA-A4784793DDE5}" type="pres">
      <dgm:prSet presAssocID="{1731A452-294D-4C69-97EA-ABFB841FA0AB}" presName="connTx" presStyleLbl="parChTrans1D3" presStyleIdx="2" presStyleCnt="29"/>
      <dgm:spPr/>
    </dgm:pt>
    <dgm:pt modelId="{7019262D-F9E7-43D3-B6F1-BE5C8FC760AB}" type="pres">
      <dgm:prSet presAssocID="{4C9D4A9F-DD4B-450F-BD60-CED00D3393A2}" presName="root2" presStyleCnt="0"/>
      <dgm:spPr/>
    </dgm:pt>
    <dgm:pt modelId="{049F2968-73E2-4348-A8D7-E885F2B2F00E}" type="pres">
      <dgm:prSet presAssocID="{4C9D4A9F-DD4B-450F-BD60-CED00D3393A2}" presName="LevelTwoTextNode" presStyleLbl="node3" presStyleIdx="2" presStyleCnt="29" custAng="10800000" custFlipVert="1" custScaleX="1556230" custScaleY="323249" custLinFactX="-731296" custLinFactY="200000" custLinFactNeighborX="-800000" custLinFactNeighborY="298507">
        <dgm:presLayoutVars>
          <dgm:chPref val="3"/>
        </dgm:presLayoutVars>
      </dgm:prSet>
      <dgm:spPr/>
    </dgm:pt>
    <dgm:pt modelId="{9CD1B84C-59C7-4394-B671-9D4A34E2A244}" type="pres">
      <dgm:prSet presAssocID="{4C9D4A9F-DD4B-450F-BD60-CED00D3393A2}" presName="level3hierChild" presStyleCnt="0"/>
      <dgm:spPr/>
    </dgm:pt>
    <dgm:pt modelId="{6C074D18-1EA0-40FB-94A6-DD4C52B7D46C}" type="pres">
      <dgm:prSet presAssocID="{84547787-FAB0-4D90-A3B1-62ECE02E3768}" presName="conn2-1" presStyleLbl="parChTrans1D2" presStyleIdx="1" presStyleCnt="5" custSzX="14400019"/>
      <dgm:spPr/>
    </dgm:pt>
    <dgm:pt modelId="{740522B2-75E3-4986-BE71-6201CAF74879}" type="pres">
      <dgm:prSet presAssocID="{84547787-FAB0-4D90-A3B1-62ECE02E3768}" presName="connTx" presStyleLbl="parChTrans1D2" presStyleIdx="1" presStyleCnt="5"/>
      <dgm:spPr/>
    </dgm:pt>
    <dgm:pt modelId="{923ABA98-7991-407C-B596-10BA5F513C20}" type="pres">
      <dgm:prSet presAssocID="{5BEDA607-8DED-42F2-9BA0-692D403C0EC7}" presName="root2" presStyleCnt="0"/>
      <dgm:spPr/>
    </dgm:pt>
    <dgm:pt modelId="{3B5C04C0-1026-4BCC-B8D1-09CC708E27EF}" type="pres">
      <dgm:prSet presAssocID="{5BEDA607-8DED-42F2-9BA0-692D403C0EC7}" presName="LevelTwoTextNode" presStyleLbl="node2" presStyleIdx="1" presStyleCnt="5" custScaleX="1120331" custScaleY="716455" custLinFactX="-1100000" custLinFactY="200000" custLinFactNeighborX="-1117350" custLinFactNeighborY="264884">
        <dgm:presLayoutVars>
          <dgm:chPref val="3"/>
        </dgm:presLayoutVars>
      </dgm:prSet>
      <dgm:spPr/>
    </dgm:pt>
    <dgm:pt modelId="{63E65136-FB97-46CC-93F6-1E9121ADE6EE}" type="pres">
      <dgm:prSet presAssocID="{5BEDA607-8DED-42F2-9BA0-692D403C0EC7}" presName="level3hierChild" presStyleCnt="0"/>
      <dgm:spPr/>
    </dgm:pt>
    <dgm:pt modelId="{1933032C-D9EF-4E95-9447-72395E90BD3C}" type="pres">
      <dgm:prSet presAssocID="{07D04FA9-5869-4D23-B691-B49B006E8BC9}" presName="conn2-1" presStyleLbl="parChTrans1D3" presStyleIdx="3" presStyleCnt="29" custSzX="14400014"/>
      <dgm:spPr/>
    </dgm:pt>
    <dgm:pt modelId="{DDA1B4D0-DAFF-4A7B-B757-2D0EB38A13A7}" type="pres">
      <dgm:prSet presAssocID="{07D04FA9-5869-4D23-B691-B49B006E8BC9}" presName="connTx" presStyleLbl="parChTrans1D3" presStyleIdx="3" presStyleCnt="29"/>
      <dgm:spPr/>
    </dgm:pt>
    <dgm:pt modelId="{658C8869-04C9-4951-AD31-366FF613DDA0}" type="pres">
      <dgm:prSet presAssocID="{26FE1203-5ADF-4E90-A8D9-0247D9F49394}" presName="root2" presStyleCnt="0"/>
      <dgm:spPr/>
    </dgm:pt>
    <dgm:pt modelId="{85D196B6-063E-44EA-88B6-502D03441A95}" type="pres">
      <dgm:prSet presAssocID="{26FE1203-5ADF-4E90-A8D9-0247D9F49394}" presName="LevelTwoTextNode" presStyleLbl="node3" presStyleIdx="3" presStyleCnt="29" custScaleX="1609839" custScaleY="350494" custLinFactX="559676" custLinFactY="100000" custLinFactNeighborX="600000" custLinFactNeighborY="196097">
        <dgm:presLayoutVars>
          <dgm:chPref val="3"/>
        </dgm:presLayoutVars>
      </dgm:prSet>
      <dgm:spPr/>
    </dgm:pt>
    <dgm:pt modelId="{6631D1CF-F995-496A-B550-A56FC7462583}" type="pres">
      <dgm:prSet presAssocID="{26FE1203-5ADF-4E90-A8D9-0247D9F49394}" presName="level3hierChild" presStyleCnt="0"/>
      <dgm:spPr/>
    </dgm:pt>
    <dgm:pt modelId="{39A8889A-DFEF-4793-B12D-3BA4A3083E3E}" type="pres">
      <dgm:prSet presAssocID="{03C2E030-813C-4887-94E5-82269C93F63C}" presName="conn2-1" presStyleLbl="parChTrans1D4" presStyleIdx="0" presStyleCnt="9" custSzX="14400012"/>
      <dgm:spPr/>
    </dgm:pt>
    <dgm:pt modelId="{993A1D06-E7B1-4637-8296-1DEAAA23799F}" type="pres">
      <dgm:prSet presAssocID="{03C2E030-813C-4887-94E5-82269C93F63C}" presName="connTx" presStyleLbl="parChTrans1D4" presStyleIdx="0" presStyleCnt="9"/>
      <dgm:spPr/>
    </dgm:pt>
    <dgm:pt modelId="{70EDD1C1-63F0-4263-8036-027FA4CD0523}" type="pres">
      <dgm:prSet presAssocID="{9A5197BB-7B1D-4DC8-A917-46D969DA792E}" presName="root2" presStyleCnt="0"/>
      <dgm:spPr/>
    </dgm:pt>
    <dgm:pt modelId="{29B3ABBF-0291-41BA-9070-E0CB070E1723}" type="pres">
      <dgm:prSet presAssocID="{9A5197BB-7B1D-4DC8-A917-46D969DA792E}" presName="LevelTwoTextNode" presStyleLbl="node4" presStyleIdx="0" presStyleCnt="9" custScaleX="1608267" custScaleY="350896" custLinFactX="1000000" custLinFactY="107292" custLinFactNeighborX="1081980" custLinFactNeighborY="200000">
        <dgm:presLayoutVars>
          <dgm:chPref val="3"/>
        </dgm:presLayoutVars>
      </dgm:prSet>
      <dgm:spPr/>
    </dgm:pt>
    <dgm:pt modelId="{FAA504E9-7E4D-4F77-A140-2ECF8E058BD1}" type="pres">
      <dgm:prSet presAssocID="{9A5197BB-7B1D-4DC8-A917-46D969DA792E}" presName="level3hierChild" presStyleCnt="0"/>
      <dgm:spPr/>
    </dgm:pt>
    <dgm:pt modelId="{16EDC4EB-15B1-4BED-A913-C4910A592E43}" type="pres">
      <dgm:prSet presAssocID="{D40E33C4-65A6-43F0-8A5A-668871AD40F3}" presName="conn2-1" presStyleLbl="parChTrans1D4" presStyleIdx="1" presStyleCnt="9" custSzX="14400063"/>
      <dgm:spPr/>
    </dgm:pt>
    <dgm:pt modelId="{16FE4A7B-83F7-4D09-B9FE-7AABA7BB071E}" type="pres">
      <dgm:prSet presAssocID="{D40E33C4-65A6-43F0-8A5A-668871AD40F3}" presName="connTx" presStyleLbl="parChTrans1D4" presStyleIdx="1" presStyleCnt="9"/>
      <dgm:spPr/>
    </dgm:pt>
    <dgm:pt modelId="{682C3E9E-A664-4AEB-98FA-7A56B9FCB066}" type="pres">
      <dgm:prSet presAssocID="{2F02F2CE-1BCD-446E-BECB-6973E7ACA9E4}" presName="root2" presStyleCnt="0"/>
      <dgm:spPr/>
    </dgm:pt>
    <dgm:pt modelId="{3D93AA13-F9BF-4516-9343-01C4FE687B9F}" type="pres">
      <dgm:prSet presAssocID="{2F02F2CE-1BCD-446E-BECB-6973E7ACA9E4}" presName="LevelTwoTextNode" presStyleLbl="node4" presStyleIdx="1" presStyleCnt="9" custScaleX="1608267" custScaleY="350895" custLinFactX="1000000" custLinFactY="127099" custLinFactNeighborX="1081980" custLinFactNeighborY="200000">
        <dgm:presLayoutVars>
          <dgm:chPref val="3"/>
        </dgm:presLayoutVars>
      </dgm:prSet>
      <dgm:spPr/>
    </dgm:pt>
    <dgm:pt modelId="{FA14F626-8A10-4F1C-A2B9-289709A47DFF}" type="pres">
      <dgm:prSet presAssocID="{2F02F2CE-1BCD-446E-BECB-6973E7ACA9E4}" presName="level3hierChild" presStyleCnt="0"/>
      <dgm:spPr/>
    </dgm:pt>
    <dgm:pt modelId="{BE69F2C5-1F16-4884-B39F-EE6B06025848}" type="pres">
      <dgm:prSet presAssocID="{BE23815E-A548-4C9A-9302-6B0219BE53D6}" presName="conn2-1" presStyleLbl="parChTrans1D3" presStyleIdx="4" presStyleCnt="29" custSzX="14400005"/>
      <dgm:spPr/>
    </dgm:pt>
    <dgm:pt modelId="{7095C669-4F3E-4E90-960F-1302F717ACD3}" type="pres">
      <dgm:prSet presAssocID="{BE23815E-A548-4C9A-9302-6B0219BE53D6}" presName="connTx" presStyleLbl="parChTrans1D3" presStyleIdx="4" presStyleCnt="29"/>
      <dgm:spPr/>
    </dgm:pt>
    <dgm:pt modelId="{FB910F99-8F7B-4955-BA14-D3CBD5F0BE0B}" type="pres">
      <dgm:prSet presAssocID="{9EEC29B6-B262-48C2-8C7F-8D2337E7AA42}" presName="root2" presStyleCnt="0"/>
      <dgm:spPr/>
    </dgm:pt>
    <dgm:pt modelId="{C631F0D8-FAAD-405A-A21C-737F0EB151CA}" type="pres">
      <dgm:prSet presAssocID="{9EEC29B6-B262-48C2-8C7F-8D2337E7AA42}" presName="LevelTwoTextNode" presStyleLbl="node3" presStyleIdx="4" presStyleCnt="29" custScaleX="1609839" custScaleY="350494" custLinFactX="563423" custLinFactY="179370" custLinFactNeighborX="600000" custLinFactNeighborY="200000">
        <dgm:presLayoutVars>
          <dgm:chPref val="3"/>
        </dgm:presLayoutVars>
      </dgm:prSet>
      <dgm:spPr/>
    </dgm:pt>
    <dgm:pt modelId="{FBF4A851-80A7-4420-B39A-AFC31A510810}" type="pres">
      <dgm:prSet presAssocID="{9EEC29B6-B262-48C2-8C7F-8D2337E7AA42}" presName="level3hierChild" presStyleCnt="0"/>
      <dgm:spPr/>
    </dgm:pt>
    <dgm:pt modelId="{8D2BE030-0831-42B2-98C2-0F6E87AD5B7D}" type="pres">
      <dgm:prSet presAssocID="{E8E96543-F299-474B-9FCF-7801EFC57576}" presName="conn2-1" presStyleLbl="parChTrans1D3" presStyleIdx="5" presStyleCnt="29" custSzX="14400009"/>
      <dgm:spPr/>
    </dgm:pt>
    <dgm:pt modelId="{778A5A6C-5BCE-43A2-9985-988597C18905}" type="pres">
      <dgm:prSet presAssocID="{E8E96543-F299-474B-9FCF-7801EFC57576}" presName="connTx" presStyleLbl="parChTrans1D3" presStyleIdx="5" presStyleCnt="29"/>
      <dgm:spPr/>
    </dgm:pt>
    <dgm:pt modelId="{32EA519B-D3EF-457A-9C5B-9E4A9B562622}" type="pres">
      <dgm:prSet presAssocID="{99F805CD-8B05-4B09-8106-E7D62662EFAB}" presName="root2" presStyleCnt="0"/>
      <dgm:spPr/>
    </dgm:pt>
    <dgm:pt modelId="{29EF756E-ED73-4753-83B6-EFB27D8AB242}" type="pres">
      <dgm:prSet presAssocID="{99F805CD-8B05-4B09-8106-E7D62662EFAB}" presName="LevelTwoTextNode" presStyleLbl="node3" presStyleIdx="5" presStyleCnt="29" custScaleX="1609839" custScaleY="350494" custLinFactX="565410" custLinFactY="200000" custLinFactNeighborX="600000" custLinFactNeighborY="245076">
        <dgm:presLayoutVars>
          <dgm:chPref val="3"/>
        </dgm:presLayoutVars>
      </dgm:prSet>
      <dgm:spPr/>
    </dgm:pt>
    <dgm:pt modelId="{B580F2EF-10D1-43DE-86DA-65887B64442D}" type="pres">
      <dgm:prSet presAssocID="{99F805CD-8B05-4B09-8106-E7D62662EFAB}" presName="level3hierChild" presStyleCnt="0"/>
      <dgm:spPr/>
    </dgm:pt>
    <dgm:pt modelId="{A20C5029-8277-4F52-A215-36A9DA1AB52E}" type="pres">
      <dgm:prSet presAssocID="{FB410C4C-ACA6-43C1-94D1-C7A844E0F3B3}" presName="conn2-1" presStyleLbl="parChTrans1D3" presStyleIdx="6" presStyleCnt="29" custSzX="14400016"/>
      <dgm:spPr/>
    </dgm:pt>
    <dgm:pt modelId="{B80DAFEB-A4DF-442E-B7BA-955CB74D383A}" type="pres">
      <dgm:prSet presAssocID="{FB410C4C-ACA6-43C1-94D1-C7A844E0F3B3}" presName="connTx" presStyleLbl="parChTrans1D3" presStyleIdx="6" presStyleCnt="29"/>
      <dgm:spPr/>
    </dgm:pt>
    <dgm:pt modelId="{00239F36-7CCC-4EC4-8664-6CDB34CC30AA}" type="pres">
      <dgm:prSet presAssocID="{518E9C13-B9BA-4F04-A7EC-F36C8D246639}" presName="root2" presStyleCnt="0"/>
      <dgm:spPr/>
    </dgm:pt>
    <dgm:pt modelId="{EC3C7E9C-DE6F-4CF5-B8A3-EB96093DECF2}" type="pres">
      <dgm:prSet presAssocID="{518E9C13-B9BA-4F04-A7EC-F36C8D246639}" presName="LevelTwoTextNode" presStyleLbl="node3" presStyleIdx="6" presStyleCnt="29" custScaleX="1609839" custScaleY="350494" custLinFactX="562247" custLinFactY="212255" custLinFactNeighborX="600000" custLinFactNeighborY="300000">
        <dgm:presLayoutVars>
          <dgm:chPref val="3"/>
        </dgm:presLayoutVars>
      </dgm:prSet>
      <dgm:spPr/>
    </dgm:pt>
    <dgm:pt modelId="{9547E60A-4616-40DD-BB3B-048D8FF09B27}" type="pres">
      <dgm:prSet presAssocID="{518E9C13-B9BA-4F04-A7EC-F36C8D246639}" presName="level3hierChild" presStyleCnt="0"/>
      <dgm:spPr/>
    </dgm:pt>
    <dgm:pt modelId="{FCAF4F74-DA65-4B57-BED5-BD3F26CA3653}" type="pres">
      <dgm:prSet presAssocID="{6F25122C-9DC2-4635-960D-7ABCFA19A050}" presName="conn2-1" presStyleLbl="parChTrans1D3" presStyleIdx="7" presStyleCnt="29" custSzX="14400014"/>
      <dgm:spPr/>
    </dgm:pt>
    <dgm:pt modelId="{58DDB727-F29C-4C9B-AF2C-EA0167F90FF0}" type="pres">
      <dgm:prSet presAssocID="{6F25122C-9DC2-4635-960D-7ABCFA19A050}" presName="connTx" presStyleLbl="parChTrans1D3" presStyleIdx="7" presStyleCnt="29"/>
      <dgm:spPr/>
    </dgm:pt>
    <dgm:pt modelId="{91501DD1-CFE9-4FBA-823D-10880E2002A9}" type="pres">
      <dgm:prSet presAssocID="{109BE932-8DDB-46FE-93F1-0C28F0100D1E}" presName="root2" presStyleCnt="0"/>
      <dgm:spPr/>
    </dgm:pt>
    <dgm:pt modelId="{963787CF-28FB-43DF-98C2-C462DE3D4B6D}" type="pres">
      <dgm:prSet presAssocID="{109BE932-8DDB-46FE-93F1-0C28F0100D1E}" presName="LevelTwoTextNode" presStyleLbl="node3" presStyleIdx="7" presStyleCnt="29" custScaleX="1609839" custScaleY="350494" custLinFactX="570286" custLinFactY="300000" custLinFactNeighborX="600000" custLinFactNeighborY="300747">
        <dgm:presLayoutVars>
          <dgm:chPref val="3"/>
        </dgm:presLayoutVars>
      </dgm:prSet>
      <dgm:spPr/>
    </dgm:pt>
    <dgm:pt modelId="{793CF8CB-4DC0-4A07-8366-31517125F577}" type="pres">
      <dgm:prSet presAssocID="{109BE932-8DDB-46FE-93F1-0C28F0100D1E}" presName="level3hierChild" presStyleCnt="0"/>
      <dgm:spPr/>
    </dgm:pt>
    <dgm:pt modelId="{52995CFF-A2C0-41A9-B8F6-E167247A0F1E}" type="pres">
      <dgm:prSet presAssocID="{C6A0CEB6-9E0F-4493-8DE5-DBE1EBED4241}" presName="conn2-1" presStyleLbl="parChTrans1D3" presStyleIdx="8" presStyleCnt="29" custSzX="14400013"/>
      <dgm:spPr/>
    </dgm:pt>
    <dgm:pt modelId="{363F3F8F-4CCA-4730-9344-E43FC3582DD0}" type="pres">
      <dgm:prSet presAssocID="{C6A0CEB6-9E0F-4493-8DE5-DBE1EBED4241}" presName="connTx" presStyleLbl="parChTrans1D3" presStyleIdx="8" presStyleCnt="29"/>
      <dgm:spPr/>
    </dgm:pt>
    <dgm:pt modelId="{539280CC-7E34-4575-8E03-0EE6EBFD0B7C}" type="pres">
      <dgm:prSet presAssocID="{F4B2B415-9F5D-4A5C-A517-33028F9EDE23}" presName="root2" presStyleCnt="0"/>
      <dgm:spPr/>
    </dgm:pt>
    <dgm:pt modelId="{15869452-7DB1-4E38-961A-AD18E7BF97A4}" type="pres">
      <dgm:prSet presAssocID="{F4B2B415-9F5D-4A5C-A517-33028F9EDE23}" presName="LevelTwoTextNode" presStyleLbl="node3" presStyleIdx="8" presStyleCnt="29" custScaleX="1609839" custScaleY="350494" custLinFactX="570609" custLinFactY="300000" custLinFactNeighborX="600000" custLinFactNeighborY="356097">
        <dgm:presLayoutVars>
          <dgm:chPref val="3"/>
        </dgm:presLayoutVars>
      </dgm:prSet>
      <dgm:spPr/>
    </dgm:pt>
    <dgm:pt modelId="{A67F4D00-5318-48B1-8F6F-4C6D0840EE34}" type="pres">
      <dgm:prSet presAssocID="{F4B2B415-9F5D-4A5C-A517-33028F9EDE23}" presName="level3hierChild" presStyleCnt="0"/>
      <dgm:spPr/>
    </dgm:pt>
    <dgm:pt modelId="{6DE65224-3B60-4229-ACDA-981AA44CA426}" type="pres">
      <dgm:prSet presAssocID="{CA6A9C70-223C-4BA6-B22F-E7EE9FCEF901}" presName="conn2-1" presStyleLbl="parChTrans1D4" presStyleIdx="2" presStyleCnt="9" custSzX="14400023"/>
      <dgm:spPr/>
    </dgm:pt>
    <dgm:pt modelId="{30A5F9D5-7BBD-431C-88C3-CC070B8111E2}" type="pres">
      <dgm:prSet presAssocID="{CA6A9C70-223C-4BA6-B22F-E7EE9FCEF901}" presName="connTx" presStyleLbl="parChTrans1D4" presStyleIdx="2" presStyleCnt="9"/>
      <dgm:spPr/>
    </dgm:pt>
    <dgm:pt modelId="{4C27843F-B856-4330-96BA-255D39C16F9A}" type="pres">
      <dgm:prSet presAssocID="{1BB53B11-3670-415B-805A-CE32EE8357FF}" presName="root2" presStyleCnt="0"/>
      <dgm:spPr/>
    </dgm:pt>
    <dgm:pt modelId="{D2E49161-A7B6-4759-AC1C-493631AA99EA}" type="pres">
      <dgm:prSet presAssocID="{1BB53B11-3670-415B-805A-CE32EE8357FF}" presName="LevelTwoTextNode" presStyleLbl="node4" presStyleIdx="2" presStyleCnt="9" custScaleX="1608267" custScaleY="350896" custLinFactX="1000000" custLinFactY="100000" custLinFactNeighborX="1081980" custLinFactNeighborY="169521">
        <dgm:presLayoutVars>
          <dgm:chPref val="3"/>
        </dgm:presLayoutVars>
      </dgm:prSet>
      <dgm:spPr/>
    </dgm:pt>
    <dgm:pt modelId="{B34508A2-9F6C-4930-976B-93634811EA5F}" type="pres">
      <dgm:prSet presAssocID="{1BB53B11-3670-415B-805A-CE32EE8357FF}" presName="level3hierChild" presStyleCnt="0"/>
      <dgm:spPr/>
    </dgm:pt>
    <dgm:pt modelId="{D3655785-2D54-4F59-9234-66AFAA7E681A}" type="pres">
      <dgm:prSet presAssocID="{6CF7CD4C-0917-44C0-B3FE-FDC2C5B2A919}" presName="conn2-1" presStyleLbl="parChTrans1D4" presStyleIdx="3" presStyleCnt="9" custSzX="14400042"/>
      <dgm:spPr/>
    </dgm:pt>
    <dgm:pt modelId="{9698C83B-59AA-460C-B76E-A13EFE8BCD17}" type="pres">
      <dgm:prSet presAssocID="{6CF7CD4C-0917-44C0-B3FE-FDC2C5B2A919}" presName="connTx" presStyleLbl="parChTrans1D4" presStyleIdx="3" presStyleCnt="9"/>
      <dgm:spPr/>
    </dgm:pt>
    <dgm:pt modelId="{1C087AE5-74C3-48F7-9B1F-7643819D62F7}" type="pres">
      <dgm:prSet presAssocID="{E2EBA384-91D3-4018-9EF6-F6F2CD249D13}" presName="root2" presStyleCnt="0"/>
      <dgm:spPr/>
    </dgm:pt>
    <dgm:pt modelId="{A26EDAF6-44C8-4854-8F91-1F5749D4DC73}" type="pres">
      <dgm:prSet presAssocID="{E2EBA384-91D3-4018-9EF6-F6F2CD249D13}" presName="LevelTwoTextNode" presStyleLbl="node4" presStyleIdx="3" presStyleCnt="9" custScaleX="1608267" custScaleY="350896" custLinFactX="1000000" custLinFactY="135259" custLinFactNeighborX="1081980" custLinFactNeighborY="200000">
        <dgm:presLayoutVars>
          <dgm:chPref val="3"/>
        </dgm:presLayoutVars>
      </dgm:prSet>
      <dgm:spPr/>
    </dgm:pt>
    <dgm:pt modelId="{E9A748F2-229D-45E3-B7F0-1D7693EBB797}" type="pres">
      <dgm:prSet presAssocID="{E2EBA384-91D3-4018-9EF6-F6F2CD249D13}" presName="level3hierChild" presStyleCnt="0"/>
      <dgm:spPr/>
    </dgm:pt>
    <dgm:pt modelId="{FB2F6D88-F506-4847-B326-8EC15F62040F}" type="pres">
      <dgm:prSet presAssocID="{539788D9-F5CD-499B-8EFE-4BDF10193421}" presName="conn2-1" presStyleLbl="parChTrans1D4" presStyleIdx="4" presStyleCnt="9" custSzX="14400018"/>
      <dgm:spPr/>
    </dgm:pt>
    <dgm:pt modelId="{5BC45E89-1EAB-43BA-B311-8A95F182C2C2}" type="pres">
      <dgm:prSet presAssocID="{539788D9-F5CD-499B-8EFE-4BDF10193421}" presName="connTx" presStyleLbl="parChTrans1D4" presStyleIdx="4" presStyleCnt="9"/>
      <dgm:spPr/>
    </dgm:pt>
    <dgm:pt modelId="{66D7E067-5337-459E-866E-2A8CE9CD2228}" type="pres">
      <dgm:prSet presAssocID="{CE4A4217-0410-4729-9337-C36C75DD601B}" presName="root2" presStyleCnt="0"/>
      <dgm:spPr/>
    </dgm:pt>
    <dgm:pt modelId="{4364814E-1DC4-41D8-96F5-7FCAA16DA2B0}" type="pres">
      <dgm:prSet presAssocID="{CE4A4217-0410-4729-9337-C36C75DD601B}" presName="LevelTwoTextNode" presStyleLbl="node4" presStyleIdx="4" presStyleCnt="9" custScaleX="1608267" custScaleY="350896" custLinFactX="1000000" custLinFactY="190074" custLinFactNeighborX="1081980" custLinFactNeighborY="200000">
        <dgm:presLayoutVars>
          <dgm:chPref val="3"/>
        </dgm:presLayoutVars>
      </dgm:prSet>
      <dgm:spPr/>
    </dgm:pt>
    <dgm:pt modelId="{654D766E-39ED-4868-AAEF-1A28544B5F5D}" type="pres">
      <dgm:prSet presAssocID="{CE4A4217-0410-4729-9337-C36C75DD601B}" presName="level3hierChild" presStyleCnt="0"/>
      <dgm:spPr/>
    </dgm:pt>
    <dgm:pt modelId="{5BC2E700-F976-45E3-88A6-547D0BC5C286}" type="pres">
      <dgm:prSet presAssocID="{8F1E2ECC-9C8C-4137-9CC2-148EC633E965}" presName="conn2-1" presStyleLbl="parChTrans1D4" presStyleIdx="5" presStyleCnt="9" custSzX="14400031"/>
      <dgm:spPr/>
    </dgm:pt>
    <dgm:pt modelId="{5EE677E4-1C6E-4B89-9610-5064AAB1F7F5}" type="pres">
      <dgm:prSet presAssocID="{8F1E2ECC-9C8C-4137-9CC2-148EC633E965}" presName="connTx" presStyleLbl="parChTrans1D4" presStyleIdx="5" presStyleCnt="9"/>
      <dgm:spPr/>
    </dgm:pt>
    <dgm:pt modelId="{6A66418A-D546-46F7-87E7-DA1E687FB1FE}" type="pres">
      <dgm:prSet presAssocID="{359B501C-2EC2-4B8C-BD62-7A96D0CFC1AF}" presName="root2" presStyleCnt="0"/>
      <dgm:spPr/>
    </dgm:pt>
    <dgm:pt modelId="{677DE54C-6078-40B3-9FE8-CF37F7EF3F0C}" type="pres">
      <dgm:prSet presAssocID="{359B501C-2EC2-4B8C-BD62-7A96D0CFC1AF}" presName="LevelTwoTextNode" presStyleLbl="node4" presStyleIdx="5" presStyleCnt="9" custFlipVert="0" custScaleX="1608267" custScaleY="350895" custLinFactX="1000000" custLinFactY="200000" custLinFactNeighborX="1081980" custLinFactNeighborY="258146">
        <dgm:presLayoutVars>
          <dgm:chPref val="3"/>
        </dgm:presLayoutVars>
      </dgm:prSet>
      <dgm:spPr/>
    </dgm:pt>
    <dgm:pt modelId="{A887E327-8C38-4695-BD51-70185935A672}" type="pres">
      <dgm:prSet presAssocID="{359B501C-2EC2-4B8C-BD62-7A96D0CFC1AF}" presName="level3hierChild" presStyleCnt="0"/>
      <dgm:spPr/>
    </dgm:pt>
    <dgm:pt modelId="{007AF09B-7B63-4C84-BFB2-EF40ED79070D}" type="pres">
      <dgm:prSet presAssocID="{3B2039F4-2BA1-4802-A7AA-25308413273C}" presName="conn2-1" presStyleLbl="parChTrans1D4" presStyleIdx="6" presStyleCnt="9" custSzX="14400044"/>
      <dgm:spPr/>
    </dgm:pt>
    <dgm:pt modelId="{1C784E67-44D5-495B-BFB2-4C4FDB887CF2}" type="pres">
      <dgm:prSet presAssocID="{3B2039F4-2BA1-4802-A7AA-25308413273C}" presName="connTx" presStyleLbl="parChTrans1D4" presStyleIdx="6" presStyleCnt="9"/>
      <dgm:spPr/>
    </dgm:pt>
    <dgm:pt modelId="{DF9FF149-B0C6-4C8C-BC41-DF43A2913708}" type="pres">
      <dgm:prSet presAssocID="{B87C2DC1-653F-4929-9260-6C6E30534E07}" presName="root2" presStyleCnt="0"/>
      <dgm:spPr/>
    </dgm:pt>
    <dgm:pt modelId="{38194E2B-8C9B-446D-93B0-01D743C0AC69}" type="pres">
      <dgm:prSet presAssocID="{B87C2DC1-653F-4929-9260-6C6E30534E07}" presName="LevelTwoTextNode" presStyleLbl="node4" presStyleIdx="6" presStyleCnt="9" custScaleX="1608267" custScaleY="350896" custLinFactX="1000000" custLinFactY="209806" custLinFactNeighborX="1081980" custLinFactNeighborY="300000">
        <dgm:presLayoutVars>
          <dgm:chPref val="3"/>
        </dgm:presLayoutVars>
      </dgm:prSet>
      <dgm:spPr/>
    </dgm:pt>
    <dgm:pt modelId="{B2CF7225-C61E-43D9-B9C8-7DB119B5C411}" type="pres">
      <dgm:prSet presAssocID="{B87C2DC1-653F-4929-9260-6C6E30534E07}" presName="level3hierChild" presStyleCnt="0"/>
      <dgm:spPr/>
    </dgm:pt>
    <dgm:pt modelId="{925EDBFF-3D85-437B-9D22-40DBEB5AB8DA}" type="pres">
      <dgm:prSet presAssocID="{A1B0E159-B1C8-4060-A4E0-14F2712C19F0}" presName="conn2-1" presStyleLbl="parChTrans1D2" presStyleIdx="2" presStyleCnt="5" custSzX="14400001"/>
      <dgm:spPr/>
    </dgm:pt>
    <dgm:pt modelId="{B814C4C0-4FD5-42D0-888F-22B47EF7775E}" type="pres">
      <dgm:prSet presAssocID="{A1B0E159-B1C8-4060-A4E0-14F2712C19F0}" presName="connTx" presStyleLbl="parChTrans1D2" presStyleIdx="2" presStyleCnt="5"/>
      <dgm:spPr/>
    </dgm:pt>
    <dgm:pt modelId="{32813329-F5DE-4D43-9999-7021733058B4}" type="pres">
      <dgm:prSet presAssocID="{A7E59208-D8C8-472E-BF12-F8E4CF3114A2}" presName="root2" presStyleCnt="0"/>
      <dgm:spPr/>
    </dgm:pt>
    <dgm:pt modelId="{933E68AA-CF10-49A1-ABCC-DA114DDEAF2A}" type="pres">
      <dgm:prSet presAssocID="{A7E59208-D8C8-472E-BF12-F8E4CF3114A2}" presName="LevelTwoTextNode" presStyleLbl="node2" presStyleIdx="2" presStyleCnt="5" custScaleX="1120331" custScaleY="716455" custLinFactX="-1100000" custLinFactY="200000" custLinFactNeighborX="-1115792" custLinFactNeighborY="261635">
        <dgm:presLayoutVars>
          <dgm:chPref val="3"/>
        </dgm:presLayoutVars>
      </dgm:prSet>
      <dgm:spPr/>
    </dgm:pt>
    <dgm:pt modelId="{0BB7042D-0783-4AF0-A2AC-0560AE754DBB}" type="pres">
      <dgm:prSet presAssocID="{A7E59208-D8C8-472E-BF12-F8E4CF3114A2}" presName="level3hierChild" presStyleCnt="0"/>
      <dgm:spPr/>
    </dgm:pt>
    <dgm:pt modelId="{0E872D06-F66B-4811-92EA-E374B25899A2}" type="pres">
      <dgm:prSet presAssocID="{96C75850-7C10-4A02-8605-049A49CD2E2D}" presName="conn2-1" presStyleLbl="parChTrans1D3" presStyleIdx="9" presStyleCnt="29" custSzX="14400025"/>
      <dgm:spPr/>
    </dgm:pt>
    <dgm:pt modelId="{72B52D37-7D34-4ADE-968E-0497344DEB80}" type="pres">
      <dgm:prSet presAssocID="{96C75850-7C10-4A02-8605-049A49CD2E2D}" presName="connTx" presStyleLbl="parChTrans1D3" presStyleIdx="9" presStyleCnt="29"/>
      <dgm:spPr/>
    </dgm:pt>
    <dgm:pt modelId="{02CBB79E-92BB-43E9-BC76-EB3CA055D3F6}" type="pres">
      <dgm:prSet presAssocID="{3CF53495-E7A9-4FFB-983F-8FC85A5AADF1}" presName="root2" presStyleCnt="0"/>
      <dgm:spPr/>
    </dgm:pt>
    <dgm:pt modelId="{3F552C8C-859A-4030-A503-8872BA917E0A}" type="pres">
      <dgm:prSet presAssocID="{3CF53495-E7A9-4FFB-983F-8FC85A5AADF1}" presName="LevelTwoTextNode" presStyleLbl="node3" presStyleIdx="9" presStyleCnt="29" custScaleX="1575914" custScaleY="319172" custLinFactX="-726997" custLinFactY="132968" custLinFactNeighborX="-800000" custLinFactNeighborY="200000">
        <dgm:presLayoutVars>
          <dgm:chPref val="3"/>
        </dgm:presLayoutVars>
      </dgm:prSet>
      <dgm:spPr/>
    </dgm:pt>
    <dgm:pt modelId="{90941FE9-BA76-4E83-BB38-DFDC96B69634}" type="pres">
      <dgm:prSet presAssocID="{3CF53495-E7A9-4FFB-983F-8FC85A5AADF1}" presName="level3hierChild" presStyleCnt="0"/>
      <dgm:spPr/>
    </dgm:pt>
    <dgm:pt modelId="{168B63D6-E582-4001-8D06-4264135971C6}" type="pres">
      <dgm:prSet presAssocID="{0CC02BC8-A818-4832-81BB-32F3133B8621}" presName="conn2-1" presStyleLbl="parChTrans1D3" presStyleIdx="10" presStyleCnt="29" custSzX="14400008"/>
      <dgm:spPr/>
    </dgm:pt>
    <dgm:pt modelId="{1CC6C369-6E50-42DA-A881-F2FD7708779E}" type="pres">
      <dgm:prSet presAssocID="{0CC02BC8-A818-4832-81BB-32F3133B8621}" presName="connTx" presStyleLbl="parChTrans1D3" presStyleIdx="10" presStyleCnt="29"/>
      <dgm:spPr/>
    </dgm:pt>
    <dgm:pt modelId="{509B91C6-26BD-453B-AB33-E3A76B562994}" type="pres">
      <dgm:prSet presAssocID="{ECD62ED1-5D11-481E-9BBC-AB020A2EFAFF}" presName="root2" presStyleCnt="0"/>
      <dgm:spPr/>
    </dgm:pt>
    <dgm:pt modelId="{BF83AAD4-9518-47AA-835D-A40E2C49AF13}" type="pres">
      <dgm:prSet presAssocID="{ECD62ED1-5D11-481E-9BBC-AB020A2EFAFF}" presName="LevelTwoTextNode" presStyleLbl="node3" presStyleIdx="10" presStyleCnt="29" custScaleX="1574897" custScaleY="319172" custLinFactX="-727702" custLinFactY="184451" custLinFactNeighborX="-800000" custLinFactNeighborY="200000">
        <dgm:presLayoutVars>
          <dgm:chPref val="3"/>
        </dgm:presLayoutVars>
      </dgm:prSet>
      <dgm:spPr/>
    </dgm:pt>
    <dgm:pt modelId="{372B43B3-F831-4836-9D42-D22FD7E162E2}" type="pres">
      <dgm:prSet presAssocID="{ECD62ED1-5D11-481E-9BBC-AB020A2EFAFF}" presName="level3hierChild" presStyleCnt="0"/>
      <dgm:spPr/>
    </dgm:pt>
    <dgm:pt modelId="{12649787-8B1A-4097-B62E-BBC1879F2014}" type="pres">
      <dgm:prSet presAssocID="{72696429-0052-4BF2-A3D6-BBDE6FE074F3}" presName="conn2-1" presStyleLbl="parChTrans1D3" presStyleIdx="11" presStyleCnt="29" custSzX="14400016"/>
      <dgm:spPr/>
    </dgm:pt>
    <dgm:pt modelId="{D70BE76E-DF8A-41C7-B32C-B201D4602719}" type="pres">
      <dgm:prSet presAssocID="{72696429-0052-4BF2-A3D6-BBDE6FE074F3}" presName="connTx" presStyleLbl="parChTrans1D3" presStyleIdx="11" presStyleCnt="29"/>
      <dgm:spPr/>
    </dgm:pt>
    <dgm:pt modelId="{6FBA47E0-66A4-4DA5-A275-39BDD110ECB7}" type="pres">
      <dgm:prSet presAssocID="{B9C65307-6730-4D84-A9EC-F5E07D061332}" presName="root2" presStyleCnt="0"/>
      <dgm:spPr/>
    </dgm:pt>
    <dgm:pt modelId="{D4B8489D-29A0-450D-846E-6780D2436C16}" type="pres">
      <dgm:prSet presAssocID="{B9C65307-6730-4D84-A9EC-F5E07D061332}" presName="LevelTwoTextNode" presStyleLbl="node3" presStyleIdx="11" presStyleCnt="29" custScaleX="1574897" custScaleY="317063" custLinFactX="-729064" custLinFactY="200000" custLinFactNeighborX="-800000" custLinFactNeighborY="236492">
        <dgm:presLayoutVars>
          <dgm:chPref val="3"/>
        </dgm:presLayoutVars>
      </dgm:prSet>
      <dgm:spPr/>
    </dgm:pt>
    <dgm:pt modelId="{359345A4-19E5-49DB-8245-6F2492C61000}" type="pres">
      <dgm:prSet presAssocID="{B9C65307-6730-4D84-A9EC-F5E07D061332}" presName="level3hierChild" presStyleCnt="0"/>
      <dgm:spPr/>
    </dgm:pt>
    <dgm:pt modelId="{87A49760-64CE-4CBD-BF78-45B22D2A4949}" type="pres">
      <dgm:prSet presAssocID="{5E84A072-2EA0-45DE-B57C-DA217CA13318}" presName="conn2-1" presStyleLbl="parChTrans1D3" presStyleIdx="12" presStyleCnt="29" custSzX="14400032"/>
      <dgm:spPr/>
    </dgm:pt>
    <dgm:pt modelId="{894D3D26-1468-4F2C-88F6-01751D8C7D69}" type="pres">
      <dgm:prSet presAssocID="{5E84A072-2EA0-45DE-B57C-DA217CA13318}" presName="connTx" presStyleLbl="parChTrans1D3" presStyleIdx="12" presStyleCnt="29"/>
      <dgm:spPr/>
    </dgm:pt>
    <dgm:pt modelId="{0B54FA82-637D-47AA-AA43-07DF2CC550CF}" type="pres">
      <dgm:prSet presAssocID="{3E305254-2A1B-4466-9716-16D92D48BD39}" presName="root2" presStyleCnt="0"/>
      <dgm:spPr/>
    </dgm:pt>
    <dgm:pt modelId="{C50E5B3A-B9FE-43B9-85D2-DC2953853106}" type="pres">
      <dgm:prSet presAssocID="{3E305254-2A1B-4466-9716-16D92D48BD39}" presName="LevelTwoTextNode" presStyleLbl="node3" presStyleIdx="12" presStyleCnt="29" custScaleX="1575914" custScaleY="693754" custLinFactX="-729257" custLinFactY="200000" custLinFactNeighborX="-800000" custLinFactNeighborY="295557">
        <dgm:presLayoutVars>
          <dgm:chPref val="3"/>
        </dgm:presLayoutVars>
      </dgm:prSet>
      <dgm:spPr/>
    </dgm:pt>
    <dgm:pt modelId="{55980929-F735-4B98-A398-02108F7A9B12}" type="pres">
      <dgm:prSet presAssocID="{3E305254-2A1B-4466-9716-16D92D48BD39}" presName="level3hierChild" presStyleCnt="0"/>
      <dgm:spPr/>
    </dgm:pt>
    <dgm:pt modelId="{FC687F4F-95AF-4388-A390-2F0E64666848}" type="pres">
      <dgm:prSet presAssocID="{1930F7C4-5EB2-4BFC-B652-6F6645AD8029}" presName="conn2-1" presStyleLbl="parChTrans1D3" presStyleIdx="13" presStyleCnt="29" custSzX="14400056"/>
      <dgm:spPr/>
    </dgm:pt>
    <dgm:pt modelId="{94C13FA5-1561-4553-ADA9-69D482E5248A}" type="pres">
      <dgm:prSet presAssocID="{1930F7C4-5EB2-4BFC-B652-6F6645AD8029}" presName="connTx" presStyleLbl="parChTrans1D3" presStyleIdx="13" presStyleCnt="29"/>
      <dgm:spPr/>
    </dgm:pt>
    <dgm:pt modelId="{33E788E1-A069-4A13-98BB-73D866B82E71}" type="pres">
      <dgm:prSet presAssocID="{AB141E1E-8A47-473D-BDC9-A740AE0EA3F7}" presName="root2" presStyleCnt="0"/>
      <dgm:spPr/>
    </dgm:pt>
    <dgm:pt modelId="{D7C3B540-AAE3-47B6-8689-6F42331FBB0D}" type="pres">
      <dgm:prSet presAssocID="{AB141E1E-8A47-473D-BDC9-A740AE0EA3F7}" presName="LevelTwoTextNode" presStyleLbl="node3" presStyleIdx="13" presStyleCnt="29" custScaleX="1574896" custScaleY="378345" custLinFactX="-728592" custLinFactY="275760" custLinFactNeighborX="-800000" custLinFactNeighborY="300000">
        <dgm:presLayoutVars>
          <dgm:chPref val="3"/>
        </dgm:presLayoutVars>
      </dgm:prSet>
      <dgm:spPr/>
    </dgm:pt>
    <dgm:pt modelId="{85CD2B0D-0C87-4BEE-9E1C-E0A79E674051}" type="pres">
      <dgm:prSet presAssocID="{AB141E1E-8A47-473D-BDC9-A740AE0EA3F7}" presName="level3hierChild" presStyleCnt="0"/>
      <dgm:spPr/>
    </dgm:pt>
    <dgm:pt modelId="{91683DB7-5821-4F63-939D-8271AEDB1AC2}" type="pres">
      <dgm:prSet presAssocID="{579F7746-AF17-435C-A54C-9C6E6EE94B1D}" presName="conn2-1" presStyleLbl="parChTrans1D2" presStyleIdx="3" presStyleCnt="5" custSzX="14400002"/>
      <dgm:spPr/>
    </dgm:pt>
    <dgm:pt modelId="{D9B96937-FBE0-4586-A2C5-BC85D2155D05}" type="pres">
      <dgm:prSet presAssocID="{579F7746-AF17-435C-A54C-9C6E6EE94B1D}" presName="connTx" presStyleLbl="parChTrans1D2" presStyleIdx="3" presStyleCnt="5"/>
      <dgm:spPr/>
    </dgm:pt>
    <dgm:pt modelId="{EE01913B-A6F0-42CE-AF5A-9DEAF5D8DBB0}" type="pres">
      <dgm:prSet presAssocID="{4DCC093E-5118-4588-BF05-784A120C438E}" presName="root2" presStyleCnt="0"/>
      <dgm:spPr/>
    </dgm:pt>
    <dgm:pt modelId="{DDCB18A7-5217-498E-8109-AEC8891AEF63}" type="pres">
      <dgm:prSet presAssocID="{4DCC093E-5118-4588-BF05-784A120C438E}" presName="LevelTwoTextNode" presStyleLbl="node2" presStyleIdx="3" presStyleCnt="5" custScaleX="1120331" custScaleY="861353" custLinFactX="-1100000" custLinFactY="-31760" custLinFactNeighborX="-1116178" custLinFactNeighborY="-100000">
        <dgm:presLayoutVars>
          <dgm:chPref val="3"/>
        </dgm:presLayoutVars>
      </dgm:prSet>
      <dgm:spPr/>
    </dgm:pt>
    <dgm:pt modelId="{B02E7AF6-66DA-4252-B52D-833FA55306E0}" type="pres">
      <dgm:prSet presAssocID="{4DCC093E-5118-4588-BF05-784A120C438E}" presName="level3hierChild" presStyleCnt="0"/>
      <dgm:spPr/>
    </dgm:pt>
    <dgm:pt modelId="{87C9AC31-CDDE-4E1F-B79F-69064C460489}" type="pres">
      <dgm:prSet presAssocID="{CEA4C598-03BA-4196-8096-D8D9940A747B}" presName="conn2-1" presStyleLbl="parChTrans1D3" presStyleIdx="14" presStyleCnt="29" custSzX="14400004"/>
      <dgm:spPr/>
    </dgm:pt>
    <dgm:pt modelId="{EBD2F8EB-D76E-4ECE-AD86-C67210D41D3D}" type="pres">
      <dgm:prSet presAssocID="{CEA4C598-03BA-4196-8096-D8D9940A747B}" presName="connTx" presStyleLbl="parChTrans1D3" presStyleIdx="14" presStyleCnt="29"/>
      <dgm:spPr/>
    </dgm:pt>
    <dgm:pt modelId="{18B3E9C4-212E-4910-9E2D-34244862C8BF}" type="pres">
      <dgm:prSet presAssocID="{B8C47AF5-72F4-4882-A03A-756E7DB0314D}" presName="root2" presStyleCnt="0"/>
      <dgm:spPr/>
    </dgm:pt>
    <dgm:pt modelId="{BD9D8B61-1FCA-4DBF-95E6-59B9130798B9}" type="pres">
      <dgm:prSet presAssocID="{B8C47AF5-72F4-4882-A03A-756E7DB0314D}" presName="LevelTwoTextNode" presStyleLbl="node3" presStyleIdx="14" presStyleCnt="29" custScaleX="1600945" custScaleY="348054" custLinFactX="567610" custLinFactY="-141944" custLinFactNeighborX="600000" custLinFactNeighborY="-200000">
        <dgm:presLayoutVars>
          <dgm:chPref val="3"/>
        </dgm:presLayoutVars>
      </dgm:prSet>
      <dgm:spPr/>
    </dgm:pt>
    <dgm:pt modelId="{518C82D6-093F-4ABC-ABE5-99666F772EAD}" type="pres">
      <dgm:prSet presAssocID="{B8C47AF5-72F4-4882-A03A-756E7DB0314D}" presName="level3hierChild" presStyleCnt="0"/>
      <dgm:spPr/>
    </dgm:pt>
    <dgm:pt modelId="{56FAFC49-D0EA-4E25-8D48-7123A498BD9B}" type="pres">
      <dgm:prSet presAssocID="{C1EACDD7-D989-416D-9681-817FEB9BF90B}" presName="conn2-1" presStyleLbl="parChTrans1D3" presStyleIdx="15" presStyleCnt="29" custSzX="14400008"/>
      <dgm:spPr/>
    </dgm:pt>
    <dgm:pt modelId="{69674B81-12B1-4530-81E5-B46611BDEBD3}" type="pres">
      <dgm:prSet presAssocID="{C1EACDD7-D989-416D-9681-817FEB9BF90B}" presName="connTx" presStyleLbl="parChTrans1D3" presStyleIdx="15" presStyleCnt="29"/>
      <dgm:spPr/>
    </dgm:pt>
    <dgm:pt modelId="{AC80BB0E-C09A-4A3A-A6DC-68DD0D75747A}" type="pres">
      <dgm:prSet presAssocID="{3B6E185B-6A1C-411C-B39C-F27A6010733C}" presName="root2" presStyleCnt="0"/>
      <dgm:spPr/>
    </dgm:pt>
    <dgm:pt modelId="{E730F18F-48B0-4E0B-9A8D-D539E63CE9D4}" type="pres">
      <dgm:prSet presAssocID="{3B6E185B-6A1C-411C-B39C-F27A6010733C}" presName="LevelTwoTextNode" presStyleLbl="node3" presStyleIdx="15" presStyleCnt="29" custScaleX="1600945" custScaleY="348054" custLinFactX="574431" custLinFactY="-100000" custLinFactNeighborX="600000" custLinFactNeighborY="-195759">
        <dgm:presLayoutVars>
          <dgm:chPref val="3"/>
        </dgm:presLayoutVars>
      </dgm:prSet>
      <dgm:spPr/>
    </dgm:pt>
    <dgm:pt modelId="{360EA3B4-0F47-4D6B-A63D-BB2A4077DE52}" type="pres">
      <dgm:prSet presAssocID="{3B6E185B-6A1C-411C-B39C-F27A6010733C}" presName="level3hierChild" presStyleCnt="0"/>
      <dgm:spPr/>
    </dgm:pt>
    <dgm:pt modelId="{04B5A4E1-0824-444B-B0DF-49A3641E7799}" type="pres">
      <dgm:prSet presAssocID="{1A36E4A0-3C95-4A7E-8403-6FC00333987E}" presName="conn2-1" presStyleLbl="parChTrans1D4" presStyleIdx="7" presStyleCnt="9" custSzX="14400028"/>
      <dgm:spPr/>
    </dgm:pt>
    <dgm:pt modelId="{272D572E-5B26-4488-A75D-C75C5F075451}" type="pres">
      <dgm:prSet presAssocID="{1A36E4A0-3C95-4A7E-8403-6FC00333987E}" presName="connTx" presStyleLbl="parChTrans1D4" presStyleIdx="7" presStyleCnt="9"/>
      <dgm:spPr/>
    </dgm:pt>
    <dgm:pt modelId="{19108BD8-503D-4075-A1CF-53550D590BD4}" type="pres">
      <dgm:prSet presAssocID="{0EF4F3AF-041E-4FDF-983F-FF187C733655}" presName="root2" presStyleCnt="0"/>
      <dgm:spPr/>
    </dgm:pt>
    <dgm:pt modelId="{4DCF8B3D-4AC6-4BA4-83D6-71D9BD5CEED2}" type="pres">
      <dgm:prSet presAssocID="{0EF4F3AF-041E-4FDF-983F-FF187C733655}" presName="LevelTwoTextNode" presStyleLbl="node4" presStyleIdx="7" presStyleCnt="9" custScaleX="1608267" custScaleY="656446" custLinFactX="1000000" custLinFactY="-128390" custLinFactNeighborX="1098821" custLinFactNeighborY="-200000">
        <dgm:presLayoutVars>
          <dgm:chPref val="3"/>
        </dgm:presLayoutVars>
      </dgm:prSet>
      <dgm:spPr/>
    </dgm:pt>
    <dgm:pt modelId="{D35E8196-0F33-4D66-8A3D-9E7CA82C9867}" type="pres">
      <dgm:prSet presAssocID="{0EF4F3AF-041E-4FDF-983F-FF187C733655}" presName="level3hierChild" presStyleCnt="0"/>
      <dgm:spPr/>
    </dgm:pt>
    <dgm:pt modelId="{4422E06E-D77E-4F56-8840-95885C852043}" type="pres">
      <dgm:prSet presAssocID="{425A3179-1413-4460-9678-40448B2E5A42}" presName="conn2-1" presStyleLbl="parChTrans1D4" presStyleIdx="8" presStyleCnt="9" custSzX="14400023"/>
      <dgm:spPr/>
    </dgm:pt>
    <dgm:pt modelId="{78BB6245-6919-431D-8F6D-FEFDFE3AC3B2}" type="pres">
      <dgm:prSet presAssocID="{425A3179-1413-4460-9678-40448B2E5A42}" presName="connTx" presStyleLbl="parChTrans1D4" presStyleIdx="8" presStyleCnt="9"/>
      <dgm:spPr/>
    </dgm:pt>
    <dgm:pt modelId="{D65C5CDD-56AD-44ED-96AA-F28E3AD2C69B}" type="pres">
      <dgm:prSet presAssocID="{85CA1953-8DEE-44BB-BE58-B97A59C65C13}" presName="root2" presStyleCnt="0"/>
      <dgm:spPr/>
    </dgm:pt>
    <dgm:pt modelId="{63E06D80-B4DA-4AF5-B318-48676A80383C}" type="pres">
      <dgm:prSet presAssocID="{85CA1953-8DEE-44BB-BE58-B97A59C65C13}" presName="LevelTwoTextNode" presStyleLbl="node4" presStyleIdx="8" presStyleCnt="9" custScaleX="1608267" custScaleY="701789" custLinFactX="1000000" custLinFactY="-100000" custLinFactNeighborX="1098821" custLinFactNeighborY="-171709">
        <dgm:presLayoutVars>
          <dgm:chPref val="3"/>
        </dgm:presLayoutVars>
      </dgm:prSet>
      <dgm:spPr/>
    </dgm:pt>
    <dgm:pt modelId="{FF8F3D66-F4A7-4E59-9130-E75CEE01CEC5}" type="pres">
      <dgm:prSet presAssocID="{85CA1953-8DEE-44BB-BE58-B97A59C65C13}" presName="level3hierChild" presStyleCnt="0"/>
      <dgm:spPr/>
    </dgm:pt>
    <dgm:pt modelId="{82D2DBC9-D5F1-41B2-B475-FC62C3A7004B}" type="pres">
      <dgm:prSet presAssocID="{21F29C5E-B439-428D-89D6-0B6C5058BC6D}" presName="conn2-1" presStyleLbl="parChTrans1D3" presStyleIdx="16" presStyleCnt="29" custSzX="14400012"/>
      <dgm:spPr/>
    </dgm:pt>
    <dgm:pt modelId="{14C8F2DC-5402-4C02-AEC9-5324C6C4963A}" type="pres">
      <dgm:prSet presAssocID="{21F29C5E-B439-428D-89D6-0B6C5058BC6D}" presName="connTx" presStyleLbl="parChTrans1D3" presStyleIdx="16" presStyleCnt="29"/>
      <dgm:spPr/>
    </dgm:pt>
    <dgm:pt modelId="{939F4CFE-8C60-446F-BA29-9CB807C1727D}" type="pres">
      <dgm:prSet presAssocID="{41D6EC2F-3103-40F0-AD9A-B96A94477A77}" presName="root2" presStyleCnt="0"/>
      <dgm:spPr/>
    </dgm:pt>
    <dgm:pt modelId="{481798CD-BDE5-4B57-B01A-E2CEFF5196BF}" type="pres">
      <dgm:prSet presAssocID="{41D6EC2F-3103-40F0-AD9A-B96A94477A77}" presName="LevelTwoTextNode" presStyleLbl="node3" presStyleIdx="16" presStyleCnt="29" custScaleX="1600945" custScaleY="674244" custLinFactX="573594" custLinFactY="-100000" custLinFactNeighborX="600000" custLinFactNeighborY="-139269">
        <dgm:presLayoutVars>
          <dgm:chPref val="3"/>
        </dgm:presLayoutVars>
      </dgm:prSet>
      <dgm:spPr/>
    </dgm:pt>
    <dgm:pt modelId="{B42E1832-2937-4B92-8923-31358112F338}" type="pres">
      <dgm:prSet presAssocID="{41D6EC2F-3103-40F0-AD9A-B96A94477A77}" presName="level3hierChild" presStyleCnt="0"/>
      <dgm:spPr/>
    </dgm:pt>
    <dgm:pt modelId="{22457488-96D2-492A-A67D-1DA42B35C92F}" type="pres">
      <dgm:prSet presAssocID="{760F7733-46EF-4539-A2FB-454CD8F95E50}" presName="conn2-1" presStyleLbl="parChTrans1D3" presStyleIdx="17" presStyleCnt="29" custSzX="14400001"/>
      <dgm:spPr/>
    </dgm:pt>
    <dgm:pt modelId="{7E42A3E7-F188-48F4-99B5-B1F4D367F825}" type="pres">
      <dgm:prSet presAssocID="{760F7733-46EF-4539-A2FB-454CD8F95E50}" presName="connTx" presStyleLbl="parChTrans1D3" presStyleIdx="17" presStyleCnt="29"/>
      <dgm:spPr/>
    </dgm:pt>
    <dgm:pt modelId="{40E1F38D-F838-4B3A-8959-C57390990E61}" type="pres">
      <dgm:prSet presAssocID="{F576FE14-F223-4751-B256-BF313602C91E}" presName="root2" presStyleCnt="0"/>
      <dgm:spPr/>
    </dgm:pt>
    <dgm:pt modelId="{DC301E58-40D8-4D3D-9A40-BAA0C92BDE59}" type="pres">
      <dgm:prSet presAssocID="{F576FE14-F223-4751-B256-BF313602C91E}" presName="LevelTwoTextNode" presStyleLbl="node3" presStyleIdx="17" presStyleCnt="29" custScaleX="1600945" custScaleY="755449" custLinFactX="571512" custLinFactY="-71738" custLinFactNeighborX="600000" custLinFactNeighborY="-100000">
        <dgm:presLayoutVars>
          <dgm:chPref val="3"/>
        </dgm:presLayoutVars>
      </dgm:prSet>
      <dgm:spPr/>
    </dgm:pt>
    <dgm:pt modelId="{F06368F7-EC0F-4A1D-9A8E-247D54BEDDBC}" type="pres">
      <dgm:prSet presAssocID="{F576FE14-F223-4751-B256-BF313602C91E}" presName="level3hierChild" presStyleCnt="0"/>
      <dgm:spPr/>
    </dgm:pt>
    <dgm:pt modelId="{2E231434-ED7F-44D1-8C73-4DA73C333BE6}" type="pres">
      <dgm:prSet presAssocID="{F79E2E4E-D09E-4761-9D42-D0B633170619}" presName="conn2-1" presStyleLbl="parChTrans1D3" presStyleIdx="18" presStyleCnt="29" custSzX="14400008"/>
      <dgm:spPr/>
    </dgm:pt>
    <dgm:pt modelId="{1DF7A0FE-D847-4A6C-886A-53CFFF4E83C7}" type="pres">
      <dgm:prSet presAssocID="{F79E2E4E-D09E-4761-9D42-D0B633170619}" presName="connTx" presStyleLbl="parChTrans1D3" presStyleIdx="18" presStyleCnt="29"/>
      <dgm:spPr/>
    </dgm:pt>
    <dgm:pt modelId="{BE8A502F-FC97-4D68-B5C8-EF15A6D273CA}" type="pres">
      <dgm:prSet presAssocID="{B18AAAC7-07A3-44B8-A053-45D1FF816FFD}" presName="root2" presStyleCnt="0"/>
      <dgm:spPr/>
    </dgm:pt>
    <dgm:pt modelId="{665072C3-8ADE-40C1-BDA5-4FAA68E4319F}" type="pres">
      <dgm:prSet presAssocID="{B18AAAC7-07A3-44B8-A053-45D1FF816FFD}" presName="LevelTwoTextNode" presStyleLbl="node3" presStyleIdx="18" presStyleCnt="29" custScaleX="1600945" custScaleY="755449" custLinFactX="574460" custLinFactY="-11180" custLinFactNeighborX="600000" custLinFactNeighborY="-100000">
        <dgm:presLayoutVars>
          <dgm:chPref val="3"/>
        </dgm:presLayoutVars>
      </dgm:prSet>
      <dgm:spPr/>
    </dgm:pt>
    <dgm:pt modelId="{351C6D74-3715-400D-811D-2BFE8ADB6101}" type="pres">
      <dgm:prSet presAssocID="{B18AAAC7-07A3-44B8-A053-45D1FF816FFD}" presName="level3hierChild" presStyleCnt="0"/>
      <dgm:spPr/>
    </dgm:pt>
    <dgm:pt modelId="{134D7A88-2D4D-4FE0-A203-5D2DFDE9B8B0}" type="pres">
      <dgm:prSet presAssocID="{010FD920-EA56-439A-976D-37845A8E9EE8}" presName="conn2-1" presStyleLbl="parChTrans1D3" presStyleIdx="19" presStyleCnt="29" custSzX="14400004"/>
      <dgm:spPr/>
    </dgm:pt>
    <dgm:pt modelId="{E34F5E68-97F6-448B-93CC-7F50A4D760A8}" type="pres">
      <dgm:prSet presAssocID="{010FD920-EA56-439A-976D-37845A8E9EE8}" presName="connTx" presStyleLbl="parChTrans1D3" presStyleIdx="19" presStyleCnt="29"/>
      <dgm:spPr/>
    </dgm:pt>
    <dgm:pt modelId="{F778CF73-89A3-42BA-AB6F-C2C1BC63090E}" type="pres">
      <dgm:prSet presAssocID="{E7091F61-EB43-4F07-B67B-2EE2EED76652}" presName="root2" presStyleCnt="0"/>
      <dgm:spPr/>
    </dgm:pt>
    <dgm:pt modelId="{3E90B72A-F33B-4C19-AA15-D10953CC4340}" type="pres">
      <dgm:prSet presAssocID="{E7091F61-EB43-4F07-B67B-2EE2EED76652}" presName="LevelTwoTextNode" presStyleLbl="node3" presStyleIdx="19" presStyleCnt="29" custAng="10800000" custFlipVert="1" custScaleX="1600945" custScaleY="348054" custLinFactX="569883" custLinFactNeighborX="600000" custLinFactNeighborY="-64522">
        <dgm:presLayoutVars>
          <dgm:chPref val="3"/>
        </dgm:presLayoutVars>
      </dgm:prSet>
      <dgm:spPr/>
    </dgm:pt>
    <dgm:pt modelId="{D524E27F-D99E-41B2-BF90-B4E8FC5E68DB}" type="pres">
      <dgm:prSet presAssocID="{E7091F61-EB43-4F07-B67B-2EE2EED76652}" presName="level3hierChild" presStyleCnt="0"/>
      <dgm:spPr/>
    </dgm:pt>
    <dgm:pt modelId="{CBE2BF13-B4B2-4CCE-B9CD-9C2AE1DB9827}" type="pres">
      <dgm:prSet presAssocID="{2F8F9AB3-8452-43EC-87B2-17B5891BF608}" presName="conn2-1" presStyleLbl="parChTrans1D3" presStyleIdx="20" presStyleCnt="29" custSzX="14400007"/>
      <dgm:spPr/>
    </dgm:pt>
    <dgm:pt modelId="{BCDDDD5C-AFED-4205-A736-CCA5522531A5}" type="pres">
      <dgm:prSet presAssocID="{2F8F9AB3-8452-43EC-87B2-17B5891BF608}" presName="connTx" presStyleLbl="parChTrans1D3" presStyleIdx="20" presStyleCnt="29"/>
      <dgm:spPr/>
    </dgm:pt>
    <dgm:pt modelId="{D82F3EC8-11FE-44FB-A347-97A3FBA6D574}" type="pres">
      <dgm:prSet presAssocID="{8598F285-6469-41DF-8C80-D94935C42364}" presName="root2" presStyleCnt="0"/>
      <dgm:spPr/>
    </dgm:pt>
    <dgm:pt modelId="{48E4B145-A01E-4F97-9B06-6C33D2269A47}" type="pres">
      <dgm:prSet presAssocID="{8598F285-6469-41DF-8C80-D94935C42364}" presName="LevelTwoTextNode" presStyleLbl="node3" presStyleIdx="20" presStyleCnt="29" custScaleX="1600945" custScaleY="348054" custLinFactX="574464" custLinFactNeighborX="600000" custLinFactNeighborY="-7945">
        <dgm:presLayoutVars>
          <dgm:chPref val="3"/>
        </dgm:presLayoutVars>
      </dgm:prSet>
      <dgm:spPr/>
    </dgm:pt>
    <dgm:pt modelId="{47268DB0-FBEE-4541-9325-FAEE019D20F8}" type="pres">
      <dgm:prSet presAssocID="{8598F285-6469-41DF-8C80-D94935C42364}" presName="level3hierChild" presStyleCnt="0"/>
      <dgm:spPr/>
    </dgm:pt>
    <dgm:pt modelId="{92D0DEB7-F9E3-4085-A056-1B4AA5D907F0}" type="pres">
      <dgm:prSet presAssocID="{7D4974A8-D315-42CC-B9BB-A3A5CD5225A3}" presName="conn2-1" presStyleLbl="parChTrans1D3" presStyleIdx="21" presStyleCnt="29" custSzX="14400007"/>
      <dgm:spPr/>
    </dgm:pt>
    <dgm:pt modelId="{D5CD040A-B516-438A-972F-8ED8CDC5F1F6}" type="pres">
      <dgm:prSet presAssocID="{7D4974A8-D315-42CC-B9BB-A3A5CD5225A3}" presName="connTx" presStyleLbl="parChTrans1D3" presStyleIdx="21" presStyleCnt="29"/>
      <dgm:spPr/>
    </dgm:pt>
    <dgm:pt modelId="{53EE630F-B50A-4E44-9F26-7A437E403F30}" type="pres">
      <dgm:prSet presAssocID="{4C4B97E3-F5BD-4198-B4CF-00796D7DABC4}" presName="root2" presStyleCnt="0"/>
      <dgm:spPr/>
    </dgm:pt>
    <dgm:pt modelId="{0F72C090-6894-4EAC-91C9-4AB4F7819088}" type="pres">
      <dgm:prSet presAssocID="{4C4B97E3-F5BD-4198-B4CF-00796D7DABC4}" presName="LevelTwoTextNode" presStyleLbl="node3" presStyleIdx="21" presStyleCnt="29" custScaleX="1600945" custScaleY="348054" custLinFactX="572839" custLinFactNeighborX="600000" custLinFactNeighborY="39381">
        <dgm:presLayoutVars>
          <dgm:chPref val="3"/>
        </dgm:presLayoutVars>
      </dgm:prSet>
      <dgm:spPr/>
    </dgm:pt>
    <dgm:pt modelId="{29CFB243-3B0B-48A1-BA31-68AEECA8538E}" type="pres">
      <dgm:prSet presAssocID="{4C4B97E3-F5BD-4198-B4CF-00796D7DABC4}" presName="level3hierChild" presStyleCnt="0"/>
      <dgm:spPr/>
    </dgm:pt>
    <dgm:pt modelId="{6AB18905-010D-4722-AD52-A8029684E429}" type="pres">
      <dgm:prSet presAssocID="{AA6D12B2-DCA4-4A02-AF03-C8580B7BB7CB}" presName="conn2-1" presStyleLbl="parChTrans1D3" presStyleIdx="22" presStyleCnt="29" custSzX="14400001"/>
      <dgm:spPr/>
    </dgm:pt>
    <dgm:pt modelId="{029D14F4-73D5-48A5-9409-1B7CD1A98ED4}" type="pres">
      <dgm:prSet presAssocID="{AA6D12B2-DCA4-4A02-AF03-C8580B7BB7CB}" presName="connTx" presStyleLbl="parChTrans1D3" presStyleIdx="22" presStyleCnt="29"/>
      <dgm:spPr/>
    </dgm:pt>
    <dgm:pt modelId="{7543E19F-1B2D-40F5-8A03-204EE3BF2B6C}" type="pres">
      <dgm:prSet presAssocID="{C8881E16-4787-451C-81F6-A6E1C5F25824}" presName="root2" presStyleCnt="0"/>
      <dgm:spPr/>
    </dgm:pt>
    <dgm:pt modelId="{93ED179E-6CE9-427B-AFAE-295FB95A4083}" type="pres">
      <dgm:prSet presAssocID="{C8881E16-4787-451C-81F6-A6E1C5F25824}" presName="LevelTwoTextNode" presStyleLbl="node3" presStyleIdx="22" presStyleCnt="29" custScaleX="1600945" custScaleY="348054" custLinFactX="574250" custLinFactNeighborX="600000" custLinFactNeighborY="87952">
        <dgm:presLayoutVars>
          <dgm:chPref val="3"/>
        </dgm:presLayoutVars>
      </dgm:prSet>
      <dgm:spPr/>
    </dgm:pt>
    <dgm:pt modelId="{2A0D38E4-EC3B-4BAE-ADB2-23C127B643DB}" type="pres">
      <dgm:prSet presAssocID="{C8881E16-4787-451C-81F6-A6E1C5F25824}" presName="level3hierChild" presStyleCnt="0"/>
      <dgm:spPr/>
    </dgm:pt>
    <dgm:pt modelId="{B3990D9E-965A-4A87-9024-A31D8C18D9AC}" type="pres">
      <dgm:prSet presAssocID="{A7EB2E53-A0F7-41F9-9F6A-A28410E699DB}" presName="conn2-1" presStyleLbl="parChTrans1D3" presStyleIdx="23" presStyleCnt="29" custSzX="14400005"/>
      <dgm:spPr/>
    </dgm:pt>
    <dgm:pt modelId="{C4665A5D-7A69-4FC2-9029-35B5452AAAD6}" type="pres">
      <dgm:prSet presAssocID="{A7EB2E53-A0F7-41F9-9F6A-A28410E699DB}" presName="connTx" presStyleLbl="parChTrans1D3" presStyleIdx="23" presStyleCnt="29"/>
      <dgm:spPr/>
    </dgm:pt>
    <dgm:pt modelId="{F5AD516C-03B4-44A2-8D7F-A01D980EC8F6}" type="pres">
      <dgm:prSet presAssocID="{1AACD66D-838A-4857-A8DC-3EF6272EECE2}" presName="root2" presStyleCnt="0"/>
      <dgm:spPr/>
    </dgm:pt>
    <dgm:pt modelId="{55C48720-204C-4364-9D3A-54C5764186B5}" type="pres">
      <dgm:prSet presAssocID="{1AACD66D-838A-4857-A8DC-3EF6272EECE2}" presName="LevelTwoTextNode" presStyleLbl="node3" presStyleIdx="23" presStyleCnt="29" custScaleX="1600945" custScaleY="715120" custLinFactX="572640" custLinFactY="34528" custLinFactNeighborX="600000" custLinFactNeighborY="100000">
        <dgm:presLayoutVars>
          <dgm:chPref val="3"/>
        </dgm:presLayoutVars>
      </dgm:prSet>
      <dgm:spPr/>
    </dgm:pt>
    <dgm:pt modelId="{6F03AD0E-EAEA-491F-81D8-AED0C9D56D57}" type="pres">
      <dgm:prSet presAssocID="{1AACD66D-838A-4857-A8DC-3EF6272EECE2}" presName="level3hierChild" presStyleCnt="0"/>
      <dgm:spPr/>
    </dgm:pt>
    <dgm:pt modelId="{77548836-C3C7-4F26-AB2C-7B9D48F92339}" type="pres">
      <dgm:prSet presAssocID="{AF9EC442-AE64-421C-9DF3-0ED0B18D4EC6}" presName="conn2-1" presStyleLbl="parChTrans1D3" presStyleIdx="24" presStyleCnt="29" custSzX="14400004"/>
      <dgm:spPr/>
    </dgm:pt>
    <dgm:pt modelId="{D315BFC2-F4AA-453C-BEEE-7A8513151049}" type="pres">
      <dgm:prSet presAssocID="{AF9EC442-AE64-421C-9DF3-0ED0B18D4EC6}" presName="connTx" presStyleLbl="parChTrans1D3" presStyleIdx="24" presStyleCnt="29"/>
      <dgm:spPr/>
    </dgm:pt>
    <dgm:pt modelId="{5C1C1437-237B-4D2F-972C-182C150A65D7}" type="pres">
      <dgm:prSet presAssocID="{139D31B5-E436-4EC0-97A7-7F66DB8AA5D7}" presName="root2" presStyleCnt="0"/>
      <dgm:spPr/>
    </dgm:pt>
    <dgm:pt modelId="{58A40D43-4424-4837-A5A1-19217FD9A569}" type="pres">
      <dgm:prSet presAssocID="{139D31B5-E436-4EC0-97A7-7F66DB8AA5D7}" presName="LevelTwoTextNode" presStyleLbl="node3" presStyleIdx="24" presStyleCnt="29" custScaleX="1600945" custScaleY="348054" custLinFactX="567064" custLinFactY="77879" custLinFactNeighborX="600000" custLinFactNeighborY="100000">
        <dgm:presLayoutVars>
          <dgm:chPref val="3"/>
        </dgm:presLayoutVars>
      </dgm:prSet>
      <dgm:spPr/>
    </dgm:pt>
    <dgm:pt modelId="{1CD09DDF-64D1-4B28-B2BA-D1CA4F7E8EBD}" type="pres">
      <dgm:prSet presAssocID="{139D31B5-E436-4EC0-97A7-7F66DB8AA5D7}" presName="level3hierChild" presStyleCnt="0"/>
      <dgm:spPr/>
    </dgm:pt>
    <dgm:pt modelId="{616D48F1-5BF9-475C-A680-5A4648439758}" type="pres">
      <dgm:prSet presAssocID="{493FD3B1-4C0C-4AB6-93B7-144BA121C706}" presName="conn2-1" presStyleLbl="parChTrans1D3" presStyleIdx="25" presStyleCnt="29" custSzX="14400001"/>
      <dgm:spPr/>
    </dgm:pt>
    <dgm:pt modelId="{6A5659FF-62AA-4A8C-B658-A072CD59A9AB}" type="pres">
      <dgm:prSet presAssocID="{493FD3B1-4C0C-4AB6-93B7-144BA121C706}" presName="connTx" presStyleLbl="parChTrans1D3" presStyleIdx="25" presStyleCnt="29"/>
      <dgm:spPr/>
    </dgm:pt>
    <dgm:pt modelId="{B46B9E47-28AB-4556-93A1-61511E051437}" type="pres">
      <dgm:prSet presAssocID="{1526BD2C-5491-407F-8729-1EE2B6B3A855}" presName="root2" presStyleCnt="0"/>
      <dgm:spPr/>
    </dgm:pt>
    <dgm:pt modelId="{AC865C7C-D34F-4978-B07D-384D670F1E47}" type="pres">
      <dgm:prSet presAssocID="{1526BD2C-5491-407F-8729-1EE2B6B3A855}" presName="LevelTwoTextNode" presStyleLbl="node3" presStyleIdx="25" presStyleCnt="29" custScaleX="1600945" custScaleY="348054" custLinFactX="572647" custLinFactY="100000" custLinFactNeighborX="600000" custLinFactNeighborY="137029">
        <dgm:presLayoutVars>
          <dgm:chPref val="3"/>
        </dgm:presLayoutVars>
      </dgm:prSet>
      <dgm:spPr/>
    </dgm:pt>
    <dgm:pt modelId="{4636BF3F-FB11-41F8-AD53-27057F815E44}" type="pres">
      <dgm:prSet presAssocID="{1526BD2C-5491-407F-8729-1EE2B6B3A855}" presName="level3hierChild" presStyleCnt="0"/>
      <dgm:spPr/>
    </dgm:pt>
    <dgm:pt modelId="{0534A5B7-9C7A-4B37-8658-B389BC363051}" type="pres">
      <dgm:prSet presAssocID="{064DB9D2-173A-4CFB-BE23-C2F5395E90CE}" presName="conn2-1" presStyleLbl="parChTrans1D3" presStyleIdx="26" presStyleCnt="29" custSzX="14400001"/>
      <dgm:spPr/>
    </dgm:pt>
    <dgm:pt modelId="{57096B24-8CD4-406B-927F-3FABEDAA0D69}" type="pres">
      <dgm:prSet presAssocID="{064DB9D2-173A-4CFB-BE23-C2F5395E90CE}" presName="connTx" presStyleLbl="parChTrans1D3" presStyleIdx="26" presStyleCnt="29"/>
      <dgm:spPr/>
    </dgm:pt>
    <dgm:pt modelId="{1DE5FA74-54E7-473E-99BC-89B7AB6B71BE}" type="pres">
      <dgm:prSet presAssocID="{0427F775-9407-4A06-A301-D22BFE5F9A2F}" presName="root2" presStyleCnt="0"/>
      <dgm:spPr/>
    </dgm:pt>
    <dgm:pt modelId="{4B059EDE-FDEA-4C68-BB44-42AF88AE4840}" type="pres">
      <dgm:prSet presAssocID="{0427F775-9407-4A06-A301-D22BFE5F9A2F}" presName="LevelTwoTextNode" presStyleLbl="node3" presStyleIdx="26" presStyleCnt="29" custScaleX="1600945" custScaleY="348054" custLinFactX="571615" custLinFactY="100000" custLinFactNeighborX="600000" custLinFactNeighborY="197195">
        <dgm:presLayoutVars>
          <dgm:chPref val="3"/>
        </dgm:presLayoutVars>
      </dgm:prSet>
      <dgm:spPr/>
    </dgm:pt>
    <dgm:pt modelId="{C7AC535D-4EF6-4344-BDD7-25229982B388}" type="pres">
      <dgm:prSet presAssocID="{0427F775-9407-4A06-A301-D22BFE5F9A2F}" presName="level3hierChild" presStyleCnt="0"/>
      <dgm:spPr/>
    </dgm:pt>
    <dgm:pt modelId="{06162D70-667D-4321-A2A5-50E71EC54502}" type="pres">
      <dgm:prSet presAssocID="{895AD288-8C3F-4FEF-8348-DE71D8D3CA8C}" presName="conn2-1" presStyleLbl="parChTrans1D2" presStyleIdx="4" presStyleCnt="5" custSzX="14400010"/>
      <dgm:spPr/>
    </dgm:pt>
    <dgm:pt modelId="{9EDF16DF-0468-41C5-93DA-122D14D8465F}" type="pres">
      <dgm:prSet presAssocID="{895AD288-8C3F-4FEF-8348-DE71D8D3CA8C}" presName="connTx" presStyleLbl="parChTrans1D2" presStyleIdx="4" presStyleCnt="5"/>
      <dgm:spPr/>
    </dgm:pt>
    <dgm:pt modelId="{4E419202-E138-4240-93A2-456AC2B2742F}" type="pres">
      <dgm:prSet presAssocID="{4E60B1B3-870B-4A1B-9517-73B33DCA2C20}" presName="root2" presStyleCnt="0"/>
      <dgm:spPr/>
    </dgm:pt>
    <dgm:pt modelId="{DDF72957-287B-449A-A1C9-C4F10755C0F8}" type="pres">
      <dgm:prSet presAssocID="{4E60B1B3-870B-4A1B-9517-73B33DCA2C20}" presName="LevelTwoTextNode" presStyleLbl="node2" presStyleIdx="4" presStyleCnt="5" custScaleX="1120331" custScaleY="716455" custLinFactX="-1100000" custLinFactY="-239058" custLinFactNeighborX="-1112643" custLinFactNeighborY="-300000">
        <dgm:presLayoutVars>
          <dgm:chPref val="3"/>
        </dgm:presLayoutVars>
      </dgm:prSet>
      <dgm:spPr/>
    </dgm:pt>
    <dgm:pt modelId="{05ECC4B5-9675-4F0D-8C38-19D9BB077CA3}" type="pres">
      <dgm:prSet presAssocID="{4E60B1B3-870B-4A1B-9517-73B33DCA2C20}" presName="level3hierChild" presStyleCnt="0"/>
      <dgm:spPr/>
    </dgm:pt>
    <dgm:pt modelId="{39CD6B7A-D9CD-49C5-B1C3-2BF6CA65E035}" type="pres">
      <dgm:prSet presAssocID="{2A9BE497-61AC-492C-9E1D-96073DB72DE2}" presName="conn2-1" presStyleLbl="parChTrans1D3" presStyleIdx="27" presStyleCnt="29" custSzX="14400152"/>
      <dgm:spPr/>
    </dgm:pt>
    <dgm:pt modelId="{B84FD6DC-6F83-483B-A6F6-D1143D7FCD3D}" type="pres">
      <dgm:prSet presAssocID="{2A9BE497-61AC-492C-9E1D-96073DB72DE2}" presName="connTx" presStyleLbl="parChTrans1D3" presStyleIdx="27" presStyleCnt="29"/>
      <dgm:spPr/>
    </dgm:pt>
    <dgm:pt modelId="{40BB6ACB-057D-4260-AB2B-BDED580401D0}" type="pres">
      <dgm:prSet presAssocID="{89246641-77CD-487A-83F2-C7F1200B9CD3}" presName="root2" presStyleCnt="0"/>
      <dgm:spPr/>
    </dgm:pt>
    <dgm:pt modelId="{800253CE-BB59-4266-9CEA-CEBDA03E4027}" type="pres">
      <dgm:prSet presAssocID="{89246641-77CD-487A-83F2-C7F1200B9CD3}" presName="LevelTwoTextNode" presStyleLbl="node3" presStyleIdx="27" presStyleCnt="29" custScaleX="1575914" custScaleY="327903" custLinFactX="-724025" custLinFactY="-262690" custLinFactNeighborX="-800000" custLinFactNeighborY="-300000">
        <dgm:presLayoutVars>
          <dgm:chPref val="3"/>
        </dgm:presLayoutVars>
      </dgm:prSet>
      <dgm:spPr/>
    </dgm:pt>
    <dgm:pt modelId="{F411FA26-74A1-460C-ABAE-D2DD5B610286}" type="pres">
      <dgm:prSet presAssocID="{89246641-77CD-487A-83F2-C7F1200B9CD3}" presName="level3hierChild" presStyleCnt="0"/>
      <dgm:spPr/>
    </dgm:pt>
    <dgm:pt modelId="{83DAAF3F-DBF1-49B0-8604-B525FB5C908A}" type="pres">
      <dgm:prSet presAssocID="{1A98DB96-17DF-475F-B57D-AA7AEC31238C}" presName="conn2-1" presStyleLbl="parChTrans1D3" presStyleIdx="28" presStyleCnt="29" custSzX="14400131"/>
      <dgm:spPr/>
    </dgm:pt>
    <dgm:pt modelId="{3CA6E368-4B5A-4A8C-BA3F-B3AD90C9E9E9}" type="pres">
      <dgm:prSet presAssocID="{1A98DB96-17DF-475F-B57D-AA7AEC31238C}" presName="connTx" presStyleLbl="parChTrans1D3" presStyleIdx="28" presStyleCnt="29"/>
      <dgm:spPr/>
    </dgm:pt>
    <dgm:pt modelId="{7C15682E-E524-46DA-82C6-F952A81CACA0}" type="pres">
      <dgm:prSet presAssocID="{6125DCFA-27DB-435B-BEA4-88B2190500A1}" presName="root2" presStyleCnt="0"/>
      <dgm:spPr/>
    </dgm:pt>
    <dgm:pt modelId="{914215F8-CB99-49A5-92BE-A5364C5EF1A5}" type="pres">
      <dgm:prSet presAssocID="{6125DCFA-27DB-435B-BEA4-88B2190500A1}" presName="LevelTwoTextNode" presStyleLbl="node3" presStyleIdx="28" presStyleCnt="29" custScaleX="1575914" custScaleY="327901" custLinFactX="-724024" custLinFactY="-200000" custLinFactNeighborX="-800000" custLinFactNeighborY="-281087">
        <dgm:presLayoutVars>
          <dgm:chPref val="3"/>
        </dgm:presLayoutVars>
      </dgm:prSet>
      <dgm:spPr/>
    </dgm:pt>
    <dgm:pt modelId="{F6AF657D-F445-4FBE-AA16-B88EE08E3861}" type="pres">
      <dgm:prSet presAssocID="{6125DCFA-27DB-435B-BEA4-88B2190500A1}" presName="level3hierChild" presStyleCnt="0"/>
      <dgm:spPr/>
    </dgm:pt>
  </dgm:ptLst>
  <dgm:cxnLst>
    <dgm:cxn modelId="{28926F01-4C50-42E8-B91C-EB4AB276390F}" srcId="{A7E59208-D8C8-472E-BF12-F8E4CF3114A2}" destId="{3CF53495-E7A9-4FFB-983F-8FC85A5AADF1}" srcOrd="0" destOrd="0" parTransId="{96C75850-7C10-4A02-8605-049A49CD2E2D}" sibTransId="{D9F24578-11A8-4686-B575-3BEBFF1584D9}"/>
    <dgm:cxn modelId="{0A0CF701-79B2-47F2-8622-FC36046D2926}" srcId="{5E805EC3-C58D-4BD5-A99E-B5CA51F30872}" destId="{4C9D4A9F-DD4B-450F-BD60-CED00D3393A2}" srcOrd="2" destOrd="0" parTransId="{1731A452-294D-4C69-97EA-ABFB841FA0AB}" sibTransId="{71D5611E-9C7C-4282-88EB-4D6B84C36EA4}"/>
    <dgm:cxn modelId="{795F5A02-DA6A-42B0-9552-BF91B1BAF7C4}" type="presOf" srcId="{26FE1203-5ADF-4E90-A8D9-0247D9F49394}" destId="{85D196B6-063E-44EA-88B6-502D03441A95}" srcOrd="0" destOrd="0" presId="urn:microsoft.com/office/officeart/2005/8/layout/hierarchy2"/>
    <dgm:cxn modelId="{0292F002-650B-49D0-AE03-C8DDF4B97AC1}" srcId="{5BEDA607-8DED-42F2-9BA0-692D403C0EC7}" destId="{109BE932-8DDB-46FE-93F1-0C28F0100D1E}" srcOrd="4" destOrd="0" parTransId="{6F25122C-9DC2-4635-960D-7ABCFA19A050}" sibTransId="{A744AE17-7DC2-4DEE-8DD3-48BA06300DB6}"/>
    <dgm:cxn modelId="{CAFAE303-3DC3-4537-9772-86B9E5063BC8}" srcId="{4DCC093E-5118-4588-BF05-784A120C438E}" destId="{E7091F61-EB43-4F07-B67B-2EE2EED76652}" srcOrd="5" destOrd="0" parTransId="{010FD920-EA56-439A-976D-37845A8E9EE8}" sibTransId="{E9EE7CCA-3E70-4442-89A7-97C9D193AFA2}"/>
    <dgm:cxn modelId="{10E7BB04-8034-4A73-BDED-663C3B2D9FEB}" type="presOf" srcId="{84547787-FAB0-4D90-A3B1-62ECE02E3768}" destId="{740522B2-75E3-4986-BE71-6201CAF74879}" srcOrd="1" destOrd="0" presId="urn:microsoft.com/office/officeart/2005/8/layout/hierarchy2"/>
    <dgm:cxn modelId="{94199405-C4AF-4981-BB8E-1CD2D5B12077}" srcId="{26FE1203-5ADF-4E90-A8D9-0247D9F49394}" destId="{9A5197BB-7B1D-4DC8-A917-46D969DA792E}" srcOrd="0" destOrd="0" parTransId="{03C2E030-813C-4887-94E5-82269C93F63C}" sibTransId="{A996E5A6-72C3-45F3-B265-EB01532B76AD}"/>
    <dgm:cxn modelId="{CF4E620A-9AD3-4C56-8996-7BC265D0C439}" srcId="{4DCC093E-5118-4588-BF05-784A120C438E}" destId="{B18AAAC7-07A3-44B8-A053-45D1FF816FFD}" srcOrd="4" destOrd="0" parTransId="{F79E2E4E-D09E-4761-9D42-D0B633170619}" sibTransId="{72E1387F-70BB-477C-B1AA-2ABCDA2AC2A1}"/>
    <dgm:cxn modelId="{C387F40B-DFA9-474A-9874-C47292BE7553}" type="presOf" srcId="{84547787-FAB0-4D90-A3B1-62ECE02E3768}" destId="{6C074D18-1EA0-40FB-94A6-DD4C52B7D46C}" srcOrd="0" destOrd="0" presId="urn:microsoft.com/office/officeart/2005/8/layout/hierarchy2"/>
    <dgm:cxn modelId="{171C8B0C-881B-4B3B-894B-FD7D7E222816}" srcId="{4E60B1B3-870B-4A1B-9517-73B33DCA2C20}" destId="{89246641-77CD-487A-83F2-C7F1200B9CD3}" srcOrd="0" destOrd="0" parTransId="{2A9BE497-61AC-492C-9E1D-96073DB72DE2}" sibTransId="{8FE26FC0-4536-4E72-BA73-6E6DB87FDB86}"/>
    <dgm:cxn modelId="{993E970D-AEB1-4F79-A5D6-442CCF3116C7}" type="presOf" srcId="{6F25122C-9DC2-4635-960D-7ABCFA19A050}" destId="{FCAF4F74-DA65-4B57-BED5-BD3F26CA3653}" srcOrd="0" destOrd="0" presId="urn:microsoft.com/office/officeart/2005/8/layout/hierarchy2"/>
    <dgm:cxn modelId="{9386AE0E-2F7B-4B2D-A2A0-8ED89691D55E}" srcId="{5BEDA607-8DED-42F2-9BA0-692D403C0EC7}" destId="{518E9C13-B9BA-4F04-A7EC-F36C8D246639}" srcOrd="3" destOrd="0" parTransId="{FB410C4C-ACA6-43C1-94D1-C7A844E0F3B3}" sibTransId="{5BB641B2-739A-4F95-9858-A0BD6DA4CF4F}"/>
    <dgm:cxn modelId="{234F9010-5139-42E0-80F6-0F2D307A11F3}" srcId="{4DCC093E-5118-4588-BF05-784A120C438E}" destId="{0427F775-9407-4A06-A301-D22BFE5F9A2F}" srcOrd="12" destOrd="0" parTransId="{064DB9D2-173A-4CFB-BE23-C2F5395E90CE}" sibTransId="{284BA064-CA16-40B8-ABB6-39297C736969}"/>
    <dgm:cxn modelId="{DB66B812-E1E0-45FC-BB26-4974FD34809F}" srcId="{26FE1203-5ADF-4E90-A8D9-0247D9F49394}" destId="{2F02F2CE-1BCD-446E-BECB-6973E7ACA9E4}" srcOrd="1" destOrd="0" parTransId="{D40E33C4-65A6-43F0-8A5A-668871AD40F3}" sibTransId="{D22232FC-EFFC-4ED5-BFEA-E170EC048C0E}"/>
    <dgm:cxn modelId="{D8292315-BD87-4142-A496-C8850E8504B4}" type="presOf" srcId="{4C9D4A9F-DD4B-450F-BD60-CED00D3393A2}" destId="{049F2968-73E2-4348-A8D7-E885F2B2F00E}" srcOrd="0" destOrd="0" presId="urn:microsoft.com/office/officeart/2005/8/layout/hierarchy2"/>
    <dgm:cxn modelId="{A9302518-6ADB-4EFD-9798-25FD8FC5D3C1}" srcId="{F4B2B415-9F5D-4A5C-A517-33028F9EDE23}" destId="{B87C2DC1-653F-4929-9260-6C6E30534E07}" srcOrd="4" destOrd="0" parTransId="{3B2039F4-2BA1-4802-A7AA-25308413273C}" sibTransId="{D969B3C1-13FB-4D01-8F61-046C91361577}"/>
    <dgm:cxn modelId="{1714F218-14F6-4E9E-B0F3-59D39F508675}" type="presOf" srcId="{1AACD66D-838A-4857-A8DC-3EF6272EECE2}" destId="{55C48720-204C-4364-9D3A-54C5764186B5}" srcOrd="0" destOrd="0" presId="urn:microsoft.com/office/officeart/2005/8/layout/hierarchy2"/>
    <dgm:cxn modelId="{58F3D619-C819-4165-9832-15B8B47FAB73}" type="presOf" srcId="{1930F7C4-5EB2-4BFC-B652-6F6645AD8029}" destId="{FC687F4F-95AF-4388-A390-2F0E64666848}" srcOrd="0" destOrd="0" presId="urn:microsoft.com/office/officeart/2005/8/layout/hierarchy2"/>
    <dgm:cxn modelId="{53DBED19-15A7-46E9-973A-9D264D591D01}" type="presOf" srcId="{064DB9D2-173A-4CFB-BE23-C2F5395E90CE}" destId="{0534A5B7-9C7A-4B37-8658-B389BC363051}" srcOrd="0" destOrd="0" presId="urn:microsoft.com/office/officeart/2005/8/layout/hierarchy2"/>
    <dgm:cxn modelId="{05F6961A-A220-4985-B2C8-B5A6245F70D8}" type="presOf" srcId="{D40E33C4-65A6-43F0-8A5A-668871AD40F3}" destId="{16EDC4EB-15B1-4BED-A913-C4910A592E43}" srcOrd="0" destOrd="0" presId="urn:microsoft.com/office/officeart/2005/8/layout/hierarchy2"/>
    <dgm:cxn modelId="{C9F2961B-5CC2-48E5-BAEE-534D951C12BF}" type="presOf" srcId="{2F8F9AB3-8452-43EC-87B2-17B5891BF608}" destId="{CBE2BF13-B4B2-4CCE-B9CD-9C2AE1DB9827}" srcOrd="0" destOrd="0" presId="urn:microsoft.com/office/officeart/2005/8/layout/hierarchy2"/>
    <dgm:cxn modelId="{B622461C-ABE9-40E4-898D-4C86EA57E67A}" type="presOf" srcId="{425A3179-1413-4460-9678-40448B2E5A42}" destId="{4422E06E-D77E-4F56-8840-95885C852043}" srcOrd="0" destOrd="0" presId="urn:microsoft.com/office/officeart/2005/8/layout/hierarchy2"/>
    <dgm:cxn modelId="{9CEDC11C-136F-41B2-8B1A-7F65506AA089}" srcId="{5BEDA607-8DED-42F2-9BA0-692D403C0EC7}" destId="{9EEC29B6-B262-48C2-8C7F-8D2337E7AA42}" srcOrd="1" destOrd="0" parTransId="{BE23815E-A548-4C9A-9302-6B0219BE53D6}" sibTransId="{41B53EC5-CB3D-457D-A5B5-3DED8454A648}"/>
    <dgm:cxn modelId="{7E741121-3465-4D04-BF60-56919F6F4B45}" srcId="{353C6F70-9685-47CA-B6F4-8BAAB244C13E}" destId="{5E805EC3-C58D-4BD5-A99E-B5CA51F30872}" srcOrd="0" destOrd="0" parTransId="{F855B30C-366F-4036-B5AE-48974C07A80E}" sibTransId="{B59D055C-2884-474E-9D56-8022BD751C43}"/>
    <dgm:cxn modelId="{36599623-182A-480E-BBAC-966ED1CF3002}" srcId="{5BEDA607-8DED-42F2-9BA0-692D403C0EC7}" destId="{26FE1203-5ADF-4E90-A8D9-0247D9F49394}" srcOrd="0" destOrd="0" parTransId="{07D04FA9-5869-4D23-B691-B49B006E8BC9}" sibTransId="{A7D50C71-D674-4373-B823-7229A869B85A}"/>
    <dgm:cxn modelId="{83FD3924-D776-40C1-BC51-6CDC49E47891}" type="presOf" srcId="{518E9C13-B9BA-4F04-A7EC-F36C8D246639}" destId="{EC3C7E9C-DE6F-4CF5-B8A3-EB96093DECF2}" srcOrd="0" destOrd="0" presId="urn:microsoft.com/office/officeart/2005/8/layout/hierarchy2"/>
    <dgm:cxn modelId="{66014825-61F1-476E-BD5A-9231CDFD9B14}" type="presOf" srcId="{1731A452-294D-4C69-97EA-ABFB841FA0AB}" destId="{B99573E9-A46B-4C67-A741-44E4FCB4FC8A}" srcOrd="0" destOrd="0" presId="urn:microsoft.com/office/officeart/2005/8/layout/hierarchy2"/>
    <dgm:cxn modelId="{5AC37025-FB0C-494E-AC6F-47ECD5EFB559}" type="presOf" srcId="{9A5197BB-7B1D-4DC8-A917-46D969DA792E}" destId="{29B3ABBF-0291-41BA-9070-E0CB070E1723}" srcOrd="0" destOrd="0" presId="urn:microsoft.com/office/officeart/2005/8/layout/hierarchy2"/>
    <dgm:cxn modelId="{804E502C-F68B-43F0-B577-A94326A81C84}" type="presOf" srcId="{72696429-0052-4BF2-A3D6-BBDE6FE074F3}" destId="{D70BE76E-DF8A-41C7-B32C-B201D4602719}" srcOrd="1" destOrd="0" presId="urn:microsoft.com/office/officeart/2005/8/layout/hierarchy2"/>
    <dgm:cxn modelId="{291F772C-20F4-4C15-B3EC-1E4FEB7684CE}" srcId="{4DCC093E-5118-4588-BF05-784A120C438E}" destId="{139D31B5-E436-4EC0-97A7-7F66DB8AA5D7}" srcOrd="10" destOrd="0" parTransId="{AF9EC442-AE64-421C-9DF3-0ED0B18D4EC6}" sibTransId="{12528D3C-0831-4D11-8576-30D0B612443D}"/>
    <dgm:cxn modelId="{5C2DB32C-93DB-4F68-9A52-C26952AA7C63}" type="presOf" srcId="{F79E2E4E-D09E-4761-9D42-D0B633170619}" destId="{1DF7A0FE-D847-4A6C-886A-53CFFF4E83C7}" srcOrd="1" destOrd="0" presId="urn:microsoft.com/office/officeart/2005/8/layout/hierarchy2"/>
    <dgm:cxn modelId="{7FF0D72C-8256-4CB0-BD43-E3D69ACE2203}" type="presOf" srcId="{B87C2DC1-653F-4929-9260-6C6E30534E07}" destId="{38194E2B-8C9B-446D-93B0-01D743C0AC69}" srcOrd="0" destOrd="0" presId="urn:microsoft.com/office/officeart/2005/8/layout/hierarchy2"/>
    <dgm:cxn modelId="{ABAF072D-729E-4B57-9163-D0065AEE9336}" srcId="{4DCC093E-5118-4588-BF05-784A120C438E}" destId="{1526BD2C-5491-407F-8729-1EE2B6B3A855}" srcOrd="11" destOrd="0" parTransId="{493FD3B1-4C0C-4AB6-93B7-144BA121C706}" sibTransId="{43AD28CE-0CF1-43EF-A291-AAB3F34ECA2E}"/>
    <dgm:cxn modelId="{4A81E52E-C0B7-4257-8F3C-DB8656B79E86}" type="presOf" srcId="{5BEDA607-8DED-42F2-9BA0-692D403C0EC7}" destId="{3B5C04C0-1026-4BCC-B8D1-09CC708E27EF}" srcOrd="0" destOrd="0" presId="urn:microsoft.com/office/officeart/2005/8/layout/hierarchy2"/>
    <dgm:cxn modelId="{C2652932-C5C1-48E8-9908-A85A6B4A4AFA}" type="presOf" srcId="{96C75850-7C10-4A02-8605-049A49CD2E2D}" destId="{72B52D37-7D34-4ADE-968E-0497344DEB80}" srcOrd="1" destOrd="0" presId="urn:microsoft.com/office/officeart/2005/8/layout/hierarchy2"/>
    <dgm:cxn modelId="{EE4DD132-A251-4BA5-8356-494F3570E984}" srcId="{4DCC093E-5118-4588-BF05-784A120C438E}" destId="{1AACD66D-838A-4857-A8DC-3EF6272EECE2}" srcOrd="9" destOrd="0" parTransId="{A7EB2E53-A0F7-41F9-9F6A-A28410E699DB}" sibTransId="{ACD72424-B859-42FC-AD95-05CBCCEC32EB}"/>
    <dgm:cxn modelId="{E5FFF033-92C3-46BF-A8FF-F0AD3390E504}" type="presOf" srcId="{A7EB2E53-A0F7-41F9-9F6A-A28410E699DB}" destId="{C4665A5D-7A69-4FC2-9029-35B5452AAAD6}" srcOrd="1" destOrd="0" presId="urn:microsoft.com/office/officeart/2005/8/layout/hierarchy2"/>
    <dgm:cxn modelId="{90F35834-B666-4104-88F3-BB9F2FA3E632}" type="presOf" srcId="{FB410C4C-ACA6-43C1-94D1-C7A844E0F3B3}" destId="{B80DAFEB-A4DF-442E-B7BA-955CB74D383A}" srcOrd="1" destOrd="0" presId="urn:microsoft.com/office/officeart/2005/8/layout/hierarchy2"/>
    <dgm:cxn modelId="{BABCA734-F03C-4004-822D-5C6C262DD56D}" type="presOf" srcId="{109BE932-8DDB-46FE-93F1-0C28F0100D1E}" destId="{963787CF-28FB-43DF-98C2-C462DE3D4B6D}" srcOrd="0" destOrd="0" presId="urn:microsoft.com/office/officeart/2005/8/layout/hierarchy2"/>
    <dgm:cxn modelId="{4D21EB35-58D2-4366-9D1B-32DF647D51E6}" type="presOf" srcId="{07D04FA9-5869-4D23-B691-B49B006E8BC9}" destId="{1933032C-D9EF-4E95-9447-72395E90BD3C}" srcOrd="0" destOrd="0" presId="urn:microsoft.com/office/officeart/2005/8/layout/hierarchy2"/>
    <dgm:cxn modelId="{49466C37-4BE8-46AD-A372-9BD08D8C1F3E}" type="presOf" srcId="{AB141E1E-8A47-473D-BDC9-A740AE0EA3F7}" destId="{D7C3B540-AAE3-47B6-8689-6F42331FBB0D}" srcOrd="0" destOrd="0" presId="urn:microsoft.com/office/officeart/2005/8/layout/hierarchy2"/>
    <dgm:cxn modelId="{D3611739-A676-412C-BEA5-41831881B894}" type="presOf" srcId="{B9C65307-6730-4D84-A9EC-F5E07D061332}" destId="{D4B8489D-29A0-450D-846E-6780D2436C16}" srcOrd="0" destOrd="0" presId="urn:microsoft.com/office/officeart/2005/8/layout/hierarchy2"/>
    <dgm:cxn modelId="{E1EECC3A-612D-4A36-9D5E-657AC950EA7D}" type="presOf" srcId="{010FD920-EA56-439A-976D-37845A8E9EE8}" destId="{134D7A88-2D4D-4FE0-A203-5D2DFDE9B8B0}" srcOrd="0" destOrd="0" presId="urn:microsoft.com/office/officeart/2005/8/layout/hierarchy2"/>
    <dgm:cxn modelId="{FE22743B-5CE1-4587-B152-F07517BB420D}" type="presOf" srcId="{760F7733-46EF-4539-A2FB-454CD8F95E50}" destId="{22457488-96D2-492A-A67D-1DA42B35C92F}" srcOrd="0" destOrd="0" presId="urn:microsoft.com/office/officeart/2005/8/layout/hierarchy2"/>
    <dgm:cxn modelId="{3160B13C-405E-4042-9A63-BD2CD7CB824F}" srcId="{3B6E185B-6A1C-411C-B39C-F27A6010733C}" destId="{0EF4F3AF-041E-4FDF-983F-FF187C733655}" srcOrd="0" destOrd="0" parTransId="{1A36E4A0-3C95-4A7E-8403-6FC00333987E}" sibTransId="{F28EBEB7-D767-4F82-B6D2-883ABD1AD9BF}"/>
    <dgm:cxn modelId="{A4C9B23C-5196-4A21-9C6A-A300E70E09A3}" srcId="{5E805EC3-C58D-4BD5-A99E-B5CA51F30872}" destId="{358A984D-84A8-4882-B614-7818D9052477}" srcOrd="1" destOrd="0" parTransId="{8C8C0F98-AF8B-47BC-ACBA-EC4EA96F1883}" sibTransId="{FB721D93-4426-41AA-BDE6-2476D51C93FF}"/>
    <dgm:cxn modelId="{B9DE823E-B6E7-42D2-8A94-444038183F86}" type="presOf" srcId="{C6A0CEB6-9E0F-4493-8DE5-DBE1EBED4241}" destId="{363F3F8F-4CCA-4730-9344-E43FC3582DD0}" srcOrd="1" destOrd="0" presId="urn:microsoft.com/office/officeart/2005/8/layout/hierarchy2"/>
    <dgm:cxn modelId="{6DE0893F-B247-4E43-8300-4268C1AE9B97}" type="presOf" srcId="{3CF53495-E7A9-4FFB-983F-8FC85A5AADF1}" destId="{3F552C8C-859A-4030-A503-8872BA917E0A}" srcOrd="0" destOrd="0" presId="urn:microsoft.com/office/officeart/2005/8/layout/hierarchy2"/>
    <dgm:cxn modelId="{599C7741-D5A5-42DF-BD8C-6782D1ABCBC9}" type="presOf" srcId="{21F29C5E-B439-428D-89D6-0B6C5058BC6D}" destId="{14C8F2DC-5402-4C02-AEC9-5324C6C4963A}" srcOrd="1" destOrd="0" presId="urn:microsoft.com/office/officeart/2005/8/layout/hierarchy2"/>
    <dgm:cxn modelId="{0EDAB841-CCEC-4A76-ABF4-E427F12CBF77}" type="presOf" srcId="{A1B0E159-B1C8-4060-A4E0-14F2712C19F0}" destId="{B814C4C0-4FD5-42D0-888F-22B47EF7775E}" srcOrd="1" destOrd="0" presId="urn:microsoft.com/office/officeart/2005/8/layout/hierarchy2"/>
    <dgm:cxn modelId="{1B735042-1CE9-4380-9204-33A4EF828EA4}" type="presOf" srcId="{E7091F61-EB43-4F07-B67B-2EE2EED76652}" destId="{3E90B72A-F33B-4C19-AA15-D10953CC4340}" srcOrd="0" destOrd="0" presId="urn:microsoft.com/office/officeart/2005/8/layout/hierarchy2"/>
    <dgm:cxn modelId="{DEEA8D42-3607-4DE8-9F8C-1FBBAC4983DE}" type="presOf" srcId="{4C4B97E3-F5BD-4198-B4CF-00796D7DABC4}" destId="{0F72C090-6894-4EAC-91C9-4AB4F7819088}" srcOrd="0" destOrd="0" presId="urn:microsoft.com/office/officeart/2005/8/layout/hierarchy2"/>
    <dgm:cxn modelId="{1998B242-00F1-4CEC-93EF-0F4D48861C0E}" type="presOf" srcId="{6CF7CD4C-0917-44C0-B3FE-FDC2C5B2A919}" destId="{9698C83B-59AA-460C-B76E-A13EFE8BCD17}" srcOrd="1" destOrd="0" presId="urn:microsoft.com/office/officeart/2005/8/layout/hierarchy2"/>
    <dgm:cxn modelId="{9BE90D45-2873-4BF4-B9CF-0178F530F060}" type="presOf" srcId="{895AD288-8C3F-4FEF-8348-DE71D8D3CA8C}" destId="{06162D70-667D-4321-A2A5-50E71EC54502}" srcOrd="0" destOrd="0" presId="urn:microsoft.com/office/officeart/2005/8/layout/hierarchy2"/>
    <dgm:cxn modelId="{B3F5674A-4402-4EB3-AE33-BA190C5A46B8}" srcId="{F4B2B415-9F5D-4A5C-A517-33028F9EDE23}" destId="{CE4A4217-0410-4729-9337-C36C75DD601B}" srcOrd="2" destOrd="0" parTransId="{539788D9-F5CD-499B-8EFE-4BDF10193421}" sibTransId="{1D71D8A5-0DC5-4C1F-8009-4A0D76746D08}"/>
    <dgm:cxn modelId="{320BDA4A-A0EB-4EC8-ADAD-5E8F5C924BB2}" type="presOf" srcId="{AF9EC442-AE64-421C-9DF3-0ED0B18D4EC6}" destId="{77548836-C3C7-4F26-AB2C-7B9D48F92339}" srcOrd="0" destOrd="0" presId="urn:microsoft.com/office/officeart/2005/8/layout/hierarchy2"/>
    <dgm:cxn modelId="{FDECB74C-72D9-4396-8CE6-848F8C3F1C3E}" type="presOf" srcId="{3B2039F4-2BA1-4802-A7AA-25308413273C}" destId="{007AF09B-7B63-4C84-BFB2-EF40ED79070D}" srcOrd="0" destOrd="0" presId="urn:microsoft.com/office/officeart/2005/8/layout/hierarchy2"/>
    <dgm:cxn modelId="{7365E84C-E0AB-49BB-AE7B-184CF01D4001}" type="presOf" srcId="{8C8C0F98-AF8B-47BC-ACBA-EC4EA96F1883}" destId="{750F2EA3-C6A2-49D8-A4E9-ECB36FFC366E}" srcOrd="0" destOrd="0" presId="urn:microsoft.com/office/officeart/2005/8/layout/hierarchy2"/>
    <dgm:cxn modelId="{F84FF34D-9027-4496-8DDA-E28AA1A98EC2}" type="presOf" srcId="{C09B2D6A-14B0-4151-BFD3-E21110A5E135}" destId="{4838F315-A0EB-4974-8233-371CFFCC1CE4}" srcOrd="0" destOrd="0" presId="urn:microsoft.com/office/officeart/2005/8/layout/hierarchy2"/>
    <dgm:cxn modelId="{4644454E-788A-4ECC-A1B6-1ECB4780A87E}" srcId="{4DCC093E-5118-4588-BF05-784A120C438E}" destId="{41D6EC2F-3103-40F0-AD9A-B96A94477A77}" srcOrd="2" destOrd="0" parTransId="{21F29C5E-B439-428D-89D6-0B6C5058BC6D}" sibTransId="{6A310679-E6DA-4236-BE0A-D973336D0C61}"/>
    <dgm:cxn modelId="{6124E14E-C616-45E8-9E06-77ADDF868362}" type="presOf" srcId="{0CC02BC8-A818-4832-81BB-32F3133B8621}" destId="{1CC6C369-6E50-42DA-A881-F2FD7708779E}" srcOrd="1" destOrd="0" presId="urn:microsoft.com/office/officeart/2005/8/layout/hierarchy2"/>
    <dgm:cxn modelId="{6EDC0D4F-EA1E-466B-BEB7-E24BB973A5FC}" type="presOf" srcId="{2F8F9AB3-8452-43EC-87B2-17B5891BF608}" destId="{BCDDDD5C-AFED-4205-A736-CCA5522531A5}" srcOrd="1" destOrd="0" presId="urn:microsoft.com/office/officeart/2005/8/layout/hierarchy2"/>
    <dgm:cxn modelId="{A0FB7E4F-44FD-4DBA-A042-6A79F97D56F4}" type="presOf" srcId="{E8E96543-F299-474B-9FCF-7801EFC57576}" destId="{8D2BE030-0831-42B2-98C2-0F6E87AD5B7D}" srcOrd="0" destOrd="0" presId="urn:microsoft.com/office/officeart/2005/8/layout/hierarchy2"/>
    <dgm:cxn modelId="{55DB3554-19B4-4F3D-83DA-D4752F78CF7E}" type="presOf" srcId="{BE23815E-A548-4C9A-9302-6B0219BE53D6}" destId="{BE69F2C5-1F16-4884-B39F-EE6B06025848}" srcOrd="0" destOrd="0" presId="urn:microsoft.com/office/officeart/2005/8/layout/hierarchy2"/>
    <dgm:cxn modelId="{810A5A54-637D-49F4-B0F1-8C07E5DA090E}" type="presOf" srcId="{6125DCFA-27DB-435B-BEA4-88B2190500A1}" destId="{914215F8-CB99-49A5-92BE-A5364C5EF1A5}" srcOrd="0" destOrd="0" presId="urn:microsoft.com/office/officeart/2005/8/layout/hierarchy2"/>
    <dgm:cxn modelId="{0CD93C55-BD44-4E41-9B56-54AAA16609B5}" type="presOf" srcId="{0427F775-9407-4A06-A301-D22BFE5F9A2F}" destId="{4B059EDE-FDEA-4C68-BB44-42AF88AE4840}" srcOrd="0" destOrd="0" presId="urn:microsoft.com/office/officeart/2005/8/layout/hierarchy2"/>
    <dgm:cxn modelId="{DA8B6458-9A29-407D-847C-4015D64F4774}" type="presOf" srcId="{AA6D12B2-DCA4-4A02-AF03-C8580B7BB7CB}" destId="{029D14F4-73D5-48A5-9409-1B7CD1A98ED4}" srcOrd="1" destOrd="0" presId="urn:microsoft.com/office/officeart/2005/8/layout/hierarchy2"/>
    <dgm:cxn modelId="{416CBB58-49CA-48D3-AD71-87B640D30FD3}" type="presOf" srcId="{F79E2E4E-D09E-4761-9D42-D0B633170619}" destId="{2E231434-ED7F-44D1-8C73-4DA73C333BE6}" srcOrd="0" destOrd="0" presId="urn:microsoft.com/office/officeart/2005/8/layout/hierarchy2"/>
    <dgm:cxn modelId="{9DED155D-6C53-47A3-B87C-8EA66F399A88}" type="presOf" srcId="{539788D9-F5CD-499B-8EFE-4BDF10193421}" destId="{FB2F6D88-F506-4847-B326-8EC15F62040F}" srcOrd="0" destOrd="0" presId="urn:microsoft.com/office/officeart/2005/8/layout/hierarchy2"/>
    <dgm:cxn modelId="{88AFD95D-4989-42FB-9A69-E7CF03E1B6E3}" type="presOf" srcId="{21F29C5E-B439-428D-89D6-0B6C5058BC6D}" destId="{82D2DBC9-D5F1-41B2-B475-FC62C3A7004B}" srcOrd="0" destOrd="0" presId="urn:microsoft.com/office/officeart/2005/8/layout/hierarchy2"/>
    <dgm:cxn modelId="{A348F95E-EC39-4B0A-B118-7067A75674BE}" srcId="{A7E59208-D8C8-472E-BF12-F8E4CF3114A2}" destId="{B9C65307-6730-4D84-A9EC-F5E07D061332}" srcOrd="2" destOrd="0" parTransId="{72696429-0052-4BF2-A3D6-BBDE6FE074F3}" sibTransId="{335D4C02-6620-4C99-B00C-8D1A5C8FA344}"/>
    <dgm:cxn modelId="{72A27E5F-70CA-465A-BF34-DE7508F5C4E0}" type="presOf" srcId="{D40E33C4-65A6-43F0-8A5A-668871AD40F3}" destId="{16FE4A7B-83F7-4D09-B9FE-7AABA7BB071E}" srcOrd="1" destOrd="0" presId="urn:microsoft.com/office/officeart/2005/8/layout/hierarchy2"/>
    <dgm:cxn modelId="{E2C6DA5F-B36D-4F88-BA3D-ED062640B494}" type="presOf" srcId="{359B501C-2EC2-4B8C-BD62-7A96D0CFC1AF}" destId="{677DE54C-6078-40B3-9FE8-CF37F7EF3F0C}" srcOrd="0" destOrd="0" presId="urn:microsoft.com/office/officeart/2005/8/layout/hierarchy2"/>
    <dgm:cxn modelId="{E9D9EE5F-B2E5-4165-9CF2-9A68B627E740}" type="presOf" srcId="{3B2039F4-2BA1-4802-A7AA-25308413273C}" destId="{1C784E67-44D5-495B-BFB2-4C4FDB887CF2}" srcOrd="1" destOrd="0" presId="urn:microsoft.com/office/officeart/2005/8/layout/hierarchy2"/>
    <dgm:cxn modelId="{0DA5FE60-70BB-4371-8D5E-DCBCF04D22FD}" type="presOf" srcId="{03C2E030-813C-4887-94E5-82269C93F63C}" destId="{39A8889A-DFEF-4793-B12D-3BA4A3083E3E}" srcOrd="0" destOrd="0" presId="urn:microsoft.com/office/officeart/2005/8/layout/hierarchy2"/>
    <dgm:cxn modelId="{89B24861-AA4B-427B-8B00-CFDBBECF146E}" type="presOf" srcId="{CEA4C598-03BA-4196-8096-D8D9940A747B}" destId="{EBD2F8EB-D76E-4ECE-AD86-C67210D41D3D}" srcOrd="1" destOrd="0" presId="urn:microsoft.com/office/officeart/2005/8/layout/hierarchy2"/>
    <dgm:cxn modelId="{F19D9763-6EC4-4C58-A212-4CB5C96C1C4B}" srcId="{353C6F70-9685-47CA-B6F4-8BAAB244C13E}" destId="{5BEDA607-8DED-42F2-9BA0-692D403C0EC7}" srcOrd="1" destOrd="0" parTransId="{84547787-FAB0-4D90-A3B1-62ECE02E3768}" sibTransId="{85E28AF0-9D48-40FF-95C5-6BCCE65C1A96}"/>
    <dgm:cxn modelId="{4A2C5E67-8424-4571-BB23-BA2ECA3579FA}" srcId="{4DCC093E-5118-4588-BF05-784A120C438E}" destId="{B8C47AF5-72F4-4882-A03A-756E7DB0314D}" srcOrd="0" destOrd="0" parTransId="{CEA4C598-03BA-4196-8096-D8D9940A747B}" sibTransId="{EC6E509A-E8EC-47FA-9CF3-59C646F77411}"/>
    <dgm:cxn modelId="{AB333D68-3F92-4449-A44F-D972443E467B}" type="presOf" srcId="{3A98E99E-5EB9-499E-9929-61172C5675F2}" destId="{0B80F301-D09A-4FB6-916E-CECF32B2F143}" srcOrd="0" destOrd="0" presId="urn:microsoft.com/office/officeart/2005/8/layout/hierarchy2"/>
    <dgm:cxn modelId="{E657CA68-7262-414C-8915-DA2904315788}" srcId="{F4B2B415-9F5D-4A5C-A517-33028F9EDE23}" destId="{1BB53B11-3670-415B-805A-CE32EE8357FF}" srcOrd="0" destOrd="0" parTransId="{CA6A9C70-223C-4BA6-B22F-E7EE9FCEF901}" sibTransId="{15B10DEE-88A1-4399-88DF-14098CAE15AD}"/>
    <dgm:cxn modelId="{9A7A4469-6431-4785-A88E-CE5D88D36955}" type="presOf" srcId="{C6A0CEB6-9E0F-4493-8DE5-DBE1EBED4241}" destId="{52995CFF-A2C0-41A9-B8F6-E167247A0F1E}" srcOrd="0" destOrd="0" presId="urn:microsoft.com/office/officeart/2005/8/layout/hierarchy2"/>
    <dgm:cxn modelId="{F03E4F69-6CE6-4C30-8469-8E8928E70355}" type="presOf" srcId="{895AD288-8C3F-4FEF-8348-DE71D8D3CA8C}" destId="{9EDF16DF-0468-41C5-93DA-122D14D8465F}" srcOrd="1" destOrd="0" presId="urn:microsoft.com/office/officeart/2005/8/layout/hierarchy2"/>
    <dgm:cxn modelId="{67948D6B-0256-4B3B-A7B3-49660316C4F2}" type="presOf" srcId="{425A3179-1413-4460-9678-40448B2E5A42}" destId="{78BB6245-6919-431D-8F6D-FEFDFE3AC3B2}" srcOrd="1" destOrd="0" presId="urn:microsoft.com/office/officeart/2005/8/layout/hierarchy2"/>
    <dgm:cxn modelId="{176A946C-5CA5-4F20-9515-6CFF3244107D}" srcId="{F4B2B415-9F5D-4A5C-A517-33028F9EDE23}" destId="{359B501C-2EC2-4B8C-BD62-7A96D0CFC1AF}" srcOrd="3" destOrd="0" parTransId="{8F1E2ECC-9C8C-4137-9CC2-148EC633E965}" sibTransId="{215BF104-439D-4F69-8669-82DF0A50A615}"/>
    <dgm:cxn modelId="{DFF9B770-3709-4E2F-8117-8D886A23F450}" type="presOf" srcId="{C09B2D6A-14B0-4151-BFD3-E21110A5E135}" destId="{E36F28F1-4932-4D2B-B680-9D2F1B515793}" srcOrd="1" destOrd="0" presId="urn:microsoft.com/office/officeart/2005/8/layout/hierarchy2"/>
    <dgm:cxn modelId="{572A4773-DAF7-49C5-BBA4-FE93C4756DDB}" type="presOf" srcId="{139D31B5-E436-4EC0-97A7-7F66DB8AA5D7}" destId="{58A40D43-4424-4837-A5A1-19217FD9A569}" srcOrd="0" destOrd="0" presId="urn:microsoft.com/office/officeart/2005/8/layout/hierarchy2"/>
    <dgm:cxn modelId="{7FAC6E76-7F26-4E09-B406-9502FCA84A7C}" type="presOf" srcId="{FB410C4C-ACA6-43C1-94D1-C7A844E0F3B3}" destId="{A20C5029-8277-4F52-A215-36A9DA1AB52E}" srcOrd="0" destOrd="0" presId="urn:microsoft.com/office/officeart/2005/8/layout/hierarchy2"/>
    <dgm:cxn modelId="{04D6DC77-F106-4C55-92DF-A7B3E0A59C0C}" srcId="{353C6F70-9685-47CA-B6F4-8BAAB244C13E}" destId="{A7E59208-D8C8-472E-BF12-F8E4CF3114A2}" srcOrd="2" destOrd="0" parTransId="{A1B0E159-B1C8-4060-A4E0-14F2712C19F0}" sibTransId="{51A6C234-0D46-49B1-9152-315F121BE747}"/>
    <dgm:cxn modelId="{A126AB78-FF01-4734-9D4B-02922D146EAB}" type="presOf" srcId="{F4B2B415-9F5D-4A5C-A517-33028F9EDE23}" destId="{15869452-7DB1-4E38-961A-AD18E7BF97A4}" srcOrd="0" destOrd="0" presId="urn:microsoft.com/office/officeart/2005/8/layout/hierarchy2"/>
    <dgm:cxn modelId="{9AA7707A-539E-4889-89B5-1389033F4728}" type="presOf" srcId="{5E84A072-2EA0-45DE-B57C-DA217CA13318}" destId="{87A49760-64CE-4CBD-BF78-45B22D2A4949}" srcOrd="0" destOrd="0" presId="urn:microsoft.com/office/officeart/2005/8/layout/hierarchy2"/>
    <dgm:cxn modelId="{B17F247B-DE53-473E-AE7F-E3D046AECE17}" type="presOf" srcId="{1A36E4A0-3C95-4A7E-8403-6FC00333987E}" destId="{04B5A4E1-0824-444B-B0DF-49A3641E7799}" srcOrd="0" destOrd="0" presId="urn:microsoft.com/office/officeart/2005/8/layout/hierarchy2"/>
    <dgm:cxn modelId="{0689377C-1BBE-430D-8305-DB6340B9BEBE}" type="presOf" srcId="{AA6D12B2-DCA4-4A02-AF03-C8580B7BB7CB}" destId="{6AB18905-010D-4722-AD52-A8029684E429}" srcOrd="0" destOrd="0" presId="urn:microsoft.com/office/officeart/2005/8/layout/hierarchy2"/>
    <dgm:cxn modelId="{8B1F417C-D57E-4A5D-BE66-6CACFE4FD74B}" srcId="{4DCC093E-5118-4588-BF05-784A120C438E}" destId="{4C4B97E3-F5BD-4198-B4CF-00796D7DABC4}" srcOrd="7" destOrd="0" parTransId="{7D4974A8-D315-42CC-B9BB-A3A5CD5225A3}" sibTransId="{2F5833B1-8B55-4651-83AB-AE1350EC55C1}"/>
    <dgm:cxn modelId="{AE20747C-286D-4E12-BE4A-F487C0D2B4F3}" type="presOf" srcId="{6F25122C-9DC2-4635-960D-7ABCFA19A050}" destId="{58DDB727-F29C-4C9B-AF2C-EA0167F90FF0}" srcOrd="1" destOrd="0" presId="urn:microsoft.com/office/officeart/2005/8/layout/hierarchy2"/>
    <dgm:cxn modelId="{908C8E7E-1A8E-4117-9A9A-5795A60ABDF5}" type="presOf" srcId="{1A98DB96-17DF-475F-B57D-AA7AEC31238C}" destId="{3CA6E368-4B5A-4A8C-BA3F-B3AD90C9E9E9}" srcOrd="1" destOrd="0" presId="urn:microsoft.com/office/officeart/2005/8/layout/hierarchy2"/>
    <dgm:cxn modelId="{85253C84-89B8-44D2-B134-7BDB6F14AA69}" type="presOf" srcId="{493FD3B1-4C0C-4AB6-93B7-144BA121C706}" destId="{616D48F1-5BF9-475C-A680-5A4648439758}" srcOrd="0" destOrd="0" presId="urn:microsoft.com/office/officeart/2005/8/layout/hierarchy2"/>
    <dgm:cxn modelId="{22468D87-9E8B-4AC0-A1D8-F0624582D39C}" srcId="{4DCC093E-5118-4588-BF05-784A120C438E}" destId="{F576FE14-F223-4751-B256-BF313602C91E}" srcOrd="3" destOrd="0" parTransId="{760F7733-46EF-4539-A2FB-454CD8F95E50}" sibTransId="{014EF3D8-71ED-448E-95E6-C5CAB103F661}"/>
    <dgm:cxn modelId="{5EE1DB87-1E1C-4EB4-B955-5E302A28EF82}" type="presOf" srcId="{4DCC093E-5118-4588-BF05-784A120C438E}" destId="{DDCB18A7-5217-498E-8109-AEC8891AEF63}" srcOrd="0" destOrd="0" presId="urn:microsoft.com/office/officeart/2005/8/layout/hierarchy2"/>
    <dgm:cxn modelId="{FD35F389-DEE8-421A-8AD7-7D577F5CFC02}" type="presOf" srcId="{72696429-0052-4BF2-A3D6-BBDE6FE074F3}" destId="{12649787-8B1A-4097-B62E-BBC1879F2014}" srcOrd="0" destOrd="0" presId="urn:microsoft.com/office/officeart/2005/8/layout/hierarchy2"/>
    <dgm:cxn modelId="{8726108A-CBAB-490D-9A18-E96240C38C81}" type="presOf" srcId="{493FD3B1-4C0C-4AB6-93B7-144BA121C706}" destId="{6A5659FF-62AA-4A8C-B658-A072CD59A9AB}" srcOrd="1" destOrd="0" presId="urn:microsoft.com/office/officeart/2005/8/layout/hierarchy2"/>
    <dgm:cxn modelId="{5147278B-3E0B-49CB-8D2F-890F5AEC30A8}" type="presOf" srcId="{2F02F2CE-1BCD-446E-BECB-6973E7ACA9E4}" destId="{3D93AA13-F9BF-4516-9343-01C4FE687B9F}" srcOrd="0" destOrd="0" presId="urn:microsoft.com/office/officeart/2005/8/layout/hierarchy2"/>
    <dgm:cxn modelId="{3D343B8B-1248-4DFE-8A34-AF4186B05CDE}" srcId="{A7E59208-D8C8-472E-BF12-F8E4CF3114A2}" destId="{ECD62ED1-5D11-481E-9BBC-AB020A2EFAFF}" srcOrd="1" destOrd="0" parTransId="{0CC02BC8-A818-4832-81BB-32F3133B8621}" sibTransId="{94E1BBA4-DAA9-4674-B28C-E8D1C76D9ED9}"/>
    <dgm:cxn modelId="{A3337F8B-F6A7-4497-AF59-193A5BC380DA}" srcId="{3B6E185B-6A1C-411C-B39C-F27A6010733C}" destId="{85CA1953-8DEE-44BB-BE58-B97A59C65C13}" srcOrd="1" destOrd="0" parTransId="{425A3179-1413-4460-9678-40448B2E5A42}" sibTransId="{80DB0B72-C4D4-4215-94FF-91C54AF93D83}"/>
    <dgm:cxn modelId="{F0A9C28B-8E03-4C11-AFB9-D16E408B23F6}" type="presOf" srcId="{0CC02BC8-A818-4832-81BB-32F3133B8621}" destId="{168B63D6-E582-4001-8D06-4264135971C6}" srcOrd="0" destOrd="0" presId="urn:microsoft.com/office/officeart/2005/8/layout/hierarchy2"/>
    <dgm:cxn modelId="{A9259A8C-6AA1-48F1-871B-6A2B9CCA10FF}" type="presOf" srcId="{3B6E185B-6A1C-411C-B39C-F27A6010733C}" destId="{E730F18F-48B0-4E0B-9A8D-D539E63CE9D4}" srcOrd="0" destOrd="0" presId="urn:microsoft.com/office/officeart/2005/8/layout/hierarchy2"/>
    <dgm:cxn modelId="{6A60D78C-E8EE-4DB3-A9CB-F6E2A46628B6}" type="presOf" srcId="{0EF4F3AF-041E-4FDF-983F-FF187C733655}" destId="{4DCF8B3D-4AC6-4BA4-83D6-71D9BD5CEED2}" srcOrd="0" destOrd="0" presId="urn:microsoft.com/office/officeart/2005/8/layout/hierarchy2"/>
    <dgm:cxn modelId="{11A3DC8E-FF1F-4699-9A3B-B670663B4676}" srcId="{5BEDA607-8DED-42F2-9BA0-692D403C0EC7}" destId="{99F805CD-8B05-4B09-8106-E7D62662EFAB}" srcOrd="2" destOrd="0" parTransId="{E8E96543-F299-474B-9FCF-7801EFC57576}" sibTransId="{D7B2BED0-5F36-4662-A45B-3AF98D5317EC}"/>
    <dgm:cxn modelId="{2A530990-1895-45DD-BDA1-70DF94728E35}" type="presOf" srcId="{1BB53B11-3670-415B-805A-CE32EE8357FF}" destId="{D2E49161-A7B6-4759-AC1C-493631AA99EA}" srcOrd="0" destOrd="0" presId="urn:microsoft.com/office/officeart/2005/8/layout/hierarchy2"/>
    <dgm:cxn modelId="{63C95192-7E8F-4E66-912B-8934733F0E2D}" type="presOf" srcId="{358A984D-84A8-4882-B614-7818D9052477}" destId="{70A6C9AF-4497-49E2-8F6B-4022C002A32C}" srcOrd="0" destOrd="0" presId="urn:microsoft.com/office/officeart/2005/8/layout/hierarchy2"/>
    <dgm:cxn modelId="{7CBA8D92-C34A-4774-915C-38C0363A598A}" type="presOf" srcId="{3E305254-2A1B-4466-9716-16D92D48BD39}" destId="{C50E5B3A-B9FE-43B9-85D2-DC2953853106}" srcOrd="0" destOrd="0" presId="urn:microsoft.com/office/officeart/2005/8/layout/hierarchy2"/>
    <dgm:cxn modelId="{15319A92-C074-4977-B5E9-2263A96B15AA}" type="presOf" srcId="{8598F285-6469-41DF-8C80-D94935C42364}" destId="{48E4B145-A01E-4F97-9B06-6C33D2269A47}" srcOrd="0" destOrd="0" presId="urn:microsoft.com/office/officeart/2005/8/layout/hierarchy2"/>
    <dgm:cxn modelId="{AB7F0793-DC3B-4A16-8D2C-145B72045198}" type="presOf" srcId="{5E805EC3-C58D-4BD5-A99E-B5CA51F30872}" destId="{430F15C4-6A15-46B0-808C-1CBD7A4F9165}" srcOrd="0" destOrd="0" presId="urn:microsoft.com/office/officeart/2005/8/layout/hierarchy2"/>
    <dgm:cxn modelId="{21C65893-33D8-4049-82B7-95D567D3FD44}" type="presOf" srcId="{8F1E2ECC-9C8C-4137-9CC2-148EC633E965}" destId="{5BC2E700-F976-45E3-88A6-547D0BC5C286}" srcOrd="0" destOrd="0" presId="urn:microsoft.com/office/officeart/2005/8/layout/hierarchy2"/>
    <dgm:cxn modelId="{3FB75F94-347C-4CCA-BCC7-DF4DE208FB2D}" type="presOf" srcId="{E8E96543-F299-474B-9FCF-7801EFC57576}" destId="{778A5A6C-5BCE-43A2-9985-988597C18905}" srcOrd="1" destOrd="0" presId="urn:microsoft.com/office/officeart/2005/8/layout/hierarchy2"/>
    <dgm:cxn modelId="{6C9BCC96-83CA-4C49-BD33-5E28962C6972}" type="presOf" srcId="{C8881E16-4787-451C-81F6-A6E1C5F25824}" destId="{93ED179E-6CE9-427B-AFAE-295FB95A4083}" srcOrd="0" destOrd="0" presId="urn:microsoft.com/office/officeart/2005/8/layout/hierarchy2"/>
    <dgm:cxn modelId="{3AB27197-1CBC-487D-907C-3FC6A3044E4F}" type="presOf" srcId="{C1EACDD7-D989-416D-9681-817FEB9BF90B}" destId="{69674B81-12B1-4530-81E5-B46611BDEBD3}" srcOrd="1" destOrd="0" presId="urn:microsoft.com/office/officeart/2005/8/layout/hierarchy2"/>
    <dgm:cxn modelId="{D4295A9A-3E2B-4444-BDA3-FAE29D08EC17}" type="presOf" srcId="{A7E59208-D8C8-472E-BF12-F8E4CF3114A2}" destId="{933E68AA-CF10-49A1-ABCC-DA114DDEAF2A}" srcOrd="0" destOrd="0" presId="urn:microsoft.com/office/officeart/2005/8/layout/hierarchy2"/>
    <dgm:cxn modelId="{23C9F99B-9986-43C9-B8F5-C6B41AEBFF0A}" type="presOf" srcId="{2A9BE497-61AC-492C-9E1D-96073DB72DE2}" destId="{B84FD6DC-6F83-483B-A6F6-D1143D7FCD3D}" srcOrd="1" destOrd="0" presId="urn:microsoft.com/office/officeart/2005/8/layout/hierarchy2"/>
    <dgm:cxn modelId="{ABD331A0-37D6-4A12-874A-064E3C212C9C}" type="presOf" srcId="{4E60B1B3-870B-4A1B-9517-73B33DCA2C20}" destId="{DDF72957-287B-449A-A1C9-C4F10755C0F8}" srcOrd="0" destOrd="0" presId="urn:microsoft.com/office/officeart/2005/8/layout/hierarchy2"/>
    <dgm:cxn modelId="{9C023FA6-3F9E-4DAC-AF18-7A43F20ED9AF}" type="presOf" srcId="{6CF7CD4C-0917-44C0-B3FE-FDC2C5B2A919}" destId="{D3655785-2D54-4F59-9234-66AFAA7E681A}" srcOrd="0" destOrd="0" presId="urn:microsoft.com/office/officeart/2005/8/layout/hierarchy2"/>
    <dgm:cxn modelId="{21D2CBA7-4E8B-4913-B267-78660AC9127F}" srcId="{353C6F70-9685-47CA-B6F4-8BAAB244C13E}" destId="{4DCC093E-5118-4588-BF05-784A120C438E}" srcOrd="3" destOrd="0" parTransId="{579F7746-AF17-435C-A54C-9C6E6EE94B1D}" sibTransId="{EA649D5B-149D-4781-A689-D23905969596}"/>
    <dgm:cxn modelId="{AFA80EAB-D299-4224-8AAB-599701A4B9AB}" type="presOf" srcId="{F855B30C-366F-4036-B5AE-48974C07A80E}" destId="{8E782F7D-B5EB-45C3-8750-549909A533F3}" srcOrd="1" destOrd="0" presId="urn:microsoft.com/office/officeart/2005/8/layout/hierarchy2"/>
    <dgm:cxn modelId="{69BB00B2-945D-43B6-B677-33EA6648970F}" type="presOf" srcId="{8C8C0F98-AF8B-47BC-ACBA-EC4EA96F1883}" destId="{066D82E6-DD7A-4789-BA1F-74B091D397C9}" srcOrd="1" destOrd="0" presId="urn:microsoft.com/office/officeart/2005/8/layout/hierarchy2"/>
    <dgm:cxn modelId="{CFBC75B3-6B2D-492A-9E29-EDE294FDB12A}" srcId="{5BEDA607-8DED-42F2-9BA0-692D403C0EC7}" destId="{F4B2B415-9F5D-4A5C-A517-33028F9EDE23}" srcOrd="5" destOrd="0" parTransId="{C6A0CEB6-9E0F-4493-8DE5-DBE1EBED4241}" sibTransId="{5F9517A7-3764-4E96-8F05-51C754E9941B}"/>
    <dgm:cxn modelId="{0079F2B4-2BA0-4985-89AA-1AE40E7F6DD8}" type="presOf" srcId="{B18AAAC7-07A3-44B8-A053-45D1FF816FFD}" destId="{665072C3-8ADE-40C1-BDA5-4FAA68E4319F}" srcOrd="0" destOrd="0" presId="urn:microsoft.com/office/officeart/2005/8/layout/hierarchy2"/>
    <dgm:cxn modelId="{4F33CEB7-B766-459F-BAFF-8AB2BF17B87E}" type="presOf" srcId="{96C75850-7C10-4A02-8605-049A49CD2E2D}" destId="{0E872D06-F66B-4811-92EA-E374B25899A2}" srcOrd="0" destOrd="0" presId="urn:microsoft.com/office/officeart/2005/8/layout/hierarchy2"/>
    <dgm:cxn modelId="{02CC0FB9-47A9-4EB3-A846-97F4167ED513}" type="presOf" srcId="{9EEC29B6-B262-48C2-8C7F-8D2337E7AA42}" destId="{C631F0D8-FAAD-405A-A21C-737F0EB151CA}" srcOrd="0" destOrd="0" presId="urn:microsoft.com/office/officeart/2005/8/layout/hierarchy2"/>
    <dgm:cxn modelId="{A6C878B9-EBF4-42CF-95ED-C5FEAC6D408F}" srcId="{4DCC093E-5118-4588-BF05-784A120C438E}" destId="{8598F285-6469-41DF-8C80-D94935C42364}" srcOrd="6" destOrd="0" parTransId="{2F8F9AB3-8452-43EC-87B2-17B5891BF608}" sibTransId="{9ED8CEDE-19AD-4186-9063-3C72CFA86202}"/>
    <dgm:cxn modelId="{2FF5E2B9-2F3E-4955-A3BA-2277D18944EF}" type="presOf" srcId="{8F1E2ECC-9C8C-4137-9CC2-148EC633E965}" destId="{5EE677E4-1C6E-4B89-9610-5064AAB1F7F5}" srcOrd="1" destOrd="0" presId="urn:microsoft.com/office/officeart/2005/8/layout/hierarchy2"/>
    <dgm:cxn modelId="{BE9FC8BC-30C8-4F47-89AB-AE0CFBC29094}" type="presOf" srcId="{353C6F70-9685-47CA-B6F4-8BAAB244C13E}" destId="{F78A7B94-B816-41D1-873A-8D5A3EB8CC40}" srcOrd="0" destOrd="0" presId="urn:microsoft.com/office/officeart/2005/8/layout/hierarchy2"/>
    <dgm:cxn modelId="{72E4F6BF-B93D-485F-9F94-4A18A0DBC316}" type="presOf" srcId="{BE23815E-A548-4C9A-9302-6B0219BE53D6}" destId="{7095C669-4F3E-4E90-960F-1302F717ACD3}" srcOrd="1" destOrd="0" presId="urn:microsoft.com/office/officeart/2005/8/layout/hierarchy2"/>
    <dgm:cxn modelId="{9CC962C0-6FB0-4EAC-9823-CB6EEDB8B9A3}" type="presOf" srcId="{B8C47AF5-72F4-4882-A03A-756E7DB0314D}" destId="{BD9D8B61-1FCA-4DBF-95E6-59B9130798B9}" srcOrd="0" destOrd="0" presId="urn:microsoft.com/office/officeart/2005/8/layout/hierarchy2"/>
    <dgm:cxn modelId="{792252C4-467B-4BE7-86A3-C7F1EB8EA99D}" type="presOf" srcId="{1930F7C4-5EB2-4BFC-B652-6F6645AD8029}" destId="{94C13FA5-1561-4553-ADA9-69D482E5248A}" srcOrd="1" destOrd="0" presId="urn:microsoft.com/office/officeart/2005/8/layout/hierarchy2"/>
    <dgm:cxn modelId="{DDCC96C5-BE0B-41E9-A0E8-ECFF717BAD76}" type="presOf" srcId="{07D04FA9-5869-4D23-B691-B49B006E8BC9}" destId="{DDA1B4D0-DAFF-4A7B-B757-2D0EB38A13A7}" srcOrd="1" destOrd="0" presId="urn:microsoft.com/office/officeart/2005/8/layout/hierarchy2"/>
    <dgm:cxn modelId="{22C919C7-7D34-4C3F-A8B9-F14CC53A801F}" type="presOf" srcId="{C256443A-5739-41C3-976C-086C241C3437}" destId="{4A87926E-2F89-4541-AD41-F858508AC316}" srcOrd="0" destOrd="0" presId="urn:microsoft.com/office/officeart/2005/8/layout/hierarchy2"/>
    <dgm:cxn modelId="{AF913AC7-4944-4AC8-B610-F40FED6AE744}" type="presOf" srcId="{5E84A072-2EA0-45DE-B57C-DA217CA13318}" destId="{894D3D26-1468-4F2C-88F6-01751D8C7D69}" srcOrd="1" destOrd="0" presId="urn:microsoft.com/office/officeart/2005/8/layout/hierarchy2"/>
    <dgm:cxn modelId="{DF94F1C7-920F-4CE4-AABF-D5D98F7AF32C}" type="presOf" srcId="{99F805CD-8B05-4B09-8106-E7D62662EFAB}" destId="{29EF756E-ED73-4753-83B6-EFB27D8AB242}" srcOrd="0" destOrd="0" presId="urn:microsoft.com/office/officeart/2005/8/layout/hierarchy2"/>
    <dgm:cxn modelId="{390CBAC9-7EDF-4013-9577-DF3CBEFB668D}" type="presOf" srcId="{CA6A9C70-223C-4BA6-B22F-E7EE9FCEF901}" destId="{30A5F9D5-7BBD-431C-88C3-CC070B8111E2}" srcOrd="1" destOrd="0" presId="urn:microsoft.com/office/officeart/2005/8/layout/hierarchy2"/>
    <dgm:cxn modelId="{05E2D8CA-3F04-43FA-A9A0-EFB380FF7C1A}" srcId="{4DCC093E-5118-4588-BF05-784A120C438E}" destId="{C8881E16-4787-451C-81F6-A6E1C5F25824}" srcOrd="8" destOrd="0" parTransId="{AA6D12B2-DCA4-4A02-AF03-C8580B7BB7CB}" sibTransId="{69FD0CA8-8B7F-4C0A-B522-919D737E5030}"/>
    <dgm:cxn modelId="{26DE23CD-1483-4CD3-969A-481532799F85}" type="presOf" srcId="{A7EB2E53-A0F7-41F9-9F6A-A28410E699DB}" destId="{B3990D9E-965A-4A87-9024-A31D8C18D9AC}" srcOrd="0" destOrd="0" presId="urn:microsoft.com/office/officeart/2005/8/layout/hierarchy2"/>
    <dgm:cxn modelId="{1D4F00CE-66E9-4243-9837-69CFA11D23D7}" type="presOf" srcId="{2A9BE497-61AC-492C-9E1D-96073DB72DE2}" destId="{39CD6B7A-D9CD-49C5-B1C3-2BF6CA65E035}" srcOrd="0" destOrd="0" presId="urn:microsoft.com/office/officeart/2005/8/layout/hierarchy2"/>
    <dgm:cxn modelId="{5239AFCF-DFE0-4396-84E6-5D57AE412BB8}" type="presOf" srcId="{CA6A9C70-223C-4BA6-B22F-E7EE9FCEF901}" destId="{6DE65224-3B60-4229-ACDA-981AA44CA426}" srcOrd="0" destOrd="0" presId="urn:microsoft.com/office/officeart/2005/8/layout/hierarchy2"/>
    <dgm:cxn modelId="{1934D0CF-1E8D-4B17-B666-0C945913728B}" srcId="{A7E59208-D8C8-472E-BF12-F8E4CF3114A2}" destId="{AB141E1E-8A47-473D-BDC9-A740AE0EA3F7}" srcOrd="4" destOrd="0" parTransId="{1930F7C4-5EB2-4BFC-B652-6F6645AD8029}" sibTransId="{91192A3F-4210-4580-A1AE-30F1DDACAD26}"/>
    <dgm:cxn modelId="{95B1A6D3-4246-4BED-8605-9D006627188E}" type="presOf" srcId="{1731A452-294D-4C69-97EA-ABFB841FA0AB}" destId="{AAEF59AE-AA15-4AA2-AEAA-A4784793DDE5}" srcOrd="1" destOrd="0" presId="urn:microsoft.com/office/officeart/2005/8/layout/hierarchy2"/>
    <dgm:cxn modelId="{3A31ACD3-1034-4409-80B6-14C943FE7441}" type="presOf" srcId="{1A98DB96-17DF-475F-B57D-AA7AEC31238C}" destId="{83DAAF3F-DBF1-49B0-8604-B525FB5C908A}" srcOrd="0" destOrd="0" presId="urn:microsoft.com/office/officeart/2005/8/layout/hierarchy2"/>
    <dgm:cxn modelId="{5BDED2D5-1FA4-41FE-B3D2-D464DA59B622}" type="presOf" srcId="{CE4A4217-0410-4729-9337-C36C75DD601B}" destId="{4364814E-1DC4-41D8-96F5-7FCAA16DA2B0}" srcOrd="0" destOrd="0" presId="urn:microsoft.com/office/officeart/2005/8/layout/hierarchy2"/>
    <dgm:cxn modelId="{AB214ED7-45AF-4038-88E6-13DE66C5A0CF}" type="presOf" srcId="{85CA1953-8DEE-44BB-BE58-B97A59C65C13}" destId="{63E06D80-B4DA-4AF5-B318-48676A80383C}" srcOrd="0" destOrd="0" presId="urn:microsoft.com/office/officeart/2005/8/layout/hierarchy2"/>
    <dgm:cxn modelId="{8E7AB9D7-5E84-44E1-B1AE-52F3EA136985}" srcId="{A7E59208-D8C8-472E-BF12-F8E4CF3114A2}" destId="{3E305254-2A1B-4466-9716-16D92D48BD39}" srcOrd="3" destOrd="0" parTransId="{5E84A072-2EA0-45DE-B57C-DA217CA13318}" sibTransId="{28E68593-7507-41E2-BA36-8D5C9263D978}"/>
    <dgm:cxn modelId="{1BA694DA-CAFA-477B-A6D7-2E1B3C64B243}" type="presOf" srcId="{579F7746-AF17-435C-A54C-9C6E6EE94B1D}" destId="{91683DB7-5821-4F63-939D-8271AEDB1AC2}" srcOrd="0" destOrd="0" presId="urn:microsoft.com/office/officeart/2005/8/layout/hierarchy2"/>
    <dgm:cxn modelId="{6C2929DE-5EE4-4902-988F-020CE1D11A52}" type="presOf" srcId="{AF9EC442-AE64-421C-9DF3-0ED0B18D4EC6}" destId="{D315BFC2-F4AA-453C-BEEE-7A8513151049}" srcOrd="1" destOrd="0" presId="urn:microsoft.com/office/officeart/2005/8/layout/hierarchy2"/>
    <dgm:cxn modelId="{95E83BDF-0A7C-4D79-BD1D-E2C11EB1BDB8}" type="presOf" srcId="{CEA4C598-03BA-4196-8096-D8D9940A747B}" destId="{87C9AC31-CDDE-4E1F-B79F-69064C460489}" srcOrd="0" destOrd="0" presId="urn:microsoft.com/office/officeart/2005/8/layout/hierarchy2"/>
    <dgm:cxn modelId="{CB998EE0-00FC-46E7-9404-8446AAA43148}" type="presOf" srcId="{1526BD2C-5491-407F-8729-1EE2B6B3A855}" destId="{AC865C7C-D34F-4978-B07D-384D670F1E47}" srcOrd="0" destOrd="0" presId="urn:microsoft.com/office/officeart/2005/8/layout/hierarchy2"/>
    <dgm:cxn modelId="{31AD32E1-C5F3-41E2-8A34-FBA4D83488DD}" srcId="{4DCC093E-5118-4588-BF05-784A120C438E}" destId="{3B6E185B-6A1C-411C-B39C-F27A6010733C}" srcOrd="1" destOrd="0" parTransId="{C1EACDD7-D989-416D-9681-817FEB9BF90B}" sibTransId="{9A34BB95-B186-435B-AAA0-ED02B3A2EB5F}"/>
    <dgm:cxn modelId="{48228AE2-96F1-4374-9289-F4ACD72A6E17}" type="presOf" srcId="{064DB9D2-173A-4CFB-BE23-C2F5395E90CE}" destId="{57096B24-8CD4-406B-927F-3FABEDAA0D69}" srcOrd="1" destOrd="0" presId="urn:microsoft.com/office/officeart/2005/8/layout/hierarchy2"/>
    <dgm:cxn modelId="{4FFBF3E2-1522-42AF-BA23-014F92B921B3}" srcId="{5E805EC3-C58D-4BD5-A99E-B5CA51F30872}" destId="{3A98E99E-5EB9-499E-9929-61172C5675F2}" srcOrd="0" destOrd="0" parTransId="{C09B2D6A-14B0-4151-BFD3-E21110A5E135}" sibTransId="{E8089669-DCD2-4DB6-A714-273990695241}"/>
    <dgm:cxn modelId="{1A9D4DE3-4A37-4227-B403-A2ADA5B17FB0}" srcId="{C256443A-5739-41C3-976C-086C241C3437}" destId="{353C6F70-9685-47CA-B6F4-8BAAB244C13E}" srcOrd="0" destOrd="0" parTransId="{87404468-AF06-4D92-8599-AEA8859A7AA9}" sibTransId="{68C29FC2-7381-479D-98A3-371A7F9C8B6D}"/>
    <dgm:cxn modelId="{F0C939E4-74A5-4310-86AA-06D23BDBB5AE}" type="presOf" srcId="{1A36E4A0-3C95-4A7E-8403-6FC00333987E}" destId="{272D572E-5B26-4488-A75D-C75C5F075451}" srcOrd="1" destOrd="0" presId="urn:microsoft.com/office/officeart/2005/8/layout/hierarchy2"/>
    <dgm:cxn modelId="{28EAC9E6-7EC9-4452-B6B3-92A0B14CC2D2}" type="presOf" srcId="{F576FE14-F223-4751-B256-BF313602C91E}" destId="{DC301E58-40D8-4D3D-9A40-BAA0C92BDE59}" srcOrd="0" destOrd="0" presId="urn:microsoft.com/office/officeart/2005/8/layout/hierarchy2"/>
    <dgm:cxn modelId="{691788E7-7748-4341-A1AA-2A20B2EF1010}" type="presOf" srcId="{7D4974A8-D315-42CC-B9BB-A3A5CD5225A3}" destId="{D5CD040A-B516-438A-972F-8ED8CDC5F1F6}" srcOrd="1" destOrd="0" presId="urn:microsoft.com/office/officeart/2005/8/layout/hierarchy2"/>
    <dgm:cxn modelId="{225F28E9-5723-4F77-9501-13923EB7D7AE}" srcId="{4E60B1B3-870B-4A1B-9517-73B33DCA2C20}" destId="{6125DCFA-27DB-435B-BEA4-88B2190500A1}" srcOrd="1" destOrd="0" parTransId="{1A98DB96-17DF-475F-B57D-AA7AEC31238C}" sibTransId="{514F69F3-BA1B-4306-A43E-9B675BA1B5FC}"/>
    <dgm:cxn modelId="{5B586EEA-A9C3-484F-86A0-2980FBD7EC53}" type="presOf" srcId="{539788D9-F5CD-499B-8EFE-4BDF10193421}" destId="{5BC45E89-1EAB-43BA-B311-8A95F182C2C2}" srcOrd="1" destOrd="0" presId="urn:microsoft.com/office/officeart/2005/8/layout/hierarchy2"/>
    <dgm:cxn modelId="{8BBCB2EA-1678-4140-B004-E6CBBFA88A2B}" type="presOf" srcId="{E2EBA384-91D3-4018-9EF6-F6F2CD249D13}" destId="{A26EDAF6-44C8-4854-8F91-1F5749D4DC73}" srcOrd="0" destOrd="0" presId="urn:microsoft.com/office/officeart/2005/8/layout/hierarchy2"/>
    <dgm:cxn modelId="{13AF42EF-7EB9-455A-BEE7-083526220C66}" type="presOf" srcId="{A1B0E159-B1C8-4060-A4E0-14F2712C19F0}" destId="{925EDBFF-3D85-437B-9D22-40DBEB5AB8DA}" srcOrd="0" destOrd="0" presId="urn:microsoft.com/office/officeart/2005/8/layout/hierarchy2"/>
    <dgm:cxn modelId="{FE7B8CEF-0BE8-440B-8FE6-48CFBE9258AA}" type="presOf" srcId="{C1EACDD7-D989-416D-9681-817FEB9BF90B}" destId="{56FAFC49-D0EA-4E25-8D48-7123A498BD9B}" srcOrd="0" destOrd="0" presId="urn:microsoft.com/office/officeart/2005/8/layout/hierarchy2"/>
    <dgm:cxn modelId="{F2CE26F0-8DF5-4A14-9C9D-59EFE771385C}" type="presOf" srcId="{89246641-77CD-487A-83F2-C7F1200B9CD3}" destId="{800253CE-BB59-4266-9CEA-CEBDA03E4027}" srcOrd="0" destOrd="0" presId="urn:microsoft.com/office/officeart/2005/8/layout/hierarchy2"/>
    <dgm:cxn modelId="{7ED40CF1-28FB-4983-B533-E0D9648A74B7}" type="presOf" srcId="{03C2E030-813C-4887-94E5-82269C93F63C}" destId="{993A1D06-E7B1-4637-8296-1DEAAA23799F}" srcOrd="1" destOrd="0" presId="urn:microsoft.com/office/officeart/2005/8/layout/hierarchy2"/>
    <dgm:cxn modelId="{7FBB60F2-1783-4DD1-8C7C-AD1030F81ED4}" type="presOf" srcId="{760F7733-46EF-4539-A2FB-454CD8F95E50}" destId="{7E42A3E7-F188-48F4-99B5-B1F4D367F825}" srcOrd="1" destOrd="0" presId="urn:microsoft.com/office/officeart/2005/8/layout/hierarchy2"/>
    <dgm:cxn modelId="{3EBA66F2-A18B-4041-B671-9C6537054F25}" type="presOf" srcId="{579F7746-AF17-435C-A54C-9C6E6EE94B1D}" destId="{D9B96937-FBE0-4586-A2C5-BC85D2155D05}" srcOrd="1" destOrd="0" presId="urn:microsoft.com/office/officeart/2005/8/layout/hierarchy2"/>
    <dgm:cxn modelId="{31FAE4F2-0198-4611-B83E-E9222506DDF1}" type="presOf" srcId="{F855B30C-366F-4036-B5AE-48974C07A80E}" destId="{2F7D4346-F118-454B-9AAD-5BD4A706F402}" srcOrd="0" destOrd="0" presId="urn:microsoft.com/office/officeart/2005/8/layout/hierarchy2"/>
    <dgm:cxn modelId="{52F3EFF6-AE34-4DE1-A420-9A1FB0E5A6E8}" type="presOf" srcId="{41D6EC2F-3103-40F0-AD9A-B96A94477A77}" destId="{481798CD-BDE5-4B57-B01A-E2CEFF5196BF}" srcOrd="0" destOrd="0" presId="urn:microsoft.com/office/officeart/2005/8/layout/hierarchy2"/>
    <dgm:cxn modelId="{9F5227F9-C539-43B5-A269-FBDD076C8049}" type="presOf" srcId="{ECD62ED1-5D11-481E-9BBC-AB020A2EFAFF}" destId="{BF83AAD4-9518-47AA-835D-A40E2C49AF13}" srcOrd="0" destOrd="0" presId="urn:microsoft.com/office/officeart/2005/8/layout/hierarchy2"/>
    <dgm:cxn modelId="{18B32BF9-C15D-49A4-94AE-9BE5B96D30B1}" srcId="{353C6F70-9685-47CA-B6F4-8BAAB244C13E}" destId="{4E60B1B3-870B-4A1B-9517-73B33DCA2C20}" srcOrd="4" destOrd="0" parTransId="{895AD288-8C3F-4FEF-8348-DE71D8D3CA8C}" sibTransId="{E66CBDB9-DF23-432A-9DE5-67E5508FEEDF}"/>
    <dgm:cxn modelId="{BD8AFAFB-6827-47A4-BEE6-B7BD500A967C}" srcId="{F4B2B415-9F5D-4A5C-A517-33028F9EDE23}" destId="{E2EBA384-91D3-4018-9EF6-F6F2CD249D13}" srcOrd="1" destOrd="0" parTransId="{6CF7CD4C-0917-44C0-B3FE-FDC2C5B2A919}" sibTransId="{DEA0B624-4869-47B4-804B-98EC11BA11B7}"/>
    <dgm:cxn modelId="{D337F7FC-93A6-4C86-B264-5AD157D24BFE}" type="presOf" srcId="{010FD920-EA56-439A-976D-37845A8E9EE8}" destId="{E34F5E68-97F6-448B-93CC-7F50A4D760A8}" srcOrd="1" destOrd="0" presId="urn:microsoft.com/office/officeart/2005/8/layout/hierarchy2"/>
    <dgm:cxn modelId="{7E06C4FF-C4C0-473E-B740-F3D69BDDDEEE}" type="presOf" srcId="{7D4974A8-D315-42CC-B9BB-A3A5CD5225A3}" destId="{92D0DEB7-F9E3-4085-A056-1B4AA5D907F0}" srcOrd="0" destOrd="0" presId="urn:microsoft.com/office/officeart/2005/8/layout/hierarchy2"/>
    <dgm:cxn modelId="{597F06D3-B575-465D-B676-B0F722FB30BE}" type="presParOf" srcId="{4A87926E-2F89-4541-AD41-F858508AC316}" destId="{D0337419-FCAE-4D52-B05C-516C20818889}" srcOrd="0" destOrd="0" presId="urn:microsoft.com/office/officeart/2005/8/layout/hierarchy2"/>
    <dgm:cxn modelId="{1F24460F-0471-46BE-BA03-288B7DF16AA9}" type="presParOf" srcId="{D0337419-FCAE-4D52-B05C-516C20818889}" destId="{F78A7B94-B816-41D1-873A-8D5A3EB8CC40}" srcOrd="0" destOrd="0" presId="urn:microsoft.com/office/officeart/2005/8/layout/hierarchy2"/>
    <dgm:cxn modelId="{743AA5F4-CE3B-4B5B-8CEE-481703E525FD}" type="presParOf" srcId="{D0337419-FCAE-4D52-B05C-516C20818889}" destId="{457B3FD6-8EF7-4A94-BB29-C9471CDE92CD}" srcOrd="1" destOrd="0" presId="urn:microsoft.com/office/officeart/2005/8/layout/hierarchy2"/>
    <dgm:cxn modelId="{BD059158-A805-4DC5-90B2-7843B32CEB7E}" type="presParOf" srcId="{457B3FD6-8EF7-4A94-BB29-C9471CDE92CD}" destId="{2F7D4346-F118-454B-9AAD-5BD4A706F402}" srcOrd="0" destOrd="0" presId="urn:microsoft.com/office/officeart/2005/8/layout/hierarchy2"/>
    <dgm:cxn modelId="{E9C42014-BB56-4DF6-A4D5-8B643B58546B}" type="presParOf" srcId="{2F7D4346-F118-454B-9AAD-5BD4A706F402}" destId="{8E782F7D-B5EB-45C3-8750-549909A533F3}" srcOrd="0" destOrd="0" presId="urn:microsoft.com/office/officeart/2005/8/layout/hierarchy2"/>
    <dgm:cxn modelId="{15C6BAC7-CC53-4C13-92ED-C434044C7832}" type="presParOf" srcId="{457B3FD6-8EF7-4A94-BB29-C9471CDE92CD}" destId="{D988932E-C931-4512-A8F2-C38E4F67EB7D}" srcOrd="1" destOrd="0" presId="urn:microsoft.com/office/officeart/2005/8/layout/hierarchy2"/>
    <dgm:cxn modelId="{AD375933-167D-4601-A024-5576B5020DC1}" type="presParOf" srcId="{D988932E-C931-4512-A8F2-C38E4F67EB7D}" destId="{430F15C4-6A15-46B0-808C-1CBD7A4F9165}" srcOrd="0" destOrd="0" presId="urn:microsoft.com/office/officeart/2005/8/layout/hierarchy2"/>
    <dgm:cxn modelId="{F890348F-EE5D-4E90-A3F7-9AD8D90F07B5}" type="presParOf" srcId="{D988932E-C931-4512-A8F2-C38E4F67EB7D}" destId="{A62861FB-C1E1-4913-99BB-D18D0BA7EF62}" srcOrd="1" destOrd="0" presId="urn:microsoft.com/office/officeart/2005/8/layout/hierarchy2"/>
    <dgm:cxn modelId="{678A64AF-7BC9-445E-92CC-B519135F6398}" type="presParOf" srcId="{A62861FB-C1E1-4913-99BB-D18D0BA7EF62}" destId="{4838F315-A0EB-4974-8233-371CFFCC1CE4}" srcOrd="0" destOrd="0" presId="urn:microsoft.com/office/officeart/2005/8/layout/hierarchy2"/>
    <dgm:cxn modelId="{3B98B53A-3FFC-4F7E-BE10-6D68A92C0513}" type="presParOf" srcId="{4838F315-A0EB-4974-8233-371CFFCC1CE4}" destId="{E36F28F1-4932-4D2B-B680-9D2F1B515793}" srcOrd="0" destOrd="0" presId="urn:microsoft.com/office/officeart/2005/8/layout/hierarchy2"/>
    <dgm:cxn modelId="{1D351115-D6A0-4CE4-9696-89C536797AC6}" type="presParOf" srcId="{A62861FB-C1E1-4913-99BB-D18D0BA7EF62}" destId="{DDFF5742-CF69-471F-841B-FF79B1E24A3C}" srcOrd="1" destOrd="0" presId="urn:microsoft.com/office/officeart/2005/8/layout/hierarchy2"/>
    <dgm:cxn modelId="{28022EF5-8C2F-46A0-9000-9C262A34A1D3}" type="presParOf" srcId="{DDFF5742-CF69-471F-841B-FF79B1E24A3C}" destId="{0B80F301-D09A-4FB6-916E-CECF32B2F143}" srcOrd="0" destOrd="0" presId="urn:microsoft.com/office/officeart/2005/8/layout/hierarchy2"/>
    <dgm:cxn modelId="{68AD8F80-EF68-480D-AA85-5D5602110B0E}" type="presParOf" srcId="{DDFF5742-CF69-471F-841B-FF79B1E24A3C}" destId="{01C225FF-8339-4AED-93A9-27AB32E3DF0B}" srcOrd="1" destOrd="0" presId="urn:microsoft.com/office/officeart/2005/8/layout/hierarchy2"/>
    <dgm:cxn modelId="{03BAA165-9A4C-4098-A664-306688DCE6BE}" type="presParOf" srcId="{A62861FB-C1E1-4913-99BB-D18D0BA7EF62}" destId="{750F2EA3-C6A2-49D8-A4E9-ECB36FFC366E}" srcOrd="2" destOrd="0" presId="urn:microsoft.com/office/officeart/2005/8/layout/hierarchy2"/>
    <dgm:cxn modelId="{24A098B6-C80D-44CD-8A26-C20028D01058}" type="presParOf" srcId="{750F2EA3-C6A2-49D8-A4E9-ECB36FFC366E}" destId="{066D82E6-DD7A-4789-BA1F-74B091D397C9}" srcOrd="0" destOrd="0" presId="urn:microsoft.com/office/officeart/2005/8/layout/hierarchy2"/>
    <dgm:cxn modelId="{DA5073F8-B0FE-4FA8-B647-668DF28A9DFE}" type="presParOf" srcId="{A62861FB-C1E1-4913-99BB-D18D0BA7EF62}" destId="{D3F69F3A-148E-4673-B1FF-6A8AC1FE2DCE}" srcOrd="3" destOrd="0" presId="urn:microsoft.com/office/officeart/2005/8/layout/hierarchy2"/>
    <dgm:cxn modelId="{3C3B564C-5064-436C-9F5D-0F9D2581EF21}" type="presParOf" srcId="{D3F69F3A-148E-4673-B1FF-6A8AC1FE2DCE}" destId="{70A6C9AF-4497-49E2-8F6B-4022C002A32C}" srcOrd="0" destOrd="0" presId="urn:microsoft.com/office/officeart/2005/8/layout/hierarchy2"/>
    <dgm:cxn modelId="{CF1CE5E8-B994-4993-90A2-DB6E02897FA7}" type="presParOf" srcId="{D3F69F3A-148E-4673-B1FF-6A8AC1FE2DCE}" destId="{75CD52C9-9125-48F6-9D99-712D3BC58122}" srcOrd="1" destOrd="0" presId="urn:microsoft.com/office/officeart/2005/8/layout/hierarchy2"/>
    <dgm:cxn modelId="{3465795E-55B9-42EF-BC29-D2E506D67FDE}" type="presParOf" srcId="{A62861FB-C1E1-4913-99BB-D18D0BA7EF62}" destId="{B99573E9-A46B-4C67-A741-44E4FCB4FC8A}" srcOrd="4" destOrd="0" presId="urn:microsoft.com/office/officeart/2005/8/layout/hierarchy2"/>
    <dgm:cxn modelId="{1D4B3EFE-7129-49B7-A4BE-65C05A19A1F1}" type="presParOf" srcId="{B99573E9-A46B-4C67-A741-44E4FCB4FC8A}" destId="{AAEF59AE-AA15-4AA2-AEAA-A4784793DDE5}" srcOrd="0" destOrd="0" presId="urn:microsoft.com/office/officeart/2005/8/layout/hierarchy2"/>
    <dgm:cxn modelId="{5226A0E2-2609-4953-8D10-AB4528A6C2E2}" type="presParOf" srcId="{A62861FB-C1E1-4913-99BB-D18D0BA7EF62}" destId="{7019262D-F9E7-43D3-B6F1-BE5C8FC760AB}" srcOrd="5" destOrd="0" presId="urn:microsoft.com/office/officeart/2005/8/layout/hierarchy2"/>
    <dgm:cxn modelId="{A7A58A64-A5BE-4AC5-8D7E-3C54174EB9BC}" type="presParOf" srcId="{7019262D-F9E7-43D3-B6F1-BE5C8FC760AB}" destId="{049F2968-73E2-4348-A8D7-E885F2B2F00E}" srcOrd="0" destOrd="0" presId="urn:microsoft.com/office/officeart/2005/8/layout/hierarchy2"/>
    <dgm:cxn modelId="{62E60BA4-19F8-4BE5-9CA4-4782AFC0BDAB}" type="presParOf" srcId="{7019262D-F9E7-43D3-B6F1-BE5C8FC760AB}" destId="{9CD1B84C-59C7-4394-B671-9D4A34E2A244}" srcOrd="1" destOrd="0" presId="urn:microsoft.com/office/officeart/2005/8/layout/hierarchy2"/>
    <dgm:cxn modelId="{3C6E73A1-AD49-4BE9-81A8-24A7E4B91F6C}" type="presParOf" srcId="{457B3FD6-8EF7-4A94-BB29-C9471CDE92CD}" destId="{6C074D18-1EA0-40FB-94A6-DD4C52B7D46C}" srcOrd="2" destOrd="0" presId="urn:microsoft.com/office/officeart/2005/8/layout/hierarchy2"/>
    <dgm:cxn modelId="{19938980-7021-4114-8956-A9626061AFF6}" type="presParOf" srcId="{6C074D18-1EA0-40FB-94A6-DD4C52B7D46C}" destId="{740522B2-75E3-4986-BE71-6201CAF74879}" srcOrd="0" destOrd="0" presId="urn:microsoft.com/office/officeart/2005/8/layout/hierarchy2"/>
    <dgm:cxn modelId="{F5883D1D-4C9C-4F12-87C6-CD9BF270EDF9}" type="presParOf" srcId="{457B3FD6-8EF7-4A94-BB29-C9471CDE92CD}" destId="{923ABA98-7991-407C-B596-10BA5F513C20}" srcOrd="3" destOrd="0" presId="urn:microsoft.com/office/officeart/2005/8/layout/hierarchy2"/>
    <dgm:cxn modelId="{1D5DB772-BB59-452A-9751-AA2DC9225FF3}" type="presParOf" srcId="{923ABA98-7991-407C-B596-10BA5F513C20}" destId="{3B5C04C0-1026-4BCC-B8D1-09CC708E27EF}" srcOrd="0" destOrd="0" presId="urn:microsoft.com/office/officeart/2005/8/layout/hierarchy2"/>
    <dgm:cxn modelId="{4620C55A-B514-4F7B-BC09-1A60334F55B2}" type="presParOf" srcId="{923ABA98-7991-407C-B596-10BA5F513C20}" destId="{63E65136-FB97-46CC-93F6-1E9121ADE6EE}" srcOrd="1" destOrd="0" presId="urn:microsoft.com/office/officeart/2005/8/layout/hierarchy2"/>
    <dgm:cxn modelId="{60418301-86D3-4D2D-92E0-2303337C7CAD}" type="presParOf" srcId="{63E65136-FB97-46CC-93F6-1E9121ADE6EE}" destId="{1933032C-D9EF-4E95-9447-72395E90BD3C}" srcOrd="0" destOrd="0" presId="urn:microsoft.com/office/officeart/2005/8/layout/hierarchy2"/>
    <dgm:cxn modelId="{925D5D40-D67B-4703-A1F2-E698ECD90017}" type="presParOf" srcId="{1933032C-D9EF-4E95-9447-72395E90BD3C}" destId="{DDA1B4D0-DAFF-4A7B-B757-2D0EB38A13A7}" srcOrd="0" destOrd="0" presId="urn:microsoft.com/office/officeart/2005/8/layout/hierarchy2"/>
    <dgm:cxn modelId="{FFDAD2E4-6B8E-4DEE-9F59-443AEC4A4B89}" type="presParOf" srcId="{63E65136-FB97-46CC-93F6-1E9121ADE6EE}" destId="{658C8869-04C9-4951-AD31-366FF613DDA0}" srcOrd="1" destOrd="0" presId="urn:microsoft.com/office/officeart/2005/8/layout/hierarchy2"/>
    <dgm:cxn modelId="{BA7D15FC-240B-4E86-BA77-4E02E65347F8}" type="presParOf" srcId="{658C8869-04C9-4951-AD31-366FF613DDA0}" destId="{85D196B6-063E-44EA-88B6-502D03441A95}" srcOrd="0" destOrd="0" presId="urn:microsoft.com/office/officeart/2005/8/layout/hierarchy2"/>
    <dgm:cxn modelId="{41DDCFA7-8E3D-44F4-AD23-F7A20F734B2A}" type="presParOf" srcId="{658C8869-04C9-4951-AD31-366FF613DDA0}" destId="{6631D1CF-F995-496A-B550-A56FC7462583}" srcOrd="1" destOrd="0" presId="urn:microsoft.com/office/officeart/2005/8/layout/hierarchy2"/>
    <dgm:cxn modelId="{2B2BCCB1-A94B-46A8-9505-554BFED7CA00}" type="presParOf" srcId="{6631D1CF-F995-496A-B550-A56FC7462583}" destId="{39A8889A-DFEF-4793-B12D-3BA4A3083E3E}" srcOrd="0" destOrd="0" presId="urn:microsoft.com/office/officeart/2005/8/layout/hierarchy2"/>
    <dgm:cxn modelId="{809A581F-BE5C-4903-8808-5C31E944FF5B}" type="presParOf" srcId="{39A8889A-DFEF-4793-B12D-3BA4A3083E3E}" destId="{993A1D06-E7B1-4637-8296-1DEAAA23799F}" srcOrd="0" destOrd="0" presId="urn:microsoft.com/office/officeart/2005/8/layout/hierarchy2"/>
    <dgm:cxn modelId="{FB819964-57DD-455F-93C0-80D347B8D81D}" type="presParOf" srcId="{6631D1CF-F995-496A-B550-A56FC7462583}" destId="{70EDD1C1-63F0-4263-8036-027FA4CD0523}" srcOrd="1" destOrd="0" presId="urn:microsoft.com/office/officeart/2005/8/layout/hierarchy2"/>
    <dgm:cxn modelId="{3B8D2B87-2B6E-4EBF-A32E-BE4737759471}" type="presParOf" srcId="{70EDD1C1-63F0-4263-8036-027FA4CD0523}" destId="{29B3ABBF-0291-41BA-9070-E0CB070E1723}" srcOrd="0" destOrd="0" presId="urn:microsoft.com/office/officeart/2005/8/layout/hierarchy2"/>
    <dgm:cxn modelId="{F8080303-9DDE-409E-88AD-2A0B70B21C82}" type="presParOf" srcId="{70EDD1C1-63F0-4263-8036-027FA4CD0523}" destId="{FAA504E9-7E4D-4F77-A140-2ECF8E058BD1}" srcOrd="1" destOrd="0" presId="urn:microsoft.com/office/officeart/2005/8/layout/hierarchy2"/>
    <dgm:cxn modelId="{22FD1C93-0C9B-4A3C-B796-4FB5F079B9B2}" type="presParOf" srcId="{6631D1CF-F995-496A-B550-A56FC7462583}" destId="{16EDC4EB-15B1-4BED-A913-C4910A592E43}" srcOrd="2" destOrd="0" presId="urn:microsoft.com/office/officeart/2005/8/layout/hierarchy2"/>
    <dgm:cxn modelId="{2170520A-E0EE-4CD9-9AA2-62E8B800CAC2}" type="presParOf" srcId="{16EDC4EB-15B1-4BED-A913-C4910A592E43}" destId="{16FE4A7B-83F7-4D09-B9FE-7AABA7BB071E}" srcOrd="0" destOrd="0" presId="urn:microsoft.com/office/officeart/2005/8/layout/hierarchy2"/>
    <dgm:cxn modelId="{AC712E41-161D-4E27-82D1-504F40B0353F}" type="presParOf" srcId="{6631D1CF-F995-496A-B550-A56FC7462583}" destId="{682C3E9E-A664-4AEB-98FA-7A56B9FCB066}" srcOrd="3" destOrd="0" presId="urn:microsoft.com/office/officeart/2005/8/layout/hierarchy2"/>
    <dgm:cxn modelId="{54983000-5356-4AE5-A207-2BA92A53D99B}" type="presParOf" srcId="{682C3E9E-A664-4AEB-98FA-7A56B9FCB066}" destId="{3D93AA13-F9BF-4516-9343-01C4FE687B9F}" srcOrd="0" destOrd="0" presId="urn:microsoft.com/office/officeart/2005/8/layout/hierarchy2"/>
    <dgm:cxn modelId="{477E67DA-EE18-494B-88E4-4AB5D524ECBC}" type="presParOf" srcId="{682C3E9E-A664-4AEB-98FA-7A56B9FCB066}" destId="{FA14F626-8A10-4F1C-A2B9-289709A47DFF}" srcOrd="1" destOrd="0" presId="urn:microsoft.com/office/officeart/2005/8/layout/hierarchy2"/>
    <dgm:cxn modelId="{0061186C-9F00-4A54-94B7-4B68BE7A2D13}" type="presParOf" srcId="{63E65136-FB97-46CC-93F6-1E9121ADE6EE}" destId="{BE69F2C5-1F16-4884-B39F-EE6B06025848}" srcOrd="2" destOrd="0" presId="urn:microsoft.com/office/officeart/2005/8/layout/hierarchy2"/>
    <dgm:cxn modelId="{0E4D0548-5519-4FCA-8FDA-0367C505242C}" type="presParOf" srcId="{BE69F2C5-1F16-4884-B39F-EE6B06025848}" destId="{7095C669-4F3E-4E90-960F-1302F717ACD3}" srcOrd="0" destOrd="0" presId="urn:microsoft.com/office/officeart/2005/8/layout/hierarchy2"/>
    <dgm:cxn modelId="{9BC4DC1F-71BE-41AB-B6D5-A8E87E3D0C9D}" type="presParOf" srcId="{63E65136-FB97-46CC-93F6-1E9121ADE6EE}" destId="{FB910F99-8F7B-4955-BA14-D3CBD5F0BE0B}" srcOrd="3" destOrd="0" presId="urn:microsoft.com/office/officeart/2005/8/layout/hierarchy2"/>
    <dgm:cxn modelId="{CE4C4482-BA09-4F35-AF28-345F8879B05A}" type="presParOf" srcId="{FB910F99-8F7B-4955-BA14-D3CBD5F0BE0B}" destId="{C631F0D8-FAAD-405A-A21C-737F0EB151CA}" srcOrd="0" destOrd="0" presId="urn:microsoft.com/office/officeart/2005/8/layout/hierarchy2"/>
    <dgm:cxn modelId="{E85D544F-0A0D-49D9-9834-45CD2A0A44D3}" type="presParOf" srcId="{FB910F99-8F7B-4955-BA14-D3CBD5F0BE0B}" destId="{FBF4A851-80A7-4420-B39A-AFC31A510810}" srcOrd="1" destOrd="0" presId="urn:microsoft.com/office/officeart/2005/8/layout/hierarchy2"/>
    <dgm:cxn modelId="{536E1237-813C-4E34-8A3F-689FAD71F483}" type="presParOf" srcId="{63E65136-FB97-46CC-93F6-1E9121ADE6EE}" destId="{8D2BE030-0831-42B2-98C2-0F6E87AD5B7D}" srcOrd="4" destOrd="0" presId="urn:microsoft.com/office/officeart/2005/8/layout/hierarchy2"/>
    <dgm:cxn modelId="{D4FEFEEA-BC90-4BA0-B70B-B64139842084}" type="presParOf" srcId="{8D2BE030-0831-42B2-98C2-0F6E87AD5B7D}" destId="{778A5A6C-5BCE-43A2-9985-988597C18905}" srcOrd="0" destOrd="0" presId="urn:microsoft.com/office/officeart/2005/8/layout/hierarchy2"/>
    <dgm:cxn modelId="{32DBB28F-63FA-423F-9351-0D740436839A}" type="presParOf" srcId="{63E65136-FB97-46CC-93F6-1E9121ADE6EE}" destId="{32EA519B-D3EF-457A-9C5B-9E4A9B562622}" srcOrd="5" destOrd="0" presId="urn:microsoft.com/office/officeart/2005/8/layout/hierarchy2"/>
    <dgm:cxn modelId="{DFC0D8A7-0998-49F6-A00D-77B38273FB66}" type="presParOf" srcId="{32EA519B-D3EF-457A-9C5B-9E4A9B562622}" destId="{29EF756E-ED73-4753-83B6-EFB27D8AB242}" srcOrd="0" destOrd="0" presId="urn:microsoft.com/office/officeart/2005/8/layout/hierarchy2"/>
    <dgm:cxn modelId="{36968C25-30D5-45D3-B432-AC71B71DB041}" type="presParOf" srcId="{32EA519B-D3EF-457A-9C5B-9E4A9B562622}" destId="{B580F2EF-10D1-43DE-86DA-65887B64442D}" srcOrd="1" destOrd="0" presId="urn:microsoft.com/office/officeart/2005/8/layout/hierarchy2"/>
    <dgm:cxn modelId="{EA057276-E93F-41C5-8811-E8EAC0000EB7}" type="presParOf" srcId="{63E65136-FB97-46CC-93F6-1E9121ADE6EE}" destId="{A20C5029-8277-4F52-A215-36A9DA1AB52E}" srcOrd="6" destOrd="0" presId="urn:microsoft.com/office/officeart/2005/8/layout/hierarchy2"/>
    <dgm:cxn modelId="{1F5E7CDC-A434-4087-BF5A-702A773F9C84}" type="presParOf" srcId="{A20C5029-8277-4F52-A215-36A9DA1AB52E}" destId="{B80DAFEB-A4DF-442E-B7BA-955CB74D383A}" srcOrd="0" destOrd="0" presId="urn:microsoft.com/office/officeart/2005/8/layout/hierarchy2"/>
    <dgm:cxn modelId="{A702F75C-64B5-432C-B6D3-042BD3CADA8F}" type="presParOf" srcId="{63E65136-FB97-46CC-93F6-1E9121ADE6EE}" destId="{00239F36-7CCC-4EC4-8664-6CDB34CC30AA}" srcOrd="7" destOrd="0" presId="urn:microsoft.com/office/officeart/2005/8/layout/hierarchy2"/>
    <dgm:cxn modelId="{99F43357-8D08-4AF0-B3AD-0FAEC35E540F}" type="presParOf" srcId="{00239F36-7CCC-4EC4-8664-6CDB34CC30AA}" destId="{EC3C7E9C-DE6F-4CF5-B8A3-EB96093DECF2}" srcOrd="0" destOrd="0" presId="urn:microsoft.com/office/officeart/2005/8/layout/hierarchy2"/>
    <dgm:cxn modelId="{9299794E-1D9F-4C48-83D4-4AC972801EEB}" type="presParOf" srcId="{00239F36-7CCC-4EC4-8664-6CDB34CC30AA}" destId="{9547E60A-4616-40DD-BB3B-048D8FF09B27}" srcOrd="1" destOrd="0" presId="urn:microsoft.com/office/officeart/2005/8/layout/hierarchy2"/>
    <dgm:cxn modelId="{48EEA27C-2564-460C-A5AC-8B7B0475FB61}" type="presParOf" srcId="{63E65136-FB97-46CC-93F6-1E9121ADE6EE}" destId="{FCAF4F74-DA65-4B57-BED5-BD3F26CA3653}" srcOrd="8" destOrd="0" presId="urn:microsoft.com/office/officeart/2005/8/layout/hierarchy2"/>
    <dgm:cxn modelId="{D6D5780E-CA0E-4A88-B8F7-C5125F68F4BB}" type="presParOf" srcId="{FCAF4F74-DA65-4B57-BED5-BD3F26CA3653}" destId="{58DDB727-F29C-4C9B-AF2C-EA0167F90FF0}" srcOrd="0" destOrd="0" presId="urn:microsoft.com/office/officeart/2005/8/layout/hierarchy2"/>
    <dgm:cxn modelId="{9D5208E0-3292-464F-BD75-077B9B810ED8}" type="presParOf" srcId="{63E65136-FB97-46CC-93F6-1E9121ADE6EE}" destId="{91501DD1-CFE9-4FBA-823D-10880E2002A9}" srcOrd="9" destOrd="0" presId="urn:microsoft.com/office/officeart/2005/8/layout/hierarchy2"/>
    <dgm:cxn modelId="{91F1DC3C-926C-4FD6-B67E-78392CBD503C}" type="presParOf" srcId="{91501DD1-CFE9-4FBA-823D-10880E2002A9}" destId="{963787CF-28FB-43DF-98C2-C462DE3D4B6D}" srcOrd="0" destOrd="0" presId="urn:microsoft.com/office/officeart/2005/8/layout/hierarchy2"/>
    <dgm:cxn modelId="{30B821F8-F6CC-421C-BA8D-AA3B0183CD06}" type="presParOf" srcId="{91501DD1-CFE9-4FBA-823D-10880E2002A9}" destId="{793CF8CB-4DC0-4A07-8366-31517125F577}" srcOrd="1" destOrd="0" presId="urn:microsoft.com/office/officeart/2005/8/layout/hierarchy2"/>
    <dgm:cxn modelId="{ABF2E6C8-2019-45CA-896E-4529A88515C7}" type="presParOf" srcId="{63E65136-FB97-46CC-93F6-1E9121ADE6EE}" destId="{52995CFF-A2C0-41A9-B8F6-E167247A0F1E}" srcOrd="10" destOrd="0" presId="urn:microsoft.com/office/officeart/2005/8/layout/hierarchy2"/>
    <dgm:cxn modelId="{A9224AB5-E523-4331-A327-B5A9534DA474}" type="presParOf" srcId="{52995CFF-A2C0-41A9-B8F6-E167247A0F1E}" destId="{363F3F8F-4CCA-4730-9344-E43FC3582DD0}" srcOrd="0" destOrd="0" presId="urn:microsoft.com/office/officeart/2005/8/layout/hierarchy2"/>
    <dgm:cxn modelId="{EBEFF2E9-D311-40A5-9A17-15EF1745C2E6}" type="presParOf" srcId="{63E65136-FB97-46CC-93F6-1E9121ADE6EE}" destId="{539280CC-7E34-4575-8E03-0EE6EBFD0B7C}" srcOrd="11" destOrd="0" presId="urn:microsoft.com/office/officeart/2005/8/layout/hierarchy2"/>
    <dgm:cxn modelId="{57422252-288C-48FA-B935-985DF04028FC}" type="presParOf" srcId="{539280CC-7E34-4575-8E03-0EE6EBFD0B7C}" destId="{15869452-7DB1-4E38-961A-AD18E7BF97A4}" srcOrd="0" destOrd="0" presId="urn:microsoft.com/office/officeart/2005/8/layout/hierarchy2"/>
    <dgm:cxn modelId="{ED4039E8-6923-4C41-B1E3-10F7BF3D3F34}" type="presParOf" srcId="{539280CC-7E34-4575-8E03-0EE6EBFD0B7C}" destId="{A67F4D00-5318-48B1-8F6F-4C6D0840EE34}" srcOrd="1" destOrd="0" presId="urn:microsoft.com/office/officeart/2005/8/layout/hierarchy2"/>
    <dgm:cxn modelId="{06717F61-43E2-4F69-925A-14AADC8270E2}" type="presParOf" srcId="{A67F4D00-5318-48B1-8F6F-4C6D0840EE34}" destId="{6DE65224-3B60-4229-ACDA-981AA44CA426}" srcOrd="0" destOrd="0" presId="urn:microsoft.com/office/officeart/2005/8/layout/hierarchy2"/>
    <dgm:cxn modelId="{DA0CCBD6-8447-4106-B082-BA8A7007C677}" type="presParOf" srcId="{6DE65224-3B60-4229-ACDA-981AA44CA426}" destId="{30A5F9D5-7BBD-431C-88C3-CC070B8111E2}" srcOrd="0" destOrd="0" presId="urn:microsoft.com/office/officeart/2005/8/layout/hierarchy2"/>
    <dgm:cxn modelId="{0097F2C7-AC29-4F24-80C3-6D0BA014875B}" type="presParOf" srcId="{A67F4D00-5318-48B1-8F6F-4C6D0840EE34}" destId="{4C27843F-B856-4330-96BA-255D39C16F9A}" srcOrd="1" destOrd="0" presId="urn:microsoft.com/office/officeart/2005/8/layout/hierarchy2"/>
    <dgm:cxn modelId="{052E1475-5936-4A09-AD9A-DDA2B66D9A31}" type="presParOf" srcId="{4C27843F-B856-4330-96BA-255D39C16F9A}" destId="{D2E49161-A7B6-4759-AC1C-493631AA99EA}" srcOrd="0" destOrd="0" presId="urn:microsoft.com/office/officeart/2005/8/layout/hierarchy2"/>
    <dgm:cxn modelId="{52773B41-F33C-4E77-B63B-22E0902091C2}" type="presParOf" srcId="{4C27843F-B856-4330-96BA-255D39C16F9A}" destId="{B34508A2-9F6C-4930-976B-93634811EA5F}" srcOrd="1" destOrd="0" presId="urn:microsoft.com/office/officeart/2005/8/layout/hierarchy2"/>
    <dgm:cxn modelId="{5D4DDC7A-5010-42C8-9AD3-8FE3A96A4F42}" type="presParOf" srcId="{A67F4D00-5318-48B1-8F6F-4C6D0840EE34}" destId="{D3655785-2D54-4F59-9234-66AFAA7E681A}" srcOrd="2" destOrd="0" presId="urn:microsoft.com/office/officeart/2005/8/layout/hierarchy2"/>
    <dgm:cxn modelId="{6BEBB540-1D6C-4EAE-AF7E-5DDEDC211AD1}" type="presParOf" srcId="{D3655785-2D54-4F59-9234-66AFAA7E681A}" destId="{9698C83B-59AA-460C-B76E-A13EFE8BCD17}" srcOrd="0" destOrd="0" presId="urn:microsoft.com/office/officeart/2005/8/layout/hierarchy2"/>
    <dgm:cxn modelId="{FA91B72A-3038-4A54-8ABE-87EA853FCC3C}" type="presParOf" srcId="{A67F4D00-5318-48B1-8F6F-4C6D0840EE34}" destId="{1C087AE5-74C3-48F7-9B1F-7643819D62F7}" srcOrd="3" destOrd="0" presId="urn:microsoft.com/office/officeart/2005/8/layout/hierarchy2"/>
    <dgm:cxn modelId="{87F84FEF-638F-4E90-8E6F-51BD504A70F2}" type="presParOf" srcId="{1C087AE5-74C3-48F7-9B1F-7643819D62F7}" destId="{A26EDAF6-44C8-4854-8F91-1F5749D4DC73}" srcOrd="0" destOrd="0" presId="urn:microsoft.com/office/officeart/2005/8/layout/hierarchy2"/>
    <dgm:cxn modelId="{CBCFE522-6DE8-4B1D-B88A-B9D50D85D2AD}" type="presParOf" srcId="{1C087AE5-74C3-48F7-9B1F-7643819D62F7}" destId="{E9A748F2-229D-45E3-B7F0-1D7693EBB797}" srcOrd="1" destOrd="0" presId="urn:microsoft.com/office/officeart/2005/8/layout/hierarchy2"/>
    <dgm:cxn modelId="{AC2EB3FF-6A64-4773-B986-35FE29F6FAF2}" type="presParOf" srcId="{A67F4D00-5318-48B1-8F6F-4C6D0840EE34}" destId="{FB2F6D88-F506-4847-B326-8EC15F62040F}" srcOrd="4" destOrd="0" presId="urn:microsoft.com/office/officeart/2005/8/layout/hierarchy2"/>
    <dgm:cxn modelId="{7BA27F37-18B8-4459-9FD4-013034FEC5DB}" type="presParOf" srcId="{FB2F6D88-F506-4847-B326-8EC15F62040F}" destId="{5BC45E89-1EAB-43BA-B311-8A95F182C2C2}" srcOrd="0" destOrd="0" presId="urn:microsoft.com/office/officeart/2005/8/layout/hierarchy2"/>
    <dgm:cxn modelId="{576F151C-5255-4F08-B925-D0C6BC4D6947}" type="presParOf" srcId="{A67F4D00-5318-48B1-8F6F-4C6D0840EE34}" destId="{66D7E067-5337-459E-866E-2A8CE9CD2228}" srcOrd="5" destOrd="0" presId="urn:microsoft.com/office/officeart/2005/8/layout/hierarchy2"/>
    <dgm:cxn modelId="{321B38E5-EE1B-4B1D-A3BF-8DE416A88537}" type="presParOf" srcId="{66D7E067-5337-459E-866E-2A8CE9CD2228}" destId="{4364814E-1DC4-41D8-96F5-7FCAA16DA2B0}" srcOrd="0" destOrd="0" presId="urn:microsoft.com/office/officeart/2005/8/layout/hierarchy2"/>
    <dgm:cxn modelId="{4A25102A-972A-4233-805F-16BEA3514E79}" type="presParOf" srcId="{66D7E067-5337-459E-866E-2A8CE9CD2228}" destId="{654D766E-39ED-4868-AAEF-1A28544B5F5D}" srcOrd="1" destOrd="0" presId="urn:microsoft.com/office/officeart/2005/8/layout/hierarchy2"/>
    <dgm:cxn modelId="{7CA94465-80EB-4D5B-9580-DBF783C6FB6A}" type="presParOf" srcId="{A67F4D00-5318-48B1-8F6F-4C6D0840EE34}" destId="{5BC2E700-F976-45E3-88A6-547D0BC5C286}" srcOrd="6" destOrd="0" presId="urn:microsoft.com/office/officeart/2005/8/layout/hierarchy2"/>
    <dgm:cxn modelId="{0ECCEF91-D189-45D6-9A4F-E9BD3D65BE69}" type="presParOf" srcId="{5BC2E700-F976-45E3-88A6-547D0BC5C286}" destId="{5EE677E4-1C6E-4B89-9610-5064AAB1F7F5}" srcOrd="0" destOrd="0" presId="urn:microsoft.com/office/officeart/2005/8/layout/hierarchy2"/>
    <dgm:cxn modelId="{A67EB32F-7804-4F4E-BE80-96593AD330CF}" type="presParOf" srcId="{A67F4D00-5318-48B1-8F6F-4C6D0840EE34}" destId="{6A66418A-D546-46F7-87E7-DA1E687FB1FE}" srcOrd="7" destOrd="0" presId="urn:microsoft.com/office/officeart/2005/8/layout/hierarchy2"/>
    <dgm:cxn modelId="{3A9388F7-7C21-451D-99C2-633FDE439124}" type="presParOf" srcId="{6A66418A-D546-46F7-87E7-DA1E687FB1FE}" destId="{677DE54C-6078-40B3-9FE8-CF37F7EF3F0C}" srcOrd="0" destOrd="0" presId="urn:microsoft.com/office/officeart/2005/8/layout/hierarchy2"/>
    <dgm:cxn modelId="{F60C5AC0-8147-4907-8379-FF40B5FFA4BC}" type="presParOf" srcId="{6A66418A-D546-46F7-87E7-DA1E687FB1FE}" destId="{A887E327-8C38-4695-BD51-70185935A672}" srcOrd="1" destOrd="0" presId="urn:microsoft.com/office/officeart/2005/8/layout/hierarchy2"/>
    <dgm:cxn modelId="{288CCAA8-2435-4DCC-B56B-1F8D72EA1CC4}" type="presParOf" srcId="{A67F4D00-5318-48B1-8F6F-4C6D0840EE34}" destId="{007AF09B-7B63-4C84-BFB2-EF40ED79070D}" srcOrd="8" destOrd="0" presId="urn:microsoft.com/office/officeart/2005/8/layout/hierarchy2"/>
    <dgm:cxn modelId="{0942A9B8-9920-49B7-A73C-33E094C171FC}" type="presParOf" srcId="{007AF09B-7B63-4C84-BFB2-EF40ED79070D}" destId="{1C784E67-44D5-495B-BFB2-4C4FDB887CF2}" srcOrd="0" destOrd="0" presId="urn:microsoft.com/office/officeart/2005/8/layout/hierarchy2"/>
    <dgm:cxn modelId="{11DD04B2-587F-498E-8E59-9A861DC11A03}" type="presParOf" srcId="{A67F4D00-5318-48B1-8F6F-4C6D0840EE34}" destId="{DF9FF149-B0C6-4C8C-BC41-DF43A2913708}" srcOrd="9" destOrd="0" presId="urn:microsoft.com/office/officeart/2005/8/layout/hierarchy2"/>
    <dgm:cxn modelId="{A60DB433-9F51-4C68-8039-B5FE027626C8}" type="presParOf" srcId="{DF9FF149-B0C6-4C8C-BC41-DF43A2913708}" destId="{38194E2B-8C9B-446D-93B0-01D743C0AC69}" srcOrd="0" destOrd="0" presId="urn:microsoft.com/office/officeart/2005/8/layout/hierarchy2"/>
    <dgm:cxn modelId="{2D2767F6-5904-466F-822B-4C189A526FC2}" type="presParOf" srcId="{DF9FF149-B0C6-4C8C-BC41-DF43A2913708}" destId="{B2CF7225-C61E-43D9-B9C8-7DB119B5C411}" srcOrd="1" destOrd="0" presId="urn:microsoft.com/office/officeart/2005/8/layout/hierarchy2"/>
    <dgm:cxn modelId="{64B399DA-9B0F-4C56-A3F2-F07CE951986F}" type="presParOf" srcId="{457B3FD6-8EF7-4A94-BB29-C9471CDE92CD}" destId="{925EDBFF-3D85-437B-9D22-40DBEB5AB8DA}" srcOrd="4" destOrd="0" presId="urn:microsoft.com/office/officeart/2005/8/layout/hierarchy2"/>
    <dgm:cxn modelId="{4CB8633B-5455-490C-B9BE-B085B68E2591}" type="presParOf" srcId="{925EDBFF-3D85-437B-9D22-40DBEB5AB8DA}" destId="{B814C4C0-4FD5-42D0-888F-22B47EF7775E}" srcOrd="0" destOrd="0" presId="urn:microsoft.com/office/officeart/2005/8/layout/hierarchy2"/>
    <dgm:cxn modelId="{51F9543F-E56B-43AA-A1A5-9161EF023FAF}" type="presParOf" srcId="{457B3FD6-8EF7-4A94-BB29-C9471CDE92CD}" destId="{32813329-F5DE-4D43-9999-7021733058B4}" srcOrd="5" destOrd="0" presId="urn:microsoft.com/office/officeart/2005/8/layout/hierarchy2"/>
    <dgm:cxn modelId="{E691172E-A2A1-4ED8-9433-4E89B03CA2F3}" type="presParOf" srcId="{32813329-F5DE-4D43-9999-7021733058B4}" destId="{933E68AA-CF10-49A1-ABCC-DA114DDEAF2A}" srcOrd="0" destOrd="0" presId="urn:microsoft.com/office/officeart/2005/8/layout/hierarchy2"/>
    <dgm:cxn modelId="{040C7049-E196-4D1B-AD9D-BB3C6BA87370}" type="presParOf" srcId="{32813329-F5DE-4D43-9999-7021733058B4}" destId="{0BB7042D-0783-4AF0-A2AC-0560AE754DBB}" srcOrd="1" destOrd="0" presId="urn:microsoft.com/office/officeart/2005/8/layout/hierarchy2"/>
    <dgm:cxn modelId="{9DD4D88E-25B8-49C5-ABD0-5F5385177ACC}" type="presParOf" srcId="{0BB7042D-0783-4AF0-A2AC-0560AE754DBB}" destId="{0E872D06-F66B-4811-92EA-E374B25899A2}" srcOrd="0" destOrd="0" presId="urn:microsoft.com/office/officeart/2005/8/layout/hierarchy2"/>
    <dgm:cxn modelId="{ACE64050-B8AE-444A-B9BA-D2FEFFDC35AA}" type="presParOf" srcId="{0E872D06-F66B-4811-92EA-E374B25899A2}" destId="{72B52D37-7D34-4ADE-968E-0497344DEB80}" srcOrd="0" destOrd="0" presId="urn:microsoft.com/office/officeart/2005/8/layout/hierarchy2"/>
    <dgm:cxn modelId="{9094CD33-D848-4AE5-844A-5E0AF49A8A3D}" type="presParOf" srcId="{0BB7042D-0783-4AF0-A2AC-0560AE754DBB}" destId="{02CBB79E-92BB-43E9-BC76-EB3CA055D3F6}" srcOrd="1" destOrd="0" presId="urn:microsoft.com/office/officeart/2005/8/layout/hierarchy2"/>
    <dgm:cxn modelId="{E1629CE1-086B-4C61-8969-C90947BC4685}" type="presParOf" srcId="{02CBB79E-92BB-43E9-BC76-EB3CA055D3F6}" destId="{3F552C8C-859A-4030-A503-8872BA917E0A}" srcOrd="0" destOrd="0" presId="urn:microsoft.com/office/officeart/2005/8/layout/hierarchy2"/>
    <dgm:cxn modelId="{11A62BF8-4D7C-4911-97EE-B3F43D79ABAE}" type="presParOf" srcId="{02CBB79E-92BB-43E9-BC76-EB3CA055D3F6}" destId="{90941FE9-BA76-4E83-BB38-DFDC96B69634}" srcOrd="1" destOrd="0" presId="urn:microsoft.com/office/officeart/2005/8/layout/hierarchy2"/>
    <dgm:cxn modelId="{DC966E1F-910C-4CE7-9572-85DCE2170180}" type="presParOf" srcId="{0BB7042D-0783-4AF0-A2AC-0560AE754DBB}" destId="{168B63D6-E582-4001-8D06-4264135971C6}" srcOrd="2" destOrd="0" presId="urn:microsoft.com/office/officeart/2005/8/layout/hierarchy2"/>
    <dgm:cxn modelId="{295D804C-1CAB-4BE7-8779-040C5D60448B}" type="presParOf" srcId="{168B63D6-E582-4001-8D06-4264135971C6}" destId="{1CC6C369-6E50-42DA-A881-F2FD7708779E}" srcOrd="0" destOrd="0" presId="urn:microsoft.com/office/officeart/2005/8/layout/hierarchy2"/>
    <dgm:cxn modelId="{BE6B2F30-7AC9-405E-ACA9-9F3CFA33C526}" type="presParOf" srcId="{0BB7042D-0783-4AF0-A2AC-0560AE754DBB}" destId="{509B91C6-26BD-453B-AB33-E3A76B562994}" srcOrd="3" destOrd="0" presId="urn:microsoft.com/office/officeart/2005/8/layout/hierarchy2"/>
    <dgm:cxn modelId="{D9CBE557-F63A-40DC-A7B1-26841874A930}" type="presParOf" srcId="{509B91C6-26BD-453B-AB33-E3A76B562994}" destId="{BF83AAD4-9518-47AA-835D-A40E2C49AF13}" srcOrd="0" destOrd="0" presId="urn:microsoft.com/office/officeart/2005/8/layout/hierarchy2"/>
    <dgm:cxn modelId="{E3C02B0F-9CDD-456D-B6F5-91A97FDEAC58}" type="presParOf" srcId="{509B91C6-26BD-453B-AB33-E3A76B562994}" destId="{372B43B3-F831-4836-9D42-D22FD7E162E2}" srcOrd="1" destOrd="0" presId="urn:microsoft.com/office/officeart/2005/8/layout/hierarchy2"/>
    <dgm:cxn modelId="{3C1D07DE-91EA-4CE0-8E02-94F5D82C28F9}" type="presParOf" srcId="{0BB7042D-0783-4AF0-A2AC-0560AE754DBB}" destId="{12649787-8B1A-4097-B62E-BBC1879F2014}" srcOrd="4" destOrd="0" presId="urn:microsoft.com/office/officeart/2005/8/layout/hierarchy2"/>
    <dgm:cxn modelId="{FA3ED925-22A7-4EFC-975B-2F203FA8250C}" type="presParOf" srcId="{12649787-8B1A-4097-B62E-BBC1879F2014}" destId="{D70BE76E-DF8A-41C7-B32C-B201D4602719}" srcOrd="0" destOrd="0" presId="urn:microsoft.com/office/officeart/2005/8/layout/hierarchy2"/>
    <dgm:cxn modelId="{6509DE06-AE6C-46FE-BB51-AE67BEAF0925}" type="presParOf" srcId="{0BB7042D-0783-4AF0-A2AC-0560AE754DBB}" destId="{6FBA47E0-66A4-4DA5-A275-39BDD110ECB7}" srcOrd="5" destOrd="0" presId="urn:microsoft.com/office/officeart/2005/8/layout/hierarchy2"/>
    <dgm:cxn modelId="{57763950-B10B-4A81-B5EE-B58320A0BC06}" type="presParOf" srcId="{6FBA47E0-66A4-4DA5-A275-39BDD110ECB7}" destId="{D4B8489D-29A0-450D-846E-6780D2436C16}" srcOrd="0" destOrd="0" presId="urn:microsoft.com/office/officeart/2005/8/layout/hierarchy2"/>
    <dgm:cxn modelId="{E736CB94-B675-4F32-899B-A24F5D3665C1}" type="presParOf" srcId="{6FBA47E0-66A4-4DA5-A275-39BDD110ECB7}" destId="{359345A4-19E5-49DB-8245-6F2492C61000}" srcOrd="1" destOrd="0" presId="urn:microsoft.com/office/officeart/2005/8/layout/hierarchy2"/>
    <dgm:cxn modelId="{13B21A5D-2141-4630-8C0C-5BB6BB642B8A}" type="presParOf" srcId="{0BB7042D-0783-4AF0-A2AC-0560AE754DBB}" destId="{87A49760-64CE-4CBD-BF78-45B22D2A4949}" srcOrd="6" destOrd="0" presId="urn:microsoft.com/office/officeart/2005/8/layout/hierarchy2"/>
    <dgm:cxn modelId="{C568A2B5-9ED7-4CD7-8B4E-B9B8DC91BAAF}" type="presParOf" srcId="{87A49760-64CE-4CBD-BF78-45B22D2A4949}" destId="{894D3D26-1468-4F2C-88F6-01751D8C7D69}" srcOrd="0" destOrd="0" presId="urn:microsoft.com/office/officeart/2005/8/layout/hierarchy2"/>
    <dgm:cxn modelId="{82BD302C-BDA5-4CE2-8B1F-D71D150EEB4B}" type="presParOf" srcId="{0BB7042D-0783-4AF0-A2AC-0560AE754DBB}" destId="{0B54FA82-637D-47AA-AA43-07DF2CC550CF}" srcOrd="7" destOrd="0" presId="urn:microsoft.com/office/officeart/2005/8/layout/hierarchy2"/>
    <dgm:cxn modelId="{2E482FBD-973B-4F76-A52B-BC0D4152D5FE}" type="presParOf" srcId="{0B54FA82-637D-47AA-AA43-07DF2CC550CF}" destId="{C50E5B3A-B9FE-43B9-85D2-DC2953853106}" srcOrd="0" destOrd="0" presId="urn:microsoft.com/office/officeart/2005/8/layout/hierarchy2"/>
    <dgm:cxn modelId="{B285FA97-85AD-4303-9608-28F0B8BE1F7C}" type="presParOf" srcId="{0B54FA82-637D-47AA-AA43-07DF2CC550CF}" destId="{55980929-F735-4B98-A398-02108F7A9B12}" srcOrd="1" destOrd="0" presId="urn:microsoft.com/office/officeart/2005/8/layout/hierarchy2"/>
    <dgm:cxn modelId="{52341875-A59B-41C4-AD2A-74124AA03C90}" type="presParOf" srcId="{0BB7042D-0783-4AF0-A2AC-0560AE754DBB}" destId="{FC687F4F-95AF-4388-A390-2F0E64666848}" srcOrd="8" destOrd="0" presId="urn:microsoft.com/office/officeart/2005/8/layout/hierarchy2"/>
    <dgm:cxn modelId="{6F821025-9F47-41D4-8EEF-EFE49574530A}" type="presParOf" srcId="{FC687F4F-95AF-4388-A390-2F0E64666848}" destId="{94C13FA5-1561-4553-ADA9-69D482E5248A}" srcOrd="0" destOrd="0" presId="urn:microsoft.com/office/officeart/2005/8/layout/hierarchy2"/>
    <dgm:cxn modelId="{FE2C469A-3240-42ED-912D-300C267CB894}" type="presParOf" srcId="{0BB7042D-0783-4AF0-A2AC-0560AE754DBB}" destId="{33E788E1-A069-4A13-98BB-73D866B82E71}" srcOrd="9" destOrd="0" presId="urn:microsoft.com/office/officeart/2005/8/layout/hierarchy2"/>
    <dgm:cxn modelId="{8CA05B30-D4F5-43DA-8CA5-EDA64B056DF1}" type="presParOf" srcId="{33E788E1-A069-4A13-98BB-73D866B82E71}" destId="{D7C3B540-AAE3-47B6-8689-6F42331FBB0D}" srcOrd="0" destOrd="0" presId="urn:microsoft.com/office/officeart/2005/8/layout/hierarchy2"/>
    <dgm:cxn modelId="{DE2AB737-659A-4C0D-80C6-83B0D8F40570}" type="presParOf" srcId="{33E788E1-A069-4A13-98BB-73D866B82E71}" destId="{85CD2B0D-0C87-4BEE-9E1C-E0A79E674051}" srcOrd="1" destOrd="0" presId="urn:microsoft.com/office/officeart/2005/8/layout/hierarchy2"/>
    <dgm:cxn modelId="{44762066-E709-4D23-B0C5-F6A4AB93BC28}" type="presParOf" srcId="{457B3FD6-8EF7-4A94-BB29-C9471CDE92CD}" destId="{91683DB7-5821-4F63-939D-8271AEDB1AC2}" srcOrd="6" destOrd="0" presId="urn:microsoft.com/office/officeart/2005/8/layout/hierarchy2"/>
    <dgm:cxn modelId="{8F278349-4E03-46B2-81B9-042A5FEFB738}" type="presParOf" srcId="{91683DB7-5821-4F63-939D-8271AEDB1AC2}" destId="{D9B96937-FBE0-4586-A2C5-BC85D2155D05}" srcOrd="0" destOrd="0" presId="urn:microsoft.com/office/officeart/2005/8/layout/hierarchy2"/>
    <dgm:cxn modelId="{A7C75217-9777-4AEF-89A8-A26CA7E648D1}" type="presParOf" srcId="{457B3FD6-8EF7-4A94-BB29-C9471CDE92CD}" destId="{EE01913B-A6F0-42CE-AF5A-9DEAF5D8DBB0}" srcOrd="7" destOrd="0" presId="urn:microsoft.com/office/officeart/2005/8/layout/hierarchy2"/>
    <dgm:cxn modelId="{1C9D34A8-28FB-4796-BA30-BBE94AF7AC7B}" type="presParOf" srcId="{EE01913B-A6F0-42CE-AF5A-9DEAF5D8DBB0}" destId="{DDCB18A7-5217-498E-8109-AEC8891AEF63}" srcOrd="0" destOrd="0" presId="urn:microsoft.com/office/officeart/2005/8/layout/hierarchy2"/>
    <dgm:cxn modelId="{47D89B06-8875-413D-BF36-1A1556995BB1}" type="presParOf" srcId="{EE01913B-A6F0-42CE-AF5A-9DEAF5D8DBB0}" destId="{B02E7AF6-66DA-4252-B52D-833FA55306E0}" srcOrd="1" destOrd="0" presId="urn:microsoft.com/office/officeart/2005/8/layout/hierarchy2"/>
    <dgm:cxn modelId="{CE5161CC-0B65-4F18-9E52-93216F483609}" type="presParOf" srcId="{B02E7AF6-66DA-4252-B52D-833FA55306E0}" destId="{87C9AC31-CDDE-4E1F-B79F-69064C460489}" srcOrd="0" destOrd="0" presId="urn:microsoft.com/office/officeart/2005/8/layout/hierarchy2"/>
    <dgm:cxn modelId="{B48AA77D-169E-44B1-ABFD-65D61AD3742C}" type="presParOf" srcId="{87C9AC31-CDDE-4E1F-B79F-69064C460489}" destId="{EBD2F8EB-D76E-4ECE-AD86-C67210D41D3D}" srcOrd="0" destOrd="0" presId="urn:microsoft.com/office/officeart/2005/8/layout/hierarchy2"/>
    <dgm:cxn modelId="{7E6D547F-7095-4886-B75B-09E398A48620}" type="presParOf" srcId="{B02E7AF6-66DA-4252-B52D-833FA55306E0}" destId="{18B3E9C4-212E-4910-9E2D-34244862C8BF}" srcOrd="1" destOrd="0" presId="urn:microsoft.com/office/officeart/2005/8/layout/hierarchy2"/>
    <dgm:cxn modelId="{0F30C815-9587-459D-ADBC-9850B140A832}" type="presParOf" srcId="{18B3E9C4-212E-4910-9E2D-34244862C8BF}" destId="{BD9D8B61-1FCA-4DBF-95E6-59B9130798B9}" srcOrd="0" destOrd="0" presId="urn:microsoft.com/office/officeart/2005/8/layout/hierarchy2"/>
    <dgm:cxn modelId="{E25CD250-8A58-40E0-9094-9D8531FFFF44}" type="presParOf" srcId="{18B3E9C4-212E-4910-9E2D-34244862C8BF}" destId="{518C82D6-093F-4ABC-ABE5-99666F772EAD}" srcOrd="1" destOrd="0" presId="urn:microsoft.com/office/officeart/2005/8/layout/hierarchy2"/>
    <dgm:cxn modelId="{EA1892D2-95D5-4ED5-8658-2022C89B295D}" type="presParOf" srcId="{B02E7AF6-66DA-4252-B52D-833FA55306E0}" destId="{56FAFC49-D0EA-4E25-8D48-7123A498BD9B}" srcOrd="2" destOrd="0" presId="urn:microsoft.com/office/officeart/2005/8/layout/hierarchy2"/>
    <dgm:cxn modelId="{9B64216F-A830-4172-9928-D7740C8C3243}" type="presParOf" srcId="{56FAFC49-D0EA-4E25-8D48-7123A498BD9B}" destId="{69674B81-12B1-4530-81E5-B46611BDEBD3}" srcOrd="0" destOrd="0" presId="urn:microsoft.com/office/officeart/2005/8/layout/hierarchy2"/>
    <dgm:cxn modelId="{DE49BE2B-082B-4DDE-B3ED-E76126F6075E}" type="presParOf" srcId="{B02E7AF6-66DA-4252-B52D-833FA55306E0}" destId="{AC80BB0E-C09A-4A3A-A6DC-68DD0D75747A}" srcOrd="3" destOrd="0" presId="urn:microsoft.com/office/officeart/2005/8/layout/hierarchy2"/>
    <dgm:cxn modelId="{2640A66A-1D0B-4DCB-A5EC-F2BDA45CBE80}" type="presParOf" srcId="{AC80BB0E-C09A-4A3A-A6DC-68DD0D75747A}" destId="{E730F18F-48B0-4E0B-9A8D-D539E63CE9D4}" srcOrd="0" destOrd="0" presId="urn:microsoft.com/office/officeart/2005/8/layout/hierarchy2"/>
    <dgm:cxn modelId="{9935A020-F756-41F7-BEA0-A98E196AD2E9}" type="presParOf" srcId="{AC80BB0E-C09A-4A3A-A6DC-68DD0D75747A}" destId="{360EA3B4-0F47-4D6B-A63D-BB2A4077DE52}" srcOrd="1" destOrd="0" presId="urn:microsoft.com/office/officeart/2005/8/layout/hierarchy2"/>
    <dgm:cxn modelId="{818251BF-A941-4F13-9E32-540F48D8DDC9}" type="presParOf" srcId="{360EA3B4-0F47-4D6B-A63D-BB2A4077DE52}" destId="{04B5A4E1-0824-444B-B0DF-49A3641E7799}" srcOrd="0" destOrd="0" presId="urn:microsoft.com/office/officeart/2005/8/layout/hierarchy2"/>
    <dgm:cxn modelId="{25EA96E6-0434-4A0A-8576-DE47791ACE9A}" type="presParOf" srcId="{04B5A4E1-0824-444B-B0DF-49A3641E7799}" destId="{272D572E-5B26-4488-A75D-C75C5F075451}" srcOrd="0" destOrd="0" presId="urn:microsoft.com/office/officeart/2005/8/layout/hierarchy2"/>
    <dgm:cxn modelId="{42282F3A-D510-4D42-8D26-542B8C0B23F2}" type="presParOf" srcId="{360EA3B4-0F47-4D6B-A63D-BB2A4077DE52}" destId="{19108BD8-503D-4075-A1CF-53550D590BD4}" srcOrd="1" destOrd="0" presId="urn:microsoft.com/office/officeart/2005/8/layout/hierarchy2"/>
    <dgm:cxn modelId="{27C00C35-1119-466D-A9F7-A496549AFB97}" type="presParOf" srcId="{19108BD8-503D-4075-A1CF-53550D590BD4}" destId="{4DCF8B3D-4AC6-4BA4-83D6-71D9BD5CEED2}" srcOrd="0" destOrd="0" presId="urn:microsoft.com/office/officeart/2005/8/layout/hierarchy2"/>
    <dgm:cxn modelId="{B7C86938-078E-4DB6-AE20-FB0524252785}" type="presParOf" srcId="{19108BD8-503D-4075-A1CF-53550D590BD4}" destId="{D35E8196-0F33-4D66-8A3D-9E7CA82C9867}" srcOrd="1" destOrd="0" presId="urn:microsoft.com/office/officeart/2005/8/layout/hierarchy2"/>
    <dgm:cxn modelId="{06148604-44D5-4AF6-BCDE-7D887C3FEFB7}" type="presParOf" srcId="{360EA3B4-0F47-4D6B-A63D-BB2A4077DE52}" destId="{4422E06E-D77E-4F56-8840-95885C852043}" srcOrd="2" destOrd="0" presId="urn:microsoft.com/office/officeart/2005/8/layout/hierarchy2"/>
    <dgm:cxn modelId="{EC258D87-0611-47E4-B663-C60749C8949A}" type="presParOf" srcId="{4422E06E-D77E-4F56-8840-95885C852043}" destId="{78BB6245-6919-431D-8F6D-FEFDFE3AC3B2}" srcOrd="0" destOrd="0" presId="urn:microsoft.com/office/officeart/2005/8/layout/hierarchy2"/>
    <dgm:cxn modelId="{972B387F-DB03-4F29-995C-ED70F07680EC}" type="presParOf" srcId="{360EA3B4-0F47-4D6B-A63D-BB2A4077DE52}" destId="{D65C5CDD-56AD-44ED-96AA-F28E3AD2C69B}" srcOrd="3" destOrd="0" presId="urn:microsoft.com/office/officeart/2005/8/layout/hierarchy2"/>
    <dgm:cxn modelId="{935CC4BE-DFEB-4797-9B67-95BA3718EE81}" type="presParOf" srcId="{D65C5CDD-56AD-44ED-96AA-F28E3AD2C69B}" destId="{63E06D80-B4DA-4AF5-B318-48676A80383C}" srcOrd="0" destOrd="0" presId="urn:microsoft.com/office/officeart/2005/8/layout/hierarchy2"/>
    <dgm:cxn modelId="{0D61875E-510B-49C4-968A-9492B8BC6543}" type="presParOf" srcId="{D65C5CDD-56AD-44ED-96AA-F28E3AD2C69B}" destId="{FF8F3D66-F4A7-4E59-9130-E75CEE01CEC5}" srcOrd="1" destOrd="0" presId="urn:microsoft.com/office/officeart/2005/8/layout/hierarchy2"/>
    <dgm:cxn modelId="{4AA42FEB-2061-4344-9DC6-7960868B2F16}" type="presParOf" srcId="{B02E7AF6-66DA-4252-B52D-833FA55306E0}" destId="{82D2DBC9-D5F1-41B2-B475-FC62C3A7004B}" srcOrd="4" destOrd="0" presId="urn:microsoft.com/office/officeart/2005/8/layout/hierarchy2"/>
    <dgm:cxn modelId="{1F4C73C5-461C-4000-B3EF-81B961517303}" type="presParOf" srcId="{82D2DBC9-D5F1-41B2-B475-FC62C3A7004B}" destId="{14C8F2DC-5402-4C02-AEC9-5324C6C4963A}" srcOrd="0" destOrd="0" presId="urn:microsoft.com/office/officeart/2005/8/layout/hierarchy2"/>
    <dgm:cxn modelId="{4C68B7D9-FDA5-4EFE-8DB0-027A47F52894}" type="presParOf" srcId="{B02E7AF6-66DA-4252-B52D-833FA55306E0}" destId="{939F4CFE-8C60-446F-BA29-9CB807C1727D}" srcOrd="5" destOrd="0" presId="urn:microsoft.com/office/officeart/2005/8/layout/hierarchy2"/>
    <dgm:cxn modelId="{4A6BB811-27C2-4E56-BCC8-CD272A3AB184}" type="presParOf" srcId="{939F4CFE-8C60-446F-BA29-9CB807C1727D}" destId="{481798CD-BDE5-4B57-B01A-E2CEFF5196BF}" srcOrd="0" destOrd="0" presId="urn:microsoft.com/office/officeart/2005/8/layout/hierarchy2"/>
    <dgm:cxn modelId="{C58BBC9F-FCFE-4EC8-A4FC-04FFD0876FAC}" type="presParOf" srcId="{939F4CFE-8C60-446F-BA29-9CB807C1727D}" destId="{B42E1832-2937-4B92-8923-31358112F338}" srcOrd="1" destOrd="0" presId="urn:microsoft.com/office/officeart/2005/8/layout/hierarchy2"/>
    <dgm:cxn modelId="{AD632E8B-A693-4C2B-86F4-B40B7DF85027}" type="presParOf" srcId="{B02E7AF6-66DA-4252-B52D-833FA55306E0}" destId="{22457488-96D2-492A-A67D-1DA42B35C92F}" srcOrd="6" destOrd="0" presId="urn:microsoft.com/office/officeart/2005/8/layout/hierarchy2"/>
    <dgm:cxn modelId="{3ED1A33A-D4F2-4129-8724-58752E1EE3A3}" type="presParOf" srcId="{22457488-96D2-492A-A67D-1DA42B35C92F}" destId="{7E42A3E7-F188-48F4-99B5-B1F4D367F825}" srcOrd="0" destOrd="0" presId="urn:microsoft.com/office/officeart/2005/8/layout/hierarchy2"/>
    <dgm:cxn modelId="{9EC0CA5F-1049-4967-817A-BD4A696D5579}" type="presParOf" srcId="{B02E7AF6-66DA-4252-B52D-833FA55306E0}" destId="{40E1F38D-F838-4B3A-8959-C57390990E61}" srcOrd="7" destOrd="0" presId="urn:microsoft.com/office/officeart/2005/8/layout/hierarchy2"/>
    <dgm:cxn modelId="{A05D6F94-59A3-48CC-998D-46457398F056}" type="presParOf" srcId="{40E1F38D-F838-4B3A-8959-C57390990E61}" destId="{DC301E58-40D8-4D3D-9A40-BAA0C92BDE59}" srcOrd="0" destOrd="0" presId="urn:microsoft.com/office/officeart/2005/8/layout/hierarchy2"/>
    <dgm:cxn modelId="{D2AC992A-3010-4A5E-A3C4-82C284D9D699}" type="presParOf" srcId="{40E1F38D-F838-4B3A-8959-C57390990E61}" destId="{F06368F7-EC0F-4A1D-9A8E-247D54BEDDBC}" srcOrd="1" destOrd="0" presId="urn:microsoft.com/office/officeart/2005/8/layout/hierarchy2"/>
    <dgm:cxn modelId="{4D8E657E-4E42-4457-B0FF-9849F7410392}" type="presParOf" srcId="{B02E7AF6-66DA-4252-B52D-833FA55306E0}" destId="{2E231434-ED7F-44D1-8C73-4DA73C333BE6}" srcOrd="8" destOrd="0" presId="urn:microsoft.com/office/officeart/2005/8/layout/hierarchy2"/>
    <dgm:cxn modelId="{21E6F8B5-D09B-4DC3-9B99-584A82D29644}" type="presParOf" srcId="{2E231434-ED7F-44D1-8C73-4DA73C333BE6}" destId="{1DF7A0FE-D847-4A6C-886A-53CFFF4E83C7}" srcOrd="0" destOrd="0" presId="urn:microsoft.com/office/officeart/2005/8/layout/hierarchy2"/>
    <dgm:cxn modelId="{AC8B39D1-3353-4CC3-A15A-60C5D076CEA0}" type="presParOf" srcId="{B02E7AF6-66DA-4252-B52D-833FA55306E0}" destId="{BE8A502F-FC97-4D68-B5C8-EF15A6D273CA}" srcOrd="9" destOrd="0" presId="urn:microsoft.com/office/officeart/2005/8/layout/hierarchy2"/>
    <dgm:cxn modelId="{4DE378C2-FFBF-46D3-A70C-5A20A6FECC69}" type="presParOf" srcId="{BE8A502F-FC97-4D68-B5C8-EF15A6D273CA}" destId="{665072C3-8ADE-40C1-BDA5-4FAA68E4319F}" srcOrd="0" destOrd="0" presId="urn:microsoft.com/office/officeart/2005/8/layout/hierarchy2"/>
    <dgm:cxn modelId="{7362117A-C29A-4045-BB09-85A8BE660275}" type="presParOf" srcId="{BE8A502F-FC97-4D68-B5C8-EF15A6D273CA}" destId="{351C6D74-3715-400D-811D-2BFE8ADB6101}" srcOrd="1" destOrd="0" presId="urn:microsoft.com/office/officeart/2005/8/layout/hierarchy2"/>
    <dgm:cxn modelId="{FF5DF936-8891-4C3A-AA5B-4017BBB9299A}" type="presParOf" srcId="{B02E7AF6-66DA-4252-B52D-833FA55306E0}" destId="{134D7A88-2D4D-4FE0-A203-5D2DFDE9B8B0}" srcOrd="10" destOrd="0" presId="urn:microsoft.com/office/officeart/2005/8/layout/hierarchy2"/>
    <dgm:cxn modelId="{BD46A77C-A169-424A-8918-85257FB0E4DF}" type="presParOf" srcId="{134D7A88-2D4D-4FE0-A203-5D2DFDE9B8B0}" destId="{E34F5E68-97F6-448B-93CC-7F50A4D760A8}" srcOrd="0" destOrd="0" presId="urn:microsoft.com/office/officeart/2005/8/layout/hierarchy2"/>
    <dgm:cxn modelId="{504DCDC5-B203-4050-B300-BD5D8E47DC4E}" type="presParOf" srcId="{B02E7AF6-66DA-4252-B52D-833FA55306E0}" destId="{F778CF73-89A3-42BA-AB6F-C2C1BC63090E}" srcOrd="11" destOrd="0" presId="urn:microsoft.com/office/officeart/2005/8/layout/hierarchy2"/>
    <dgm:cxn modelId="{E454AE1C-B4EB-40E6-B808-79CB984EAEC5}" type="presParOf" srcId="{F778CF73-89A3-42BA-AB6F-C2C1BC63090E}" destId="{3E90B72A-F33B-4C19-AA15-D10953CC4340}" srcOrd="0" destOrd="0" presId="urn:microsoft.com/office/officeart/2005/8/layout/hierarchy2"/>
    <dgm:cxn modelId="{363D4AB3-F5EA-4EB8-9059-EDF365BF5E31}" type="presParOf" srcId="{F778CF73-89A3-42BA-AB6F-C2C1BC63090E}" destId="{D524E27F-D99E-41B2-BF90-B4E8FC5E68DB}" srcOrd="1" destOrd="0" presId="urn:microsoft.com/office/officeart/2005/8/layout/hierarchy2"/>
    <dgm:cxn modelId="{EEB67A15-9290-4843-967C-189B91A4BB19}" type="presParOf" srcId="{B02E7AF6-66DA-4252-B52D-833FA55306E0}" destId="{CBE2BF13-B4B2-4CCE-B9CD-9C2AE1DB9827}" srcOrd="12" destOrd="0" presId="urn:microsoft.com/office/officeart/2005/8/layout/hierarchy2"/>
    <dgm:cxn modelId="{4ED6EDA7-8B4D-4EE0-AAA5-1075E91A6289}" type="presParOf" srcId="{CBE2BF13-B4B2-4CCE-B9CD-9C2AE1DB9827}" destId="{BCDDDD5C-AFED-4205-A736-CCA5522531A5}" srcOrd="0" destOrd="0" presId="urn:microsoft.com/office/officeart/2005/8/layout/hierarchy2"/>
    <dgm:cxn modelId="{0BF7967A-8710-41B4-9519-17CC05724561}" type="presParOf" srcId="{B02E7AF6-66DA-4252-B52D-833FA55306E0}" destId="{D82F3EC8-11FE-44FB-A347-97A3FBA6D574}" srcOrd="13" destOrd="0" presId="urn:microsoft.com/office/officeart/2005/8/layout/hierarchy2"/>
    <dgm:cxn modelId="{82D6CA74-8187-4C98-BA26-B4DE6B22FC54}" type="presParOf" srcId="{D82F3EC8-11FE-44FB-A347-97A3FBA6D574}" destId="{48E4B145-A01E-4F97-9B06-6C33D2269A47}" srcOrd="0" destOrd="0" presId="urn:microsoft.com/office/officeart/2005/8/layout/hierarchy2"/>
    <dgm:cxn modelId="{588EA4D5-9213-4BBE-9454-2F5814EC7CF1}" type="presParOf" srcId="{D82F3EC8-11FE-44FB-A347-97A3FBA6D574}" destId="{47268DB0-FBEE-4541-9325-FAEE019D20F8}" srcOrd="1" destOrd="0" presId="urn:microsoft.com/office/officeart/2005/8/layout/hierarchy2"/>
    <dgm:cxn modelId="{51021CF5-DD2A-4982-BF30-DE72ED234BA1}" type="presParOf" srcId="{B02E7AF6-66DA-4252-B52D-833FA55306E0}" destId="{92D0DEB7-F9E3-4085-A056-1B4AA5D907F0}" srcOrd="14" destOrd="0" presId="urn:microsoft.com/office/officeart/2005/8/layout/hierarchy2"/>
    <dgm:cxn modelId="{FAD12376-5B9D-4022-829E-3EA478D3EE9C}" type="presParOf" srcId="{92D0DEB7-F9E3-4085-A056-1B4AA5D907F0}" destId="{D5CD040A-B516-438A-972F-8ED8CDC5F1F6}" srcOrd="0" destOrd="0" presId="urn:microsoft.com/office/officeart/2005/8/layout/hierarchy2"/>
    <dgm:cxn modelId="{CA7374B0-9A8A-4A31-BB58-0DD5739F0544}" type="presParOf" srcId="{B02E7AF6-66DA-4252-B52D-833FA55306E0}" destId="{53EE630F-B50A-4E44-9F26-7A437E403F30}" srcOrd="15" destOrd="0" presId="urn:microsoft.com/office/officeart/2005/8/layout/hierarchy2"/>
    <dgm:cxn modelId="{22F128DB-E5C9-4D21-879B-55F651A934A6}" type="presParOf" srcId="{53EE630F-B50A-4E44-9F26-7A437E403F30}" destId="{0F72C090-6894-4EAC-91C9-4AB4F7819088}" srcOrd="0" destOrd="0" presId="urn:microsoft.com/office/officeart/2005/8/layout/hierarchy2"/>
    <dgm:cxn modelId="{CEB23374-DE9A-43BC-A02F-158C1DB6471E}" type="presParOf" srcId="{53EE630F-B50A-4E44-9F26-7A437E403F30}" destId="{29CFB243-3B0B-48A1-BA31-68AEECA8538E}" srcOrd="1" destOrd="0" presId="urn:microsoft.com/office/officeart/2005/8/layout/hierarchy2"/>
    <dgm:cxn modelId="{10BD7537-52C9-4CA1-BF29-988F1C9B39F5}" type="presParOf" srcId="{B02E7AF6-66DA-4252-B52D-833FA55306E0}" destId="{6AB18905-010D-4722-AD52-A8029684E429}" srcOrd="16" destOrd="0" presId="urn:microsoft.com/office/officeart/2005/8/layout/hierarchy2"/>
    <dgm:cxn modelId="{72B529EE-CDC1-492F-8213-479353F31DA3}" type="presParOf" srcId="{6AB18905-010D-4722-AD52-A8029684E429}" destId="{029D14F4-73D5-48A5-9409-1B7CD1A98ED4}" srcOrd="0" destOrd="0" presId="urn:microsoft.com/office/officeart/2005/8/layout/hierarchy2"/>
    <dgm:cxn modelId="{C9B34063-B3F9-49D4-8BFF-F23C444D7459}" type="presParOf" srcId="{B02E7AF6-66DA-4252-B52D-833FA55306E0}" destId="{7543E19F-1B2D-40F5-8A03-204EE3BF2B6C}" srcOrd="17" destOrd="0" presId="urn:microsoft.com/office/officeart/2005/8/layout/hierarchy2"/>
    <dgm:cxn modelId="{CFE3BECB-A03B-4E31-84C3-EAE33C659861}" type="presParOf" srcId="{7543E19F-1B2D-40F5-8A03-204EE3BF2B6C}" destId="{93ED179E-6CE9-427B-AFAE-295FB95A4083}" srcOrd="0" destOrd="0" presId="urn:microsoft.com/office/officeart/2005/8/layout/hierarchy2"/>
    <dgm:cxn modelId="{838EC3E9-0106-4363-8438-9C7B9C7C0AD0}" type="presParOf" srcId="{7543E19F-1B2D-40F5-8A03-204EE3BF2B6C}" destId="{2A0D38E4-EC3B-4BAE-ADB2-23C127B643DB}" srcOrd="1" destOrd="0" presId="urn:microsoft.com/office/officeart/2005/8/layout/hierarchy2"/>
    <dgm:cxn modelId="{AD788A59-BAE6-428F-80F6-989561482B4D}" type="presParOf" srcId="{B02E7AF6-66DA-4252-B52D-833FA55306E0}" destId="{B3990D9E-965A-4A87-9024-A31D8C18D9AC}" srcOrd="18" destOrd="0" presId="urn:microsoft.com/office/officeart/2005/8/layout/hierarchy2"/>
    <dgm:cxn modelId="{E8A0E7E5-061B-4943-A78A-0912FD54A97E}" type="presParOf" srcId="{B3990D9E-965A-4A87-9024-A31D8C18D9AC}" destId="{C4665A5D-7A69-4FC2-9029-35B5452AAAD6}" srcOrd="0" destOrd="0" presId="urn:microsoft.com/office/officeart/2005/8/layout/hierarchy2"/>
    <dgm:cxn modelId="{24671901-F289-40F2-ABA7-1BAFA3394C64}" type="presParOf" srcId="{B02E7AF6-66DA-4252-B52D-833FA55306E0}" destId="{F5AD516C-03B4-44A2-8D7F-A01D980EC8F6}" srcOrd="19" destOrd="0" presId="urn:microsoft.com/office/officeart/2005/8/layout/hierarchy2"/>
    <dgm:cxn modelId="{EB5EF4C8-62C1-4136-B192-3184991A66D3}" type="presParOf" srcId="{F5AD516C-03B4-44A2-8D7F-A01D980EC8F6}" destId="{55C48720-204C-4364-9D3A-54C5764186B5}" srcOrd="0" destOrd="0" presId="urn:microsoft.com/office/officeart/2005/8/layout/hierarchy2"/>
    <dgm:cxn modelId="{14D053FC-F1FE-4DE2-A768-89F7C363E9B5}" type="presParOf" srcId="{F5AD516C-03B4-44A2-8D7F-A01D980EC8F6}" destId="{6F03AD0E-EAEA-491F-81D8-AED0C9D56D57}" srcOrd="1" destOrd="0" presId="urn:microsoft.com/office/officeart/2005/8/layout/hierarchy2"/>
    <dgm:cxn modelId="{ABDC8553-9C20-4602-A9BE-42B364643DF3}" type="presParOf" srcId="{B02E7AF6-66DA-4252-B52D-833FA55306E0}" destId="{77548836-C3C7-4F26-AB2C-7B9D48F92339}" srcOrd="20" destOrd="0" presId="urn:microsoft.com/office/officeart/2005/8/layout/hierarchy2"/>
    <dgm:cxn modelId="{D6C81276-86AE-4498-A837-BC8D79BAE853}" type="presParOf" srcId="{77548836-C3C7-4F26-AB2C-7B9D48F92339}" destId="{D315BFC2-F4AA-453C-BEEE-7A8513151049}" srcOrd="0" destOrd="0" presId="urn:microsoft.com/office/officeart/2005/8/layout/hierarchy2"/>
    <dgm:cxn modelId="{BA094617-7CE0-42A0-A84D-93A8A2928B70}" type="presParOf" srcId="{B02E7AF6-66DA-4252-B52D-833FA55306E0}" destId="{5C1C1437-237B-4D2F-972C-182C150A65D7}" srcOrd="21" destOrd="0" presId="urn:microsoft.com/office/officeart/2005/8/layout/hierarchy2"/>
    <dgm:cxn modelId="{884917A3-F37A-4CC3-AB71-CFFE2B0D1467}" type="presParOf" srcId="{5C1C1437-237B-4D2F-972C-182C150A65D7}" destId="{58A40D43-4424-4837-A5A1-19217FD9A569}" srcOrd="0" destOrd="0" presId="urn:microsoft.com/office/officeart/2005/8/layout/hierarchy2"/>
    <dgm:cxn modelId="{5C7D234A-814E-489F-A57E-7901FF7EAC10}" type="presParOf" srcId="{5C1C1437-237B-4D2F-972C-182C150A65D7}" destId="{1CD09DDF-64D1-4B28-B2BA-D1CA4F7E8EBD}" srcOrd="1" destOrd="0" presId="urn:microsoft.com/office/officeart/2005/8/layout/hierarchy2"/>
    <dgm:cxn modelId="{A9222C2B-1AA4-4050-BD3E-CC99977117FE}" type="presParOf" srcId="{B02E7AF6-66DA-4252-B52D-833FA55306E0}" destId="{616D48F1-5BF9-475C-A680-5A4648439758}" srcOrd="22" destOrd="0" presId="urn:microsoft.com/office/officeart/2005/8/layout/hierarchy2"/>
    <dgm:cxn modelId="{90F993AF-CD71-4045-9E90-8F48FA74D707}" type="presParOf" srcId="{616D48F1-5BF9-475C-A680-5A4648439758}" destId="{6A5659FF-62AA-4A8C-B658-A072CD59A9AB}" srcOrd="0" destOrd="0" presId="urn:microsoft.com/office/officeart/2005/8/layout/hierarchy2"/>
    <dgm:cxn modelId="{96C0D876-3B7D-404F-AED2-D34160F45FCE}" type="presParOf" srcId="{B02E7AF6-66DA-4252-B52D-833FA55306E0}" destId="{B46B9E47-28AB-4556-93A1-61511E051437}" srcOrd="23" destOrd="0" presId="urn:microsoft.com/office/officeart/2005/8/layout/hierarchy2"/>
    <dgm:cxn modelId="{0A1A67A8-DFD1-42C1-84F8-2EB67948A9BF}" type="presParOf" srcId="{B46B9E47-28AB-4556-93A1-61511E051437}" destId="{AC865C7C-D34F-4978-B07D-384D670F1E47}" srcOrd="0" destOrd="0" presId="urn:microsoft.com/office/officeart/2005/8/layout/hierarchy2"/>
    <dgm:cxn modelId="{B3A9BF38-6B54-4429-88D5-901A38FEC00F}" type="presParOf" srcId="{B46B9E47-28AB-4556-93A1-61511E051437}" destId="{4636BF3F-FB11-41F8-AD53-27057F815E44}" srcOrd="1" destOrd="0" presId="urn:microsoft.com/office/officeart/2005/8/layout/hierarchy2"/>
    <dgm:cxn modelId="{F79E7A86-8BC7-45B2-BFEE-751EAF5606BC}" type="presParOf" srcId="{B02E7AF6-66DA-4252-B52D-833FA55306E0}" destId="{0534A5B7-9C7A-4B37-8658-B389BC363051}" srcOrd="24" destOrd="0" presId="urn:microsoft.com/office/officeart/2005/8/layout/hierarchy2"/>
    <dgm:cxn modelId="{898C2AC9-E8ED-4C2B-B278-B0000E1ADAD3}" type="presParOf" srcId="{0534A5B7-9C7A-4B37-8658-B389BC363051}" destId="{57096B24-8CD4-406B-927F-3FABEDAA0D69}" srcOrd="0" destOrd="0" presId="urn:microsoft.com/office/officeart/2005/8/layout/hierarchy2"/>
    <dgm:cxn modelId="{60995C5A-BC99-40E5-A7D9-F595FF8BB4A9}" type="presParOf" srcId="{B02E7AF6-66DA-4252-B52D-833FA55306E0}" destId="{1DE5FA74-54E7-473E-99BC-89B7AB6B71BE}" srcOrd="25" destOrd="0" presId="urn:microsoft.com/office/officeart/2005/8/layout/hierarchy2"/>
    <dgm:cxn modelId="{935857A9-CC06-4EDF-8B9A-27E825ADACBB}" type="presParOf" srcId="{1DE5FA74-54E7-473E-99BC-89B7AB6B71BE}" destId="{4B059EDE-FDEA-4C68-BB44-42AF88AE4840}" srcOrd="0" destOrd="0" presId="urn:microsoft.com/office/officeart/2005/8/layout/hierarchy2"/>
    <dgm:cxn modelId="{8CEA1123-2A14-4FCC-8A0B-024A4738C14B}" type="presParOf" srcId="{1DE5FA74-54E7-473E-99BC-89B7AB6B71BE}" destId="{C7AC535D-4EF6-4344-BDD7-25229982B388}" srcOrd="1" destOrd="0" presId="urn:microsoft.com/office/officeart/2005/8/layout/hierarchy2"/>
    <dgm:cxn modelId="{AB9E0AF3-DFE9-4B39-A18D-261CF6B7A02D}" type="presParOf" srcId="{457B3FD6-8EF7-4A94-BB29-C9471CDE92CD}" destId="{06162D70-667D-4321-A2A5-50E71EC54502}" srcOrd="8" destOrd="0" presId="urn:microsoft.com/office/officeart/2005/8/layout/hierarchy2"/>
    <dgm:cxn modelId="{AC829303-DF58-49D2-98C5-7B5CA7076D53}" type="presParOf" srcId="{06162D70-667D-4321-A2A5-50E71EC54502}" destId="{9EDF16DF-0468-41C5-93DA-122D14D8465F}" srcOrd="0" destOrd="0" presId="urn:microsoft.com/office/officeart/2005/8/layout/hierarchy2"/>
    <dgm:cxn modelId="{E807A686-C71B-4586-A6ED-BA7A485CE9D5}" type="presParOf" srcId="{457B3FD6-8EF7-4A94-BB29-C9471CDE92CD}" destId="{4E419202-E138-4240-93A2-456AC2B2742F}" srcOrd="9" destOrd="0" presId="urn:microsoft.com/office/officeart/2005/8/layout/hierarchy2"/>
    <dgm:cxn modelId="{FBB397FF-2942-43DF-B3A7-5887642406F7}" type="presParOf" srcId="{4E419202-E138-4240-93A2-456AC2B2742F}" destId="{DDF72957-287B-449A-A1C9-C4F10755C0F8}" srcOrd="0" destOrd="0" presId="urn:microsoft.com/office/officeart/2005/8/layout/hierarchy2"/>
    <dgm:cxn modelId="{D37C845E-1018-4FD3-96F1-5C1F87BA149E}" type="presParOf" srcId="{4E419202-E138-4240-93A2-456AC2B2742F}" destId="{05ECC4B5-9675-4F0D-8C38-19D9BB077CA3}" srcOrd="1" destOrd="0" presId="urn:microsoft.com/office/officeart/2005/8/layout/hierarchy2"/>
    <dgm:cxn modelId="{E5BCC4B5-ABAC-4C1F-9DEA-7B138BDA621D}" type="presParOf" srcId="{05ECC4B5-9675-4F0D-8C38-19D9BB077CA3}" destId="{39CD6B7A-D9CD-49C5-B1C3-2BF6CA65E035}" srcOrd="0" destOrd="0" presId="urn:microsoft.com/office/officeart/2005/8/layout/hierarchy2"/>
    <dgm:cxn modelId="{469FC08E-9BA2-403E-8013-9D2326BB79E4}" type="presParOf" srcId="{39CD6B7A-D9CD-49C5-B1C3-2BF6CA65E035}" destId="{B84FD6DC-6F83-483B-A6F6-D1143D7FCD3D}" srcOrd="0" destOrd="0" presId="urn:microsoft.com/office/officeart/2005/8/layout/hierarchy2"/>
    <dgm:cxn modelId="{A7D2200F-C79D-4453-AEDA-91A7EDF89196}" type="presParOf" srcId="{05ECC4B5-9675-4F0D-8C38-19D9BB077CA3}" destId="{40BB6ACB-057D-4260-AB2B-BDED580401D0}" srcOrd="1" destOrd="0" presId="urn:microsoft.com/office/officeart/2005/8/layout/hierarchy2"/>
    <dgm:cxn modelId="{9F4BB03C-5A14-44A8-B64D-62FBB746E717}" type="presParOf" srcId="{40BB6ACB-057D-4260-AB2B-BDED580401D0}" destId="{800253CE-BB59-4266-9CEA-CEBDA03E4027}" srcOrd="0" destOrd="0" presId="urn:microsoft.com/office/officeart/2005/8/layout/hierarchy2"/>
    <dgm:cxn modelId="{D2072DE8-3E3B-4E7A-964A-511E69A099C2}" type="presParOf" srcId="{40BB6ACB-057D-4260-AB2B-BDED580401D0}" destId="{F411FA26-74A1-460C-ABAE-D2DD5B610286}" srcOrd="1" destOrd="0" presId="urn:microsoft.com/office/officeart/2005/8/layout/hierarchy2"/>
    <dgm:cxn modelId="{3281458D-6639-4B14-B4B6-65464DB574DA}" type="presParOf" srcId="{05ECC4B5-9675-4F0D-8C38-19D9BB077CA3}" destId="{83DAAF3F-DBF1-49B0-8604-B525FB5C908A}" srcOrd="2" destOrd="0" presId="urn:microsoft.com/office/officeart/2005/8/layout/hierarchy2"/>
    <dgm:cxn modelId="{FC51DEA8-810F-4FC1-AA8F-728C381D3CB5}" type="presParOf" srcId="{83DAAF3F-DBF1-49B0-8604-B525FB5C908A}" destId="{3CA6E368-4B5A-4A8C-BA3F-B3AD90C9E9E9}" srcOrd="0" destOrd="0" presId="urn:microsoft.com/office/officeart/2005/8/layout/hierarchy2"/>
    <dgm:cxn modelId="{C161834E-700F-4C5C-A5DD-105164D97471}" type="presParOf" srcId="{05ECC4B5-9675-4F0D-8C38-19D9BB077CA3}" destId="{7C15682E-E524-46DA-82C6-F952A81CACA0}" srcOrd="3" destOrd="0" presId="urn:microsoft.com/office/officeart/2005/8/layout/hierarchy2"/>
    <dgm:cxn modelId="{FD0A6097-8661-438F-8D79-65725D30870D}" type="presParOf" srcId="{7C15682E-E524-46DA-82C6-F952A81CACA0}" destId="{914215F8-CB99-49A5-92BE-A5364C5EF1A5}" srcOrd="0" destOrd="0" presId="urn:microsoft.com/office/officeart/2005/8/layout/hierarchy2"/>
    <dgm:cxn modelId="{E089B151-0A1C-4ECB-BDC1-14816743F41B}" type="presParOf" srcId="{7C15682E-E524-46DA-82C6-F952A81CACA0}" destId="{F6AF657D-F445-4FBE-AA16-B88EE08E3861}" srcOrd="1" destOrd="0" presId="urn:microsoft.com/office/officeart/2005/8/layout/hierarchy2"/>
  </dgm:cxnLst>
  <dgm:bg/>
  <dgm:whole/>
  <dgm:extLst>
    <a:ext uri="http://schemas.microsoft.com/office/drawing/2008/diagram">
      <dsp:dataModelExt xmlns:dsp="http://schemas.microsoft.com/office/drawing/2008/diagram" relId="rId7" minVer="http://schemas.openxmlformats.org/drawingml/2006/diagram"/>
    </a:ext>
  </dgm:extLst>
</dgm:dataModel>
</file>

<file path=ppt/diagrams/drawing1.xml><?xml version="1.0" encoding="utf-8"?>
<dsp:drawing xmlns:dgm="http://schemas.openxmlformats.org/drawingml/2006/diagram" xmlns:dsp="http://schemas.microsoft.com/office/drawing/2008/diagram" xmlns:a="http://schemas.openxmlformats.org/drawingml/2006/main">
  <dsp:spTree>
    <dsp:nvGrpSpPr>
      <dsp:cNvPr id="0" name=""/>
      <dsp:cNvGrpSpPr/>
    </dsp:nvGrpSpPr>
    <dsp:grpSpPr/>
    <dsp:sp modelId="{F78A7B94-B816-41D1-873A-8D5A3EB8CC40}">
      <dsp:nvSpPr>
        <dsp:cNvPr id="0" name=""/>
        <dsp:cNvSpPr/>
      </dsp:nvSpPr>
      <dsp:spPr>
        <a:xfrm>
          <a:off x="90087" y="2767392"/>
          <a:ext cx="1184726" cy="874644"/>
        </a:xfrm>
        <a:prstGeom prst="roundRect">
          <a:avLst>
            <a:gd name="adj" fmla="val 10000"/>
          </a:avLst>
        </a:prstGeom>
        <a:solidFill>
          <a:schemeClr val="lt1"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dk1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7620" tIns="7620" rIns="7620" bIns="7620" numCol="1" spcCol="1270" anchor="ctr" anchorCtr="0">
          <a:noAutofit/>
        </a:bodyPr>
        <a:lstStyle/>
        <a:p>
          <a:pPr marL="0" lvl="0" indent="0" algn="ctr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de-DE" sz="1200" kern="1200" dirty="0">
              <a:latin typeface="Times New Roman" panose="02020603050405020304" pitchFamily="18" charset="0"/>
              <a:cs typeface="Times New Roman" panose="02020603050405020304" pitchFamily="18" charset="0"/>
            </a:rPr>
            <a:t>Conversations on public health issue – </a:t>
          </a:r>
          <a:r>
            <a:rPr lang="de-DE" sz="1200" i="1" kern="1200" dirty="0">
              <a:latin typeface="Times New Roman" panose="02020603050405020304" pitchFamily="18" charset="0"/>
              <a:cs typeface="Times New Roman" panose="02020603050405020304" pitchFamily="18" charset="0"/>
            </a:rPr>
            <a:t>health issue X</a:t>
          </a:r>
          <a:r>
            <a:rPr lang="de-DE" sz="1200" kern="1200" dirty="0">
              <a:latin typeface="Times New Roman" panose="02020603050405020304" pitchFamily="18" charset="0"/>
              <a:cs typeface="Times New Roman" panose="02020603050405020304" pitchFamily="18" charset="0"/>
            </a:rPr>
            <a:t> </a:t>
          </a:r>
        </a:p>
      </dsp:txBody>
      <dsp:txXfrm>
        <a:off x="115704" y="2793009"/>
        <a:ext cx="1133492" cy="823410"/>
      </dsp:txXfrm>
    </dsp:sp>
    <dsp:sp modelId="{2F7D4346-F118-454B-9AAD-5BD4A706F402}">
      <dsp:nvSpPr>
        <dsp:cNvPr id="0" name=""/>
        <dsp:cNvSpPr/>
      </dsp:nvSpPr>
      <dsp:spPr>
        <a:xfrm rot="16869295">
          <a:off x="174792" y="1865477"/>
          <a:ext cx="2727761" cy="2246"/>
        </a:xfrm>
        <a:custGeom>
          <a:avLst/>
          <a:gdLst/>
          <a:ahLst/>
          <a:cxnLst/>
          <a:rect l="0" t="0" r="0" b="0"/>
          <a:pathLst>
            <a:path>
              <a:moveTo>
                <a:pt x="0" y="1123"/>
              </a:moveTo>
              <a:lnTo>
                <a:pt x="2727761" y="1123"/>
              </a:lnTo>
            </a:path>
          </a:pathLst>
        </a:custGeom>
        <a:noFill/>
        <a:ln w="12700" cap="flat" cmpd="sng" algn="ctr">
          <a:solidFill>
            <a:schemeClr val="dk1">
              <a:shade val="6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2700" tIns="0" rIns="12700" bIns="0" numCol="1" spcCol="1270" anchor="ctr" anchorCtr="0">
          <a:noAutofit/>
        </a:bodyPr>
        <a:lstStyle/>
        <a:p>
          <a:pPr marL="0" lvl="0" indent="0" algn="ctr" defTabSz="4889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endParaRPr lang="de-DE" sz="1100" kern="1200">
            <a:latin typeface="Times New Roman" panose="02020603050405020304" pitchFamily="18" charset="0"/>
            <a:cs typeface="Times New Roman" panose="02020603050405020304" pitchFamily="18" charset="0"/>
          </a:endParaRPr>
        </a:p>
      </dsp:txBody>
      <dsp:txXfrm>
        <a:off x="-4342879" y="1798406"/>
        <a:ext cx="11763107" cy="136388"/>
      </dsp:txXfrm>
    </dsp:sp>
    <dsp:sp modelId="{430F15C4-6A15-46B0-808C-1CBD7A4F9165}">
      <dsp:nvSpPr>
        <dsp:cNvPr id="0" name=""/>
        <dsp:cNvSpPr/>
      </dsp:nvSpPr>
      <dsp:spPr>
        <a:xfrm>
          <a:off x="1802533" y="427835"/>
          <a:ext cx="1736719" cy="201301"/>
        </a:xfrm>
        <a:prstGeom prst="roundRect">
          <a:avLst>
            <a:gd name="adj" fmla="val 10000"/>
          </a:avLst>
        </a:prstGeom>
        <a:solidFill>
          <a:schemeClr val="lt1"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dk1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7620" tIns="7620" rIns="7620" bIns="7620" numCol="1" spcCol="1270" anchor="ctr" anchorCtr="0">
          <a:noAutofit/>
        </a:bodyPr>
        <a:lstStyle/>
        <a:p>
          <a:pPr marL="0" lvl="0" indent="0" algn="ctr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de-DE" sz="1200" kern="1200" dirty="0">
              <a:latin typeface="Times New Roman" panose="02020603050405020304" pitchFamily="18" charset="0"/>
              <a:cs typeface="Times New Roman" panose="02020603050405020304" pitchFamily="18" charset="0"/>
            </a:rPr>
            <a:t>The </a:t>
          </a:r>
          <a:r>
            <a:rPr lang="de-DE" sz="1200" kern="1200" dirty="0" err="1">
              <a:latin typeface="Times New Roman" panose="02020603050405020304" pitchFamily="18" charset="0"/>
              <a:cs typeface="Times New Roman" panose="02020603050405020304" pitchFamily="18" charset="0"/>
            </a:rPr>
            <a:t>Cause</a:t>
          </a:r>
          <a:endParaRPr lang="de-DE" sz="1200" kern="1200" dirty="0">
            <a:latin typeface="Times New Roman" panose="02020603050405020304" pitchFamily="18" charset="0"/>
            <a:cs typeface="Times New Roman" panose="02020603050405020304" pitchFamily="18" charset="0"/>
          </a:endParaRPr>
        </a:p>
      </dsp:txBody>
      <dsp:txXfrm>
        <a:off x="1808429" y="433731"/>
        <a:ext cx="1724927" cy="189509"/>
      </dsp:txXfrm>
    </dsp:sp>
    <dsp:sp modelId="{4838F315-A0EB-4974-8233-371CFFCC1CE4}">
      <dsp:nvSpPr>
        <dsp:cNvPr id="0" name=""/>
        <dsp:cNvSpPr/>
      </dsp:nvSpPr>
      <dsp:spPr>
        <a:xfrm rot="20358855">
          <a:off x="3517764" y="409617"/>
          <a:ext cx="666657" cy="2246"/>
        </a:xfrm>
        <a:custGeom>
          <a:avLst/>
          <a:gdLst/>
          <a:ahLst/>
          <a:cxnLst/>
          <a:rect l="0" t="0" r="0" b="0"/>
          <a:pathLst>
            <a:path>
              <a:moveTo>
                <a:pt x="0" y="1123"/>
              </a:moveTo>
              <a:lnTo>
                <a:pt x="666657" y="1123"/>
              </a:lnTo>
            </a:path>
          </a:pathLst>
        </a:custGeom>
        <a:noFill/>
        <a:ln w="12700" cap="flat" cmpd="sng" algn="ctr">
          <a:solidFill>
            <a:schemeClr val="dk1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2700" tIns="0" rIns="12700" bIns="0" numCol="1" spcCol="1270" anchor="ctr" anchorCtr="0">
          <a:noAutofit/>
        </a:bodyPr>
        <a:lstStyle/>
        <a:p>
          <a:pPr marL="0" lvl="0" indent="0" algn="ctr" defTabSz="4889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endParaRPr lang="de-DE" sz="1100" kern="1200">
            <a:latin typeface="Times New Roman" panose="02020603050405020304" pitchFamily="18" charset="0"/>
            <a:cs typeface="Times New Roman" panose="02020603050405020304" pitchFamily="18" charset="0"/>
          </a:endParaRPr>
        </a:p>
      </dsp:txBody>
      <dsp:txXfrm>
        <a:off x="-2030460" y="394074"/>
        <a:ext cx="11763107" cy="33332"/>
      </dsp:txXfrm>
    </dsp:sp>
    <dsp:sp modelId="{0B80F301-D09A-4FB6-916E-CECF32B2F143}">
      <dsp:nvSpPr>
        <dsp:cNvPr id="0" name=""/>
        <dsp:cNvSpPr/>
      </dsp:nvSpPr>
      <dsp:spPr>
        <a:xfrm>
          <a:off x="4162932" y="192344"/>
          <a:ext cx="1845265" cy="201301"/>
        </a:xfrm>
        <a:prstGeom prst="roundRect">
          <a:avLst>
            <a:gd name="adj" fmla="val 10000"/>
          </a:avLst>
        </a:prstGeom>
        <a:solidFill>
          <a:schemeClr val="lt1"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dk1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7620" tIns="7620" rIns="7620" bIns="7620" numCol="1" spcCol="1270" anchor="ctr" anchorCtr="0">
          <a:noAutofit/>
        </a:bodyPr>
        <a:lstStyle/>
        <a:p>
          <a:pPr marL="0" lvl="0" indent="0" algn="ctr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de-DE" sz="1200" kern="1200" dirty="0">
              <a:latin typeface="Times New Roman" panose="02020603050405020304" pitchFamily="18" charset="0"/>
              <a:cs typeface="Times New Roman" panose="02020603050405020304" pitchFamily="18" charset="0"/>
            </a:rPr>
            <a:t>The </a:t>
          </a:r>
          <a:r>
            <a:rPr lang="de-DE" sz="1200" kern="1200" dirty="0" err="1">
              <a:latin typeface="Times New Roman" panose="02020603050405020304" pitchFamily="18" charset="0"/>
              <a:cs typeface="Times New Roman" panose="02020603050405020304" pitchFamily="18" charset="0"/>
            </a:rPr>
            <a:t>cause</a:t>
          </a:r>
          <a:r>
            <a:rPr lang="de-DE" sz="1200" kern="1200" dirty="0">
              <a:latin typeface="Times New Roman" panose="02020603050405020304" pitchFamily="18" charset="0"/>
              <a:cs typeface="Times New Roman" panose="02020603050405020304" pitchFamily="18" charset="0"/>
            </a:rPr>
            <a:t> of the </a:t>
          </a:r>
          <a:r>
            <a:rPr lang="de-DE" sz="1200" kern="1200" dirty="0" err="1">
              <a:latin typeface="Times New Roman" panose="02020603050405020304" pitchFamily="18" charset="0"/>
              <a:cs typeface="Times New Roman" panose="02020603050405020304" pitchFamily="18" charset="0"/>
            </a:rPr>
            <a:t>virus</a:t>
          </a:r>
          <a:endParaRPr lang="de-DE" sz="1200" kern="1200" dirty="0">
            <a:latin typeface="Times New Roman" panose="02020603050405020304" pitchFamily="18" charset="0"/>
            <a:cs typeface="Times New Roman" panose="02020603050405020304" pitchFamily="18" charset="0"/>
          </a:endParaRPr>
        </a:p>
      </dsp:txBody>
      <dsp:txXfrm>
        <a:off x="4168828" y="198240"/>
        <a:ext cx="1833473" cy="189509"/>
      </dsp:txXfrm>
    </dsp:sp>
    <dsp:sp modelId="{750F2EA3-C6A2-49D8-A4E9-ECB36FFC366E}">
      <dsp:nvSpPr>
        <dsp:cNvPr id="0" name=""/>
        <dsp:cNvSpPr/>
      </dsp:nvSpPr>
      <dsp:spPr>
        <a:xfrm rot="21553588">
          <a:off x="3539225" y="523168"/>
          <a:ext cx="621489" cy="2246"/>
        </a:xfrm>
        <a:custGeom>
          <a:avLst/>
          <a:gdLst/>
          <a:ahLst/>
          <a:cxnLst/>
          <a:rect l="0" t="0" r="0" b="0"/>
          <a:pathLst>
            <a:path>
              <a:moveTo>
                <a:pt x="0" y="1123"/>
              </a:moveTo>
              <a:lnTo>
                <a:pt x="621489" y="1123"/>
              </a:lnTo>
            </a:path>
          </a:pathLst>
        </a:custGeom>
        <a:noFill/>
        <a:ln w="12700" cap="flat" cmpd="sng" algn="ctr">
          <a:solidFill>
            <a:schemeClr val="dk1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2700" tIns="0" rIns="12700" bIns="0" numCol="1" spcCol="1270" anchor="ctr" anchorCtr="0">
          <a:noAutofit/>
        </a:bodyPr>
        <a:lstStyle/>
        <a:p>
          <a:pPr marL="0" lvl="0" indent="0" algn="ctr" defTabSz="4889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endParaRPr lang="de-DE" sz="1100" kern="1200">
            <a:latin typeface="Times New Roman" panose="02020603050405020304" pitchFamily="18" charset="0"/>
            <a:cs typeface="Times New Roman" panose="02020603050405020304" pitchFamily="18" charset="0"/>
          </a:endParaRPr>
        </a:p>
      </dsp:txBody>
      <dsp:txXfrm>
        <a:off x="-2031583" y="508754"/>
        <a:ext cx="11763107" cy="31074"/>
      </dsp:txXfrm>
    </dsp:sp>
    <dsp:sp modelId="{70A6C9AF-4497-49E2-8F6B-4022C002A32C}">
      <dsp:nvSpPr>
        <dsp:cNvPr id="0" name=""/>
        <dsp:cNvSpPr/>
      </dsp:nvSpPr>
      <dsp:spPr>
        <a:xfrm>
          <a:off x="4160686" y="419445"/>
          <a:ext cx="1845265" cy="201301"/>
        </a:xfrm>
        <a:prstGeom prst="roundRect">
          <a:avLst>
            <a:gd name="adj" fmla="val 10000"/>
          </a:avLst>
        </a:prstGeom>
        <a:solidFill>
          <a:schemeClr val="lt1"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dk1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7620" tIns="7620" rIns="7620" bIns="7620" numCol="1" spcCol="1270" anchor="ctr" anchorCtr="0">
          <a:noAutofit/>
        </a:bodyPr>
        <a:lstStyle/>
        <a:p>
          <a:pPr marL="0" lvl="0" indent="0" algn="ctr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de-DE" sz="1200" kern="1200">
              <a:latin typeface="Times New Roman" panose="02020603050405020304" pitchFamily="18" charset="0"/>
              <a:cs typeface="Times New Roman" panose="02020603050405020304" pitchFamily="18" charset="0"/>
            </a:rPr>
            <a:t>Stigma</a:t>
          </a:r>
        </a:p>
      </dsp:txBody>
      <dsp:txXfrm>
        <a:off x="4166582" y="425341"/>
        <a:ext cx="1833473" cy="189509"/>
      </dsp:txXfrm>
    </dsp:sp>
    <dsp:sp modelId="{B99573E9-A46B-4C67-A741-44E4FCB4FC8A}">
      <dsp:nvSpPr>
        <dsp:cNvPr id="0" name=""/>
        <dsp:cNvSpPr/>
      </dsp:nvSpPr>
      <dsp:spPr>
        <a:xfrm rot="1186513">
          <a:off x="3519513" y="640614"/>
          <a:ext cx="669469" cy="2246"/>
        </a:xfrm>
        <a:custGeom>
          <a:avLst/>
          <a:gdLst/>
          <a:ahLst/>
          <a:cxnLst/>
          <a:rect l="0" t="0" r="0" b="0"/>
          <a:pathLst>
            <a:path>
              <a:moveTo>
                <a:pt x="0" y="1123"/>
              </a:moveTo>
              <a:lnTo>
                <a:pt x="669469" y="1123"/>
              </a:lnTo>
            </a:path>
          </a:pathLst>
        </a:custGeom>
        <a:noFill/>
        <a:ln w="12700" cap="flat" cmpd="sng" algn="ctr">
          <a:solidFill>
            <a:schemeClr val="dk1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2700" tIns="0" rIns="12700" bIns="0" numCol="1" spcCol="1270" anchor="ctr" anchorCtr="0">
          <a:noAutofit/>
        </a:bodyPr>
        <a:lstStyle/>
        <a:p>
          <a:pPr marL="0" lvl="0" indent="0" algn="ctr" defTabSz="4889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endParaRPr lang="de-DE" sz="1100" kern="1200">
            <a:latin typeface="Times New Roman" panose="02020603050405020304" pitchFamily="18" charset="0"/>
            <a:cs typeface="Times New Roman" panose="02020603050405020304" pitchFamily="18" charset="0"/>
          </a:endParaRPr>
        </a:p>
      </dsp:txBody>
      <dsp:txXfrm>
        <a:off x="-2027305" y="625000"/>
        <a:ext cx="11763107" cy="33473"/>
      </dsp:txXfrm>
    </dsp:sp>
    <dsp:sp modelId="{049F2968-73E2-4348-A8D7-E885F2B2F00E}">
      <dsp:nvSpPr>
        <dsp:cNvPr id="0" name=""/>
        <dsp:cNvSpPr/>
      </dsp:nvSpPr>
      <dsp:spPr>
        <a:xfrm rot="10800000" flipV="1">
          <a:off x="4169242" y="654337"/>
          <a:ext cx="1845265" cy="201301"/>
        </a:xfrm>
        <a:prstGeom prst="roundRect">
          <a:avLst>
            <a:gd name="adj" fmla="val 10000"/>
          </a:avLst>
        </a:prstGeom>
        <a:solidFill>
          <a:schemeClr val="lt1"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dk1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7620" tIns="7620" rIns="7620" bIns="7620" numCol="1" spcCol="1270" anchor="ctr" anchorCtr="0">
          <a:noAutofit/>
        </a:bodyPr>
        <a:lstStyle/>
        <a:p>
          <a:pPr marL="0" lvl="0" indent="0" algn="ctr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de-DE" sz="1200" kern="1200">
              <a:latin typeface="Times New Roman" panose="02020603050405020304" pitchFamily="18" charset="0"/>
              <a:cs typeface="Times New Roman" panose="02020603050405020304" pitchFamily="18" charset="0"/>
            </a:rPr>
            <a:t>Spread and </a:t>
          </a:r>
          <a:r>
            <a:rPr lang="de-DE" sz="1200" kern="1200" err="1">
              <a:latin typeface="Times New Roman" panose="02020603050405020304" pitchFamily="18" charset="0"/>
              <a:cs typeface="Times New Roman" panose="02020603050405020304" pitchFamily="18" charset="0"/>
            </a:rPr>
            <a:t>immunity</a:t>
          </a:r>
          <a:endParaRPr lang="de-DE" sz="1200" kern="1200">
            <a:latin typeface="Times New Roman" panose="02020603050405020304" pitchFamily="18" charset="0"/>
            <a:cs typeface="Times New Roman" panose="02020603050405020304" pitchFamily="18" charset="0"/>
          </a:endParaRPr>
        </a:p>
      </dsp:txBody>
      <dsp:txXfrm rot="-10800000">
        <a:off x="4175138" y="660233"/>
        <a:ext cx="1833473" cy="189509"/>
      </dsp:txXfrm>
    </dsp:sp>
    <dsp:sp modelId="{6C074D18-1EA0-40FB-94A6-DD4C52B7D46C}">
      <dsp:nvSpPr>
        <dsp:cNvPr id="0" name=""/>
        <dsp:cNvSpPr/>
      </dsp:nvSpPr>
      <dsp:spPr>
        <a:xfrm rot="17260861">
          <a:off x="669446" y="2375232"/>
          <a:ext cx="1738856" cy="2246"/>
        </a:xfrm>
        <a:custGeom>
          <a:avLst/>
          <a:gdLst/>
          <a:ahLst/>
          <a:cxnLst/>
          <a:rect l="0" t="0" r="0" b="0"/>
          <a:pathLst>
            <a:path>
              <a:moveTo>
                <a:pt x="0" y="1123"/>
              </a:moveTo>
              <a:lnTo>
                <a:pt x="1738856" y="1123"/>
              </a:lnTo>
            </a:path>
          </a:pathLst>
        </a:custGeom>
        <a:noFill/>
        <a:ln w="12700" cap="flat" cmpd="sng" algn="ctr">
          <a:solidFill>
            <a:schemeClr val="dk1">
              <a:shade val="6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2700" tIns="0" rIns="12700" bIns="0" numCol="1" spcCol="1270" anchor="ctr" anchorCtr="0">
          <a:noAutofit/>
        </a:bodyPr>
        <a:lstStyle/>
        <a:p>
          <a:pPr marL="0" lvl="0" indent="0" algn="ctr" defTabSz="4889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endParaRPr lang="de-DE" sz="1100" kern="1200">
            <a:latin typeface="Times New Roman" panose="02020603050405020304" pitchFamily="18" charset="0"/>
            <a:cs typeface="Times New Roman" panose="02020603050405020304" pitchFamily="18" charset="0"/>
          </a:endParaRPr>
        </a:p>
      </dsp:txBody>
      <dsp:txXfrm>
        <a:off x="-4342678" y="2332884"/>
        <a:ext cx="11763107" cy="86942"/>
      </dsp:txXfrm>
    </dsp:sp>
    <dsp:sp modelId="{3B5C04C0-1026-4BCC-B8D1-09CC708E27EF}">
      <dsp:nvSpPr>
        <dsp:cNvPr id="0" name=""/>
        <dsp:cNvSpPr/>
      </dsp:nvSpPr>
      <dsp:spPr>
        <a:xfrm>
          <a:off x="1802935" y="1447346"/>
          <a:ext cx="1736719" cy="201301"/>
        </a:xfrm>
        <a:prstGeom prst="roundRect">
          <a:avLst>
            <a:gd name="adj" fmla="val 10000"/>
          </a:avLst>
        </a:prstGeom>
        <a:solidFill>
          <a:schemeClr val="lt1"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dk1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7620" tIns="7620" rIns="7620" bIns="7620" numCol="1" spcCol="1270" anchor="ctr" anchorCtr="0">
          <a:noAutofit/>
        </a:bodyPr>
        <a:lstStyle/>
        <a:p>
          <a:pPr marL="0" lvl="0" indent="0" algn="ctr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de-DE" sz="1200" kern="1200" dirty="0">
              <a:latin typeface="Times New Roman" panose="02020603050405020304" pitchFamily="18" charset="0"/>
              <a:cs typeface="Times New Roman" panose="02020603050405020304" pitchFamily="18" charset="0"/>
            </a:rPr>
            <a:t>The </a:t>
          </a:r>
          <a:r>
            <a:rPr lang="de-DE" sz="1200" kern="1200" dirty="0" err="1">
              <a:latin typeface="Times New Roman" panose="02020603050405020304" pitchFamily="18" charset="0"/>
              <a:cs typeface="Times New Roman" panose="02020603050405020304" pitchFamily="18" charset="0"/>
            </a:rPr>
            <a:t>Illness</a:t>
          </a:r>
          <a:endParaRPr lang="de-DE" sz="1200" kern="1200" dirty="0">
            <a:latin typeface="Times New Roman" panose="02020603050405020304" pitchFamily="18" charset="0"/>
            <a:cs typeface="Times New Roman" panose="02020603050405020304" pitchFamily="18" charset="0"/>
          </a:endParaRPr>
        </a:p>
      </dsp:txBody>
      <dsp:txXfrm>
        <a:off x="1808831" y="1453242"/>
        <a:ext cx="1724927" cy="189509"/>
      </dsp:txXfrm>
    </dsp:sp>
    <dsp:sp modelId="{1933032C-D9EF-4E95-9447-72395E90BD3C}">
      <dsp:nvSpPr>
        <dsp:cNvPr id="0" name=""/>
        <dsp:cNvSpPr/>
      </dsp:nvSpPr>
      <dsp:spPr>
        <a:xfrm rot="20946397">
          <a:off x="3513647" y="1274118"/>
          <a:ext cx="2886579" cy="2246"/>
        </a:xfrm>
        <a:custGeom>
          <a:avLst/>
          <a:gdLst/>
          <a:ahLst/>
          <a:cxnLst/>
          <a:rect l="0" t="0" r="0" b="0"/>
          <a:pathLst>
            <a:path>
              <a:moveTo>
                <a:pt x="0" y="1123"/>
              </a:moveTo>
              <a:lnTo>
                <a:pt x="2886579" y="1123"/>
              </a:lnTo>
            </a:path>
          </a:pathLst>
        </a:custGeom>
        <a:noFill/>
        <a:ln w="12700" cap="flat" cmpd="sng" algn="ctr">
          <a:solidFill>
            <a:schemeClr val="dk1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2700" tIns="0" rIns="12700" bIns="0" numCol="1" spcCol="1270" anchor="ctr" anchorCtr="0">
          <a:noAutofit/>
        </a:bodyPr>
        <a:lstStyle/>
        <a:p>
          <a:pPr marL="0" lvl="0" indent="0" algn="ctr" defTabSz="4889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endParaRPr lang="de-DE" sz="1100" kern="1200">
            <a:latin typeface="Times New Roman" panose="02020603050405020304" pitchFamily="18" charset="0"/>
            <a:cs typeface="Times New Roman" panose="02020603050405020304" pitchFamily="18" charset="0"/>
          </a:endParaRPr>
        </a:p>
      </dsp:txBody>
      <dsp:txXfrm>
        <a:off x="-924616" y="1203077"/>
        <a:ext cx="11763107" cy="144328"/>
      </dsp:txXfrm>
    </dsp:sp>
    <dsp:sp modelId="{85D196B6-063E-44EA-88B6-502D03441A95}">
      <dsp:nvSpPr>
        <dsp:cNvPr id="0" name=""/>
        <dsp:cNvSpPr/>
      </dsp:nvSpPr>
      <dsp:spPr>
        <a:xfrm>
          <a:off x="6374219" y="901834"/>
          <a:ext cx="1845265" cy="201301"/>
        </a:xfrm>
        <a:prstGeom prst="roundRect">
          <a:avLst>
            <a:gd name="adj" fmla="val 10000"/>
          </a:avLst>
        </a:prstGeom>
        <a:solidFill>
          <a:schemeClr val="lt1"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dk1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7620" tIns="7620" rIns="7620" bIns="7620" numCol="1" spcCol="1270" anchor="ctr" anchorCtr="0">
          <a:noAutofit/>
        </a:bodyPr>
        <a:lstStyle/>
        <a:p>
          <a:pPr marL="0" lvl="0" indent="0" algn="ctr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de-DE" sz="1200" kern="1200">
              <a:latin typeface="Times New Roman" panose="02020603050405020304" pitchFamily="18" charset="0"/>
              <a:cs typeface="Times New Roman" panose="02020603050405020304" pitchFamily="18" charset="0"/>
            </a:rPr>
            <a:t>Symptoms</a:t>
          </a:r>
        </a:p>
      </dsp:txBody>
      <dsp:txXfrm>
        <a:off x="6380115" y="907730"/>
        <a:ext cx="1833473" cy="189509"/>
      </dsp:txXfrm>
    </dsp:sp>
    <dsp:sp modelId="{39A8889A-DFEF-4793-B12D-3BA4A3083E3E}">
      <dsp:nvSpPr>
        <dsp:cNvPr id="0" name=""/>
        <dsp:cNvSpPr/>
      </dsp:nvSpPr>
      <dsp:spPr>
        <a:xfrm rot="21247448">
          <a:off x="8216197" y="937311"/>
          <a:ext cx="1251315" cy="2246"/>
        </a:xfrm>
        <a:custGeom>
          <a:avLst/>
          <a:gdLst/>
          <a:ahLst/>
          <a:cxnLst/>
          <a:rect l="0" t="0" r="0" b="0"/>
          <a:pathLst>
            <a:path>
              <a:moveTo>
                <a:pt x="0" y="1123"/>
              </a:moveTo>
              <a:lnTo>
                <a:pt x="1251315" y="1123"/>
              </a:lnTo>
            </a:path>
          </a:pathLst>
        </a:custGeom>
        <a:noFill/>
        <a:ln w="12700" cap="flat" cmpd="sng" algn="ctr">
          <a:solidFill>
            <a:schemeClr val="dk1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2700" tIns="0" rIns="12700" bIns="0" numCol="1" spcCol="1270" anchor="ctr" anchorCtr="0">
          <a:noAutofit/>
        </a:bodyPr>
        <a:lstStyle/>
        <a:p>
          <a:pPr marL="0" lvl="0" indent="0" algn="ctr" defTabSz="4889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endParaRPr lang="de-DE" sz="1100" kern="1200">
            <a:latin typeface="Times New Roman" panose="02020603050405020304" pitchFamily="18" charset="0"/>
            <a:cs typeface="Times New Roman" panose="02020603050405020304" pitchFamily="18" charset="0"/>
          </a:endParaRPr>
        </a:p>
      </dsp:txBody>
      <dsp:txXfrm>
        <a:off x="2960301" y="907152"/>
        <a:ext cx="11763107" cy="62565"/>
      </dsp:txXfrm>
    </dsp:sp>
    <dsp:sp modelId="{29B3ABBF-0291-41BA-9070-E0CB070E1723}">
      <dsp:nvSpPr>
        <dsp:cNvPr id="0" name=""/>
        <dsp:cNvSpPr/>
      </dsp:nvSpPr>
      <dsp:spPr>
        <a:xfrm>
          <a:off x="9464225" y="778816"/>
          <a:ext cx="1979999" cy="191134"/>
        </a:xfrm>
        <a:prstGeom prst="roundRect">
          <a:avLst>
            <a:gd name="adj" fmla="val 10000"/>
          </a:avLst>
        </a:prstGeom>
        <a:solidFill>
          <a:schemeClr val="lt1"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dk1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7620" tIns="7620" rIns="7620" bIns="7620" numCol="1" spcCol="1270" anchor="ctr" anchorCtr="0">
          <a:noAutofit/>
        </a:bodyPr>
        <a:lstStyle/>
        <a:p>
          <a:pPr marL="0" lvl="0" indent="0" algn="ctr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de-DE" sz="1200" kern="1200" err="1">
              <a:latin typeface="Times New Roman" panose="02020603050405020304" pitchFamily="18" charset="0"/>
              <a:cs typeface="Times New Roman" panose="02020603050405020304" pitchFamily="18" charset="0"/>
            </a:rPr>
            <a:t>Confirmed</a:t>
          </a:r>
          <a:endParaRPr lang="de-DE" sz="1200" kern="1200">
            <a:latin typeface="Times New Roman" panose="02020603050405020304" pitchFamily="18" charset="0"/>
            <a:cs typeface="Times New Roman" panose="02020603050405020304" pitchFamily="18" charset="0"/>
          </a:endParaRPr>
        </a:p>
      </dsp:txBody>
      <dsp:txXfrm>
        <a:off x="9469823" y="784414"/>
        <a:ext cx="1968803" cy="179938"/>
      </dsp:txXfrm>
    </dsp:sp>
    <dsp:sp modelId="{16EDC4EB-15B1-4BED-A913-C4910A592E43}">
      <dsp:nvSpPr>
        <dsp:cNvPr id="0" name=""/>
        <dsp:cNvSpPr/>
      </dsp:nvSpPr>
      <dsp:spPr>
        <a:xfrm rot="301941">
          <a:off x="8217093" y="1055797"/>
          <a:ext cx="1241135" cy="2246"/>
        </a:xfrm>
        <a:custGeom>
          <a:avLst/>
          <a:gdLst/>
          <a:ahLst/>
          <a:cxnLst/>
          <a:rect l="0" t="0" r="0" b="0"/>
          <a:pathLst>
            <a:path>
              <a:moveTo>
                <a:pt x="0" y="1123"/>
              </a:moveTo>
              <a:lnTo>
                <a:pt x="1241135" y="1123"/>
              </a:lnTo>
            </a:path>
          </a:pathLst>
        </a:custGeom>
        <a:noFill/>
        <a:ln w="12700" cap="flat" cmpd="sng" algn="ctr">
          <a:solidFill>
            <a:schemeClr val="dk1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2700" tIns="0" rIns="12700" bIns="0" numCol="1" spcCol="1270" anchor="ctr" anchorCtr="0">
          <a:noAutofit/>
        </a:bodyPr>
        <a:lstStyle/>
        <a:p>
          <a:pPr marL="0" lvl="0" indent="0" algn="ctr" defTabSz="4889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endParaRPr lang="de-DE" sz="1100" kern="1200">
            <a:latin typeface="Times New Roman" panose="02020603050405020304" pitchFamily="18" charset="0"/>
            <a:cs typeface="Times New Roman" panose="02020603050405020304" pitchFamily="18" charset="0"/>
          </a:endParaRPr>
        </a:p>
      </dsp:txBody>
      <dsp:txXfrm>
        <a:off x="2956107" y="1025892"/>
        <a:ext cx="11763107" cy="62056"/>
      </dsp:txXfrm>
    </dsp:sp>
    <dsp:sp modelId="{3D93AA13-F9BF-4516-9343-01C4FE687B9F}">
      <dsp:nvSpPr>
        <dsp:cNvPr id="0" name=""/>
        <dsp:cNvSpPr/>
      </dsp:nvSpPr>
      <dsp:spPr>
        <a:xfrm>
          <a:off x="9455836" y="1015788"/>
          <a:ext cx="1979999" cy="191135"/>
        </a:xfrm>
        <a:prstGeom prst="roundRect">
          <a:avLst>
            <a:gd name="adj" fmla="val 10000"/>
          </a:avLst>
        </a:prstGeom>
        <a:solidFill>
          <a:schemeClr val="lt1"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dk1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7620" tIns="7620" rIns="7620" bIns="7620" numCol="1" spcCol="1270" anchor="ctr" anchorCtr="0">
          <a:noAutofit/>
        </a:bodyPr>
        <a:lstStyle/>
        <a:p>
          <a:pPr marL="0" lvl="0" indent="0" algn="ctr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de-DE" sz="1200" kern="1200">
              <a:latin typeface="Times New Roman" panose="02020603050405020304" pitchFamily="18" charset="0"/>
              <a:cs typeface="Times New Roman" panose="02020603050405020304" pitchFamily="18" charset="0"/>
            </a:rPr>
            <a:t>Other</a:t>
          </a:r>
        </a:p>
      </dsp:txBody>
      <dsp:txXfrm>
        <a:off x="9461434" y="1021386"/>
        <a:ext cx="1968803" cy="179939"/>
      </dsp:txXfrm>
    </dsp:sp>
    <dsp:sp modelId="{BE69F2C5-1F16-4884-B39F-EE6B06025848}">
      <dsp:nvSpPr>
        <dsp:cNvPr id="0" name=""/>
        <dsp:cNvSpPr/>
      </dsp:nvSpPr>
      <dsp:spPr>
        <a:xfrm rot="21211666">
          <a:off x="3530545" y="1385761"/>
          <a:ext cx="2858592" cy="2246"/>
        </a:xfrm>
        <a:custGeom>
          <a:avLst/>
          <a:gdLst/>
          <a:ahLst/>
          <a:cxnLst/>
          <a:rect l="0" t="0" r="0" b="0"/>
          <a:pathLst>
            <a:path>
              <a:moveTo>
                <a:pt x="0" y="1123"/>
              </a:moveTo>
              <a:lnTo>
                <a:pt x="2858592" y="1123"/>
              </a:lnTo>
            </a:path>
          </a:pathLst>
        </a:custGeom>
        <a:noFill/>
        <a:ln w="12700" cap="flat" cmpd="sng" algn="ctr">
          <a:solidFill>
            <a:schemeClr val="dk1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2700" tIns="0" rIns="12700" bIns="0" numCol="1" spcCol="1270" anchor="ctr" anchorCtr="0">
          <a:noAutofit/>
        </a:bodyPr>
        <a:lstStyle/>
        <a:p>
          <a:pPr marL="0" lvl="0" indent="0" algn="ctr" defTabSz="4889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endParaRPr lang="de-DE" sz="1100" kern="1200">
            <a:latin typeface="Times New Roman" panose="02020603050405020304" pitchFamily="18" charset="0"/>
            <a:cs typeface="Times New Roman" panose="02020603050405020304" pitchFamily="18" charset="0"/>
          </a:endParaRPr>
        </a:p>
      </dsp:txBody>
      <dsp:txXfrm>
        <a:off x="-921711" y="1315419"/>
        <a:ext cx="11763107" cy="142929"/>
      </dsp:txXfrm>
    </dsp:sp>
    <dsp:sp modelId="{C631F0D8-FAAD-405A-A21C-737F0EB151CA}">
      <dsp:nvSpPr>
        <dsp:cNvPr id="0" name=""/>
        <dsp:cNvSpPr/>
      </dsp:nvSpPr>
      <dsp:spPr>
        <a:xfrm>
          <a:off x="6380028" y="1125121"/>
          <a:ext cx="1845265" cy="201301"/>
        </a:xfrm>
        <a:prstGeom prst="roundRect">
          <a:avLst>
            <a:gd name="adj" fmla="val 10000"/>
          </a:avLst>
        </a:prstGeom>
        <a:solidFill>
          <a:schemeClr val="lt1"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dk1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7620" tIns="7620" rIns="7620" bIns="7620" numCol="1" spcCol="1270" anchor="ctr" anchorCtr="0">
          <a:noAutofit/>
        </a:bodyPr>
        <a:lstStyle/>
        <a:p>
          <a:pPr marL="0" lvl="0" indent="0" algn="ctr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de-DE" sz="1200" kern="1200" err="1">
              <a:latin typeface="Times New Roman" panose="02020603050405020304" pitchFamily="18" charset="0"/>
              <a:cs typeface="Times New Roman" panose="02020603050405020304" pitchFamily="18" charset="0"/>
            </a:rPr>
            <a:t>Asymptomatic</a:t>
          </a:r>
          <a:endParaRPr lang="de-DE" sz="1200" kern="1200">
            <a:latin typeface="Times New Roman" panose="02020603050405020304" pitchFamily="18" charset="0"/>
            <a:cs typeface="Times New Roman" panose="02020603050405020304" pitchFamily="18" charset="0"/>
          </a:endParaRPr>
        </a:p>
      </dsp:txBody>
      <dsp:txXfrm>
        <a:off x="6385924" y="1131017"/>
        <a:ext cx="1833473" cy="189509"/>
      </dsp:txXfrm>
    </dsp:sp>
    <dsp:sp modelId="{8D2BE030-0831-42B2-98C2-0F6E87AD5B7D}">
      <dsp:nvSpPr>
        <dsp:cNvPr id="0" name=""/>
        <dsp:cNvSpPr/>
      </dsp:nvSpPr>
      <dsp:spPr>
        <a:xfrm rot="21485799">
          <a:off x="3538870" y="1499627"/>
          <a:ext cx="2845023" cy="2246"/>
        </a:xfrm>
        <a:custGeom>
          <a:avLst/>
          <a:gdLst/>
          <a:ahLst/>
          <a:cxnLst/>
          <a:rect l="0" t="0" r="0" b="0"/>
          <a:pathLst>
            <a:path>
              <a:moveTo>
                <a:pt x="0" y="1123"/>
              </a:moveTo>
              <a:lnTo>
                <a:pt x="2845023" y="1123"/>
              </a:lnTo>
            </a:path>
          </a:pathLst>
        </a:custGeom>
        <a:noFill/>
        <a:ln w="12700" cap="flat" cmpd="sng" algn="ctr">
          <a:solidFill>
            <a:schemeClr val="dk1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2700" tIns="0" rIns="12700" bIns="0" numCol="1" spcCol="1270" anchor="ctr" anchorCtr="0">
          <a:noAutofit/>
        </a:bodyPr>
        <a:lstStyle/>
        <a:p>
          <a:pPr marL="0" lvl="0" indent="0" algn="ctr" defTabSz="4889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endParaRPr lang="de-DE" sz="1100" kern="1200">
            <a:latin typeface="Times New Roman" panose="02020603050405020304" pitchFamily="18" charset="0"/>
            <a:cs typeface="Times New Roman" panose="02020603050405020304" pitchFamily="18" charset="0"/>
          </a:endParaRPr>
        </a:p>
      </dsp:txBody>
      <dsp:txXfrm>
        <a:off x="-920171" y="1429625"/>
        <a:ext cx="11763107" cy="142251"/>
      </dsp:txXfrm>
    </dsp:sp>
    <dsp:sp modelId="{29EF756E-ED73-4753-83B6-EFB27D8AB242}">
      <dsp:nvSpPr>
        <dsp:cNvPr id="0" name=""/>
        <dsp:cNvSpPr/>
      </dsp:nvSpPr>
      <dsp:spPr>
        <a:xfrm>
          <a:off x="6383108" y="1352853"/>
          <a:ext cx="1845265" cy="201301"/>
        </a:xfrm>
        <a:prstGeom prst="roundRect">
          <a:avLst>
            <a:gd name="adj" fmla="val 10000"/>
          </a:avLst>
        </a:prstGeom>
        <a:solidFill>
          <a:schemeClr val="lt1"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dk1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7620" tIns="7620" rIns="7620" bIns="7620" numCol="1" spcCol="1270" anchor="ctr" anchorCtr="0">
          <a:noAutofit/>
        </a:bodyPr>
        <a:lstStyle/>
        <a:p>
          <a:pPr marL="0" lvl="0" indent="0" algn="ctr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de-DE" sz="1200" kern="1200" err="1">
              <a:latin typeface="Times New Roman" panose="02020603050405020304" pitchFamily="18" charset="0"/>
              <a:cs typeface="Times New Roman" panose="02020603050405020304" pitchFamily="18" charset="0"/>
            </a:rPr>
            <a:t>Presymptomatic</a:t>
          </a:r>
          <a:endParaRPr lang="de-DE" sz="1200" kern="1200">
            <a:latin typeface="Times New Roman" panose="02020603050405020304" pitchFamily="18" charset="0"/>
            <a:cs typeface="Times New Roman" panose="02020603050405020304" pitchFamily="18" charset="0"/>
          </a:endParaRPr>
        </a:p>
      </dsp:txBody>
      <dsp:txXfrm>
        <a:off x="6389004" y="1358749"/>
        <a:ext cx="1833473" cy="189509"/>
      </dsp:txXfrm>
    </dsp:sp>
    <dsp:sp modelId="{A20C5029-8277-4F52-A215-36A9DA1AB52E}">
      <dsp:nvSpPr>
        <dsp:cNvPr id="0" name=""/>
        <dsp:cNvSpPr/>
      </dsp:nvSpPr>
      <dsp:spPr>
        <a:xfrm rot="161887">
          <a:off x="3538072" y="1614064"/>
          <a:ext cx="2854679" cy="2246"/>
        </a:xfrm>
        <a:custGeom>
          <a:avLst/>
          <a:gdLst/>
          <a:ahLst/>
          <a:cxnLst/>
          <a:rect l="0" t="0" r="0" b="0"/>
          <a:pathLst>
            <a:path>
              <a:moveTo>
                <a:pt x="0" y="1123"/>
              </a:moveTo>
              <a:lnTo>
                <a:pt x="2854679" y="1123"/>
              </a:lnTo>
            </a:path>
          </a:pathLst>
        </a:custGeom>
        <a:noFill/>
        <a:ln w="12700" cap="flat" cmpd="sng" algn="ctr">
          <a:solidFill>
            <a:schemeClr val="dk1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2700" tIns="0" rIns="12700" bIns="0" numCol="1" spcCol="1270" anchor="ctr" anchorCtr="0">
          <a:noAutofit/>
        </a:bodyPr>
        <a:lstStyle/>
        <a:p>
          <a:pPr marL="0" lvl="0" indent="0" algn="ctr" defTabSz="4889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endParaRPr lang="de-DE" sz="1100" kern="1200">
            <a:latin typeface="Times New Roman" panose="02020603050405020304" pitchFamily="18" charset="0"/>
            <a:cs typeface="Times New Roman" panose="02020603050405020304" pitchFamily="18" charset="0"/>
          </a:endParaRPr>
        </a:p>
      </dsp:txBody>
      <dsp:txXfrm>
        <a:off x="-916141" y="1543820"/>
        <a:ext cx="11763107" cy="142733"/>
      </dsp:txXfrm>
    </dsp:sp>
    <dsp:sp modelId="{EC3C7E9C-DE6F-4CF5-B8A3-EB96093DECF2}">
      <dsp:nvSpPr>
        <dsp:cNvPr id="0" name=""/>
        <dsp:cNvSpPr/>
      </dsp:nvSpPr>
      <dsp:spPr>
        <a:xfrm>
          <a:off x="6391169" y="1581727"/>
          <a:ext cx="1845265" cy="201301"/>
        </a:xfrm>
        <a:prstGeom prst="roundRect">
          <a:avLst>
            <a:gd name="adj" fmla="val 10000"/>
          </a:avLst>
        </a:prstGeom>
        <a:solidFill>
          <a:schemeClr val="lt1"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dk1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7620" tIns="7620" rIns="7620" bIns="7620" numCol="1" spcCol="1270" anchor="ctr" anchorCtr="0">
          <a:noAutofit/>
        </a:bodyPr>
        <a:lstStyle/>
        <a:p>
          <a:pPr marL="0" lvl="0" indent="0" algn="ctr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de-DE" sz="1200" kern="1200" dirty="0" err="1">
              <a:latin typeface="Times New Roman" panose="02020603050405020304" pitchFamily="18" charset="0"/>
              <a:cs typeface="Times New Roman" panose="02020603050405020304" pitchFamily="18" charset="0"/>
            </a:rPr>
            <a:t>Means</a:t>
          </a:r>
          <a:r>
            <a:rPr lang="de-DE" sz="1200" kern="1200" dirty="0">
              <a:latin typeface="Times New Roman" panose="02020603050405020304" pitchFamily="18" charset="0"/>
              <a:cs typeface="Times New Roman" panose="02020603050405020304" pitchFamily="18" charset="0"/>
            </a:rPr>
            <a:t> of </a:t>
          </a:r>
          <a:r>
            <a:rPr lang="de-DE" sz="1200" kern="1200" dirty="0" err="1">
              <a:latin typeface="Times New Roman" panose="02020603050405020304" pitchFamily="18" charset="0"/>
              <a:cs typeface="Times New Roman" panose="02020603050405020304" pitchFamily="18" charset="0"/>
            </a:rPr>
            <a:t>transmission</a:t>
          </a:r>
          <a:endParaRPr lang="de-DE" sz="1200" kern="1200" dirty="0">
            <a:latin typeface="Times New Roman" panose="02020603050405020304" pitchFamily="18" charset="0"/>
            <a:cs typeface="Times New Roman" panose="02020603050405020304" pitchFamily="18" charset="0"/>
          </a:endParaRPr>
        </a:p>
      </dsp:txBody>
      <dsp:txXfrm>
        <a:off x="6397065" y="1587623"/>
        <a:ext cx="1833473" cy="189509"/>
      </dsp:txXfrm>
    </dsp:sp>
    <dsp:sp modelId="{FCAF4F74-DA65-4B57-BED5-BD3F26CA3653}">
      <dsp:nvSpPr>
        <dsp:cNvPr id="0" name=""/>
        <dsp:cNvSpPr/>
      </dsp:nvSpPr>
      <dsp:spPr>
        <a:xfrm rot="433834">
          <a:off x="3528228" y="1727730"/>
          <a:ext cx="2873866" cy="2246"/>
        </a:xfrm>
        <a:custGeom>
          <a:avLst/>
          <a:gdLst/>
          <a:ahLst/>
          <a:cxnLst/>
          <a:rect l="0" t="0" r="0" b="0"/>
          <a:pathLst>
            <a:path>
              <a:moveTo>
                <a:pt x="0" y="1123"/>
              </a:moveTo>
              <a:lnTo>
                <a:pt x="2873866" y="1123"/>
              </a:lnTo>
            </a:path>
          </a:pathLst>
        </a:custGeom>
        <a:noFill/>
        <a:ln w="12700" cap="flat" cmpd="sng" algn="ctr">
          <a:solidFill>
            <a:schemeClr val="dk1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2700" tIns="0" rIns="12700" bIns="0" numCol="1" spcCol="1270" anchor="ctr" anchorCtr="0">
          <a:noAutofit/>
        </a:bodyPr>
        <a:lstStyle/>
        <a:p>
          <a:pPr marL="0" lvl="0" indent="0" algn="ctr" defTabSz="4889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endParaRPr lang="de-DE" sz="1100" kern="1200">
            <a:latin typeface="Times New Roman" panose="02020603050405020304" pitchFamily="18" charset="0"/>
            <a:cs typeface="Times New Roman" panose="02020603050405020304" pitchFamily="18" charset="0"/>
          </a:endParaRPr>
        </a:p>
      </dsp:txBody>
      <dsp:txXfrm>
        <a:off x="-916392" y="1657006"/>
        <a:ext cx="11763107" cy="143693"/>
      </dsp:txXfrm>
    </dsp:sp>
    <dsp:sp modelId="{963787CF-28FB-43DF-98C2-C462DE3D4B6D}">
      <dsp:nvSpPr>
        <dsp:cNvPr id="0" name=""/>
        <dsp:cNvSpPr/>
      </dsp:nvSpPr>
      <dsp:spPr>
        <a:xfrm>
          <a:off x="6390667" y="1809058"/>
          <a:ext cx="1845265" cy="201301"/>
        </a:xfrm>
        <a:prstGeom prst="roundRect">
          <a:avLst>
            <a:gd name="adj" fmla="val 10000"/>
          </a:avLst>
        </a:prstGeom>
        <a:solidFill>
          <a:schemeClr val="lt1"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dk1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7620" tIns="7620" rIns="7620" bIns="7620" numCol="1" spcCol="1270" anchor="ctr" anchorCtr="0">
          <a:noAutofit/>
        </a:bodyPr>
        <a:lstStyle/>
        <a:p>
          <a:pPr marL="0" lvl="0" indent="0" algn="ctr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de-DE" sz="1200" kern="1200" err="1">
              <a:latin typeface="Times New Roman" panose="02020603050405020304" pitchFamily="18" charset="0"/>
              <a:cs typeface="Times New Roman" panose="02020603050405020304" pitchFamily="18" charset="0"/>
            </a:rPr>
            <a:t>Protection</a:t>
          </a:r>
          <a:r>
            <a:rPr lang="de-DE" sz="1200" kern="1200">
              <a:latin typeface="Times New Roman" panose="02020603050405020304" pitchFamily="18" charset="0"/>
              <a:cs typeface="Times New Roman" panose="02020603050405020304" pitchFamily="18" charset="0"/>
            </a:rPr>
            <a:t> </a:t>
          </a:r>
          <a:r>
            <a:rPr lang="de-DE" sz="1200" kern="1200" err="1">
              <a:latin typeface="Times New Roman" panose="02020603050405020304" pitchFamily="18" charset="0"/>
              <a:cs typeface="Times New Roman" panose="02020603050405020304" pitchFamily="18" charset="0"/>
            </a:rPr>
            <a:t>from</a:t>
          </a:r>
          <a:r>
            <a:rPr lang="de-DE" sz="1200" kern="1200">
              <a:latin typeface="Times New Roman" panose="02020603050405020304" pitchFamily="18" charset="0"/>
              <a:cs typeface="Times New Roman" panose="02020603050405020304" pitchFamily="18" charset="0"/>
            </a:rPr>
            <a:t> </a:t>
          </a:r>
          <a:r>
            <a:rPr lang="de-DE" sz="1200" kern="1200" err="1">
              <a:latin typeface="Times New Roman" panose="02020603050405020304" pitchFamily="18" charset="0"/>
              <a:cs typeface="Times New Roman" panose="02020603050405020304" pitchFamily="18" charset="0"/>
            </a:rPr>
            <a:t>transmission</a:t>
          </a:r>
          <a:endParaRPr lang="de-DE" sz="1200" kern="1200">
            <a:latin typeface="Times New Roman" panose="02020603050405020304" pitchFamily="18" charset="0"/>
            <a:cs typeface="Times New Roman" panose="02020603050405020304" pitchFamily="18" charset="0"/>
          </a:endParaRPr>
        </a:p>
      </dsp:txBody>
      <dsp:txXfrm>
        <a:off x="6396563" y="1814954"/>
        <a:ext cx="1833473" cy="189509"/>
      </dsp:txXfrm>
    </dsp:sp>
    <dsp:sp modelId="{52995CFF-A2C0-41A9-B8F6-E167247A0F1E}">
      <dsp:nvSpPr>
        <dsp:cNvPr id="0" name=""/>
        <dsp:cNvSpPr/>
      </dsp:nvSpPr>
      <dsp:spPr>
        <a:xfrm rot="691470">
          <a:off x="3510319" y="1837582"/>
          <a:ext cx="2910184" cy="2246"/>
        </a:xfrm>
        <a:custGeom>
          <a:avLst/>
          <a:gdLst/>
          <a:ahLst/>
          <a:cxnLst/>
          <a:rect l="0" t="0" r="0" b="0"/>
          <a:pathLst>
            <a:path>
              <a:moveTo>
                <a:pt x="0" y="1123"/>
              </a:moveTo>
              <a:lnTo>
                <a:pt x="2910184" y="1123"/>
              </a:lnTo>
            </a:path>
          </a:pathLst>
        </a:custGeom>
        <a:noFill/>
        <a:ln w="12700" cap="flat" cmpd="sng" algn="ctr">
          <a:solidFill>
            <a:schemeClr val="dk1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2700" tIns="0" rIns="12700" bIns="0" numCol="1" spcCol="1270" anchor="ctr" anchorCtr="0">
          <a:noAutofit/>
        </a:bodyPr>
        <a:lstStyle/>
        <a:p>
          <a:pPr marL="0" lvl="0" indent="0" algn="ctr" defTabSz="4889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endParaRPr lang="de-DE" sz="1100" kern="1200">
            <a:latin typeface="Times New Roman" panose="02020603050405020304" pitchFamily="18" charset="0"/>
            <a:cs typeface="Times New Roman" panose="02020603050405020304" pitchFamily="18" charset="0"/>
          </a:endParaRPr>
        </a:p>
      </dsp:txBody>
      <dsp:txXfrm>
        <a:off x="-916141" y="1765951"/>
        <a:ext cx="11763107" cy="145509"/>
      </dsp:txXfrm>
    </dsp:sp>
    <dsp:sp modelId="{15869452-7DB1-4E38-961A-AD18E7BF97A4}">
      <dsp:nvSpPr>
        <dsp:cNvPr id="0" name=""/>
        <dsp:cNvSpPr/>
      </dsp:nvSpPr>
      <dsp:spPr>
        <a:xfrm>
          <a:off x="6391168" y="2028764"/>
          <a:ext cx="1845265" cy="201301"/>
        </a:xfrm>
        <a:prstGeom prst="roundRect">
          <a:avLst>
            <a:gd name="adj" fmla="val 10000"/>
          </a:avLst>
        </a:prstGeom>
        <a:solidFill>
          <a:schemeClr val="lt1"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dk1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7620" tIns="7620" rIns="7620" bIns="7620" numCol="1" spcCol="1270" anchor="ctr" anchorCtr="0">
          <a:noAutofit/>
        </a:bodyPr>
        <a:lstStyle/>
        <a:p>
          <a:pPr marL="0" lvl="0" indent="0" algn="ctr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de-DE" sz="1200" kern="1200">
              <a:latin typeface="Times New Roman" panose="02020603050405020304" pitchFamily="18" charset="0"/>
              <a:cs typeface="Times New Roman" panose="02020603050405020304" pitchFamily="18" charset="0"/>
            </a:rPr>
            <a:t>Risk</a:t>
          </a:r>
        </a:p>
      </dsp:txBody>
      <dsp:txXfrm>
        <a:off x="6397064" y="2034660"/>
        <a:ext cx="1833473" cy="189509"/>
      </dsp:txXfrm>
    </dsp:sp>
    <dsp:sp modelId="{6DE65224-3B60-4229-ACDA-981AA44CA426}">
      <dsp:nvSpPr>
        <dsp:cNvPr id="0" name=""/>
        <dsp:cNvSpPr/>
      </dsp:nvSpPr>
      <dsp:spPr>
        <a:xfrm rot="20383053">
          <a:off x="8196331" y="1904097"/>
          <a:ext cx="1293495" cy="2246"/>
        </a:xfrm>
        <a:custGeom>
          <a:avLst/>
          <a:gdLst/>
          <a:ahLst/>
          <a:cxnLst/>
          <a:rect l="0" t="0" r="0" b="0"/>
          <a:pathLst>
            <a:path>
              <a:moveTo>
                <a:pt x="0" y="1123"/>
              </a:moveTo>
              <a:lnTo>
                <a:pt x="1293495" y="1123"/>
              </a:lnTo>
            </a:path>
          </a:pathLst>
        </a:custGeom>
        <a:noFill/>
        <a:ln w="12700" cap="flat" cmpd="sng" algn="ctr">
          <a:solidFill>
            <a:schemeClr val="dk1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2700" tIns="0" rIns="12700" bIns="0" numCol="1" spcCol="1270" anchor="ctr" anchorCtr="0">
          <a:noAutofit/>
        </a:bodyPr>
        <a:lstStyle/>
        <a:p>
          <a:pPr marL="0" lvl="0" indent="0" algn="ctr" defTabSz="4889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endParaRPr lang="de-DE" sz="1100" kern="1200">
            <a:latin typeface="Times New Roman" panose="02020603050405020304" pitchFamily="18" charset="0"/>
            <a:cs typeface="Times New Roman" panose="02020603050405020304" pitchFamily="18" charset="0"/>
          </a:endParaRPr>
        </a:p>
      </dsp:txBody>
      <dsp:txXfrm>
        <a:off x="2961525" y="1872883"/>
        <a:ext cx="11763107" cy="64674"/>
      </dsp:txXfrm>
    </dsp:sp>
    <dsp:sp modelId="{D2E49161-A7B6-4759-AC1C-493631AA99EA}">
      <dsp:nvSpPr>
        <dsp:cNvPr id="0" name=""/>
        <dsp:cNvSpPr/>
      </dsp:nvSpPr>
      <dsp:spPr>
        <a:xfrm>
          <a:off x="9449725" y="1585458"/>
          <a:ext cx="1979999" cy="191136"/>
        </a:xfrm>
        <a:prstGeom prst="roundRect">
          <a:avLst>
            <a:gd name="adj" fmla="val 10000"/>
          </a:avLst>
        </a:prstGeom>
        <a:solidFill>
          <a:schemeClr val="lt1"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dk1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7620" tIns="7620" rIns="7620" bIns="7620" numCol="1" spcCol="1270" anchor="ctr" anchorCtr="0">
          <a:noAutofit/>
        </a:bodyPr>
        <a:lstStyle/>
        <a:p>
          <a:pPr marL="0" lvl="0" indent="0" algn="ctr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de-DE" sz="1200" kern="1200">
              <a:latin typeface="Times New Roman" panose="02020603050405020304" pitchFamily="18" charset="0"/>
              <a:cs typeface="Times New Roman" panose="02020603050405020304" pitchFamily="18" charset="0"/>
            </a:rPr>
            <a:t>Underlying </a:t>
          </a:r>
          <a:r>
            <a:rPr lang="de-DE" sz="1200" kern="1200" err="1">
              <a:latin typeface="Times New Roman" panose="02020603050405020304" pitchFamily="18" charset="0"/>
              <a:cs typeface="Times New Roman" panose="02020603050405020304" pitchFamily="18" charset="0"/>
            </a:rPr>
            <a:t>conditions</a:t>
          </a:r>
          <a:endParaRPr lang="de-DE" sz="1200" kern="1200">
            <a:latin typeface="Times New Roman" panose="02020603050405020304" pitchFamily="18" charset="0"/>
            <a:cs typeface="Times New Roman" panose="02020603050405020304" pitchFamily="18" charset="0"/>
          </a:endParaRPr>
        </a:p>
      </dsp:txBody>
      <dsp:txXfrm>
        <a:off x="9455323" y="1591056"/>
        <a:ext cx="1968803" cy="179940"/>
      </dsp:txXfrm>
    </dsp:sp>
    <dsp:sp modelId="{D3655785-2D54-4F59-9234-66AFAA7E681A}">
      <dsp:nvSpPr>
        <dsp:cNvPr id="0" name=""/>
        <dsp:cNvSpPr/>
      </dsp:nvSpPr>
      <dsp:spPr>
        <a:xfrm rot="21053073">
          <a:off x="8228674" y="2030954"/>
          <a:ext cx="1228810" cy="2246"/>
        </a:xfrm>
        <a:custGeom>
          <a:avLst/>
          <a:gdLst/>
          <a:ahLst/>
          <a:cxnLst/>
          <a:rect l="0" t="0" r="0" b="0"/>
          <a:pathLst>
            <a:path>
              <a:moveTo>
                <a:pt x="0" y="1123"/>
              </a:moveTo>
              <a:lnTo>
                <a:pt x="1228810" y="1123"/>
              </a:lnTo>
            </a:path>
          </a:pathLst>
        </a:custGeom>
        <a:noFill/>
        <a:ln w="12700" cap="flat" cmpd="sng" algn="ctr">
          <a:solidFill>
            <a:schemeClr val="dk1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2700" tIns="0" rIns="12700" bIns="0" numCol="1" spcCol="1270" anchor="ctr" anchorCtr="0">
          <a:noAutofit/>
        </a:bodyPr>
        <a:lstStyle/>
        <a:p>
          <a:pPr marL="0" lvl="0" indent="0" algn="ctr" defTabSz="4889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endParaRPr lang="de-DE" sz="1100" kern="1200">
            <a:latin typeface="Times New Roman" panose="02020603050405020304" pitchFamily="18" charset="0"/>
            <a:cs typeface="Times New Roman" panose="02020603050405020304" pitchFamily="18" charset="0"/>
          </a:endParaRPr>
        </a:p>
      </dsp:txBody>
      <dsp:txXfrm>
        <a:off x="2961525" y="2001357"/>
        <a:ext cx="11763107" cy="61440"/>
      </dsp:txXfrm>
    </dsp:sp>
    <dsp:sp modelId="{A26EDAF6-44C8-4854-8F91-1F5749D4DC73}">
      <dsp:nvSpPr>
        <dsp:cNvPr id="0" name=""/>
        <dsp:cNvSpPr/>
      </dsp:nvSpPr>
      <dsp:spPr>
        <a:xfrm>
          <a:off x="9449725" y="1839174"/>
          <a:ext cx="1979999" cy="191134"/>
        </a:xfrm>
        <a:prstGeom prst="roundRect">
          <a:avLst>
            <a:gd name="adj" fmla="val 10000"/>
          </a:avLst>
        </a:prstGeom>
        <a:solidFill>
          <a:schemeClr val="lt1"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dk1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7620" tIns="7620" rIns="7620" bIns="7620" numCol="1" spcCol="1270" anchor="ctr" anchorCtr="0">
          <a:noAutofit/>
        </a:bodyPr>
        <a:lstStyle/>
        <a:p>
          <a:pPr marL="0" lvl="0" indent="0" algn="ctr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de-DE" sz="1200" kern="1200">
              <a:latin typeface="Times New Roman" panose="02020603050405020304" pitchFamily="18" charset="0"/>
              <a:cs typeface="Times New Roman" panose="02020603050405020304" pitchFamily="18" charset="0"/>
            </a:rPr>
            <a:t>Age</a:t>
          </a:r>
        </a:p>
      </dsp:txBody>
      <dsp:txXfrm>
        <a:off x="9455323" y="1844772"/>
        <a:ext cx="1968803" cy="179938"/>
      </dsp:txXfrm>
    </dsp:sp>
    <dsp:sp modelId="{FB2F6D88-F506-4847-B326-8EC15F62040F}">
      <dsp:nvSpPr>
        <dsp:cNvPr id="0" name=""/>
        <dsp:cNvSpPr/>
      </dsp:nvSpPr>
      <dsp:spPr>
        <a:xfrm rot="143215">
          <a:off x="8235906" y="2153578"/>
          <a:ext cx="1214345" cy="2246"/>
        </a:xfrm>
        <a:custGeom>
          <a:avLst/>
          <a:gdLst/>
          <a:ahLst/>
          <a:cxnLst/>
          <a:rect l="0" t="0" r="0" b="0"/>
          <a:pathLst>
            <a:path>
              <a:moveTo>
                <a:pt x="0" y="1123"/>
              </a:moveTo>
              <a:lnTo>
                <a:pt x="1214345" y="1123"/>
              </a:lnTo>
            </a:path>
          </a:pathLst>
        </a:custGeom>
        <a:noFill/>
        <a:ln w="12700" cap="flat" cmpd="sng" algn="ctr">
          <a:solidFill>
            <a:schemeClr val="dk1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2700" tIns="0" rIns="12700" bIns="0" numCol="1" spcCol="1270" anchor="ctr" anchorCtr="0">
          <a:noAutofit/>
        </a:bodyPr>
        <a:lstStyle/>
        <a:p>
          <a:pPr marL="0" lvl="0" indent="0" algn="ctr" defTabSz="4889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endParaRPr lang="de-DE" sz="1100" kern="1200">
            <a:latin typeface="Times New Roman" panose="02020603050405020304" pitchFamily="18" charset="0"/>
            <a:cs typeface="Times New Roman" panose="02020603050405020304" pitchFamily="18" charset="0"/>
          </a:endParaRPr>
        </a:p>
      </dsp:txBody>
      <dsp:txXfrm>
        <a:off x="2961525" y="2124343"/>
        <a:ext cx="11763107" cy="60717"/>
      </dsp:txXfrm>
    </dsp:sp>
    <dsp:sp modelId="{4364814E-1DC4-41D8-96F5-7FCAA16DA2B0}">
      <dsp:nvSpPr>
        <dsp:cNvPr id="0" name=""/>
        <dsp:cNvSpPr/>
      </dsp:nvSpPr>
      <dsp:spPr>
        <a:xfrm>
          <a:off x="9449725" y="2084421"/>
          <a:ext cx="1979999" cy="191134"/>
        </a:xfrm>
        <a:prstGeom prst="roundRect">
          <a:avLst>
            <a:gd name="adj" fmla="val 10000"/>
          </a:avLst>
        </a:prstGeom>
        <a:solidFill>
          <a:schemeClr val="lt1"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dk1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7620" tIns="7620" rIns="7620" bIns="7620" numCol="1" spcCol="1270" anchor="ctr" anchorCtr="0">
          <a:noAutofit/>
        </a:bodyPr>
        <a:lstStyle/>
        <a:p>
          <a:pPr marL="0" lvl="0" indent="0" algn="ctr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de-DE" sz="1200" kern="1200">
              <a:latin typeface="Times New Roman" panose="02020603050405020304" pitchFamily="18" charset="0"/>
              <a:cs typeface="Times New Roman" panose="02020603050405020304" pitchFamily="18" charset="0"/>
            </a:rPr>
            <a:t>Sex</a:t>
          </a:r>
        </a:p>
      </dsp:txBody>
      <dsp:txXfrm>
        <a:off x="9455323" y="2090019"/>
        <a:ext cx="1968803" cy="179938"/>
      </dsp:txXfrm>
    </dsp:sp>
    <dsp:sp modelId="{5BC2E700-F976-45E3-88A6-547D0BC5C286}">
      <dsp:nvSpPr>
        <dsp:cNvPr id="0" name=""/>
        <dsp:cNvSpPr/>
      </dsp:nvSpPr>
      <dsp:spPr>
        <a:xfrm rot="849568">
          <a:off x="8217425" y="2281340"/>
          <a:ext cx="1251308" cy="2246"/>
        </a:xfrm>
        <a:custGeom>
          <a:avLst/>
          <a:gdLst/>
          <a:ahLst/>
          <a:cxnLst/>
          <a:rect l="0" t="0" r="0" b="0"/>
          <a:pathLst>
            <a:path>
              <a:moveTo>
                <a:pt x="0" y="1123"/>
              </a:moveTo>
              <a:lnTo>
                <a:pt x="1251308" y="1123"/>
              </a:lnTo>
            </a:path>
          </a:pathLst>
        </a:custGeom>
        <a:noFill/>
        <a:ln w="12700" cap="flat" cmpd="sng" algn="ctr">
          <a:solidFill>
            <a:schemeClr val="dk1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2700" tIns="0" rIns="12700" bIns="0" numCol="1" spcCol="1270" anchor="ctr" anchorCtr="0">
          <a:noAutofit/>
        </a:bodyPr>
        <a:lstStyle/>
        <a:p>
          <a:pPr marL="0" lvl="0" indent="0" algn="ctr" defTabSz="4889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endParaRPr lang="de-DE" sz="1100" kern="1200">
            <a:latin typeface="Times New Roman" panose="02020603050405020304" pitchFamily="18" charset="0"/>
            <a:cs typeface="Times New Roman" panose="02020603050405020304" pitchFamily="18" charset="0"/>
          </a:endParaRPr>
        </a:p>
      </dsp:txBody>
      <dsp:txXfrm>
        <a:off x="2961525" y="2251180"/>
        <a:ext cx="11763107" cy="62565"/>
      </dsp:txXfrm>
    </dsp:sp>
    <dsp:sp modelId="{677DE54C-6078-40B3-9FE8-CF37F7EF3F0C}">
      <dsp:nvSpPr>
        <dsp:cNvPr id="0" name=""/>
        <dsp:cNvSpPr/>
      </dsp:nvSpPr>
      <dsp:spPr>
        <a:xfrm>
          <a:off x="9449725" y="2339944"/>
          <a:ext cx="1979999" cy="191133"/>
        </a:xfrm>
        <a:prstGeom prst="roundRect">
          <a:avLst>
            <a:gd name="adj" fmla="val 10000"/>
          </a:avLst>
        </a:prstGeom>
        <a:solidFill>
          <a:schemeClr val="lt1"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dk1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7620" tIns="7620" rIns="7620" bIns="7620" numCol="1" spcCol="1270" anchor="ctr" anchorCtr="0">
          <a:noAutofit/>
        </a:bodyPr>
        <a:lstStyle/>
        <a:p>
          <a:pPr marL="0" lvl="0" indent="0" algn="ctr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de-DE" sz="1200" kern="1200">
              <a:latin typeface="Times New Roman" panose="02020603050405020304" pitchFamily="18" charset="0"/>
              <a:cs typeface="Times New Roman" panose="02020603050405020304" pitchFamily="18" charset="0"/>
            </a:rPr>
            <a:t>Vulnerable </a:t>
          </a:r>
          <a:r>
            <a:rPr lang="de-DE" sz="1200" kern="1200" err="1">
              <a:latin typeface="Times New Roman" panose="02020603050405020304" pitchFamily="18" charset="0"/>
              <a:cs typeface="Times New Roman" panose="02020603050405020304" pitchFamily="18" charset="0"/>
            </a:rPr>
            <a:t>people</a:t>
          </a:r>
          <a:endParaRPr lang="de-DE" sz="1200" kern="1200">
            <a:latin typeface="Times New Roman" panose="02020603050405020304" pitchFamily="18" charset="0"/>
            <a:cs typeface="Times New Roman" panose="02020603050405020304" pitchFamily="18" charset="0"/>
          </a:endParaRPr>
        </a:p>
      </dsp:txBody>
      <dsp:txXfrm>
        <a:off x="9455323" y="2345542"/>
        <a:ext cx="1968803" cy="179937"/>
      </dsp:txXfrm>
    </dsp:sp>
    <dsp:sp modelId="{007AF09B-7B63-4C84-BFB2-EF40ED79070D}">
      <dsp:nvSpPr>
        <dsp:cNvPr id="0" name=""/>
        <dsp:cNvSpPr/>
      </dsp:nvSpPr>
      <dsp:spPr>
        <a:xfrm rot="1462070">
          <a:off x="8177175" y="2402740"/>
          <a:ext cx="1330363" cy="2246"/>
        </a:xfrm>
        <a:custGeom>
          <a:avLst/>
          <a:gdLst/>
          <a:ahLst/>
          <a:cxnLst/>
          <a:rect l="0" t="0" r="0" b="0"/>
          <a:pathLst>
            <a:path>
              <a:moveTo>
                <a:pt x="0" y="1123"/>
              </a:moveTo>
              <a:lnTo>
                <a:pt x="1330363" y="1123"/>
              </a:lnTo>
            </a:path>
          </a:pathLst>
        </a:custGeom>
        <a:noFill/>
        <a:ln w="12700" cap="flat" cmpd="sng" algn="ctr">
          <a:solidFill>
            <a:schemeClr val="dk1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2700" tIns="0" rIns="12700" bIns="0" numCol="1" spcCol="1270" anchor="ctr" anchorCtr="0">
          <a:noAutofit/>
        </a:bodyPr>
        <a:lstStyle/>
        <a:p>
          <a:pPr marL="0" lvl="0" indent="0" algn="ctr" defTabSz="3556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endParaRPr lang="de-DE" sz="800" kern="1200">
            <a:latin typeface="Times New Roman" panose="02020603050405020304" pitchFamily="18" charset="0"/>
            <a:cs typeface="Times New Roman" panose="02020603050405020304" pitchFamily="18" charset="0"/>
          </a:endParaRPr>
        </a:p>
      </dsp:txBody>
      <dsp:txXfrm>
        <a:off x="2960804" y="2370605"/>
        <a:ext cx="11763107" cy="66518"/>
      </dsp:txXfrm>
    </dsp:sp>
    <dsp:sp modelId="{38194E2B-8C9B-446D-93B0-01D743C0AC69}">
      <dsp:nvSpPr>
        <dsp:cNvPr id="0" name=""/>
        <dsp:cNvSpPr/>
      </dsp:nvSpPr>
      <dsp:spPr>
        <a:xfrm>
          <a:off x="9448282" y="2582746"/>
          <a:ext cx="1979999" cy="191134"/>
        </a:xfrm>
        <a:prstGeom prst="roundRect">
          <a:avLst>
            <a:gd name="adj" fmla="val 10000"/>
          </a:avLst>
        </a:prstGeom>
        <a:solidFill>
          <a:schemeClr val="lt1"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dk1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7620" tIns="7620" rIns="7620" bIns="7620" numCol="1" spcCol="1270" anchor="ctr" anchorCtr="0">
          <a:noAutofit/>
        </a:bodyPr>
        <a:lstStyle/>
        <a:p>
          <a:pPr marL="0" lvl="0" indent="0" algn="ctr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de-DE" sz="1200" kern="1200">
              <a:latin typeface="Times New Roman" panose="02020603050405020304" pitchFamily="18" charset="0"/>
              <a:cs typeface="Times New Roman" panose="02020603050405020304" pitchFamily="18" charset="0"/>
            </a:rPr>
            <a:t>Vulnerable </a:t>
          </a:r>
          <a:r>
            <a:rPr lang="de-DE" sz="1200" kern="1200" err="1">
              <a:latin typeface="Times New Roman" panose="02020603050405020304" pitchFamily="18" charset="0"/>
              <a:cs typeface="Times New Roman" panose="02020603050405020304" pitchFamily="18" charset="0"/>
            </a:rPr>
            <a:t>communities</a:t>
          </a:r>
          <a:endParaRPr lang="de-DE" sz="1200" kern="1200">
            <a:latin typeface="Times New Roman" panose="02020603050405020304" pitchFamily="18" charset="0"/>
            <a:cs typeface="Times New Roman" panose="02020603050405020304" pitchFamily="18" charset="0"/>
          </a:endParaRPr>
        </a:p>
      </dsp:txBody>
      <dsp:txXfrm>
        <a:off x="9453880" y="2588344"/>
        <a:ext cx="1968803" cy="179938"/>
      </dsp:txXfrm>
    </dsp:sp>
    <dsp:sp modelId="{925EDBFF-3D85-437B-9D22-40DBEB5AB8DA}">
      <dsp:nvSpPr>
        <dsp:cNvPr id="0" name=""/>
        <dsp:cNvSpPr/>
      </dsp:nvSpPr>
      <dsp:spPr>
        <a:xfrm rot="19296154">
          <a:off x="1201596" y="2993323"/>
          <a:ext cx="677068" cy="2246"/>
        </a:xfrm>
        <a:custGeom>
          <a:avLst/>
          <a:gdLst/>
          <a:ahLst/>
          <a:cxnLst/>
          <a:rect l="0" t="0" r="0" b="0"/>
          <a:pathLst>
            <a:path>
              <a:moveTo>
                <a:pt x="0" y="1123"/>
              </a:moveTo>
              <a:lnTo>
                <a:pt x="677068" y="1123"/>
              </a:lnTo>
            </a:path>
          </a:pathLst>
        </a:custGeom>
        <a:noFill/>
        <a:ln w="12700" cap="flat" cmpd="sng" algn="ctr">
          <a:solidFill>
            <a:schemeClr val="dk1">
              <a:shade val="6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2700" tIns="0" rIns="12700" bIns="0" numCol="1" spcCol="1270" anchor="ctr" anchorCtr="0">
          <a:noAutofit/>
        </a:bodyPr>
        <a:lstStyle/>
        <a:p>
          <a:pPr marL="0" lvl="0" indent="0" algn="ctr" defTabSz="4889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endParaRPr lang="de-DE" sz="1100" kern="1200">
            <a:latin typeface="Times New Roman" panose="02020603050405020304" pitchFamily="18" charset="0"/>
            <a:cs typeface="Times New Roman" panose="02020603050405020304" pitchFamily="18" charset="0"/>
          </a:endParaRPr>
        </a:p>
      </dsp:txBody>
      <dsp:txXfrm>
        <a:off x="-4341423" y="2977520"/>
        <a:ext cx="11763107" cy="33853"/>
      </dsp:txXfrm>
    </dsp:sp>
    <dsp:sp modelId="{933E68AA-CF10-49A1-ABCC-DA114DDEAF2A}">
      <dsp:nvSpPr>
        <dsp:cNvPr id="0" name=""/>
        <dsp:cNvSpPr/>
      </dsp:nvSpPr>
      <dsp:spPr>
        <a:xfrm>
          <a:off x="1805446" y="2683528"/>
          <a:ext cx="1736719" cy="201301"/>
        </a:xfrm>
        <a:prstGeom prst="roundRect">
          <a:avLst>
            <a:gd name="adj" fmla="val 10000"/>
          </a:avLst>
        </a:prstGeom>
        <a:solidFill>
          <a:schemeClr val="lt1"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dk1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7620" tIns="7620" rIns="7620" bIns="7620" numCol="1" spcCol="1270" anchor="ctr" anchorCtr="0">
          <a:noAutofit/>
        </a:bodyPr>
        <a:lstStyle/>
        <a:p>
          <a:pPr marL="0" lvl="0" indent="0" algn="ctr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de-DE" sz="1200" kern="1200" dirty="0">
              <a:latin typeface="Times New Roman" panose="02020603050405020304" pitchFamily="18" charset="0"/>
              <a:cs typeface="Times New Roman" panose="02020603050405020304" pitchFamily="18" charset="0"/>
            </a:rPr>
            <a:t>The Treatment</a:t>
          </a:r>
        </a:p>
      </dsp:txBody>
      <dsp:txXfrm>
        <a:off x="1811342" y="2689424"/>
        <a:ext cx="1724927" cy="189509"/>
      </dsp:txXfrm>
    </dsp:sp>
    <dsp:sp modelId="{0E872D06-F66B-4811-92EA-E374B25899A2}">
      <dsp:nvSpPr>
        <dsp:cNvPr id="0" name=""/>
        <dsp:cNvSpPr/>
      </dsp:nvSpPr>
      <dsp:spPr>
        <a:xfrm rot="19441780">
          <a:off x="3470095" y="2561049"/>
          <a:ext cx="755936" cy="2246"/>
        </a:xfrm>
        <a:custGeom>
          <a:avLst/>
          <a:gdLst/>
          <a:ahLst/>
          <a:cxnLst/>
          <a:rect l="0" t="0" r="0" b="0"/>
          <a:pathLst>
            <a:path>
              <a:moveTo>
                <a:pt x="0" y="1123"/>
              </a:moveTo>
              <a:lnTo>
                <a:pt x="755936" y="1123"/>
              </a:lnTo>
            </a:path>
          </a:pathLst>
        </a:custGeom>
        <a:noFill/>
        <a:ln w="12700" cap="flat" cmpd="sng" algn="ctr">
          <a:solidFill>
            <a:schemeClr val="dk1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2700" tIns="0" rIns="12700" bIns="0" numCol="1" spcCol="1270" anchor="ctr" anchorCtr="0">
          <a:noAutofit/>
        </a:bodyPr>
        <a:lstStyle/>
        <a:p>
          <a:pPr marL="0" lvl="0" indent="0" algn="ctr" defTabSz="4889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endParaRPr lang="de-DE" sz="1100" kern="1200">
            <a:latin typeface="Times New Roman" panose="02020603050405020304" pitchFamily="18" charset="0"/>
            <a:cs typeface="Times New Roman" panose="02020603050405020304" pitchFamily="18" charset="0"/>
          </a:endParaRPr>
        </a:p>
      </dsp:txBody>
      <dsp:txXfrm>
        <a:off x="-2033489" y="2543274"/>
        <a:ext cx="11763107" cy="37796"/>
      </dsp:txXfrm>
    </dsp:sp>
    <dsp:sp modelId="{3F552C8C-859A-4030-A503-8872BA917E0A}">
      <dsp:nvSpPr>
        <dsp:cNvPr id="0" name=""/>
        <dsp:cNvSpPr/>
      </dsp:nvSpPr>
      <dsp:spPr>
        <a:xfrm>
          <a:off x="4153962" y="2244506"/>
          <a:ext cx="1752058" cy="191321"/>
        </a:xfrm>
        <a:prstGeom prst="roundRect">
          <a:avLst>
            <a:gd name="adj" fmla="val 10000"/>
          </a:avLst>
        </a:prstGeom>
        <a:solidFill>
          <a:schemeClr val="lt1"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dk1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7620" tIns="7620" rIns="7620" bIns="7620" numCol="1" spcCol="1270" anchor="ctr" anchorCtr="0">
          <a:noAutofit/>
        </a:bodyPr>
        <a:lstStyle/>
        <a:p>
          <a:pPr marL="0" lvl="0" indent="0" algn="ctr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de-DE" sz="1200" kern="1200" err="1">
              <a:latin typeface="Times New Roman" panose="02020603050405020304" pitchFamily="18" charset="0"/>
              <a:cs typeface="Times New Roman" panose="02020603050405020304" pitchFamily="18" charset="0"/>
            </a:rPr>
            <a:t>Current</a:t>
          </a:r>
          <a:r>
            <a:rPr lang="de-DE" sz="1200" kern="1200">
              <a:latin typeface="Times New Roman" panose="02020603050405020304" pitchFamily="18" charset="0"/>
              <a:cs typeface="Times New Roman" panose="02020603050405020304" pitchFamily="18" charset="0"/>
            </a:rPr>
            <a:t> </a:t>
          </a:r>
          <a:r>
            <a:rPr lang="de-DE" sz="1200" kern="1200" err="1">
              <a:latin typeface="Times New Roman" panose="02020603050405020304" pitchFamily="18" charset="0"/>
              <a:cs typeface="Times New Roman" panose="02020603050405020304" pitchFamily="18" charset="0"/>
            </a:rPr>
            <a:t>treatment</a:t>
          </a:r>
          <a:endParaRPr lang="de-DE" sz="1200" kern="1200">
            <a:latin typeface="Times New Roman" panose="02020603050405020304" pitchFamily="18" charset="0"/>
            <a:cs typeface="Times New Roman" panose="02020603050405020304" pitchFamily="18" charset="0"/>
          </a:endParaRPr>
        </a:p>
      </dsp:txBody>
      <dsp:txXfrm>
        <a:off x="4159566" y="2250110"/>
        <a:ext cx="1740850" cy="180113"/>
      </dsp:txXfrm>
    </dsp:sp>
    <dsp:sp modelId="{168B63D6-E582-4001-8D06-4264135971C6}">
      <dsp:nvSpPr>
        <dsp:cNvPr id="0" name=""/>
        <dsp:cNvSpPr/>
      </dsp:nvSpPr>
      <dsp:spPr>
        <a:xfrm rot="20383938">
          <a:off x="3522012" y="2670298"/>
          <a:ext cx="651010" cy="2246"/>
        </a:xfrm>
        <a:custGeom>
          <a:avLst/>
          <a:gdLst/>
          <a:ahLst/>
          <a:cxnLst/>
          <a:rect l="0" t="0" r="0" b="0"/>
          <a:pathLst>
            <a:path>
              <a:moveTo>
                <a:pt x="0" y="1123"/>
              </a:moveTo>
              <a:lnTo>
                <a:pt x="651010" y="1123"/>
              </a:lnTo>
            </a:path>
          </a:pathLst>
        </a:custGeom>
        <a:noFill/>
        <a:ln w="12700" cap="flat" cmpd="sng" algn="ctr">
          <a:solidFill>
            <a:schemeClr val="dk1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2700" tIns="0" rIns="12700" bIns="0" numCol="1" spcCol="1270" anchor="ctr" anchorCtr="0">
          <a:noAutofit/>
        </a:bodyPr>
        <a:lstStyle/>
        <a:p>
          <a:pPr marL="0" lvl="0" indent="0" algn="ctr" defTabSz="3556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endParaRPr lang="de-DE" sz="800" kern="1200">
            <a:latin typeface="Times New Roman" panose="02020603050405020304" pitchFamily="18" charset="0"/>
            <a:cs typeface="Times New Roman" panose="02020603050405020304" pitchFamily="18" charset="0"/>
          </a:endParaRPr>
        </a:p>
      </dsp:txBody>
      <dsp:txXfrm>
        <a:off x="-2034035" y="2655146"/>
        <a:ext cx="11763107" cy="32550"/>
      </dsp:txXfrm>
    </dsp:sp>
    <dsp:sp modelId="{BF83AAD4-9518-47AA-835D-A40E2C49AF13}">
      <dsp:nvSpPr>
        <dsp:cNvPr id="0" name=""/>
        <dsp:cNvSpPr/>
      </dsp:nvSpPr>
      <dsp:spPr>
        <a:xfrm>
          <a:off x="4152869" y="2463004"/>
          <a:ext cx="1752058" cy="191320"/>
        </a:xfrm>
        <a:prstGeom prst="roundRect">
          <a:avLst>
            <a:gd name="adj" fmla="val 10000"/>
          </a:avLst>
        </a:prstGeom>
        <a:solidFill>
          <a:schemeClr val="lt1"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dk1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7620" tIns="7620" rIns="7620" bIns="7620" numCol="1" spcCol="1270" anchor="ctr" anchorCtr="0">
          <a:noAutofit/>
        </a:bodyPr>
        <a:lstStyle/>
        <a:p>
          <a:pPr marL="0" lvl="0" indent="0" algn="ctr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de-DE" sz="1200" kern="1200" err="1">
              <a:latin typeface="Times New Roman" panose="02020603050405020304" pitchFamily="18" charset="0"/>
              <a:cs typeface="Times New Roman" panose="02020603050405020304" pitchFamily="18" charset="0"/>
            </a:rPr>
            <a:t>Vaccines</a:t>
          </a:r>
          <a:endParaRPr lang="de-DE" sz="1200" kern="1200">
            <a:latin typeface="Times New Roman" panose="02020603050405020304" pitchFamily="18" charset="0"/>
            <a:cs typeface="Times New Roman" panose="02020603050405020304" pitchFamily="18" charset="0"/>
          </a:endParaRPr>
        </a:p>
      </dsp:txBody>
      <dsp:txXfrm>
        <a:off x="4158473" y="2468608"/>
        <a:ext cx="1740850" cy="180112"/>
      </dsp:txXfrm>
    </dsp:sp>
    <dsp:sp modelId="{12649787-8B1A-4097-B62E-BBC1879F2014}">
      <dsp:nvSpPr>
        <dsp:cNvPr id="0" name=""/>
        <dsp:cNvSpPr/>
      </dsp:nvSpPr>
      <dsp:spPr>
        <a:xfrm rot="21571192">
          <a:off x="3542155" y="2780505"/>
          <a:ext cx="608612" cy="2246"/>
        </a:xfrm>
        <a:custGeom>
          <a:avLst/>
          <a:gdLst/>
          <a:ahLst/>
          <a:cxnLst/>
          <a:rect l="0" t="0" r="0" b="0"/>
          <a:pathLst>
            <a:path>
              <a:moveTo>
                <a:pt x="0" y="1123"/>
              </a:moveTo>
              <a:lnTo>
                <a:pt x="608612" y="1123"/>
              </a:lnTo>
            </a:path>
          </a:pathLst>
        </a:custGeom>
        <a:noFill/>
        <a:ln w="12700" cap="flat" cmpd="sng" algn="ctr">
          <a:solidFill>
            <a:schemeClr val="dk1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2700" tIns="0" rIns="12700" bIns="0" numCol="1" spcCol="1270" anchor="ctr" anchorCtr="0">
          <a:noAutofit/>
        </a:bodyPr>
        <a:lstStyle/>
        <a:p>
          <a:pPr marL="0" lvl="0" indent="0" algn="ctr" defTabSz="4889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endParaRPr lang="de-DE" sz="1100" kern="1200">
            <a:latin typeface="Times New Roman" panose="02020603050405020304" pitchFamily="18" charset="0"/>
            <a:cs typeface="Times New Roman" panose="02020603050405020304" pitchFamily="18" charset="0"/>
          </a:endParaRPr>
        </a:p>
      </dsp:txBody>
      <dsp:txXfrm>
        <a:off x="-2035091" y="2766413"/>
        <a:ext cx="11763107" cy="30430"/>
      </dsp:txXfrm>
    </dsp:sp>
    <dsp:sp modelId="{D4B8489D-29A0-450D-846E-6780D2436C16}">
      <dsp:nvSpPr>
        <dsp:cNvPr id="0" name=""/>
        <dsp:cNvSpPr/>
      </dsp:nvSpPr>
      <dsp:spPr>
        <a:xfrm>
          <a:off x="4150757" y="2683510"/>
          <a:ext cx="1752058" cy="191136"/>
        </a:xfrm>
        <a:prstGeom prst="roundRect">
          <a:avLst>
            <a:gd name="adj" fmla="val 10000"/>
          </a:avLst>
        </a:prstGeom>
        <a:solidFill>
          <a:schemeClr val="lt1"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dk1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7620" tIns="7620" rIns="7620" bIns="7620" numCol="1" spcCol="1270" anchor="ctr" anchorCtr="0">
          <a:noAutofit/>
        </a:bodyPr>
        <a:lstStyle/>
        <a:p>
          <a:pPr marL="0" lvl="0" indent="0" algn="ctr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de-DE" sz="1200" kern="1200">
              <a:latin typeface="Times New Roman" panose="02020603050405020304" pitchFamily="18" charset="0"/>
              <a:cs typeface="Times New Roman" panose="02020603050405020304" pitchFamily="18" charset="0"/>
            </a:rPr>
            <a:t>Research and </a:t>
          </a:r>
          <a:r>
            <a:rPr lang="de-DE" sz="1200" kern="1200" err="1">
              <a:latin typeface="Times New Roman" panose="02020603050405020304" pitchFamily="18" charset="0"/>
              <a:cs typeface="Times New Roman" panose="02020603050405020304" pitchFamily="18" charset="0"/>
            </a:rPr>
            <a:t>development</a:t>
          </a:r>
          <a:endParaRPr lang="de-DE" sz="1200" kern="1200">
            <a:latin typeface="Times New Roman" panose="02020603050405020304" pitchFamily="18" charset="0"/>
            <a:cs typeface="Times New Roman" panose="02020603050405020304" pitchFamily="18" charset="0"/>
          </a:endParaRPr>
        </a:p>
      </dsp:txBody>
      <dsp:txXfrm>
        <a:off x="4156355" y="2689108"/>
        <a:ext cx="1740862" cy="179940"/>
      </dsp:txXfrm>
    </dsp:sp>
    <dsp:sp modelId="{87A49760-64CE-4CBD-BF78-45B22D2A4949}">
      <dsp:nvSpPr>
        <dsp:cNvPr id="0" name=""/>
        <dsp:cNvSpPr/>
      </dsp:nvSpPr>
      <dsp:spPr>
        <a:xfrm rot="1127829">
          <a:off x="3525022" y="2886629"/>
          <a:ext cx="642879" cy="2246"/>
        </a:xfrm>
        <a:custGeom>
          <a:avLst/>
          <a:gdLst/>
          <a:ahLst/>
          <a:cxnLst/>
          <a:rect l="0" t="0" r="0" b="0"/>
          <a:pathLst>
            <a:path>
              <a:moveTo>
                <a:pt x="0" y="1123"/>
              </a:moveTo>
              <a:lnTo>
                <a:pt x="642879" y="1123"/>
              </a:lnTo>
            </a:path>
          </a:pathLst>
        </a:custGeom>
        <a:noFill/>
        <a:ln w="12700" cap="flat" cmpd="sng" algn="ctr">
          <a:solidFill>
            <a:schemeClr val="dk1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2700" tIns="0" rIns="12700" bIns="0" numCol="1" spcCol="1270" anchor="ctr" anchorCtr="0">
          <a:noAutofit/>
        </a:bodyPr>
        <a:lstStyle/>
        <a:p>
          <a:pPr marL="0" lvl="0" indent="0" algn="ctr" defTabSz="4889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endParaRPr lang="de-DE" sz="1100" kern="1200">
            <a:latin typeface="Times New Roman" panose="02020603050405020304" pitchFamily="18" charset="0"/>
            <a:cs typeface="Times New Roman" panose="02020603050405020304" pitchFamily="18" charset="0"/>
          </a:endParaRPr>
        </a:p>
      </dsp:txBody>
      <dsp:txXfrm>
        <a:off x="-2035091" y="2871680"/>
        <a:ext cx="11763107" cy="32143"/>
      </dsp:txXfrm>
    </dsp:sp>
    <dsp:sp modelId="{C50E5B3A-B9FE-43B9-85D2-DC2953853106}">
      <dsp:nvSpPr>
        <dsp:cNvPr id="0" name=""/>
        <dsp:cNvSpPr/>
      </dsp:nvSpPr>
      <dsp:spPr>
        <a:xfrm>
          <a:off x="4150757" y="2895665"/>
          <a:ext cx="1752058" cy="191322"/>
        </a:xfrm>
        <a:prstGeom prst="roundRect">
          <a:avLst>
            <a:gd name="adj" fmla="val 10000"/>
          </a:avLst>
        </a:prstGeom>
        <a:solidFill>
          <a:schemeClr val="lt1"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dk1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7620" tIns="7620" rIns="7620" bIns="7620" numCol="1" spcCol="1270" anchor="ctr" anchorCtr="0">
          <a:noAutofit/>
        </a:bodyPr>
        <a:lstStyle/>
        <a:p>
          <a:pPr marL="0" lvl="0" indent="0" algn="ctr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de-DE" sz="1200" kern="1200" err="1">
              <a:latin typeface="Times New Roman" panose="02020603050405020304" pitchFamily="18" charset="0"/>
              <a:cs typeface="Times New Roman" panose="02020603050405020304" pitchFamily="18" charset="0"/>
            </a:rPr>
            <a:t>Nonproven</a:t>
          </a:r>
          <a:r>
            <a:rPr lang="de-DE" sz="1200" kern="1200">
              <a:latin typeface="Times New Roman" panose="02020603050405020304" pitchFamily="18" charset="0"/>
              <a:cs typeface="Times New Roman" panose="02020603050405020304" pitchFamily="18" charset="0"/>
            </a:rPr>
            <a:t> </a:t>
          </a:r>
          <a:r>
            <a:rPr lang="de-DE" sz="1200" kern="1200" err="1">
              <a:latin typeface="Times New Roman" panose="02020603050405020304" pitchFamily="18" charset="0"/>
              <a:cs typeface="Times New Roman" panose="02020603050405020304" pitchFamily="18" charset="0"/>
            </a:rPr>
            <a:t>treatment</a:t>
          </a:r>
          <a:endParaRPr lang="de-DE" sz="1200" kern="1200">
            <a:latin typeface="Times New Roman" panose="02020603050405020304" pitchFamily="18" charset="0"/>
            <a:cs typeface="Times New Roman" panose="02020603050405020304" pitchFamily="18" charset="0"/>
          </a:endParaRPr>
        </a:p>
      </dsp:txBody>
      <dsp:txXfrm>
        <a:off x="4156361" y="2901269"/>
        <a:ext cx="1740850" cy="180114"/>
      </dsp:txXfrm>
    </dsp:sp>
    <dsp:sp modelId="{FC687F4F-95AF-4388-A390-2F0E64666848}">
      <dsp:nvSpPr>
        <dsp:cNvPr id="0" name=""/>
        <dsp:cNvSpPr/>
      </dsp:nvSpPr>
      <dsp:spPr>
        <a:xfrm rot="2108585">
          <a:off x="3474252" y="2997517"/>
          <a:ext cx="745151" cy="2246"/>
        </a:xfrm>
        <a:custGeom>
          <a:avLst/>
          <a:gdLst/>
          <a:ahLst/>
          <a:cxnLst/>
          <a:rect l="0" t="0" r="0" b="0"/>
          <a:pathLst>
            <a:path>
              <a:moveTo>
                <a:pt x="0" y="1123"/>
              </a:moveTo>
              <a:lnTo>
                <a:pt x="745151" y="1123"/>
              </a:lnTo>
            </a:path>
          </a:pathLst>
        </a:custGeom>
        <a:noFill/>
        <a:ln w="12700" cap="flat" cmpd="sng" algn="ctr">
          <a:solidFill>
            <a:schemeClr val="dk1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2700" tIns="0" rIns="12700" bIns="0" numCol="1" spcCol="1270" anchor="ctr" anchorCtr="0">
          <a:noAutofit/>
        </a:bodyPr>
        <a:lstStyle/>
        <a:p>
          <a:pPr marL="0" lvl="0" indent="0" algn="ctr" defTabSz="4889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endParaRPr lang="de-DE" sz="1100" kern="1200">
            <a:latin typeface="Times New Roman" panose="02020603050405020304" pitchFamily="18" charset="0"/>
            <a:cs typeface="Times New Roman" panose="02020603050405020304" pitchFamily="18" charset="0"/>
          </a:endParaRPr>
        </a:p>
      </dsp:txBody>
      <dsp:txXfrm>
        <a:off x="-2034725" y="2980012"/>
        <a:ext cx="11763107" cy="37257"/>
      </dsp:txXfrm>
    </dsp:sp>
    <dsp:sp modelId="{D7C3B540-AAE3-47B6-8689-6F42331FBB0D}">
      <dsp:nvSpPr>
        <dsp:cNvPr id="0" name=""/>
        <dsp:cNvSpPr/>
      </dsp:nvSpPr>
      <dsp:spPr>
        <a:xfrm>
          <a:off x="4151489" y="3117443"/>
          <a:ext cx="1752058" cy="191320"/>
        </a:xfrm>
        <a:prstGeom prst="roundRect">
          <a:avLst>
            <a:gd name="adj" fmla="val 10000"/>
          </a:avLst>
        </a:prstGeom>
        <a:solidFill>
          <a:schemeClr val="lt1"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dk1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7620" tIns="7620" rIns="7620" bIns="7620" numCol="1" spcCol="1270" anchor="ctr" anchorCtr="0">
          <a:noAutofit/>
        </a:bodyPr>
        <a:lstStyle/>
        <a:p>
          <a:pPr marL="0" lvl="0" indent="0" algn="ctr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de-DE" sz="1200" kern="1200">
              <a:latin typeface="Times New Roman" panose="02020603050405020304" pitchFamily="18" charset="0"/>
              <a:cs typeface="Times New Roman" panose="02020603050405020304" pitchFamily="18" charset="0"/>
            </a:rPr>
            <a:t>Treatment </a:t>
          </a:r>
          <a:r>
            <a:rPr lang="de-DE" sz="1200" kern="1200" err="1">
              <a:latin typeface="Times New Roman" panose="02020603050405020304" pitchFamily="18" charset="0"/>
              <a:cs typeface="Times New Roman" panose="02020603050405020304" pitchFamily="18" charset="0"/>
            </a:rPr>
            <a:t>myths</a:t>
          </a:r>
          <a:endParaRPr lang="de-DE" sz="1200" kern="1200">
            <a:latin typeface="Times New Roman" panose="02020603050405020304" pitchFamily="18" charset="0"/>
            <a:cs typeface="Times New Roman" panose="02020603050405020304" pitchFamily="18" charset="0"/>
          </a:endParaRPr>
        </a:p>
      </dsp:txBody>
      <dsp:txXfrm>
        <a:off x="4157093" y="3123047"/>
        <a:ext cx="1740850" cy="180112"/>
      </dsp:txXfrm>
    </dsp:sp>
    <dsp:sp modelId="{91683DB7-5821-4F63-939D-8271AEDB1AC2}">
      <dsp:nvSpPr>
        <dsp:cNvPr id="0" name=""/>
        <dsp:cNvSpPr/>
      </dsp:nvSpPr>
      <dsp:spPr>
        <a:xfrm rot="3667017">
          <a:off x="991180" y="3683983"/>
          <a:ext cx="1097277" cy="2246"/>
        </a:xfrm>
        <a:custGeom>
          <a:avLst/>
          <a:gdLst/>
          <a:ahLst/>
          <a:cxnLst/>
          <a:rect l="0" t="0" r="0" b="0"/>
          <a:pathLst>
            <a:path>
              <a:moveTo>
                <a:pt x="0" y="1123"/>
              </a:moveTo>
              <a:lnTo>
                <a:pt x="1097277" y="1123"/>
              </a:lnTo>
            </a:path>
          </a:pathLst>
        </a:custGeom>
        <a:noFill/>
        <a:ln w="12700" cap="flat" cmpd="sng" algn="ctr">
          <a:solidFill>
            <a:schemeClr val="dk1">
              <a:shade val="6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2700" tIns="0" rIns="12700" bIns="0" numCol="1" spcCol="1270" anchor="ctr" anchorCtr="0">
          <a:noAutofit/>
        </a:bodyPr>
        <a:lstStyle/>
        <a:p>
          <a:pPr marL="0" lvl="0" indent="0" algn="ctr" defTabSz="4889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endParaRPr lang="de-DE" sz="1100" kern="1200">
            <a:latin typeface="Times New Roman" panose="02020603050405020304" pitchFamily="18" charset="0"/>
            <a:cs typeface="Times New Roman" panose="02020603050405020304" pitchFamily="18" charset="0"/>
          </a:endParaRPr>
        </a:p>
      </dsp:txBody>
      <dsp:txXfrm>
        <a:off x="-4341734" y="3657674"/>
        <a:ext cx="11763107" cy="54863"/>
      </dsp:txXfrm>
    </dsp:sp>
    <dsp:sp modelId="{DDCB18A7-5217-498E-8109-AEC8891AEF63}">
      <dsp:nvSpPr>
        <dsp:cNvPr id="0" name=""/>
        <dsp:cNvSpPr/>
      </dsp:nvSpPr>
      <dsp:spPr>
        <a:xfrm>
          <a:off x="1804824" y="4064848"/>
          <a:ext cx="1736719" cy="201301"/>
        </a:xfrm>
        <a:prstGeom prst="roundRect">
          <a:avLst>
            <a:gd name="adj" fmla="val 10000"/>
          </a:avLst>
        </a:prstGeom>
        <a:solidFill>
          <a:schemeClr val="lt1"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dk1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7620" tIns="7620" rIns="7620" bIns="7620" numCol="1" spcCol="1270" anchor="ctr" anchorCtr="0">
          <a:noAutofit/>
        </a:bodyPr>
        <a:lstStyle/>
        <a:p>
          <a:pPr marL="0" lvl="0" indent="0" algn="ctr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de-DE" sz="1200" kern="1200" dirty="0">
              <a:latin typeface="Times New Roman" panose="02020603050405020304" pitchFamily="18" charset="0"/>
              <a:cs typeface="Times New Roman" panose="02020603050405020304" pitchFamily="18" charset="0"/>
            </a:rPr>
            <a:t>The</a:t>
          </a:r>
          <a:r>
            <a:rPr lang="de-DE" sz="1200" kern="1200" baseline="0" dirty="0">
              <a:latin typeface="Times New Roman" panose="02020603050405020304" pitchFamily="18" charset="0"/>
              <a:cs typeface="Times New Roman" panose="02020603050405020304" pitchFamily="18" charset="0"/>
            </a:rPr>
            <a:t> </a:t>
          </a:r>
          <a:r>
            <a:rPr lang="de-DE" sz="1200" kern="1200" baseline="0" dirty="0" err="1">
              <a:latin typeface="Times New Roman" panose="02020603050405020304" pitchFamily="18" charset="0"/>
              <a:cs typeface="Times New Roman" panose="02020603050405020304" pitchFamily="18" charset="0"/>
            </a:rPr>
            <a:t>Interventions</a:t>
          </a:r>
          <a:endParaRPr lang="de-DE" sz="1200" kern="1200" dirty="0">
            <a:latin typeface="Times New Roman" panose="02020603050405020304" pitchFamily="18" charset="0"/>
            <a:cs typeface="Times New Roman" panose="02020603050405020304" pitchFamily="18" charset="0"/>
          </a:endParaRPr>
        </a:p>
      </dsp:txBody>
      <dsp:txXfrm>
        <a:off x="1810720" y="4070744"/>
        <a:ext cx="1724927" cy="189509"/>
      </dsp:txXfrm>
    </dsp:sp>
    <dsp:sp modelId="{87C9AC31-CDDE-4E1F-B79F-69064C460489}">
      <dsp:nvSpPr>
        <dsp:cNvPr id="0" name=""/>
        <dsp:cNvSpPr/>
      </dsp:nvSpPr>
      <dsp:spPr>
        <a:xfrm rot="20499918">
          <a:off x="3447096" y="3579123"/>
          <a:ext cx="3720999" cy="2246"/>
        </a:xfrm>
        <a:custGeom>
          <a:avLst/>
          <a:gdLst/>
          <a:ahLst/>
          <a:cxnLst/>
          <a:rect l="0" t="0" r="0" b="0"/>
          <a:pathLst>
            <a:path>
              <a:moveTo>
                <a:pt x="0" y="1123"/>
              </a:moveTo>
              <a:lnTo>
                <a:pt x="3720999" y="1123"/>
              </a:lnTo>
            </a:path>
          </a:pathLst>
        </a:custGeom>
        <a:noFill/>
        <a:ln w="12700" cap="flat" cmpd="sng" algn="ctr">
          <a:solidFill>
            <a:schemeClr val="dk1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2700" tIns="0" rIns="12700" bIns="0" numCol="1" spcCol="1270" anchor="ctr" anchorCtr="0">
          <a:noAutofit/>
        </a:bodyPr>
        <a:lstStyle/>
        <a:p>
          <a:pPr marL="0" lvl="0" indent="0" algn="ctr" defTabSz="4889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endParaRPr lang="de-DE" sz="1100" kern="1200">
            <a:latin typeface="Times New Roman" panose="02020603050405020304" pitchFamily="18" charset="0"/>
            <a:cs typeface="Times New Roman" panose="02020603050405020304" pitchFamily="18" charset="0"/>
          </a:endParaRPr>
        </a:p>
      </dsp:txBody>
      <dsp:txXfrm>
        <a:off x="-573957" y="3487221"/>
        <a:ext cx="11763107" cy="186049"/>
      </dsp:txXfrm>
    </dsp:sp>
    <dsp:sp modelId="{BD9D8B61-1FCA-4DBF-95E6-59B9130798B9}">
      <dsp:nvSpPr>
        <dsp:cNvPr id="0" name=""/>
        <dsp:cNvSpPr/>
      </dsp:nvSpPr>
      <dsp:spPr>
        <a:xfrm>
          <a:off x="7073647" y="2893157"/>
          <a:ext cx="1979999" cy="203672"/>
        </a:xfrm>
        <a:prstGeom prst="roundRect">
          <a:avLst>
            <a:gd name="adj" fmla="val 10000"/>
          </a:avLst>
        </a:prstGeom>
        <a:solidFill>
          <a:schemeClr val="lt1"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dk1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7620" tIns="7620" rIns="7620" bIns="7620" numCol="1" spcCol="1270" anchor="ctr" anchorCtr="0">
          <a:noAutofit/>
        </a:bodyPr>
        <a:lstStyle/>
        <a:p>
          <a:pPr marL="0" lvl="0" indent="0" algn="ctr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de-DE" sz="1200" kern="1200" err="1">
              <a:latin typeface="Times New Roman" panose="02020603050405020304" pitchFamily="18" charset="0"/>
              <a:cs typeface="Times New Roman" panose="02020603050405020304" pitchFamily="18" charset="0"/>
            </a:rPr>
            <a:t>Testing</a:t>
          </a:r>
          <a:endParaRPr lang="de-DE" sz="1200" kern="1200">
            <a:latin typeface="Times New Roman" panose="02020603050405020304" pitchFamily="18" charset="0"/>
            <a:cs typeface="Times New Roman" panose="02020603050405020304" pitchFamily="18" charset="0"/>
          </a:endParaRPr>
        </a:p>
      </dsp:txBody>
      <dsp:txXfrm>
        <a:off x="7079612" y="2899122"/>
        <a:ext cx="1968069" cy="191742"/>
      </dsp:txXfrm>
    </dsp:sp>
    <dsp:sp modelId="{56FAFC49-D0EA-4E25-8D48-7123A498BD9B}">
      <dsp:nvSpPr>
        <dsp:cNvPr id="0" name=""/>
        <dsp:cNvSpPr/>
      </dsp:nvSpPr>
      <dsp:spPr>
        <a:xfrm rot="20714644">
          <a:off x="3481353" y="3699532"/>
          <a:ext cx="3650094" cy="2246"/>
        </a:xfrm>
        <a:custGeom>
          <a:avLst/>
          <a:gdLst/>
          <a:ahLst/>
          <a:cxnLst/>
          <a:rect l="0" t="0" r="0" b="0"/>
          <a:pathLst>
            <a:path>
              <a:moveTo>
                <a:pt x="0" y="1123"/>
              </a:moveTo>
              <a:lnTo>
                <a:pt x="3650094" y="1123"/>
              </a:lnTo>
            </a:path>
          </a:pathLst>
        </a:custGeom>
        <a:noFill/>
        <a:ln w="12700" cap="flat" cmpd="sng" algn="ctr">
          <a:solidFill>
            <a:schemeClr val="dk1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2700" tIns="0" rIns="12700" bIns="0" numCol="1" spcCol="1270" anchor="ctr" anchorCtr="0">
          <a:noAutofit/>
        </a:bodyPr>
        <a:lstStyle/>
        <a:p>
          <a:pPr marL="0" lvl="0" indent="0" algn="ctr" defTabSz="4889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endParaRPr lang="de-DE" sz="1100" kern="1200">
            <a:latin typeface="Times New Roman" panose="02020603050405020304" pitchFamily="18" charset="0"/>
            <a:cs typeface="Times New Roman" panose="02020603050405020304" pitchFamily="18" charset="0"/>
          </a:endParaRPr>
        </a:p>
      </dsp:txBody>
      <dsp:txXfrm>
        <a:off x="-575152" y="3609403"/>
        <a:ext cx="11763107" cy="182504"/>
      </dsp:txXfrm>
    </dsp:sp>
    <dsp:sp modelId="{E730F18F-48B0-4E0B-9A8D-D539E63CE9D4}">
      <dsp:nvSpPr>
        <dsp:cNvPr id="0" name=""/>
        <dsp:cNvSpPr/>
      </dsp:nvSpPr>
      <dsp:spPr>
        <a:xfrm>
          <a:off x="7071257" y="3127812"/>
          <a:ext cx="1979999" cy="216000"/>
        </a:xfrm>
        <a:prstGeom prst="roundRect">
          <a:avLst>
            <a:gd name="adj" fmla="val 10000"/>
          </a:avLst>
        </a:prstGeom>
        <a:solidFill>
          <a:schemeClr val="lt1"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dk1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7620" tIns="7620" rIns="7620" bIns="7620" numCol="1" spcCol="1270" anchor="ctr" anchorCtr="0">
          <a:noAutofit/>
        </a:bodyPr>
        <a:lstStyle/>
        <a:p>
          <a:pPr marL="0" lvl="0" indent="0" algn="ctr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de-DE" sz="1200" kern="1200">
              <a:latin typeface="Times New Roman" panose="02020603050405020304" pitchFamily="18" charset="0"/>
              <a:cs typeface="Times New Roman" panose="02020603050405020304" pitchFamily="18" charset="0"/>
            </a:rPr>
            <a:t>Supportive care</a:t>
          </a:r>
        </a:p>
      </dsp:txBody>
      <dsp:txXfrm>
        <a:off x="7077583" y="3134138"/>
        <a:ext cx="1967347" cy="203348"/>
      </dsp:txXfrm>
    </dsp:sp>
    <dsp:sp modelId="{04B5A4E1-0824-444B-B0DF-49A3641E7799}">
      <dsp:nvSpPr>
        <dsp:cNvPr id="0" name=""/>
        <dsp:cNvSpPr/>
      </dsp:nvSpPr>
      <dsp:spPr>
        <a:xfrm rot="979001">
          <a:off x="9043076" y="3291752"/>
          <a:ext cx="406223" cy="2246"/>
        </a:xfrm>
        <a:custGeom>
          <a:avLst/>
          <a:gdLst/>
          <a:ahLst/>
          <a:cxnLst/>
          <a:rect l="0" t="0" r="0" b="0"/>
          <a:pathLst>
            <a:path>
              <a:moveTo>
                <a:pt x="0" y="1123"/>
              </a:moveTo>
              <a:lnTo>
                <a:pt x="406223" y="1123"/>
              </a:lnTo>
            </a:path>
          </a:pathLst>
        </a:custGeom>
        <a:noFill/>
        <a:ln w="12700" cap="flat" cmpd="sng" algn="ctr">
          <a:solidFill>
            <a:schemeClr val="dk1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2700" tIns="0" rIns="12700" bIns="0" numCol="1" spcCol="1270" anchor="ctr" anchorCtr="0">
          <a:noAutofit/>
        </a:bodyPr>
        <a:lstStyle/>
        <a:p>
          <a:pPr marL="0" lvl="0" indent="0" algn="ctr" defTabSz="4889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endParaRPr lang="de-DE" sz="1100" kern="1200">
            <a:latin typeface="Times New Roman" panose="02020603050405020304" pitchFamily="18" charset="0"/>
            <a:cs typeface="Times New Roman" panose="02020603050405020304" pitchFamily="18" charset="0"/>
          </a:endParaRPr>
        </a:p>
      </dsp:txBody>
      <dsp:txXfrm>
        <a:off x="3364634" y="3282720"/>
        <a:ext cx="11763107" cy="20311"/>
      </dsp:txXfrm>
    </dsp:sp>
    <dsp:sp modelId="{4DCF8B3D-4AC6-4BA4-83D6-71D9BD5CEED2}">
      <dsp:nvSpPr>
        <dsp:cNvPr id="0" name=""/>
        <dsp:cNvSpPr/>
      </dsp:nvSpPr>
      <dsp:spPr>
        <a:xfrm>
          <a:off x="9441118" y="3254324"/>
          <a:ext cx="1980001" cy="191229"/>
        </a:xfrm>
        <a:prstGeom prst="roundRect">
          <a:avLst>
            <a:gd name="adj" fmla="val 10000"/>
          </a:avLst>
        </a:prstGeom>
        <a:solidFill>
          <a:schemeClr val="lt1"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dk1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7620" tIns="7620" rIns="7620" bIns="7620" numCol="1" spcCol="1270" anchor="ctr" anchorCtr="0">
          <a:noAutofit/>
        </a:bodyPr>
        <a:lstStyle/>
        <a:p>
          <a:pPr marL="0" lvl="0" indent="0" algn="ctr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de-DE" sz="1200" kern="1200" dirty="0">
              <a:latin typeface="Times New Roman" panose="02020603050405020304" pitchFamily="18" charset="0"/>
              <a:cs typeface="Times New Roman" panose="02020603050405020304" pitchFamily="18" charset="0"/>
            </a:rPr>
            <a:t>Health care</a:t>
          </a:r>
        </a:p>
      </dsp:txBody>
      <dsp:txXfrm>
        <a:off x="9446719" y="3259925"/>
        <a:ext cx="1968799" cy="180027"/>
      </dsp:txXfrm>
    </dsp:sp>
    <dsp:sp modelId="{4422E06E-D77E-4F56-8840-95885C852043}">
      <dsp:nvSpPr>
        <dsp:cNvPr id="0" name=""/>
        <dsp:cNvSpPr/>
      </dsp:nvSpPr>
      <dsp:spPr>
        <a:xfrm rot="20556123">
          <a:off x="9041936" y="3173772"/>
          <a:ext cx="407461" cy="2246"/>
        </a:xfrm>
        <a:custGeom>
          <a:avLst/>
          <a:gdLst/>
          <a:ahLst/>
          <a:cxnLst/>
          <a:rect l="0" t="0" r="0" b="0"/>
          <a:pathLst>
            <a:path>
              <a:moveTo>
                <a:pt x="0" y="1123"/>
              </a:moveTo>
              <a:lnTo>
                <a:pt x="407461" y="1123"/>
              </a:lnTo>
            </a:path>
          </a:pathLst>
        </a:custGeom>
        <a:noFill/>
        <a:ln w="12700" cap="flat" cmpd="sng" algn="ctr">
          <a:solidFill>
            <a:schemeClr val="dk1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2700" tIns="0" rIns="12700" bIns="0" numCol="1" spcCol="1270" anchor="ctr" anchorCtr="0">
          <a:noAutofit/>
        </a:bodyPr>
        <a:lstStyle/>
        <a:p>
          <a:pPr marL="0" lvl="0" indent="0" algn="ctr" defTabSz="4889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endParaRPr lang="de-DE" sz="1100" kern="1200">
            <a:latin typeface="Times New Roman" panose="02020603050405020304" pitchFamily="18" charset="0"/>
            <a:cs typeface="Times New Roman" panose="02020603050405020304" pitchFamily="18" charset="0"/>
          </a:endParaRPr>
        </a:p>
      </dsp:txBody>
      <dsp:txXfrm>
        <a:off x="3364113" y="3164709"/>
        <a:ext cx="11763107" cy="20373"/>
      </dsp:txXfrm>
    </dsp:sp>
    <dsp:sp modelId="{63E06D80-B4DA-4AF5-B318-48676A80383C}">
      <dsp:nvSpPr>
        <dsp:cNvPr id="0" name=""/>
        <dsp:cNvSpPr/>
      </dsp:nvSpPr>
      <dsp:spPr>
        <a:xfrm>
          <a:off x="9440077" y="3018363"/>
          <a:ext cx="1980001" cy="191230"/>
        </a:xfrm>
        <a:prstGeom prst="roundRect">
          <a:avLst>
            <a:gd name="adj" fmla="val 10000"/>
          </a:avLst>
        </a:prstGeom>
        <a:solidFill>
          <a:schemeClr val="lt1"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dk1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7620" tIns="7620" rIns="7620" bIns="7620" numCol="1" spcCol="1270" anchor="ctr" anchorCtr="0">
          <a:noAutofit/>
        </a:bodyPr>
        <a:lstStyle/>
        <a:p>
          <a:pPr marL="0" lvl="0" indent="0" algn="ctr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de-DE" sz="1200" kern="1200" dirty="0">
              <a:latin typeface="Times New Roman" panose="02020603050405020304" pitchFamily="18" charset="0"/>
              <a:cs typeface="Times New Roman" panose="02020603050405020304" pitchFamily="18" charset="0"/>
            </a:rPr>
            <a:t>Health care </a:t>
          </a:r>
          <a:r>
            <a:rPr lang="de-DE" sz="1200" kern="1200" dirty="0" err="1">
              <a:latin typeface="Times New Roman" panose="02020603050405020304" pitchFamily="18" charset="0"/>
              <a:cs typeface="Times New Roman" panose="02020603050405020304" pitchFamily="18" charset="0"/>
            </a:rPr>
            <a:t>equipment</a:t>
          </a:r>
          <a:endParaRPr lang="de-DE" sz="1200" kern="1200" dirty="0">
            <a:latin typeface="Times New Roman" panose="02020603050405020304" pitchFamily="18" charset="0"/>
            <a:cs typeface="Times New Roman" panose="02020603050405020304" pitchFamily="18" charset="0"/>
          </a:endParaRPr>
        </a:p>
      </dsp:txBody>
      <dsp:txXfrm>
        <a:off x="9445678" y="3023964"/>
        <a:ext cx="1968799" cy="180028"/>
      </dsp:txXfrm>
    </dsp:sp>
    <dsp:sp modelId="{82D2DBC9-D5F1-41B2-B475-FC62C3A7004B}">
      <dsp:nvSpPr>
        <dsp:cNvPr id="0" name=""/>
        <dsp:cNvSpPr/>
      </dsp:nvSpPr>
      <dsp:spPr>
        <a:xfrm rot="20931019">
          <a:off x="3507605" y="3816663"/>
          <a:ext cx="3596287" cy="2246"/>
        </a:xfrm>
        <a:custGeom>
          <a:avLst/>
          <a:gdLst/>
          <a:ahLst/>
          <a:cxnLst/>
          <a:rect l="0" t="0" r="0" b="0"/>
          <a:pathLst>
            <a:path>
              <a:moveTo>
                <a:pt x="0" y="1123"/>
              </a:moveTo>
              <a:lnTo>
                <a:pt x="3596287" y="1123"/>
              </a:lnTo>
            </a:path>
          </a:pathLst>
        </a:custGeom>
        <a:noFill/>
        <a:ln w="12700" cap="flat" cmpd="sng" algn="ctr">
          <a:solidFill>
            <a:schemeClr val="dk1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2700" tIns="0" rIns="12700" bIns="0" numCol="1" spcCol="1270" anchor="ctr" anchorCtr="0">
          <a:noAutofit/>
        </a:bodyPr>
        <a:lstStyle/>
        <a:p>
          <a:pPr marL="0" lvl="0" indent="0" algn="ctr" defTabSz="4889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endParaRPr lang="de-DE" sz="1100" kern="1200">
            <a:latin typeface="Times New Roman" panose="02020603050405020304" pitchFamily="18" charset="0"/>
            <a:cs typeface="Times New Roman" panose="02020603050405020304" pitchFamily="18" charset="0"/>
          </a:endParaRPr>
        </a:p>
      </dsp:txBody>
      <dsp:txXfrm>
        <a:off x="-575804" y="3727879"/>
        <a:ext cx="11763107" cy="179814"/>
      </dsp:txXfrm>
    </dsp:sp>
    <dsp:sp modelId="{481798CD-BDE5-4B57-B01A-E2CEFF5196BF}">
      <dsp:nvSpPr>
        <dsp:cNvPr id="0" name=""/>
        <dsp:cNvSpPr/>
      </dsp:nvSpPr>
      <dsp:spPr>
        <a:xfrm>
          <a:off x="7069953" y="3368238"/>
          <a:ext cx="1979999" cy="203670"/>
        </a:xfrm>
        <a:prstGeom prst="roundRect">
          <a:avLst>
            <a:gd name="adj" fmla="val 10000"/>
          </a:avLst>
        </a:prstGeom>
        <a:solidFill>
          <a:schemeClr val="lt1"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dk1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7620" tIns="7620" rIns="7620" bIns="7620" numCol="1" spcCol="1270" anchor="ctr" anchorCtr="0">
          <a:noAutofit/>
        </a:bodyPr>
        <a:lstStyle/>
        <a:p>
          <a:pPr marL="0" lvl="0" indent="0" algn="ctr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de-DE" sz="1200" kern="1200">
              <a:latin typeface="Times New Roman" panose="02020603050405020304" pitchFamily="18" charset="0"/>
              <a:cs typeface="Times New Roman" panose="02020603050405020304" pitchFamily="18" charset="0"/>
            </a:rPr>
            <a:t>Personal </a:t>
          </a:r>
          <a:r>
            <a:rPr lang="de-DE" sz="1200" kern="1200" err="1">
              <a:latin typeface="Times New Roman" panose="02020603050405020304" pitchFamily="18" charset="0"/>
              <a:cs typeface="Times New Roman" panose="02020603050405020304" pitchFamily="18" charset="0"/>
            </a:rPr>
            <a:t>measures</a:t>
          </a:r>
          <a:endParaRPr lang="de-DE" sz="1200" kern="1200">
            <a:latin typeface="Times New Roman" panose="02020603050405020304" pitchFamily="18" charset="0"/>
            <a:cs typeface="Times New Roman" panose="02020603050405020304" pitchFamily="18" charset="0"/>
          </a:endParaRPr>
        </a:p>
      </dsp:txBody>
      <dsp:txXfrm>
        <a:off x="7075918" y="3374203"/>
        <a:ext cx="1968069" cy="191740"/>
      </dsp:txXfrm>
    </dsp:sp>
    <dsp:sp modelId="{22457488-96D2-492A-A67D-1DA42B35C92F}">
      <dsp:nvSpPr>
        <dsp:cNvPr id="0" name=""/>
        <dsp:cNvSpPr/>
      </dsp:nvSpPr>
      <dsp:spPr>
        <a:xfrm rot="21155055">
          <a:off x="3526622" y="3934118"/>
          <a:ext cx="3567994" cy="2246"/>
        </a:xfrm>
        <a:custGeom>
          <a:avLst/>
          <a:gdLst/>
          <a:ahLst/>
          <a:cxnLst/>
          <a:rect l="0" t="0" r="0" b="0"/>
          <a:pathLst>
            <a:path>
              <a:moveTo>
                <a:pt x="0" y="1123"/>
              </a:moveTo>
              <a:lnTo>
                <a:pt x="3567994" y="1123"/>
              </a:lnTo>
            </a:path>
          </a:pathLst>
        </a:custGeom>
        <a:noFill/>
        <a:ln w="12700" cap="flat" cmpd="sng" algn="ctr">
          <a:solidFill>
            <a:schemeClr val="dk1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2700" tIns="0" rIns="12700" bIns="0" numCol="1" spcCol="1270" anchor="ctr" anchorCtr="0">
          <a:noAutofit/>
        </a:bodyPr>
        <a:lstStyle/>
        <a:p>
          <a:pPr marL="0" lvl="0" indent="0" algn="ctr" defTabSz="4889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endParaRPr lang="de-DE" sz="1100" kern="1200">
            <a:latin typeface="Times New Roman" panose="02020603050405020304" pitchFamily="18" charset="0"/>
            <a:cs typeface="Times New Roman" panose="02020603050405020304" pitchFamily="18" charset="0"/>
          </a:endParaRPr>
        </a:p>
      </dsp:txBody>
      <dsp:txXfrm>
        <a:off x="-570933" y="3846041"/>
        <a:ext cx="11763107" cy="178399"/>
      </dsp:txXfrm>
    </dsp:sp>
    <dsp:sp modelId="{DC301E58-40D8-4D3D-9A40-BAA0C92BDE59}">
      <dsp:nvSpPr>
        <dsp:cNvPr id="0" name=""/>
        <dsp:cNvSpPr/>
      </dsp:nvSpPr>
      <dsp:spPr>
        <a:xfrm>
          <a:off x="7079694" y="3596984"/>
          <a:ext cx="1979999" cy="216000"/>
        </a:xfrm>
        <a:prstGeom prst="roundRect">
          <a:avLst>
            <a:gd name="adj" fmla="val 10000"/>
          </a:avLst>
        </a:prstGeom>
        <a:solidFill>
          <a:schemeClr val="lt1"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dk1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7620" tIns="7620" rIns="7620" bIns="7620" numCol="1" spcCol="1270" anchor="ctr" anchorCtr="0">
          <a:noAutofit/>
        </a:bodyPr>
        <a:lstStyle/>
        <a:p>
          <a:pPr marL="0" lvl="0" indent="0" algn="ctr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de-DE" sz="1200" kern="1200" dirty="0" err="1">
              <a:latin typeface="Times New Roman" panose="02020603050405020304" pitchFamily="18" charset="0"/>
              <a:cs typeface="Times New Roman" panose="02020603050405020304" pitchFamily="18" charset="0"/>
            </a:rPr>
            <a:t>Measures</a:t>
          </a:r>
          <a:r>
            <a:rPr lang="de-DE" sz="1200" kern="1200" dirty="0">
              <a:latin typeface="Times New Roman" panose="02020603050405020304" pitchFamily="18" charset="0"/>
              <a:cs typeface="Times New Roman" panose="02020603050405020304" pitchFamily="18" charset="0"/>
            </a:rPr>
            <a:t> in public </a:t>
          </a:r>
          <a:r>
            <a:rPr lang="de-DE" sz="1200" kern="1200" dirty="0" err="1">
              <a:latin typeface="Times New Roman" panose="02020603050405020304" pitchFamily="18" charset="0"/>
              <a:cs typeface="Times New Roman" panose="02020603050405020304" pitchFamily="18" charset="0"/>
            </a:rPr>
            <a:t>settings</a:t>
          </a:r>
          <a:endParaRPr lang="de-DE" sz="1200" kern="1200" dirty="0">
            <a:latin typeface="Times New Roman" panose="02020603050405020304" pitchFamily="18" charset="0"/>
            <a:cs typeface="Times New Roman" panose="02020603050405020304" pitchFamily="18" charset="0"/>
          </a:endParaRPr>
        </a:p>
      </dsp:txBody>
      <dsp:txXfrm>
        <a:off x="7086020" y="3603310"/>
        <a:ext cx="1967347" cy="203348"/>
      </dsp:txXfrm>
    </dsp:sp>
    <dsp:sp modelId="{2E231434-ED7F-44D1-8C73-4DA73C333BE6}">
      <dsp:nvSpPr>
        <dsp:cNvPr id="0" name=""/>
        <dsp:cNvSpPr/>
      </dsp:nvSpPr>
      <dsp:spPr>
        <a:xfrm rot="21375334">
          <a:off x="3537769" y="4048871"/>
          <a:ext cx="3537308" cy="2246"/>
        </a:xfrm>
        <a:custGeom>
          <a:avLst/>
          <a:gdLst/>
          <a:ahLst/>
          <a:cxnLst/>
          <a:rect l="0" t="0" r="0" b="0"/>
          <a:pathLst>
            <a:path>
              <a:moveTo>
                <a:pt x="0" y="1123"/>
              </a:moveTo>
              <a:lnTo>
                <a:pt x="3537308" y="1123"/>
              </a:lnTo>
            </a:path>
          </a:pathLst>
        </a:custGeom>
        <a:noFill/>
        <a:ln w="12700" cap="flat" cmpd="sng" algn="ctr">
          <a:solidFill>
            <a:schemeClr val="dk1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2700" tIns="0" rIns="12700" bIns="0" numCol="1" spcCol="1270" anchor="ctr" anchorCtr="0">
          <a:noAutofit/>
        </a:bodyPr>
        <a:lstStyle/>
        <a:p>
          <a:pPr marL="0" lvl="0" indent="0" algn="ctr" defTabSz="4889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endParaRPr lang="de-DE" sz="1100" kern="1200">
            <a:latin typeface="Times New Roman" panose="02020603050405020304" pitchFamily="18" charset="0"/>
            <a:cs typeface="Times New Roman" panose="02020603050405020304" pitchFamily="18" charset="0"/>
          </a:endParaRPr>
        </a:p>
      </dsp:txBody>
      <dsp:txXfrm>
        <a:off x="-575130" y="3961562"/>
        <a:ext cx="11763107" cy="176865"/>
      </dsp:txXfrm>
    </dsp:sp>
    <dsp:sp modelId="{665072C3-8ADE-40C1-BDA5-4FAA68E4319F}">
      <dsp:nvSpPr>
        <dsp:cNvPr id="0" name=""/>
        <dsp:cNvSpPr/>
      </dsp:nvSpPr>
      <dsp:spPr>
        <a:xfrm>
          <a:off x="7071302" y="3832654"/>
          <a:ext cx="1979999" cy="203672"/>
        </a:xfrm>
        <a:prstGeom prst="roundRect">
          <a:avLst>
            <a:gd name="adj" fmla="val 10000"/>
          </a:avLst>
        </a:prstGeom>
        <a:solidFill>
          <a:schemeClr val="lt1"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dk1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7620" tIns="7620" rIns="7620" bIns="7620" numCol="1" spcCol="1270" anchor="ctr" anchorCtr="0">
          <a:noAutofit/>
        </a:bodyPr>
        <a:lstStyle/>
        <a:p>
          <a:pPr marL="0" lvl="0" indent="0" algn="ctr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de-DE" sz="1200" kern="1200" dirty="0" err="1">
              <a:latin typeface="Times New Roman" panose="02020603050405020304" pitchFamily="18" charset="0"/>
              <a:cs typeface="Times New Roman" panose="02020603050405020304" pitchFamily="18" charset="0"/>
            </a:rPr>
            <a:t>Reduction</a:t>
          </a:r>
          <a:r>
            <a:rPr lang="de-DE" sz="1200" kern="1200" dirty="0">
              <a:latin typeface="Times New Roman" panose="02020603050405020304" pitchFamily="18" charset="0"/>
              <a:cs typeface="Times New Roman" panose="02020603050405020304" pitchFamily="18" charset="0"/>
            </a:rPr>
            <a:t> of </a:t>
          </a:r>
          <a:r>
            <a:rPr lang="de-DE" sz="1200" kern="1200" dirty="0" err="1">
              <a:latin typeface="Times New Roman" panose="02020603050405020304" pitchFamily="18" charset="0"/>
              <a:cs typeface="Times New Roman" panose="02020603050405020304" pitchFamily="18" charset="0"/>
            </a:rPr>
            <a:t>movement</a:t>
          </a:r>
          <a:endParaRPr lang="de-DE" sz="1200" kern="1200" dirty="0">
            <a:latin typeface="Times New Roman" panose="02020603050405020304" pitchFamily="18" charset="0"/>
            <a:cs typeface="Times New Roman" panose="02020603050405020304" pitchFamily="18" charset="0"/>
          </a:endParaRPr>
        </a:p>
      </dsp:txBody>
      <dsp:txXfrm>
        <a:off x="7077267" y="3838619"/>
        <a:ext cx="1968069" cy="191742"/>
      </dsp:txXfrm>
    </dsp:sp>
    <dsp:sp modelId="{134D7A88-2D4D-4FE0-A203-5D2DFDE9B8B0}">
      <dsp:nvSpPr>
        <dsp:cNvPr id="0" name=""/>
        <dsp:cNvSpPr/>
      </dsp:nvSpPr>
      <dsp:spPr>
        <a:xfrm rot="7283">
          <a:off x="3541540" y="4168121"/>
          <a:ext cx="3535634" cy="2246"/>
        </a:xfrm>
        <a:custGeom>
          <a:avLst/>
          <a:gdLst/>
          <a:ahLst/>
          <a:cxnLst/>
          <a:rect l="0" t="0" r="0" b="0"/>
          <a:pathLst>
            <a:path>
              <a:moveTo>
                <a:pt x="0" y="1123"/>
              </a:moveTo>
              <a:lnTo>
                <a:pt x="3535634" y="1123"/>
              </a:lnTo>
            </a:path>
          </a:pathLst>
        </a:custGeom>
        <a:noFill/>
        <a:ln w="12700" cap="flat" cmpd="sng" algn="ctr">
          <a:solidFill>
            <a:schemeClr val="dk1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2700" tIns="0" rIns="12700" bIns="0" numCol="1" spcCol="1270" anchor="ctr" anchorCtr="0">
          <a:noAutofit/>
        </a:bodyPr>
        <a:lstStyle/>
        <a:p>
          <a:pPr marL="0" lvl="0" indent="0" algn="ctr" defTabSz="4889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endParaRPr lang="de-DE" sz="1100" kern="1200">
            <a:latin typeface="Times New Roman" panose="02020603050405020304" pitchFamily="18" charset="0"/>
            <a:cs typeface="Times New Roman" panose="02020603050405020304" pitchFamily="18" charset="0"/>
          </a:endParaRPr>
        </a:p>
      </dsp:txBody>
      <dsp:txXfrm>
        <a:off x="-572195" y="4080853"/>
        <a:ext cx="11763107" cy="176781"/>
      </dsp:txXfrm>
    </dsp:sp>
    <dsp:sp modelId="{3E90B72A-F33B-4C19-AA15-D10953CC4340}">
      <dsp:nvSpPr>
        <dsp:cNvPr id="0" name=""/>
        <dsp:cNvSpPr/>
      </dsp:nvSpPr>
      <dsp:spPr>
        <a:xfrm rot="10800000" flipV="1">
          <a:off x="7077171" y="4071152"/>
          <a:ext cx="1979999" cy="203673"/>
        </a:xfrm>
        <a:prstGeom prst="roundRect">
          <a:avLst>
            <a:gd name="adj" fmla="val 10000"/>
          </a:avLst>
        </a:prstGeom>
        <a:solidFill>
          <a:schemeClr val="lt1"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dk1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7620" tIns="7620" rIns="7620" bIns="7620" numCol="1" spcCol="1270" anchor="ctr" anchorCtr="0">
          <a:noAutofit/>
        </a:bodyPr>
        <a:lstStyle/>
        <a:p>
          <a:pPr marL="0" lvl="0" indent="0" algn="ctr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de-DE" sz="1200" kern="1200" err="1">
              <a:latin typeface="Times New Roman" panose="02020603050405020304" pitchFamily="18" charset="0"/>
              <a:cs typeface="Times New Roman" panose="02020603050405020304" pitchFamily="18" charset="0"/>
            </a:rPr>
            <a:t>Protection</a:t>
          </a:r>
          <a:endParaRPr lang="de-DE" sz="1200" kern="1200">
            <a:latin typeface="Times New Roman" panose="02020603050405020304" pitchFamily="18" charset="0"/>
            <a:cs typeface="Times New Roman" panose="02020603050405020304" pitchFamily="18" charset="0"/>
          </a:endParaRPr>
        </a:p>
      </dsp:txBody>
      <dsp:txXfrm rot="-10800000">
        <a:off x="7083136" y="4077117"/>
        <a:ext cx="1968069" cy="191743"/>
      </dsp:txXfrm>
    </dsp:sp>
    <dsp:sp modelId="{CBE2BF13-B4B2-4CCE-B9CD-9C2AE1DB9827}">
      <dsp:nvSpPr>
        <dsp:cNvPr id="0" name=""/>
        <dsp:cNvSpPr/>
      </dsp:nvSpPr>
      <dsp:spPr>
        <a:xfrm rot="234074">
          <a:off x="3537445" y="4284731"/>
          <a:ext cx="3537960" cy="2246"/>
        </a:xfrm>
        <a:custGeom>
          <a:avLst/>
          <a:gdLst/>
          <a:ahLst/>
          <a:cxnLst/>
          <a:rect l="0" t="0" r="0" b="0"/>
          <a:pathLst>
            <a:path>
              <a:moveTo>
                <a:pt x="0" y="1123"/>
              </a:moveTo>
              <a:lnTo>
                <a:pt x="3537960" y="1123"/>
              </a:lnTo>
            </a:path>
          </a:pathLst>
        </a:custGeom>
        <a:noFill/>
        <a:ln w="12700" cap="flat" cmpd="sng" algn="ctr">
          <a:solidFill>
            <a:schemeClr val="dk1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2700" tIns="0" rIns="12700" bIns="0" numCol="1" spcCol="1270" anchor="ctr" anchorCtr="0">
          <a:noAutofit/>
        </a:bodyPr>
        <a:lstStyle/>
        <a:p>
          <a:pPr marL="0" lvl="0" indent="0" algn="ctr" defTabSz="4889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endParaRPr lang="de-DE" sz="1100" kern="1200">
            <a:latin typeface="Times New Roman" panose="02020603050405020304" pitchFamily="18" charset="0"/>
            <a:cs typeface="Times New Roman" panose="02020603050405020304" pitchFamily="18" charset="0"/>
          </a:endParaRPr>
        </a:p>
      </dsp:txBody>
      <dsp:txXfrm>
        <a:off x="-575127" y="4197405"/>
        <a:ext cx="11763107" cy="176898"/>
      </dsp:txXfrm>
    </dsp:sp>
    <dsp:sp modelId="{48E4B145-A01E-4F97-9B06-6C33D2269A47}">
      <dsp:nvSpPr>
        <dsp:cNvPr id="0" name=""/>
        <dsp:cNvSpPr/>
      </dsp:nvSpPr>
      <dsp:spPr>
        <a:xfrm>
          <a:off x="7071306" y="4304375"/>
          <a:ext cx="1979999" cy="203670"/>
        </a:xfrm>
        <a:prstGeom prst="roundRect">
          <a:avLst>
            <a:gd name="adj" fmla="val 10000"/>
          </a:avLst>
        </a:prstGeom>
        <a:solidFill>
          <a:schemeClr val="lt1"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dk1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7620" tIns="7620" rIns="7620" bIns="7620" numCol="1" spcCol="1270" anchor="ctr" anchorCtr="0">
          <a:noAutofit/>
        </a:bodyPr>
        <a:lstStyle/>
        <a:p>
          <a:pPr marL="0" lvl="0" indent="0" algn="ctr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de-DE" sz="1200" kern="1200">
              <a:latin typeface="Times New Roman" panose="02020603050405020304" pitchFamily="18" charset="0"/>
              <a:cs typeface="Times New Roman" panose="02020603050405020304" pitchFamily="18" charset="0"/>
            </a:rPr>
            <a:t>Technology</a:t>
          </a:r>
        </a:p>
      </dsp:txBody>
      <dsp:txXfrm>
        <a:off x="7077271" y="4310340"/>
        <a:ext cx="1968069" cy="191740"/>
      </dsp:txXfrm>
    </dsp:sp>
    <dsp:sp modelId="{92D0DEB7-F9E3-4085-A056-1B4AA5D907F0}">
      <dsp:nvSpPr>
        <dsp:cNvPr id="0" name=""/>
        <dsp:cNvSpPr/>
      </dsp:nvSpPr>
      <dsp:spPr>
        <a:xfrm rot="464703">
          <a:off x="3525307" y="4404239"/>
          <a:ext cx="3559716" cy="2246"/>
        </a:xfrm>
        <a:custGeom>
          <a:avLst/>
          <a:gdLst/>
          <a:ahLst/>
          <a:cxnLst/>
          <a:rect l="0" t="0" r="0" b="0"/>
          <a:pathLst>
            <a:path>
              <a:moveTo>
                <a:pt x="0" y="1123"/>
              </a:moveTo>
              <a:lnTo>
                <a:pt x="3559716" y="1123"/>
              </a:lnTo>
            </a:path>
          </a:pathLst>
        </a:custGeom>
        <a:noFill/>
        <a:ln w="12700" cap="flat" cmpd="sng" algn="ctr">
          <a:solidFill>
            <a:schemeClr val="dk1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2700" tIns="0" rIns="12700" bIns="0" numCol="1" spcCol="1270" anchor="ctr" anchorCtr="0">
          <a:noAutofit/>
        </a:bodyPr>
        <a:lstStyle/>
        <a:p>
          <a:pPr marL="0" lvl="0" indent="0" algn="ctr" defTabSz="4889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endParaRPr lang="de-DE" sz="1100" kern="1200">
            <a:latin typeface="Times New Roman" panose="02020603050405020304" pitchFamily="18" charset="0"/>
            <a:cs typeface="Times New Roman" panose="02020603050405020304" pitchFamily="18" charset="0"/>
          </a:endParaRPr>
        </a:p>
      </dsp:txBody>
      <dsp:txXfrm>
        <a:off x="-576387" y="4316369"/>
        <a:ext cx="11763107" cy="177985"/>
      </dsp:txXfrm>
    </dsp:sp>
    <dsp:sp modelId="{0F72C090-6894-4EAC-91C9-4AB4F7819088}">
      <dsp:nvSpPr>
        <dsp:cNvPr id="0" name=""/>
        <dsp:cNvSpPr/>
      </dsp:nvSpPr>
      <dsp:spPr>
        <a:xfrm>
          <a:off x="7068787" y="4543389"/>
          <a:ext cx="1979999" cy="203672"/>
        </a:xfrm>
        <a:prstGeom prst="roundRect">
          <a:avLst>
            <a:gd name="adj" fmla="val 10000"/>
          </a:avLst>
        </a:prstGeom>
        <a:solidFill>
          <a:schemeClr val="lt1"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dk1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7620" tIns="7620" rIns="7620" bIns="7620" numCol="1" spcCol="1270" anchor="ctr" anchorCtr="0">
          <a:noAutofit/>
        </a:bodyPr>
        <a:lstStyle/>
        <a:p>
          <a:pPr marL="0" lvl="0" indent="0" algn="ctr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de-DE" sz="1200" kern="1200">
              <a:latin typeface="Times New Roman" panose="02020603050405020304" pitchFamily="18" charset="0"/>
              <a:cs typeface="Times New Roman" panose="02020603050405020304" pitchFamily="18" charset="0"/>
            </a:rPr>
            <a:t>Travel</a:t>
          </a:r>
        </a:p>
      </dsp:txBody>
      <dsp:txXfrm>
        <a:off x="7074752" y="4549354"/>
        <a:ext cx="1968069" cy="191742"/>
      </dsp:txXfrm>
    </dsp:sp>
    <dsp:sp modelId="{6AB18905-010D-4722-AD52-A8029684E429}">
      <dsp:nvSpPr>
        <dsp:cNvPr id="0" name=""/>
        <dsp:cNvSpPr/>
      </dsp:nvSpPr>
      <dsp:spPr>
        <a:xfrm rot="694126">
          <a:off x="3504950" y="4525617"/>
          <a:ext cx="3602620" cy="2246"/>
        </a:xfrm>
        <a:custGeom>
          <a:avLst/>
          <a:gdLst/>
          <a:ahLst/>
          <a:cxnLst/>
          <a:rect l="0" t="0" r="0" b="0"/>
          <a:pathLst>
            <a:path>
              <a:moveTo>
                <a:pt x="0" y="1123"/>
              </a:moveTo>
              <a:lnTo>
                <a:pt x="3602620" y="1123"/>
              </a:lnTo>
            </a:path>
          </a:pathLst>
        </a:custGeom>
        <a:noFill/>
        <a:ln w="12700" cap="flat" cmpd="sng" algn="ctr">
          <a:solidFill>
            <a:schemeClr val="dk1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2700" tIns="0" rIns="12700" bIns="0" numCol="1" spcCol="1270" anchor="ctr" anchorCtr="0">
          <a:noAutofit/>
        </a:bodyPr>
        <a:lstStyle/>
        <a:p>
          <a:pPr marL="0" lvl="0" indent="0" algn="ctr" defTabSz="4889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endParaRPr lang="de-DE" sz="1100" kern="1200">
            <a:latin typeface="Times New Roman" panose="02020603050405020304" pitchFamily="18" charset="0"/>
            <a:cs typeface="Times New Roman" panose="02020603050405020304" pitchFamily="18" charset="0"/>
          </a:endParaRPr>
        </a:p>
      </dsp:txBody>
      <dsp:txXfrm>
        <a:off x="-575292" y="4436675"/>
        <a:ext cx="11763107" cy="180131"/>
      </dsp:txXfrm>
    </dsp:sp>
    <dsp:sp modelId="{93ED179E-6CE9-427B-AFAE-295FB95A4083}">
      <dsp:nvSpPr>
        <dsp:cNvPr id="0" name=""/>
        <dsp:cNvSpPr/>
      </dsp:nvSpPr>
      <dsp:spPr>
        <a:xfrm>
          <a:off x="7070976" y="4786146"/>
          <a:ext cx="1979999" cy="203670"/>
        </a:xfrm>
        <a:prstGeom prst="roundRect">
          <a:avLst>
            <a:gd name="adj" fmla="val 10000"/>
          </a:avLst>
        </a:prstGeom>
        <a:solidFill>
          <a:schemeClr val="lt1"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dk1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7620" tIns="7620" rIns="7620" bIns="7620" numCol="1" spcCol="1270" anchor="ctr" anchorCtr="0">
          <a:noAutofit/>
        </a:bodyPr>
        <a:lstStyle/>
        <a:p>
          <a:pPr marL="0" lvl="0" indent="0" algn="ctr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de-DE" sz="1200" kern="1200">
              <a:latin typeface="Times New Roman" panose="02020603050405020304" pitchFamily="18" charset="0"/>
              <a:cs typeface="Times New Roman" panose="02020603050405020304" pitchFamily="18" charset="0"/>
            </a:rPr>
            <a:t>Faith</a:t>
          </a:r>
        </a:p>
      </dsp:txBody>
      <dsp:txXfrm>
        <a:off x="7076941" y="4792111"/>
        <a:ext cx="1968069" cy="191740"/>
      </dsp:txXfrm>
    </dsp:sp>
    <dsp:sp modelId="{B3990D9E-965A-4A87-9024-A31D8C18D9AC}">
      <dsp:nvSpPr>
        <dsp:cNvPr id="0" name=""/>
        <dsp:cNvSpPr/>
      </dsp:nvSpPr>
      <dsp:spPr>
        <a:xfrm rot="914422">
          <a:off x="3477265" y="4644834"/>
          <a:ext cx="3655496" cy="2246"/>
        </a:xfrm>
        <a:custGeom>
          <a:avLst/>
          <a:gdLst/>
          <a:ahLst/>
          <a:cxnLst/>
          <a:rect l="0" t="0" r="0" b="0"/>
          <a:pathLst>
            <a:path>
              <a:moveTo>
                <a:pt x="0" y="1123"/>
              </a:moveTo>
              <a:lnTo>
                <a:pt x="3655496" y="1123"/>
              </a:lnTo>
            </a:path>
          </a:pathLst>
        </a:custGeom>
        <a:noFill/>
        <a:ln w="12700" cap="flat" cmpd="sng" algn="ctr">
          <a:solidFill>
            <a:schemeClr val="dk1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2700" tIns="0" rIns="12700" bIns="0" numCol="1" spcCol="1270" anchor="ctr" anchorCtr="0">
          <a:noAutofit/>
        </a:bodyPr>
        <a:lstStyle/>
        <a:p>
          <a:pPr marL="0" lvl="0" indent="0" algn="ctr" defTabSz="4889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endParaRPr lang="de-DE" sz="1100" kern="1200">
            <a:latin typeface="Times New Roman" panose="02020603050405020304" pitchFamily="18" charset="0"/>
            <a:cs typeface="Times New Roman" panose="02020603050405020304" pitchFamily="18" charset="0"/>
          </a:endParaRPr>
        </a:p>
      </dsp:txBody>
      <dsp:txXfrm>
        <a:off x="-576539" y="4554570"/>
        <a:ext cx="11763107" cy="182774"/>
      </dsp:txXfrm>
    </dsp:sp>
    <dsp:sp modelId="{55C48720-204C-4364-9D3A-54C5764186B5}">
      <dsp:nvSpPr>
        <dsp:cNvPr id="0" name=""/>
        <dsp:cNvSpPr/>
      </dsp:nvSpPr>
      <dsp:spPr>
        <a:xfrm>
          <a:off x="7068482" y="5024580"/>
          <a:ext cx="1979999" cy="203670"/>
        </a:xfrm>
        <a:prstGeom prst="roundRect">
          <a:avLst>
            <a:gd name="adj" fmla="val 10000"/>
          </a:avLst>
        </a:prstGeom>
        <a:solidFill>
          <a:schemeClr val="lt1"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dk1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7620" tIns="7620" rIns="7620" bIns="7620" numCol="1" spcCol="1270" anchor="ctr" anchorCtr="0">
          <a:noAutofit/>
        </a:bodyPr>
        <a:lstStyle/>
        <a:p>
          <a:pPr marL="0" lvl="0" indent="0" algn="ctr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de-DE" sz="1200" kern="1200" err="1">
              <a:latin typeface="Times New Roman" panose="02020603050405020304" pitchFamily="18" charset="0"/>
              <a:cs typeface="Times New Roman" panose="02020603050405020304" pitchFamily="18" charset="0"/>
            </a:rPr>
            <a:t>Unions</a:t>
          </a:r>
          <a:r>
            <a:rPr lang="de-DE" sz="1200" kern="1200" baseline="0">
              <a:latin typeface="Times New Roman" panose="02020603050405020304" pitchFamily="18" charset="0"/>
              <a:cs typeface="Times New Roman" panose="02020603050405020304" pitchFamily="18" charset="0"/>
            </a:rPr>
            <a:t> and </a:t>
          </a:r>
          <a:r>
            <a:rPr lang="de-DE" sz="1200" kern="1200" baseline="0" err="1">
              <a:latin typeface="Times New Roman" panose="02020603050405020304" pitchFamily="18" charset="0"/>
              <a:cs typeface="Times New Roman" panose="02020603050405020304" pitchFamily="18" charset="0"/>
            </a:rPr>
            <a:t>industry</a:t>
          </a:r>
          <a:endParaRPr lang="de-DE" sz="1200" kern="1200">
            <a:latin typeface="Times New Roman" panose="02020603050405020304" pitchFamily="18" charset="0"/>
            <a:cs typeface="Times New Roman" panose="02020603050405020304" pitchFamily="18" charset="0"/>
          </a:endParaRPr>
        </a:p>
      </dsp:txBody>
      <dsp:txXfrm>
        <a:off x="7074447" y="5030545"/>
        <a:ext cx="1968069" cy="191740"/>
      </dsp:txXfrm>
    </dsp:sp>
    <dsp:sp modelId="{77548836-C3C7-4F26-AB2C-7B9D48F92339}">
      <dsp:nvSpPr>
        <dsp:cNvPr id="0" name=""/>
        <dsp:cNvSpPr/>
      </dsp:nvSpPr>
      <dsp:spPr>
        <a:xfrm rot="1123386">
          <a:off x="3442888" y="4762801"/>
          <a:ext cx="3728567" cy="2246"/>
        </a:xfrm>
        <a:custGeom>
          <a:avLst/>
          <a:gdLst/>
          <a:ahLst/>
          <a:cxnLst/>
          <a:rect l="0" t="0" r="0" b="0"/>
          <a:pathLst>
            <a:path>
              <a:moveTo>
                <a:pt x="0" y="1123"/>
              </a:moveTo>
              <a:lnTo>
                <a:pt x="3728567" y="1123"/>
              </a:lnTo>
            </a:path>
          </a:pathLst>
        </a:custGeom>
        <a:noFill/>
        <a:ln w="12700" cap="flat" cmpd="sng" algn="ctr">
          <a:solidFill>
            <a:schemeClr val="dk1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2700" tIns="0" rIns="12700" bIns="0" numCol="1" spcCol="1270" anchor="ctr" anchorCtr="0">
          <a:noAutofit/>
        </a:bodyPr>
        <a:lstStyle/>
        <a:p>
          <a:pPr marL="0" lvl="0" indent="0" algn="ctr" defTabSz="4889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endParaRPr lang="de-DE" sz="1100" kern="1200">
            <a:latin typeface="Times New Roman" panose="02020603050405020304" pitchFamily="18" charset="0"/>
            <a:cs typeface="Times New Roman" panose="02020603050405020304" pitchFamily="18" charset="0"/>
          </a:endParaRPr>
        </a:p>
      </dsp:txBody>
      <dsp:txXfrm>
        <a:off x="-574381" y="4670710"/>
        <a:ext cx="11763107" cy="186428"/>
      </dsp:txXfrm>
    </dsp:sp>
    <dsp:sp modelId="{58A40D43-4424-4837-A5A1-19217FD9A569}">
      <dsp:nvSpPr>
        <dsp:cNvPr id="0" name=""/>
        <dsp:cNvSpPr/>
      </dsp:nvSpPr>
      <dsp:spPr>
        <a:xfrm>
          <a:off x="7072799" y="5260513"/>
          <a:ext cx="1979999" cy="203672"/>
        </a:xfrm>
        <a:prstGeom prst="roundRect">
          <a:avLst>
            <a:gd name="adj" fmla="val 10000"/>
          </a:avLst>
        </a:prstGeom>
        <a:solidFill>
          <a:schemeClr val="lt1"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dk1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7620" tIns="7620" rIns="7620" bIns="7620" numCol="1" spcCol="1270" anchor="ctr" anchorCtr="0">
          <a:noAutofit/>
        </a:bodyPr>
        <a:lstStyle/>
        <a:p>
          <a:pPr marL="0" lvl="0" indent="0" algn="ctr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de-DE" sz="1200" kern="1200" dirty="0">
              <a:latin typeface="Times New Roman" panose="02020603050405020304" pitchFamily="18" charset="0"/>
              <a:cs typeface="Times New Roman" panose="02020603050405020304" pitchFamily="18" charset="0"/>
            </a:rPr>
            <a:t>The </a:t>
          </a:r>
          <a:r>
            <a:rPr lang="de-DE" sz="1200" kern="1200" dirty="0" err="1">
              <a:latin typeface="Times New Roman" panose="02020603050405020304" pitchFamily="18" charset="0"/>
              <a:cs typeface="Times New Roman" panose="02020603050405020304" pitchFamily="18" charset="0"/>
            </a:rPr>
            <a:t>enviroment</a:t>
          </a:r>
          <a:endParaRPr lang="de-DE" sz="1200" kern="1200" dirty="0">
            <a:latin typeface="Times New Roman" panose="02020603050405020304" pitchFamily="18" charset="0"/>
            <a:cs typeface="Times New Roman" panose="02020603050405020304" pitchFamily="18" charset="0"/>
          </a:endParaRPr>
        </a:p>
      </dsp:txBody>
      <dsp:txXfrm>
        <a:off x="7078764" y="5266478"/>
        <a:ext cx="1968069" cy="191742"/>
      </dsp:txXfrm>
    </dsp:sp>
    <dsp:sp modelId="{616D48F1-5BF9-475C-A680-5A4648439758}">
      <dsp:nvSpPr>
        <dsp:cNvPr id="0" name=""/>
        <dsp:cNvSpPr/>
      </dsp:nvSpPr>
      <dsp:spPr>
        <a:xfrm rot="1325934">
          <a:off x="3401720" y="4880408"/>
          <a:ext cx="3806595" cy="2246"/>
        </a:xfrm>
        <a:custGeom>
          <a:avLst/>
          <a:gdLst/>
          <a:ahLst/>
          <a:cxnLst/>
          <a:rect l="0" t="0" r="0" b="0"/>
          <a:pathLst>
            <a:path>
              <a:moveTo>
                <a:pt x="0" y="1123"/>
              </a:moveTo>
              <a:lnTo>
                <a:pt x="3806595" y="1123"/>
              </a:lnTo>
            </a:path>
          </a:pathLst>
        </a:custGeom>
        <a:noFill/>
        <a:ln w="12700" cap="flat" cmpd="sng" algn="ctr">
          <a:solidFill>
            <a:schemeClr val="dk1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2700" tIns="0" rIns="12700" bIns="0" numCol="1" spcCol="1270" anchor="ctr" anchorCtr="0">
          <a:noAutofit/>
        </a:bodyPr>
        <a:lstStyle/>
        <a:p>
          <a:pPr marL="0" lvl="0" indent="0" algn="ctr" defTabSz="4889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endParaRPr lang="de-DE" sz="1100" kern="1200">
            <a:latin typeface="Times New Roman" panose="02020603050405020304" pitchFamily="18" charset="0"/>
            <a:cs typeface="Times New Roman" panose="02020603050405020304" pitchFamily="18" charset="0"/>
          </a:endParaRPr>
        </a:p>
      </dsp:txBody>
      <dsp:txXfrm>
        <a:off x="-576535" y="4786366"/>
        <a:ext cx="11763107" cy="190329"/>
      </dsp:txXfrm>
    </dsp:sp>
    <dsp:sp modelId="{AC865C7C-D34F-4978-B07D-384D670F1E47}">
      <dsp:nvSpPr>
        <dsp:cNvPr id="0" name=""/>
        <dsp:cNvSpPr/>
      </dsp:nvSpPr>
      <dsp:spPr>
        <a:xfrm>
          <a:off x="7068491" y="5495728"/>
          <a:ext cx="1979999" cy="203672"/>
        </a:xfrm>
        <a:prstGeom prst="roundRect">
          <a:avLst>
            <a:gd name="adj" fmla="val 10000"/>
          </a:avLst>
        </a:prstGeom>
        <a:solidFill>
          <a:schemeClr val="lt1"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dk1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7620" tIns="7620" rIns="7620" bIns="7620" numCol="1" spcCol="1270" anchor="ctr" anchorCtr="0">
          <a:noAutofit/>
        </a:bodyPr>
        <a:lstStyle/>
        <a:p>
          <a:pPr marL="0" lvl="0" indent="0" algn="ctr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de-DE" sz="1200" kern="1200" err="1">
              <a:latin typeface="Times New Roman" panose="02020603050405020304" pitchFamily="18" charset="0"/>
              <a:cs typeface="Times New Roman" panose="02020603050405020304" pitchFamily="18" charset="0"/>
            </a:rPr>
            <a:t>Inequalities</a:t>
          </a:r>
          <a:endParaRPr lang="de-DE" sz="1200" kern="1200">
            <a:latin typeface="Times New Roman" panose="02020603050405020304" pitchFamily="18" charset="0"/>
            <a:cs typeface="Times New Roman" panose="02020603050405020304" pitchFamily="18" charset="0"/>
          </a:endParaRPr>
        </a:p>
      </dsp:txBody>
      <dsp:txXfrm>
        <a:off x="7074456" y="5501693"/>
        <a:ext cx="1968069" cy="191742"/>
      </dsp:txXfrm>
    </dsp:sp>
    <dsp:sp modelId="{0534A5B7-9C7A-4B37-8658-B389BC363051}">
      <dsp:nvSpPr>
        <dsp:cNvPr id="0" name=""/>
        <dsp:cNvSpPr/>
      </dsp:nvSpPr>
      <dsp:spPr>
        <a:xfrm rot="1519313">
          <a:off x="3354184" y="4998410"/>
          <a:ext cx="3900065" cy="2246"/>
        </a:xfrm>
        <a:custGeom>
          <a:avLst/>
          <a:gdLst/>
          <a:ahLst/>
          <a:cxnLst/>
          <a:rect l="0" t="0" r="0" b="0"/>
          <a:pathLst>
            <a:path>
              <a:moveTo>
                <a:pt x="0" y="1123"/>
              </a:moveTo>
              <a:lnTo>
                <a:pt x="3900065" y="1123"/>
              </a:lnTo>
            </a:path>
          </a:pathLst>
        </a:custGeom>
        <a:noFill/>
        <a:ln w="12700" cap="flat" cmpd="sng" algn="ctr">
          <a:solidFill>
            <a:schemeClr val="dk1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2700" tIns="0" rIns="12700" bIns="0" numCol="1" spcCol="1270" anchor="ctr" anchorCtr="0">
          <a:noAutofit/>
        </a:bodyPr>
        <a:lstStyle/>
        <a:p>
          <a:pPr marL="0" lvl="0" indent="0" algn="ctr" defTabSz="4889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endParaRPr lang="de-DE" sz="1100" kern="1200">
            <a:latin typeface="Times New Roman" panose="02020603050405020304" pitchFamily="18" charset="0"/>
            <a:cs typeface="Times New Roman" panose="02020603050405020304" pitchFamily="18" charset="0"/>
          </a:endParaRPr>
        </a:p>
      </dsp:txBody>
      <dsp:txXfrm>
        <a:off x="-577336" y="4902032"/>
        <a:ext cx="11763107" cy="195003"/>
      </dsp:txXfrm>
    </dsp:sp>
    <dsp:sp modelId="{4B059EDE-FDEA-4C68-BB44-42AF88AE4840}">
      <dsp:nvSpPr>
        <dsp:cNvPr id="0" name=""/>
        <dsp:cNvSpPr/>
      </dsp:nvSpPr>
      <dsp:spPr>
        <a:xfrm>
          <a:off x="7066888" y="5731733"/>
          <a:ext cx="1979999" cy="203672"/>
        </a:xfrm>
        <a:prstGeom prst="roundRect">
          <a:avLst>
            <a:gd name="adj" fmla="val 10000"/>
          </a:avLst>
        </a:prstGeom>
        <a:solidFill>
          <a:schemeClr val="lt1"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dk1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7620" tIns="7620" rIns="7620" bIns="7620" numCol="1" spcCol="1270" anchor="ctr" anchorCtr="0">
          <a:noAutofit/>
        </a:bodyPr>
        <a:lstStyle/>
        <a:p>
          <a:pPr marL="0" lvl="0" indent="0" algn="ctr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de-DE" sz="1200" kern="1200" err="1">
              <a:latin typeface="Times New Roman" panose="02020603050405020304" pitchFamily="18" charset="0"/>
              <a:cs typeface="Times New Roman" panose="02020603050405020304" pitchFamily="18" charset="0"/>
            </a:rPr>
            <a:t>Civil</a:t>
          </a:r>
          <a:r>
            <a:rPr lang="de-DE" sz="1200" kern="1200">
              <a:latin typeface="Times New Roman" panose="02020603050405020304" pitchFamily="18" charset="0"/>
              <a:cs typeface="Times New Roman" panose="02020603050405020304" pitchFamily="18" charset="0"/>
            </a:rPr>
            <a:t> </a:t>
          </a:r>
          <a:r>
            <a:rPr lang="de-DE" sz="1200" kern="1200" err="1">
              <a:latin typeface="Times New Roman" panose="02020603050405020304" pitchFamily="18" charset="0"/>
              <a:cs typeface="Times New Roman" panose="02020603050405020304" pitchFamily="18" charset="0"/>
            </a:rPr>
            <a:t>unrest</a:t>
          </a:r>
          <a:endParaRPr lang="de-DE" sz="1200" kern="1200">
            <a:latin typeface="Times New Roman" panose="02020603050405020304" pitchFamily="18" charset="0"/>
            <a:cs typeface="Times New Roman" panose="02020603050405020304" pitchFamily="18" charset="0"/>
          </a:endParaRPr>
        </a:p>
      </dsp:txBody>
      <dsp:txXfrm>
        <a:off x="7072853" y="5737698"/>
        <a:ext cx="1968069" cy="191742"/>
      </dsp:txXfrm>
    </dsp:sp>
    <dsp:sp modelId="{06162D70-667D-4321-A2A5-50E71EC54502}">
      <dsp:nvSpPr>
        <dsp:cNvPr id="0" name=""/>
        <dsp:cNvSpPr/>
      </dsp:nvSpPr>
      <dsp:spPr>
        <a:xfrm rot="4603426">
          <a:off x="354868" y="4365860"/>
          <a:ext cx="2388370" cy="2246"/>
        </a:xfrm>
        <a:custGeom>
          <a:avLst/>
          <a:gdLst/>
          <a:ahLst/>
          <a:cxnLst/>
          <a:rect l="0" t="0" r="0" b="0"/>
          <a:pathLst>
            <a:path>
              <a:moveTo>
                <a:pt x="0" y="1123"/>
              </a:moveTo>
              <a:lnTo>
                <a:pt x="2388370" y="1123"/>
              </a:lnTo>
            </a:path>
          </a:pathLst>
        </a:custGeom>
        <a:noFill/>
        <a:ln w="12700" cap="flat" cmpd="sng" algn="ctr">
          <a:solidFill>
            <a:schemeClr val="dk1">
              <a:shade val="6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2700" tIns="0" rIns="12700" bIns="0" numCol="1" spcCol="1270" anchor="ctr" anchorCtr="0">
          <a:noAutofit/>
        </a:bodyPr>
        <a:lstStyle/>
        <a:p>
          <a:pPr marL="0" lvl="0" indent="0" algn="ctr" defTabSz="4889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endParaRPr lang="de-DE" sz="1100" kern="1200">
            <a:latin typeface="Times New Roman" panose="02020603050405020304" pitchFamily="18" charset="0"/>
            <a:cs typeface="Times New Roman" panose="02020603050405020304" pitchFamily="18" charset="0"/>
          </a:endParaRPr>
        </a:p>
      </dsp:txBody>
      <dsp:txXfrm>
        <a:off x="-4332499" y="4307274"/>
        <a:ext cx="11763107" cy="119418"/>
      </dsp:txXfrm>
    </dsp:sp>
    <dsp:sp modelId="{DDF72957-287B-449A-A1C9-C4F10755C0F8}">
      <dsp:nvSpPr>
        <dsp:cNvPr id="0" name=""/>
        <dsp:cNvSpPr/>
      </dsp:nvSpPr>
      <dsp:spPr>
        <a:xfrm>
          <a:off x="1823293" y="5428602"/>
          <a:ext cx="1736719" cy="201301"/>
        </a:xfrm>
        <a:prstGeom prst="roundRect">
          <a:avLst>
            <a:gd name="adj" fmla="val 10000"/>
          </a:avLst>
        </a:prstGeom>
        <a:solidFill>
          <a:schemeClr val="lt1"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dk1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7620" tIns="7620" rIns="7620" bIns="7620" numCol="1" spcCol="1270" anchor="ctr" anchorCtr="0">
          <a:noAutofit/>
        </a:bodyPr>
        <a:lstStyle/>
        <a:p>
          <a:pPr marL="0" lvl="0" indent="0" algn="ctr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de-DE" sz="1200" kern="1200" dirty="0">
              <a:latin typeface="Times New Roman" panose="02020603050405020304" pitchFamily="18" charset="0"/>
              <a:cs typeface="Times New Roman" panose="02020603050405020304" pitchFamily="18" charset="0"/>
            </a:rPr>
            <a:t>Information</a:t>
          </a:r>
        </a:p>
      </dsp:txBody>
      <dsp:txXfrm>
        <a:off x="1829189" y="5434498"/>
        <a:ext cx="1724927" cy="189509"/>
      </dsp:txXfrm>
    </dsp:sp>
    <dsp:sp modelId="{39CD6B7A-D9CD-49C5-B1C3-2BF6CA65E035}">
      <dsp:nvSpPr>
        <dsp:cNvPr id="0" name=""/>
        <dsp:cNvSpPr/>
      </dsp:nvSpPr>
      <dsp:spPr>
        <a:xfrm rot="20904457">
          <a:off x="3554375" y="5472588"/>
          <a:ext cx="552800" cy="2246"/>
        </a:xfrm>
        <a:custGeom>
          <a:avLst/>
          <a:gdLst/>
          <a:ahLst/>
          <a:cxnLst/>
          <a:rect l="0" t="0" r="0" b="0"/>
          <a:pathLst>
            <a:path>
              <a:moveTo>
                <a:pt x="0" y="1123"/>
              </a:moveTo>
              <a:lnTo>
                <a:pt x="552800" y="1123"/>
              </a:lnTo>
            </a:path>
          </a:pathLst>
        </a:custGeom>
        <a:noFill/>
        <a:ln w="12700" cap="flat" cmpd="sng" algn="ctr">
          <a:solidFill>
            <a:schemeClr val="dk1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2700" tIns="0" rIns="12700" bIns="0" numCol="1" spcCol="1270" anchor="ctr" anchorCtr="0">
          <a:noAutofit/>
        </a:bodyPr>
        <a:lstStyle/>
        <a:p>
          <a:pPr marL="0" lvl="0" indent="0" algn="ctr" defTabSz="4889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endParaRPr lang="de-DE" sz="1100" kern="1200">
            <a:latin typeface="Times New Roman" panose="02020603050405020304" pitchFamily="18" charset="0"/>
            <a:cs typeface="Times New Roman" panose="02020603050405020304" pitchFamily="18" charset="0"/>
          </a:endParaRPr>
        </a:p>
      </dsp:txBody>
      <dsp:txXfrm>
        <a:off x="-2050777" y="5459891"/>
        <a:ext cx="11763107" cy="27640"/>
      </dsp:txXfrm>
    </dsp:sp>
    <dsp:sp modelId="{800253CE-BB59-4266-9CEA-CEBDA03E4027}">
      <dsp:nvSpPr>
        <dsp:cNvPr id="0" name=""/>
        <dsp:cNvSpPr/>
      </dsp:nvSpPr>
      <dsp:spPr>
        <a:xfrm>
          <a:off x="4101537" y="5322554"/>
          <a:ext cx="1752925" cy="191229"/>
        </a:xfrm>
        <a:prstGeom prst="roundRect">
          <a:avLst>
            <a:gd name="adj" fmla="val 10000"/>
          </a:avLst>
        </a:prstGeom>
        <a:solidFill>
          <a:schemeClr val="lt1"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dk1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7620" tIns="7620" rIns="7620" bIns="7620" numCol="1" spcCol="1270" anchor="ctr" anchorCtr="0">
          <a:noAutofit/>
        </a:bodyPr>
        <a:lstStyle/>
        <a:p>
          <a:pPr marL="0" lvl="0" indent="0" algn="ctr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de-DE" sz="1200" kern="1200" err="1">
              <a:latin typeface="Times New Roman" panose="02020603050405020304" pitchFamily="18" charset="0"/>
              <a:cs typeface="Times New Roman" panose="02020603050405020304" pitchFamily="18" charset="0"/>
            </a:rPr>
            <a:t>Statistics</a:t>
          </a:r>
          <a:r>
            <a:rPr lang="de-DE" sz="1200" kern="1200">
              <a:latin typeface="Times New Roman" panose="02020603050405020304" pitchFamily="18" charset="0"/>
              <a:cs typeface="Times New Roman" panose="02020603050405020304" pitchFamily="18" charset="0"/>
            </a:rPr>
            <a:t> and </a:t>
          </a:r>
          <a:r>
            <a:rPr lang="de-DE" sz="1200" kern="1200" err="1">
              <a:latin typeface="Times New Roman" panose="02020603050405020304" pitchFamily="18" charset="0"/>
              <a:cs typeface="Times New Roman" panose="02020603050405020304" pitchFamily="18" charset="0"/>
            </a:rPr>
            <a:t>data</a:t>
          </a:r>
          <a:endParaRPr lang="de-DE" sz="1200" kern="1200">
            <a:latin typeface="Times New Roman" panose="02020603050405020304" pitchFamily="18" charset="0"/>
            <a:cs typeface="Times New Roman" panose="02020603050405020304" pitchFamily="18" charset="0"/>
          </a:endParaRPr>
        </a:p>
      </dsp:txBody>
      <dsp:txXfrm>
        <a:off x="4107138" y="5328155"/>
        <a:ext cx="1741723" cy="180027"/>
      </dsp:txXfrm>
    </dsp:sp>
    <dsp:sp modelId="{83DAAF3F-DBF1-49B0-8604-B525FB5C908A}">
      <dsp:nvSpPr>
        <dsp:cNvPr id="0" name=""/>
        <dsp:cNvSpPr/>
      </dsp:nvSpPr>
      <dsp:spPr>
        <a:xfrm rot="725540">
          <a:off x="3553869" y="5586138"/>
          <a:ext cx="553812" cy="2246"/>
        </a:xfrm>
        <a:custGeom>
          <a:avLst/>
          <a:gdLst/>
          <a:ahLst/>
          <a:cxnLst/>
          <a:rect l="0" t="0" r="0" b="0"/>
          <a:pathLst>
            <a:path>
              <a:moveTo>
                <a:pt x="0" y="1123"/>
              </a:moveTo>
              <a:lnTo>
                <a:pt x="553812" y="1123"/>
              </a:lnTo>
            </a:path>
          </a:pathLst>
        </a:custGeom>
        <a:noFill/>
        <a:ln w="12700" cap="flat" cmpd="sng" algn="ctr">
          <a:solidFill>
            <a:schemeClr val="dk1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2700" tIns="0" rIns="12700" bIns="0" numCol="1" spcCol="1270" anchor="ctr" anchorCtr="0">
          <a:noAutofit/>
        </a:bodyPr>
        <a:lstStyle/>
        <a:p>
          <a:pPr marL="0" lvl="0" indent="0" algn="ctr" defTabSz="4889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endParaRPr lang="de-DE" sz="1100" kern="1200">
            <a:latin typeface="Times New Roman" panose="02020603050405020304" pitchFamily="18" charset="0"/>
            <a:cs typeface="Times New Roman" panose="02020603050405020304" pitchFamily="18" charset="0"/>
          </a:endParaRPr>
        </a:p>
      </dsp:txBody>
      <dsp:txXfrm>
        <a:off x="-2050777" y="5573416"/>
        <a:ext cx="11763107" cy="27690"/>
      </dsp:txXfrm>
    </dsp:sp>
    <dsp:sp modelId="{914215F8-CB99-49A5-92BE-A5364C5EF1A5}">
      <dsp:nvSpPr>
        <dsp:cNvPr id="0" name=""/>
        <dsp:cNvSpPr/>
      </dsp:nvSpPr>
      <dsp:spPr>
        <a:xfrm>
          <a:off x="4101537" y="5549656"/>
          <a:ext cx="1752925" cy="191229"/>
        </a:xfrm>
        <a:prstGeom prst="roundRect">
          <a:avLst>
            <a:gd name="adj" fmla="val 10000"/>
          </a:avLst>
        </a:prstGeom>
        <a:solidFill>
          <a:schemeClr val="lt1"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dk1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7620" tIns="7620" rIns="7620" bIns="7620" numCol="1" spcCol="1270" anchor="ctr" anchorCtr="0">
          <a:noAutofit/>
        </a:bodyPr>
        <a:lstStyle/>
        <a:p>
          <a:pPr marL="0" lvl="0" indent="0" algn="ctr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de-DE" sz="1200" kern="1200" err="1">
              <a:latin typeface="Times New Roman" panose="02020603050405020304" pitchFamily="18" charset="0"/>
              <a:cs typeface="Times New Roman" panose="02020603050405020304" pitchFamily="18" charset="0"/>
            </a:rPr>
            <a:t>Mis</a:t>
          </a:r>
          <a:r>
            <a:rPr lang="de-DE" sz="1200" kern="1200">
              <a:latin typeface="Times New Roman" panose="02020603050405020304" pitchFamily="18" charset="0"/>
              <a:cs typeface="Times New Roman" panose="02020603050405020304" pitchFamily="18" charset="0"/>
            </a:rPr>
            <a:t>- and </a:t>
          </a:r>
          <a:r>
            <a:rPr lang="de-DE" sz="1200" kern="1200" err="1">
              <a:latin typeface="Times New Roman" panose="02020603050405020304" pitchFamily="18" charset="0"/>
              <a:cs typeface="Times New Roman" panose="02020603050405020304" pitchFamily="18" charset="0"/>
            </a:rPr>
            <a:t>disinformation</a:t>
          </a:r>
          <a:endParaRPr lang="de-DE" sz="1200" kern="1200">
            <a:latin typeface="Times New Roman" panose="02020603050405020304" pitchFamily="18" charset="0"/>
            <a:cs typeface="Times New Roman" panose="02020603050405020304" pitchFamily="18" charset="0"/>
          </a:endParaRPr>
        </a:p>
      </dsp:txBody>
      <dsp:txXfrm>
        <a:off x="4107138" y="5555257"/>
        <a:ext cx="1741723" cy="180027"/>
      </dsp:txXfrm>
    </dsp:sp>
  </dsp:spTree>
</dsp:drawing>
</file>

<file path=ppt/diagrams/drawing2.xml><?xml version="1.0" encoding="utf-8"?>
<dsp:drawing xmlns:dgm="http://schemas.openxmlformats.org/drawingml/2006/diagram" xmlns:dsp="http://schemas.microsoft.com/office/drawing/2008/diagram" xmlns:a="http://schemas.openxmlformats.org/drawingml/2006/main">
  <dsp:spTree>
    <dsp:nvGrpSpPr>
      <dsp:cNvPr id="0" name=""/>
      <dsp:cNvGrpSpPr/>
    </dsp:nvGrpSpPr>
    <dsp:grpSpPr/>
    <dsp:sp modelId="{F78A7B94-B816-41D1-873A-8D5A3EB8CC40}">
      <dsp:nvSpPr>
        <dsp:cNvPr id="0" name=""/>
        <dsp:cNvSpPr/>
      </dsp:nvSpPr>
      <dsp:spPr>
        <a:xfrm>
          <a:off x="0" y="2720470"/>
          <a:ext cx="766597" cy="1003073"/>
        </a:xfrm>
        <a:prstGeom prst="roundRect">
          <a:avLst>
            <a:gd name="adj" fmla="val 10000"/>
          </a:avLst>
        </a:prstGeom>
        <a:solidFill>
          <a:schemeClr val="lt1"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dk1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7620" tIns="7620" rIns="7620" bIns="7620" numCol="1" spcCol="1270" anchor="ctr" anchorCtr="0">
          <a:noAutofit/>
        </a:bodyPr>
        <a:lstStyle/>
        <a:p>
          <a:pPr marL="0" lvl="0" indent="0" algn="ctr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de-DE" sz="1200" kern="1200" dirty="0">
              <a:latin typeface="Times New Roman" panose="02020603050405020304" pitchFamily="18" charset="0"/>
              <a:cs typeface="Times New Roman" panose="02020603050405020304" pitchFamily="18" charset="0"/>
            </a:rPr>
            <a:t>Themen in Public Health:</a:t>
          </a:r>
          <a:r>
            <a:rPr lang="de-DE" sz="1200" i="1" kern="1200" dirty="0">
              <a:latin typeface="Times New Roman" panose="02020603050405020304" pitchFamily="18" charset="0"/>
              <a:cs typeface="Times New Roman" panose="02020603050405020304" pitchFamily="18" charset="0"/>
            </a:rPr>
            <a:t> Gesund-</a:t>
          </a:r>
          <a:r>
            <a:rPr lang="de-DE" sz="1200" i="1" kern="1200" dirty="0" err="1">
              <a:latin typeface="Times New Roman" panose="02020603050405020304" pitchFamily="18" charset="0"/>
              <a:cs typeface="Times New Roman" panose="02020603050405020304" pitchFamily="18" charset="0"/>
            </a:rPr>
            <a:t>heitspro</a:t>
          </a:r>
          <a:r>
            <a:rPr lang="de-DE" sz="1200" i="1" kern="1200" dirty="0">
              <a:latin typeface="Times New Roman" panose="02020603050405020304" pitchFamily="18" charset="0"/>
              <a:cs typeface="Times New Roman" panose="02020603050405020304" pitchFamily="18" charset="0"/>
            </a:rPr>
            <a:t>-</a:t>
          </a:r>
          <a:r>
            <a:rPr lang="de-DE" sz="1200" i="1" kern="1200" dirty="0" err="1">
              <a:latin typeface="Times New Roman" panose="02020603050405020304" pitchFamily="18" charset="0"/>
              <a:cs typeface="Times New Roman" panose="02020603050405020304" pitchFamily="18" charset="0"/>
            </a:rPr>
            <a:t>blem</a:t>
          </a:r>
          <a:r>
            <a:rPr lang="de-DE" sz="1200" i="1" kern="1200" dirty="0">
              <a:latin typeface="Times New Roman" panose="02020603050405020304" pitchFamily="18" charset="0"/>
              <a:cs typeface="Times New Roman" panose="02020603050405020304" pitchFamily="18" charset="0"/>
            </a:rPr>
            <a:t> X </a:t>
          </a:r>
        </a:p>
      </dsp:txBody>
      <dsp:txXfrm>
        <a:off x="22453" y="2742923"/>
        <a:ext cx="721691" cy="958167"/>
      </dsp:txXfrm>
    </dsp:sp>
    <dsp:sp modelId="{2F7D4346-F118-454B-9AAD-5BD4A706F402}">
      <dsp:nvSpPr>
        <dsp:cNvPr id="0" name=""/>
        <dsp:cNvSpPr/>
      </dsp:nvSpPr>
      <dsp:spPr>
        <a:xfrm rot="17518344">
          <a:off x="-148909" y="1864689"/>
          <a:ext cx="2925690" cy="1455"/>
        </a:xfrm>
        <a:custGeom>
          <a:avLst/>
          <a:gdLst/>
          <a:ahLst/>
          <a:cxnLst/>
          <a:rect l="0" t="0" r="0" b="0"/>
          <a:pathLst>
            <a:path>
              <a:moveTo>
                <a:pt x="0" y="727"/>
              </a:moveTo>
              <a:lnTo>
                <a:pt x="2925690" y="727"/>
              </a:lnTo>
            </a:path>
          </a:pathLst>
        </a:custGeom>
        <a:noFill/>
        <a:ln w="12700" cap="flat" cmpd="sng" algn="ctr">
          <a:solidFill>
            <a:schemeClr val="dk1">
              <a:shade val="6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2700" tIns="0" rIns="12700" bIns="0" numCol="1" spcCol="1270" anchor="ctr" anchorCtr="0">
          <a:noAutofit/>
        </a:bodyPr>
        <a:lstStyle/>
        <a:p>
          <a:pPr marL="0" lvl="0" indent="0" algn="ctr" defTabSz="4889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endParaRPr lang="de-DE" sz="1100" kern="1200">
            <a:latin typeface="Times New Roman" panose="02020603050405020304" pitchFamily="18" charset="0"/>
            <a:cs typeface="Times New Roman" panose="02020603050405020304" pitchFamily="18" charset="0"/>
          </a:endParaRPr>
        </a:p>
      </dsp:txBody>
      <dsp:txXfrm>
        <a:off x="-4567617" y="1792274"/>
        <a:ext cx="11763107" cy="146284"/>
      </dsp:txXfrm>
    </dsp:sp>
    <dsp:sp modelId="{430F15C4-6A15-46B0-808C-1CBD7A4F9165}">
      <dsp:nvSpPr>
        <dsp:cNvPr id="0" name=""/>
        <dsp:cNvSpPr/>
      </dsp:nvSpPr>
      <dsp:spPr>
        <a:xfrm>
          <a:off x="1861273" y="329162"/>
          <a:ext cx="1123774" cy="359328"/>
        </a:xfrm>
        <a:prstGeom prst="roundRect">
          <a:avLst>
            <a:gd name="adj" fmla="val 10000"/>
          </a:avLst>
        </a:prstGeom>
        <a:solidFill>
          <a:schemeClr val="lt1"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dk1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6985" tIns="6985" rIns="6985" bIns="6985" numCol="1" spcCol="1270" anchor="ctr" anchorCtr="0">
          <a:noAutofit/>
        </a:bodyPr>
        <a:lstStyle/>
        <a:p>
          <a:pPr marL="0" lvl="0" indent="0" algn="ctr" defTabSz="466725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de-DE" sz="1050" kern="1200">
              <a:latin typeface="Times New Roman" panose="02020603050405020304" pitchFamily="18" charset="0"/>
              <a:cs typeface="Times New Roman" panose="02020603050405020304" pitchFamily="18" charset="0"/>
            </a:rPr>
            <a:t>Ursprung</a:t>
          </a:r>
        </a:p>
      </dsp:txBody>
      <dsp:txXfrm>
        <a:off x="1871797" y="339686"/>
        <a:ext cx="1102726" cy="338280"/>
      </dsp:txXfrm>
    </dsp:sp>
    <dsp:sp modelId="{4838F315-A0EB-4974-8233-371CFFCC1CE4}">
      <dsp:nvSpPr>
        <dsp:cNvPr id="0" name=""/>
        <dsp:cNvSpPr/>
      </dsp:nvSpPr>
      <dsp:spPr>
        <a:xfrm rot="20509274">
          <a:off x="2966261" y="390670"/>
          <a:ext cx="752791" cy="1455"/>
        </a:xfrm>
        <a:custGeom>
          <a:avLst/>
          <a:gdLst/>
          <a:ahLst/>
          <a:cxnLst/>
          <a:rect l="0" t="0" r="0" b="0"/>
          <a:pathLst>
            <a:path>
              <a:moveTo>
                <a:pt x="0" y="727"/>
              </a:moveTo>
              <a:lnTo>
                <a:pt x="752791" y="727"/>
              </a:lnTo>
            </a:path>
          </a:pathLst>
        </a:custGeom>
        <a:noFill/>
        <a:ln w="12700" cap="flat" cmpd="sng" algn="ctr">
          <a:solidFill>
            <a:schemeClr val="dk1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2700" tIns="0" rIns="12700" bIns="0" numCol="1" spcCol="1270" anchor="ctr" anchorCtr="0">
          <a:noAutofit/>
        </a:bodyPr>
        <a:lstStyle/>
        <a:p>
          <a:pPr marL="0" lvl="0" indent="0" algn="ctr" defTabSz="4889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endParaRPr lang="de-DE" sz="1100" kern="1200">
            <a:latin typeface="Times New Roman" panose="02020603050405020304" pitchFamily="18" charset="0"/>
            <a:cs typeface="Times New Roman" panose="02020603050405020304" pitchFamily="18" charset="0"/>
          </a:endParaRPr>
        </a:p>
      </dsp:txBody>
      <dsp:txXfrm>
        <a:off x="-2538896" y="372578"/>
        <a:ext cx="11763107" cy="37639"/>
      </dsp:txXfrm>
    </dsp:sp>
    <dsp:sp modelId="{0B80F301-D09A-4FB6-916E-CECF32B2F143}">
      <dsp:nvSpPr>
        <dsp:cNvPr id="0" name=""/>
        <dsp:cNvSpPr/>
      </dsp:nvSpPr>
      <dsp:spPr>
        <a:xfrm>
          <a:off x="3700265" y="192908"/>
          <a:ext cx="1561013" cy="162121"/>
        </a:xfrm>
        <a:prstGeom prst="roundRect">
          <a:avLst>
            <a:gd name="adj" fmla="val 10000"/>
          </a:avLst>
        </a:prstGeom>
        <a:solidFill>
          <a:schemeClr val="lt1"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dk1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6985" tIns="6985" rIns="6985" bIns="6985" numCol="1" spcCol="1270" anchor="ctr" anchorCtr="0">
          <a:noAutofit/>
        </a:bodyPr>
        <a:lstStyle/>
        <a:p>
          <a:pPr marL="0" lvl="0" indent="0" algn="ctr" defTabSz="466725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de-DE" sz="1050" kern="1200">
              <a:latin typeface="Times New Roman" panose="02020603050405020304" pitchFamily="18" charset="0"/>
              <a:cs typeface="Times New Roman" panose="02020603050405020304" pitchFamily="18" charset="0"/>
            </a:rPr>
            <a:t>Herkunft des Virus</a:t>
          </a:r>
        </a:p>
      </dsp:txBody>
      <dsp:txXfrm>
        <a:off x="3705013" y="197656"/>
        <a:ext cx="1551517" cy="152625"/>
      </dsp:txXfrm>
    </dsp:sp>
    <dsp:sp modelId="{750F2EA3-C6A2-49D8-A4E9-ECB36FFC366E}">
      <dsp:nvSpPr>
        <dsp:cNvPr id="0" name=""/>
        <dsp:cNvSpPr/>
      </dsp:nvSpPr>
      <dsp:spPr>
        <a:xfrm rot="21384273">
          <a:off x="2984351" y="485908"/>
          <a:ext cx="707696" cy="1455"/>
        </a:xfrm>
        <a:custGeom>
          <a:avLst/>
          <a:gdLst/>
          <a:ahLst/>
          <a:cxnLst/>
          <a:rect l="0" t="0" r="0" b="0"/>
          <a:pathLst>
            <a:path>
              <a:moveTo>
                <a:pt x="0" y="727"/>
              </a:moveTo>
              <a:lnTo>
                <a:pt x="707696" y="727"/>
              </a:lnTo>
            </a:path>
          </a:pathLst>
        </a:custGeom>
        <a:noFill/>
        <a:ln w="12700" cap="flat" cmpd="sng" algn="ctr">
          <a:solidFill>
            <a:schemeClr val="dk1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2700" tIns="0" rIns="12700" bIns="0" numCol="1" spcCol="1270" anchor="ctr" anchorCtr="0">
          <a:noAutofit/>
        </a:bodyPr>
        <a:lstStyle/>
        <a:p>
          <a:pPr marL="0" lvl="0" indent="0" algn="ctr" defTabSz="4889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endParaRPr lang="de-DE" sz="1100" kern="1200">
            <a:latin typeface="Times New Roman" panose="02020603050405020304" pitchFamily="18" charset="0"/>
            <a:cs typeface="Times New Roman" panose="02020603050405020304" pitchFamily="18" charset="0"/>
          </a:endParaRPr>
        </a:p>
      </dsp:txBody>
      <dsp:txXfrm>
        <a:off x="-2543353" y="468944"/>
        <a:ext cx="11763107" cy="35384"/>
      </dsp:txXfrm>
    </dsp:sp>
    <dsp:sp modelId="{70A6C9AF-4497-49E2-8F6B-4022C002A32C}">
      <dsp:nvSpPr>
        <dsp:cNvPr id="0" name=""/>
        <dsp:cNvSpPr/>
      </dsp:nvSpPr>
      <dsp:spPr>
        <a:xfrm>
          <a:off x="3691351" y="384140"/>
          <a:ext cx="1561013" cy="160611"/>
        </a:xfrm>
        <a:prstGeom prst="roundRect">
          <a:avLst>
            <a:gd name="adj" fmla="val 10000"/>
          </a:avLst>
        </a:prstGeom>
        <a:solidFill>
          <a:schemeClr val="lt1"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dk1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6985" tIns="6985" rIns="6985" bIns="6985" numCol="1" spcCol="1270" anchor="ctr" anchorCtr="0">
          <a:noAutofit/>
        </a:bodyPr>
        <a:lstStyle/>
        <a:p>
          <a:pPr marL="0" lvl="0" indent="0" algn="ctr" defTabSz="466725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de-DE" sz="1050" kern="1200">
              <a:latin typeface="Times New Roman" panose="02020603050405020304" pitchFamily="18" charset="0"/>
              <a:cs typeface="Times New Roman" panose="02020603050405020304" pitchFamily="18" charset="0"/>
            </a:rPr>
            <a:t>Stigmatisierung</a:t>
          </a:r>
        </a:p>
      </dsp:txBody>
      <dsp:txXfrm>
        <a:off x="3696055" y="388844"/>
        <a:ext cx="1551605" cy="151203"/>
      </dsp:txXfrm>
    </dsp:sp>
    <dsp:sp modelId="{B99573E9-A46B-4C67-A741-44E4FCB4FC8A}">
      <dsp:nvSpPr>
        <dsp:cNvPr id="0" name=""/>
        <dsp:cNvSpPr/>
      </dsp:nvSpPr>
      <dsp:spPr>
        <a:xfrm rot="726048">
          <a:off x="2976960" y="584397"/>
          <a:ext cx="727926" cy="1455"/>
        </a:xfrm>
        <a:custGeom>
          <a:avLst/>
          <a:gdLst/>
          <a:ahLst/>
          <a:cxnLst/>
          <a:rect l="0" t="0" r="0" b="0"/>
          <a:pathLst>
            <a:path>
              <a:moveTo>
                <a:pt x="0" y="727"/>
              </a:moveTo>
              <a:lnTo>
                <a:pt x="727926" y="727"/>
              </a:lnTo>
            </a:path>
          </a:pathLst>
        </a:custGeom>
        <a:noFill/>
        <a:ln w="12700" cap="flat" cmpd="sng" algn="ctr">
          <a:solidFill>
            <a:schemeClr val="dk1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2700" tIns="0" rIns="12700" bIns="0" numCol="1" spcCol="1270" anchor="ctr" anchorCtr="0">
          <a:noAutofit/>
        </a:bodyPr>
        <a:lstStyle/>
        <a:p>
          <a:pPr marL="0" lvl="0" indent="0" algn="ctr" defTabSz="4889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endParaRPr lang="de-DE" sz="1100" kern="1200">
            <a:latin typeface="Times New Roman" panose="02020603050405020304" pitchFamily="18" charset="0"/>
            <a:cs typeface="Times New Roman" panose="02020603050405020304" pitchFamily="18" charset="0"/>
          </a:endParaRPr>
        </a:p>
      </dsp:txBody>
      <dsp:txXfrm>
        <a:off x="-2540629" y="566927"/>
        <a:ext cx="11763107" cy="36396"/>
      </dsp:txXfrm>
    </dsp:sp>
    <dsp:sp modelId="{049F2968-73E2-4348-A8D7-E885F2B2F00E}">
      <dsp:nvSpPr>
        <dsp:cNvPr id="0" name=""/>
        <dsp:cNvSpPr/>
      </dsp:nvSpPr>
      <dsp:spPr>
        <a:xfrm rot="10800000" flipV="1">
          <a:off x="3696800" y="580363"/>
          <a:ext cx="1561013" cy="162121"/>
        </a:xfrm>
        <a:prstGeom prst="roundRect">
          <a:avLst>
            <a:gd name="adj" fmla="val 10000"/>
          </a:avLst>
        </a:prstGeom>
        <a:solidFill>
          <a:schemeClr val="lt1"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dk1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6985" tIns="6985" rIns="6985" bIns="6985" numCol="1" spcCol="1270" anchor="ctr" anchorCtr="0">
          <a:noAutofit/>
        </a:bodyPr>
        <a:lstStyle/>
        <a:p>
          <a:pPr marL="0" lvl="0" indent="0" algn="ctr" defTabSz="466725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de-DE" sz="1050" kern="1200">
              <a:latin typeface="Times New Roman" panose="02020603050405020304" pitchFamily="18" charset="0"/>
              <a:cs typeface="Times New Roman" panose="02020603050405020304" pitchFamily="18" charset="0"/>
            </a:rPr>
            <a:t>Verbreitung und Immunität</a:t>
          </a:r>
        </a:p>
      </dsp:txBody>
      <dsp:txXfrm rot="-10800000">
        <a:off x="3701548" y="585111"/>
        <a:ext cx="1551517" cy="152625"/>
      </dsp:txXfrm>
    </dsp:sp>
    <dsp:sp modelId="{6C074D18-1EA0-40FB-94A6-DD4C52B7D46C}">
      <dsp:nvSpPr>
        <dsp:cNvPr id="0" name=""/>
        <dsp:cNvSpPr/>
      </dsp:nvSpPr>
      <dsp:spPr>
        <a:xfrm rot="18013284">
          <a:off x="234687" y="2295858"/>
          <a:ext cx="2141963" cy="1455"/>
        </a:xfrm>
        <a:custGeom>
          <a:avLst/>
          <a:gdLst/>
          <a:ahLst/>
          <a:cxnLst/>
          <a:rect l="0" t="0" r="0" b="0"/>
          <a:pathLst>
            <a:path>
              <a:moveTo>
                <a:pt x="0" y="727"/>
              </a:moveTo>
              <a:lnTo>
                <a:pt x="2141963" y="727"/>
              </a:lnTo>
            </a:path>
          </a:pathLst>
        </a:custGeom>
        <a:noFill/>
        <a:ln w="12700" cap="flat" cmpd="sng" algn="ctr">
          <a:solidFill>
            <a:schemeClr val="dk1">
              <a:shade val="6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2700" tIns="0" rIns="12700" bIns="0" numCol="1" spcCol="1270" anchor="ctr" anchorCtr="0">
          <a:noAutofit/>
        </a:bodyPr>
        <a:lstStyle/>
        <a:p>
          <a:pPr marL="0" lvl="0" indent="0" algn="ctr" defTabSz="4889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endParaRPr lang="de-DE" sz="1100" kern="1200">
            <a:latin typeface="Times New Roman" panose="02020603050405020304" pitchFamily="18" charset="0"/>
            <a:cs typeface="Times New Roman" panose="02020603050405020304" pitchFamily="18" charset="0"/>
          </a:endParaRPr>
        </a:p>
      </dsp:txBody>
      <dsp:txXfrm>
        <a:off x="-4575884" y="2243036"/>
        <a:ext cx="11763107" cy="107098"/>
      </dsp:txXfrm>
    </dsp:sp>
    <dsp:sp modelId="{3B5C04C0-1026-4BCC-B8D1-09CC708E27EF}">
      <dsp:nvSpPr>
        <dsp:cNvPr id="0" name=""/>
        <dsp:cNvSpPr/>
      </dsp:nvSpPr>
      <dsp:spPr>
        <a:xfrm>
          <a:off x="1844740" y="1191500"/>
          <a:ext cx="1123774" cy="359328"/>
        </a:xfrm>
        <a:prstGeom prst="roundRect">
          <a:avLst>
            <a:gd name="adj" fmla="val 10000"/>
          </a:avLst>
        </a:prstGeom>
        <a:solidFill>
          <a:schemeClr val="lt1"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dk1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6985" tIns="6985" rIns="6985" bIns="6985" numCol="1" spcCol="1270" anchor="ctr" anchorCtr="0">
          <a:noAutofit/>
        </a:bodyPr>
        <a:lstStyle/>
        <a:p>
          <a:pPr marL="0" lvl="0" indent="0" algn="ctr" defTabSz="466725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de-DE" sz="1050" kern="1200">
              <a:latin typeface="Times New Roman" panose="02020603050405020304" pitchFamily="18" charset="0"/>
              <a:cs typeface="Times New Roman" panose="02020603050405020304" pitchFamily="18" charset="0"/>
            </a:rPr>
            <a:t>Krankheit</a:t>
          </a:r>
        </a:p>
      </dsp:txBody>
      <dsp:txXfrm>
        <a:off x="1855264" y="1202024"/>
        <a:ext cx="1102726" cy="338280"/>
      </dsp:txXfrm>
    </dsp:sp>
    <dsp:sp modelId="{1933032C-D9EF-4E95-9447-72395E90BD3C}">
      <dsp:nvSpPr>
        <dsp:cNvPr id="0" name=""/>
        <dsp:cNvSpPr/>
      </dsp:nvSpPr>
      <dsp:spPr>
        <a:xfrm rot="21059944">
          <a:off x="2947147" y="1098975"/>
          <a:ext cx="3470262" cy="1453"/>
        </a:xfrm>
        <a:custGeom>
          <a:avLst/>
          <a:gdLst/>
          <a:ahLst/>
          <a:cxnLst/>
          <a:rect l="0" t="0" r="0" b="0"/>
          <a:pathLst>
            <a:path>
              <a:moveTo>
                <a:pt x="0" y="726"/>
              </a:moveTo>
              <a:lnTo>
                <a:pt x="3470262" y="726"/>
              </a:lnTo>
            </a:path>
          </a:pathLst>
        </a:custGeom>
        <a:noFill/>
        <a:ln w="12700" cap="flat" cmpd="sng" algn="ctr">
          <a:solidFill>
            <a:schemeClr val="dk1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2700" tIns="0" rIns="12700" bIns="0" numCol="1" spcCol="1270" anchor="ctr" anchorCtr="0">
          <a:noAutofit/>
        </a:bodyPr>
        <a:lstStyle/>
        <a:p>
          <a:pPr marL="0" lvl="0" indent="0" algn="ctr" defTabSz="4889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endParaRPr lang="de-DE" sz="1100" kern="1200">
            <a:latin typeface="Times New Roman" panose="02020603050405020304" pitchFamily="18" charset="0"/>
            <a:cs typeface="Times New Roman" panose="02020603050405020304" pitchFamily="18" charset="0"/>
          </a:endParaRPr>
        </a:p>
      </dsp:txBody>
      <dsp:txXfrm>
        <a:off x="-1199274" y="1012945"/>
        <a:ext cx="11763107" cy="173513"/>
      </dsp:txXfrm>
    </dsp:sp>
    <dsp:sp modelId="{85D196B6-063E-44EA-88B6-502D03441A95}">
      <dsp:nvSpPr>
        <dsp:cNvPr id="0" name=""/>
        <dsp:cNvSpPr/>
      </dsp:nvSpPr>
      <dsp:spPr>
        <a:xfrm>
          <a:off x="6396042" y="740346"/>
          <a:ext cx="1614786" cy="175785"/>
        </a:xfrm>
        <a:prstGeom prst="roundRect">
          <a:avLst>
            <a:gd name="adj" fmla="val 10000"/>
          </a:avLst>
        </a:prstGeom>
        <a:solidFill>
          <a:schemeClr val="lt1"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dk1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6985" tIns="6985" rIns="6985" bIns="6985" numCol="1" spcCol="1270" anchor="ctr" anchorCtr="0">
          <a:noAutofit/>
        </a:bodyPr>
        <a:lstStyle/>
        <a:p>
          <a:pPr marL="0" lvl="0" indent="0" algn="ctr" defTabSz="466725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de-DE" sz="1050" kern="1200">
              <a:latin typeface="Times New Roman" panose="02020603050405020304" pitchFamily="18" charset="0"/>
              <a:cs typeface="Times New Roman" panose="02020603050405020304" pitchFamily="18" charset="0"/>
            </a:rPr>
            <a:t>Symptome</a:t>
          </a:r>
        </a:p>
      </dsp:txBody>
      <dsp:txXfrm>
        <a:off x="6401191" y="745495"/>
        <a:ext cx="1604488" cy="165487"/>
      </dsp:txXfrm>
    </dsp:sp>
    <dsp:sp modelId="{39A8889A-DFEF-4793-B12D-3BA4A3083E3E}">
      <dsp:nvSpPr>
        <dsp:cNvPr id="0" name=""/>
        <dsp:cNvSpPr/>
      </dsp:nvSpPr>
      <dsp:spPr>
        <a:xfrm rot="21294025">
          <a:off x="8008911" y="784442"/>
          <a:ext cx="969097" cy="1453"/>
        </a:xfrm>
        <a:custGeom>
          <a:avLst/>
          <a:gdLst/>
          <a:ahLst/>
          <a:cxnLst/>
          <a:rect l="0" t="0" r="0" b="0"/>
          <a:pathLst>
            <a:path>
              <a:moveTo>
                <a:pt x="0" y="726"/>
              </a:moveTo>
              <a:lnTo>
                <a:pt x="969097" y="726"/>
              </a:lnTo>
            </a:path>
          </a:pathLst>
        </a:custGeom>
        <a:noFill/>
        <a:ln w="12700" cap="flat" cmpd="sng" algn="ctr">
          <a:solidFill>
            <a:schemeClr val="dk1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2700" tIns="0" rIns="12700" bIns="0" numCol="1" spcCol="1270" anchor="ctr" anchorCtr="0">
          <a:noAutofit/>
        </a:bodyPr>
        <a:lstStyle/>
        <a:p>
          <a:pPr marL="0" lvl="0" indent="0" algn="ctr" defTabSz="4889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endParaRPr lang="de-DE" sz="1100" kern="1200">
            <a:latin typeface="Times New Roman" panose="02020603050405020304" pitchFamily="18" charset="0"/>
            <a:cs typeface="Times New Roman" panose="02020603050405020304" pitchFamily="18" charset="0"/>
          </a:endParaRPr>
        </a:p>
      </dsp:txBody>
      <dsp:txXfrm>
        <a:off x="2611907" y="760942"/>
        <a:ext cx="11763107" cy="48454"/>
      </dsp:txXfrm>
    </dsp:sp>
    <dsp:sp modelId="{29B3ABBF-0291-41BA-9070-E0CB070E1723}">
      <dsp:nvSpPr>
        <dsp:cNvPr id="0" name=""/>
        <dsp:cNvSpPr/>
      </dsp:nvSpPr>
      <dsp:spPr>
        <a:xfrm>
          <a:off x="8976091" y="654105"/>
          <a:ext cx="1613210" cy="175987"/>
        </a:xfrm>
        <a:prstGeom prst="roundRect">
          <a:avLst>
            <a:gd name="adj" fmla="val 10000"/>
          </a:avLst>
        </a:prstGeom>
        <a:solidFill>
          <a:schemeClr val="lt1"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dk1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6985" tIns="6985" rIns="6985" bIns="6985" numCol="1" spcCol="1270" anchor="ctr" anchorCtr="0">
          <a:noAutofit/>
        </a:bodyPr>
        <a:lstStyle/>
        <a:p>
          <a:pPr marL="0" lvl="0" indent="0" algn="ctr" defTabSz="466725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de-DE" sz="1050" kern="1200">
              <a:latin typeface="Times New Roman" panose="02020603050405020304" pitchFamily="18" charset="0"/>
              <a:cs typeface="Times New Roman" panose="02020603050405020304" pitchFamily="18" charset="0"/>
            </a:rPr>
            <a:t>Bestätigt</a:t>
          </a:r>
        </a:p>
      </dsp:txBody>
      <dsp:txXfrm>
        <a:off x="8981245" y="659259"/>
        <a:ext cx="1602902" cy="165679"/>
      </dsp:txXfrm>
    </dsp:sp>
    <dsp:sp modelId="{16EDC4EB-15B1-4BED-A913-C4910A592E43}">
      <dsp:nvSpPr>
        <dsp:cNvPr id="0" name=""/>
        <dsp:cNvSpPr/>
      </dsp:nvSpPr>
      <dsp:spPr>
        <a:xfrm rot="380596">
          <a:off x="8007856" y="881164"/>
          <a:ext cx="971207" cy="1453"/>
        </a:xfrm>
        <a:custGeom>
          <a:avLst/>
          <a:gdLst/>
          <a:ahLst/>
          <a:cxnLst/>
          <a:rect l="0" t="0" r="0" b="0"/>
          <a:pathLst>
            <a:path>
              <a:moveTo>
                <a:pt x="0" y="726"/>
              </a:moveTo>
              <a:lnTo>
                <a:pt x="971207" y="726"/>
              </a:lnTo>
            </a:path>
          </a:pathLst>
        </a:custGeom>
        <a:noFill/>
        <a:ln w="12700" cap="flat" cmpd="sng" algn="ctr">
          <a:solidFill>
            <a:schemeClr val="dk1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2700" tIns="0" rIns="12700" bIns="0" numCol="1" spcCol="1270" anchor="ctr" anchorCtr="0">
          <a:noAutofit/>
        </a:bodyPr>
        <a:lstStyle/>
        <a:p>
          <a:pPr marL="0" lvl="0" indent="0" algn="ctr" defTabSz="4889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endParaRPr lang="de-DE" sz="1100" kern="1200">
            <a:latin typeface="Times New Roman" panose="02020603050405020304" pitchFamily="18" charset="0"/>
            <a:cs typeface="Times New Roman" panose="02020603050405020304" pitchFamily="18" charset="0"/>
          </a:endParaRPr>
        </a:p>
      </dsp:txBody>
      <dsp:txXfrm>
        <a:off x="2611907" y="857611"/>
        <a:ext cx="11763107" cy="48560"/>
      </dsp:txXfrm>
    </dsp:sp>
    <dsp:sp modelId="{3D93AA13-F9BF-4516-9343-01C4FE687B9F}">
      <dsp:nvSpPr>
        <dsp:cNvPr id="0" name=""/>
        <dsp:cNvSpPr/>
      </dsp:nvSpPr>
      <dsp:spPr>
        <a:xfrm>
          <a:off x="8976091" y="847550"/>
          <a:ext cx="1613210" cy="175986"/>
        </a:xfrm>
        <a:prstGeom prst="roundRect">
          <a:avLst>
            <a:gd name="adj" fmla="val 10000"/>
          </a:avLst>
        </a:prstGeom>
        <a:solidFill>
          <a:schemeClr val="lt1"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dk1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6985" tIns="6985" rIns="6985" bIns="6985" numCol="1" spcCol="1270" anchor="ctr" anchorCtr="0">
          <a:noAutofit/>
        </a:bodyPr>
        <a:lstStyle/>
        <a:p>
          <a:pPr marL="0" lvl="0" indent="0" algn="ctr" defTabSz="466725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de-DE" sz="1050" kern="1200">
              <a:latin typeface="Times New Roman" panose="02020603050405020304" pitchFamily="18" charset="0"/>
              <a:cs typeface="Times New Roman" panose="02020603050405020304" pitchFamily="18" charset="0"/>
            </a:rPr>
            <a:t>Andere</a:t>
          </a:r>
        </a:p>
      </dsp:txBody>
      <dsp:txXfrm>
        <a:off x="8981245" y="852704"/>
        <a:ext cx="1602902" cy="165678"/>
      </dsp:txXfrm>
    </dsp:sp>
    <dsp:sp modelId="{BE69F2C5-1F16-4884-B39F-EE6B06025848}">
      <dsp:nvSpPr>
        <dsp:cNvPr id="0" name=""/>
        <dsp:cNvSpPr/>
      </dsp:nvSpPr>
      <dsp:spPr>
        <a:xfrm rot="21282456">
          <a:off x="2961169" y="1211511"/>
          <a:ext cx="3445977" cy="1453"/>
        </a:xfrm>
        <a:custGeom>
          <a:avLst/>
          <a:gdLst/>
          <a:ahLst/>
          <a:cxnLst/>
          <a:rect l="0" t="0" r="0" b="0"/>
          <a:pathLst>
            <a:path>
              <a:moveTo>
                <a:pt x="0" y="726"/>
              </a:moveTo>
              <a:lnTo>
                <a:pt x="3445977" y="726"/>
              </a:lnTo>
            </a:path>
          </a:pathLst>
        </a:custGeom>
        <a:noFill/>
        <a:ln w="12700" cap="flat" cmpd="sng" algn="ctr">
          <a:solidFill>
            <a:schemeClr val="dk1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2700" tIns="0" rIns="12700" bIns="0" numCol="1" spcCol="1270" anchor="ctr" anchorCtr="0">
          <a:noAutofit/>
        </a:bodyPr>
        <a:lstStyle/>
        <a:p>
          <a:pPr marL="0" lvl="0" indent="0" algn="ctr" defTabSz="4889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endParaRPr lang="de-DE" sz="1100" kern="1200">
            <a:latin typeface="Times New Roman" panose="02020603050405020304" pitchFamily="18" charset="0"/>
            <a:cs typeface="Times New Roman" panose="02020603050405020304" pitchFamily="18" charset="0"/>
          </a:endParaRPr>
        </a:p>
      </dsp:txBody>
      <dsp:txXfrm>
        <a:off x="-1197395" y="1126089"/>
        <a:ext cx="11763107" cy="172298"/>
      </dsp:txXfrm>
    </dsp:sp>
    <dsp:sp modelId="{C631F0D8-FAAD-405A-A21C-737F0EB151CA}">
      <dsp:nvSpPr>
        <dsp:cNvPr id="0" name=""/>
        <dsp:cNvSpPr/>
      </dsp:nvSpPr>
      <dsp:spPr>
        <a:xfrm>
          <a:off x="6399801" y="965420"/>
          <a:ext cx="1614786" cy="175785"/>
        </a:xfrm>
        <a:prstGeom prst="roundRect">
          <a:avLst>
            <a:gd name="adj" fmla="val 10000"/>
          </a:avLst>
        </a:prstGeom>
        <a:solidFill>
          <a:schemeClr val="lt1"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dk1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6985" tIns="6985" rIns="6985" bIns="6985" numCol="1" spcCol="1270" anchor="ctr" anchorCtr="0">
          <a:noAutofit/>
        </a:bodyPr>
        <a:lstStyle/>
        <a:p>
          <a:pPr marL="0" lvl="0" indent="0" algn="ctr" defTabSz="466725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de-DE" sz="1050" kern="1200">
              <a:latin typeface="Times New Roman" panose="02020603050405020304" pitchFamily="18" charset="0"/>
              <a:cs typeface="Times New Roman" panose="02020603050405020304" pitchFamily="18" charset="0"/>
            </a:rPr>
            <a:t>Asymptomatisch</a:t>
          </a:r>
        </a:p>
      </dsp:txBody>
      <dsp:txXfrm>
        <a:off x="6404950" y="970569"/>
        <a:ext cx="1604488" cy="165487"/>
      </dsp:txXfrm>
    </dsp:sp>
    <dsp:sp modelId="{8D2BE030-0831-42B2-98C2-0F6E87AD5B7D}">
      <dsp:nvSpPr>
        <dsp:cNvPr id="0" name=""/>
        <dsp:cNvSpPr/>
      </dsp:nvSpPr>
      <dsp:spPr>
        <a:xfrm rot="21498309">
          <a:off x="2967763" y="1319643"/>
          <a:ext cx="3434782" cy="1453"/>
        </a:xfrm>
        <a:custGeom>
          <a:avLst/>
          <a:gdLst/>
          <a:ahLst/>
          <a:cxnLst/>
          <a:rect l="0" t="0" r="0" b="0"/>
          <a:pathLst>
            <a:path>
              <a:moveTo>
                <a:pt x="0" y="726"/>
              </a:moveTo>
              <a:lnTo>
                <a:pt x="3434782" y="726"/>
              </a:lnTo>
            </a:path>
          </a:pathLst>
        </a:custGeom>
        <a:noFill/>
        <a:ln w="12700" cap="flat" cmpd="sng" algn="ctr">
          <a:solidFill>
            <a:schemeClr val="dk1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2700" tIns="0" rIns="12700" bIns="0" numCol="1" spcCol="1270" anchor="ctr" anchorCtr="0">
          <a:noAutofit/>
        </a:bodyPr>
        <a:lstStyle/>
        <a:p>
          <a:pPr marL="0" lvl="0" indent="0" algn="ctr" defTabSz="4889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endParaRPr lang="de-DE" sz="1100" kern="1200">
            <a:latin typeface="Times New Roman" panose="02020603050405020304" pitchFamily="18" charset="0"/>
            <a:cs typeface="Times New Roman" panose="02020603050405020304" pitchFamily="18" charset="0"/>
          </a:endParaRPr>
        </a:p>
      </dsp:txBody>
      <dsp:txXfrm>
        <a:off x="-1196398" y="1234500"/>
        <a:ext cx="11763107" cy="171739"/>
      </dsp:txXfrm>
    </dsp:sp>
    <dsp:sp modelId="{29EF756E-ED73-4753-83B6-EFB27D8AB242}">
      <dsp:nvSpPr>
        <dsp:cNvPr id="0" name=""/>
        <dsp:cNvSpPr/>
      </dsp:nvSpPr>
      <dsp:spPr>
        <a:xfrm>
          <a:off x="6401794" y="1181682"/>
          <a:ext cx="1614786" cy="175785"/>
        </a:xfrm>
        <a:prstGeom prst="roundRect">
          <a:avLst>
            <a:gd name="adj" fmla="val 10000"/>
          </a:avLst>
        </a:prstGeom>
        <a:solidFill>
          <a:schemeClr val="lt1"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dk1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6985" tIns="6985" rIns="6985" bIns="6985" numCol="1" spcCol="1270" anchor="ctr" anchorCtr="0">
          <a:noAutofit/>
        </a:bodyPr>
        <a:lstStyle/>
        <a:p>
          <a:pPr marL="0" lvl="0" indent="0" algn="ctr" defTabSz="466725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de-DE" sz="1050" kern="1200">
              <a:latin typeface="Times New Roman" panose="02020603050405020304" pitchFamily="18" charset="0"/>
              <a:cs typeface="Times New Roman" panose="02020603050405020304" pitchFamily="18" charset="0"/>
            </a:rPr>
            <a:t>Präsymptomatisch</a:t>
          </a:r>
        </a:p>
      </dsp:txBody>
      <dsp:txXfrm>
        <a:off x="6406943" y="1186831"/>
        <a:ext cx="1604488" cy="165487"/>
      </dsp:txXfrm>
    </dsp:sp>
    <dsp:sp modelId="{A20C5029-8277-4F52-A215-36A9DA1AB52E}">
      <dsp:nvSpPr>
        <dsp:cNvPr id="0" name=""/>
        <dsp:cNvSpPr/>
      </dsp:nvSpPr>
      <dsp:spPr>
        <a:xfrm rot="115626">
          <a:off x="2967543" y="1428143"/>
          <a:ext cx="3432048" cy="1453"/>
        </a:xfrm>
        <a:custGeom>
          <a:avLst/>
          <a:gdLst/>
          <a:ahLst/>
          <a:cxnLst/>
          <a:rect l="0" t="0" r="0" b="0"/>
          <a:pathLst>
            <a:path>
              <a:moveTo>
                <a:pt x="0" y="726"/>
              </a:moveTo>
              <a:lnTo>
                <a:pt x="3432048" y="726"/>
              </a:lnTo>
            </a:path>
          </a:pathLst>
        </a:custGeom>
        <a:noFill/>
        <a:ln w="12700" cap="flat" cmpd="sng" algn="ctr">
          <a:solidFill>
            <a:schemeClr val="dk1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2700" tIns="0" rIns="12700" bIns="0" numCol="1" spcCol="1270" anchor="ctr" anchorCtr="0">
          <a:noAutofit/>
        </a:bodyPr>
        <a:lstStyle/>
        <a:p>
          <a:pPr marL="0" lvl="0" indent="0" algn="ctr" defTabSz="4889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endParaRPr lang="de-DE" sz="1100" kern="1200">
            <a:latin typeface="Times New Roman" panose="02020603050405020304" pitchFamily="18" charset="0"/>
            <a:cs typeface="Times New Roman" panose="02020603050405020304" pitchFamily="18" charset="0"/>
          </a:endParaRPr>
        </a:p>
      </dsp:txBody>
      <dsp:txXfrm>
        <a:off x="-1197985" y="1343069"/>
        <a:ext cx="11763107" cy="171602"/>
      </dsp:txXfrm>
    </dsp:sp>
    <dsp:sp modelId="{EC3C7E9C-DE6F-4CF5-B8A3-EB96093DECF2}">
      <dsp:nvSpPr>
        <dsp:cNvPr id="0" name=""/>
        <dsp:cNvSpPr/>
      </dsp:nvSpPr>
      <dsp:spPr>
        <a:xfrm>
          <a:off x="6398621" y="1398684"/>
          <a:ext cx="1614786" cy="175785"/>
        </a:xfrm>
        <a:prstGeom prst="roundRect">
          <a:avLst>
            <a:gd name="adj" fmla="val 10000"/>
          </a:avLst>
        </a:prstGeom>
        <a:solidFill>
          <a:schemeClr val="lt1"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dk1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6985" tIns="6985" rIns="6985" bIns="6985" numCol="1" spcCol="1270" anchor="ctr" anchorCtr="0">
          <a:noAutofit/>
        </a:bodyPr>
        <a:lstStyle/>
        <a:p>
          <a:pPr marL="0" lvl="0" indent="0" algn="ctr" defTabSz="466725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de-DE" sz="1050" kern="1200">
              <a:latin typeface="Times New Roman" panose="02020603050405020304" pitchFamily="18" charset="0"/>
              <a:cs typeface="Times New Roman" panose="02020603050405020304" pitchFamily="18" charset="0"/>
            </a:rPr>
            <a:t>Übertragungswege</a:t>
          </a:r>
        </a:p>
      </dsp:txBody>
      <dsp:txXfrm>
        <a:off x="6403770" y="1403833"/>
        <a:ext cx="1604488" cy="165487"/>
      </dsp:txXfrm>
    </dsp:sp>
    <dsp:sp modelId="{FCAF4F74-DA65-4B57-BED5-BD3F26CA3653}">
      <dsp:nvSpPr>
        <dsp:cNvPr id="0" name=""/>
        <dsp:cNvSpPr/>
      </dsp:nvSpPr>
      <dsp:spPr>
        <a:xfrm rot="341929">
          <a:off x="2959975" y="1541989"/>
          <a:ext cx="3455248" cy="1453"/>
        </a:xfrm>
        <a:custGeom>
          <a:avLst/>
          <a:gdLst/>
          <a:ahLst/>
          <a:cxnLst/>
          <a:rect l="0" t="0" r="0" b="0"/>
          <a:pathLst>
            <a:path>
              <a:moveTo>
                <a:pt x="0" y="726"/>
              </a:moveTo>
              <a:lnTo>
                <a:pt x="3455248" y="726"/>
              </a:lnTo>
            </a:path>
          </a:pathLst>
        </a:custGeom>
        <a:noFill/>
        <a:ln w="12700" cap="flat" cmpd="sng" algn="ctr">
          <a:solidFill>
            <a:schemeClr val="dk1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2700" tIns="0" rIns="12700" bIns="0" numCol="1" spcCol="1270" anchor="ctr" anchorCtr="0">
          <a:noAutofit/>
        </a:bodyPr>
        <a:lstStyle/>
        <a:p>
          <a:pPr marL="0" lvl="0" indent="0" algn="ctr" defTabSz="4889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endParaRPr lang="de-DE" sz="1100" kern="1200">
            <a:latin typeface="Times New Roman" panose="02020603050405020304" pitchFamily="18" charset="0"/>
            <a:cs typeface="Times New Roman" panose="02020603050405020304" pitchFamily="18" charset="0"/>
          </a:endParaRPr>
        </a:p>
      </dsp:txBody>
      <dsp:txXfrm>
        <a:off x="-1193953" y="1456334"/>
        <a:ext cx="11763107" cy="172762"/>
      </dsp:txXfrm>
    </dsp:sp>
    <dsp:sp modelId="{963787CF-28FB-43DF-98C2-C462DE3D4B6D}">
      <dsp:nvSpPr>
        <dsp:cNvPr id="0" name=""/>
        <dsp:cNvSpPr/>
      </dsp:nvSpPr>
      <dsp:spPr>
        <a:xfrm>
          <a:off x="6406685" y="1626374"/>
          <a:ext cx="1614786" cy="175785"/>
        </a:xfrm>
        <a:prstGeom prst="roundRect">
          <a:avLst>
            <a:gd name="adj" fmla="val 10000"/>
          </a:avLst>
        </a:prstGeom>
        <a:solidFill>
          <a:schemeClr val="lt1"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dk1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6985" tIns="6985" rIns="6985" bIns="6985" numCol="1" spcCol="1270" anchor="ctr" anchorCtr="0">
          <a:noAutofit/>
        </a:bodyPr>
        <a:lstStyle/>
        <a:p>
          <a:pPr marL="0" lvl="0" indent="0" algn="ctr" defTabSz="466725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de-DE" sz="1050" kern="1200">
              <a:latin typeface="Times New Roman" panose="02020603050405020304" pitchFamily="18" charset="0"/>
              <a:cs typeface="Times New Roman" panose="02020603050405020304" pitchFamily="18" charset="0"/>
            </a:rPr>
            <a:t>Schutz vor Übertragung</a:t>
          </a:r>
        </a:p>
      </dsp:txBody>
      <dsp:txXfrm>
        <a:off x="6411834" y="1631523"/>
        <a:ext cx="1604488" cy="165487"/>
      </dsp:txXfrm>
    </dsp:sp>
    <dsp:sp modelId="{52995CFF-A2C0-41A9-B8F6-E167247A0F1E}">
      <dsp:nvSpPr>
        <dsp:cNvPr id="0" name=""/>
        <dsp:cNvSpPr/>
      </dsp:nvSpPr>
      <dsp:spPr>
        <a:xfrm rot="549328">
          <a:off x="2946329" y="1647523"/>
          <a:ext cx="3482865" cy="1453"/>
        </a:xfrm>
        <a:custGeom>
          <a:avLst/>
          <a:gdLst/>
          <a:ahLst/>
          <a:cxnLst/>
          <a:rect l="0" t="0" r="0" b="0"/>
          <a:pathLst>
            <a:path>
              <a:moveTo>
                <a:pt x="0" y="726"/>
              </a:moveTo>
              <a:lnTo>
                <a:pt x="3482865" y="726"/>
              </a:lnTo>
            </a:path>
          </a:pathLst>
        </a:custGeom>
        <a:noFill/>
        <a:ln w="12700" cap="flat" cmpd="sng" algn="ctr">
          <a:solidFill>
            <a:schemeClr val="dk1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2700" tIns="0" rIns="12700" bIns="0" numCol="1" spcCol="1270" anchor="ctr" anchorCtr="0">
          <a:noAutofit/>
        </a:bodyPr>
        <a:lstStyle/>
        <a:p>
          <a:pPr marL="0" lvl="0" indent="0" algn="ctr" defTabSz="4889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endParaRPr lang="de-DE" sz="1100" kern="1200">
            <a:latin typeface="Times New Roman" panose="02020603050405020304" pitchFamily="18" charset="0"/>
            <a:cs typeface="Times New Roman" panose="02020603050405020304" pitchFamily="18" charset="0"/>
          </a:endParaRPr>
        </a:p>
      </dsp:txBody>
      <dsp:txXfrm>
        <a:off x="-1193791" y="1561178"/>
        <a:ext cx="11763107" cy="174143"/>
      </dsp:txXfrm>
    </dsp:sp>
    <dsp:sp modelId="{15869452-7DB1-4E38-961A-AD18E7BF97A4}">
      <dsp:nvSpPr>
        <dsp:cNvPr id="0" name=""/>
        <dsp:cNvSpPr/>
      </dsp:nvSpPr>
      <dsp:spPr>
        <a:xfrm>
          <a:off x="6407009" y="1837443"/>
          <a:ext cx="1614786" cy="175785"/>
        </a:xfrm>
        <a:prstGeom prst="roundRect">
          <a:avLst>
            <a:gd name="adj" fmla="val 10000"/>
          </a:avLst>
        </a:prstGeom>
        <a:solidFill>
          <a:schemeClr val="lt1"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dk1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6985" tIns="6985" rIns="6985" bIns="6985" numCol="1" spcCol="1270" anchor="ctr" anchorCtr="0">
          <a:noAutofit/>
        </a:bodyPr>
        <a:lstStyle/>
        <a:p>
          <a:pPr marL="0" lvl="0" indent="0" algn="ctr" defTabSz="466725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de-DE" sz="1050" kern="1200">
              <a:latin typeface="Times New Roman" panose="02020603050405020304" pitchFamily="18" charset="0"/>
              <a:cs typeface="Times New Roman" panose="02020603050405020304" pitchFamily="18" charset="0"/>
            </a:rPr>
            <a:t>Risiken</a:t>
          </a:r>
        </a:p>
      </dsp:txBody>
      <dsp:txXfrm>
        <a:off x="6412158" y="1842592"/>
        <a:ext cx="1604488" cy="165487"/>
      </dsp:txXfrm>
    </dsp:sp>
    <dsp:sp modelId="{6DE65224-3B60-4229-ACDA-981AA44CA426}">
      <dsp:nvSpPr>
        <dsp:cNvPr id="0" name=""/>
        <dsp:cNvSpPr/>
      </dsp:nvSpPr>
      <dsp:spPr>
        <a:xfrm rot="19773266">
          <a:off x="7945479" y="1644158"/>
          <a:ext cx="1106928" cy="1453"/>
        </a:xfrm>
        <a:custGeom>
          <a:avLst/>
          <a:gdLst/>
          <a:ahLst/>
          <a:cxnLst/>
          <a:rect l="0" t="0" r="0" b="0"/>
          <a:pathLst>
            <a:path>
              <a:moveTo>
                <a:pt x="0" y="726"/>
              </a:moveTo>
              <a:lnTo>
                <a:pt x="1106928" y="726"/>
              </a:lnTo>
            </a:path>
          </a:pathLst>
        </a:custGeom>
        <a:noFill/>
        <a:ln w="12700" cap="flat" cmpd="sng" algn="ctr">
          <a:solidFill>
            <a:schemeClr val="dk1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2700" tIns="0" rIns="12700" bIns="0" numCol="1" spcCol="1270" anchor="ctr" anchorCtr="0">
          <a:noAutofit/>
        </a:bodyPr>
        <a:lstStyle/>
        <a:p>
          <a:pPr marL="0" lvl="0" indent="0" algn="ctr" defTabSz="4889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endParaRPr lang="de-DE" sz="1100" kern="1200">
            <a:latin typeface="Times New Roman" panose="02020603050405020304" pitchFamily="18" charset="0"/>
            <a:cs typeface="Times New Roman" panose="02020603050405020304" pitchFamily="18" charset="0"/>
          </a:endParaRPr>
        </a:p>
      </dsp:txBody>
      <dsp:txXfrm>
        <a:off x="2617390" y="1617212"/>
        <a:ext cx="11763107" cy="55346"/>
      </dsp:txXfrm>
    </dsp:sp>
    <dsp:sp modelId="{D2E49161-A7B6-4759-AC1C-493631AA99EA}">
      <dsp:nvSpPr>
        <dsp:cNvPr id="0" name=""/>
        <dsp:cNvSpPr/>
      </dsp:nvSpPr>
      <dsp:spPr>
        <a:xfrm>
          <a:off x="8976091" y="1276440"/>
          <a:ext cx="1613210" cy="175987"/>
        </a:xfrm>
        <a:prstGeom prst="roundRect">
          <a:avLst>
            <a:gd name="adj" fmla="val 10000"/>
          </a:avLst>
        </a:prstGeom>
        <a:solidFill>
          <a:schemeClr val="lt1"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dk1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6985" tIns="6985" rIns="6985" bIns="6985" numCol="1" spcCol="1270" anchor="ctr" anchorCtr="0">
          <a:noAutofit/>
        </a:bodyPr>
        <a:lstStyle/>
        <a:p>
          <a:pPr marL="0" lvl="0" indent="0" algn="ctr" defTabSz="466725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de-DE" sz="1050" kern="1200">
              <a:latin typeface="Times New Roman" panose="02020603050405020304" pitchFamily="18" charset="0"/>
              <a:cs typeface="Times New Roman" panose="02020603050405020304" pitchFamily="18" charset="0"/>
            </a:rPr>
            <a:t>Grundlegende Bedingungen</a:t>
          </a:r>
        </a:p>
      </dsp:txBody>
      <dsp:txXfrm>
        <a:off x="8981245" y="1281594"/>
        <a:ext cx="1602902" cy="165679"/>
      </dsp:txXfrm>
    </dsp:sp>
    <dsp:sp modelId="{D3655785-2D54-4F59-9234-66AFAA7E681A}">
      <dsp:nvSpPr>
        <dsp:cNvPr id="0" name=""/>
        <dsp:cNvSpPr/>
      </dsp:nvSpPr>
      <dsp:spPr>
        <a:xfrm rot="20409275">
          <a:off x="7991670" y="1752398"/>
          <a:ext cx="1014547" cy="1453"/>
        </a:xfrm>
        <a:custGeom>
          <a:avLst/>
          <a:gdLst/>
          <a:ahLst/>
          <a:cxnLst/>
          <a:rect l="0" t="0" r="0" b="0"/>
          <a:pathLst>
            <a:path>
              <a:moveTo>
                <a:pt x="0" y="726"/>
              </a:moveTo>
              <a:lnTo>
                <a:pt x="1014547" y="726"/>
              </a:lnTo>
            </a:path>
          </a:pathLst>
        </a:custGeom>
        <a:noFill/>
        <a:ln w="12700" cap="flat" cmpd="sng" algn="ctr">
          <a:solidFill>
            <a:schemeClr val="dk1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2700" tIns="0" rIns="12700" bIns="0" numCol="1" spcCol="1270" anchor="ctr" anchorCtr="0">
          <a:noAutofit/>
        </a:bodyPr>
        <a:lstStyle/>
        <a:p>
          <a:pPr marL="0" lvl="0" indent="0" algn="ctr" defTabSz="4889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endParaRPr lang="de-DE" sz="1100" kern="1200">
            <a:latin typeface="Times New Roman" panose="02020603050405020304" pitchFamily="18" charset="0"/>
            <a:cs typeface="Times New Roman" panose="02020603050405020304" pitchFamily="18" charset="0"/>
          </a:endParaRPr>
        </a:p>
      </dsp:txBody>
      <dsp:txXfrm>
        <a:off x="2617390" y="1727761"/>
        <a:ext cx="11763107" cy="50727"/>
      </dsp:txXfrm>
    </dsp:sp>
    <dsp:sp modelId="{A26EDAF6-44C8-4854-8F91-1F5749D4DC73}">
      <dsp:nvSpPr>
        <dsp:cNvPr id="0" name=""/>
        <dsp:cNvSpPr/>
      </dsp:nvSpPr>
      <dsp:spPr>
        <a:xfrm>
          <a:off x="8976091" y="1492920"/>
          <a:ext cx="1613210" cy="175987"/>
        </a:xfrm>
        <a:prstGeom prst="roundRect">
          <a:avLst>
            <a:gd name="adj" fmla="val 10000"/>
          </a:avLst>
        </a:prstGeom>
        <a:solidFill>
          <a:schemeClr val="lt1"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dk1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6985" tIns="6985" rIns="6985" bIns="6985" numCol="1" spcCol="1270" anchor="ctr" anchorCtr="0">
          <a:noAutofit/>
        </a:bodyPr>
        <a:lstStyle/>
        <a:p>
          <a:pPr marL="0" lvl="0" indent="0" algn="ctr" defTabSz="466725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de-DE" sz="1050" kern="1200">
              <a:latin typeface="Times New Roman" panose="02020603050405020304" pitchFamily="18" charset="0"/>
              <a:cs typeface="Times New Roman" panose="02020603050405020304" pitchFamily="18" charset="0"/>
            </a:rPr>
            <a:t>Alter</a:t>
          </a:r>
        </a:p>
      </dsp:txBody>
      <dsp:txXfrm>
        <a:off x="8981245" y="1498074"/>
        <a:ext cx="1602902" cy="165679"/>
      </dsp:txXfrm>
    </dsp:sp>
    <dsp:sp modelId="{FB2F6D88-F506-4847-B326-8EC15F62040F}">
      <dsp:nvSpPr>
        <dsp:cNvPr id="0" name=""/>
        <dsp:cNvSpPr/>
      </dsp:nvSpPr>
      <dsp:spPr>
        <a:xfrm rot="21122464">
          <a:off x="8017155" y="1857899"/>
          <a:ext cx="963576" cy="1453"/>
        </a:xfrm>
        <a:custGeom>
          <a:avLst/>
          <a:gdLst/>
          <a:ahLst/>
          <a:cxnLst/>
          <a:rect l="0" t="0" r="0" b="0"/>
          <a:pathLst>
            <a:path>
              <a:moveTo>
                <a:pt x="0" y="726"/>
              </a:moveTo>
              <a:lnTo>
                <a:pt x="963576" y="726"/>
              </a:lnTo>
            </a:path>
          </a:pathLst>
        </a:custGeom>
        <a:noFill/>
        <a:ln w="12700" cap="flat" cmpd="sng" algn="ctr">
          <a:solidFill>
            <a:schemeClr val="dk1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2700" tIns="0" rIns="12700" bIns="0" numCol="1" spcCol="1270" anchor="ctr" anchorCtr="0">
          <a:noAutofit/>
        </a:bodyPr>
        <a:lstStyle/>
        <a:p>
          <a:pPr marL="0" lvl="0" indent="0" algn="ctr" defTabSz="4889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endParaRPr lang="de-DE" sz="1100" kern="1200">
            <a:latin typeface="Times New Roman" panose="02020603050405020304" pitchFamily="18" charset="0"/>
            <a:cs typeface="Times New Roman" panose="02020603050405020304" pitchFamily="18" charset="0"/>
          </a:endParaRPr>
        </a:p>
      </dsp:txBody>
      <dsp:txXfrm>
        <a:off x="2617390" y="1834537"/>
        <a:ext cx="11763107" cy="48178"/>
      </dsp:txXfrm>
    </dsp:sp>
    <dsp:sp modelId="{4364814E-1DC4-41D8-96F5-7FCAA16DA2B0}">
      <dsp:nvSpPr>
        <dsp:cNvPr id="0" name=""/>
        <dsp:cNvSpPr/>
      </dsp:nvSpPr>
      <dsp:spPr>
        <a:xfrm>
          <a:off x="8976091" y="1703922"/>
          <a:ext cx="1613210" cy="175987"/>
        </a:xfrm>
        <a:prstGeom prst="roundRect">
          <a:avLst>
            <a:gd name="adj" fmla="val 10000"/>
          </a:avLst>
        </a:prstGeom>
        <a:solidFill>
          <a:schemeClr val="lt1"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dk1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6985" tIns="6985" rIns="6985" bIns="6985" numCol="1" spcCol="1270" anchor="ctr" anchorCtr="0">
          <a:noAutofit/>
        </a:bodyPr>
        <a:lstStyle/>
        <a:p>
          <a:pPr marL="0" lvl="0" indent="0" algn="ctr" defTabSz="466725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de-DE" sz="1050" kern="1200">
              <a:latin typeface="Times New Roman" panose="02020603050405020304" pitchFamily="18" charset="0"/>
              <a:cs typeface="Times New Roman" panose="02020603050405020304" pitchFamily="18" charset="0"/>
            </a:rPr>
            <a:t>Geschlecht</a:t>
          </a:r>
        </a:p>
      </dsp:txBody>
      <dsp:txXfrm>
        <a:off x="8981245" y="1709076"/>
        <a:ext cx="1602902" cy="165679"/>
      </dsp:txXfrm>
    </dsp:sp>
    <dsp:sp modelId="{5BC2E700-F976-45E3-88A6-547D0BC5C286}">
      <dsp:nvSpPr>
        <dsp:cNvPr id="0" name=""/>
        <dsp:cNvSpPr/>
      </dsp:nvSpPr>
      <dsp:spPr>
        <a:xfrm rot="302647">
          <a:off x="8019941" y="1966724"/>
          <a:ext cx="958005" cy="1453"/>
        </a:xfrm>
        <a:custGeom>
          <a:avLst/>
          <a:gdLst/>
          <a:ahLst/>
          <a:cxnLst/>
          <a:rect l="0" t="0" r="0" b="0"/>
          <a:pathLst>
            <a:path>
              <a:moveTo>
                <a:pt x="0" y="726"/>
              </a:moveTo>
              <a:lnTo>
                <a:pt x="958005" y="726"/>
              </a:lnTo>
            </a:path>
          </a:pathLst>
        </a:custGeom>
        <a:noFill/>
        <a:ln w="12700" cap="flat" cmpd="sng" algn="ctr">
          <a:solidFill>
            <a:schemeClr val="dk1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2700" tIns="0" rIns="12700" bIns="0" numCol="1" spcCol="1270" anchor="ctr" anchorCtr="0">
          <a:noAutofit/>
        </a:bodyPr>
        <a:lstStyle/>
        <a:p>
          <a:pPr marL="0" lvl="0" indent="0" algn="ctr" defTabSz="4889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endParaRPr lang="de-DE" sz="1100" kern="1200">
            <a:latin typeface="Times New Roman" panose="02020603050405020304" pitchFamily="18" charset="0"/>
            <a:cs typeface="Times New Roman" panose="02020603050405020304" pitchFamily="18" charset="0"/>
          </a:endParaRPr>
        </a:p>
      </dsp:txBody>
      <dsp:txXfrm>
        <a:off x="2617390" y="1943501"/>
        <a:ext cx="11763107" cy="47900"/>
      </dsp:txXfrm>
    </dsp:sp>
    <dsp:sp modelId="{677DE54C-6078-40B3-9FE8-CF37F7EF3F0C}">
      <dsp:nvSpPr>
        <dsp:cNvPr id="0" name=""/>
        <dsp:cNvSpPr/>
      </dsp:nvSpPr>
      <dsp:spPr>
        <a:xfrm>
          <a:off x="8976091" y="1921573"/>
          <a:ext cx="1613210" cy="175986"/>
        </a:xfrm>
        <a:prstGeom prst="roundRect">
          <a:avLst>
            <a:gd name="adj" fmla="val 10000"/>
          </a:avLst>
        </a:prstGeom>
        <a:solidFill>
          <a:schemeClr val="lt1"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dk1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6985" tIns="6985" rIns="6985" bIns="6985" numCol="1" spcCol="1270" anchor="ctr" anchorCtr="0">
          <a:noAutofit/>
        </a:bodyPr>
        <a:lstStyle/>
        <a:p>
          <a:pPr marL="0" lvl="0" indent="0" algn="ctr" defTabSz="466725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de-DE" sz="1050" kern="1200">
              <a:latin typeface="Times New Roman" panose="02020603050405020304" pitchFamily="18" charset="0"/>
              <a:cs typeface="Times New Roman" panose="02020603050405020304" pitchFamily="18" charset="0"/>
            </a:rPr>
            <a:t>Vulnerable Gruppen</a:t>
          </a:r>
        </a:p>
      </dsp:txBody>
      <dsp:txXfrm>
        <a:off x="8981245" y="1926727"/>
        <a:ext cx="1602902" cy="165678"/>
      </dsp:txXfrm>
    </dsp:sp>
    <dsp:sp modelId="{007AF09B-7B63-4C84-BFB2-EF40ED79070D}">
      <dsp:nvSpPr>
        <dsp:cNvPr id="0" name=""/>
        <dsp:cNvSpPr/>
      </dsp:nvSpPr>
      <dsp:spPr>
        <a:xfrm rot="1026232">
          <a:off x="7999717" y="2071434"/>
          <a:ext cx="998453" cy="1453"/>
        </a:xfrm>
        <a:custGeom>
          <a:avLst/>
          <a:gdLst/>
          <a:ahLst/>
          <a:cxnLst/>
          <a:rect l="0" t="0" r="0" b="0"/>
          <a:pathLst>
            <a:path>
              <a:moveTo>
                <a:pt x="0" y="726"/>
              </a:moveTo>
              <a:lnTo>
                <a:pt x="998453" y="726"/>
              </a:lnTo>
            </a:path>
          </a:pathLst>
        </a:custGeom>
        <a:noFill/>
        <a:ln w="12700" cap="flat" cmpd="sng" algn="ctr">
          <a:solidFill>
            <a:schemeClr val="dk1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2700" tIns="0" rIns="12700" bIns="0" numCol="1" spcCol="1270" anchor="ctr" anchorCtr="0">
          <a:noAutofit/>
        </a:bodyPr>
        <a:lstStyle/>
        <a:p>
          <a:pPr marL="0" lvl="0" indent="0" algn="ctr" defTabSz="3556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endParaRPr lang="de-DE" sz="800" kern="1200">
            <a:latin typeface="Times New Roman" panose="02020603050405020304" pitchFamily="18" charset="0"/>
            <a:cs typeface="Times New Roman" panose="02020603050405020304" pitchFamily="18" charset="0"/>
          </a:endParaRPr>
        </a:p>
      </dsp:txBody>
      <dsp:txXfrm>
        <a:off x="2617390" y="2047200"/>
        <a:ext cx="11763107" cy="49922"/>
      </dsp:txXfrm>
    </dsp:sp>
    <dsp:sp modelId="{38194E2B-8C9B-446D-93B0-01D743C0AC69}">
      <dsp:nvSpPr>
        <dsp:cNvPr id="0" name=""/>
        <dsp:cNvSpPr/>
      </dsp:nvSpPr>
      <dsp:spPr>
        <a:xfrm>
          <a:off x="8976091" y="2130992"/>
          <a:ext cx="1613210" cy="175987"/>
        </a:xfrm>
        <a:prstGeom prst="roundRect">
          <a:avLst>
            <a:gd name="adj" fmla="val 10000"/>
          </a:avLst>
        </a:prstGeom>
        <a:solidFill>
          <a:schemeClr val="lt1"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dk1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6985" tIns="6985" rIns="6985" bIns="6985" numCol="1" spcCol="1270" anchor="ctr" anchorCtr="0">
          <a:noAutofit/>
        </a:bodyPr>
        <a:lstStyle/>
        <a:p>
          <a:pPr marL="0" lvl="0" indent="0" algn="ctr" defTabSz="466725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de-DE" sz="1050" kern="1200">
              <a:latin typeface="Times New Roman" panose="02020603050405020304" pitchFamily="18" charset="0"/>
              <a:cs typeface="Times New Roman" panose="02020603050405020304" pitchFamily="18" charset="0"/>
            </a:rPr>
            <a:t>Vulnerable Gemeinschaften</a:t>
          </a:r>
        </a:p>
      </dsp:txBody>
      <dsp:txXfrm>
        <a:off x="8981245" y="2136146"/>
        <a:ext cx="1602902" cy="165679"/>
      </dsp:txXfrm>
    </dsp:sp>
    <dsp:sp modelId="{925EDBFF-3D85-437B-9D22-40DBEB5AB8DA}">
      <dsp:nvSpPr>
        <dsp:cNvPr id="0" name=""/>
        <dsp:cNvSpPr/>
      </dsp:nvSpPr>
      <dsp:spPr>
        <a:xfrm rot="19459140">
          <a:off x="641834" y="2833627"/>
          <a:ext cx="1329232" cy="1455"/>
        </a:xfrm>
        <a:custGeom>
          <a:avLst/>
          <a:gdLst/>
          <a:ahLst/>
          <a:cxnLst/>
          <a:rect l="0" t="0" r="0" b="0"/>
          <a:pathLst>
            <a:path>
              <a:moveTo>
                <a:pt x="0" y="727"/>
              </a:moveTo>
              <a:lnTo>
                <a:pt x="1329232" y="727"/>
              </a:lnTo>
            </a:path>
          </a:pathLst>
        </a:custGeom>
        <a:noFill/>
        <a:ln w="12700" cap="flat" cmpd="sng" algn="ctr">
          <a:solidFill>
            <a:schemeClr val="dk1">
              <a:shade val="6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2700" tIns="0" rIns="12700" bIns="0" numCol="1" spcCol="1270" anchor="ctr" anchorCtr="0">
          <a:noAutofit/>
        </a:bodyPr>
        <a:lstStyle/>
        <a:p>
          <a:pPr marL="0" lvl="0" indent="0" algn="ctr" defTabSz="4889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endParaRPr lang="de-DE" sz="1100" kern="1200">
            <a:latin typeface="Times New Roman" panose="02020603050405020304" pitchFamily="18" charset="0"/>
            <a:cs typeface="Times New Roman" panose="02020603050405020304" pitchFamily="18" charset="0"/>
          </a:endParaRPr>
        </a:p>
      </dsp:txBody>
      <dsp:txXfrm>
        <a:off x="-4575103" y="2801124"/>
        <a:ext cx="11763107" cy="66461"/>
      </dsp:txXfrm>
    </dsp:sp>
    <dsp:sp modelId="{933E68AA-CF10-49A1-ABCC-DA114DDEAF2A}">
      <dsp:nvSpPr>
        <dsp:cNvPr id="0" name=""/>
        <dsp:cNvSpPr/>
      </dsp:nvSpPr>
      <dsp:spPr>
        <a:xfrm>
          <a:off x="1846302" y="2267038"/>
          <a:ext cx="1123774" cy="359328"/>
        </a:xfrm>
        <a:prstGeom prst="roundRect">
          <a:avLst>
            <a:gd name="adj" fmla="val 10000"/>
          </a:avLst>
        </a:prstGeom>
        <a:solidFill>
          <a:schemeClr val="lt1"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dk1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6985" tIns="6985" rIns="6985" bIns="6985" numCol="1" spcCol="1270" anchor="ctr" anchorCtr="0">
          <a:noAutofit/>
        </a:bodyPr>
        <a:lstStyle/>
        <a:p>
          <a:pPr marL="0" lvl="0" indent="0" algn="ctr" defTabSz="466725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de-DE" sz="1050" kern="1200">
              <a:latin typeface="Times New Roman" panose="02020603050405020304" pitchFamily="18" charset="0"/>
              <a:cs typeface="Times New Roman" panose="02020603050405020304" pitchFamily="18" charset="0"/>
            </a:rPr>
            <a:t>Behandlung</a:t>
          </a:r>
        </a:p>
      </dsp:txBody>
      <dsp:txXfrm>
        <a:off x="1856826" y="2277562"/>
        <a:ext cx="1102726" cy="338280"/>
      </dsp:txXfrm>
    </dsp:sp>
    <dsp:sp modelId="{0E872D06-F66B-4811-92EA-E374B25899A2}">
      <dsp:nvSpPr>
        <dsp:cNvPr id="0" name=""/>
        <dsp:cNvSpPr/>
      </dsp:nvSpPr>
      <dsp:spPr>
        <a:xfrm rot="19512346">
          <a:off x="2890496" y="2191988"/>
          <a:ext cx="890196" cy="1455"/>
        </a:xfrm>
        <a:custGeom>
          <a:avLst/>
          <a:gdLst/>
          <a:ahLst/>
          <a:cxnLst/>
          <a:rect l="0" t="0" r="0" b="0"/>
          <a:pathLst>
            <a:path>
              <a:moveTo>
                <a:pt x="0" y="727"/>
              </a:moveTo>
              <a:lnTo>
                <a:pt x="890196" y="727"/>
              </a:lnTo>
            </a:path>
          </a:pathLst>
        </a:custGeom>
        <a:noFill/>
        <a:ln w="12700" cap="flat" cmpd="sng" algn="ctr">
          <a:solidFill>
            <a:schemeClr val="dk1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2700" tIns="0" rIns="12700" bIns="0" numCol="1" spcCol="1270" anchor="ctr" anchorCtr="0">
          <a:noAutofit/>
        </a:bodyPr>
        <a:lstStyle/>
        <a:p>
          <a:pPr marL="0" lvl="0" indent="0" algn="ctr" defTabSz="4889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endParaRPr lang="de-DE" sz="1100" kern="1200">
            <a:latin typeface="Times New Roman" panose="02020603050405020304" pitchFamily="18" charset="0"/>
            <a:cs typeface="Times New Roman" panose="02020603050405020304" pitchFamily="18" charset="0"/>
          </a:endParaRPr>
        </a:p>
      </dsp:txBody>
      <dsp:txXfrm>
        <a:off x="-2545958" y="2170461"/>
        <a:ext cx="11763107" cy="44509"/>
      </dsp:txXfrm>
    </dsp:sp>
    <dsp:sp modelId="{3F552C8C-859A-4030-A503-8872BA917E0A}">
      <dsp:nvSpPr>
        <dsp:cNvPr id="0" name=""/>
        <dsp:cNvSpPr/>
      </dsp:nvSpPr>
      <dsp:spPr>
        <a:xfrm>
          <a:off x="3701112" y="1858691"/>
          <a:ext cx="1580757" cy="160076"/>
        </a:xfrm>
        <a:prstGeom prst="roundRect">
          <a:avLst>
            <a:gd name="adj" fmla="val 10000"/>
          </a:avLst>
        </a:prstGeom>
        <a:solidFill>
          <a:schemeClr val="lt1"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dk1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6985" tIns="6985" rIns="6985" bIns="6985" numCol="1" spcCol="1270" anchor="ctr" anchorCtr="0">
          <a:noAutofit/>
        </a:bodyPr>
        <a:lstStyle/>
        <a:p>
          <a:pPr marL="0" lvl="0" indent="0" algn="ctr" defTabSz="466725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de-DE" sz="1050" kern="1200">
              <a:latin typeface="Times New Roman" panose="02020603050405020304" pitchFamily="18" charset="0"/>
              <a:cs typeface="Times New Roman" panose="02020603050405020304" pitchFamily="18" charset="0"/>
            </a:rPr>
            <a:t>Aktuelle Behandlung</a:t>
          </a:r>
        </a:p>
      </dsp:txBody>
      <dsp:txXfrm>
        <a:off x="3705800" y="1863379"/>
        <a:ext cx="1571381" cy="150700"/>
      </dsp:txXfrm>
    </dsp:sp>
    <dsp:sp modelId="{168B63D6-E582-4001-8D06-4264135971C6}">
      <dsp:nvSpPr>
        <dsp:cNvPr id="0" name=""/>
        <dsp:cNvSpPr/>
      </dsp:nvSpPr>
      <dsp:spPr>
        <a:xfrm rot="20201903">
          <a:off x="2937647" y="2288698"/>
          <a:ext cx="795187" cy="1455"/>
        </a:xfrm>
        <a:custGeom>
          <a:avLst/>
          <a:gdLst/>
          <a:ahLst/>
          <a:cxnLst/>
          <a:rect l="0" t="0" r="0" b="0"/>
          <a:pathLst>
            <a:path>
              <a:moveTo>
                <a:pt x="0" y="727"/>
              </a:moveTo>
              <a:lnTo>
                <a:pt x="795187" y="727"/>
              </a:lnTo>
            </a:path>
          </a:pathLst>
        </a:custGeom>
        <a:noFill/>
        <a:ln w="12700" cap="flat" cmpd="sng" algn="ctr">
          <a:solidFill>
            <a:schemeClr val="dk1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2700" tIns="0" rIns="12700" bIns="0" numCol="1" spcCol="1270" anchor="ctr" anchorCtr="0">
          <a:noAutofit/>
        </a:bodyPr>
        <a:lstStyle/>
        <a:p>
          <a:pPr marL="0" lvl="0" indent="0" algn="ctr" defTabSz="3556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endParaRPr lang="de-DE" sz="800" kern="1200">
            <a:latin typeface="Times New Roman" panose="02020603050405020304" pitchFamily="18" charset="0"/>
            <a:cs typeface="Times New Roman" panose="02020603050405020304" pitchFamily="18" charset="0"/>
          </a:endParaRPr>
        </a:p>
      </dsp:txBody>
      <dsp:txXfrm>
        <a:off x="-2546312" y="2269546"/>
        <a:ext cx="11763107" cy="39759"/>
      </dsp:txXfrm>
    </dsp:sp>
    <dsp:sp modelId="{BF83AAD4-9518-47AA-835D-A40E2C49AF13}">
      <dsp:nvSpPr>
        <dsp:cNvPr id="0" name=""/>
        <dsp:cNvSpPr/>
      </dsp:nvSpPr>
      <dsp:spPr>
        <a:xfrm>
          <a:off x="3700405" y="2052111"/>
          <a:ext cx="1579737" cy="160076"/>
        </a:xfrm>
        <a:prstGeom prst="roundRect">
          <a:avLst>
            <a:gd name="adj" fmla="val 10000"/>
          </a:avLst>
        </a:prstGeom>
        <a:solidFill>
          <a:schemeClr val="lt1"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dk1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6985" tIns="6985" rIns="6985" bIns="6985" numCol="1" spcCol="1270" anchor="ctr" anchorCtr="0">
          <a:noAutofit/>
        </a:bodyPr>
        <a:lstStyle/>
        <a:p>
          <a:pPr marL="0" lvl="0" indent="0" algn="ctr" defTabSz="466725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de-DE" sz="1050" kern="1200">
              <a:latin typeface="Times New Roman" panose="02020603050405020304" pitchFamily="18" charset="0"/>
              <a:cs typeface="Times New Roman" panose="02020603050405020304" pitchFamily="18" charset="0"/>
            </a:rPr>
            <a:t>Impfungen</a:t>
          </a:r>
        </a:p>
      </dsp:txBody>
      <dsp:txXfrm>
        <a:off x="3705093" y="2056799"/>
        <a:ext cx="1570361" cy="150700"/>
      </dsp:txXfrm>
    </dsp:sp>
    <dsp:sp modelId="{12649787-8B1A-4097-B62E-BBC1879F2014}">
      <dsp:nvSpPr>
        <dsp:cNvPr id="0" name=""/>
        <dsp:cNvSpPr/>
      </dsp:nvSpPr>
      <dsp:spPr>
        <a:xfrm rot="21032772">
          <a:off x="2965058" y="2385284"/>
          <a:ext cx="738998" cy="1455"/>
        </a:xfrm>
        <a:custGeom>
          <a:avLst/>
          <a:gdLst/>
          <a:ahLst/>
          <a:cxnLst/>
          <a:rect l="0" t="0" r="0" b="0"/>
          <a:pathLst>
            <a:path>
              <a:moveTo>
                <a:pt x="0" y="727"/>
              </a:moveTo>
              <a:lnTo>
                <a:pt x="738998" y="727"/>
              </a:lnTo>
            </a:path>
          </a:pathLst>
        </a:custGeom>
        <a:noFill/>
        <a:ln w="12700" cap="flat" cmpd="sng" algn="ctr">
          <a:solidFill>
            <a:schemeClr val="dk1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2700" tIns="0" rIns="12700" bIns="0" numCol="1" spcCol="1270" anchor="ctr" anchorCtr="0">
          <a:noAutofit/>
        </a:bodyPr>
        <a:lstStyle/>
        <a:p>
          <a:pPr marL="0" lvl="0" indent="0" algn="ctr" defTabSz="4889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endParaRPr lang="de-DE" sz="1100" kern="1200">
            <a:latin typeface="Times New Roman" panose="02020603050405020304" pitchFamily="18" charset="0"/>
            <a:cs typeface="Times New Roman" panose="02020603050405020304" pitchFamily="18" charset="0"/>
          </a:endParaRPr>
        </a:p>
      </dsp:txBody>
      <dsp:txXfrm>
        <a:off x="-2546995" y="2367536"/>
        <a:ext cx="11763107" cy="36949"/>
      </dsp:txXfrm>
    </dsp:sp>
    <dsp:sp modelId="{D4B8489D-29A0-450D-846E-6780D2436C16}">
      <dsp:nvSpPr>
        <dsp:cNvPr id="0" name=""/>
        <dsp:cNvSpPr/>
      </dsp:nvSpPr>
      <dsp:spPr>
        <a:xfrm>
          <a:off x="3699038" y="2245811"/>
          <a:ext cx="1579737" cy="159018"/>
        </a:xfrm>
        <a:prstGeom prst="roundRect">
          <a:avLst>
            <a:gd name="adj" fmla="val 10000"/>
          </a:avLst>
        </a:prstGeom>
        <a:solidFill>
          <a:schemeClr val="lt1"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dk1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6985" tIns="6985" rIns="6985" bIns="6985" numCol="1" spcCol="1270" anchor="ctr" anchorCtr="0">
          <a:noAutofit/>
        </a:bodyPr>
        <a:lstStyle/>
        <a:p>
          <a:pPr marL="0" lvl="0" indent="0" algn="ctr" defTabSz="466725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de-DE" sz="1050" kern="1200">
              <a:latin typeface="Times New Roman" panose="02020603050405020304" pitchFamily="18" charset="0"/>
              <a:cs typeface="Times New Roman" panose="02020603050405020304" pitchFamily="18" charset="0"/>
            </a:rPr>
            <a:t>Forschung und Entwicklung</a:t>
          </a:r>
        </a:p>
      </dsp:txBody>
      <dsp:txXfrm>
        <a:off x="3703695" y="2250468"/>
        <a:ext cx="1570423" cy="149704"/>
      </dsp:txXfrm>
    </dsp:sp>
    <dsp:sp modelId="{87A49760-64CE-4CBD-BF78-45B22D2A4949}">
      <dsp:nvSpPr>
        <dsp:cNvPr id="0" name=""/>
        <dsp:cNvSpPr/>
      </dsp:nvSpPr>
      <dsp:spPr>
        <a:xfrm rot="784458">
          <a:off x="2960380" y="2530597"/>
          <a:ext cx="748162" cy="1455"/>
        </a:xfrm>
        <a:custGeom>
          <a:avLst/>
          <a:gdLst/>
          <a:ahLst/>
          <a:cxnLst/>
          <a:rect l="0" t="0" r="0" b="0"/>
          <a:pathLst>
            <a:path>
              <a:moveTo>
                <a:pt x="0" y="727"/>
              </a:moveTo>
              <a:lnTo>
                <a:pt x="748162" y="727"/>
              </a:lnTo>
            </a:path>
          </a:pathLst>
        </a:custGeom>
        <a:noFill/>
        <a:ln w="12700" cap="flat" cmpd="sng" algn="ctr">
          <a:solidFill>
            <a:schemeClr val="dk1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2700" tIns="0" rIns="12700" bIns="0" numCol="1" spcCol="1270" anchor="ctr" anchorCtr="0">
          <a:noAutofit/>
        </a:bodyPr>
        <a:lstStyle/>
        <a:p>
          <a:pPr marL="0" lvl="0" indent="0" algn="ctr" defTabSz="4889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endParaRPr lang="de-DE" sz="1100" kern="1200">
            <a:latin typeface="Times New Roman" panose="02020603050405020304" pitchFamily="18" charset="0"/>
            <a:cs typeface="Times New Roman" panose="02020603050405020304" pitchFamily="18" charset="0"/>
          </a:endParaRPr>
        </a:p>
      </dsp:txBody>
      <dsp:txXfrm>
        <a:off x="-2547092" y="2512621"/>
        <a:ext cx="11763107" cy="37408"/>
      </dsp:txXfrm>
    </dsp:sp>
    <dsp:sp modelId="{C50E5B3A-B9FE-43B9-85D2-DC2953853106}">
      <dsp:nvSpPr>
        <dsp:cNvPr id="0" name=""/>
        <dsp:cNvSpPr/>
      </dsp:nvSpPr>
      <dsp:spPr>
        <a:xfrm>
          <a:off x="3698845" y="2441976"/>
          <a:ext cx="1580757" cy="347943"/>
        </a:xfrm>
        <a:prstGeom prst="roundRect">
          <a:avLst>
            <a:gd name="adj" fmla="val 10000"/>
          </a:avLst>
        </a:prstGeom>
        <a:solidFill>
          <a:schemeClr val="lt1"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dk1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6985" tIns="6985" rIns="6985" bIns="6985" numCol="1" spcCol="1270" anchor="ctr" anchorCtr="0">
          <a:noAutofit/>
        </a:bodyPr>
        <a:lstStyle/>
        <a:p>
          <a:pPr marL="0" lvl="0" indent="0" algn="ctr" defTabSz="466725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de-DE" sz="1050" kern="1200">
              <a:latin typeface="Times New Roman" panose="02020603050405020304" pitchFamily="18" charset="0"/>
              <a:cs typeface="Times New Roman" panose="02020603050405020304" pitchFamily="18" charset="0"/>
            </a:rPr>
            <a:t>Ungeprüfte Behandlungsweisen</a:t>
          </a:r>
        </a:p>
      </dsp:txBody>
      <dsp:txXfrm>
        <a:off x="3709036" y="2452167"/>
        <a:ext cx="1560375" cy="327561"/>
      </dsp:txXfrm>
    </dsp:sp>
    <dsp:sp modelId="{FC687F4F-95AF-4388-A390-2F0E64666848}">
      <dsp:nvSpPr>
        <dsp:cNvPr id="0" name=""/>
        <dsp:cNvSpPr/>
      </dsp:nvSpPr>
      <dsp:spPr>
        <a:xfrm rot="2019940">
          <a:off x="2896583" y="2688896"/>
          <a:ext cx="876423" cy="1455"/>
        </a:xfrm>
        <a:custGeom>
          <a:avLst/>
          <a:gdLst/>
          <a:ahLst/>
          <a:cxnLst/>
          <a:rect l="0" t="0" r="0" b="0"/>
          <a:pathLst>
            <a:path>
              <a:moveTo>
                <a:pt x="0" y="727"/>
              </a:moveTo>
              <a:lnTo>
                <a:pt x="876423" y="727"/>
              </a:lnTo>
            </a:path>
          </a:pathLst>
        </a:custGeom>
        <a:noFill/>
        <a:ln w="12700" cap="flat" cmpd="sng" algn="ctr">
          <a:solidFill>
            <a:schemeClr val="dk1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2700" tIns="0" rIns="12700" bIns="0" numCol="1" spcCol="1270" anchor="ctr" anchorCtr="0">
          <a:noAutofit/>
        </a:bodyPr>
        <a:lstStyle/>
        <a:p>
          <a:pPr marL="0" lvl="0" indent="0" algn="ctr" defTabSz="4889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endParaRPr lang="de-DE" sz="1100" kern="1200">
            <a:latin typeface="Times New Roman" panose="02020603050405020304" pitchFamily="18" charset="0"/>
            <a:cs typeface="Times New Roman" panose="02020603050405020304" pitchFamily="18" charset="0"/>
          </a:endParaRPr>
        </a:p>
      </dsp:txBody>
      <dsp:txXfrm>
        <a:off x="-2546758" y="2667713"/>
        <a:ext cx="11763107" cy="43821"/>
      </dsp:txXfrm>
    </dsp:sp>
    <dsp:sp modelId="{D7C3B540-AAE3-47B6-8689-6F42331FBB0D}">
      <dsp:nvSpPr>
        <dsp:cNvPr id="0" name=""/>
        <dsp:cNvSpPr/>
      </dsp:nvSpPr>
      <dsp:spPr>
        <a:xfrm>
          <a:off x="3699512" y="2837667"/>
          <a:ext cx="1579736" cy="189753"/>
        </a:xfrm>
        <a:prstGeom prst="roundRect">
          <a:avLst>
            <a:gd name="adj" fmla="val 10000"/>
          </a:avLst>
        </a:prstGeom>
        <a:solidFill>
          <a:schemeClr val="lt1"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dk1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6985" tIns="6985" rIns="6985" bIns="6985" numCol="1" spcCol="1270" anchor="ctr" anchorCtr="0">
          <a:noAutofit/>
        </a:bodyPr>
        <a:lstStyle/>
        <a:p>
          <a:pPr marL="0" lvl="0" indent="0" algn="ctr" defTabSz="466725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de-DE" sz="1050" kern="1200">
              <a:latin typeface="Times New Roman" panose="02020603050405020304" pitchFamily="18" charset="0"/>
              <a:cs typeface="Times New Roman" panose="02020603050405020304" pitchFamily="18" charset="0"/>
            </a:rPr>
            <a:t>Mythen</a:t>
          </a:r>
        </a:p>
      </dsp:txBody>
      <dsp:txXfrm>
        <a:off x="3705070" y="2843225"/>
        <a:ext cx="1568620" cy="178637"/>
      </dsp:txXfrm>
    </dsp:sp>
    <dsp:sp modelId="{91683DB7-5821-4F63-939D-8271AEDB1AC2}">
      <dsp:nvSpPr>
        <dsp:cNvPr id="0" name=""/>
        <dsp:cNvSpPr/>
      </dsp:nvSpPr>
      <dsp:spPr>
        <a:xfrm rot="2596234">
          <a:off x="565094" y="3729304"/>
          <a:ext cx="1482324" cy="1455"/>
        </a:xfrm>
        <a:custGeom>
          <a:avLst/>
          <a:gdLst/>
          <a:ahLst/>
          <a:cxnLst/>
          <a:rect l="0" t="0" r="0" b="0"/>
          <a:pathLst>
            <a:path>
              <a:moveTo>
                <a:pt x="0" y="727"/>
              </a:moveTo>
              <a:lnTo>
                <a:pt x="1482324" y="727"/>
              </a:lnTo>
            </a:path>
          </a:pathLst>
        </a:custGeom>
        <a:noFill/>
        <a:ln w="12700" cap="flat" cmpd="sng" algn="ctr">
          <a:solidFill>
            <a:schemeClr val="dk1">
              <a:shade val="6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2700" tIns="0" rIns="12700" bIns="0" numCol="1" spcCol="1270" anchor="ctr" anchorCtr="0">
          <a:noAutofit/>
        </a:bodyPr>
        <a:lstStyle/>
        <a:p>
          <a:pPr marL="0" lvl="0" indent="0" algn="ctr" defTabSz="4889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endParaRPr lang="de-DE" sz="1100" kern="1200">
            <a:latin typeface="Times New Roman" panose="02020603050405020304" pitchFamily="18" charset="0"/>
            <a:cs typeface="Times New Roman" panose="02020603050405020304" pitchFamily="18" charset="0"/>
          </a:endParaRPr>
        </a:p>
      </dsp:txBody>
      <dsp:txXfrm>
        <a:off x="-4575296" y="3692974"/>
        <a:ext cx="11763107" cy="74116"/>
      </dsp:txXfrm>
    </dsp:sp>
    <dsp:sp modelId="{DDCB18A7-5217-498E-8109-AEC8891AEF63}">
      <dsp:nvSpPr>
        <dsp:cNvPr id="0" name=""/>
        <dsp:cNvSpPr/>
      </dsp:nvSpPr>
      <dsp:spPr>
        <a:xfrm>
          <a:off x="1845915" y="4022057"/>
          <a:ext cx="1123774" cy="432000"/>
        </a:xfrm>
        <a:prstGeom prst="roundRect">
          <a:avLst>
            <a:gd name="adj" fmla="val 10000"/>
          </a:avLst>
        </a:prstGeom>
        <a:solidFill>
          <a:schemeClr val="lt1"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dk1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6985" tIns="6985" rIns="6985" bIns="6985" numCol="1" spcCol="1270" anchor="ctr" anchorCtr="0">
          <a:noAutofit/>
        </a:bodyPr>
        <a:lstStyle/>
        <a:p>
          <a:pPr marL="0" lvl="0" indent="0" algn="ctr" defTabSz="466725">
            <a:lnSpc>
              <a:spcPct val="10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de-DE" sz="1050" kern="1200">
              <a:latin typeface="Times New Roman" panose="02020603050405020304" pitchFamily="18" charset="0"/>
              <a:cs typeface="Times New Roman" panose="02020603050405020304" pitchFamily="18" charset="0"/>
            </a:rPr>
            <a:t>Interventionen/</a:t>
          </a:r>
        </a:p>
        <a:p>
          <a:pPr marL="0" lvl="0" indent="0" algn="ctr" defTabSz="466725">
            <a:lnSpc>
              <a:spcPct val="10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de-DE" sz="1050" kern="1200">
              <a:latin typeface="Times New Roman" panose="02020603050405020304" pitchFamily="18" charset="0"/>
              <a:cs typeface="Times New Roman" panose="02020603050405020304" pitchFamily="18" charset="0"/>
            </a:rPr>
            <a:t>Maßnahmen</a:t>
          </a:r>
        </a:p>
      </dsp:txBody>
      <dsp:txXfrm>
        <a:off x="1858568" y="4034710"/>
        <a:ext cx="1098468" cy="406694"/>
      </dsp:txXfrm>
    </dsp:sp>
    <dsp:sp modelId="{87C9AC31-CDDE-4E1F-B79F-69064C460489}">
      <dsp:nvSpPr>
        <dsp:cNvPr id="0" name=""/>
        <dsp:cNvSpPr/>
      </dsp:nvSpPr>
      <dsp:spPr>
        <a:xfrm rot="20120903">
          <a:off x="2797496" y="3449282"/>
          <a:ext cx="3778699" cy="1455"/>
        </a:xfrm>
        <a:custGeom>
          <a:avLst/>
          <a:gdLst/>
          <a:ahLst/>
          <a:cxnLst/>
          <a:rect l="0" t="0" r="0" b="0"/>
          <a:pathLst>
            <a:path>
              <a:moveTo>
                <a:pt x="0" y="727"/>
              </a:moveTo>
              <a:lnTo>
                <a:pt x="3778699" y="727"/>
              </a:lnTo>
            </a:path>
          </a:pathLst>
        </a:custGeom>
        <a:noFill/>
        <a:ln w="12700" cap="flat" cmpd="sng" algn="ctr">
          <a:solidFill>
            <a:schemeClr val="dk1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2700" tIns="0" rIns="12700" bIns="0" numCol="1" spcCol="1270" anchor="ctr" anchorCtr="0">
          <a:noAutofit/>
        </a:bodyPr>
        <a:lstStyle/>
        <a:p>
          <a:pPr marL="0" lvl="0" indent="0" algn="ctr" defTabSz="4889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endParaRPr lang="de-DE" sz="1100" kern="1200">
            <a:latin typeface="Times New Roman" panose="02020603050405020304" pitchFamily="18" charset="0"/>
            <a:cs typeface="Times New Roman" panose="02020603050405020304" pitchFamily="18" charset="0"/>
          </a:endParaRPr>
        </a:p>
      </dsp:txBody>
      <dsp:txXfrm>
        <a:off x="-1194707" y="3355543"/>
        <a:ext cx="11763107" cy="188934"/>
      </dsp:txXfrm>
    </dsp:sp>
    <dsp:sp modelId="{BD9D8B61-1FCA-4DBF-95E6-59B9130798B9}">
      <dsp:nvSpPr>
        <dsp:cNvPr id="0" name=""/>
        <dsp:cNvSpPr/>
      </dsp:nvSpPr>
      <dsp:spPr>
        <a:xfrm>
          <a:off x="6404001" y="2574682"/>
          <a:ext cx="1605865" cy="174561"/>
        </a:xfrm>
        <a:prstGeom prst="roundRect">
          <a:avLst>
            <a:gd name="adj" fmla="val 10000"/>
          </a:avLst>
        </a:prstGeom>
        <a:solidFill>
          <a:schemeClr val="lt1"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dk1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6985" tIns="6985" rIns="6985" bIns="6985" numCol="1" spcCol="1270" anchor="ctr" anchorCtr="0">
          <a:noAutofit/>
        </a:bodyPr>
        <a:lstStyle/>
        <a:p>
          <a:pPr marL="0" lvl="0" indent="0" algn="ctr" defTabSz="466725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de-DE" sz="1050" kern="1200">
              <a:latin typeface="Times New Roman" panose="02020603050405020304" pitchFamily="18" charset="0"/>
              <a:cs typeface="Times New Roman" panose="02020603050405020304" pitchFamily="18" charset="0"/>
            </a:rPr>
            <a:t>Tests</a:t>
          </a:r>
        </a:p>
      </dsp:txBody>
      <dsp:txXfrm>
        <a:off x="6409114" y="2579795"/>
        <a:ext cx="1595639" cy="164335"/>
      </dsp:txXfrm>
    </dsp:sp>
    <dsp:sp modelId="{56FAFC49-D0EA-4E25-8D48-7123A498BD9B}">
      <dsp:nvSpPr>
        <dsp:cNvPr id="0" name=""/>
        <dsp:cNvSpPr/>
      </dsp:nvSpPr>
      <dsp:spPr>
        <a:xfrm rot="20296754">
          <a:off x="2838189" y="3551907"/>
          <a:ext cx="3704153" cy="1455"/>
        </a:xfrm>
        <a:custGeom>
          <a:avLst/>
          <a:gdLst/>
          <a:ahLst/>
          <a:cxnLst/>
          <a:rect l="0" t="0" r="0" b="0"/>
          <a:pathLst>
            <a:path>
              <a:moveTo>
                <a:pt x="0" y="727"/>
              </a:moveTo>
              <a:lnTo>
                <a:pt x="3704153" y="727"/>
              </a:lnTo>
            </a:path>
          </a:pathLst>
        </a:custGeom>
        <a:noFill/>
        <a:ln w="12700" cap="flat" cmpd="sng" algn="ctr">
          <a:solidFill>
            <a:schemeClr val="dk1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2700" tIns="0" rIns="12700" bIns="0" numCol="1" spcCol="1270" anchor="ctr" anchorCtr="0">
          <a:noAutofit/>
        </a:bodyPr>
        <a:lstStyle/>
        <a:p>
          <a:pPr marL="0" lvl="0" indent="0" algn="ctr" defTabSz="4889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endParaRPr lang="de-DE" sz="1100" kern="1200">
            <a:latin typeface="Times New Roman" panose="02020603050405020304" pitchFamily="18" charset="0"/>
            <a:cs typeface="Times New Roman" panose="02020603050405020304" pitchFamily="18" charset="0"/>
          </a:endParaRPr>
        </a:p>
      </dsp:txBody>
      <dsp:txXfrm>
        <a:off x="-1191286" y="3460030"/>
        <a:ext cx="11763107" cy="185207"/>
      </dsp:txXfrm>
    </dsp:sp>
    <dsp:sp modelId="{E730F18F-48B0-4E0B-9A8D-D539E63CE9D4}">
      <dsp:nvSpPr>
        <dsp:cNvPr id="0" name=""/>
        <dsp:cNvSpPr/>
      </dsp:nvSpPr>
      <dsp:spPr>
        <a:xfrm>
          <a:off x="6410843" y="2779930"/>
          <a:ext cx="1605865" cy="174561"/>
        </a:xfrm>
        <a:prstGeom prst="roundRect">
          <a:avLst>
            <a:gd name="adj" fmla="val 10000"/>
          </a:avLst>
        </a:prstGeom>
        <a:solidFill>
          <a:schemeClr val="lt1"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dk1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6985" tIns="6985" rIns="6985" bIns="6985" numCol="1" spcCol="1270" anchor="ctr" anchorCtr="0">
          <a:noAutofit/>
        </a:bodyPr>
        <a:lstStyle/>
        <a:p>
          <a:pPr marL="0" lvl="0" indent="0" algn="ctr" defTabSz="466725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de-DE" sz="1050" kern="1200">
              <a:latin typeface="Times New Roman" panose="02020603050405020304" pitchFamily="18" charset="0"/>
              <a:cs typeface="Times New Roman" panose="02020603050405020304" pitchFamily="18" charset="0"/>
            </a:rPr>
            <a:t>Unterstützende Maßnahmen</a:t>
          </a:r>
        </a:p>
      </dsp:txBody>
      <dsp:txXfrm>
        <a:off x="6415956" y="2785043"/>
        <a:ext cx="1595639" cy="164335"/>
      </dsp:txXfrm>
    </dsp:sp>
    <dsp:sp modelId="{04B5A4E1-0824-444B-B0DF-49A3641E7799}">
      <dsp:nvSpPr>
        <dsp:cNvPr id="0" name=""/>
        <dsp:cNvSpPr/>
      </dsp:nvSpPr>
      <dsp:spPr>
        <a:xfrm rot="20912378">
          <a:off x="8006869" y="2768427"/>
          <a:ext cx="987033" cy="1455"/>
        </a:xfrm>
        <a:custGeom>
          <a:avLst/>
          <a:gdLst/>
          <a:ahLst/>
          <a:cxnLst/>
          <a:rect l="0" t="0" r="0" b="0"/>
          <a:pathLst>
            <a:path>
              <a:moveTo>
                <a:pt x="0" y="727"/>
              </a:moveTo>
              <a:lnTo>
                <a:pt x="987033" y="727"/>
              </a:lnTo>
            </a:path>
          </a:pathLst>
        </a:custGeom>
        <a:noFill/>
        <a:ln w="12700" cap="flat" cmpd="sng" algn="ctr">
          <a:solidFill>
            <a:schemeClr val="dk1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2700" tIns="0" rIns="12700" bIns="0" numCol="1" spcCol="1270" anchor="ctr" anchorCtr="0">
          <a:noAutofit/>
        </a:bodyPr>
        <a:lstStyle/>
        <a:p>
          <a:pPr marL="0" lvl="0" indent="0" algn="ctr" defTabSz="4889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endParaRPr lang="de-DE" sz="1100" kern="1200">
            <a:latin typeface="Times New Roman" panose="02020603050405020304" pitchFamily="18" charset="0"/>
            <a:cs typeface="Times New Roman" panose="02020603050405020304" pitchFamily="18" charset="0"/>
          </a:endParaRPr>
        </a:p>
      </dsp:txBody>
      <dsp:txXfrm>
        <a:off x="2618832" y="2744478"/>
        <a:ext cx="11763107" cy="49351"/>
      </dsp:txXfrm>
    </dsp:sp>
    <dsp:sp modelId="{4DCF8B3D-4AC6-4BA4-83D6-71D9BD5CEED2}">
      <dsp:nvSpPr>
        <dsp:cNvPr id="0" name=""/>
        <dsp:cNvSpPr/>
      </dsp:nvSpPr>
      <dsp:spPr>
        <a:xfrm>
          <a:off x="8984063" y="2506481"/>
          <a:ext cx="1613210" cy="329231"/>
        </a:xfrm>
        <a:prstGeom prst="roundRect">
          <a:avLst>
            <a:gd name="adj" fmla="val 10000"/>
          </a:avLst>
        </a:prstGeom>
        <a:solidFill>
          <a:schemeClr val="lt1"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dk1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6985" tIns="6985" rIns="6985" bIns="6985" numCol="1" spcCol="1270" anchor="ctr" anchorCtr="0">
          <a:noAutofit/>
        </a:bodyPr>
        <a:lstStyle/>
        <a:p>
          <a:pPr marL="0" lvl="0" indent="0" algn="ctr" defTabSz="466725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de-DE" sz="1050" kern="1200">
              <a:latin typeface="Times New Roman" panose="02020603050405020304" pitchFamily="18" charset="0"/>
              <a:cs typeface="Times New Roman" panose="02020603050405020304" pitchFamily="18" charset="0"/>
            </a:rPr>
            <a:t>Gesundheitssystem/-versorgung</a:t>
          </a:r>
        </a:p>
      </dsp:txBody>
      <dsp:txXfrm>
        <a:off x="8993706" y="2516124"/>
        <a:ext cx="1593924" cy="309945"/>
      </dsp:txXfrm>
    </dsp:sp>
    <dsp:sp modelId="{4422E06E-D77E-4F56-8840-95885C852043}">
      <dsp:nvSpPr>
        <dsp:cNvPr id="0" name=""/>
        <dsp:cNvSpPr/>
      </dsp:nvSpPr>
      <dsp:spPr>
        <a:xfrm rot="633953">
          <a:off x="8008366" y="2956703"/>
          <a:ext cx="984038" cy="1455"/>
        </a:xfrm>
        <a:custGeom>
          <a:avLst/>
          <a:gdLst/>
          <a:ahLst/>
          <a:cxnLst/>
          <a:rect l="0" t="0" r="0" b="0"/>
          <a:pathLst>
            <a:path>
              <a:moveTo>
                <a:pt x="0" y="727"/>
              </a:moveTo>
              <a:lnTo>
                <a:pt x="984038" y="727"/>
              </a:lnTo>
            </a:path>
          </a:pathLst>
        </a:custGeom>
        <a:noFill/>
        <a:ln w="12700" cap="flat" cmpd="sng" algn="ctr">
          <a:solidFill>
            <a:schemeClr val="dk1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2700" tIns="0" rIns="12700" bIns="0" numCol="1" spcCol="1270" anchor="ctr" anchorCtr="0">
          <a:noAutofit/>
        </a:bodyPr>
        <a:lstStyle/>
        <a:p>
          <a:pPr marL="0" lvl="0" indent="0" algn="ctr" defTabSz="4889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endParaRPr lang="de-DE" sz="1100" kern="1200">
            <a:latin typeface="Times New Roman" panose="02020603050405020304" pitchFamily="18" charset="0"/>
            <a:cs typeface="Times New Roman" panose="02020603050405020304" pitchFamily="18" charset="0"/>
          </a:endParaRPr>
        </a:p>
      </dsp:txBody>
      <dsp:txXfrm>
        <a:off x="2618832" y="2932830"/>
        <a:ext cx="11763107" cy="49201"/>
      </dsp:txXfrm>
    </dsp:sp>
    <dsp:sp modelId="{63E06D80-B4DA-4AF5-B318-48676A80383C}">
      <dsp:nvSpPr>
        <dsp:cNvPr id="0" name=""/>
        <dsp:cNvSpPr/>
      </dsp:nvSpPr>
      <dsp:spPr>
        <a:xfrm>
          <a:off x="8984063" y="2871664"/>
          <a:ext cx="1613210" cy="351973"/>
        </a:xfrm>
        <a:prstGeom prst="roundRect">
          <a:avLst>
            <a:gd name="adj" fmla="val 10000"/>
          </a:avLst>
        </a:prstGeom>
        <a:solidFill>
          <a:schemeClr val="lt1"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dk1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6985" tIns="6985" rIns="6985" bIns="6985" numCol="1" spcCol="1270" anchor="ctr" anchorCtr="0">
          <a:noAutofit/>
        </a:bodyPr>
        <a:lstStyle/>
        <a:p>
          <a:pPr marL="0" lvl="0" indent="0" algn="ctr" defTabSz="466725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de-DE" sz="1050" kern="1200">
              <a:latin typeface="Times New Roman" panose="02020603050405020304" pitchFamily="18" charset="0"/>
              <a:cs typeface="Times New Roman" panose="02020603050405020304" pitchFamily="18" charset="0"/>
            </a:rPr>
            <a:t>Ausstattung des Gesundheitssystems</a:t>
          </a:r>
        </a:p>
      </dsp:txBody>
      <dsp:txXfrm>
        <a:off x="8994372" y="2881973"/>
        <a:ext cx="1592592" cy="331355"/>
      </dsp:txXfrm>
    </dsp:sp>
    <dsp:sp modelId="{82D2DBC9-D5F1-41B2-B475-FC62C3A7004B}">
      <dsp:nvSpPr>
        <dsp:cNvPr id="0" name=""/>
        <dsp:cNvSpPr/>
      </dsp:nvSpPr>
      <dsp:spPr>
        <a:xfrm rot="20555543">
          <a:off x="2887126" y="3698014"/>
          <a:ext cx="3605440" cy="1455"/>
        </a:xfrm>
        <a:custGeom>
          <a:avLst/>
          <a:gdLst/>
          <a:ahLst/>
          <a:cxnLst/>
          <a:rect l="0" t="0" r="0" b="0"/>
          <a:pathLst>
            <a:path>
              <a:moveTo>
                <a:pt x="0" y="727"/>
              </a:moveTo>
              <a:lnTo>
                <a:pt x="3605440" y="727"/>
              </a:lnTo>
            </a:path>
          </a:pathLst>
        </a:custGeom>
        <a:noFill/>
        <a:ln w="12700" cap="flat" cmpd="sng" algn="ctr">
          <a:solidFill>
            <a:schemeClr val="dk1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2700" tIns="0" rIns="12700" bIns="0" numCol="1" spcCol="1270" anchor="ctr" anchorCtr="0">
          <a:noAutofit/>
        </a:bodyPr>
        <a:lstStyle/>
        <a:p>
          <a:pPr marL="0" lvl="0" indent="0" algn="ctr" defTabSz="4889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endParaRPr lang="de-DE" sz="1100" kern="1200">
            <a:latin typeface="Times New Roman" panose="02020603050405020304" pitchFamily="18" charset="0"/>
            <a:cs typeface="Times New Roman" panose="02020603050405020304" pitchFamily="18" charset="0"/>
          </a:endParaRPr>
        </a:p>
      </dsp:txBody>
      <dsp:txXfrm>
        <a:off x="-1191706" y="3608606"/>
        <a:ext cx="11763107" cy="180272"/>
      </dsp:txXfrm>
    </dsp:sp>
    <dsp:sp modelId="{481798CD-BDE5-4B57-B01A-E2CEFF5196BF}">
      <dsp:nvSpPr>
        <dsp:cNvPr id="0" name=""/>
        <dsp:cNvSpPr/>
      </dsp:nvSpPr>
      <dsp:spPr>
        <a:xfrm>
          <a:off x="6410003" y="2990347"/>
          <a:ext cx="1605865" cy="338158"/>
        </a:xfrm>
        <a:prstGeom prst="roundRect">
          <a:avLst>
            <a:gd name="adj" fmla="val 10000"/>
          </a:avLst>
        </a:prstGeom>
        <a:solidFill>
          <a:schemeClr val="lt1"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dk1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6985" tIns="6985" rIns="6985" bIns="6985" numCol="1" spcCol="1270" anchor="ctr" anchorCtr="0">
          <a:noAutofit/>
        </a:bodyPr>
        <a:lstStyle/>
        <a:p>
          <a:pPr marL="0" lvl="0" indent="0" algn="ctr" defTabSz="466725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de-DE" sz="1050" kern="1200">
              <a:latin typeface="Times New Roman" panose="02020603050405020304" pitchFamily="18" charset="0"/>
              <a:cs typeface="Times New Roman" panose="02020603050405020304" pitchFamily="18" charset="0"/>
            </a:rPr>
            <a:t>Personenbezogene Maßnahmen</a:t>
          </a:r>
        </a:p>
      </dsp:txBody>
      <dsp:txXfrm>
        <a:off x="6419907" y="3000251"/>
        <a:ext cx="1586057" cy="318350"/>
      </dsp:txXfrm>
    </dsp:sp>
    <dsp:sp modelId="{22457488-96D2-492A-A67D-1DA42B35C92F}">
      <dsp:nvSpPr>
        <dsp:cNvPr id="0" name=""/>
        <dsp:cNvSpPr/>
      </dsp:nvSpPr>
      <dsp:spPr>
        <a:xfrm rot="20929991">
          <a:off x="2936514" y="3897971"/>
          <a:ext cx="3504575" cy="1455"/>
        </a:xfrm>
        <a:custGeom>
          <a:avLst/>
          <a:gdLst/>
          <a:ahLst/>
          <a:cxnLst/>
          <a:rect l="0" t="0" r="0" b="0"/>
          <a:pathLst>
            <a:path>
              <a:moveTo>
                <a:pt x="0" y="727"/>
              </a:moveTo>
              <a:lnTo>
                <a:pt x="3504575" y="727"/>
              </a:lnTo>
            </a:path>
          </a:pathLst>
        </a:custGeom>
        <a:noFill/>
        <a:ln w="12700" cap="flat" cmpd="sng" algn="ctr">
          <a:solidFill>
            <a:schemeClr val="dk1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2700" tIns="0" rIns="12700" bIns="0" numCol="1" spcCol="1270" anchor="ctr" anchorCtr="0">
          <a:noAutofit/>
        </a:bodyPr>
        <a:lstStyle/>
        <a:p>
          <a:pPr marL="0" lvl="0" indent="0" algn="ctr" defTabSz="4889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endParaRPr lang="de-DE" sz="1100" kern="1200">
            <a:latin typeface="Times New Roman" panose="02020603050405020304" pitchFamily="18" charset="0"/>
            <a:cs typeface="Times New Roman" panose="02020603050405020304" pitchFamily="18" charset="0"/>
          </a:endParaRPr>
        </a:p>
      </dsp:txBody>
      <dsp:txXfrm>
        <a:off x="-1192750" y="3811084"/>
        <a:ext cx="11763107" cy="175228"/>
      </dsp:txXfrm>
    </dsp:sp>
    <dsp:sp modelId="{DC301E58-40D8-4D3D-9A40-BAA0C92BDE59}">
      <dsp:nvSpPr>
        <dsp:cNvPr id="0" name=""/>
        <dsp:cNvSpPr/>
      </dsp:nvSpPr>
      <dsp:spPr>
        <a:xfrm>
          <a:off x="6407915" y="3369897"/>
          <a:ext cx="1605865" cy="378885"/>
        </a:xfrm>
        <a:prstGeom prst="roundRect">
          <a:avLst>
            <a:gd name="adj" fmla="val 10000"/>
          </a:avLst>
        </a:prstGeom>
        <a:solidFill>
          <a:schemeClr val="lt1"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dk1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6985" tIns="6985" rIns="6985" bIns="6985" numCol="1" spcCol="1270" anchor="ctr" anchorCtr="0">
          <a:noAutofit/>
        </a:bodyPr>
        <a:lstStyle/>
        <a:p>
          <a:pPr marL="0" lvl="0" indent="0" algn="ctr" defTabSz="466725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de-DE" sz="1050" kern="1200">
              <a:latin typeface="Times New Roman" panose="02020603050405020304" pitchFamily="18" charset="0"/>
              <a:cs typeface="Times New Roman" panose="02020603050405020304" pitchFamily="18" charset="0"/>
            </a:rPr>
            <a:t>Maßnahmen im öffentlichen Bereich</a:t>
          </a:r>
        </a:p>
      </dsp:txBody>
      <dsp:txXfrm>
        <a:off x="6419012" y="3380994"/>
        <a:ext cx="1583671" cy="356691"/>
      </dsp:txXfrm>
    </dsp:sp>
    <dsp:sp modelId="{2E231434-ED7F-44D1-8C73-4DA73C333BE6}">
      <dsp:nvSpPr>
        <dsp:cNvPr id="0" name=""/>
        <dsp:cNvSpPr/>
      </dsp:nvSpPr>
      <dsp:spPr>
        <a:xfrm rot="21338828">
          <a:off x="2964712" y="4106362"/>
          <a:ext cx="3451137" cy="1455"/>
        </a:xfrm>
        <a:custGeom>
          <a:avLst/>
          <a:gdLst/>
          <a:ahLst/>
          <a:cxnLst/>
          <a:rect l="0" t="0" r="0" b="0"/>
          <a:pathLst>
            <a:path>
              <a:moveTo>
                <a:pt x="0" y="727"/>
              </a:moveTo>
              <a:lnTo>
                <a:pt x="3451137" y="727"/>
              </a:lnTo>
            </a:path>
          </a:pathLst>
        </a:custGeom>
        <a:noFill/>
        <a:ln w="12700" cap="flat" cmpd="sng" algn="ctr">
          <a:solidFill>
            <a:schemeClr val="dk1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2700" tIns="0" rIns="12700" bIns="0" numCol="1" spcCol="1270" anchor="ctr" anchorCtr="0">
          <a:noAutofit/>
        </a:bodyPr>
        <a:lstStyle/>
        <a:p>
          <a:pPr marL="0" lvl="0" indent="0" algn="ctr" defTabSz="4889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endParaRPr lang="de-DE" sz="1100" kern="1200">
            <a:latin typeface="Times New Roman" panose="02020603050405020304" pitchFamily="18" charset="0"/>
            <a:cs typeface="Times New Roman" panose="02020603050405020304" pitchFamily="18" charset="0"/>
          </a:endParaRPr>
        </a:p>
      </dsp:txBody>
      <dsp:txXfrm>
        <a:off x="-1191272" y="4020811"/>
        <a:ext cx="11763107" cy="172556"/>
      </dsp:txXfrm>
    </dsp:sp>
    <dsp:sp modelId="{665072C3-8ADE-40C1-BDA5-4FAA68E4319F}">
      <dsp:nvSpPr>
        <dsp:cNvPr id="0" name=""/>
        <dsp:cNvSpPr/>
      </dsp:nvSpPr>
      <dsp:spPr>
        <a:xfrm>
          <a:off x="6410872" y="3786678"/>
          <a:ext cx="1605865" cy="378885"/>
        </a:xfrm>
        <a:prstGeom prst="roundRect">
          <a:avLst>
            <a:gd name="adj" fmla="val 10000"/>
          </a:avLst>
        </a:prstGeom>
        <a:solidFill>
          <a:schemeClr val="lt1"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dk1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6985" tIns="6985" rIns="6985" bIns="6985" numCol="1" spcCol="1270" anchor="ctr" anchorCtr="0">
          <a:noAutofit/>
        </a:bodyPr>
        <a:lstStyle/>
        <a:p>
          <a:pPr marL="0" lvl="0" indent="0" algn="ctr" defTabSz="466725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de-DE" sz="1050" kern="1200">
              <a:latin typeface="Times New Roman" panose="02020603050405020304" pitchFamily="18" charset="0"/>
              <a:cs typeface="Times New Roman" panose="02020603050405020304" pitchFamily="18" charset="0"/>
            </a:rPr>
            <a:t>Einschränkung der Bewegungsfreiheit</a:t>
          </a:r>
        </a:p>
      </dsp:txBody>
      <dsp:txXfrm>
        <a:off x="6421969" y="3797775"/>
        <a:ext cx="1583671" cy="356691"/>
      </dsp:txXfrm>
    </dsp:sp>
    <dsp:sp modelId="{134D7A88-2D4D-4FE0-A203-5D2DFDE9B8B0}">
      <dsp:nvSpPr>
        <dsp:cNvPr id="0" name=""/>
        <dsp:cNvSpPr/>
      </dsp:nvSpPr>
      <dsp:spPr>
        <a:xfrm rot="45723">
          <a:off x="2969538" y="4260185"/>
          <a:ext cx="3436895" cy="1455"/>
        </a:xfrm>
        <a:custGeom>
          <a:avLst/>
          <a:gdLst/>
          <a:ahLst/>
          <a:cxnLst/>
          <a:rect l="0" t="0" r="0" b="0"/>
          <a:pathLst>
            <a:path>
              <a:moveTo>
                <a:pt x="0" y="727"/>
              </a:moveTo>
              <a:lnTo>
                <a:pt x="3436895" y="727"/>
              </a:lnTo>
            </a:path>
          </a:pathLst>
        </a:custGeom>
        <a:noFill/>
        <a:ln w="12700" cap="flat" cmpd="sng" algn="ctr">
          <a:solidFill>
            <a:schemeClr val="dk1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2700" tIns="0" rIns="12700" bIns="0" numCol="1" spcCol="1270" anchor="ctr" anchorCtr="0">
          <a:noAutofit/>
        </a:bodyPr>
        <a:lstStyle/>
        <a:p>
          <a:pPr marL="0" lvl="0" indent="0" algn="ctr" defTabSz="4889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endParaRPr lang="de-DE" sz="1100" kern="1200">
            <a:latin typeface="Times New Roman" panose="02020603050405020304" pitchFamily="18" charset="0"/>
            <a:cs typeface="Times New Roman" panose="02020603050405020304" pitchFamily="18" charset="0"/>
          </a:endParaRPr>
        </a:p>
      </dsp:txBody>
      <dsp:txXfrm>
        <a:off x="-1193567" y="4174990"/>
        <a:ext cx="11763107" cy="171844"/>
      </dsp:txXfrm>
    </dsp:sp>
    <dsp:sp modelId="{3E90B72A-F33B-4C19-AA15-D10953CC4340}">
      <dsp:nvSpPr>
        <dsp:cNvPr id="0" name=""/>
        <dsp:cNvSpPr/>
      </dsp:nvSpPr>
      <dsp:spPr>
        <a:xfrm rot="10800000" flipV="1">
          <a:off x="6406281" y="4196487"/>
          <a:ext cx="1605865" cy="174561"/>
        </a:xfrm>
        <a:prstGeom prst="roundRect">
          <a:avLst>
            <a:gd name="adj" fmla="val 10000"/>
          </a:avLst>
        </a:prstGeom>
        <a:solidFill>
          <a:schemeClr val="lt1"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dk1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6985" tIns="6985" rIns="6985" bIns="6985" numCol="1" spcCol="1270" anchor="ctr" anchorCtr="0">
          <a:noAutofit/>
        </a:bodyPr>
        <a:lstStyle/>
        <a:p>
          <a:pPr marL="0" lvl="0" indent="0" algn="ctr" defTabSz="466725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de-DE" sz="1050" kern="1200">
              <a:latin typeface="Times New Roman" panose="02020603050405020304" pitchFamily="18" charset="0"/>
              <a:cs typeface="Times New Roman" panose="02020603050405020304" pitchFamily="18" charset="0"/>
            </a:rPr>
            <a:t>Schutz</a:t>
          </a:r>
        </a:p>
      </dsp:txBody>
      <dsp:txXfrm rot="-10800000">
        <a:off x="6411394" y="4201600"/>
        <a:ext cx="1595639" cy="164335"/>
      </dsp:txXfrm>
    </dsp:sp>
    <dsp:sp modelId="{CBE2BF13-B4B2-4CCE-B9CD-9C2AE1DB9827}">
      <dsp:nvSpPr>
        <dsp:cNvPr id="0" name=""/>
        <dsp:cNvSpPr/>
      </dsp:nvSpPr>
      <dsp:spPr>
        <a:xfrm rot="255444">
          <a:off x="2964929" y="4365415"/>
          <a:ext cx="3450708" cy="1455"/>
        </a:xfrm>
        <a:custGeom>
          <a:avLst/>
          <a:gdLst/>
          <a:ahLst/>
          <a:cxnLst/>
          <a:rect l="0" t="0" r="0" b="0"/>
          <a:pathLst>
            <a:path>
              <a:moveTo>
                <a:pt x="0" y="727"/>
              </a:moveTo>
              <a:lnTo>
                <a:pt x="3450708" y="727"/>
              </a:lnTo>
            </a:path>
          </a:pathLst>
        </a:custGeom>
        <a:noFill/>
        <a:ln w="12700" cap="flat" cmpd="sng" algn="ctr">
          <a:solidFill>
            <a:schemeClr val="dk1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2700" tIns="0" rIns="12700" bIns="0" numCol="1" spcCol="1270" anchor="ctr" anchorCtr="0">
          <a:noAutofit/>
        </a:bodyPr>
        <a:lstStyle/>
        <a:p>
          <a:pPr marL="0" lvl="0" indent="0" algn="ctr" defTabSz="4889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endParaRPr lang="de-DE" sz="1100" kern="1200">
            <a:latin typeface="Times New Roman" panose="02020603050405020304" pitchFamily="18" charset="0"/>
            <a:cs typeface="Times New Roman" panose="02020603050405020304" pitchFamily="18" charset="0"/>
          </a:endParaRPr>
        </a:p>
      </dsp:txBody>
      <dsp:txXfrm>
        <a:off x="-1191270" y="4279875"/>
        <a:ext cx="11763107" cy="172535"/>
      </dsp:txXfrm>
    </dsp:sp>
    <dsp:sp modelId="{48E4B145-A01E-4F97-9B06-6C33D2269A47}">
      <dsp:nvSpPr>
        <dsp:cNvPr id="0" name=""/>
        <dsp:cNvSpPr/>
      </dsp:nvSpPr>
      <dsp:spPr>
        <a:xfrm>
          <a:off x="6410876" y="4406948"/>
          <a:ext cx="1605865" cy="174561"/>
        </a:xfrm>
        <a:prstGeom prst="roundRect">
          <a:avLst>
            <a:gd name="adj" fmla="val 10000"/>
          </a:avLst>
        </a:prstGeom>
        <a:solidFill>
          <a:schemeClr val="lt1"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dk1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6985" tIns="6985" rIns="6985" bIns="6985" numCol="1" spcCol="1270" anchor="ctr" anchorCtr="0">
          <a:noAutofit/>
        </a:bodyPr>
        <a:lstStyle/>
        <a:p>
          <a:pPr marL="0" lvl="0" indent="0" algn="ctr" defTabSz="466725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de-DE" sz="1050" kern="1200">
              <a:latin typeface="Times New Roman" panose="02020603050405020304" pitchFamily="18" charset="0"/>
              <a:cs typeface="Times New Roman" panose="02020603050405020304" pitchFamily="18" charset="0"/>
            </a:rPr>
            <a:t>Technologie</a:t>
          </a:r>
        </a:p>
      </dsp:txBody>
      <dsp:txXfrm>
        <a:off x="6415989" y="4412061"/>
        <a:ext cx="1595639" cy="164335"/>
      </dsp:txXfrm>
    </dsp:sp>
    <dsp:sp modelId="{92D0DEB7-F9E3-4085-A056-1B4AA5D907F0}">
      <dsp:nvSpPr>
        <dsp:cNvPr id="0" name=""/>
        <dsp:cNvSpPr/>
      </dsp:nvSpPr>
      <dsp:spPr>
        <a:xfrm rot="459001">
          <a:off x="2954246" y="4468326"/>
          <a:ext cx="3470444" cy="1455"/>
        </a:xfrm>
        <a:custGeom>
          <a:avLst/>
          <a:gdLst/>
          <a:ahLst/>
          <a:cxnLst/>
          <a:rect l="0" t="0" r="0" b="0"/>
          <a:pathLst>
            <a:path>
              <a:moveTo>
                <a:pt x="0" y="727"/>
              </a:moveTo>
              <a:lnTo>
                <a:pt x="3470444" y="727"/>
              </a:lnTo>
            </a:path>
          </a:pathLst>
        </a:custGeom>
        <a:noFill/>
        <a:ln w="12700" cap="flat" cmpd="sng" algn="ctr">
          <a:solidFill>
            <a:schemeClr val="dk1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2700" tIns="0" rIns="12700" bIns="0" numCol="1" spcCol="1270" anchor="ctr" anchorCtr="0">
          <a:noAutofit/>
        </a:bodyPr>
        <a:lstStyle/>
        <a:p>
          <a:pPr marL="0" lvl="0" indent="0" algn="ctr" defTabSz="4889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endParaRPr lang="de-DE" sz="1100" kern="1200">
            <a:latin typeface="Times New Roman" panose="02020603050405020304" pitchFamily="18" charset="0"/>
            <a:cs typeface="Times New Roman" panose="02020603050405020304" pitchFamily="18" charset="0"/>
          </a:endParaRPr>
        </a:p>
      </dsp:txBody>
      <dsp:txXfrm>
        <a:off x="-1192085" y="4382292"/>
        <a:ext cx="11763107" cy="173522"/>
      </dsp:txXfrm>
    </dsp:sp>
    <dsp:sp modelId="{0F72C090-6894-4EAC-91C9-4AB4F7819088}">
      <dsp:nvSpPr>
        <dsp:cNvPr id="0" name=""/>
        <dsp:cNvSpPr/>
      </dsp:nvSpPr>
      <dsp:spPr>
        <a:xfrm>
          <a:off x="6409246" y="4612768"/>
          <a:ext cx="1605865" cy="174561"/>
        </a:xfrm>
        <a:prstGeom prst="roundRect">
          <a:avLst>
            <a:gd name="adj" fmla="val 10000"/>
          </a:avLst>
        </a:prstGeom>
        <a:solidFill>
          <a:schemeClr val="lt1"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dk1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6985" tIns="6985" rIns="6985" bIns="6985" numCol="1" spcCol="1270" anchor="ctr" anchorCtr="0">
          <a:noAutofit/>
        </a:bodyPr>
        <a:lstStyle/>
        <a:p>
          <a:pPr marL="0" lvl="0" indent="0" algn="ctr" defTabSz="466725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de-DE" sz="1050" kern="1200">
              <a:latin typeface="Times New Roman" panose="02020603050405020304" pitchFamily="18" charset="0"/>
              <a:cs typeface="Times New Roman" panose="02020603050405020304" pitchFamily="18" charset="0"/>
            </a:rPr>
            <a:t>Reisen</a:t>
          </a:r>
        </a:p>
      </dsp:txBody>
      <dsp:txXfrm>
        <a:off x="6414359" y="4617881"/>
        <a:ext cx="1595639" cy="164335"/>
      </dsp:txXfrm>
    </dsp:sp>
    <dsp:sp modelId="{6AB18905-010D-4722-AD52-A8029684E429}">
      <dsp:nvSpPr>
        <dsp:cNvPr id="0" name=""/>
        <dsp:cNvSpPr/>
      </dsp:nvSpPr>
      <dsp:spPr>
        <a:xfrm rot="659595">
          <a:off x="2937528" y="4571548"/>
          <a:ext cx="3505295" cy="1455"/>
        </a:xfrm>
        <a:custGeom>
          <a:avLst/>
          <a:gdLst/>
          <a:ahLst/>
          <a:cxnLst/>
          <a:rect l="0" t="0" r="0" b="0"/>
          <a:pathLst>
            <a:path>
              <a:moveTo>
                <a:pt x="0" y="727"/>
              </a:moveTo>
              <a:lnTo>
                <a:pt x="3505295" y="727"/>
              </a:lnTo>
            </a:path>
          </a:pathLst>
        </a:custGeom>
        <a:noFill/>
        <a:ln w="12700" cap="flat" cmpd="sng" algn="ctr">
          <a:solidFill>
            <a:schemeClr val="dk1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2700" tIns="0" rIns="12700" bIns="0" numCol="1" spcCol="1270" anchor="ctr" anchorCtr="0">
          <a:noAutofit/>
        </a:bodyPr>
        <a:lstStyle/>
        <a:p>
          <a:pPr marL="0" lvl="0" indent="0" algn="ctr" defTabSz="4889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endParaRPr lang="de-DE" sz="1100" kern="1200">
            <a:latin typeface="Times New Roman" panose="02020603050405020304" pitchFamily="18" charset="0"/>
            <a:cs typeface="Times New Roman" panose="02020603050405020304" pitchFamily="18" charset="0"/>
          </a:endParaRPr>
        </a:p>
      </dsp:txBody>
      <dsp:txXfrm>
        <a:off x="-1191377" y="4484643"/>
        <a:ext cx="11763107" cy="175264"/>
      </dsp:txXfrm>
    </dsp:sp>
    <dsp:sp modelId="{93ED179E-6CE9-427B-AFAE-295FB95A4083}">
      <dsp:nvSpPr>
        <dsp:cNvPr id="0" name=""/>
        <dsp:cNvSpPr/>
      </dsp:nvSpPr>
      <dsp:spPr>
        <a:xfrm>
          <a:off x="6410661" y="4819213"/>
          <a:ext cx="1605865" cy="174561"/>
        </a:xfrm>
        <a:prstGeom prst="roundRect">
          <a:avLst>
            <a:gd name="adj" fmla="val 10000"/>
          </a:avLst>
        </a:prstGeom>
        <a:solidFill>
          <a:schemeClr val="lt1"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dk1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6985" tIns="6985" rIns="6985" bIns="6985" numCol="1" spcCol="1270" anchor="ctr" anchorCtr="0">
          <a:noAutofit/>
        </a:bodyPr>
        <a:lstStyle/>
        <a:p>
          <a:pPr marL="0" lvl="0" indent="0" algn="ctr" defTabSz="466725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de-DE" sz="1050" kern="1200">
              <a:latin typeface="Times New Roman" panose="02020603050405020304" pitchFamily="18" charset="0"/>
              <a:cs typeface="Times New Roman" panose="02020603050405020304" pitchFamily="18" charset="0"/>
            </a:rPr>
            <a:t>Vertrauen</a:t>
          </a:r>
        </a:p>
      </dsp:txBody>
      <dsp:txXfrm>
        <a:off x="6415774" y="4824326"/>
        <a:ext cx="1595639" cy="164335"/>
      </dsp:txXfrm>
    </dsp:sp>
    <dsp:sp modelId="{B3990D9E-965A-4A87-9024-A31D8C18D9AC}">
      <dsp:nvSpPr>
        <dsp:cNvPr id="0" name=""/>
        <dsp:cNvSpPr/>
      </dsp:nvSpPr>
      <dsp:spPr>
        <a:xfrm rot="941231">
          <a:off x="2903157" y="4720295"/>
          <a:ext cx="3572421" cy="1455"/>
        </a:xfrm>
        <a:custGeom>
          <a:avLst/>
          <a:gdLst/>
          <a:ahLst/>
          <a:cxnLst/>
          <a:rect l="0" t="0" r="0" b="0"/>
          <a:pathLst>
            <a:path>
              <a:moveTo>
                <a:pt x="0" y="727"/>
              </a:moveTo>
              <a:lnTo>
                <a:pt x="3572421" y="727"/>
              </a:lnTo>
            </a:path>
          </a:pathLst>
        </a:custGeom>
        <a:noFill/>
        <a:ln w="12700" cap="flat" cmpd="sng" algn="ctr">
          <a:solidFill>
            <a:schemeClr val="dk1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2700" tIns="0" rIns="12700" bIns="0" numCol="1" spcCol="1270" anchor="ctr" anchorCtr="0">
          <a:noAutofit/>
        </a:bodyPr>
        <a:lstStyle/>
        <a:p>
          <a:pPr marL="0" lvl="0" indent="0" algn="ctr" defTabSz="4889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endParaRPr lang="de-DE" sz="1100" kern="1200">
            <a:latin typeface="Times New Roman" panose="02020603050405020304" pitchFamily="18" charset="0"/>
            <a:cs typeface="Times New Roman" panose="02020603050405020304" pitchFamily="18" charset="0"/>
          </a:endParaRPr>
        </a:p>
      </dsp:txBody>
      <dsp:txXfrm>
        <a:off x="-1192185" y="4631712"/>
        <a:ext cx="11763107" cy="178621"/>
      </dsp:txXfrm>
    </dsp:sp>
    <dsp:sp modelId="{55C48720-204C-4364-9D3A-54C5764186B5}">
      <dsp:nvSpPr>
        <dsp:cNvPr id="0" name=""/>
        <dsp:cNvSpPr/>
      </dsp:nvSpPr>
      <dsp:spPr>
        <a:xfrm>
          <a:off x="6409046" y="5024658"/>
          <a:ext cx="1605865" cy="358658"/>
        </a:xfrm>
        <a:prstGeom prst="roundRect">
          <a:avLst>
            <a:gd name="adj" fmla="val 10000"/>
          </a:avLst>
        </a:prstGeom>
        <a:solidFill>
          <a:schemeClr val="lt1"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dk1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6985" tIns="6985" rIns="6985" bIns="6985" numCol="1" spcCol="1270" anchor="ctr" anchorCtr="0">
          <a:noAutofit/>
        </a:bodyPr>
        <a:lstStyle/>
        <a:p>
          <a:pPr marL="0" lvl="0" indent="0" algn="ctr" defTabSz="466725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de-DE" sz="1050" kern="1200">
              <a:latin typeface="Times New Roman" panose="02020603050405020304" pitchFamily="18" charset="0"/>
              <a:cs typeface="Times New Roman" panose="02020603050405020304" pitchFamily="18" charset="0"/>
            </a:rPr>
            <a:t>Gewerkschaften und Industrie</a:t>
          </a:r>
        </a:p>
      </dsp:txBody>
      <dsp:txXfrm>
        <a:off x="6419551" y="5035163"/>
        <a:ext cx="1584855" cy="337648"/>
      </dsp:txXfrm>
    </dsp:sp>
    <dsp:sp modelId="{77548836-C3C7-4F26-AB2C-7B9D48F92339}">
      <dsp:nvSpPr>
        <dsp:cNvPr id="0" name=""/>
        <dsp:cNvSpPr/>
      </dsp:nvSpPr>
      <dsp:spPr>
        <a:xfrm rot="1210612">
          <a:off x="2857440" y="4868233"/>
          <a:ext cx="3658262" cy="1455"/>
        </a:xfrm>
        <a:custGeom>
          <a:avLst/>
          <a:gdLst/>
          <a:ahLst/>
          <a:cxnLst/>
          <a:rect l="0" t="0" r="0" b="0"/>
          <a:pathLst>
            <a:path>
              <a:moveTo>
                <a:pt x="0" y="727"/>
              </a:moveTo>
              <a:lnTo>
                <a:pt x="3658262" y="727"/>
              </a:lnTo>
            </a:path>
          </a:pathLst>
        </a:custGeom>
        <a:noFill/>
        <a:ln w="12700" cap="flat" cmpd="sng" algn="ctr">
          <a:solidFill>
            <a:schemeClr val="dk1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2700" tIns="0" rIns="12700" bIns="0" numCol="1" spcCol="1270" anchor="ctr" anchorCtr="0">
          <a:noAutofit/>
        </a:bodyPr>
        <a:lstStyle/>
        <a:p>
          <a:pPr marL="0" lvl="0" indent="0" algn="ctr" defTabSz="4889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endParaRPr lang="de-DE" sz="1100" kern="1200">
            <a:latin typeface="Times New Roman" panose="02020603050405020304" pitchFamily="18" charset="0"/>
            <a:cs typeface="Times New Roman" panose="02020603050405020304" pitchFamily="18" charset="0"/>
          </a:endParaRPr>
        </a:p>
      </dsp:txBody>
      <dsp:txXfrm>
        <a:off x="-1194981" y="4777504"/>
        <a:ext cx="11763107" cy="182913"/>
      </dsp:txXfrm>
    </dsp:sp>
    <dsp:sp modelId="{58A40D43-4424-4837-A5A1-19217FD9A569}">
      <dsp:nvSpPr>
        <dsp:cNvPr id="0" name=""/>
        <dsp:cNvSpPr/>
      </dsp:nvSpPr>
      <dsp:spPr>
        <a:xfrm>
          <a:off x="6403453" y="5412582"/>
          <a:ext cx="1605865" cy="174561"/>
        </a:xfrm>
        <a:prstGeom prst="roundRect">
          <a:avLst>
            <a:gd name="adj" fmla="val 10000"/>
          </a:avLst>
        </a:prstGeom>
        <a:solidFill>
          <a:schemeClr val="lt1"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dk1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6985" tIns="6985" rIns="6985" bIns="6985" numCol="1" spcCol="1270" anchor="ctr" anchorCtr="0">
          <a:noAutofit/>
        </a:bodyPr>
        <a:lstStyle/>
        <a:p>
          <a:pPr marL="0" lvl="0" indent="0" algn="ctr" defTabSz="466725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de-DE" sz="1050" kern="1200">
              <a:latin typeface="Times New Roman" panose="02020603050405020304" pitchFamily="18" charset="0"/>
              <a:cs typeface="Times New Roman" panose="02020603050405020304" pitchFamily="18" charset="0"/>
            </a:rPr>
            <a:t>Umwelt</a:t>
          </a:r>
        </a:p>
      </dsp:txBody>
      <dsp:txXfrm>
        <a:off x="6408566" y="5417695"/>
        <a:ext cx="1595639" cy="164335"/>
      </dsp:txXfrm>
    </dsp:sp>
    <dsp:sp modelId="{616D48F1-5BF9-475C-A680-5A4648439758}">
      <dsp:nvSpPr>
        <dsp:cNvPr id="0" name=""/>
        <dsp:cNvSpPr/>
      </dsp:nvSpPr>
      <dsp:spPr>
        <a:xfrm rot="1391530">
          <a:off x="2818503" y="4974108"/>
          <a:ext cx="3741736" cy="1455"/>
        </a:xfrm>
        <a:custGeom>
          <a:avLst/>
          <a:gdLst/>
          <a:ahLst/>
          <a:cxnLst/>
          <a:rect l="0" t="0" r="0" b="0"/>
          <a:pathLst>
            <a:path>
              <a:moveTo>
                <a:pt x="0" y="727"/>
              </a:moveTo>
              <a:lnTo>
                <a:pt x="3741736" y="727"/>
              </a:lnTo>
            </a:path>
          </a:pathLst>
        </a:custGeom>
        <a:noFill/>
        <a:ln w="12700" cap="flat" cmpd="sng" algn="ctr">
          <a:solidFill>
            <a:schemeClr val="dk1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2700" tIns="0" rIns="12700" bIns="0" numCol="1" spcCol="1270" anchor="ctr" anchorCtr="0">
          <a:noAutofit/>
        </a:bodyPr>
        <a:lstStyle/>
        <a:p>
          <a:pPr marL="0" lvl="0" indent="0" algn="ctr" defTabSz="4889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endParaRPr lang="de-DE" sz="1100" kern="1200">
            <a:latin typeface="Times New Roman" panose="02020603050405020304" pitchFamily="18" charset="0"/>
            <a:cs typeface="Times New Roman" panose="02020603050405020304" pitchFamily="18" charset="0"/>
          </a:endParaRPr>
        </a:p>
      </dsp:txBody>
      <dsp:txXfrm>
        <a:off x="-1192181" y="4881292"/>
        <a:ext cx="11763107" cy="187086"/>
      </dsp:txXfrm>
    </dsp:sp>
    <dsp:sp modelId="{AC865C7C-D34F-4978-B07D-384D670F1E47}">
      <dsp:nvSpPr>
        <dsp:cNvPr id="0" name=""/>
        <dsp:cNvSpPr/>
      </dsp:nvSpPr>
      <dsp:spPr>
        <a:xfrm>
          <a:off x="6409053" y="5624333"/>
          <a:ext cx="1605865" cy="174561"/>
        </a:xfrm>
        <a:prstGeom prst="roundRect">
          <a:avLst>
            <a:gd name="adj" fmla="val 10000"/>
          </a:avLst>
        </a:prstGeom>
        <a:solidFill>
          <a:schemeClr val="lt1"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dk1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6985" tIns="6985" rIns="6985" bIns="6985" numCol="1" spcCol="1270" anchor="ctr" anchorCtr="0">
          <a:noAutofit/>
        </a:bodyPr>
        <a:lstStyle/>
        <a:p>
          <a:pPr marL="0" lvl="0" indent="0" algn="ctr" defTabSz="466725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de-DE" sz="1050" kern="1200">
              <a:latin typeface="Times New Roman" panose="02020603050405020304" pitchFamily="18" charset="0"/>
              <a:cs typeface="Times New Roman" panose="02020603050405020304" pitchFamily="18" charset="0"/>
            </a:rPr>
            <a:t>Ungerechtigkeiten</a:t>
          </a:r>
        </a:p>
      </dsp:txBody>
      <dsp:txXfrm>
        <a:off x="6414166" y="5629446"/>
        <a:ext cx="1595639" cy="164335"/>
      </dsp:txXfrm>
    </dsp:sp>
    <dsp:sp modelId="{0534A5B7-9C7A-4B37-8658-B389BC363051}">
      <dsp:nvSpPr>
        <dsp:cNvPr id="0" name=""/>
        <dsp:cNvSpPr/>
      </dsp:nvSpPr>
      <dsp:spPr>
        <a:xfrm rot="1567126">
          <a:off x="2774168" y="5080238"/>
          <a:ext cx="3829370" cy="1455"/>
        </a:xfrm>
        <a:custGeom>
          <a:avLst/>
          <a:gdLst/>
          <a:ahLst/>
          <a:cxnLst/>
          <a:rect l="0" t="0" r="0" b="0"/>
          <a:pathLst>
            <a:path>
              <a:moveTo>
                <a:pt x="0" y="727"/>
              </a:moveTo>
              <a:lnTo>
                <a:pt x="3829370" y="727"/>
              </a:lnTo>
            </a:path>
          </a:pathLst>
        </a:custGeom>
        <a:noFill/>
        <a:ln w="12700" cap="flat" cmpd="sng" algn="ctr">
          <a:solidFill>
            <a:schemeClr val="dk1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2700" tIns="0" rIns="12700" bIns="0" numCol="1" spcCol="1270" anchor="ctr" anchorCtr="0">
          <a:noAutofit/>
        </a:bodyPr>
        <a:lstStyle/>
        <a:p>
          <a:pPr marL="0" lvl="0" indent="0" algn="ctr" defTabSz="4889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endParaRPr lang="de-DE" sz="1100" kern="1200">
            <a:latin typeface="Times New Roman" panose="02020603050405020304" pitchFamily="18" charset="0"/>
            <a:cs typeface="Times New Roman" panose="02020603050405020304" pitchFamily="18" charset="0"/>
          </a:endParaRPr>
        </a:p>
      </dsp:txBody>
      <dsp:txXfrm>
        <a:off x="-1192699" y="4985232"/>
        <a:ext cx="11763107" cy="191468"/>
      </dsp:txXfrm>
    </dsp:sp>
    <dsp:sp modelId="{4B059EDE-FDEA-4C68-BB44-42AF88AE4840}">
      <dsp:nvSpPr>
        <dsp:cNvPr id="0" name=""/>
        <dsp:cNvSpPr/>
      </dsp:nvSpPr>
      <dsp:spPr>
        <a:xfrm>
          <a:off x="6408018" y="5836593"/>
          <a:ext cx="1605865" cy="174561"/>
        </a:xfrm>
        <a:prstGeom prst="roundRect">
          <a:avLst>
            <a:gd name="adj" fmla="val 10000"/>
          </a:avLst>
        </a:prstGeom>
        <a:solidFill>
          <a:schemeClr val="lt1"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dk1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6985" tIns="6985" rIns="6985" bIns="6985" numCol="1" spcCol="1270" anchor="ctr" anchorCtr="0">
          <a:noAutofit/>
        </a:bodyPr>
        <a:lstStyle/>
        <a:p>
          <a:pPr marL="0" lvl="0" indent="0" algn="ctr" defTabSz="466725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de-DE" sz="1050" kern="1200">
              <a:latin typeface="Times New Roman" panose="02020603050405020304" pitchFamily="18" charset="0"/>
              <a:cs typeface="Times New Roman" panose="02020603050405020304" pitchFamily="18" charset="0"/>
            </a:rPr>
            <a:t>Zivile Unruhen</a:t>
          </a:r>
        </a:p>
      </dsp:txBody>
      <dsp:txXfrm>
        <a:off x="6413131" y="5841706"/>
        <a:ext cx="1595639" cy="164335"/>
      </dsp:txXfrm>
    </dsp:sp>
    <dsp:sp modelId="{06162D70-667D-4321-A2A5-50E71EC54502}">
      <dsp:nvSpPr>
        <dsp:cNvPr id="0" name=""/>
        <dsp:cNvSpPr/>
      </dsp:nvSpPr>
      <dsp:spPr>
        <a:xfrm rot="4017285">
          <a:off x="-75086" y="4494017"/>
          <a:ext cx="2766232" cy="1455"/>
        </a:xfrm>
        <a:custGeom>
          <a:avLst/>
          <a:gdLst/>
          <a:ahLst/>
          <a:cxnLst/>
          <a:rect l="0" t="0" r="0" b="0"/>
          <a:pathLst>
            <a:path>
              <a:moveTo>
                <a:pt x="0" y="727"/>
              </a:moveTo>
              <a:lnTo>
                <a:pt x="2766232" y="727"/>
              </a:lnTo>
            </a:path>
          </a:pathLst>
        </a:custGeom>
        <a:noFill/>
        <a:ln w="12700" cap="flat" cmpd="sng" algn="ctr">
          <a:solidFill>
            <a:schemeClr val="dk1">
              <a:shade val="6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2700" tIns="0" rIns="12700" bIns="0" numCol="1" spcCol="1270" anchor="ctr" anchorCtr="0">
          <a:noAutofit/>
        </a:bodyPr>
        <a:lstStyle/>
        <a:p>
          <a:pPr marL="0" lvl="0" indent="0" algn="ctr" defTabSz="4889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endParaRPr lang="de-DE" sz="1100" kern="1200">
            <a:latin typeface="Times New Roman" panose="02020603050405020304" pitchFamily="18" charset="0"/>
            <a:cs typeface="Times New Roman" panose="02020603050405020304" pitchFamily="18" charset="0"/>
          </a:endParaRPr>
        </a:p>
      </dsp:txBody>
      <dsp:txXfrm>
        <a:off x="-4573523" y="4425589"/>
        <a:ext cx="11763107" cy="138311"/>
      </dsp:txXfrm>
    </dsp:sp>
    <dsp:sp modelId="{DDF72957-287B-449A-A1C9-C4F10755C0F8}">
      <dsp:nvSpPr>
        <dsp:cNvPr id="0" name=""/>
        <dsp:cNvSpPr/>
      </dsp:nvSpPr>
      <dsp:spPr>
        <a:xfrm>
          <a:off x="1849461" y="5587819"/>
          <a:ext cx="1123774" cy="359328"/>
        </a:xfrm>
        <a:prstGeom prst="roundRect">
          <a:avLst>
            <a:gd name="adj" fmla="val 10000"/>
          </a:avLst>
        </a:prstGeom>
        <a:solidFill>
          <a:schemeClr val="lt1"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dk1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6985" tIns="6985" rIns="6985" bIns="6985" numCol="1" spcCol="1270" anchor="ctr" anchorCtr="0">
          <a:noAutofit/>
        </a:bodyPr>
        <a:lstStyle/>
        <a:p>
          <a:pPr marL="0" lvl="0" indent="0" algn="ctr" defTabSz="466725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de-DE" sz="1050" kern="1200">
              <a:latin typeface="Times New Roman" panose="02020603050405020304" pitchFamily="18" charset="0"/>
              <a:cs typeface="Times New Roman" panose="02020603050405020304" pitchFamily="18" charset="0"/>
            </a:rPr>
            <a:t>Informationen</a:t>
          </a:r>
        </a:p>
      </dsp:txBody>
      <dsp:txXfrm>
        <a:off x="1859985" y="5598343"/>
        <a:ext cx="1102726" cy="338280"/>
      </dsp:txXfrm>
    </dsp:sp>
    <dsp:sp modelId="{39CD6B7A-D9CD-49C5-B1C3-2BF6CA65E035}">
      <dsp:nvSpPr>
        <dsp:cNvPr id="0" name=""/>
        <dsp:cNvSpPr/>
      </dsp:nvSpPr>
      <dsp:spPr>
        <a:xfrm rot="21142503">
          <a:off x="2969975" y="5717835"/>
          <a:ext cx="737377" cy="1455"/>
        </a:xfrm>
        <a:custGeom>
          <a:avLst/>
          <a:gdLst/>
          <a:ahLst/>
          <a:cxnLst/>
          <a:rect l="0" t="0" r="0" b="0"/>
          <a:pathLst>
            <a:path>
              <a:moveTo>
                <a:pt x="0" y="727"/>
              </a:moveTo>
              <a:lnTo>
                <a:pt x="737377" y="727"/>
              </a:lnTo>
            </a:path>
          </a:pathLst>
        </a:custGeom>
        <a:noFill/>
        <a:ln w="12700" cap="flat" cmpd="sng" algn="ctr">
          <a:solidFill>
            <a:schemeClr val="dk1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2700" tIns="0" rIns="12700" bIns="0" numCol="1" spcCol="1270" anchor="ctr" anchorCtr="0">
          <a:noAutofit/>
        </a:bodyPr>
        <a:lstStyle/>
        <a:p>
          <a:pPr marL="0" lvl="0" indent="0" algn="ctr" defTabSz="4889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endParaRPr lang="de-DE" sz="1100" kern="1200">
            <a:latin typeface="Times New Roman" panose="02020603050405020304" pitchFamily="18" charset="0"/>
            <a:cs typeface="Times New Roman" panose="02020603050405020304" pitchFamily="18" charset="0"/>
          </a:endParaRPr>
        </a:p>
      </dsp:txBody>
      <dsp:txXfrm>
        <a:off x="-2542888" y="5700128"/>
        <a:ext cx="11763107" cy="36868"/>
      </dsp:txXfrm>
    </dsp:sp>
    <dsp:sp modelId="{800253CE-BB59-4266-9CEA-CEBDA03E4027}">
      <dsp:nvSpPr>
        <dsp:cNvPr id="0" name=""/>
        <dsp:cNvSpPr/>
      </dsp:nvSpPr>
      <dsp:spPr>
        <a:xfrm>
          <a:off x="3704093" y="5587414"/>
          <a:ext cx="1580757" cy="164455"/>
        </a:xfrm>
        <a:prstGeom prst="roundRect">
          <a:avLst>
            <a:gd name="adj" fmla="val 10000"/>
          </a:avLst>
        </a:prstGeom>
        <a:solidFill>
          <a:schemeClr val="lt1"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dk1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6985" tIns="6985" rIns="6985" bIns="6985" numCol="1" spcCol="1270" anchor="ctr" anchorCtr="0">
          <a:noAutofit/>
        </a:bodyPr>
        <a:lstStyle/>
        <a:p>
          <a:pPr marL="0" lvl="0" indent="0" algn="ctr" defTabSz="466725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de-DE" sz="1050" kern="1200">
              <a:latin typeface="Times New Roman" panose="02020603050405020304" pitchFamily="18" charset="0"/>
              <a:cs typeface="Times New Roman" panose="02020603050405020304" pitchFamily="18" charset="0"/>
            </a:rPr>
            <a:t>Statistiken und Daten</a:t>
          </a:r>
        </a:p>
      </dsp:txBody>
      <dsp:txXfrm>
        <a:off x="3708910" y="5592231"/>
        <a:ext cx="1571123" cy="154821"/>
      </dsp:txXfrm>
    </dsp:sp>
    <dsp:sp modelId="{83DAAF3F-DBF1-49B0-8604-B525FB5C908A}">
      <dsp:nvSpPr>
        <dsp:cNvPr id="0" name=""/>
        <dsp:cNvSpPr/>
      </dsp:nvSpPr>
      <dsp:spPr>
        <a:xfrm rot="536821">
          <a:off x="2968734" y="5824287"/>
          <a:ext cx="739860" cy="1455"/>
        </a:xfrm>
        <a:custGeom>
          <a:avLst/>
          <a:gdLst/>
          <a:ahLst/>
          <a:cxnLst/>
          <a:rect l="0" t="0" r="0" b="0"/>
          <a:pathLst>
            <a:path>
              <a:moveTo>
                <a:pt x="0" y="727"/>
              </a:moveTo>
              <a:lnTo>
                <a:pt x="739860" y="727"/>
              </a:lnTo>
            </a:path>
          </a:pathLst>
        </a:custGeom>
        <a:noFill/>
        <a:ln w="12700" cap="flat" cmpd="sng" algn="ctr">
          <a:solidFill>
            <a:schemeClr val="dk1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2700" tIns="0" rIns="12700" bIns="0" numCol="1" spcCol="1270" anchor="ctr" anchorCtr="0">
          <a:noAutofit/>
        </a:bodyPr>
        <a:lstStyle/>
        <a:p>
          <a:pPr marL="0" lvl="0" indent="0" algn="ctr" defTabSz="4889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endParaRPr lang="de-DE" sz="1100" kern="1200">
            <a:latin typeface="Times New Roman" panose="02020603050405020304" pitchFamily="18" charset="0"/>
            <a:cs typeface="Times New Roman" panose="02020603050405020304" pitchFamily="18" charset="0"/>
          </a:endParaRPr>
        </a:p>
      </dsp:txBody>
      <dsp:txXfrm>
        <a:off x="-2542888" y="5806518"/>
        <a:ext cx="11763107" cy="36993"/>
      </dsp:txXfrm>
    </dsp:sp>
    <dsp:sp modelId="{914215F8-CB99-49A5-92BE-A5364C5EF1A5}">
      <dsp:nvSpPr>
        <dsp:cNvPr id="0" name=""/>
        <dsp:cNvSpPr/>
      </dsp:nvSpPr>
      <dsp:spPr>
        <a:xfrm>
          <a:off x="3704094" y="5800320"/>
          <a:ext cx="1580757" cy="164454"/>
        </a:xfrm>
        <a:prstGeom prst="roundRect">
          <a:avLst>
            <a:gd name="adj" fmla="val 10000"/>
          </a:avLst>
        </a:prstGeom>
        <a:solidFill>
          <a:schemeClr val="lt1"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dk1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6985" tIns="6985" rIns="6985" bIns="6985" numCol="1" spcCol="1270" anchor="ctr" anchorCtr="0">
          <a:noAutofit/>
        </a:bodyPr>
        <a:lstStyle/>
        <a:p>
          <a:pPr marL="0" lvl="0" indent="0" algn="ctr" defTabSz="466725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de-DE" sz="1050" kern="1200" err="1">
              <a:latin typeface="Times New Roman" panose="02020603050405020304" pitchFamily="18" charset="0"/>
              <a:cs typeface="Times New Roman" panose="02020603050405020304" pitchFamily="18" charset="0"/>
            </a:rPr>
            <a:t>Mis</a:t>
          </a:r>
          <a:r>
            <a:rPr lang="de-DE" sz="1050" kern="1200">
              <a:latin typeface="Times New Roman" panose="02020603050405020304" pitchFamily="18" charset="0"/>
              <a:cs typeface="Times New Roman" panose="02020603050405020304" pitchFamily="18" charset="0"/>
            </a:rPr>
            <a:t>- und </a:t>
          </a:r>
          <a:r>
            <a:rPr lang="de-DE" sz="1050" kern="1200" err="1">
              <a:latin typeface="Times New Roman" panose="02020603050405020304" pitchFamily="18" charset="0"/>
              <a:cs typeface="Times New Roman" panose="02020603050405020304" pitchFamily="18" charset="0"/>
            </a:rPr>
            <a:t>Disinformationen</a:t>
          </a:r>
          <a:endParaRPr lang="de-DE" sz="1050" kern="1200">
            <a:latin typeface="Times New Roman" panose="02020603050405020304" pitchFamily="18" charset="0"/>
            <a:cs typeface="Times New Roman" panose="02020603050405020304" pitchFamily="18" charset="0"/>
          </a:endParaRPr>
        </a:p>
      </dsp:txBody>
      <dsp:txXfrm>
        <a:off x="3708911" y="5805137"/>
        <a:ext cx="1571123" cy="154820"/>
      </dsp:txXfrm>
    </dsp:sp>
  </dsp:spTree>
</dsp:drawing>
</file>

<file path=ppt/diagrams/layout1.xml><?xml version="1.0" encoding="utf-8"?>
<dgm:layoutDef xmlns:dgm="http://schemas.openxmlformats.org/drawingml/2006/diagram" xmlns:a="http://schemas.openxmlformats.org/drawingml/2006/main" uniqueId="urn:microsoft.com/office/officeart/2005/8/layout/hierarchy2">
  <dgm:title val=""/>
  <dgm:desc val=""/>
  <dgm:catLst>
    <dgm:cat type="hierarchy" pri="5000"/>
  </dgm:catLst>
  <dgm:sampData>
    <dgm:dataModel>
      <dgm:ptLst>
        <dgm:pt modelId="0" type="doc"/>
        <dgm:pt modelId="1">
          <dgm:prSet phldr="1"/>
        </dgm:pt>
        <dgm:pt modelId="2">
          <dgm:prSet phldr="1"/>
        </dgm:pt>
        <dgm:pt modelId="21">
          <dgm:prSet phldr="1"/>
        </dgm:pt>
        <dgm:pt modelId="22">
          <dgm:prSet phldr="1"/>
        </dgm:pt>
        <dgm:pt modelId="3">
          <dgm:prSet phldr="1"/>
        </dgm:pt>
        <dgm:pt modelId="31">
          <dgm:prSet phldr="1"/>
        </dgm:pt>
      </dgm:ptLst>
      <dgm:cxnLst>
        <dgm:cxn modelId="4" srcId="0" destId="1" srcOrd="0" destOrd="0"/>
        <dgm:cxn modelId="5" srcId="1" destId="2" srcOrd="0" destOrd="0"/>
        <dgm:cxn modelId="6" srcId="1" destId="3" srcOrd="1" destOrd="0"/>
        <dgm:cxn modelId="23" srcId="2" destId="21" srcOrd="0" destOrd="0"/>
        <dgm:cxn modelId="24" srcId="2" destId="22" srcOrd="1" destOrd="0"/>
        <dgm:cxn modelId="33" srcId="3" destId="31" srcOrd="0" destOrd="0"/>
      </dgm:cxnLst>
      <dgm:bg/>
      <dgm:whole/>
    </dgm:dataModel>
  </dgm:sampData>
  <dgm:styleData>
    <dgm:dataModel>
      <dgm:ptLst>
        <dgm:pt modelId="0" type="doc"/>
        <dgm:pt modelId="1"/>
        <dgm:pt modelId="11"/>
        <dgm:pt modelId="12"/>
      </dgm:ptLst>
      <dgm:cxnLst>
        <dgm:cxn modelId="2" srcId="0" destId="1" srcOrd="0" destOrd="0"/>
        <dgm:cxn modelId="13" srcId="1" destId="11" srcOrd="0" destOrd="0"/>
        <dgm:cxn modelId="14" srcId="1" destId="12" srcOrd="1" destOrd="0"/>
      </dgm:cxnLst>
      <dgm:bg/>
      <dgm:whole/>
    </dgm:dataModel>
  </dgm:styleData>
  <dgm:clrData>
    <dgm:dataModel>
      <dgm:ptLst>
        <dgm:pt modelId="0" type="doc"/>
        <dgm:pt modelId="1"/>
        <dgm:pt modelId="2"/>
        <dgm:pt modelId="21"/>
        <dgm:pt modelId="211"/>
        <dgm:pt modelId="3"/>
        <dgm:pt modelId="31"/>
        <dgm:pt modelId="311"/>
      </dgm:ptLst>
      <dgm:cxnLst>
        <dgm:cxn modelId="4" srcId="0" destId="1" srcOrd="0" destOrd="0"/>
        <dgm:cxn modelId="5" srcId="1" destId="2" srcOrd="0" destOrd="0"/>
        <dgm:cxn modelId="6" srcId="1" destId="3" srcOrd="1" destOrd="0"/>
        <dgm:cxn modelId="23" srcId="2" destId="21" srcOrd="0" destOrd="0"/>
        <dgm:cxn modelId="24" srcId="21" destId="211" srcOrd="0" destOrd="0"/>
        <dgm:cxn modelId="33" srcId="3" destId="31" srcOrd="0" destOrd="0"/>
        <dgm:cxn modelId="34" srcId="31" destId="311" srcOrd="0" destOrd="0"/>
      </dgm:cxnLst>
      <dgm:bg/>
      <dgm:whole/>
    </dgm:dataModel>
  </dgm:clrData>
  <dgm:layoutNode name="diagram">
    <dgm:varLst>
      <dgm:chPref val="1"/>
      <dgm:dir/>
      <dgm:animOne val="branch"/>
      <dgm:animLvl val="lvl"/>
      <dgm:resizeHandles val="exact"/>
    </dgm:varLst>
    <dgm:choose name="Name0">
      <dgm:if name="Name1" func="var" arg="dir" op="equ" val="norm">
        <dgm:alg type="hierChild">
          <dgm:param type="linDir" val="fromT"/>
          <dgm:param type="chAlign" val="l"/>
        </dgm:alg>
      </dgm:if>
      <dgm:else name="Name2">
        <dgm:alg type="hierChild">
          <dgm:param type="linDir" val="fromT"/>
          <dgm:param type="chAlign" val="r"/>
        </dgm:alg>
      </dgm:else>
    </dgm:choose>
    <dgm:shape xmlns:r="http://schemas.openxmlformats.org/officeDocument/2006/relationships" r:blip="">
      <dgm:adjLst/>
    </dgm:shape>
    <dgm:presOf/>
    <dgm:constrLst>
      <dgm:constr type="h" for="des" ptType="node" refType="h"/>
      <dgm:constr type="w" for="des" ptType="node" refType="h" refFor="des" refPtType="node" fact="2"/>
      <dgm:constr type="sibSp" refType="h" refFor="des" refPtType="node" op="equ" fact="0.15"/>
      <dgm:constr type="sibSp" for="des" forName="level2hierChild" refType="h" refFor="des" refPtType="node" op="equ" fact="0.15"/>
      <dgm:constr type="sibSp" for="des" forName="level3hierChild" refType="h" refFor="des" refPtType="node" op="equ" fact="0.15"/>
      <dgm:constr type="sp" for="des" forName="root1" refType="w" refFor="des" refPtType="node" fact="0.4"/>
      <dgm:constr type="sp" for="des" forName="root2" refType="sp" refFor="des" refForName="root1" op="equ"/>
      <dgm:constr type="primFontSz" for="des" ptType="node" op="equ" val="65"/>
      <dgm:constr type="primFontSz" for="des" forName="connTx" op="equ" val="55"/>
      <dgm:constr type="primFontSz" for="des" forName="connTx" refType="primFontSz" refFor="des" refPtType="node" op="lte" fact="0.8"/>
    </dgm:constrLst>
    <dgm:ruleLst/>
    <dgm:forEach name="Name3" axis="ch">
      <dgm:forEach name="Name4" axis="self" ptType="node">
        <dgm:layoutNode name="root1">
          <dgm:choose name="Name5">
            <dgm:if name="Name6" func="var" arg="dir" op="equ" val="norm">
              <dgm:alg type="hierRoot">
                <dgm:param type="hierAlign" val="lCtrCh"/>
              </dgm:alg>
            </dgm:if>
            <dgm:else name="Name7">
              <dgm:alg type="hierRoot">
                <dgm:param type="hierAlign" val="rCtrCh"/>
              </dgm:alg>
            </dgm:else>
          </dgm:choose>
          <dgm:shape xmlns:r="http://schemas.openxmlformats.org/officeDocument/2006/relationships" r:blip="">
            <dgm:adjLst/>
          </dgm:shape>
          <dgm:presOf/>
          <dgm:constrLst/>
          <dgm:ruleLst/>
          <dgm:layoutNode name="LevelOneTextNode" styleLbl="node0">
            <dgm:varLst>
              <dgm:chPref val="3"/>
            </dgm:varLst>
            <dgm:alg type="tx"/>
            <dgm:shape xmlns:r="http://schemas.openxmlformats.org/officeDocument/2006/relationships" type="roundRect" r:blip="">
              <dgm:adjLst>
                <dgm:adj idx="1" val="0.1"/>
              </dgm:adjLst>
            </dgm:shape>
            <dgm:presOf axis="self"/>
            <dgm:constrLst>
              <dgm:constr type="tMarg" refType="primFontSz" fact="0.05"/>
              <dgm:constr type="bMarg" refType="primFontSz" fact="0.05"/>
              <dgm:constr type="lMarg" refType="primFontSz" fact="0.05"/>
              <dgm:constr type="rMarg" refType="primFontSz" fact="0.05"/>
            </dgm:constrLst>
            <dgm:ruleLst>
              <dgm:rule type="primFontSz" val="5" fact="NaN" max="NaN"/>
            </dgm:ruleLst>
          </dgm:layoutNode>
          <dgm:layoutNode name="level2hierChild">
            <dgm:choose name="Name8">
              <dgm:if name="Name9" func="var" arg="dir" op="equ" val="norm">
                <dgm:alg type="hierChild">
                  <dgm:param type="linDir" val="fromT"/>
                  <dgm:param type="chAlign" val="l"/>
                </dgm:alg>
              </dgm:if>
              <dgm:else name="Name10">
                <dgm:alg type="hierChild">
                  <dgm:param type="linDir" val="fromT"/>
                  <dgm:param type="chAlign" val="r"/>
                </dgm:alg>
              </dgm:else>
            </dgm:choose>
            <dgm:shape xmlns:r="http://schemas.openxmlformats.org/officeDocument/2006/relationships" r:blip="">
              <dgm:adjLst/>
            </dgm:shape>
            <dgm:presOf/>
            <dgm:constrLst/>
            <dgm:ruleLst/>
            <dgm:forEach name="repeat" axis="ch">
              <dgm:forEach name="Name11" axis="self" ptType="parTrans" cnt="1">
                <dgm:layoutNode name="conn2-1">
                  <dgm:choose name="Name12">
                    <dgm:if name="Name13" func="var" arg="dir" op="equ" val="norm">
                      <dgm:alg type="conn">
                        <dgm:param type="dim" val="1D"/>
                        <dgm:param type="begPts" val="midR"/>
                        <dgm:param type="endPts" val="midL"/>
                        <dgm:param type="endSty" val="noArr"/>
                      </dgm:alg>
                    </dgm:if>
                    <dgm:else name="Name14">
                      <dgm:alg type="conn">
                        <dgm:param type="dim" val="1D"/>
                        <dgm:param type="begPts" val="midL"/>
                        <dgm:param type="endPts" val="midR"/>
                        <dgm:param type="endSty" val="noArr"/>
                      </dgm:alg>
                    </dgm:else>
                  </dgm:choose>
                  <dgm:shape xmlns:r="http://schemas.openxmlformats.org/officeDocument/2006/relationships" type="conn" r:blip="">
                    <dgm:adjLst/>
                  </dgm:shape>
                  <dgm:presOf axis="self"/>
                  <dgm:constrLst>
                    <dgm:constr type="w" val="1"/>
                    <dgm:constr type="h" val="5"/>
                    <dgm:constr type="connDist"/>
                    <dgm:constr type="begPad"/>
                    <dgm:constr type="endPad"/>
                    <dgm:constr type="userA" for="ch" refType="connDist"/>
                  </dgm:constrLst>
                  <dgm:ruleLst/>
                  <dgm:layoutNode name="connTx">
                    <dgm:alg type="tx">
                      <dgm:param type="autoTxRot" val="grav"/>
                    </dgm:alg>
                    <dgm:shape xmlns:r="http://schemas.openxmlformats.org/officeDocument/2006/relationships" type="rect" r:blip="" hideGeom="1">
                      <dgm:adjLst/>
                    </dgm:shape>
                    <dgm:presOf axis="self"/>
                    <dgm:constrLst>
                      <dgm:constr type="userA"/>
                      <dgm:constr type="w" refType="userA" fact="0.05"/>
                      <dgm:constr type="h" refType="userA" fact="0.05"/>
                      <dgm:constr type="lMarg" val="1"/>
                      <dgm:constr type="rMarg" val="1"/>
                      <dgm:constr type="tMarg"/>
                      <dgm:constr type="bMarg"/>
                    </dgm:constrLst>
                    <dgm:ruleLst>
                      <dgm:rule type="h" val="NaN" fact="0.25" max="NaN"/>
                      <dgm:rule type="w" val="NaN" fact="0.8" max="NaN"/>
                      <dgm:rule type="primFontSz" val="5" fact="NaN" max="NaN"/>
                    </dgm:ruleLst>
                  </dgm:layoutNode>
                </dgm:layoutNode>
              </dgm:forEach>
              <dgm:forEach name="Name15" axis="self" ptType="node">
                <dgm:layoutNode name="root2">
                  <dgm:choose name="Name16">
                    <dgm:if name="Name17" func="var" arg="dir" op="equ" val="norm">
                      <dgm:alg type="hierRoot">
                        <dgm:param type="hierAlign" val="lCtrCh"/>
                      </dgm:alg>
                    </dgm:if>
                    <dgm:else name="Name18">
                      <dgm:alg type="hierRoot">
                        <dgm:param type="hierAlign" val="rCtrCh"/>
                      </dgm:alg>
                    </dgm:else>
                  </dgm:choose>
                  <dgm:shape xmlns:r="http://schemas.openxmlformats.org/officeDocument/2006/relationships" r:blip="">
                    <dgm:adjLst/>
                  </dgm:shape>
                  <dgm:presOf/>
                  <dgm:constrLst/>
                  <dgm:ruleLst/>
                  <dgm:layoutNode name="LevelTwoTextNode">
                    <dgm:varLst>
                      <dgm:chPref val="3"/>
                    </dgm:varLst>
                    <dgm:alg type="tx"/>
                    <dgm:shape xmlns:r="http://schemas.openxmlformats.org/officeDocument/2006/relationships" type="roundRect" r:blip="">
                      <dgm:adjLst>
                        <dgm:adj idx="1" val="0.1"/>
                      </dgm:adjLst>
                    </dgm:shape>
                    <dgm:presOf axis="self"/>
                    <dgm:constrLst>
                      <dgm:constr type="tMarg" refType="primFontSz" fact="0.05"/>
                      <dgm:constr type="bMarg" refType="primFontSz" fact="0.05"/>
                      <dgm:constr type="lMarg" refType="primFontSz" fact="0.05"/>
                      <dgm:constr type="rMarg" refType="primFontSz" fact="0.05"/>
                    </dgm:constrLst>
                    <dgm:ruleLst>
                      <dgm:rule type="primFontSz" val="5" fact="NaN" max="NaN"/>
                    </dgm:ruleLst>
                  </dgm:layoutNode>
                  <dgm:layoutNode name="level3hierChild">
                    <dgm:choose name="Name19">
                      <dgm:if name="Name20" func="var" arg="dir" op="equ" val="norm">
                        <dgm:alg type="hierChild">
                          <dgm:param type="linDir" val="fromT"/>
                          <dgm:param type="chAlign" val="l"/>
                        </dgm:alg>
                      </dgm:if>
                      <dgm:else name="Name21">
                        <dgm:alg type="hierChild">
                          <dgm:param type="linDir" val="fromT"/>
                          <dgm:param type="chAlign" val="r"/>
                        </dgm:alg>
                      </dgm:else>
                    </dgm:choose>
                    <dgm:shape xmlns:r="http://schemas.openxmlformats.org/officeDocument/2006/relationships" r:blip="">
                      <dgm:adjLst/>
                    </dgm:shape>
                    <dgm:presOf/>
                    <dgm:constrLst/>
                    <dgm:ruleLst/>
                    <dgm:forEach name="Name22" ref="repeat"/>
                  </dgm:layoutNode>
                </dgm:layoutNode>
              </dgm:forEach>
            </dgm:forEach>
          </dgm:layoutNode>
        </dgm:layoutNode>
      </dgm:forEach>
    </dgm:forEach>
  </dgm:layoutNode>
</dgm:layoutDef>
</file>

<file path=ppt/diagrams/layout2.xml><?xml version="1.0" encoding="utf-8"?>
<dgm:layoutDef xmlns:dgm="http://schemas.openxmlformats.org/drawingml/2006/diagram" xmlns:a="http://schemas.openxmlformats.org/drawingml/2006/main" uniqueId="urn:microsoft.com/office/officeart/2005/8/layout/hierarchy2">
  <dgm:title val=""/>
  <dgm:desc val=""/>
  <dgm:catLst>
    <dgm:cat type="hierarchy" pri="5000"/>
  </dgm:catLst>
  <dgm:sampData>
    <dgm:dataModel>
      <dgm:ptLst>
        <dgm:pt modelId="0" type="doc"/>
        <dgm:pt modelId="1">
          <dgm:prSet phldr="1"/>
        </dgm:pt>
        <dgm:pt modelId="2">
          <dgm:prSet phldr="1"/>
        </dgm:pt>
        <dgm:pt modelId="21">
          <dgm:prSet phldr="1"/>
        </dgm:pt>
        <dgm:pt modelId="22">
          <dgm:prSet phldr="1"/>
        </dgm:pt>
        <dgm:pt modelId="3">
          <dgm:prSet phldr="1"/>
        </dgm:pt>
        <dgm:pt modelId="31">
          <dgm:prSet phldr="1"/>
        </dgm:pt>
      </dgm:ptLst>
      <dgm:cxnLst>
        <dgm:cxn modelId="4" srcId="0" destId="1" srcOrd="0" destOrd="0"/>
        <dgm:cxn modelId="5" srcId="1" destId="2" srcOrd="0" destOrd="0"/>
        <dgm:cxn modelId="6" srcId="1" destId="3" srcOrd="1" destOrd="0"/>
        <dgm:cxn modelId="23" srcId="2" destId="21" srcOrd="0" destOrd="0"/>
        <dgm:cxn modelId="24" srcId="2" destId="22" srcOrd="1" destOrd="0"/>
        <dgm:cxn modelId="33" srcId="3" destId="31" srcOrd="0" destOrd="0"/>
      </dgm:cxnLst>
      <dgm:bg/>
      <dgm:whole/>
    </dgm:dataModel>
  </dgm:sampData>
  <dgm:styleData>
    <dgm:dataModel>
      <dgm:ptLst>
        <dgm:pt modelId="0" type="doc"/>
        <dgm:pt modelId="1"/>
        <dgm:pt modelId="11"/>
        <dgm:pt modelId="12"/>
      </dgm:ptLst>
      <dgm:cxnLst>
        <dgm:cxn modelId="2" srcId="0" destId="1" srcOrd="0" destOrd="0"/>
        <dgm:cxn modelId="13" srcId="1" destId="11" srcOrd="0" destOrd="0"/>
        <dgm:cxn modelId="14" srcId="1" destId="12" srcOrd="1" destOrd="0"/>
      </dgm:cxnLst>
      <dgm:bg/>
      <dgm:whole/>
    </dgm:dataModel>
  </dgm:styleData>
  <dgm:clrData>
    <dgm:dataModel>
      <dgm:ptLst>
        <dgm:pt modelId="0" type="doc"/>
        <dgm:pt modelId="1"/>
        <dgm:pt modelId="2"/>
        <dgm:pt modelId="21"/>
        <dgm:pt modelId="211"/>
        <dgm:pt modelId="3"/>
        <dgm:pt modelId="31"/>
        <dgm:pt modelId="311"/>
      </dgm:ptLst>
      <dgm:cxnLst>
        <dgm:cxn modelId="4" srcId="0" destId="1" srcOrd="0" destOrd="0"/>
        <dgm:cxn modelId="5" srcId="1" destId="2" srcOrd="0" destOrd="0"/>
        <dgm:cxn modelId="6" srcId="1" destId="3" srcOrd="1" destOrd="0"/>
        <dgm:cxn modelId="23" srcId="2" destId="21" srcOrd="0" destOrd="0"/>
        <dgm:cxn modelId="24" srcId="21" destId="211" srcOrd="0" destOrd="0"/>
        <dgm:cxn modelId="33" srcId="3" destId="31" srcOrd="0" destOrd="0"/>
        <dgm:cxn modelId="34" srcId="31" destId="311" srcOrd="0" destOrd="0"/>
      </dgm:cxnLst>
      <dgm:bg/>
      <dgm:whole/>
    </dgm:dataModel>
  </dgm:clrData>
  <dgm:layoutNode name="diagram">
    <dgm:varLst>
      <dgm:chPref val="1"/>
      <dgm:dir/>
      <dgm:animOne val="branch"/>
      <dgm:animLvl val="lvl"/>
      <dgm:resizeHandles val="exact"/>
    </dgm:varLst>
    <dgm:choose name="Name0">
      <dgm:if name="Name1" func="var" arg="dir" op="equ" val="norm">
        <dgm:alg type="hierChild">
          <dgm:param type="linDir" val="fromT"/>
          <dgm:param type="chAlign" val="l"/>
        </dgm:alg>
      </dgm:if>
      <dgm:else name="Name2">
        <dgm:alg type="hierChild">
          <dgm:param type="linDir" val="fromT"/>
          <dgm:param type="chAlign" val="r"/>
        </dgm:alg>
      </dgm:else>
    </dgm:choose>
    <dgm:shape xmlns:r="http://schemas.openxmlformats.org/officeDocument/2006/relationships" r:blip="">
      <dgm:adjLst/>
    </dgm:shape>
    <dgm:presOf/>
    <dgm:constrLst>
      <dgm:constr type="h" for="des" ptType="node" refType="h"/>
      <dgm:constr type="w" for="des" ptType="node" refType="h" refFor="des" refPtType="node" fact="2"/>
      <dgm:constr type="sibSp" refType="h" refFor="des" refPtType="node" op="equ" fact="0.15"/>
      <dgm:constr type="sibSp" for="des" forName="level2hierChild" refType="h" refFor="des" refPtType="node" op="equ" fact="0.15"/>
      <dgm:constr type="sibSp" for="des" forName="level3hierChild" refType="h" refFor="des" refPtType="node" op="equ" fact="0.15"/>
      <dgm:constr type="sp" for="des" forName="root1" refType="w" refFor="des" refPtType="node" fact="0.4"/>
      <dgm:constr type="sp" for="des" forName="root2" refType="sp" refFor="des" refForName="root1" op="equ"/>
      <dgm:constr type="primFontSz" for="des" ptType="node" op="equ" val="65"/>
      <dgm:constr type="primFontSz" for="des" forName="connTx" op="equ" val="55"/>
      <dgm:constr type="primFontSz" for="des" forName="connTx" refType="primFontSz" refFor="des" refPtType="node" op="lte" fact="0.8"/>
    </dgm:constrLst>
    <dgm:ruleLst/>
    <dgm:forEach name="Name3" axis="ch">
      <dgm:forEach name="Name4" axis="self" ptType="node">
        <dgm:layoutNode name="root1">
          <dgm:choose name="Name5">
            <dgm:if name="Name6" func="var" arg="dir" op="equ" val="norm">
              <dgm:alg type="hierRoot">
                <dgm:param type="hierAlign" val="lCtrCh"/>
              </dgm:alg>
            </dgm:if>
            <dgm:else name="Name7">
              <dgm:alg type="hierRoot">
                <dgm:param type="hierAlign" val="rCtrCh"/>
              </dgm:alg>
            </dgm:else>
          </dgm:choose>
          <dgm:shape xmlns:r="http://schemas.openxmlformats.org/officeDocument/2006/relationships" r:blip="">
            <dgm:adjLst/>
          </dgm:shape>
          <dgm:presOf/>
          <dgm:constrLst/>
          <dgm:ruleLst/>
          <dgm:layoutNode name="LevelOneTextNode" styleLbl="node0">
            <dgm:varLst>
              <dgm:chPref val="3"/>
            </dgm:varLst>
            <dgm:alg type="tx"/>
            <dgm:shape xmlns:r="http://schemas.openxmlformats.org/officeDocument/2006/relationships" type="roundRect" r:blip="">
              <dgm:adjLst>
                <dgm:adj idx="1" val="0.1"/>
              </dgm:adjLst>
            </dgm:shape>
            <dgm:presOf axis="self"/>
            <dgm:constrLst>
              <dgm:constr type="tMarg" refType="primFontSz" fact="0.05"/>
              <dgm:constr type="bMarg" refType="primFontSz" fact="0.05"/>
              <dgm:constr type="lMarg" refType="primFontSz" fact="0.05"/>
              <dgm:constr type="rMarg" refType="primFontSz" fact="0.05"/>
            </dgm:constrLst>
            <dgm:ruleLst>
              <dgm:rule type="primFontSz" val="5" fact="NaN" max="NaN"/>
            </dgm:ruleLst>
          </dgm:layoutNode>
          <dgm:layoutNode name="level2hierChild">
            <dgm:choose name="Name8">
              <dgm:if name="Name9" func="var" arg="dir" op="equ" val="norm">
                <dgm:alg type="hierChild">
                  <dgm:param type="linDir" val="fromT"/>
                  <dgm:param type="chAlign" val="l"/>
                </dgm:alg>
              </dgm:if>
              <dgm:else name="Name10">
                <dgm:alg type="hierChild">
                  <dgm:param type="linDir" val="fromT"/>
                  <dgm:param type="chAlign" val="r"/>
                </dgm:alg>
              </dgm:else>
            </dgm:choose>
            <dgm:shape xmlns:r="http://schemas.openxmlformats.org/officeDocument/2006/relationships" r:blip="">
              <dgm:adjLst/>
            </dgm:shape>
            <dgm:presOf/>
            <dgm:constrLst/>
            <dgm:ruleLst/>
            <dgm:forEach name="repeat" axis="ch">
              <dgm:forEach name="Name11" axis="self" ptType="parTrans" cnt="1">
                <dgm:layoutNode name="conn2-1">
                  <dgm:choose name="Name12">
                    <dgm:if name="Name13" func="var" arg="dir" op="equ" val="norm">
                      <dgm:alg type="conn">
                        <dgm:param type="dim" val="1D"/>
                        <dgm:param type="begPts" val="midR"/>
                        <dgm:param type="endPts" val="midL"/>
                        <dgm:param type="endSty" val="noArr"/>
                      </dgm:alg>
                    </dgm:if>
                    <dgm:else name="Name14">
                      <dgm:alg type="conn">
                        <dgm:param type="dim" val="1D"/>
                        <dgm:param type="begPts" val="midL"/>
                        <dgm:param type="endPts" val="midR"/>
                        <dgm:param type="endSty" val="noArr"/>
                      </dgm:alg>
                    </dgm:else>
                  </dgm:choose>
                  <dgm:shape xmlns:r="http://schemas.openxmlformats.org/officeDocument/2006/relationships" type="conn" r:blip="">
                    <dgm:adjLst/>
                  </dgm:shape>
                  <dgm:presOf axis="self"/>
                  <dgm:constrLst>
                    <dgm:constr type="w" val="1"/>
                    <dgm:constr type="h" val="5"/>
                    <dgm:constr type="connDist"/>
                    <dgm:constr type="begPad"/>
                    <dgm:constr type="endPad"/>
                    <dgm:constr type="userA" for="ch" refType="connDist"/>
                  </dgm:constrLst>
                  <dgm:ruleLst/>
                  <dgm:layoutNode name="connTx">
                    <dgm:alg type="tx">
                      <dgm:param type="autoTxRot" val="grav"/>
                    </dgm:alg>
                    <dgm:shape xmlns:r="http://schemas.openxmlformats.org/officeDocument/2006/relationships" type="rect" r:blip="" hideGeom="1">
                      <dgm:adjLst/>
                    </dgm:shape>
                    <dgm:presOf axis="self"/>
                    <dgm:constrLst>
                      <dgm:constr type="userA"/>
                      <dgm:constr type="w" refType="userA" fact="0.05"/>
                      <dgm:constr type="h" refType="userA" fact="0.05"/>
                      <dgm:constr type="lMarg" val="1"/>
                      <dgm:constr type="rMarg" val="1"/>
                      <dgm:constr type="tMarg"/>
                      <dgm:constr type="bMarg"/>
                    </dgm:constrLst>
                    <dgm:ruleLst>
                      <dgm:rule type="h" val="NaN" fact="0.25" max="NaN"/>
                      <dgm:rule type="w" val="NaN" fact="0.8" max="NaN"/>
                      <dgm:rule type="primFontSz" val="5" fact="NaN" max="NaN"/>
                    </dgm:ruleLst>
                  </dgm:layoutNode>
                </dgm:layoutNode>
              </dgm:forEach>
              <dgm:forEach name="Name15" axis="self" ptType="node">
                <dgm:layoutNode name="root2">
                  <dgm:choose name="Name16">
                    <dgm:if name="Name17" func="var" arg="dir" op="equ" val="norm">
                      <dgm:alg type="hierRoot">
                        <dgm:param type="hierAlign" val="lCtrCh"/>
                      </dgm:alg>
                    </dgm:if>
                    <dgm:else name="Name18">
                      <dgm:alg type="hierRoot">
                        <dgm:param type="hierAlign" val="rCtrCh"/>
                      </dgm:alg>
                    </dgm:else>
                  </dgm:choose>
                  <dgm:shape xmlns:r="http://schemas.openxmlformats.org/officeDocument/2006/relationships" r:blip="">
                    <dgm:adjLst/>
                  </dgm:shape>
                  <dgm:presOf/>
                  <dgm:constrLst/>
                  <dgm:ruleLst/>
                  <dgm:layoutNode name="LevelTwoTextNode">
                    <dgm:varLst>
                      <dgm:chPref val="3"/>
                    </dgm:varLst>
                    <dgm:alg type="tx"/>
                    <dgm:shape xmlns:r="http://schemas.openxmlformats.org/officeDocument/2006/relationships" type="roundRect" r:blip="">
                      <dgm:adjLst>
                        <dgm:adj idx="1" val="0.1"/>
                      </dgm:adjLst>
                    </dgm:shape>
                    <dgm:presOf axis="self"/>
                    <dgm:constrLst>
                      <dgm:constr type="tMarg" refType="primFontSz" fact="0.05"/>
                      <dgm:constr type="bMarg" refType="primFontSz" fact="0.05"/>
                      <dgm:constr type="lMarg" refType="primFontSz" fact="0.05"/>
                      <dgm:constr type="rMarg" refType="primFontSz" fact="0.05"/>
                    </dgm:constrLst>
                    <dgm:ruleLst>
                      <dgm:rule type="primFontSz" val="5" fact="NaN" max="NaN"/>
                    </dgm:ruleLst>
                  </dgm:layoutNode>
                  <dgm:layoutNode name="level3hierChild">
                    <dgm:choose name="Name19">
                      <dgm:if name="Name20" func="var" arg="dir" op="equ" val="norm">
                        <dgm:alg type="hierChild">
                          <dgm:param type="linDir" val="fromT"/>
                          <dgm:param type="chAlign" val="l"/>
                        </dgm:alg>
                      </dgm:if>
                      <dgm:else name="Name21">
                        <dgm:alg type="hierChild">
                          <dgm:param type="linDir" val="fromT"/>
                          <dgm:param type="chAlign" val="r"/>
                        </dgm:alg>
                      </dgm:else>
                    </dgm:choose>
                    <dgm:shape xmlns:r="http://schemas.openxmlformats.org/officeDocument/2006/relationships" r:blip="">
                      <dgm:adjLst/>
                    </dgm:shape>
                    <dgm:presOf/>
                    <dgm:constrLst/>
                    <dgm:ruleLst/>
                    <dgm:forEach name="Name22" ref="repeat"/>
                  </dgm:layoutNode>
                </dgm:layoutNode>
              </dgm:forEach>
            </dgm:forEach>
          </dgm:layoutNode>
        </dgm:layoutNode>
      </dgm:forEach>
    </dgm:forEach>
  </dgm:layoutNode>
</dgm:layoutDef>
</file>

<file path=ppt/diagrams/quickStyle1.xml><?xml version="1.0" encoding="utf-8"?>
<dgm:styleDef xmlns:dgm="http://schemas.openxmlformats.org/drawingml/2006/diagram" xmlns:a="http://schemas.openxmlformats.org/drawingml/2006/main" uniqueId="urn:microsoft.com/office/officeart/2005/8/quickstyle/simple1">
  <dgm:title val=""/>
  <dgm:desc val=""/>
  <dgm:catLst>
    <dgm:cat type="simple" pri="10100"/>
  </dgm:catLst>
  <dgm:scene3d>
    <a:camera prst="orthographicFront"/>
    <a:lightRig rig="threePt" dir="t"/>
  </dgm:scene3d>
  <dgm:styleLbl name="node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l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ven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tx1"/>
      </a:fontRef>
    </dgm:style>
  </dgm:styleLbl>
  <dgm:styleLbl name="alig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b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sib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callout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sst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1D1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2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3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4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con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dk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Shp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revTx">
    <dgm:scene3d>
      <a:camera prst="orthographicFront"/>
      <a:lightRig rig="threePt" dir="t"/>
    </dgm:scene3d>
    <dgm:sp3d/>
    <dgm:txPr/>
    <dgm:style>
      <a:lnRef idx="0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</dgm:styleDef>
</file>

<file path=ppt/diagrams/quickStyle2.xml><?xml version="1.0" encoding="utf-8"?>
<dgm:styleDef xmlns:dgm="http://schemas.openxmlformats.org/drawingml/2006/diagram" xmlns:a="http://schemas.openxmlformats.org/drawingml/2006/main" uniqueId="urn:microsoft.com/office/officeart/2005/8/quickstyle/simple1">
  <dgm:title val=""/>
  <dgm:desc val=""/>
  <dgm:catLst>
    <dgm:cat type="simple" pri="10100"/>
  </dgm:catLst>
  <dgm:scene3d>
    <a:camera prst="orthographicFront"/>
    <a:lightRig rig="threePt" dir="t"/>
  </dgm:scene3d>
  <dgm:styleLbl name="node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l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ven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tx1"/>
      </a:fontRef>
    </dgm:style>
  </dgm:styleLbl>
  <dgm:styleLbl name="alig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b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sib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callout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sst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1D1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2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3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4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con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dk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Shp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revTx">
    <dgm:scene3d>
      <a:camera prst="orthographicFront"/>
      <a:lightRig rig="threePt" dir="t"/>
    </dgm:scene3d>
    <dgm:sp3d/>
    <dgm:txPr/>
    <dgm:style>
      <a:lnRef idx="0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</dgm:styleDef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jdelijke aanduiding voor koptekst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nl-DE"/>
          </a:p>
        </p:txBody>
      </p:sp>
      <p:sp>
        <p:nvSpPr>
          <p:cNvPr id="3" name="Tijdelijke aanduiding voor datum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8560D9E-BA9E-F64B-BB35-8AA14C66D029}" type="datetimeFigureOut">
              <a:rPr lang="nl-DE" smtClean="0"/>
              <a:t>27.05.23</a:t>
            </a:fld>
            <a:endParaRPr lang="nl-DE"/>
          </a:p>
        </p:txBody>
      </p:sp>
      <p:sp>
        <p:nvSpPr>
          <p:cNvPr id="4" name="Tijdelijke aanduiding voor dia-afbeelding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nl-DE"/>
          </a:p>
        </p:txBody>
      </p:sp>
      <p:sp>
        <p:nvSpPr>
          <p:cNvPr id="5" name="Tijdelijke aanduiding voor notitie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nl-DE"/>
          </a:p>
        </p:txBody>
      </p:sp>
      <p:sp>
        <p:nvSpPr>
          <p:cNvPr id="6" name="Tijdelijke aanduiding voor voettekst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nl-DE"/>
          </a:p>
        </p:txBody>
      </p:sp>
      <p:sp>
        <p:nvSpPr>
          <p:cNvPr id="7" name="Tijdelijke aanduiding voor dianumm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BE7C215-D60F-6846-A217-88F2B3FBB2D3}" type="slidenum">
              <a:rPr lang="nl-DE" smtClean="0"/>
              <a:t>‹nr.›</a:t>
            </a:fld>
            <a:endParaRPr lang="nl-DE"/>
          </a:p>
        </p:txBody>
      </p:sp>
    </p:spTree>
    <p:extLst>
      <p:ext uri="{BB962C8B-B14F-4D97-AF65-F5344CB8AC3E}">
        <p14:creationId xmlns:p14="http://schemas.microsoft.com/office/powerpoint/2010/main" val="264902064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jdelijke aanduiding voor dia-afbeelding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Tijdelijke aanduiding voor notiti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nl-NL" sz="1800" i="1" dirty="0">
                <a:effectLst/>
                <a:latin typeface="Times"/>
              </a:rPr>
              <a:t>Boender TS, Schneider PH, </a:t>
            </a:r>
            <a:r>
              <a:rPr lang="nl-NL" sz="1800" i="1" dirty="0" err="1">
                <a:effectLst/>
                <a:latin typeface="Times"/>
              </a:rPr>
              <a:t>Houareau</a:t>
            </a:r>
            <a:r>
              <a:rPr lang="nl-NL" sz="1800" i="1" dirty="0">
                <a:effectLst/>
                <a:latin typeface="Times"/>
              </a:rPr>
              <a:t> C, </a:t>
            </a:r>
            <a:r>
              <a:rPr lang="nl-NL" sz="1800" i="1" dirty="0" err="1">
                <a:effectLst/>
                <a:latin typeface="Times"/>
              </a:rPr>
              <a:t>Wehrli</a:t>
            </a:r>
            <a:r>
              <a:rPr lang="nl-NL" sz="1800" i="1" dirty="0">
                <a:effectLst/>
                <a:latin typeface="Times"/>
              </a:rPr>
              <a:t> S, </a:t>
            </a:r>
            <a:r>
              <a:rPr lang="nl-NL" sz="1800" i="1" dirty="0" err="1">
                <a:effectLst/>
                <a:latin typeface="Times"/>
              </a:rPr>
              <a:t>Purnat</a:t>
            </a:r>
            <a:r>
              <a:rPr lang="nl-NL" sz="1800" i="1" dirty="0">
                <a:effectLst/>
                <a:latin typeface="Times"/>
              </a:rPr>
              <a:t> TD, </a:t>
            </a:r>
            <a:r>
              <a:rPr lang="nl-NL" sz="1800" i="1" dirty="0" err="1">
                <a:effectLst/>
                <a:latin typeface="Times"/>
              </a:rPr>
              <a:t>Ishizumi</a:t>
            </a:r>
            <a:r>
              <a:rPr lang="nl-NL" sz="1800" i="1" dirty="0">
                <a:effectLst/>
                <a:latin typeface="Times"/>
              </a:rPr>
              <a:t> A, Wilhelm E, </a:t>
            </a:r>
            <a:r>
              <a:rPr lang="nl-NL" sz="1800" i="1" dirty="0" err="1">
                <a:effectLst/>
                <a:latin typeface="Times"/>
              </a:rPr>
              <a:t>Voegeli</a:t>
            </a:r>
            <a:r>
              <a:rPr lang="nl-NL" sz="1800" i="1" dirty="0">
                <a:effectLst/>
                <a:latin typeface="Times"/>
              </a:rPr>
              <a:t> C, Wieler LH, Leuker C</a:t>
            </a:r>
            <a:br>
              <a:rPr lang="nl-NL" sz="1800" i="1" dirty="0">
                <a:effectLst/>
                <a:latin typeface="Times"/>
              </a:rPr>
            </a:br>
            <a:r>
              <a:rPr lang="nl-NL" sz="1800" i="1" dirty="0" err="1">
                <a:effectLst/>
                <a:latin typeface="Times"/>
              </a:rPr>
              <a:t>Establishing</a:t>
            </a:r>
            <a:r>
              <a:rPr lang="nl-NL" sz="1800" i="1" dirty="0">
                <a:effectLst/>
                <a:latin typeface="Times"/>
              </a:rPr>
              <a:t> </a:t>
            </a:r>
            <a:r>
              <a:rPr lang="nl-NL" sz="1800" i="1" dirty="0" err="1">
                <a:effectLst/>
                <a:latin typeface="Times"/>
              </a:rPr>
              <a:t>Infodemic</a:t>
            </a:r>
            <a:r>
              <a:rPr lang="nl-NL" sz="1800" i="1" dirty="0">
                <a:effectLst/>
                <a:latin typeface="Times"/>
              </a:rPr>
              <a:t> Management in Germany: A Framework </a:t>
            </a:r>
            <a:r>
              <a:rPr lang="nl-NL" sz="1800" i="1" dirty="0" err="1">
                <a:effectLst/>
                <a:latin typeface="Times"/>
              </a:rPr>
              <a:t>for</a:t>
            </a:r>
            <a:r>
              <a:rPr lang="nl-NL" sz="1800" i="1" dirty="0">
                <a:effectLst/>
                <a:latin typeface="Times"/>
              </a:rPr>
              <a:t> </a:t>
            </a:r>
            <a:r>
              <a:rPr lang="nl-NL" sz="1800" i="1" dirty="0" err="1">
                <a:effectLst/>
                <a:latin typeface="Times"/>
              </a:rPr>
              <a:t>Social</a:t>
            </a:r>
            <a:r>
              <a:rPr lang="nl-NL" sz="1800" i="1" dirty="0">
                <a:effectLst/>
                <a:latin typeface="Times"/>
              </a:rPr>
              <a:t> </a:t>
            </a:r>
            <a:r>
              <a:rPr lang="nl-NL" sz="1800" i="1" dirty="0" err="1">
                <a:effectLst/>
                <a:latin typeface="Times"/>
              </a:rPr>
              <a:t>Listening</a:t>
            </a:r>
            <a:r>
              <a:rPr lang="nl-NL" sz="1800" i="1" dirty="0">
                <a:effectLst/>
                <a:latin typeface="Times"/>
              </a:rPr>
              <a:t> </a:t>
            </a:r>
            <a:r>
              <a:rPr lang="nl-NL" sz="1800" i="1" dirty="0" err="1">
                <a:effectLst/>
                <a:latin typeface="Times"/>
              </a:rPr>
              <a:t>and</a:t>
            </a:r>
            <a:r>
              <a:rPr lang="nl-NL" sz="1800" i="1" dirty="0">
                <a:effectLst/>
                <a:latin typeface="Times"/>
              </a:rPr>
              <a:t> </a:t>
            </a:r>
            <a:r>
              <a:rPr lang="nl-NL" sz="1800" i="1" dirty="0" err="1">
                <a:effectLst/>
                <a:latin typeface="Times"/>
              </a:rPr>
              <a:t>Integrated</a:t>
            </a:r>
            <a:r>
              <a:rPr lang="nl-NL" sz="1800" i="1" dirty="0">
                <a:effectLst/>
                <a:latin typeface="Times"/>
              </a:rPr>
              <a:t> Analysis </a:t>
            </a:r>
            <a:r>
              <a:rPr lang="nl-NL" sz="1800" i="1" dirty="0" err="1">
                <a:effectLst/>
                <a:latin typeface="Times"/>
              </a:rPr>
              <a:t>to</a:t>
            </a:r>
            <a:r>
              <a:rPr lang="nl-NL" sz="1800" i="1" dirty="0">
                <a:effectLst/>
                <a:latin typeface="Times"/>
              </a:rPr>
              <a:t> Report </a:t>
            </a:r>
            <a:r>
              <a:rPr lang="nl-NL" sz="1800" i="1" dirty="0" err="1">
                <a:effectLst/>
                <a:latin typeface="Times"/>
              </a:rPr>
              <a:t>Infodemic</a:t>
            </a:r>
            <a:r>
              <a:rPr lang="nl-NL" sz="1800" i="1" dirty="0">
                <a:effectLst/>
                <a:latin typeface="Times"/>
              </a:rPr>
              <a:t> </a:t>
            </a:r>
            <a:r>
              <a:rPr lang="nl-NL" sz="1800" i="1" dirty="0" err="1">
                <a:effectLst/>
                <a:latin typeface="Times"/>
              </a:rPr>
              <a:t>Insights</a:t>
            </a:r>
            <a:r>
              <a:rPr lang="nl-NL" sz="1800" i="1" dirty="0">
                <a:effectLst/>
                <a:latin typeface="Times"/>
              </a:rPr>
              <a:t> at </a:t>
            </a:r>
            <a:r>
              <a:rPr lang="nl-NL" sz="1800" i="1" dirty="0" err="1">
                <a:effectLst/>
                <a:latin typeface="Times"/>
              </a:rPr>
              <a:t>the</a:t>
            </a:r>
            <a:r>
              <a:rPr lang="nl-NL" sz="1800" i="1" dirty="0">
                <a:effectLst/>
                <a:latin typeface="Times"/>
              </a:rPr>
              <a:t> National Public Health </a:t>
            </a:r>
            <a:r>
              <a:rPr lang="nl-NL" sz="1800" i="1" dirty="0" err="1">
                <a:effectLst/>
                <a:latin typeface="Times"/>
              </a:rPr>
              <a:t>Institute</a:t>
            </a:r>
            <a:br>
              <a:rPr lang="nl-NL" sz="1800" i="1" dirty="0">
                <a:effectLst/>
                <a:latin typeface="Times"/>
              </a:rPr>
            </a:br>
            <a:r>
              <a:rPr lang="nl-NL" sz="1800" i="1" dirty="0">
                <a:effectLst/>
                <a:latin typeface="Times"/>
              </a:rPr>
              <a:t>JMIR </a:t>
            </a:r>
            <a:r>
              <a:rPr lang="nl-NL" sz="1800" i="1" dirty="0" err="1">
                <a:effectLst/>
                <a:latin typeface="Times"/>
              </a:rPr>
              <a:t>Infodemiology</a:t>
            </a:r>
            <a:r>
              <a:rPr lang="nl-NL" sz="1800" i="1" dirty="0">
                <a:effectLst/>
                <a:latin typeface="Times"/>
              </a:rPr>
              <a:t> 2023;3:e43646</a:t>
            </a:r>
            <a:br>
              <a:rPr lang="nl-NL" sz="1800" i="1" dirty="0">
                <a:effectLst/>
                <a:latin typeface="Times"/>
              </a:rPr>
            </a:br>
            <a:r>
              <a:rPr lang="nl-NL" sz="1800" i="1" dirty="0">
                <a:effectLst/>
                <a:latin typeface="Times"/>
              </a:rPr>
              <a:t>URL: </a:t>
            </a:r>
            <a:r>
              <a:rPr lang="nl-NL" sz="1800" i="1" dirty="0" err="1">
                <a:solidFill>
                  <a:srgbClr val="0000FF"/>
                </a:solidFill>
                <a:effectLst/>
                <a:latin typeface="Times"/>
              </a:rPr>
              <a:t>https</a:t>
            </a:r>
            <a:r>
              <a:rPr lang="nl-NL" sz="1800" i="1" dirty="0">
                <a:solidFill>
                  <a:srgbClr val="0000FF"/>
                </a:solidFill>
                <a:effectLst/>
                <a:latin typeface="Times"/>
              </a:rPr>
              <a:t>://</a:t>
            </a:r>
            <a:r>
              <a:rPr lang="nl-NL" sz="1800" i="1" dirty="0" err="1">
                <a:solidFill>
                  <a:srgbClr val="0000FF"/>
                </a:solidFill>
                <a:effectLst/>
                <a:latin typeface="Times"/>
              </a:rPr>
              <a:t>infodemiology.jmir.org</a:t>
            </a:r>
            <a:r>
              <a:rPr lang="nl-NL" sz="1800" i="1" dirty="0">
                <a:solidFill>
                  <a:srgbClr val="0000FF"/>
                </a:solidFill>
                <a:effectLst/>
                <a:latin typeface="Times"/>
              </a:rPr>
              <a:t>/2023/1/e43646/</a:t>
            </a:r>
            <a:br>
              <a:rPr lang="nl-NL" sz="1800" i="1" dirty="0">
                <a:solidFill>
                  <a:srgbClr val="0000FF"/>
                </a:solidFill>
                <a:effectLst/>
                <a:latin typeface="Times"/>
              </a:rPr>
            </a:br>
            <a:r>
              <a:rPr lang="nl-NL" sz="1800" i="1" dirty="0" err="1">
                <a:effectLst/>
                <a:latin typeface="Times"/>
              </a:rPr>
              <a:t>doi</a:t>
            </a:r>
            <a:r>
              <a:rPr lang="nl-NL" sz="1800" i="1" dirty="0">
                <a:effectLst/>
                <a:latin typeface="Times"/>
              </a:rPr>
              <a:t>: </a:t>
            </a:r>
            <a:r>
              <a:rPr lang="nl-NL" sz="1800" i="1" dirty="0">
                <a:solidFill>
                  <a:srgbClr val="0000FF"/>
                </a:solidFill>
                <a:effectLst/>
                <a:latin typeface="Times"/>
              </a:rPr>
              <a:t>10.2196/43646</a:t>
            </a:r>
            <a:br>
              <a:rPr lang="nl-NL" sz="1800" i="1" dirty="0">
                <a:solidFill>
                  <a:srgbClr val="0000FF"/>
                </a:solidFill>
                <a:effectLst/>
                <a:latin typeface="Times"/>
              </a:rPr>
            </a:br>
            <a:endParaRPr lang="nl-NL" sz="2800" dirty="0"/>
          </a:p>
          <a:p>
            <a:endParaRPr lang="nl-DE" dirty="0"/>
          </a:p>
        </p:txBody>
      </p:sp>
      <p:sp>
        <p:nvSpPr>
          <p:cNvPr id="4" name="Tijdelijke aanduiding voor dianumm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BE7C215-D60F-6846-A217-88F2B3FBB2D3}" type="slidenum">
              <a:rPr lang="nl-DE" smtClean="0"/>
              <a:t>1</a:t>
            </a:fld>
            <a:endParaRPr lang="nl-DE"/>
          </a:p>
        </p:txBody>
      </p:sp>
    </p:spTree>
    <p:extLst>
      <p:ext uri="{BB962C8B-B14F-4D97-AF65-F5344CB8AC3E}">
        <p14:creationId xmlns:p14="http://schemas.microsoft.com/office/powerpoint/2010/main" val="2244338351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jdelijke aanduiding voor dia-afbeelding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Tijdelijke aanduiding voor notiti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nl-NL" sz="1800" b="1" dirty="0" err="1">
                <a:effectLst/>
                <a:latin typeface="Times"/>
              </a:rPr>
              <a:t>Figure</a:t>
            </a:r>
            <a:r>
              <a:rPr lang="nl-NL" sz="1800" b="1" dirty="0">
                <a:effectLst/>
                <a:latin typeface="Times"/>
              </a:rPr>
              <a:t> 1. </a:t>
            </a:r>
            <a:r>
              <a:rPr lang="nl-NL" sz="1800" dirty="0" err="1">
                <a:effectLst/>
                <a:latin typeface="Times"/>
              </a:rPr>
              <a:t>Taxonomy</a:t>
            </a:r>
            <a:r>
              <a:rPr lang="nl-NL" sz="1800" dirty="0">
                <a:effectLst/>
                <a:latin typeface="Times"/>
              </a:rPr>
              <a:t> </a:t>
            </a:r>
            <a:r>
              <a:rPr lang="nl-NL" sz="1800" dirty="0" err="1">
                <a:effectLst/>
                <a:latin typeface="Times"/>
              </a:rPr>
              <a:t>to</a:t>
            </a:r>
            <a:r>
              <a:rPr lang="nl-NL" sz="1800" dirty="0">
                <a:effectLst/>
                <a:latin typeface="Times"/>
              </a:rPr>
              <a:t> </a:t>
            </a:r>
            <a:r>
              <a:rPr lang="nl-NL" sz="1800" dirty="0" err="1">
                <a:effectLst/>
                <a:latin typeface="Times"/>
              </a:rPr>
              <a:t>systematically</a:t>
            </a:r>
            <a:r>
              <a:rPr lang="nl-NL" sz="1800" dirty="0">
                <a:effectLst/>
                <a:latin typeface="Times"/>
              </a:rPr>
              <a:t> monitor </a:t>
            </a:r>
            <a:r>
              <a:rPr lang="nl-NL" sz="1800" dirty="0" err="1">
                <a:effectLst/>
                <a:latin typeface="Times"/>
              </a:rPr>
              <a:t>keywords</a:t>
            </a:r>
            <a:r>
              <a:rPr lang="nl-NL" sz="1800" dirty="0">
                <a:effectLst/>
                <a:latin typeface="Times"/>
              </a:rPr>
              <a:t> in </a:t>
            </a:r>
            <a:r>
              <a:rPr lang="nl-NL" sz="1800" dirty="0" err="1">
                <a:effectLst/>
                <a:latin typeface="Times"/>
              </a:rPr>
              <a:t>conversations</a:t>
            </a:r>
            <a:r>
              <a:rPr lang="nl-NL" sz="1800" dirty="0">
                <a:effectLst/>
                <a:latin typeface="Times"/>
              </a:rPr>
              <a:t> </a:t>
            </a:r>
            <a:r>
              <a:rPr lang="nl-NL" sz="1800" dirty="0" err="1">
                <a:effectLst/>
                <a:latin typeface="Times"/>
              </a:rPr>
              <a:t>related</a:t>
            </a:r>
            <a:r>
              <a:rPr lang="nl-NL" sz="1800" dirty="0">
                <a:effectLst/>
                <a:latin typeface="Times"/>
              </a:rPr>
              <a:t> </a:t>
            </a:r>
            <a:r>
              <a:rPr lang="nl-NL" sz="1800" dirty="0" err="1">
                <a:effectLst/>
                <a:latin typeface="Times"/>
              </a:rPr>
              <a:t>to</a:t>
            </a:r>
            <a:r>
              <a:rPr lang="nl-NL" sz="1800" dirty="0">
                <a:effectLst/>
                <a:latin typeface="Times"/>
              </a:rPr>
              <a:t> public health issue X </a:t>
            </a:r>
            <a:r>
              <a:rPr lang="nl-NL" sz="1800" dirty="0" err="1">
                <a:effectLst/>
                <a:latin typeface="Times"/>
              </a:rPr>
              <a:t>within</a:t>
            </a:r>
            <a:r>
              <a:rPr lang="nl-NL" sz="1800" dirty="0">
                <a:effectLst/>
                <a:latin typeface="Times"/>
              </a:rPr>
              <a:t> </a:t>
            </a:r>
            <a:r>
              <a:rPr lang="nl-NL" sz="1800" dirty="0" err="1">
                <a:effectLst/>
                <a:latin typeface="Times"/>
              </a:rPr>
              <a:t>thematic</a:t>
            </a:r>
            <a:r>
              <a:rPr lang="nl-NL" sz="1800" dirty="0">
                <a:effectLst/>
                <a:latin typeface="Times"/>
              </a:rPr>
              <a:t> </a:t>
            </a:r>
            <a:r>
              <a:rPr lang="nl-NL" sz="1800" dirty="0" err="1">
                <a:effectLst/>
                <a:latin typeface="Times"/>
              </a:rPr>
              <a:t>categories</a:t>
            </a:r>
            <a:r>
              <a:rPr lang="nl-NL" sz="1800" dirty="0">
                <a:effectLst/>
                <a:latin typeface="Times"/>
              </a:rPr>
              <a:t> relevant </a:t>
            </a:r>
            <a:r>
              <a:rPr lang="nl-NL" sz="1800" dirty="0" err="1">
                <a:effectLst/>
                <a:latin typeface="Times"/>
              </a:rPr>
              <a:t>to</a:t>
            </a:r>
            <a:r>
              <a:rPr lang="nl-NL" sz="1800" dirty="0">
                <a:effectLst/>
                <a:latin typeface="Times"/>
              </a:rPr>
              <a:t> public health response. </a:t>
            </a:r>
            <a:endParaRPr lang="nl-NL" sz="2800" dirty="0"/>
          </a:p>
        </p:txBody>
      </p:sp>
      <p:sp>
        <p:nvSpPr>
          <p:cNvPr id="4" name="Tijdelijke aanduiding voor dianumm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BE7C215-D60F-6846-A217-88F2B3FBB2D3}" type="slidenum">
              <a:rPr lang="nl-DE" smtClean="0"/>
              <a:t>2</a:t>
            </a:fld>
            <a:endParaRPr lang="nl-DE"/>
          </a:p>
        </p:txBody>
      </p:sp>
    </p:spTree>
    <p:extLst>
      <p:ext uri="{BB962C8B-B14F-4D97-AF65-F5344CB8AC3E}">
        <p14:creationId xmlns:p14="http://schemas.microsoft.com/office/powerpoint/2010/main" val="925015774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jdelijke aanduiding voor dia-afbeelding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Tijdelijke aanduiding voor notiti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nl-NL" sz="1800" b="1" dirty="0" err="1">
                <a:effectLst/>
                <a:latin typeface="Times"/>
              </a:rPr>
              <a:t>Figure</a:t>
            </a:r>
            <a:r>
              <a:rPr lang="nl-NL" sz="1800" b="1" dirty="0">
                <a:effectLst/>
                <a:latin typeface="Times"/>
              </a:rPr>
              <a:t> 3. </a:t>
            </a:r>
            <a:r>
              <a:rPr lang="nl-NL" sz="1800" dirty="0">
                <a:effectLst/>
                <a:latin typeface="Times"/>
              </a:rPr>
              <a:t>Risk matrix </a:t>
            </a:r>
            <a:r>
              <a:rPr lang="nl-NL" sz="1800" dirty="0" err="1">
                <a:effectLst/>
                <a:latin typeface="Times"/>
              </a:rPr>
              <a:t>and</a:t>
            </a:r>
            <a:r>
              <a:rPr lang="nl-NL" sz="1800" dirty="0">
                <a:effectLst/>
                <a:latin typeface="Times"/>
              </a:rPr>
              <a:t> </a:t>
            </a:r>
            <a:r>
              <a:rPr lang="nl-NL" sz="1800" dirty="0" err="1">
                <a:effectLst/>
                <a:latin typeface="Times"/>
              </a:rPr>
              <a:t>scalar</a:t>
            </a:r>
            <a:r>
              <a:rPr lang="nl-NL" sz="1800" dirty="0">
                <a:effectLst/>
                <a:latin typeface="Times"/>
              </a:rPr>
              <a:t> </a:t>
            </a:r>
            <a:r>
              <a:rPr lang="nl-NL" sz="1800" dirty="0" err="1">
                <a:effectLst/>
                <a:latin typeface="Times"/>
              </a:rPr>
              <a:t>judgments</a:t>
            </a:r>
            <a:r>
              <a:rPr lang="nl-NL" sz="1800" dirty="0">
                <a:effectLst/>
                <a:latin typeface="Times"/>
              </a:rPr>
              <a:t>, </a:t>
            </a:r>
            <a:r>
              <a:rPr lang="nl-NL" sz="1800" dirty="0" err="1">
                <a:effectLst/>
                <a:latin typeface="Times"/>
              </a:rPr>
              <a:t>adapted</a:t>
            </a:r>
            <a:r>
              <a:rPr lang="nl-NL" sz="1800" dirty="0">
                <a:effectLst/>
                <a:latin typeface="Times"/>
              </a:rPr>
              <a:t> </a:t>
            </a:r>
            <a:r>
              <a:rPr lang="nl-NL" sz="1800" dirty="0" err="1">
                <a:effectLst/>
                <a:latin typeface="Times"/>
              </a:rPr>
              <a:t>from</a:t>
            </a:r>
            <a:r>
              <a:rPr lang="nl-NL" sz="1800" dirty="0">
                <a:effectLst/>
                <a:latin typeface="Times"/>
              </a:rPr>
              <a:t> </a:t>
            </a:r>
            <a:r>
              <a:rPr lang="nl-NL" sz="1800" dirty="0" err="1">
                <a:effectLst/>
                <a:latin typeface="Times"/>
              </a:rPr>
              <a:t>the</a:t>
            </a:r>
            <a:r>
              <a:rPr lang="nl-NL" sz="1800" dirty="0">
                <a:effectLst/>
                <a:latin typeface="Times"/>
              </a:rPr>
              <a:t> US Centers </a:t>
            </a:r>
            <a:r>
              <a:rPr lang="nl-NL" sz="1800" dirty="0" err="1">
                <a:effectLst/>
                <a:latin typeface="Times"/>
              </a:rPr>
              <a:t>for</a:t>
            </a:r>
            <a:r>
              <a:rPr lang="nl-NL" sz="1800" dirty="0">
                <a:effectLst/>
                <a:latin typeface="Times"/>
              </a:rPr>
              <a:t> </a:t>
            </a:r>
            <a:r>
              <a:rPr lang="nl-NL" sz="1800" dirty="0" err="1">
                <a:effectLst/>
                <a:latin typeface="Times"/>
              </a:rPr>
              <a:t>Disease</a:t>
            </a:r>
            <a:r>
              <a:rPr lang="nl-NL" sz="1800" dirty="0">
                <a:effectLst/>
                <a:latin typeface="Times"/>
              </a:rPr>
              <a:t> Control </a:t>
            </a:r>
            <a:r>
              <a:rPr lang="nl-NL" sz="1800" dirty="0" err="1">
                <a:effectLst/>
                <a:latin typeface="Times"/>
              </a:rPr>
              <a:t>and</a:t>
            </a:r>
            <a:r>
              <a:rPr lang="nl-NL" sz="1800" dirty="0">
                <a:effectLst/>
                <a:latin typeface="Times"/>
              </a:rPr>
              <a:t> Prevention Vaccine </a:t>
            </a:r>
            <a:r>
              <a:rPr lang="nl-NL" sz="1800" dirty="0" err="1">
                <a:effectLst/>
                <a:latin typeface="Times"/>
              </a:rPr>
              <a:t>Confidence</a:t>
            </a:r>
            <a:r>
              <a:rPr lang="nl-NL" sz="1800" dirty="0">
                <a:effectLst/>
                <a:latin typeface="Times"/>
              </a:rPr>
              <a:t> Report </a:t>
            </a:r>
            <a:r>
              <a:rPr lang="nl-NL" sz="1800" dirty="0" err="1">
                <a:effectLst/>
                <a:latin typeface="Times"/>
              </a:rPr>
              <a:t>methodology</a:t>
            </a:r>
            <a:r>
              <a:rPr lang="nl-NL" sz="1800" dirty="0">
                <a:effectLst/>
                <a:latin typeface="Times"/>
              </a:rPr>
              <a:t> [</a:t>
            </a:r>
            <a:r>
              <a:rPr lang="nl-NL" sz="1800" dirty="0">
                <a:solidFill>
                  <a:srgbClr val="0000FF"/>
                </a:solidFill>
                <a:effectLst/>
                <a:latin typeface="Times"/>
              </a:rPr>
              <a:t>27</a:t>
            </a:r>
            <a:r>
              <a:rPr lang="nl-NL" sz="1800" dirty="0">
                <a:effectLst/>
                <a:latin typeface="Times"/>
              </a:rPr>
              <a:t>,</a:t>
            </a:r>
            <a:r>
              <a:rPr lang="nl-NL" sz="1800" dirty="0">
                <a:solidFill>
                  <a:srgbClr val="0000FF"/>
                </a:solidFill>
                <a:effectLst/>
                <a:latin typeface="Times"/>
              </a:rPr>
              <a:t>28</a:t>
            </a:r>
            <a:r>
              <a:rPr lang="nl-NL" sz="1800" dirty="0">
                <a:effectLst/>
                <a:latin typeface="Times"/>
              </a:rPr>
              <a:t>]. </a:t>
            </a:r>
            <a:endParaRPr lang="nl-NL" sz="2800" dirty="0"/>
          </a:p>
        </p:txBody>
      </p:sp>
      <p:sp>
        <p:nvSpPr>
          <p:cNvPr id="4" name="Tijdelijke aanduiding voor dianumm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BE7C215-D60F-6846-A217-88F2B3FBB2D3}" type="slidenum">
              <a:rPr lang="nl-DE" smtClean="0"/>
              <a:t>3</a:t>
            </a:fld>
            <a:endParaRPr lang="nl-DE"/>
          </a:p>
        </p:txBody>
      </p:sp>
    </p:spTree>
    <p:extLst>
      <p:ext uri="{BB962C8B-B14F-4D97-AF65-F5344CB8AC3E}">
        <p14:creationId xmlns:p14="http://schemas.microsoft.com/office/powerpoint/2010/main" val="1617539726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jdelijke aanduiding voor dia-afbeelding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Tijdelijke aanduiding voor notiti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Figure 3. </a:t>
            </a:r>
            <a:r>
              <a:rPr lang="en-US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Risk matrix and scalar judgments, adapted from the United States Centers for Disease Control and Prevention Vaccine Confidence Report methodology </a:t>
            </a:r>
            <a:r>
              <a:rPr lang="en-US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[27,28]</a:t>
            </a:r>
            <a:r>
              <a:rPr lang="en-US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.</a:t>
            </a:r>
            <a:endParaRPr lang="nl-DE" sz="1200" dirty="0">
              <a:effectLst/>
              <a:latin typeface="Calibri" panose="020F0502020204030204" pitchFamily="34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nl-DE" dirty="0"/>
          </a:p>
          <a:p>
            <a:endParaRPr lang="nl-DE" dirty="0"/>
          </a:p>
        </p:txBody>
      </p:sp>
      <p:sp>
        <p:nvSpPr>
          <p:cNvPr id="4" name="Tijdelijke aanduiding voor dianumm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BE7C215-D60F-6846-A217-88F2B3FBB2D3}" type="slidenum">
              <a:rPr lang="nl-DE" smtClean="0"/>
              <a:t>4</a:t>
            </a:fld>
            <a:endParaRPr lang="nl-DE"/>
          </a:p>
        </p:txBody>
      </p:sp>
    </p:spTree>
    <p:extLst>
      <p:ext uri="{BB962C8B-B14F-4D97-AF65-F5344CB8AC3E}">
        <p14:creationId xmlns:p14="http://schemas.microsoft.com/office/powerpoint/2010/main" val="3046126659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jdelijke aanduiding voor dia-afbeelding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Tijdelijke aanduiding voor notiti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nl-NL" sz="1800" b="1" dirty="0" err="1">
                <a:effectLst/>
                <a:latin typeface="Times"/>
              </a:rPr>
              <a:t>Figure</a:t>
            </a:r>
            <a:r>
              <a:rPr lang="nl-NL" sz="1800" b="1" dirty="0">
                <a:effectLst/>
                <a:latin typeface="Times"/>
              </a:rPr>
              <a:t> 3. </a:t>
            </a:r>
            <a:r>
              <a:rPr lang="nl-NL" sz="1800" dirty="0">
                <a:effectLst/>
                <a:latin typeface="Times"/>
              </a:rPr>
              <a:t>Risk matrix </a:t>
            </a:r>
            <a:r>
              <a:rPr lang="nl-NL" sz="1800" dirty="0" err="1">
                <a:effectLst/>
                <a:latin typeface="Times"/>
              </a:rPr>
              <a:t>and</a:t>
            </a:r>
            <a:r>
              <a:rPr lang="nl-NL" sz="1800" dirty="0">
                <a:effectLst/>
                <a:latin typeface="Times"/>
              </a:rPr>
              <a:t> </a:t>
            </a:r>
            <a:r>
              <a:rPr lang="nl-NL" sz="1800" dirty="0" err="1">
                <a:effectLst/>
                <a:latin typeface="Times"/>
              </a:rPr>
              <a:t>scalar</a:t>
            </a:r>
            <a:r>
              <a:rPr lang="nl-NL" sz="1800" dirty="0">
                <a:effectLst/>
                <a:latin typeface="Times"/>
              </a:rPr>
              <a:t> </a:t>
            </a:r>
            <a:r>
              <a:rPr lang="nl-NL" sz="1800" dirty="0" err="1">
                <a:effectLst/>
                <a:latin typeface="Times"/>
              </a:rPr>
              <a:t>judgments</a:t>
            </a:r>
            <a:r>
              <a:rPr lang="nl-NL" sz="1800" dirty="0">
                <a:effectLst/>
                <a:latin typeface="Times"/>
              </a:rPr>
              <a:t>, </a:t>
            </a:r>
            <a:r>
              <a:rPr lang="nl-NL" sz="1800" dirty="0" err="1">
                <a:effectLst/>
                <a:latin typeface="Times"/>
              </a:rPr>
              <a:t>adapted</a:t>
            </a:r>
            <a:r>
              <a:rPr lang="nl-NL" sz="1800" dirty="0">
                <a:effectLst/>
                <a:latin typeface="Times"/>
              </a:rPr>
              <a:t> </a:t>
            </a:r>
            <a:r>
              <a:rPr lang="nl-NL" sz="1800" dirty="0" err="1">
                <a:effectLst/>
                <a:latin typeface="Times"/>
              </a:rPr>
              <a:t>from</a:t>
            </a:r>
            <a:r>
              <a:rPr lang="nl-NL" sz="1800" dirty="0">
                <a:effectLst/>
                <a:latin typeface="Times"/>
              </a:rPr>
              <a:t> </a:t>
            </a:r>
            <a:r>
              <a:rPr lang="nl-NL" sz="1800" dirty="0" err="1">
                <a:effectLst/>
                <a:latin typeface="Times"/>
              </a:rPr>
              <a:t>the</a:t>
            </a:r>
            <a:r>
              <a:rPr lang="nl-NL" sz="1800" dirty="0">
                <a:effectLst/>
                <a:latin typeface="Times"/>
              </a:rPr>
              <a:t> US Centers </a:t>
            </a:r>
            <a:r>
              <a:rPr lang="nl-NL" sz="1800" dirty="0" err="1">
                <a:effectLst/>
                <a:latin typeface="Times"/>
              </a:rPr>
              <a:t>for</a:t>
            </a:r>
            <a:r>
              <a:rPr lang="nl-NL" sz="1800" dirty="0">
                <a:effectLst/>
                <a:latin typeface="Times"/>
              </a:rPr>
              <a:t> </a:t>
            </a:r>
            <a:r>
              <a:rPr lang="nl-NL" sz="1800" dirty="0" err="1">
                <a:effectLst/>
                <a:latin typeface="Times"/>
              </a:rPr>
              <a:t>Disease</a:t>
            </a:r>
            <a:r>
              <a:rPr lang="nl-NL" sz="1800" dirty="0">
                <a:effectLst/>
                <a:latin typeface="Times"/>
              </a:rPr>
              <a:t> Control </a:t>
            </a:r>
            <a:r>
              <a:rPr lang="nl-NL" sz="1800" dirty="0" err="1">
                <a:effectLst/>
                <a:latin typeface="Times"/>
              </a:rPr>
              <a:t>and</a:t>
            </a:r>
            <a:r>
              <a:rPr lang="nl-NL" sz="1800" dirty="0">
                <a:effectLst/>
                <a:latin typeface="Times"/>
              </a:rPr>
              <a:t> Prevention Vaccine </a:t>
            </a:r>
            <a:r>
              <a:rPr lang="nl-NL" sz="1800" dirty="0" err="1">
                <a:effectLst/>
                <a:latin typeface="Times"/>
              </a:rPr>
              <a:t>Confidence</a:t>
            </a:r>
            <a:r>
              <a:rPr lang="nl-NL" sz="1800" dirty="0">
                <a:effectLst/>
                <a:latin typeface="Times"/>
              </a:rPr>
              <a:t> Report </a:t>
            </a:r>
            <a:r>
              <a:rPr lang="nl-NL" sz="1800" dirty="0" err="1">
                <a:effectLst/>
                <a:latin typeface="Times"/>
              </a:rPr>
              <a:t>methodology</a:t>
            </a:r>
            <a:r>
              <a:rPr lang="nl-NL" sz="1800" dirty="0">
                <a:effectLst/>
                <a:latin typeface="Times"/>
              </a:rPr>
              <a:t> [</a:t>
            </a:r>
            <a:r>
              <a:rPr lang="nl-NL" sz="1800" dirty="0">
                <a:solidFill>
                  <a:srgbClr val="0000FF"/>
                </a:solidFill>
                <a:effectLst/>
                <a:latin typeface="Times"/>
              </a:rPr>
              <a:t>27</a:t>
            </a:r>
            <a:r>
              <a:rPr lang="nl-NL" sz="1800" dirty="0">
                <a:effectLst/>
                <a:latin typeface="Times"/>
              </a:rPr>
              <a:t>,</a:t>
            </a:r>
            <a:r>
              <a:rPr lang="nl-NL" sz="1800" dirty="0">
                <a:solidFill>
                  <a:srgbClr val="0000FF"/>
                </a:solidFill>
                <a:effectLst/>
                <a:latin typeface="Times"/>
              </a:rPr>
              <a:t>28</a:t>
            </a:r>
            <a:r>
              <a:rPr lang="nl-NL" sz="1800" dirty="0">
                <a:effectLst/>
                <a:latin typeface="Times"/>
              </a:rPr>
              <a:t>]. </a:t>
            </a:r>
            <a:endParaRPr lang="nl-NL" sz="2800" dirty="0"/>
          </a:p>
        </p:txBody>
      </p:sp>
      <p:sp>
        <p:nvSpPr>
          <p:cNvPr id="4" name="Tijdelijke aanduiding voor dianumm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BE7C215-D60F-6846-A217-88F2B3FBB2D3}" type="slidenum">
              <a:rPr lang="nl-DE" smtClean="0"/>
              <a:t>5</a:t>
            </a:fld>
            <a:endParaRPr lang="nl-DE"/>
          </a:p>
        </p:txBody>
      </p:sp>
    </p:spTree>
    <p:extLst>
      <p:ext uri="{BB962C8B-B14F-4D97-AF65-F5344CB8AC3E}">
        <p14:creationId xmlns:p14="http://schemas.microsoft.com/office/powerpoint/2010/main" val="4033929236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jdelijke aanduiding voor dia-afbeelding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Tijdelijke aanduiding voor notiti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nl-NL" sz="1800" b="1" dirty="0">
                <a:effectLst/>
                <a:latin typeface="Times"/>
              </a:rPr>
              <a:t>Multimedia Appendix 2 </a:t>
            </a:r>
            <a:endParaRPr lang="nl-NL" dirty="0"/>
          </a:p>
          <a:p>
            <a:r>
              <a:rPr lang="nl-NL" sz="1800" dirty="0" err="1">
                <a:effectLst/>
                <a:latin typeface="Times"/>
              </a:rPr>
              <a:t>Taxonomy</a:t>
            </a:r>
            <a:r>
              <a:rPr lang="nl-NL" sz="1800" dirty="0">
                <a:effectLst/>
                <a:latin typeface="Times"/>
              </a:rPr>
              <a:t> </a:t>
            </a:r>
            <a:r>
              <a:rPr lang="nl-NL" sz="1800" dirty="0" err="1">
                <a:effectLst/>
                <a:latin typeface="Times"/>
              </a:rPr>
              <a:t>to</a:t>
            </a:r>
            <a:r>
              <a:rPr lang="nl-NL" sz="1800" dirty="0">
                <a:effectLst/>
                <a:latin typeface="Times"/>
              </a:rPr>
              <a:t> </a:t>
            </a:r>
            <a:r>
              <a:rPr lang="nl-NL" sz="1800" dirty="0" err="1">
                <a:effectLst/>
                <a:latin typeface="Times"/>
              </a:rPr>
              <a:t>systematically</a:t>
            </a:r>
            <a:r>
              <a:rPr lang="nl-NL" sz="1800" dirty="0">
                <a:effectLst/>
                <a:latin typeface="Times"/>
              </a:rPr>
              <a:t> monitor </a:t>
            </a:r>
            <a:r>
              <a:rPr lang="nl-NL" sz="1800" dirty="0" err="1">
                <a:effectLst/>
                <a:latin typeface="Times"/>
              </a:rPr>
              <a:t>keywords</a:t>
            </a:r>
            <a:r>
              <a:rPr lang="nl-NL" sz="1800" dirty="0">
                <a:effectLst/>
                <a:latin typeface="Times"/>
              </a:rPr>
              <a:t> in </a:t>
            </a:r>
            <a:r>
              <a:rPr lang="nl-NL" sz="1800" dirty="0" err="1">
                <a:effectLst/>
                <a:latin typeface="Times"/>
              </a:rPr>
              <a:t>conversations</a:t>
            </a:r>
            <a:r>
              <a:rPr lang="nl-NL" sz="1800" dirty="0">
                <a:effectLst/>
                <a:latin typeface="Times"/>
              </a:rPr>
              <a:t> </a:t>
            </a:r>
            <a:r>
              <a:rPr lang="nl-NL" sz="1800" dirty="0" err="1">
                <a:effectLst/>
                <a:latin typeface="Times"/>
              </a:rPr>
              <a:t>related</a:t>
            </a:r>
            <a:r>
              <a:rPr lang="nl-NL" sz="1800" dirty="0">
                <a:effectLst/>
                <a:latin typeface="Times"/>
              </a:rPr>
              <a:t> </a:t>
            </a:r>
            <a:r>
              <a:rPr lang="nl-NL" sz="1800" dirty="0" err="1">
                <a:effectLst/>
                <a:latin typeface="Times"/>
              </a:rPr>
              <a:t>to</a:t>
            </a:r>
            <a:r>
              <a:rPr lang="nl-NL" sz="1800" dirty="0">
                <a:effectLst/>
                <a:latin typeface="Times"/>
              </a:rPr>
              <a:t> public health issue X </a:t>
            </a:r>
            <a:r>
              <a:rPr lang="nl-NL" sz="1800" dirty="0" err="1">
                <a:effectLst/>
                <a:latin typeface="Times"/>
              </a:rPr>
              <a:t>within</a:t>
            </a:r>
            <a:r>
              <a:rPr lang="nl-NL" sz="1800" dirty="0">
                <a:effectLst/>
                <a:latin typeface="Times"/>
              </a:rPr>
              <a:t> </a:t>
            </a:r>
            <a:r>
              <a:rPr lang="nl-NL" sz="1800" dirty="0" err="1">
                <a:effectLst/>
                <a:latin typeface="Times"/>
              </a:rPr>
              <a:t>thematic</a:t>
            </a:r>
            <a:r>
              <a:rPr lang="nl-NL" sz="1800" dirty="0">
                <a:effectLst/>
                <a:latin typeface="Times"/>
              </a:rPr>
              <a:t> </a:t>
            </a:r>
            <a:r>
              <a:rPr lang="nl-NL" sz="1800" dirty="0" err="1">
                <a:effectLst/>
                <a:latin typeface="Times"/>
              </a:rPr>
              <a:t>categories</a:t>
            </a:r>
            <a:r>
              <a:rPr lang="nl-NL" sz="1800" dirty="0">
                <a:effectLst/>
                <a:latin typeface="Times"/>
              </a:rPr>
              <a:t> relevant </a:t>
            </a:r>
            <a:r>
              <a:rPr lang="nl-NL" sz="1800" dirty="0" err="1">
                <a:effectLst/>
                <a:latin typeface="Times"/>
              </a:rPr>
              <a:t>to</a:t>
            </a:r>
            <a:r>
              <a:rPr lang="nl-NL" sz="1800" dirty="0">
                <a:effectLst/>
                <a:latin typeface="Times"/>
              </a:rPr>
              <a:t> public health responses.</a:t>
            </a:r>
            <a:br>
              <a:rPr lang="nl-NL" sz="1800" dirty="0">
                <a:effectLst/>
                <a:latin typeface="Times"/>
              </a:rPr>
            </a:br>
            <a:endParaRPr lang="nl-NL" dirty="0"/>
          </a:p>
          <a:p>
            <a:endParaRPr lang="nl-DE" dirty="0"/>
          </a:p>
        </p:txBody>
      </p:sp>
      <p:sp>
        <p:nvSpPr>
          <p:cNvPr id="4" name="Tijdelijke aanduiding voor dianumm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BE7C215-D60F-6846-A217-88F2B3FBB2D3}" type="slidenum">
              <a:rPr lang="nl-DE" smtClean="0"/>
              <a:t>6</a:t>
            </a:fld>
            <a:endParaRPr lang="nl-DE"/>
          </a:p>
        </p:txBody>
      </p:sp>
    </p:spTree>
    <p:extLst>
      <p:ext uri="{BB962C8B-B14F-4D97-AF65-F5344CB8AC3E}">
        <p14:creationId xmlns:p14="http://schemas.microsoft.com/office/powerpoint/2010/main" val="368697361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98858D9D-A9B1-4936-9A14-65E882D4E00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Untertitel 2">
            <a:extLst>
              <a:ext uri="{FF2B5EF4-FFF2-40B4-BE49-F238E27FC236}">
                <a16:creationId xmlns:a16="http://schemas.microsoft.com/office/drawing/2014/main" id="{FACA484B-C848-4B7F-9783-31547E122B4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/>
              <a:t>Master-Untertitel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1AA29897-FAE3-490D-BB9F-AF0365BFCFD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6C6234-04C6-4327-BEF4-5CA5D3C25248}" type="datetimeFigureOut">
              <a:rPr lang="de-DE" smtClean="0"/>
              <a:t>27.05.23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27991F4D-37BA-460D-91EB-84BDFF75F85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2D72714A-1FFF-491A-8F6D-A03B1C5C67D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11C98C-81B8-4000-A1CC-5CBED1F63FE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11269310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469EFFFE-D43D-455C-9BA9-309AD786D5B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8D4D6FE8-6FEE-4214-BBCC-95E66D420AC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5D64F8A0-6C31-4E1C-814A-5F13A7A87FA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6C6234-04C6-4327-BEF4-5CA5D3C25248}" type="datetimeFigureOut">
              <a:rPr lang="de-DE" smtClean="0"/>
              <a:t>27.05.23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C125D9D9-FEE1-4CD3-8AE0-765515380DB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BDC32A94-9B3D-4237-857C-A76C1D07DF5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11C98C-81B8-4000-A1CC-5CBED1F63FE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13178324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>
            <a:extLst>
              <a:ext uri="{FF2B5EF4-FFF2-40B4-BE49-F238E27FC236}">
                <a16:creationId xmlns:a16="http://schemas.microsoft.com/office/drawing/2014/main" id="{86A0C081-126A-43E8-871D-23BE03B8FFE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AA5E00AD-A71E-46CC-929E-50EFAB12C8B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7336C09E-2088-4ECF-933F-43B0A425021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6C6234-04C6-4327-BEF4-5CA5D3C25248}" type="datetimeFigureOut">
              <a:rPr lang="de-DE" smtClean="0"/>
              <a:t>27.05.23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99572C4A-15A6-40F5-B764-5E03F784D02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F1002C90-B9BA-412A-A978-4AE15B55FF6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11C98C-81B8-4000-A1CC-5CBED1F63FE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49444735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4EC2CBB8-DC3B-4579-A3F5-53246069726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B5AF40E0-F388-4DE1-B9C2-E3A0EE4FE81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3243CFA4-9B5C-44BA-94F7-CAE141BFE71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6C6234-04C6-4327-BEF4-5CA5D3C25248}" type="datetimeFigureOut">
              <a:rPr lang="de-DE" smtClean="0"/>
              <a:t>27.05.23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89971BB4-AC0A-4E62-803D-DCE9BDB1CEE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D648D4AF-A03B-4CF3-A21C-707645F8ABA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11C98C-81B8-4000-A1CC-5CBED1F63FE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7937523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8B29F2DB-B35B-452B-8CAA-024B98DF39B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785D8AC2-C79A-4BA6-8809-6D70250FE1E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71E9319D-2285-4D46-963B-2B75905C4F0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6C6234-04C6-4327-BEF4-5CA5D3C25248}" type="datetimeFigureOut">
              <a:rPr lang="de-DE" smtClean="0"/>
              <a:t>27.05.23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77D20E9C-6D01-4735-ACBE-7DF3DC4796D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27B25134-465A-4379-82DB-A6BF2F715F8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11C98C-81B8-4000-A1CC-5CBED1F63FE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733291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5BA97486-DC51-4FD4-BF1C-17A20C1F030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29E699BA-6095-4364-B241-6F12F7DA740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B89E94F3-36BF-476E-BEF5-64162670F23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1F483590-0D72-435A-8000-32F53A2534B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6C6234-04C6-4327-BEF4-5CA5D3C25248}" type="datetimeFigureOut">
              <a:rPr lang="de-DE" smtClean="0"/>
              <a:t>27.05.23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F905CCE9-BA52-4397-81B3-ABF71181FBD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EDD05905-2784-49FE-A0DD-4F272C29366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11C98C-81B8-4000-A1CC-5CBED1F63FE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55366133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4ADDE4AD-03B1-42C6-AE28-EDE1E295EE3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9322210C-135D-43ED-AF6F-3D1C01235A8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FBA2F020-F8DE-465A-AE47-2B5863CCD10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>
            <a:extLst>
              <a:ext uri="{FF2B5EF4-FFF2-40B4-BE49-F238E27FC236}">
                <a16:creationId xmlns:a16="http://schemas.microsoft.com/office/drawing/2014/main" id="{B2695959-378C-4DEE-B438-624F71E6AE8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Inhaltsplatzhalter 5">
            <a:extLst>
              <a:ext uri="{FF2B5EF4-FFF2-40B4-BE49-F238E27FC236}">
                <a16:creationId xmlns:a16="http://schemas.microsoft.com/office/drawing/2014/main" id="{2C2CDD63-F51E-41E1-ACD9-33C6CC59CDA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>
            <a:extLst>
              <a:ext uri="{FF2B5EF4-FFF2-40B4-BE49-F238E27FC236}">
                <a16:creationId xmlns:a16="http://schemas.microsoft.com/office/drawing/2014/main" id="{10257B66-E4DD-4427-8C56-AB130DDFA8A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6C6234-04C6-4327-BEF4-5CA5D3C25248}" type="datetimeFigureOut">
              <a:rPr lang="de-DE" smtClean="0"/>
              <a:t>27.05.23</a:t>
            </a:fld>
            <a:endParaRPr lang="de-DE"/>
          </a:p>
        </p:txBody>
      </p:sp>
      <p:sp>
        <p:nvSpPr>
          <p:cNvPr id="8" name="Fußzeilenplatzhalter 7">
            <a:extLst>
              <a:ext uri="{FF2B5EF4-FFF2-40B4-BE49-F238E27FC236}">
                <a16:creationId xmlns:a16="http://schemas.microsoft.com/office/drawing/2014/main" id="{A415283E-0C73-432B-AEC0-F5A3852AC7F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>
            <a:extLst>
              <a:ext uri="{FF2B5EF4-FFF2-40B4-BE49-F238E27FC236}">
                <a16:creationId xmlns:a16="http://schemas.microsoft.com/office/drawing/2014/main" id="{DB02182D-CD1C-4720-9D31-FC690FFBEA9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11C98C-81B8-4000-A1CC-5CBED1F63FE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29196102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E95AAA29-4C11-4EFA-B9A5-4A7CBF135CF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Datumsplatzhalter 2">
            <a:extLst>
              <a:ext uri="{FF2B5EF4-FFF2-40B4-BE49-F238E27FC236}">
                <a16:creationId xmlns:a16="http://schemas.microsoft.com/office/drawing/2014/main" id="{73479406-59E4-4E9C-98DC-523AA7CEA11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6C6234-04C6-4327-BEF4-5CA5D3C25248}" type="datetimeFigureOut">
              <a:rPr lang="de-DE" smtClean="0"/>
              <a:t>27.05.23</a:t>
            </a:fld>
            <a:endParaRPr lang="de-DE"/>
          </a:p>
        </p:txBody>
      </p:sp>
      <p:sp>
        <p:nvSpPr>
          <p:cNvPr id="4" name="Fußzeilenplatzhalter 3">
            <a:extLst>
              <a:ext uri="{FF2B5EF4-FFF2-40B4-BE49-F238E27FC236}">
                <a16:creationId xmlns:a16="http://schemas.microsoft.com/office/drawing/2014/main" id="{6F520DE5-B6A4-4DFA-93AF-290D43D716B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>
            <a:extLst>
              <a:ext uri="{FF2B5EF4-FFF2-40B4-BE49-F238E27FC236}">
                <a16:creationId xmlns:a16="http://schemas.microsoft.com/office/drawing/2014/main" id="{B35FC5D5-298B-4480-B605-2550D339915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11C98C-81B8-4000-A1CC-5CBED1F63FE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41000772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>
            <a:extLst>
              <a:ext uri="{FF2B5EF4-FFF2-40B4-BE49-F238E27FC236}">
                <a16:creationId xmlns:a16="http://schemas.microsoft.com/office/drawing/2014/main" id="{04BF36C8-3B67-48BC-AD81-100F54DBAE3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6C6234-04C6-4327-BEF4-5CA5D3C25248}" type="datetimeFigureOut">
              <a:rPr lang="de-DE" smtClean="0"/>
              <a:t>27.05.23</a:t>
            </a:fld>
            <a:endParaRPr lang="de-DE"/>
          </a:p>
        </p:txBody>
      </p:sp>
      <p:sp>
        <p:nvSpPr>
          <p:cNvPr id="3" name="Fußzeilenplatzhalter 2">
            <a:extLst>
              <a:ext uri="{FF2B5EF4-FFF2-40B4-BE49-F238E27FC236}">
                <a16:creationId xmlns:a16="http://schemas.microsoft.com/office/drawing/2014/main" id="{58C94EC6-0909-4C08-BE3E-84E7F8E1770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>
            <a:extLst>
              <a:ext uri="{FF2B5EF4-FFF2-40B4-BE49-F238E27FC236}">
                <a16:creationId xmlns:a16="http://schemas.microsoft.com/office/drawing/2014/main" id="{C4673957-73A8-4FF5-B5EC-00974E5E2BF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11C98C-81B8-4000-A1CC-5CBED1F63FE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44114399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CC86AE7D-15F5-400A-97BE-B8C3AAA4095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E3C32032-7EEE-4A5A-B685-9C7FF0906E3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B15F3AF2-B491-43BD-B184-241EFDEAACE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8573DA20-1C97-4FBD-ADFC-8633BD4243A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6C6234-04C6-4327-BEF4-5CA5D3C25248}" type="datetimeFigureOut">
              <a:rPr lang="de-DE" smtClean="0"/>
              <a:t>27.05.23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E4914AA8-4961-4217-B37C-27E47EB8FFE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AB1C01C6-30DC-46B9-BBEC-49E6AD77ED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11C98C-81B8-4000-A1CC-5CBED1F63FE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20637708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120D1BDB-FFFB-46E4-BD2C-E3C32EBB024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Bildplatzhalter 2">
            <a:extLst>
              <a:ext uri="{FF2B5EF4-FFF2-40B4-BE49-F238E27FC236}">
                <a16:creationId xmlns:a16="http://schemas.microsoft.com/office/drawing/2014/main" id="{16CAD0B3-F54D-45D0-82AA-539AF0742EC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59DBD49F-B3C5-419A-A246-1F4117B8382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66B6F198-B4C2-412C-AFE9-766A5007665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6C6234-04C6-4327-BEF4-5CA5D3C25248}" type="datetimeFigureOut">
              <a:rPr lang="de-DE" smtClean="0"/>
              <a:t>27.05.23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8E708E7C-2EC9-4E09-80F5-FAD84F26E9D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9887E949-5393-48F7-B405-3A8870C706C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11C98C-81B8-4000-A1CC-5CBED1F63FE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0588376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>
            <a:extLst>
              <a:ext uri="{FF2B5EF4-FFF2-40B4-BE49-F238E27FC236}">
                <a16:creationId xmlns:a16="http://schemas.microsoft.com/office/drawing/2014/main" id="{1773F1D2-5460-438F-85BA-EFC829BDD84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76FDB7A0-4283-4BDC-A425-DA7AF9BCB16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E817DDCD-6411-475E-98B4-A9CC2F59A8C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F6C6234-04C6-4327-BEF4-5CA5D3C25248}" type="datetimeFigureOut">
              <a:rPr lang="de-DE" smtClean="0"/>
              <a:t>27.05.23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4F673A17-25C2-4261-8BA0-48A8E3D0FBD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30AD2141-4B1B-4626-8175-1629AD27198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611C98C-81B8-4000-A1CC-5CBED1F63FE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01515325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diagramData" Target="../diagrams/data1.xml"/><Relationship Id="rId7" Type="http://schemas.microsoft.com/office/2007/relationships/diagramDrawing" Target="../diagrams/drawing1.xml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Relationship Id="rId6" Type="http://schemas.openxmlformats.org/officeDocument/2006/relationships/diagramColors" Target="../diagrams/colors1.xml"/><Relationship Id="rId5" Type="http://schemas.openxmlformats.org/officeDocument/2006/relationships/diagramQuickStyle" Target="../diagrams/quickStyle1.xml"/><Relationship Id="rId4" Type="http://schemas.openxmlformats.org/officeDocument/2006/relationships/diagramLayout" Target="../diagrams/layout1.xml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svg"/><Relationship Id="rId13" Type="http://schemas.openxmlformats.org/officeDocument/2006/relationships/image" Target="../media/image12.png"/><Relationship Id="rId18" Type="http://schemas.openxmlformats.org/officeDocument/2006/relationships/image" Target="../media/image17.svg"/><Relationship Id="rId3" Type="http://schemas.openxmlformats.org/officeDocument/2006/relationships/image" Target="../media/image2.png"/><Relationship Id="rId21" Type="http://schemas.openxmlformats.org/officeDocument/2006/relationships/image" Target="../media/image20.png"/><Relationship Id="rId7" Type="http://schemas.openxmlformats.org/officeDocument/2006/relationships/image" Target="../media/image6.png"/><Relationship Id="rId12" Type="http://schemas.openxmlformats.org/officeDocument/2006/relationships/image" Target="../media/image11.svg"/><Relationship Id="rId17" Type="http://schemas.openxmlformats.org/officeDocument/2006/relationships/image" Target="../media/image16.png"/><Relationship Id="rId2" Type="http://schemas.openxmlformats.org/officeDocument/2006/relationships/notesSlide" Target="../notesSlides/notesSlide3.xml"/><Relationship Id="rId16" Type="http://schemas.openxmlformats.org/officeDocument/2006/relationships/image" Target="../media/image15.svg"/><Relationship Id="rId20" Type="http://schemas.openxmlformats.org/officeDocument/2006/relationships/image" Target="../media/image19.sv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sv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5" Type="http://schemas.openxmlformats.org/officeDocument/2006/relationships/image" Target="../media/image14.png"/><Relationship Id="rId10" Type="http://schemas.openxmlformats.org/officeDocument/2006/relationships/image" Target="../media/image9.svg"/><Relationship Id="rId19" Type="http://schemas.openxmlformats.org/officeDocument/2006/relationships/image" Target="../media/image18.png"/><Relationship Id="rId4" Type="http://schemas.openxmlformats.org/officeDocument/2006/relationships/image" Target="../media/image3.svg"/><Relationship Id="rId9" Type="http://schemas.openxmlformats.org/officeDocument/2006/relationships/image" Target="../media/image8.png"/><Relationship Id="rId14" Type="http://schemas.openxmlformats.org/officeDocument/2006/relationships/image" Target="../media/image13.svg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diagramData" Target="../diagrams/data2.xml"/><Relationship Id="rId7" Type="http://schemas.microsoft.com/office/2007/relationships/diagramDrawing" Target="../diagrams/drawing2.xml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7.xml"/><Relationship Id="rId6" Type="http://schemas.openxmlformats.org/officeDocument/2006/relationships/diagramColors" Target="../diagrams/colors2.xml"/><Relationship Id="rId5" Type="http://schemas.openxmlformats.org/officeDocument/2006/relationships/diagramQuickStyle" Target="../diagrams/quickStyle2.xml"/><Relationship Id="rId4" Type="http://schemas.openxmlformats.org/officeDocument/2006/relationships/diagramLayout" Target="../diagrams/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69DA4854-818E-41DA-0467-949D0BE8CAC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nl-NL" sz="1800" i="1" dirty="0">
                <a:effectLst/>
                <a:latin typeface="Times"/>
              </a:rPr>
              <a:t>Boender et al. JMIR </a:t>
            </a:r>
            <a:r>
              <a:rPr lang="nl-NL" sz="1800" i="1" dirty="0" err="1">
                <a:effectLst/>
                <a:latin typeface="Times"/>
              </a:rPr>
              <a:t>Infodemiology</a:t>
            </a:r>
            <a:r>
              <a:rPr lang="nl-NL" sz="1800" i="1" dirty="0">
                <a:effectLst/>
                <a:latin typeface="Times"/>
              </a:rPr>
              <a:t> 2023;3:e43646</a:t>
            </a:r>
            <a:br>
              <a:rPr lang="nl-NL" sz="1800" i="1" dirty="0">
                <a:effectLst/>
                <a:latin typeface="Times"/>
              </a:rPr>
            </a:br>
            <a:br>
              <a:rPr lang="nl-NL" sz="1800" b="1" dirty="0">
                <a:effectLst/>
                <a:latin typeface="Times"/>
              </a:rPr>
            </a:br>
            <a:r>
              <a:rPr lang="nl-NL" sz="1800" b="1" dirty="0">
                <a:effectLst/>
                <a:latin typeface="Times"/>
              </a:rPr>
              <a:t>Multimedia </a:t>
            </a:r>
            <a:r>
              <a:rPr lang="nl-NL" sz="1800" b="1">
                <a:effectLst/>
                <a:latin typeface="Times"/>
              </a:rPr>
              <a:t>Appendix 4 </a:t>
            </a:r>
            <a:br>
              <a:rPr lang="nl-NL" sz="1800" b="1" dirty="0">
                <a:effectLst/>
                <a:latin typeface="Times"/>
              </a:rPr>
            </a:br>
            <a:r>
              <a:rPr lang="nl-NL" sz="1800" dirty="0" err="1">
                <a:effectLst/>
                <a:latin typeface="Times"/>
              </a:rPr>
              <a:t>Editable</a:t>
            </a:r>
            <a:r>
              <a:rPr lang="nl-NL" sz="1800" dirty="0">
                <a:effectLst/>
                <a:latin typeface="Times"/>
              </a:rPr>
              <a:t> </a:t>
            </a:r>
            <a:r>
              <a:rPr lang="nl-NL" sz="1800" dirty="0" err="1">
                <a:effectLst/>
                <a:latin typeface="Times"/>
              </a:rPr>
              <a:t>versions</a:t>
            </a:r>
            <a:r>
              <a:rPr lang="nl-NL" sz="1800" dirty="0">
                <a:effectLst/>
                <a:latin typeface="Times"/>
              </a:rPr>
              <a:t> of </a:t>
            </a:r>
            <a:r>
              <a:rPr lang="nl-NL" sz="1800" dirty="0" err="1">
                <a:effectLst/>
                <a:latin typeface="Times"/>
              </a:rPr>
              <a:t>Figure</a:t>
            </a:r>
            <a:r>
              <a:rPr lang="nl-NL" sz="1800" dirty="0">
                <a:effectLst/>
                <a:latin typeface="Times"/>
              </a:rPr>
              <a:t> 1, </a:t>
            </a:r>
            <a:r>
              <a:rPr lang="nl-NL" sz="1800" dirty="0" err="1">
                <a:effectLst/>
                <a:latin typeface="Times"/>
              </a:rPr>
              <a:t>Figure</a:t>
            </a:r>
            <a:r>
              <a:rPr lang="nl-NL" sz="1800" dirty="0">
                <a:effectLst/>
                <a:latin typeface="Times"/>
              </a:rPr>
              <a:t> 2, </a:t>
            </a:r>
            <a:r>
              <a:rPr lang="nl-NL" sz="1800" dirty="0" err="1">
                <a:effectLst/>
                <a:latin typeface="Times"/>
              </a:rPr>
              <a:t>Figure</a:t>
            </a:r>
            <a:r>
              <a:rPr lang="nl-NL" sz="1800" dirty="0">
                <a:effectLst/>
                <a:latin typeface="Times"/>
              </a:rPr>
              <a:t> 3 </a:t>
            </a:r>
            <a:r>
              <a:rPr lang="nl-NL" sz="1800" dirty="0" err="1">
                <a:effectLst/>
                <a:latin typeface="Times"/>
              </a:rPr>
              <a:t>and</a:t>
            </a:r>
            <a:r>
              <a:rPr lang="nl-NL" sz="1800" dirty="0">
                <a:effectLst/>
                <a:latin typeface="Times"/>
              </a:rPr>
              <a:t> Multimedia Appendix 2 </a:t>
            </a:r>
            <a:endParaRPr lang="nl-DE" dirty="0"/>
          </a:p>
        </p:txBody>
      </p:sp>
      <p:pic>
        <p:nvPicPr>
          <p:cNvPr id="4" name="Tijdelijke aanduiding voor inhoud 3">
            <a:extLst>
              <a:ext uri="{FF2B5EF4-FFF2-40B4-BE49-F238E27FC236}">
                <a16:creationId xmlns:a16="http://schemas.microsoft.com/office/drawing/2014/main" id="{0CA70B6B-915A-D2A0-5581-917928B14EE7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3"/>
          <a:stretch>
            <a:fillRect/>
          </a:stretch>
        </p:blipFill>
        <p:spPr>
          <a:xfrm>
            <a:off x="2479752" y="1825625"/>
            <a:ext cx="7232496" cy="435133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4887332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Diagramm 1">
            <a:extLst>
              <a:ext uri="{FF2B5EF4-FFF2-40B4-BE49-F238E27FC236}">
                <a16:creationId xmlns:a16="http://schemas.microsoft.com/office/drawing/2014/main" id="{80C6BE41-EB96-4766-B7EC-A02D85DB8DB6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366318670"/>
              </p:ext>
            </p:extLst>
          </p:nvPr>
        </p:nvGraphicFramePr>
        <p:xfrm>
          <a:off x="241538" y="224286"/>
          <a:ext cx="11763107" cy="6210070"/>
        </p:xfrm>
        <a:graphic>
          <a:graphicData uri="http://schemas.openxmlformats.org/drawingml/2006/diagram">
            <dgm:relIds xmlns:dgm="http://schemas.openxmlformats.org/drawingml/2006/diagram" xmlns:r="http://schemas.openxmlformats.org/officeDocument/2006/relationships" r:dm="rId3" r:lo="rId4" r:qs="rId5" r:cs="rId6"/>
          </a:graphicData>
        </a:graphic>
      </p:graphicFrame>
    </p:spTree>
    <p:extLst>
      <p:ext uri="{BB962C8B-B14F-4D97-AF65-F5344CB8AC3E}">
        <p14:creationId xmlns:p14="http://schemas.microsoft.com/office/powerpoint/2010/main" val="315277222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uppieren 3">
            <a:extLst>
              <a:ext uri="{FF2B5EF4-FFF2-40B4-BE49-F238E27FC236}">
                <a16:creationId xmlns:a16="http://schemas.microsoft.com/office/drawing/2014/main" id="{02012680-5092-455C-A71B-A002C8F0802C}"/>
              </a:ext>
            </a:extLst>
          </p:cNvPr>
          <p:cNvGrpSpPr/>
          <p:nvPr/>
        </p:nvGrpSpPr>
        <p:grpSpPr>
          <a:xfrm>
            <a:off x="655819" y="1266344"/>
            <a:ext cx="10880361" cy="3759142"/>
            <a:chOff x="32806" y="939809"/>
            <a:chExt cx="10880361" cy="3759142"/>
          </a:xfrm>
        </p:grpSpPr>
        <p:sp>
          <p:nvSpPr>
            <p:cNvPr id="5" name="Abgerundetes Rechteck 3">
              <a:extLst>
                <a:ext uri="{FF2B5EF4-FFF2-40B4-BE49-F238E27FC236}">
                  <a16:creationId xmlns:a16="http://schemas.microsoft.com/office/drawing/2014/main" id="{961BAA3D-2760-4738-A3B5-CBA4C2DF5044}"/>
                </a:ext>
              </a:extLst>
            </p:cNvPr>
            <p:cNvSpPr/>
            <p:nvPr/>
          </p:nvSpPr>
          <p:spPr>
            <a:xfrm>
              <a:off x="46466" y="2259554"/>
              <a:ext cx="1647102" cy="540000"/>
            </a:xfrm>
            <a:prstGeom prst="roundRect">
              <a:avLst/>
            </a:prstGeom>
            <a:solidFill>
              <a:schemeClr val="bg1"/>
            </a:solidFill>
            <a:ln w="254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r>
                <a:rPr lang="de-DE" sz="13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ore </a:t>
              </a:r>
              <a:r>
                <a:rPr lang="de-DE" sz="1300" dirty="0" err="1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team</a:t>
              </a:r>
              <a:r>
                <a:rPr lang="de-DE" sz="13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: </a:t>
              </a:r>
            </a:p>
            <a:p>
              <a:r>
                <a:rPr lang="de-DE" sz="13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Group </a:t>
              </a:r>
              <a:r>
                <a:rPr lang="de-DE" sz="1300" dirty="0" err="1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activities</a:t>
              </a:r>
              <a:endParaRPr lang="de-DE" sz="13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" name="Abgerundetes Rechteck 4">
              <a:extLst>
                <a:ext uri="{FF2B5EF4-FFF2-40B4-BE49-F238E27FC236}">
                  <a16:creationId xmlns:a16="http://schemas.microsoft.com/office/drawing/2014/main" id="{B8AD77FA-C7BF-4DB8-9AB2-5CD379E6AE4F}"/>
                </a:ext>
              </a:extLst>
            </p:cNvPr>
            <p:cNvSpPr/>
            <p:nvPr/>
          </p:nvSpPr>
          <p:spPr>
            <a:xfrm>
              <a:off x="46466" y="1543687"/>
              <a:ext cx="1647101" cy="540000"/>
            </a:xfrm>
            <a:prstGeom prst="roundRect">
              <a:avLst/>
            </a:prstGeom>
            <a:solidFill>
              <a:schemeClr val="bg1"/>
            </a:solidFill>
            <a:ln w="254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r>
                <a:rPr lang="de-DE" sz="13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Team </a:t>
              </a:r>
              <a:r>
                <a:rPr lang="de-DE" sz="1300" dirty="0" err="1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lead</a:t>
              </a:r>
              <a:endParaRPr lang="de-DE" sz="13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7" name="Gerade Verbindung mit Pfeil 6">
              <a:extLst>
                <a:ext uri="{FF2B5EF4-FFF2-40B4-BE49-F238E27FC236}">
                  <a16:creationId xmlns:a16="http://schemas.microsoft.com/office/drawing/2014/main" id="{FD99735D-C3DE-4721-AFDB-A8D2E7451163}"/>
                </a:ext>
              </a:extLst>
            </p:cNvPr>
            <p:cNvCxnSpPr>
              <a:cxnSpLocks/>
            </p:cNvCxnSpPr>
            <p:nvPr/>
          </p:nvCxnSpPr>
          <p:spPr>
            <a:xfrm>
              <a:off x="32806" y="4378086"/>
              <a:ext cx="10880361" cy="26561"/>
            </a:xfrm>
            <a:prstGeom prst="straightConnector1">
              <a:avLst/>
            </a:prstGeom>
            <a:ln w="25400">
              <a:solidFill>
                <a:schemeClr val="tx1"/>
              </a:solidFill>
              <a:prstDash val="solid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" name="Abgerundetes Rechteck 9">
              <a:extLst>
                <a:ext uri="{FF2B5EF4-FFF2-40B4-BE49-F238E27FC236}">
                  <a16:creationId xmlns:a16="http://schemas.microsoft.com/office/drawing/2014/main" id="{E24EBAC0-B272-460A-BC81-DE04F5BFBF08}"/>
                </a:ext>
              </a:extLst>
            </p:cNvPr>
            <p:cNvSpPr/>
            <p:nvPr/>
          </p:nvSpPr>
          <p:spPr>
            <a:xfrm>
              <a:off x="89959" y="4346765"/>
              <a:ext cx="10661058" cy="352186"/>
            </a:xfrm>
            <a:prstGeom prst="round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de-DE" sz="140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Time</a:t>
              </a:r>
            </a:p>
          </p:txBody>
        </p:sp>
        <p:sp>
          <p:nvSpPr>
            <p:cNvPr id="9" name="Abgerundetes Rechteck 12">
              <a:extLst>
                <a:ext uri="{FF2B5EF4-FFF2-40B4-BE49-F238E27FC236}">
                  <a16:creationId xmlns:a16="http://schemas.microsoft.com/office/drawing/2014/main" id="{BD95DDC5-DE15-4DC2-8D3F-D032C10245D0}"/>
                </a:ext>
              </a:extLst>
            </p:cNvPr>
            <p:cNvSpPr/>
            <p:nvPr/>
          </p:nvSpPr>
          <p:spPr>
            <a:xfrm>
              <a:off x="9531849" y="1525834"/>
              <a:ext cx="1381318" cy="540000"/>
            </a:xfrm>
            <a:prstGeom prst="round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r>
                <a:rPr lang="de-DE" sz="13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Publish and </a:t>
              </a:r>
              <a:r>
                <a:rPr lang="de-DE" sz="1300" dirty="0" err="1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distribute</a:t>
              </a:r>
              <a:r>
                <a:rPr lang="de-DE" sz="13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de-DE" sz="1300" dirty="0" err="1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report</a:t>
              </a:r>
              <a:endParaRPr lang="de-DE" sz="13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" name="Abgerundetes Rechteck 13">
              <a:extLst>
                <a:ext uri="{FF2B5EF4-FFF2-40B4-BE49-F238E27FC236}">
                  <a16:creationId xmlns:a16="http://schemas.microsoft.com/office/drawing/2014/main" id="{FBC9E7C5-D168-425A-BA74-3AF5C1FCA5CB}"/>
                </a:ext>
              </a:extLst>
            </p:cNvPr>
            <p:cNvSpPr/>
            <p:nvPr/>
          </p:nvSpPr>
          <p:spPr>
            <a:xfrm>
              <a:off x="1779874" y="1543687"/>
              <a:ext cx="1647101" cy="540000"/>
            </a:xfrm>
            <a:prstGeom prst="round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r>
                <a:rPr lang="de-DE" sz="130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Decision on data sources to be used</a:t>
              </a:r>
            </a:p>
          </p:txBody>
        </p:sp>
        <p:sp>
          <p:nvSpPr>
            <p:cNvPr id="11" name="Abgerundetes Rechteck 16">
              <a:extLst>
                <a:ext uri="{FF2B5EF4-FFF2-40B4-BE49-F238E27FC236}">
                  <a16:creationId xmlns:a16="http://schemas.microsoft.com/office/drawing/2014/main" id="{5D01D41F-DE5D-44CD-8E69-95121FC089E8}"/>
                </a:ext>
              </a:extLst>
            </p:cNvPr>
            <p:cNvSpPr/>
            <p:nvPr/>
          </p:nvSpPr>
          <p:spPr>
            <a:xfrm>
              <a:off x="2188155" y="2259554"/>
              <a:ext cx="1490695" cy="540000"/>
            </a:xfrm>
            <a:prstGeom prst="round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r>
                <a:rPr lang="de-DE" sz="130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Assign members to data sources</a:t>
              </a:r>
            </a:p>
          </p:txBody>
        </p:sp>
        <p:sp>
          <p:nvSpPr>
            <p:cNvPr id="12" name="Abgerundetes Rechteck 18">
              <a:extLst>
                <a:ext uri="{FF2B5EF4-FFF2-40B4-BE49-F238E27FC236}">
                  <a16:creationId xmlns:a16="http://schemas.microsoft.com/office/drawing/2014/main" id="{1A842B1D-9474-44E3-91C0-DA5B8247D550}"/>
                </a:ext>
              </a:extLst>
            </p:cNvPr>
            <p:cNvSpPr/>
            <p:nvPr/>
          </p:nvSpPr>
          <p:spPr>
            <a:xfrm>
              <a:off x="46466" y="3676180"/>
              <a:ext cx="1647104" cy="540000"/>
            </a:xfrm>
            <a:prstGeom prst="roundRect">
              <a:avLst/>
            </a:prstGeom>
            <a:noFill/>
            <a:ln w="254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r>
                <a:rPr lang="de-DE" sz="130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President</a:t>
              </a:r>
            </a:p>
          </p:txBody>
        </p:sp>
        <p:sp>
          <p:nvSpPr>
            <p:cNvPr id="13" name="Abgerundetes Rechteck 19">
              <a:extLst>
                <a:ext uri="{FF2B5EF4-FFF2-40B4-BE49-F238E27FC236}">
                  <a16:creationId xmlns:a16="http://schemas.microsoft.com/office/drawing/2014/main" id="{8957F57C-4CD6-49A0-8F2A-76BA785E0E9C}"/>
                </a:ext>
              </a:extLst>
            </p:cNvPr>
            <p:cNvSpPr/>
            <p:nvPr/>
          </p:nvSpPr>
          <p:spPr>
            <a:xfrm>
              <a:off x="46466" y="2975421"/>
              <a:ext cx="1647104" cy="540000"/>
            </a:xfrm>
            <a:prstGeom prst="roundRect">
              <a:avLst/>
            </a:prstGeom>
            <a:noFill/>
            <a:ln w="254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r>
                <a:rPr lang="de-DE" sz="13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ore </a:t>
              </a:r>
              <a:r>
                <a:rPr lang="de-DE" sz="1300" dirty="0" err="1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team</a:t>
              </a:r>
              <a:r>
                <a:rPr lang="de-DE" sz="13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: Individual </a:t>
              </a:r>
              <a:r>
                <a:rPr lang="de-DE" sz="1300" dirty="0" err="1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activities</a:t>
              </a:r>
              <a:endParaRPr lang="de-DE" sz="13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" name="Abgerundetes Rechteck 21">
              <a:extLst>
                <a:ext uri="{FF2B5EF4-FFF2-40B4-BE49-F238E27FC236}">
                  <a16:creationId xmlns:a16="http://schemas.microsoft.com/office/drawing/2014/main" id="{06737200-7A2F-40BD-B66F-54216C1D7DAE}"/>
                </a:ext>
              </a:extLst>
            </p:cNvPr>
            <p:cNvSpPr/>
            <p:nvPr/>
          </p:nvSpPr>
          <p:spPr>
            <a:xfrm>
              <a:off x="2670772" y="2963921"/>
              <a:ext cx="1565871" cy="540000"/>
            </a:xfrm>
            <a:prstGeom prst="round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r>
                <a:rPr lang="de-DE" sz="13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Data pull </a:t>
              </a:r>
              <a:r>
                <a:rPr lang="de-DE" sz="1300" dirty="0" err="1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from</a:t>
              </a:r>
              <a:r>
                <a:rPr lang="de-DE" sz="13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de-DE" sz="1300" dirty="0" err="1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data</a:t>
              </a:r>
              <a:r>
                <a:rPr lang="de-DE" sz="13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de-DE" sz="1300" dirty="0" err="1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ources</a:t>
              </a:r>
              <a:endParaRPr lang="de-DE" sz="13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" name="Abgerundetes Rechteck 22">
              <a:extLst>
                <a:ext uri="{FF2B5EF4-FFF2-40B4-BE49-F238E27FC236}">
                  <a16:creationId xmlns:a16="http://schemas.microsoft.com/office/drawing/2014/main" id="{A8485654-EEFE-4CCF-950E-C4AE5D511F98}"/>
                </a:ext>
              </a:extLst>
            </p:cNvPr>
            <p:cNvSpPr/>
            <p:nvPr/>
          </p:nvSpPr>
          <p:spPr>
            <a:xfrm>
              <a:off x="4362481" y="2952197"/>
              <a:ext cx="1173171" cy="540000"/>
            </a:xfrm>
            <a:prstGeom prst="round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r>
                <a:rPr lang="de-DE" sz="130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Initial themes (dump)</a:t>
              </a:r>
            </a:p>
          </p:txBody>
        </p:sp>
        <p:sp>
          <p:nvSpPr>
            <p:cNvPr id="16" name="Abgerundetes Rechteck 23">
              <a:extLst>
                <a:ext uri="{FF2B5EF4-FFF2-40B4-BE49-F238E27FC236}">
                  <a16:creationId xmlns:a16="http://schemas.microsoft.com/office/drawing/2014/main" id="{70D768DF-0BCD-4617-B53C-F52A0216612E}"/>
                </a:ext>
              </a:extLst>
            </p:cNvPr>
            <p:cNvSpPr/>
            <p:nvPr/>
          </p:nvSpPr>
          <p:spPr>
            <a:xfrm>
              <a:off x="5343940" y="2237662"/>
              <a:ext cx="1381318" cy="540000"/>
            </a:xfrm>
            <a:prstGeom prst="round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r>
                <a:rPr lang="de-DE" sz="130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Review themes</a:t>
              </a:r>
            </a:p>
          </p:txBody>
        </p:sp>
        <p:sp>
          <p:nvSpPr>
            <p:cNvPr id="17" name="Abgerundetes Rechteck 24">
              <a:extLst>
                <a:ext uri="{FF2B5EF4-FFF2-40B4-BE49-F238E27FC236}">
                  <a16:creationId xmlns:a16="http://schemas.microsoft.com/office/drawing/2014/main" id="{2BFDCE1D-D6A7-41C5-B99F-4D890D6D271C}"/>
                </a:ext>
              </a:extLst>
            </p:cNvPr>
            <p:cNvSpPr/>
            <p:nvPr/>
          </p:nvSpPr>
          <p:spPr>
            <a:xfrm>
              <a:off x="4712240" y="1514301"/>
              <a:ext cx="1381318" cy="540000"/>
            </a:xfrm>
            <a:prstGeom prst="round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r>
                <a:rPr lang="de-DE" sz="130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Organize themes</a:t>
              </a:r>
            </a:p>
          </p:txBody>
        </p:sp>
        <p:sp>
          <p:nvSpPr>
            <p:cNvPr id="18" name="Abgerundetes Rechteck 25">
              <a:extLst>
                <a:ext uri="{FF2B5EF4-FFF2-40B4-BE49-F238E27FC236}">
                  <a16:creationId xmlns:a16="http://schemas.microsoft.com/office/drawing/2014/main" id="{6DE87922-B0BD-4C5F-B1AF-E21948319EBF}"/>
                </a:ext>
              </a:extLst>
            </p:cNvPr>
            <p:cNvSpPr/>
            <p:nvPr/>
          </p:nvSpPr>
          <p:spPr>
            <a:xfrm>
              <a:off x="6153923" y="1514301"/>
              <a:ext cx="1381318" cy="540000"/>
            </a:xfrm>
            <a:prstGeom prst="round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r>
                <a:rPr lang="de-DE" sz="130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Update themes</a:t>
              </a:r>
            </a:p>
          </p:txBody>
        </p:sp>
        <p:sp>
          <p:nvSpPr>
            <p:cNvPr id="19" name="Abgerundetes Rechteck 26">
              <a:extLst>
                <a:ext uri="{FF2B5EF4-FFF2-40B4-BE49-F238E27FC236}">
                  <a16:creationId xmlns:a16="http://schemas.microsoft.com/office/drawing/2014/main" id="{2EE80FBE-59D3-45B1-BDA0-12FEFDFA4AC1}"/>
                </a:ext>
              </a:extLst>
            </p:cNvPr>
            <p:cNvSpPr/>
            <p:nvPr/>
          </p:nvSpPr>
          <p:spPr>
            <a:xfrm>
              <a:off x="6785113" y="2905617"/>
              <a:ext cx="1518632" cy="540000"/>
            </a:xfrm>
            <a:prstGeom prst="round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r>
                <a:rPr lang="de-DE" sz="130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Populate themes with examples</a:t>
              </a:r>
            </a:p>
          </p:txBody>
        </p:sp>
        <p:sp>
          <p:nvSpPr>
            <p:cNvPr id="20" name="Abgerundetes Rechteck 27">
              <a:extLst>
                <a:ext uri="{FF2B5EF4-FFF2-40B4-BE49-F238E27FC236}">
                  <a16:creationId xmlns:a16="http://schemas.microsoft.com/office/drawing/2014/main" id="{5854D0B2-59D3-451D-8736-6342B2B707E8}"/>
                </a:ext>
              </a:extLst>
            </p:cNvPr>
            <p:cNvSpPr/>
            <p:nvPr/>
          </p:nvSpPr>
          <p:spPr>
            <a:xfrm>
              <a:off x="7599149" y="1514301"/>
              <a:ext cx="1381318" cy="540000"/>
            </a:xfrm>
            <a:prstGeom prst="round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r>
                <a:rPr lang="de-DE" sz="1300" dirty="0" err="1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Draft</a:t>
              </a:r>
              <a:r>
                <a:rPr lang="de-DE" sz="13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report</a:t>
              </a:r>
            </a:p>
          </p:txBody>
        </p:sp>
        <p:sp>
          <p:nvSpPr>
            <p:cNvPr id="21" name="Abgerundetes Rechteck 28">
              <a:extLst>
                <a:ext uri="{FF2B5EF4-FFF2-40B4-BE49-F238E27FC236}">
                  <a16:creationId xmlns:a16="http://schemas.microsoft.com/office/drawing/2014/main" id="{D7777EEE-71D9-425E-A887-965B3CE6BF5E}"/>
                </a:ext>
              </a:extLst>
            </p:cNvPr>
            <p:cNvSpPr/>
            <p:nvPr/>
          </p:nvSpPr>
          <p:spPr>
            <a:xfrm>
              <a:off x="8931081" y="2921335"/>
              <a:ext cx="1381318" cy="540000"/>
            </a:xfrm>
            <a:prstGeom prst="round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r>
                <a:rPr lang="de-DE" sz="13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Review report</a:t>
              </a:r>
            </a:p>
          </p:txBody>
        </p:sp>
        <p:sp>
          <p:nvSpPr>
            <p:cNvPr id="22" name="Abgerundetes Rechteck 29">
              <a:extLst>
                <a:ext uri="{FF2B5EF4-FFF2-40B4-BE49-F238E27FC236}">
                  <a16:creationId xmlns:a16="http://schemas.microsoft.com/office/drawing/2014/main" id="{8F30BB28-AAD0-4599-A485-9F72531F2AD4}"/>
                </a:ext>
              </a:extLst>
            </p:cNvPr>
            <p:cNvSpPr/>
            <p:nvPr/>
          </p:nvSpPr>
          <p:spPr>
            <a:xfrm>
              <a:off x="9376955" y="3676180"/>
              <a:ext cx="1381318" cy="540000"/>
            </a:xfrm>
            <a:prstGeom prst="round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r>
                <a:rPr lang="de-DE" sz="130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learance</a:t>
              </a:r>
            </a:p>
          </p:txBody>
        </p:sp>
        <p:cxnSp>
          <p:nvCxnSpPr>
            <p:cNvPr id="23" name="Gerade Verbindung 32">
              <a:extLst>
                <a:ext uri="{FF2B5EF4-FFF2-40B4-BE49-F238E27FC236}">
                  <a16:creationId xmlns:a16="http://schemas.microsoft.com/office/drawing/2014/main" id="{3D9EAAE1-B48E-4354-A956-9FE8026E031E}"/>
                </a:ext>
              </a:extLst>
            </p:cNvPr>
            <p:cNvCxnSpPr/>
            <p:nvPr/>
          </p:nvCxnSpPr>
          <p:spPr>
            <a:xfrm>
              <a:off x="2575932" y="2067028"/>
              <a:ext cx="0" cy="195003"/>
            </a:xfrm>
            <a:prstGeom prst="line">
              <a:avLst/>
            </a:prstGeom>
            <a:ln w="254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" name="Gerade Verbindung 40">
              <a:extLst>
                <a:ext uri="{FF2B5EF4-FFF2-40B4-BE49-F238E27FC236}">
                  <a16:creationId xmlns:a16="http://schemas.microsoft.com/office/drawing/2014/main" id="{D9C7685C-F894-482C-81AF-8AF862BB89E0}"/>
                </a:ext>
              </a:extLst>
            </p:cNvPr>
            <p:cNvCxnSpPr/>
            <p:nvPr/>
          </p:nvCxnSpPr>
          <p:spPr>
            <a:xfrm>
              <a:off x="3175443" y="2779364"/>
              <a:ext cx="0" cy="195003"/>
            </a:xfrm>
            <a:prstGeom prst="line">
              <a:avLst/>
            </a:prstGeom>
            <a:ln w="254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" name="Gerade Verbindung 43">
              <a:extLst>
                <a:ext uri="{FF2B5EF4-FFF2-40B4-BE49-F238E27FC236}">
                  <a16:creationId xmlns:a16="http://schemas.microsoft.com/office/drawing/2014/main" id="{8DD84401-0B8E-4F70-98D6-08642EDC6AF2}"/>
                </a:ext>
              </a:extLst>
            </p:cNvPr>
            <p:cNvCxnSpPr>
              <a:cxnSpLocks/>
            </p:cNvCxnSpPr>
            <p:nvPr/>
          </p:nvCxnSpPr>
          <p:spPr>
            <a:xfrm>
              <a:off x="4213912" y="3247683"/>
              <a:ext cx="157313" cy="0"/>
            </a:xfrm>
            <a:prstGeom prst="line">
              <a:avLst/>
            </a:prstGeom>
            <a:ln w="254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" name="Gerade Verbindung 48">
              <a:extLst>
                <a:ext uri="{FF2B5EF4-FFF2-40B4-BE49-F238E27FC236}">
                  <a16:creationId xmlns:a16="http://schemas.microsoft.com/office/drawing/2014/main" id="{A7D1F865-DDE9-4CBB-9C22-E3248C0A11EA}"/>
                </a:ext>
              </a:extLst>
            </p:cNvPr>
            <p:cNvCxnSpPr/>
            <p:nvPr/>
          </p:nvCxnSpPr>
          <p:spPr>
            <a:xfrm>
              <a:off x="5670098" y="2042659"/>
              <a:ext cx="0" cy="195003"/>
            </a:xfrm>
            <a:prstGeom prst="line">
              <a:avLst/>
            </a:prstGeom>
            <a:ln w="254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" name="Gerade Verbindung 50">
              <a:extLst>
                <a:ext uri="{FF2B5EF4-FFF2-40B4-BE49-F238E27FC236}">
                  <a16:creationId xmlns:a16="http://schemas.microsoft.com/office/drawing/2014/main" id="{1B35BE5D-F6ED-4FE1-8F51-64C951FD5D94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6408285" y="2032867"/>
              <a:ext cx="0" cy="209316"/>
            </a:xfrm>
            <a:prstGeom prst="line">
              <a:avLst/>
            </a:prstGeom>
            <a:ln w="254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" name="Gerade Verbindung 53">
              <a:extLst>
                <a:ext uri="{FF2B5EF4-FFF2-40B4-BE49-F238E27FC236}">
                  <a16:creationId xmlns:a16="http://schemas.microsoft.com/office/drawing/2014/main" id="{999A3CBB-2640-4D72-BBBE-583F85631867}"/>
                </a:ext>
              </a:extLst>
            </p:cNvPr>
            <p:cNvCxnSpPr>
              <a:cxnSpLocks/>
            </p:cNvCxnSpPr>
            <p:nvPr/>
          </p:nvCxnSpPr>
          <p:spPr>
            <a:xfrm>
              <a:off x="7184365" y="2067244"/>
              <a:ext cx="0" cy="821869"/>
            </a:xfrm>
            <a:prstGeom prst="line">
              <a:avLst/>
            </a:prstGeom>
            <a:ln w="254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9" name="Gerade Verbindung 55">
              <a:extLst>
                <a:ext uri="{FF2B5EF4-FFF2-40B4-BE49-F238E27FC236}">
                  <a16:creationId xmlns:a16="http://schemas.microsoft.com/office/drawing/2014/main" id="{49F86D5F-8B45-49A5-8233-FBE22492D704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7908265" y="2037999"/>
              <a:ext cx="0" cy="867618"/>
            </a:xfrm>
            <a:prstGeom prst="line">
              <a:avLst/>
            </a:prstGeom>
            <a:ln w="254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" name="Gerade Verbindung 58">
              <a:extLst>
                <a:ext uri="{FF2B5EF4-FFF2-40B4-BE49-F238E27FC236}">
                  <a16:creationId xmlns:a16="http://schemas.microsoft.com/office/drawing/2014/main" id="{EF6A5ABB-6465-439A-A3A7-ED3529ED9325}"/>
                </a:ext>
              </a:extLst>
            </p:cNvPr>
            <p:cNvCxnSpPr>
              <a:cxnSpLocks/>
              <a:stCxn id="21" idx="2"/>
            </p:cNvCxnSpPr>
            <p:nvPr/>
          </p:nvCxnSpPr>
          <p:spPr>
            <a:xfrm>
              <a:off x="9621740" y="3461335"/>
              <a:ext cx="0" cy="214845"/>
            </a:xfrm>
            <a:prstGeom prst="line">
              <a:avLst/>
            </a:prstGeom>
            <a:ln w="254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" name="Gerade Verbindung 60">
              <a:extLst>
                <a:ext uri="{FF2B5EF4-FFF2-40B4-BE49-F238E27FC236}">
                  <a16:creationId xmlns:a16="http://schemas.microsoft.com/office/drawing/2014/main" id="{DF1FF1AE-FFD6-49E2-BEAE-0AC864E96F47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0440475" y="2091248"/>
              <a:ext cx="0" cy="1584932"/>
            </a:xfrm>
            <a:prstGeom prst="line">
              <a:avLst/>
            </a:prstGeom>
            <a:ln w="254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32" name="Graphic 84" descr="Folder Search outline">
              <a:extLst>
                <a:ext uri="{FF2B5EF4-FFF2-40B4-BE49-F238E27FC236}">
                  <a16:creationId xmlns:a16="http://schemas.microsoft.com/office/drawing/2014/main" id="{1DFA8B81-9563-48EA-98A9-412EBD118345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  <a:ext uri="{96DAC541-7B7A-43D3-8B79-37D633B846F1}">
                  <asvg:svgBlip xmlns:asvg="http://schemas.microsoft.com/office/drawing/2016/SVG/main" r:embed="rId4"/>
                </a:ext>
              </a:extLst>
            </a:blip>
            <a:stretch>
              <a:fillRect/>
            </a:stretch>
          </p:blipFill>
          <p:spPr>
            <a:xfrm>
              <a:off x="3684860" y="2308169"/>
              <a:ext cx="659960" cy="656708"/>
            </a:xfrm>
            <a:prstGeom prst="rect">
              <a:avLst/>
            </a:prstGeom>
          </p:spPr>
        </p:pic>
        <p:pic>
          <p:nvPicPr>
            <p:cNvPr id="33" name="Graphic 98" descr="Lightbulb and gear outline">
              <a:extLst>
                <a:ext uri="{FF2B5EF4-FFF2-40B4-BE49-F238E27FC236}">
                  <a16:creationId xmlns:a16="http://schemas.microsoft.com/office/drawing/2014/main" id="{D4A15A9E-6EA8-4318-82AE-67F9937FEED2}"/>
                </a:ext>
              </a:extLst>
            </p:cNvPr>
            <p:cNvPicPr>
              <a:picLocks noChangeAspect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  <a:ext uri="{96DAC541-7B7A-43D3-8B79-37D633B846F1}">
                  <asvg:svgBlip xmlns:asvg="http://schemas.microsoft.com/office/drawing/2016/SVG/main" r:embed="rId6"/>
                </a:ext>
              </a:extLst>
            </a:blip>
            <a:stretch>
              <a:fillRect/>
            </a:stretch>
          </p:blipFill>
          <p:spPr>
            <a:xfrm>
              <a:off x="4537283" y="2389871"/>
              <a:ext cx="553049" cy="550324"/>
            </a:xfrm>
            <a:prstGeom prst="rect">
              <a:avLst/>
            </a:prstGeom>
          </p:spPr>
        </p:pic>
        <p:pic>
          <p:nvPicPr>
            <p:cNvPr id="34" name="Graphic 71" descr="Clipboard Mixed outline">
              <a:extLst>
                <a:ext uri="{FF2B5EF4-FFF2-40B4-BE49-F238E27FC236}">
                  <a16:creationId xmlns:a16="http://schemas.microsoft.com/office/drawing/2014/main" id="{0280CAAE-46CC-4139-BCEE-B985B31875EB}"/>
                </a:ext>
              </a:extLst>
            </p:cNvPr>
            <p:cNvPicPr>
              <a:picLocks noChangeAspect="1"/>
            </p:cNvPicPr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  <a:ext uri="{96DAC541-7B7A-43D3-8B79-37D633B846F1}">
                  <asvg:svgBlip xmlns:asvg="http://schemas.microsoft.com/office/drawing/2016/SVG/main" r:embed="rId8"/>
                </a:ext>
              </a:extLst>
            </a:blip>
            <a:stretch>
              <a:fillRect/>
            </a:stretch>
          </p:blipFill>
          <p:spPr>
            <a:xfrm>
              <a:off x="5694138" y="2789617"/>
              <a:ext cx="608354" cy="605356"/>
            </a:xfrm>
            <a:prstGeom prst="rect">
              <a:avLst/>
            </a:prstGeom>
          </p:spPr>
        </p:pic>
        <p:pic>
          <p:nvPicPr>
            <p:cNvPr id="35" name="Graphic 82" descr="Users outline">
              <a:extLst>
                <a:ext uri="{FF2B5EF4-FFF2-40B4-BE49-F238E27FC236}">
                  <a16:creationId xmlns:a16="http://schemas.microsoft.com/office/drawing/2014/main" id="{CA261C94-1198-486B-A2AF-1029F24F2EF8}"/>
                </a:ext>
              </a:extLst>
            </p:cNvPr>
            <p:cNvPicPr>
              <a:picLocks noChangeAspect="1"/>
            </p:cNvPicPr>
            <p:nvPr/>
          </p:nvPicPr>
          <p:blipFill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  <a:ext uri="{96DAC541-7B7A-43D3-8B79-37D633B846F1}">
                  <asvg:svgBlip xmlns:asvg="http://schemas.microsoft.com/office/drawing/2016/SVG/main" r:embed="rId10"/>
                </a:ext>
              </a:extLst>
            </a:blip>
            <a:stretch>
              <a:fillRect/>
            </a:stretch>
          </p:blipFill>
          <p:spPr>
            <a:xfrm>
              <a:off x="5718807" y="3286202"/>
              <a:ext cx="553785" cy="551056"/>
            </a:xfrm>
            <a:prstGeom prst="rect">
              <a:avLst/>
            </a:prstGeom>
          </p:spPr>
        </p:pic>
        <p:pic>
          <p:nvPicPr>
            <p:cNvPr id="36" name="Graphic 4" descr="Flowchart outline">
              <a:extLst>
                <a:ext uri="{FF2B5EF4-FFF2-40B4-BE49-F238E27FC236}">
                  <a16:creationId xmlns:a16="http://schemas.microsoft.com/office/drawing/2014/main" id="{7DCFB05E-618A-45E6-8DF6-1A9E3F21721A}"/>
                </a:ext>
              </a:extLst>
            </p:cNvPr>
            <p:cNvPicPr>
              <a:picLocks noChangeAspect="1"/>
            </p:cNvPicPr>
            <p:nvPr/>
          </p:nvPicPr>
          <p:blipFill>
            <a:blip r:embed="rId11">
              <a:extLst>
                <a:ext uri="{28A0092B-C50C-407E-A947-70E740481C1C}">
                  <a14:useLocalDpi xmlns:a14="http://schemas.microsoft.com/office/drawing/2010/main" val="0"/>
                </a:ext>
                <a:ext uri="{96DAC541-7B7A-43D3-8B79-37D633B846F1}">
                  <asvg:svgBlip xmlns:asvg="http://schemas.microsoft.com/office/drawing/2016/SVG/main" r:embed="rId12"/>
                </a:ext>
              </a:extLst>
            </a:blip>
            <a:stretch>
              <a:fillRect/>
            </a:stretch>
          </p:blipFill>
          <p:spPr>
            <a:xfrm>
              <a:off x="5117982" y="939809"/>
              <a:ext cx="553049" cy="550324"/>
            </a:xfrm>
            <a:prstGeom prst="rect">
              <a:avLst/>
            </a:prstGeom>
          </p:spPr>
        </p:pic>
        <p:pic>
          <p:nvPicPr>
            <p:cNvPr id="37" name="Graphic 112" descr="List outline">
              <a:extLst>
                <a:ext uri="{FF2B5EF4-FFF2-40B4-BE49-F238E27FC236}">
                  <a16:creationId xmlns:a16="http://schemas.microsoft.com/office/drawing/2014/main" id="{BD64A06E-2B4F-404F-8FF6-2D802FAF9448}"/>
                </a:ext>
              </a:extLst>
            </p:cNvPr>
            <p:cNvPicPr>
              <a:picLocks noChangeAspect="1"/>
            </p:cNvPicPr>
            <p:nvPr/>
          </p:nvPicPr>
          <p:blipFill>
            <a:blip r:embed="rId13" cstate="print">
              <a:extLst>
                <a:ext uri="{28A0092B-C50C-407E-A947-70E740481C1C}">
                  <a14:useLocalDpi xmlns:a14="http://schemas.microsoft.com/office/drawing/2010/main" val="0"/>
                </a:ext>
                <a:ext uri="{96DAC541-7B7A-43D3-8B79-37D633B846F1}">
                  <asvg:svgBlip xmlns:asvg="http://schemas.microsoft.com/office/drawing/2016/SVG/main" r:embed="rId14"/>
                </a:ext>
              </a:extLst>
            </a:blip>
            <a:stretch>
              <a:fillRect/>
            </a:stretch>
          </p:blipFill>
          <p:spPr>
            <a:xfrm>
              <a:off x="7321124" y="3432995"/>
              <a:ext cx="442439" cy="440259"/>
            </a:xfrm>
            <a:prstGeom prst="rect">
              <a:avLst/>
            </a:prstGeom>
          </p:spPr>
        </p:pic>
        <p:pic>
          <p:nvPicPr>
            <p:cNvPr id="38" name="Graphic 111" descr="Table outline">
              <a:extLst>
                <a:ext uri="{FF2B5EF4-FFF2-40B4-BE49-F238E27FC236}">
                  <a16:creationId xmlns:a16="http://schemas.microsoft.com/office/drawing/2014/main" id="{73225B75-7AEA-4A06-9727-D888CBA48A2D}"/>
                </a:ext>
              </a:extLst>
            </p:cNvPr>
            <p:cNvPicPr>
              <a:picLocks noChangeAspect="1"/>
            </p:cNvPicPr>
            <p:nvPr/>
          </p:nvPicPr>
          <p:blipFill>
            <a:blip r:embed="rId15">
              <a:extLst>
                <a:ext uri="{28A0092B-C50C-407E-A947-70E740481C1C}">
                  <a14:useLocalDpi xmlns:a14="http://schemas.microsoft.com/office/drawing/2010/main" val="0"/>
                </a:ext>
                <a:ext uri="{96DAC541-7B7A-43D3-8B79-37D633B846F1}">
                  <asvg:svgBlip xmlns:asvg="http://schemas.microsoft.com/office/drawing/2016/SVG/main" r:embed="rId16"/>
                </a:ext>
              </a:extLst>
            </a:blip>
            <a:stretch>
              <a:fillRect/>
            </a:stretch>
          </p:blipFill>
          <p:spPr>
            <a:xfrm>
              <a:off x="7300285" y="3767453"/>
              <a:ext cx="509490" cy="495292"/>
            </a:xfrm>
            <a:prstGeom prst="rect">
              <a:avLst/>
            </a:prstGeom>
          </p:spPr>
        </p:pic>
        <p:pic>
          <p:nvPicPr>
            <p:cNvPr id="39" name="Graphic 79" descr="Document outline">
              <a:extLst>
                <a:ext uri="{FF2B5EF4-FFF2-40B4-BE49-F238E27FC236}">
                  <a16:creationId xmlns:a16="http://schemas.microsoft.com/office/drawing/2014/main" id="{CB6CF0B6-E520-43ED-9DF7-30584190B683}"/>
                </a:ext>
              </a:extLst>
            </p:cNvPr>
            <p:cNvPicPr>
              <a:picLocks noChangeAspect="1"/>
            </p:cNvPicPr>
            <p:nvPr/>
          </p:nvPicPr>
          <p:blipFill>
            <a:blip r:embed="rId17">
              <a:extLst>
                <a:ext uri="{28A0092B-C50C-407E-A947-70E740481C1C}">
                  <a14:useLocalDpi xmlns:a14="http://schemas.microsoft.com/office/drawing/2010/main" val="0"/>
                </a:ext>
                <a:ext uri="{96DAC541-7B7A-43D3-8B79-37D633B846F1}">
                  <asvg:svgBlip xmlns:asvg="http://schemas.microsoft.com/office/drawing/2016/SVG/main" r:embed="rId18"/>
                </a:ext>
              </a:extLst>
            </a:blip>
            <a:stretch>
              <a:fillRect/>
            </a:stretch>
          </p:blipFill>
          <p:spPr>
            <a:xfrm>
              <a:off x="7965281" y="950697"/>
              <a:ext cx="553049" cy="550324"/>
            </a:xfrm>
            <a:prstGeom prst="rect">
              <a:avLst/>
            </a:prstGeom>
          </p:spPr>
        </p:pic>
        <p:pic>
          <p:nvPicPr>
            <p:cNvPr id="40" name="Graphic 127" descr="Management outline">
              <a:extLst>
                <a:ext uri="{FF2B5EF4-FFF2-40B4-BE49-F238E27FC236}">
                  <a16:creationId xmlns:a16="http://schemas.microsoft.com/office/drawing/2014/main" id="{AD41426A-B97E-4F4B-9CCC-5D2A47B63F86}"/>
                </a:ext>
              </a:extLst>
            </p:cNvPr>
            <p:cNvPicPr>
              <a:picLocks noChangeAspect="1"/>
            </p:cNvPicPr>
            <p:nvPr/>
          </p:nvPicPr>
          <p:blipFill>
            <a:blip r:embed="rId19">
              <a:extLst>
                <a:ext uri="{28A0092B-C50C-407E-A947-70E740481C1C}">
                  <a14:useLocalDpi xmlns:a14="http://schemas.microsoft.com/office/drawing/2010/main" val="0"/>
                </a:ext>
                <a:ext uri="{96DAC541-7B7A-43D3-8B79-37D633B846F1}">
                  <asvg:svgBlip xmlns:asvg="http://schemas.microsoft.com/office/drawing/2016/SVG/main" r:embed="rId20"/>
                </a:ext>
              </a:extLst>
            </a:blip>
            <a:stretch>
              <a:fillRect/>
            </a:stretch>
          </p:blipFill>
          <p:spPr>
            <a:xfrm>
              <a:off x="9644526" y="2338979"/>
              <a:ext cx="617069" cy="614029"/>
            </a:xfrm>
            <a:prstGeom prst="rect">
              <a:avLst/>
            </a:prstGeom>
          </p:spPr>
        </p:pic>
        <p:cxnSp>
          <p:nvCxnSpPr>
            <p:cNvPr id="41" name="Gerade Verbindung 89">
              <a:extLst>
                <a:ext uri="{FF2B5EF4-FFF2-40B4-BE49-F238E27FC236}">
                  <a16:creationId xmlns:a16="http://schemas.microsoft.com/office/drawing/2014/main" id="{579F146D-0FA2-4F89-BF5E-936BDB866DE1}"/>
                </a:ext>
              </a:extLst>
            </p:cNvPr>
            <p:cNvCxnSpPr/>
            <p:nvPr/>
          </p:nvCxnSpPr>
          <p:spPr>
            <a:xfrm>
              <a:off x="8469475" y="2052179"/>
              <a:ext cx="0" cy="195003"/>
            </a:xfrm>
            <a:prstGeom prst="line">
              <a:avLst/>
            </a:prstGeom>
            <a:ln w="254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2" name="Abgerundetes Rechteck 90">
              <a:extLst>
                <a:ext uri="{FF2B5EF4-FFF2-40B4-BE49-F238E27FC236}">
                  <a16:creationId xmlns:a16="http://schemas.microsoft.com/office/drawing/2014/main" id="{62159B03-6E8C-426A-A8DF-D85BA608AE44}"/>
                </a:ext>
              </a:extLst>
            </p:cNvPr>
            <p:cNvSpPr/>
            <p:nvPr/>
          </p:nvSpPr>
          <p:spPr>
            <a:xfrm>
              <a:off x="8025242" y="2242900"/>
              <a:ext cx="1550529" cy="540000"/>
            </a:xfrm>
            <a:prstGeom prst="round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r>
                <a:rPr lang="de-DE" sz="13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calar and </a:t>
              </a:r>
              <a:r>
                <a:rPr lang="de-DE" sz="1300" dirty="0" err="1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risk</a:t>
              </a:r>
              <a:r>
                <a:rPr lang="de-DE" sz="13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de-DE" sz="1300" dirty="0" err="1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matrix</a:t>
              </a:r>
              <a:r>
                <a:rPr lang="de-DE" sz="13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de-DE" sz="1300" dirty="0" err="1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judgments</a:t>
              </a:r>
              <a:endParaRPr lang="de-DE" sz="13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43" name="Gerade Verbindung 91">
              <a:extLst>
                <a:ext uri="{FF2B5EF4-FFF2-40B4-BE49-F238E27FC236}">
                  <a16:creationId xmlns:a16="http://schemas.microsoft.com/office/drawing/2014/main" id="{B366AA2E-E990-4B98-B9EE-3311199E81D8}"/>
                </a:ext>
              </a:extLst>
            </p:cNvPr>
            <p:cNvCxnSpPr/>
            <p:nvPr/>
          </p:nvCxnSpPr>
          <p:spPr>
            <a:xfrm>
              <a:off x="9264823" y="2750556"/>
              <a:ext cx="0" cy="195003"/>
            </a:xfrm>
            <a:prstGeom prst="line">
              <a:avLst/>
            </a:prstGeom>
            <a:ln w="254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44" name="Picture 122">
              <a:extLst>
                <a:ext uri="{FF2B5EF4-FFF2-40B4-BE49-F238E27FC236}">
                  <a16:creationId xmlns:a16="http://schemas.microsoft.com/office/drawing/2014/main" id="{4C17FC7C-41F5-440F-B1EF-D642ACAC4B6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1"/>
            <a:srcRect l="77435" t="66071" r="16107" b="23493"/>
            <a:stretch/>
          </p:blipFill>
          <p:spPr>
            <a:xfrm>
              <a:off x="8663163" y="2847627"/>
              <a:ext cx="137254" cy="143084"/>
            </a:xfrm>
            <a:prstGeom prst="rect">
              <a:avLst/>
            </a:prstGeom>
            <a:effectLst/>
          </p:spPr>
        </p:pic>
        <p:pic>
          <p:nvPicPr>
            <p:cNvPr id="45" name="Picture 123">
              <a:extLst>
                <a:ext uri="{FF2B5EF4-FFF2-40B4-BE49-F238E27FC236}">
                  <a16:creationId xmlns:a16="http://schemas.microsoft.com/office/drawing/2014/main" id="{396B9182-BAB7-409F-9AAD-1BA7B6584A5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1"/>
            <a:srcRect l="45843" t="68806" r="48398" b="23312"/>
            <a:stretch/>
          </p:blipFill>
          <p:spPr>
            <a:xfrm>
              <a:off x="8463273" y="2861915"/>
              <a:ext cx="162046" cy="143084"/>
            </a:xfrm>
            <a:prstGeom prst="rect">
              <a:avLst/>
            </a:prstGeom>
            <a:effectLst/>
          </p:spPr>
        </p:pic>
        <p:pic>
          <p:nvPicPr>
            <p:cNvPr id="46" name="Picture 124">
              <a:extLst>
                <a:ext uri="{FF2B5EF4-FFF2-40B4-BE49-F238E27FC236}">
                  <a16:creationId xmlns:a16="http://schemas.microsoft.com/office/drawing/2014/main" id="{F5A8AEE0-6C30-4E4F-8881-9C8901949E3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1"/>
            <a:srcRect l="14582" t="66824" r="78530" b="23944"/>
            <a:stretch/>
          </p:blipFill>
          <p:spPr>
            <a:xfrm>
              <a:off x="8423141" y="2847627"/>
              <a:ext cx="165443" cy="143084"/>
            </a:xfrm>
            <a:prstGeom prst="rect">
              <a:avLst/>
            </a:prstGeom>
            <a:effectLst/>
          </p:spPr>
        </p:pic>
        <p:pic>
          <p:nvPicPr>
            <p:cNvPr id="47" name="Graphic 79" descr="Document outline">
              <a:extLst>
                <a:ext uri="{FF2B5EF4-FFF2-40B4-BE49-F238E27FC236}">
                  <a16:creationId xmlns:a16="http://schemas.microsoft.com/office/drawing/2014/main" id="{607075B1-1ED1-44A0-B034-8710615774FD}"/>
                </a:ext>
              </a:extLst>
            </p:cNvPr>
            <p:cNvPicPr>
              <a:picLocks noChangeAspect="1"/>
            </p:cNvPicPr>
            <p:nvPr/>
          </p:nvPicPr>
          <p:blipFill>
            <a:blip r:embed="rId17">
              <a:extLst>
                <a:ext uri="{28A0092B-C50C-407E-A947-70E740481C1C}">
                  <a14:useLocalDpi xmlns:a14="http://schemas.microsoft.com/office/drawing/2010/main" val="0"/>
                </a:ext>
                <a:ext uri="{96DAC541-7B7A-43D3-8B79-37D633B846F1}">
                  <asvg:svgBlip xmlns:asvg="http://schemas.microsoft.com/office/drawing/2016/SVG/main" r:embed="rId18"/>
                </a:ext>
              </a:extLst>
            </a:blip>
            <a:stretch>
              <a:fillRect/>
            </a:stretch>
          </p:blipFill>
          <p:spPr>
            <a:xfrm>
              <a:off x="10179644" y="962230"/>
              <a:ext cx="553049" cy="550324"/>
            </a:xfrm>
            <a:prstGeom prst="rect">
              <a:avLst/>
            </a:prstGeom>
          </p:spPr>
        </p:pic>
        <p:pic>
          <p:nvPicPr>
            <p:cNvPr id="48" name="Graphic 82" descr="Users outline">
              <a:extLst>
                <a:ext uri="{FF2B5EF4-FFF2-40B4-BE49-F238E27FC236}">
                  <a16:creationId xmlns:a16="http://schemas.microsoft.com/office/drawing/2014/main" id="{A37E75AA-E8F5-46C4-9151-E0461359CE86}"/>
                </a:ext>
              </a:extLst>
            </p:cNvPr>
            <p:cNvPicPr>
              <a:picLocks noChangeAspect="1"/>
            </p:cNvPicPr>
            <p:nvPr/>
          </p:nvPicPr>
          <p:blipFill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  <a:ext uri="{96DAC541-7B7A-43D3-8B79-37D633B846F1}">
                  <asvg:svgBlip xmlns:asvg="http://schemas.microsoft.com/office/drawing/2016/SVG/main" r:embed="rId10"/>
                </a:ext>
              </a:extLst>
            </a:blip>
            <a:stretch>
              <a:fillRect/>
            </a:stretch>
          </p:blipFill>
          <p:spPr>
            <a:xfrm>
              <a:off x="8350480" y="2895687"/>
              <a:ext cx="553785" cy="551056"/>
            </a:xfrm>
            <a:prstGeom prst="rect">
              <a:avLst/>
            </a:prstGeom>
          </p:spPr>
        </p:pic>
        <p:cxnSp>
          <p:nvCxnSpPr>
            <p:cNvPr id="49" name="Gerade Verbindung 80">
              <a:extLst>
                <a:ext uri="{FF2B5EF4-FFF2-40B4-BE49-F238E27FC236}">
                  <a16:creationId xmlns:a16="http://schemas.microsoft.com/office/drawing/2014/main" id="{F8DC0330-C716-49AB-9228-3F211952BF03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5215864" y="2062243"/>
              <a:ext cx="0" cy="875440"/>
            </a:xfrm>
            <a:prstGeom prst="line">
              <a:avLst/>
            </a:prstGeom>
            <a:ln w="254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165684878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" name="Gruppieren 5">
            <a:extLst>
              <a:ext uri="{FF2B5EF4-FFF2-40B4-BE49-F238E27FC236}">
                <a16:creationId xmlns:a16="http://schemas.microsoft.com/office/drawing/2014/main" id="{778CBA6E-0129-16E3-48AD-F47BB0FD2AAA}"/>
              </a:ext>
            </a:extLst>
          </p:cNvPr>
          <p:cNvGrpSpPr/>
          <p:nvPr/>
        </p:nvGrpSpPr>
        <p:grpSpPr>
          <a:xfrm>
            <a:off x="541516" y="562807"/>
            <a:ext cx="11126754" cy="6079938"/>
            <a:chOff x="541516" y="562807"/>
            <a:chExt cx="11126754" cy="6079938"/>
          </a:xfrm>
        </p:grpSpPr>
        <p:sp>
          <p:nvSpPr>
            <p:cNvPr id="2" name="Textfeld 1">
              <a:extLst>
                <a:ext uri="{FF2B5EF4-FFF2-40B4-BE49-F238E27FC236}">
                  <a16:creationId xmlns:a16="http://schemas.microsoft.com/office/drawing/2014/main" id="{651A26A8-7EF8-4EEC-BE85-52F0D18DEDCA}"/>
                </a:ext>
              </a:extLst>
            </p:cNvPr>
            <p:cNvSpPr txBox="1"/>
            <p:nvPr/>
          </p:nvSpPr>
          <p:spPr>
            <a:xfrm>
              <a:off x="6171418" y="1589600"/>
              <a:ext cx="2674188" cy="1569660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wrap="square" rtlCol="0" anchor="ctr">
              <a:spAutoFit/>
            </a:bodyPr>
            <a:lstStyle/>
            <a:p>
              <a:pPr marL="285750" indent="-285750">
                <a:buFont typeface="Arial" panose="020B0604020202020204" pitchFamily="34" charset="0"/>
                <a:buChar char="•"/>
              </a:pPr>
              <a:r>
                <a:rPr lang="de-DE" sz="16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Concerning</a:t>
              </a:r>
              <a:r>
                <a:rPr lang="de-DE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, but low risk to trigger hesistancy to health-promoting behavior</a:t>
              </a:r>
            </a:p>
            <a:p>
              <a:pPr marL="285750" indent="-285750">
                <a:buFont typeface="Arial" panose="020B0604020202020204" pitchFamily="34" charset="0"/>
                <a:buChar char="•"/>
              </a:pPr>
              <a:r>
                <a:rPr lang="de-DE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imited reach</a:t>
              </a:r>
            </a:p>
            <a:p>
              <a:pPr marL="285750" indent="-285750">
                <a:buFont typeface="Arial" panose="020B0604020202020204" pitchFamily="34" charset="0"/>
                <a:buChar char="•"/>
              </a:pPr>
              <a:r>
                <a:rPr lang="de-DE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imited dissemination</a:t>
              </a:r>
            </a:p>
            <a:p>
              <a:pPr marL="285750" indent="-285750">
                <a:buFont typeface="Arial" panose="020B0604020202020204" pitchFamily="34" charset="0"/>
                <a:buChar char="•"/>
              </a:pPr>
              <a:endParaRPr lang="de-DE" sz="16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" name="Textfeld 2">
              <a:extLst>
                <a:ext uri="{FF2B5EF4-FFF2-40B4-BE49-F238E27FC236}">
                  <a16:creationId xmlns:a16="http://schemas.microsoft.com/office/drawing/2014/main" id="{82325029-FE45-4B63-80D9-CE631784A01E}"/>
                </a:ext>
              </a:extLst>
            </p:cNvPr>
            <p:cNvSpPr txBox="1"/>
            <p:nvPr/>
          </p:nvSpPr>
          <p:spPr>
            <a:xfrm>
              <a:off x="3346396" y="1594265"/>
              <a:ext cx="2674188" cy="1569660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19050">
              <a:solidFill>
                <a:schemeClr val="tx1"/>
              </a:solidFill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wrap="square" rtlCol="0" anchor="ctr">
              <a:spAutoFit/>
            </a:bodyPr>
            <a:lstStyle/>
            <a:p>
              <a:pPr marL="285750" indent="-285750">
                <a:buFont typeface="Arial" panose="020B0604020202020204" pitchFamily="34" charset="0"/>
                <a:buChar char="•"/>
              </a:pPr>
              <a:r>
                <a:rPr lang="de-DE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an trigger hesistancy to health-promoting behaviors</a:t>
              </a:r>
            </a:p>
            <a:p>
              <a:pPr marL="285750" indent="-285750">
                <a:buFont typeface="Arial" panose="020B0604020202020204" pitchFamily="34" charset="0"/>
                <a:buChar char="•"/>
              </a:pPr>
              <a:r>
                <a:rPr lang="de-DE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oderate reach</a:t>
              </a:r>
            </a:p>
            <a:p>
              <a:pPr marL="285750" indent="-285750">
                <a:buFont typeface="Arial" panose="020B0604020202020204" pitchFamily="34" charset="0"/>
                <a:buChar char="•"/>
              </a:pPr>
              <a:r>
                <a:rPr lang="de-DE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odest dissemination</a:t>
              </a:r>
            </a:p>
            <a:p>
              <a:pPr marL="285750" indent="-285750">
                <a:buFont typeface="Arial" panose="020B0604020202020204" pitchFamily="34" charset="0"/>
                <a:buChar char="•"/>
              </a:pPr>
              <a:endParaRPr lang="de-DE" sz="16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" name="Textfeld 3">
              <a:extLst>
                <a:ext uri="{FF2B5EF4-FFF2-40B4-BE49-F238E27FC236}">
                  <a16:creationId xmlns:a16="http://schemas.microsoft.com/office/drawing/2014/main" id="{3EB6B366-D965-4246-9E7B-E021EDB2AE22}"/>
                </a:ext>
              </a:extLst>
            </p:cNvPr>
            <p:cNvSpPr txBox="1"/>
            <p:nvPr/>
          </p:nvSpPr>
          <p:spPr>
            <a:xfrm>
              <a:off x="541516" y="1589600"/>
              <a:ext cx="2679628" cy="1569660"/>
            </a:xfrm>
            <a:prstGeom prst="rect">
              <a:avLst/>
            </a:prstGeom>
            <a:solidFill>
              <a:schemeClr val="bg2">
                <a:lumMod val="75000"/>
              </a:schemeClr>
            </a:solidFill>
            <a:ln w="19050">
              <a:solidFill>
                <a:schemeClr val="tx1"/>
              </a:solidFill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wrap="square" rtlCol="0" anchor="ctr">
              <a:spAutoFit/>
            </a:bodyPr>
            <a:lstStyle/>
            <a:p>
              <a:pPr marL="285750" indent="-285750">
                <a:buFont typeface="Arial" panose="020B0604020202020204" pitchFamily="34" charset="0"/>
                <a:buChar char="•"/>
              </a:pPr>
              <a:r>
                <a:rPr lang="de-DE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ay lower health-promoting behaviors</a:t>
              </a:r>
            </a:p>
            <a:p>
              <a:pPr marL="285750" indent="-285750">
                <a:buFont typeface="Arial" panose="020B0604020202020204" pitchFamily="34" charset="0"/>
                <a:buChar char="•"/>
              </a:pPr>
              <a:r>
                <a:rPr lang="de-DE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Wide reach</a:t>
              </a:r>
            </a:p>
            <a:p>
              <a:pPr marL="285750" indent="-285750">
                <a:buFont typeface="Arial" panose="020B0604020202020204" pitchFamily="34" charset="0"/>
                <a:buChar char="•"/>
              </a:pPr>
              <a:r>
                <a:rPr lang="de-DE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ervasive</a:t>
              </a:r>
            </a:p>
            <a:p>
              <a:pPr marL="285750" indent="-285750">
                <a:buFont typeface="Arial" panose="020B0604020202020204" pitchFamily="34" charset="0"/>
                <a:buChar char="•"/>
              </a:pPr>
              <a:endParaRPr lang="de-DE" sz="16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marL="285750" indent="-285750">
                <a:buFont typeface="Arial" panose="020B0604020202020204" pitchFamily="34" charset="0"/>
                <a:buChar char="•"/>
              </a:pPr>
              <a:endParaRPr lang="de-DE" sz="16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" name="Rechteck 4">
              <a:extLst>
                <a:ext uri="{FF2B5EF4-FFF2-40B4-BE49-F238E27FC236}">
                  <a16:creationId xmlns:a16="http://schemas.microsoft.com/office/drawing/2014/main" id="{A9A3E9AC-0B84-4152-A0C2-C76A6AFEBEF1}"/>
                </a:ext>
              </a:extLst>
            </p:cNvPr>
            <p:cNvSpPr/>
            <p:nvPr/>
          </p:nvSpPr>
          <p:spPr>
            <a:xfrm>
              <a:off x="4973405" y="2924431"/>
              <a:ext cx="857839" cy="792877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12700">
              <a:solidFill>
                <a:schemeClr val="tx1">
                  <a:lumMod val="75000"/>
                  <a:lumOff val="25000"/>
                </a:schemeClr>
              </a:solidFill>
            </a:ln>
            <a:effectLst>
              <a:outerShdw blurRad="50800" dist="38100" dir="2700000" algn="tl" rotWithShape="0">
                <a:prstClr val="black">
                  <a:alpha val="40000"/>
                </a:prstClr>
              </a:outerShdw>
            </a:effec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" name="Textfeld 6">
              <a:extLst>
                <a:ext uri="{FF2B5EF4-FFF2-40B4-BE49-F238E27FC236}">
                  <a16:creationId xmlns:a16="http://schemas.microsoft.com/office/drawing/2014/main" id="{D547EB61-89AA-4DB0-BC2C-0654AA9A2DB0}"/>
                </a:ext>
              </a:extLst>
            </p:cNvPr>
            <p:cNvSpPr txBox="1"/>
            <p:nvPr/>
          </p:nvSpPr>
          <p:spPr>
            <a:xfrm>
              <a:off x="8970858" y="1589600"/>
              <a:ext cx="2674188" cy="1569660"/>
            </a:xfrm>
            <a:prstGeom prst="rect">
              <a:avLst/>
            </a:prstGeom>
            <a:solidFill>
              <a:schemeClr val="bg2">
                <a:lumMod val="25000"/>
              </a:schemeClr>
            </a:solidFill>
            <a:ln w="19050">
              <a:solidFill>
                <a:schemeClr val="tx1"/>
              </a:solidFill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wrap="square" rtlCol="0" anchor="ctr">
              <a:spAutoFit/>
            </a:bodyPr>
            <a:lstStyle/>
            <a:p>
              <a:pPr marL="285750" indent="-285750">
                <a:buFont typeface="Arial" panose="020B0604020202020204" pitchFamily="34" charset="0"/>
                <a:buChar char="•"/>
              </a:pPr>
              <a:r>
                <a:rPr lang="de-DE" sz="1600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Neutral or may increase health-promoting behaviors</a:t>
              </a:r>
            </a:p>
            <a:p>
              <a:pPr marL="285750" indent="-285750">
                <a:buFont typeface="Arial" panose="020B0604020202020204" pitchFamily="34" charset="0"/>
                <a:buChar char="•"/>
              </a:pPr>
              <a:r>
                <a:rPr lang="de-DE" sz="1600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Variable reach</a:t>
              </a:r>
            </a:p>
            <a:p>
              <a:pPr marL="285750" indent="-285750">
                <a:buFont typeface="Arial" panose="020B0604020202020204" pitchFamily="34" charset="0"/>
                <a:buChar char="•"/>
              </a:pPr>
              <a:r>
                <a:rPr lang="de-DE" sz="1600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Variable dissemination</a:t>
              </a:r>
            </a:p>
            <a:p>
              <a:pPr marL="285750" indent="-285750">
                <a:buFont typeface="Arial" panose="020B0604020202020204" pitchFamily="34" charset="0"/>
                <a:buChar char="•"/>
              </a:pPr>
              <a:endParaRPr lang="de-DE" sz="16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" name="Textfeld 7">
              <a:extLst>
                <a:ext uri="{FF2B5EF4-FFF2-40B4-BE49-F238E27FC236}">
                  <a16:creationId xmlns:a16="http://schemas.microsoft.com/office/drawing/2014/main" id="{EB3125F6-6B73-49D7-981A-C8263E2228C1}"/>
                </a:ext>
              </a:extLst>
            </p:cNvPr>
            <p:cNvSpPr txBox="1"/>
            <p:nvPr/>
          </p:nvSpPr>
          <p:spPr>
            <a:xfrm>
              <a:off x="541516" y="562807"/>
              <a:ext cx="11119444" cy="400110"/>
            </a:xfrm>
            <a:prstGeom prst="rect">
              <a:avLst/>
            </a:prstGeom>
            <a:noFill/>
            <a:ln w="69850" cmpd="dbl">
              <a:solidFill>
                <a:schemeClr val="tx1"/>
              </a:solidFill>
              <a:prstDash val="solid"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2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ow do you classify the information/theme?</a:t>
              </a:r>
            </a:p>
          </p:txBody>
        </p:sp>
        <p:sp>
          <p:nvSpPr>
            <p:cNvPr id="9" name="Textfeld 8">
              <a:extLst>
                <a:ext uri="{FF2B5EF4-FFF2-40B4-BE49-F238E27FC236}">
                  <a16:creationId xmlns:a16="http://schemas.microsoft.com/office/drawing/2014/main" id="{C04483CD-E168-49DF-8BBD-4485A7513715}"/>
                </a:ext>
              </a:extLst>
            </p:cNvPr>
            <p:cNvSpPr txBox="1"/>
            <p:nvPr/>
          </p:nvSpPr>
          <p:spPr>
            <a:xfrm>
              <a:off x="541516" y="3886736"/>
              <a:ext cx="11126754" cy="400110"/>
            </a:xfrm>
            <a:prstGeom prst="rect">
              <a:avLst/>
            </a:prstGeom>
            <a:noFill/>
            <a:ln w="66675" cmpd="dbl">
              <a:solidFill>
                <a:schemeClr val="tx1"/>
              </a:solidFill>
              <a:prstDash val="solid"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2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ow has the theme changed over time (since last report or over the course of multiple reports)?</a:t>
              </a:r>
            </a:p>
          </p:txBody>
        </p:sp>
        <p:sp>
          <p:nvSpPr>
            <p:cNvPr id="11" name="Textfeld 10">
              <a:extLst>
                <a:ext uri="{FF2B5EF4-FFF2-40B4-BE49-F238E27FC236}">
                  <a16:creationId xmlns:a16="http://schemas.microsoft.com/office/drawing/2014/main" id="{D155F18D-E738-4877-B33E-F14D54AC85A2}"/>
                </a:ext>
              </a:extLst>
            </p:cNvPr>
            <p:cNvSpPr txBox="1"/>
            <p:nvPr/>
          </p:nvSpPr>
          <p:spPr>
            <a:xfrm>
              <a:off x="4278721" y="4969533"/>
              <a:ext cx="3634558" cy="830997"/>
            </a:xfrm>
            <a:prstGeom prst="rect">
              <a:avLst/>
            </a:prstGeom>
            <a:noFill/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wrap="square" rtlCol="0" anchor="ctr">
              <a:spAutoFit/>
            </a:bodyPr>
            <a:lstStyle/>
            <a:p>
              <a:pPr algn="ctr"/>
              <a:r>
                <a:rPr lang="de-DE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br>
                <a:rPr lang="de-DE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</a:br>
              <a:r>
                <a:rPr lang="de-DE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nformation </a:t>
              </a:r>
              <a:r>
                <a:rPr lang="de-DE" sz="16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remaining</a:t>
              </a:r>
              <a:r>
                <a:rPr lang="de-DE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onstant</a:t>
              </a:r>
              <a:r>
                <a:rPr lang="de-DE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br>
                <a:rPr lang="de-DE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</a:br>
              <a:r>
                <a:rPr lang="de-DE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t prior level</a:t>
              </a:r>
            </a:p>
            <a:p>
              <a:pPr algn="ctr"/>
              <a:endParaRPr lang="de-DE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" name="Textfeld 11">
              <a:extLst>
                <a:ext uri="{FF2B5EF4-FFF2-40B4-BE49-F238E27FC236}">
                  <a16:creationId xmlns:a16="http://schemas.microsoft.com/office/drawing/2014/main" id="{04A1C6B5-691C-4FEA-A721-0972D8101652}"/>
                </a:ext>
              </a:extLst>
            </p:cNvPr>
            <p:cNvSpPr txBox="1"/>
            <p:nvPr/>
          </p:nvSpPr>
          <p:spPr>
            <a:xfrm>
              <a:off x="8026402" y="4963116"/>
              <a:ext cx="3634558" cy="830997"/>
            </a:xfrm>
            <a:prstGeom prst="rect">
              <a:avLst/>
            </a:prstGeom>
            <a:noFill/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wrap="square" rtlCol="0" anchor="ctr">
              <a:spAutoFit/>
            </a:bodyPr>
            <a:lstStyle/>
            <a:p>
              <a:pPr algn="ctr"/>
              <a:r>
                <a:rPr lang="de-DE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nformation is not gaining further traction and there has been no indication of additional activity</a:t>
              </a:r>
            </a:p>
          </p:txBody>
        </p:sp>
        <p:sp>
          <p:nvSpPr>
            <p:cNvPr id="13" name="Textfeld 12">
              <a:extLst>
                <a:ext uri="{FF2B5EF4-FFF2-40B4-BE49-F238E27FC236}">
                  <a16:creationId xmlns:a16="http://schemas.microsoft.com/office/drawing/2014/main" id="{3177020F-B8A4-404E-9323-6401616EFFDE}"/>
                </a:ext>
              </a:extLst>
            </p:cNvPr>
            <p:cNvSpPr txBox="1"/>
            <p:nvPr/>
          </p:nvSpPr>
          <p:spPr>
            <a:xfrm>
              <a:off x="541516" y="1123738"/>
              <a:ext cx="2679628" cy="378748"/>
            </a:xfrm>
            <a:prstGeom prst="rect">
              <a:avLst/>
            </a:prstGeom>
            <a:solidFill>
              <a:schemeClr val="bg2">
                <a:lumMod val="75000"/>
              </a:schemeClr>
            </a:solidFill>
            <a:ln w="19050">
              <a:solidFill>
                <a:schemeClr val="tx1"/>
              </a:solidFill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wrap="square" rtlCol="0">
              <a:spAutoFit/>
            </a:bodyPr>
            <a:lstStyle/>
            <a:p>
              <a:pPr algn="ctr"/>
              <a:r>
                <a:rPr lang="de-DE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igh </a:t>
              </a:r>
              <a:r>
                <a:rPr lang="de-DE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risk</a:t>
              </a:r>
              <a:r>
                <a:rPr lang="de-DE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</a:p>
          </p:txBody>
        </p:sp>
        <p:sp>
          <p:nvSpPr>
            <p:cNvPr id="14" name="Textfeld 13">
              <a:extLst>
                <a:ext uri="{FF2B5EF4-FFF2-40B4-BE49-F238E27FC236}">
                  <a16:creationId xmlns:a16="http://schemas.microsoft.com/office/drawing/2014/main" id="{C2900DC5-5352-4F41-BD3D-0F4170595D64}"/>
                </a:ext>
              </a:extLst>
            </p:cNvPr>
            <p:cNvSpPr txBox="1"/>
            <p:nvPr/>
          </p:nvSpPr>
          <p:spPr>
            <a:xfrm>
              <a:off x="3346396" y="1133154"/>
              <a:ext cx="2674188" cy="369332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19050">
              <a:solidFill>
                <a:schemeClr val="tx1"/>
              </a:solidFill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wrap="square" rtlCol="0">
              <a:spAutoFit/>
            </a:bodyPr>
            <a:lstStyle/>
            <a:p>
              <a:pPr algn="ctr"/>
              <a:r>
                <a:rPr lang="de-DE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oderate </a:t>
              </a:r>
              <a:r>
                <a:rPr lang="de-DE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risk</a:t>
              </a:r>
              <a:endParaRPr lang="de-DE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" name="Textfeld 14">
              <a:extLst>
                <a:ext uri="{FF2B5EF4-FFF2-40B4-BE49-F238E27FC236}">
                  <a16:creationId xmlns:a16="http://schemas.microsoft.com/office/drawing/2014/main" id="{DC4CA053-B75D-4E11-A0A1-B9FCA4E5A0AD}"/>
                </a:ext>
              </a:extLst>
            </p:cNvPr>
            <p:cNvSpPr txBox="1"/>
            <p:nvPr/>
          </p:nvSpPr>
          <p:spPr>
            <a:xfrm>
              <a:off x="6155206" y="1125561"/>
              <a:ext cx="2674188" cy="369332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wrap="square" rtlCol="0">
              <a:spAutoFit/>
            </a:bodyPr>
            <a:lstStyle/>
            <a:p>
              <a:pPr algn="ctr"/>
              <a:r>
                <a:rPr lang="de-DE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ow </a:t>
              </a:r>
              <a:r>
                <a:rPr lang="de-DE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risk</a:t>
              </a:r>
              <a:endParaRPr lang="de-DE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" name="Textfeld 15">
              <a:extLst>
                <a:ext uri="{FF2B5EF4-FFF2-40B4-BE49-F238E27FC236}">
                  <a16:creationId xmlns:a16="http://schemas.microsoft.com/office/drawing/2014/main" id="{033B26B4-781B-46C6-88BC-0591A77F1D24}"/>
                </a:ext>
              </a:extLst>
            </p:cNvPr>
            <p:cNvSpPr txBox="1"/>
            <p:nvPr/>
          </p:nvSpPr>
          <p:spPr>
            <a:xfrm>
              <a:off x="8962746" y="1128299"/>
              <a:ext cx="2679628" cy="369332"/>
            </a:xfrm>
            <a:prstGeom prst="rect">
              <a:avLst/>
            </a:prstGeom>
            <a:solidFill>
              <a:schemeClr val="bg2">
                <a:lumMod val="25000"/>
              </a:schemeClr>
            </a:solidFill>
            <a:ln w="19050">
              <a:solidFill>
                <a:schemeClr val="tx1"/>
              </a:solidFill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wrap="square" rtlCol="0">
              <a:spAutoFit/>
            </a:bodyPr>
            <a:lstStyle/>
            <a:p>
              <a:pPr algn="ctr"/>
              <a:r>
                <a:rPr lang="de-DE" dirty="0" err="1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No</a:t>
              </a:r>
              <a:r>
                <a:rPr lang="de-DE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de-DE" dirty="0" err="1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risk</a:t>
              </a:r>
              <a:endParaRPr lang="de-DE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" name="Textfeld 17">
              <a:extLst>
                <a:ext uri="{FF2B5EF4-FFF2-40B4-BE49-F238E27FC236}">
                  <a16:creationId xmlns:a16="http://schemas.microsoft.com/office/drawing/2014/main" id="{776E6281-466B-4CD9-8020-700ACD2BFFB5}"/>
                </a:ext>
              </a:extLst>
            </p:cNvPr>
            <p:cNvSpPr txBox="1"/>
            <p:nvPr/>
          </p:nvSpPr>
          <p:spPr>
            <a:xfrm>
              <a:off x="4288470" y="4441886"/>
              <a:ext cx="3634559" cy="369332"/>
            </a:xfrm>
            <a:prstGeom prst="rect">
              <a:avLst/>
            </a:prstGeom>
            <a:noFill/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wrap="square" rtlCol="0">
              <a:spAutoFit/>
            </a:bodyPr>
            <a:lstStyle/>
            <a:p>
              <a:pPr algn="ctr"/>
              <a:r>
                <a:rPr lang="de-DE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table</a:t>
              </a:r>
            </a:p>
          </p:txBody>
        </p:sp>
        <p:sp>
          <p:nvSpPr>
            <p:cNvPr id="19" name="Textfeld 18">
              <a:extLst>
                <a:ext uri="{FF2B5EF4-FFF2-40B4-BE49-F238E27FC236}">
                  <a16:creationId xmlns:a16="http://schemas.microsoft.com/office/drawing/2014/main" id="{9EA29B3A-B1F4-4C3C-BBDC-08293C00B4F5}"/>
                </a:ext>
              </a:extLst>
            </p:cNvPr>
            <p:cNvSpPr txBox="1"/>
            <p:nvPr/>
          </p:nvSpPr>
          <p:spPr>
            <a:xfrm>
              <a:off x="8026404" y="4442644"/>
              <a:ext cx="3634556" cy="369332"/>
            </a:xfrm>
            <a:prstGeom prst="rect">
              <a:avLst/>
            </a:prstGeom>
            <a:noFill/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wrap="square" rtlCol="0">
              <a:spAutoFit/>
            </a:bodyPr>
            <a:lstStyle/>
            <a:p>
              <a:pPr algn="ctr"/>
              <a:r>
                <a:rPr lang="de-DE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ecreasing</a:t>
              </a:r>
            </a:p>
          </p:txBody>
        </p:sp>
        <p:cxnSp>
          <p:nvCxnSpPr>
            <p:cNvPr id="20" name="Gerader Verbinder 19">
              <a:extLst>
                <a:ext uri="{FF2B5EF4-FFF2-40B4-BE49-F238E27FC236}">
                  <a16:creationId xmlns:a16="http://schemas.microsoft.com/office/drawing/2014/main" id="{8C8364F0-7FB5-4DA1-94C8-70AE82DE27A5}"/>
                </a:ext>
              </a:extLst>
            </p:cNvPr>
            <p:cNvCxnSpPr>
              <a:cxnSpLocks/>
            </p:cNvCxnSpPr>
            <p:nvPr/>
          </p:nvCxnSpPr>
          <p:spPr>
            <a:xfrm>
              <a:off x="2254436" y="2933178"/>
              <a:ext cx="0" cy="556182"/>
            </a:xfrm>
            <a:prstGeom prst="line">
              <a:avLst/>
            </a:prstGeom>
            <a:ln w="571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" name="Gerader Verbinder 20">
              <a:extLst>
                <a:ext uri="{FF2B5EF4-FFF2-40B4-BE49-F238E27FC236}">
                  <a16:creationId xmlns:a16="http://schemas.microsoft.com/office/drawing/2014/main" id="{D9745944-0BE9-48E3-9CA1-15FA1F47CCEC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2256533" y="3461804"/>
              <a:ext cx="622692" cy="0"/>
            </a:xfrm>
            <a:prstGeom prst="line">
              <a:avLst/>
            </a:prstGeom>
            <a:ln w="571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" name="Gerader Verbinder 21">
              <a:extLst>
                <a:ext uri="{FF2B5EF4-FFF2-40B4-BE49-F238E27FC236}">
                  <a16:creationId xmlns:a16="http://schemas.microsoft.com/office/drawing/2014/main" id="{E87EC5FA-6D6C-4C74-B7DE-1D2BDE0B1003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5071842" y="3576961"/>
              <a:ext cx="660203" cy="1951"/>
            </a:xfrm>
            <a:prstGeom prst="line">
              <a:avLst/>
            </a:prstGeom>
            <a:ln w="571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4" name="Rechteck 23">
              <a:extLst>
                <a:ext uri="{FF2B5EF4-FFF2-40B4-BE49-F238E27FC236}">
                  <a16:creationId xmlns:a16="http://schemas.microsoft.com/office/drawing/2014/main" id="{9761A931-20AA-4DC7-A57A-75805550320A}"/>
                </a:ext>
              </a:extLst>
            </p:cNvPr>
            <p:cNvSpPr/>
            <p:nvPr/>
          </p:nvSpPr>
          <p:spPr>
            <a:xfrm>
              <a:off x="7772845" y="2932798"/>
              <a:ext cx="857839" cy="792877"/>
            </a:xfrm>
            <a:prstGeom prst="rect">
              <a:avLst/>
            </a:prstGeom>
            <a:solidFill>
              <a:schemeClr val="bg1"/>
            </a:solidFill>
            <a:ln w="12700">
              <a:solidFill>
                <a:schemeClr val="tx1"/>
              </a:solidFill>
            </a:ln>
            <a:effectLst>
              <a:outerShdw blurRad="50800" dist="38100" dir="2700000" algn="tl" rotWithShape="0">
                <a:prstClr val="black">
                  <a:alpha val="40000"/>
                </a:prstClr>
              </a:outerShdw>
            </a:effec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25" name="Gerader Verbinder 24">
              <a:extLst>
                <a:ext uri="{FF2B5EF4-FFF2-40B4-BE49-F238E27FC236}">
                  <a16:creationId xmlns:a16="http://schemas.microsoft.com/office/drawing/2014/main" id="{655B7996-2983-4EE6-B978-555EDE0790A5}"/>
                </a:ext>
              </a:extLst>
            </p:cNvPr>
            <p:cNvCxnSpPr>
              <a:cxnSpLocks/>
            </p:cNvCxnSpPr>
            <p:nvPr/>
          </p:nvCxnSpPr>
          <p:spPr>
            <a:xfrm>
              <a:off x="7914246" y="3047023"/>
              <a:ext cx="0" cy="556182"/>
            </a:xfrm>
            <a:prstGeom prst="line">
              <a:avLst/>
            </a:prstGeom>
            <a:ln w="571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" name="Gerader Verbinder 25">
              <a:extLst>
                <a:ext uri="{FF2B5EF4-FFF2-40B4-BE49-F238E27FC236}">
                  <a16:creationId xmlns:a16="http://schemas.microsoft.com/office/drawing/2014/main" id="{BEFC815A-2CB8-4213-B7ED-C13E102767DB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7894870" y="3585923"/>
              <a:ext cx="622692" cy="0"/>
            </a:xfrm>
            <a:prstGeom prst="line">
              <a:avLst/>
            </a:prstGeom>
            <a:ln w="571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7" name="Rechteck 26">
              <a:extLst>
                <a:ext uri="{FF2B5EF4-FFF2-40B4-BE49-F238E27FC236}">
                  <a16:creationId xmlns:a16="http://schemas.microsoft.com/office/drawing/2014/main" id="{EC0B6F34-D87E-49E1-8A46-D711971B2C25}"/>
                </a:ext>
              </a:extLst>
            </p:cNvPr>
            <p:cNvSpPr/>
            <p:nvPr/>
          </p:nvSpPr>
          <p:spPr>
            <a:xfrm>
              <a:off x="10597867" y="2924431"/>
              <a:ext cx="857839" cy="792877"/>
            </a:xfrm>
            <a:prstGeom prst="rect">
              <a:avLst/>
            </a:prstGeom>
            <a:solidFill>
              <a:schemeClr val="bg2">
                <a:lumMod val="25000"/>
              </a:schemeClr>
            </a:solidFill>
            <a:ln w="12700">
              <a:solidFill>
                <a:schemeClr val="tx1">
                  <a:lumMod val="75000"/>
                  <a:lumOff val="25000"/>
                </a:schemeClr>
              </a:solidFill>
            </a:ln>
            <a:effectLst>
              <a:outerShdw blurRad="50800" dist="38100" dir="2700000" algn="tl" rotWithShape="0">
                <a:prstClr val="black">
                  <a:alpha val="40000"/>
                </a:prstClr>
              </a:outerShdw>
            </a:effec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28" name="Gerader Verbinder 27">
              <a:extLst>
                <a:ext uri="{FF2B5EF4-FFF2-40B4-BE49-F238E27FC236}">
                  <a16:creationId xmlns:a16="http://schemas.microsoft.com/office/drawing/2014/main" id="{F13443F2-4F7A-4C98-AD95-B2462AAD9D96}"/>
                </a:ext>
              </a:extLst>
            </p:cNvPr>
            <p:cNvCxnSpPr>
              <a:cxnSpLocks/>
            </p:cNvCxnSpPr>
            <p:nvPr/>
          </p:nvCxnSpPr>
          <p:spPr>
            <a:xfrm>
              <a:off x="10739268" y="3038656"/>
              <a:ext cx="0" cy="556182"/>
            </a:xfrm>
            <a:prstGeom prst="line">
              <a:avLst/>
            </a:prstGeom>
            <a:ln w="571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9" name="Gerader Verbinder 28">
              <a:extLst>
                <a:ext uri="{FF2B5EF4-FFF2-40B4-BE49-F238E27FC236}">
                  <a16:creationId xmlns:a16="http://schemas.microsoft.com/office/drawing/2014/main" id="{8C2C734F-AF10-4AE3-A5AC-8FC1C952F2B7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0719892" y="3577556"/>
              <a:ext cx="622692" cy="0"/>
            </a:xfrm>
            <a:prstGeom prst="line">
              <a:avLst/>
            </a:prstGeom>
            <a:ln w="571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0" name="Rechteck 29">
              <a:extLst>
                <a:ext uri="{FF2B5EF4-FFF2-40B4-BE49-F238E27FC236}">
                  <a16:creationId xmlns:a16="http://schemas.microsoft.com/office/drawing/2014/main" id="{491E321C-6737-449B-921A-3B05D0F52883}"/>
                </a:ext>
              </a:extLst>
            </p:cNvPr>
            <p:cNvSpPr/>
            <p:nvPr/>
          </p:nvSpPr>
          <p:spPr>
            <a:xfrm>
              <a:off x="1948934" y="5844071"/>
              <a:ext cx="857839" cy="792877"/>
            </a:xfrm>
            <a:prstGeom prst="rect">
              <a:avLst/>
            </a:prstGeom>
            <a:noFill/>
            <a:ln w="12700">
              <a:solidFill>
                <a:schemeClr val="tx1">
                  <a:lumMod val="75000"/>
                  <a:lumOff val="25000"/>
                </a:schemeClr>
              </a:solidFill>
            </a:ln>
            <a:effectLst>
              <a:outerShdw blurRad="50800" dist="38100" dir="2700000" algn="tl" rotWithShape="0">
                <a:prstClr val="black">
                  <a:alpha val="40000"/>
                </a:prstClr>
              </a:outerShdw>
            </a:effec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1" name="Rechteck 30">
              <a:extLst>
                <a:ext uri="{FF2B5EF4-FFF2-40B4-BE49-F238E27FC236}">
                  <a16:creationId xmlns:a16="http://schemas.microsoft.com/office/drawing/2014/main" id="{FA485FA1-043B-4FC6-A533-E0B0694DFF84}"/>
                </a:ext>
              </a:extLst>
            </p:cNvPr>
            <p:cNvSpPr/>
            <p:nvPr/>
          </p:nvSpPr>
          <p:spPr>
            <a:xfrm>
              <a:off x="5726286" y="5844071"/>
              <a:ext cx="857839" cy="792877"/>
            </a:xfrm>
            <a:prstGeom prst="rect">
              <a:avLst/>
            </a:prstGeom>
            <a:noFill/>
            <a:ln w="12700">
              <a:solidFill>
                <a:schemeClr val="tx1">
                  <a:lumMod val="75000"/>
                  <a:lumOff val="25000"/>
                </a:schemeClr>
              </a:solidFill>
            </a:ln>
            <a:effectLst>
              <a:outerShdw blurRad="50800" dist="38100" dir="2700000" algn="tl" rotWithShape="0">
                <a:prstClr val="black">
                  <a:alpha val="40000"/>
                </a:prstClr>
              </a:outerShdw>
            </a:effec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32" name="Gerader Verbinder 31">
              <a:extLst>
                <a:ext uri="{FF2B5EF4-FFF2-40B4-BE49-F238E27FC236}">
                  <a16:creationId xmlns:a16="http://schemas.microsoft.com/office/drawing/2014/main" id="{CF661E54-75AC-4F65-A23D-A13739E66E53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5886017" y="6501832"/>
              <a:ext cx="622692" cy="0"/>
            </a:xfrm>
            <a:prstGeom prst="line">
              <a:avLst/>
            </a:prstGeom>
            <a:ln w="571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3" name="Rechteck 32">
              <a:extLst>
                <a:ext uri="{FF2B5EF4-FFF2-40B4-BE49-F238E27FC236}">
                  <a16:creationId xmlns:a16="http://schemas.microsoft.com/office/drawing/2014/main" id="{26BAD19A-5EE3-4193-AC4A-6B049B1571AD}"/>
                </a:ext>
              </a:extLst>
            </p:cNvPr>
            <p:cNvSpPr/>
            <p:nvPr/>
          </p:nvSpPr>
          <p:spPr>
            <a:xfrm>
              <a:off x="9442017" y="5849868"/>
              <a:ext cx="857839" cy="792877"/>
            </a:xfrm>
            <a:prstGeom prst="rect">
              <a:avLst/>
            </a:prstGeom>
            <a:noFill/>
            <a:ln w="12700">
              <a:solidFill>
                <a:schemeClr val="tx1">
                  <a:lumMod val="75000"/>
                  <a:lumOff val="25000"/>
                </a:schemeClr>
              </a:solidFill>
            </a:ln>
            <a:effectLst>
              <a:outerShdw blurRad="50800" dist="38100" dir="2700000" algn="tl" rotWithShape="0">
                <a:prstClr val="black">
                  <a:alpha val="40000"/>
                </a:prstClr>
              </a:outerShdw>
            </a:effec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34" name="Gerader Verbinder 33">
              <a:extLst>
                <a:ext uri="{FF2B5EF4-FFF2-40B4-BE49-F238E27FC236}">
                  <a16:creationId xmlns:a16="http://schemas.microsoft.com/office/drawing/2014/main" id="{C76E3FE3-9D8A-41C3-A2FE-D7EF4F28E842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9601748" y="6507629"/>
              <a:ext cx="622692" cy="0"/>
            </a:xfrm>
            <a:prstGeom prst="line">
              <a:avLst/>
            </a:prstGeom>
            <a:ln w="571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" name="Gerade Verbindung mit Pfeil 34">
              <a:extLst>
                <a:ext uri="{FF2B5EF4-FFF2-40B4-BE49-F238E27FC236}">
                  <a16:creationId xmlns:a16="http://schemas.microsoft.com/office/drawing/2014/main" id="{6422C414-C405-4BBC-BF4A-1EC099925B66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2118335" y="6017333"/>
              <a:ext cx="613022" cy="456945"/>
            </a:xfrm>
            <a:prstGeom prst="straightConnector1">
              <a:avLst/>
            </a:prstGeom>
            <a:ln w="57150">
              <a:solidFill>
                <a:schemeClr val="tx1">
                  <a:lumMod val="50000"/>
                  <a:lumOff val="50000"/>
                </a:schemeClr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6" name="Gerade Verbindung mit Pfeil 35">
              <a:extLst>
                <a:ext uri="{FF2B5EF4-FFF2-40B4-BE49-F238E27FC236}">
                  <a16:creationId xmlns:a16="http://schemas.microsoft.com/office/drawing/2014/main" id="{74D53DBD-3212-4DD0-9324-8E10C5CD90D5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5872943" y="6193374"/>
              <a:ext cx="635766" cy="8877"/>
            </a:xfrm>
            <a:prstGeom prst="straightConnector1">
              <a:avLst/>
            </a:prstGeom>
            <a:ln w="57150">
              <a:solidFill>
                <a:schemeClr val="bg2">
                  <a:lumMod val="50000"/>
                </a:schemeClr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7" name="Gerade Verbindung mit Pfeil 36">
              <a:extLst>
                <a:ext uri="{FF2B5EF4-FFF2-40B4-BE49-F238E27FC236}">
                  <a16:creationId xmlns:a16="http://schemas.microsoft.com/office/drawing/2014/main" id="{872674DF-5D7C-4DAE-88BD-2960E6249384}"/>
                </a:ext>
              </a:extLst>
            </p:cNvPr>
            <p:cNvCxnSpPr>
              <a:cxnSpLocks/>
            </p:cNvCxnSpPr>
            <p:nvPr/>
          </p:nvCxnSpPr>
          <p:spPr>
            <a:xfrm>
              <a:off x="9603078" y="6064456"/>
              <a:ext cx="474176" cy="383480"/>
            </a:xfrm>
            <a:prstGeom prst="straightConnector1">
              <a:avLst/>
            </a:prstGeom>
            <a:ln w="57150">
              <a:solidFill>
                <a:schemeClr val="bg2">
                  <a:lumMod val="50000"/>
                </a:schemeClr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8" name="Textfeld 37">
              <a:extLst>
                <a:ext uri="{FF2B5EF4-FFF2-40B4-BE49-F238E27FC236}">
                  <a16:creationId xmlns:a16="http://schemas.microsoft.com/office/drawing/2014/main" id="{94C7D4F5-2844-470F-B6C2-A74A76AD88AB}"/>
                </a:ext>
              </a:extLst>
            </p:cNvPr>
            <p:cNvSpPr txBox="1"/>
            <p:nvPr/>
          </p:nvSpPr>
          <p:spPr>
            <a:xfrm>
              <a:off x="541516" y="4965889"/>
              <a:ext cx="3634558" cy="830997"/>
            </a:xfrm>
            <a:prstGeom prst="rect">
              <a:avLst/>
            </a:prstGeom>
            <a:noFill/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wrap="square" rtlCol="0">
              <a:spAutoFit/>
            </a:bodyPr>
            <a:lstStyle/>
            <a:p>
              <a:pPr algn="ctr"/>
              <a:endParaRPr lang="de-DE" sz="16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algn="ctr"/>
              <a:r>
                <a:rPr lang="de-DE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nformation spreading rapidly</a:t>
              </a:r>
            </a:p>
            <a:p>
              <a:pPr algn="ctr"/>
              <a:endParaRPr lang="de-DE" sz="16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9" name="Textfeld 38">
              <a:extLst>
                <a:ext uri="{FF2B5EF4-FFF2-40B4-BE49-F238E27FC236}">
                  <a16:creationId xmlns:a16="http://schemas.microsoft.com/office/drawing/2014/main" id="{BB5881B2-76C6-4C6C-B8C8-91BA6CF81590}"/>
                </a:ext>
              </a:extLst>
            </p:cNvPr>
            <p:cNvSpPr txBox="1"/>
            <p:nvPr/>
          </p:nvSpPr>
          <p:spPr>
            <a:xfrm>
              <a:off x="541517" y="4442156"/>
              <a:ext cx="3634558" cy="369332"/>
            </a:xfrm>
            <a:prstGeom prst="rect">
              <a:avLst/>
            </a:prstGeom>
            <a:noFill/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wrap="square" rtlCol="0">
              <a:spAutoFit/>
            </a:bodyPr>
            <a:lstStyle/>
            <a:p>
              <a:pPr algn="ctr"/>
              <a:r>
                <a:rPr lang="de-DE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ncreasing</a:t>
              </a:r>
            </a:p>
          </p:txBody>
        </p:sp>
        <p:cxnSp>
          <p:nvCxnSpPr>
            <p:cNvPr id="40" name="Gerader Verbinder 39">
              <a:extLst>
                <a:ext uri="{FF2B5EF4-FFF2-40B4-BE49-F238E27FC236}">
                  <a16:creationId xmlns:a16="http://schemas.microsoft.com/office/drawing/2014/main" id="{0A27E83F-8A48-46D7-8136-7F9DFEF94906}"/>
                </a:ext>
              </a:extLst>
            </p:cNvPr>
            <p:cNvCxnSpPr>
              <a:cxnSpLocks/>
            </p:cNvCxnSpPr>
            <p:nvPr/>
          </p:nvCxnSpPr>
          <p:spPr>
            <a:xfrm>
              <a:off x="9599651" y="5979003"/>
              <a:ext cx="0" cy="556182"/>
            </a:xfrm>
            <a:prstGeom prst="line">
              <a:avLst/>
            </a:prstGeom>
            <a:ln w="571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1" name="Gerader Verbinder 40">
              <a:extLst>
                <a:ext uri="{FF2B5EF4-FFF2-40B4-BE49-F238E27FC236}">
                  <a16:creationId xmlns:a16="http://schemas.microsoft.com/office/drawing/2014/main" id="{51C386FF-42CE-4150-943D-6F2CFDBBEE2C}"/>
                </a:ext>
              </a:extLst>
            </p:cNvPr>
            <p:cNvCxnSpPr>
              <a:cxnSpLocks/>
            </p:cNvCxnSpPr>
            <p:nvPr/>
          </p:nvCxnSpPr>
          <p:spPr>
            <a:xfrm>
              <a:off x="5883920" y="5973206"/>
              <a:ext cx="0" cy="556182"/>
            </a:xfrm>
            <a:prstGeom prst="line">
              <a:avLst/>
            </a:prstGeom>
            <a:ln w="571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2" name="Gerader Verbinder 41">
              <a:extLst>
                <a:ext uri="{FF2B5EF4-FFF2-40B4-BE49-F238E27FC236}">
                  <a16:creationId xmlns:a16="http://schemas.microsoft.com/office/drawing/2014/main" id="{CAAFB946-6BD8-4ACB-B01B-788E226964A3}"/>
                </a:ext>
              </a:extLst>
            </p:cNvPr>
            <p:cNvCxnSpPr>
              <a:cxnSpLocks/>
            </p:cNvCxnSpPr>
            <p:nvPr/>
          </p:nvCxnSpPr>
          <p:spPr>
            <a:xfrm>
              <a:off x="2106568" y="5973206"/>
              <a:ext cx="0" cy="556182"/>
            </a:xfrm>
            <a:prstGeom prst="line">
              <a:avLst/>
            </a:prstGeom>
            <a:ln w="571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3" name="Gerader Verbinder 42">
              <a:extLst>
                <a:ext uri="{FF2B5EF4-FFF2-40B4-BE49-F238E27FC236}">
                  <a16:creationId xmlns:a16="http://schemas.microsoft.com/office/drawing/2014/main" id="{A5C673A8-C736-4ED0-8430-CC896D4B684F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2108665" y="6501832"/>
              <a:ext cx="622692" cy="0"/>
            </a:xfrm>
            <a:prstGeom prst="line">
              <a:avLst/>
            </a:prstGeom>
            <a:ln w="571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9" name="Rechteck 48">
              <a:extLst>
                <a:ext uri="{FF2B5EF4-FFF2-40B4-BE49-F238E27FC236}">
                  <a16:creationId xmlns:a16="http://schemas.microsoft.com/office/drawing/2014/main" id="{0C7B23AA-6461-416E-BA5D-B4572E358C34}"/>
                </a:ext>
              </a:extLst>
            </p:cNvPr>
            <p:cNvSpPr/>
            <p:nvPr/>
          </p:nvSpPr>
          <p:spPr>
            <a:xfrm>
              <a:off x="2127511" y="2933801"/>
              <a:ext cx="857839" cy="792877"/>
            </a:xfrm>
            <a:prstGeom prst="rect">
              <a:avLst/>
            </a:prstGeom>
            <a:solidFill>
              <a:schemeClr val="bg2">
                <a:lumMod val="75000"/>
              </a:schemeClr>
            </a:solidFill>
            <a:ln w="12700">
              <a:solidFill>
                <a:schemeClr val="tx1">
                  <a:lumMod val="75000"/>
                  <a:lumOff val="25000"/>
                </a:schemeClr>
              </a:solidFill>
            </a:ln>
            <a:effectLst>
              <a:outerShdw blurRad="50800" dist="38100" dir="2700000" algn="tl" rotWithShape="0">
                <a:prstClr val="black">
                  <a:alpha val="40000"/>
                </a:prstClr>
              </a:outerShdw>
            </a:effec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50" name="Gerader Verbinder 49">
              <a:extLst>
                <a:ext uri="{FF2B5EF4-FFF2-40B4-BE49-F238E27FC236}">
                  <a16:creationId xmlns:a16="http://schemas.microsoft.com/office/drawing/2014/main" id="{400B4B1A-92AA-403D-9273-D3745777F0D6}"/>
                </a:ext>
              </a:extLst>
            </p:cNvPr>
            <p:cNvCxnSpPr>
              <a:cxnSpLocks/>
            </p:cNvCxnSpPr>
            <p:nvPr/>
          </p:nvCxnSpPr>
          <p:spPr>
            <a:xfrm>
              <a:off x="2263863" y="3065099"/>
              <a:ext cx="0" cy="556182"/>
            </a:xfrm>
            <a:prstGeom prst="line">
              <a:avLst/>
            </a:prstGeom>
            <a:ln w="571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1" name="Gerader Verbinder 50">
              <a:extLst>
                <a:ext uri="{FF2B5EF4-FFF2-40B4-BE49-F238E27FC236}">
                  <a16:creationId xmlns:a16="http://schemas.microsoft.com/office/drawing/2014/main" id="{B7BE32D5-BF90-4B11-B712-3ECCBC9A256F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2265960" y="3593725"/>
              <a:ext cx="622692" cy="0"/>
            </a:xfrm>
            <a:prstGeom prst="line">
              <a:avLst/>
            </a:prstGeom>
            <a:ln w="571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2" name="Gerader Verbinder 51">
              <a:extLst>
                <a:ext uri="{FF2B5EF4-FFF2-40B4-BE49-F238E27FC236}">
                  <a16:creationId xmlns:a16="http://schemas.microsoft.com/office/drawing/2014/main" id="{D559A01B-579D-4522-A32C-408E122E5ED1}"/>
                </a:ext>
              </a:extLst>
            </p:cNvPr>
            <p:cNvCxnSpPr>
              <a:cxnSpLocks/>
            </p:cNvCxnSpPr>
            <p:nvPr/>
          </p:nvCxnSpPr>
          <p:spPr>
            <a:xfrm>
              <a:off x="5100123" y="3032100"/>
              <a:ext cx="0" cy="556182"/>
            </a:xfrm>
            <a:prstGeom prst="line">
              <a:avLst/>
            </a:prstGeom>
            <a:ln w="571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294952085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feld 1">
            <a:extLst>
              <a:ext uri="{FF2B5EF4-FFF2-40B4-BE49-F238E27FC236}">
                <a16:creationId xmlns:a16="http://schemas.microsoft.com/office/drawing/2014/main" id="{651A26A8-7EF8-4EEC-BE85-52F0D18DEDCA}"/>
              </a:ext>
            </a:extLst>
          </p:cNvPr>
          <p:cNvSpPr txBox="1"/>
          <p:nvPr/>
        </p:nvSpPr>
        <p:spPr>
          <a:xfrm>
            <a:off x="6171418" y="1589600"/>
            <a:ext cx="2674188" cy="1569660"/>
          </a:xfrm>
          <a:prstGeom prst="rect">
            <a:avLst/>
          </a:prstGeom>
          <a:solidFill>
            <a:schemeClr val="accent4">
              <a:lumMod val="40000"/>
              <a:lumOff val="60000"/>
            </a:schemeClr>
          </a:solidFill>
          <a:ln w="19050">
            <a:solidFill>
              <a:schemeClr val="tx1"/>
            </a:solidFill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 anchor="ctr">
            <a:spAutoFit/>
          </a:bodyPr>
          <a:lstStyle/>
          <a:p>
            <a:pPr marL="285750" indent="-285750">
              <a:buFont typeface="Arial" panose="020B0604020202020204" pitchFamily="34" charset="0"/>
              <a:buChar char="•"/>
            </a:pPr>
            <a:r>
              <a:rPr lang="de-DE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oncerning</a:t>
            </a:r>
            <a:r>
              <a:rPr lang="de-DE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but </a:t>
            </a:r>
            <a:r>
              <a:rPr lang="de-DE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ow</a:t>
            </a:r>
            <a:r>
              <a:rPr lang="de-DE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isk</a:t>
            </a:r>
            <a:r>
              <a:rPr lang="de-DE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o</a:t>
            </a:r>
            <a:r>
              <a:rPr lang="de-DE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rigger</a:t>
            </a:r>
            <a:r>
              <a:rPr lang="de-DE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esistancy</a:t>
            </a:r>
            <a:r>
              <a:rPr lang="de-DE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o</a:t>
            </a:r>
            <a:r>
              <a:rPr lang="de-DE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health-promoting </a:t>
            </a:r>
            <a:r>
              <a:rPr lang="de-DE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ehavior</a:t>
            </a:r>
            <a:endParaRPr lang="de-DE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de-DE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imited reach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de-DE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imited dissemination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endParaRPr lang="de-DE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Textfeld 2">
            <a:extLst>
              <a:ext uri="{FF2B5EF4-FFF2-40B4-BE49-F238E27FC236}">
                <a16:creationId xmlns:a16="http://schemas.microsoft.com/office/drawing/2014/main" id="{82325029-FE45-4B63-80D9-CE631784A01E}"/>
              </a:ext>
            </a:extLst>
          </p:cNvPr>
          <p:cNvSpPr txBox="1"/>
          <p:nvPr/>
        </p:nvSpPr>
        <p:spPr>
          <a:xfrm>
            <a:off x="3346396" y="1594265"/>
            <a:ext cx="2674188" cy="1569660"/>
          </a:xfrm>
          <a:prstGeom prst="rect">
            <a:avLst/>
          </a:prstGeom>
          <a:solidFill>
            <a:schemeClr val="accent2">
              <a:lumMod val="40000"/>
              <a:lumOff val="60000"/>
            </a:schemeClr>
          </a:solidFill>
          <a:ln w="19050">
            <a:solidFill>
              <a:schemeClr val="tx1"/>
            </a:solidFill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 anchor="ctr">
            <a:spAutoFit/>
          </a:bodyPr>
          <a:lstStyle/>
          <a:p>
            <a:pPr marL="285750" indent="-285750">
              <a:buFont typeface="Arial" panose="020B0604020202020204" pitchFamily="34" charset="0"/>
              <a:buChar char="•"/>
            </a:pPr>
            <a:r>
              <a:rPr lang="de-DE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an </a:t>
            </a:r>
            <a:r>
              <a:rPr lang="de-DE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rigger</a:t>
            </a:r>
            <a:r>
              <a:rPr lang="de-DE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esistancy</a:t>
            </a:r>
            <a:r>
              <a:rPr lang="de-DE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o</a:t>
            </a:r>
            <a:r>
              <a:rPr lang="de-DE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health-promoting behaviors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de-DE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oderate reach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de-DE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odest dissemination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endParaRPr lang="de-DE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Textfeld 3">
            <a:extLst>
              <a:ext uri="{FF2B5EF4-FFF2-40B4-BE49-F238E27FC236}">
                <a16:creationId xmlns:a16="http://schemas.microsoft.com/office/drawing/2014/main" id="{3EB6B366-D965-4246-9E7B-E021EDB2AE22}"/>
              </a:ext>
            </a:extLst>
          </p:cNvPr>
          <p:cNvSpPr txBox="1"/>
          <p:nvPr/>
        </p:nvSpPr>
        <p:spPr>
          <a:xfrm>
            <a:off x="541516" y="1589600"/>
            <a:ext cx="2679628" cy="1569660"/>
          </a:xfrm>
          <a:prstGeom prst="rect">
            <a:avLst/>
          </a:prstGeom>
          <a:solidFill>
            <a:srgbClr val="FC9688"/>
          </a:solidFill>
          <a:ln w="19050">
            <a:solidFill>
              <a:schemeClr val="tx1"/>
            </a:solidFill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 anchor="ctr">
            <a:spAutoFit/>
          </a:bodyPr>
          <a:lstStyle/>
          <a:p>
            <a:pPr marL="285750" indent="-285750">
              <a:buFont typeface="Arial" panose="020B0604020202020204" pitchFamily="34" charset="0"/>
              <a:buChar char="•"/>
            </a:pPr>
            <a:r>
              <a:rPr lang="de-DE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ay </a:t>
            </a:r>
            <a:r>
              <a:rPr lang="de-DE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ower</a:t>
            </a:r>
            <a:r>
              <a:rPr lang="de-DE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health-promoting behaviors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de-DE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ide reach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de-DE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ervasisve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endParaRPr lang="de-DE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285750" indent="-285750">
              <a:buFont typeface="Arial" panose="020B0604020202020204" pitchFamily="34" charset="0"/>
              <a:buChar char="•"/>
            </a:pPr>
            <a:endParaRPr lang="de-DE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Rechteck 4">
            <a:extLst>
              <a:ext uri="{FF2B5EF4-FFF2-40B4-BE49-F238E27FC236}">
                <a16:creationId xmlns:a16="http://schemas.microsoft.com/office/drawing/2014/main" id="{A9A3E9AC-0B84-4152-A0C2-C76A6AFEBEF1}"/>
              </a:ext>
            </a:extLst>
          </p:cNvPr>
          <p:cNvSpPr/>
          <p:nvPr/>
        </p:nvSpPr>
        <p:spPr>
          <a:xfrm>
            <a:off x="4973405" y="2924431"/>
            <a:ext cx="857839" cy="792877"/>
          </a:xfrm>
          <a:prstGeom prst="rect">
            <a:avLst/>
          </a:prstGeom>
          <a:solidFill>
            <a:schemeClr val="accent2">
              <a:lumMod val="40000"/>
              <a:lumOff val="60000"/>
            </a:schemeClr>
          </a:solidFill>
          <a:ln w="12700">
            <a:solidFill>
              <a:schemeClr val="tx1">
                <a:lumMod val="75000"/>
                <a:lumOff val="25000"/>
              </a:schemeClr>
            </a:solidFill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Textfeld 6">
            <a:extLst>
              <a:ext uri="{FF2B5EF4-FFF2-40B4-BE49-F238E27FC236}">
                <a16:creationId xmlns:a16="http://schemas.microsoft.com/office/drawing/2014/main" id="{D547EB61-89AA-4DB0-BC2C-0654AA9A2DB0}"/>
              </a:ext>
            </a:extLst>
          </p:cNvPr>
          <p:cNvSpPr txBox="1"/>
          <p:nvPr/>
        </p:nvSpPr>
        <p:spPr>
          <a:xfrm>
            <a:off x="8970858" y="1589600"/>
            <a:ext cx="2674188" cy="1569660"/>
          </a:xfrm>
          <a:prstGeom prst="rect">
            <a:avLst/>
          </a:prstGeom>
          <a:solidFill>
            <a:srgbClr val="009242"/>
          </a:solidFill>
          <a:ln w="19050">
            <a:solidFill>
              <a:schemeClr val="tx1"/>
            </a:solidFill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 anchor="ctr">
            <a:spAutoFit/>
          </a:bodyPr>
          <a:lstStyle/>
          <a:p>
            <a:pPr marL="285750" indent="-285750">
              <a:buFont typeface="Arial" panose="020B0604020202020204" pitchFamily="34" charset="0"/>
              <a:buChar char="•"/>
            </a:pPr>
            <a:r>
              <a:rPr lang="de-DE" sz="16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eutral or may increase health-promoting behaviors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de-DE" sz="16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Variable reach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de-DE" sz="16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Variable dissemination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endParaRPr lang="de-DE" sz="16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Textfeld 7">
            <a:extLst>
              <a:ext uri="{FF2B5EF4-FFF2-40B4-BE49-F238E27FC236}">
                <a16:creationId xmlns:a16="http://schemas.microsoft.com/office/drawing/2014/main" id="{EB3125F6-6B73-49D7-981A-C8263E2228C1}"/>
              </a:ext>
            </a:extLst>
          </p:cNvPr>
          <p:cNvSpPr txBox="1"/>
          <p:nvPr/>
        </p:nvSpPr>
        <p:spPr>
          <a:xfrm>
            <a:off x="541516" y="562807"/>
            <a:ext cx="11119444" cy="400110"/>
          </a:xfrm>
          <a:prstGeom prst="rect">
            <a:avLst/>
          </a:prstGeom>
          <a:noFill/>
          <a:ln w="69850" cmpd="dbl">
            <a:solidFill>
              <a:schemeClr val="tx1"/>
            </a:solidFill>
            <a:prstDash val="solid"/>
          </a:ln>
        </p:spPr>
        <p:txBody>
          <a:bodyPr wrap="square" rtlCol="0">
            <a:spAutoFit/>
          </a:bodyPr>
          <a:lstStyle/>
          <a:p>
            <a:pPr algn="ctr"/>
            <a:r>
              <a:rPr lang="de-DE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ow do you classify the information/theme?</a:t>
            </a:r>
          </a:p>
        </p:txBody>
      </p:sp>
      <p:sp>
        <p:nvSpPr>
          <p:cNvPr id="9" name="Textfeld 8">
            <a:extLst>
              <a:ext uri="{FF2B5EF4-FFF2-40B4-BE49-F238E27FC236}">
                <a16:creationId xmlns:a16="http://schemas.microsoft.com/office/drawing/2014/main" id="{C04483CD-E168-49DF-8BBD-4485A7513715}"/>
              </a:ext>
            </a:extLst>
          </p:cNvPr>
          <p:cNvSpPr txBox="1"/>
          <p:nvPr/>
        </p:nvSpPr>
        <p:spPr>
          <a:xfrm>
            <a:off x="541516" y="3886736"/>
            <a:ext cx="11126754" cy="400110"/>
          </a:xfrm>
          <a:prstGeom prst="rect">
            <a:avLst/>
          </a:prstGeom>
          <a:noFill/>
          <a:ln w="66675" cmpd="dbl">
            <a:solidFill>
              <a:schemeClr val="tx1"/>
            </a:solidFill>
            <a:prstDash val="solid"/>
          </a:ln>
        </p:spPr>
        <p:txBody>
          <a:bodyPr wrap="square" rtlCol="0">
            <a:spAutoFit/>
          </a:bodyPr>
          <a:lstStyle/>
          <a:p>
            <a:pPr algn="ctr"/>
            <a:r>
              <a:rPr lang="de-DE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ow has the theme changed over time (since last report or over the course of multiple reports)?</a:t>
            </a:r>
          </a:p>
        </p:txBody>
      </p:sp>
      <p:sp>
        <p:nvSpPr>
          <p:cNvPr id="11" name="Textfeld 10">
            <a:extLst>
              <a:ext uri="{FF2B5EF4-FFF2-40B4-BE49-F238E27FC236}">
                <a16:creationId xmlns:a16="http://schemas.microsoft.com/office/drawing/2014/main" id="{D155F18D-E738-4877-B33E-F14D54AC85A2}"/>
              </a:ext>
            </a:extLst>
          </p:cNvPr>
          <p:cNvSpPr txBox="1"/>
          <p:nvPr/>
        </p:nvSpPr>
        <p:spPr>
          <a:xfrm>
            <a:off x="4278721" y="4969533"/>
            <a:ext cx="3634558" cy="830997"/>
          </a:xfrm>
          <a:prstGeom prst="rect">
            <a:avLst/>
          </a:prstGeom>
          <a:solidFill>
            <a:schemeClr val="bg2">
              <a:lumMod val="75000"/>
            </a:schemeClr>
          </a:solidFill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 anchor="ctr">
            <a:spAutoFit/>
          </a:bodyPr>
          <a:lstStyle/>
          <a:p>
            <a:pPr algn="ctr"/>
            <a:r>
              <a:rPr lang="de-DE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br>
              <a:rPr lang="de-DE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de-DE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formation remaining </a:t>
            </a:r>
            <a:r>
              <a:rPr lang="de-DE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onstant</a:t>
            </a:r>
            <a:r>
              <a:rPr lang="de-DE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br>
              <a:rPr lang="de-DE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de-DE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t prior level</a:t>
            </a:r>
          </a:p>
          <a:p>
            <a:pPr algn="ctr"/>
            <a:endParaRPr lang="de-DE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Textfeld 11">
            <a:extLst>
              <a:ext uri="{FF2B5EF4-FFF2-40B4-BE49-F238E27FC236}">
                <a16:creationId xmlns:a16="http://schemas.microsoft.com/office/drawing/2014/main" id="{04A1C6B5-691C-4FEA-A721-0972D8101652}"/>
              </a:ext>
            </a:extLst>
          </p:cNvPr>
          <p:cNvSpPr txBox="1"/>
          <p:nvPr/>
        </p:nvSpPr>
        <p:spPr>
          <a:xfrm>
            <a:off x="8026402" y="4963116"/>
            <a:ext cx="3634558" cy="830997"/>
          </a:xfrm>
          <a:prstGeom prst="rect">
            <a:avLst/>
          </a:prstGeom>
          <a:solidFill>
            <a:schemeClr val="bg2">
              <a:lumMod val="90000"/>
            </a:schemeClr>
          </a:solidFill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 anchor="ctr">
            <a:spAutoFit/>
          </a:bodyPr>
          <a:lstStyle/>
          <a:p>
            <a:pPr algn="ctr"/>
            <a:r>
              <a:rPr lang="de-DE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formation is not gaining further traction and there has been no indication of additional activity</a:t>
            </a:r>
          </a:p>
        </p:txBody>
      </p:sp>
      <p:sp>
        <p:nvSpPr>
          <p:cNvPr id="13" name="Textfeld 12">
            <a:extLst>
              <a:ext uri="{FF2B5EF4-FFF2-40B4-BE49-F238E27FC236}">
                <a16:creationId xmlns:a16="http://schemas.microsoft.com/office/drawing/2014/main" id="{3177020F-B8A4-404E-9323-6401616EFFDE}"/>
              </a:ext>
            </a:extLst>
          </p:cNvPr>
          <p:cNvSpPr txBox="1"/>
          <p:nvPr/>
        </p:nvSpPr>
        <p:spPr>
          <a:xfrm>
            <a:off x="541516" y="1123738"/>
            <a:ext cx="2679628" cy="378748"/>
          </a:xfrm>
          <a:prstGeom prst="rect">
            <a:avLst/>
          </a:prstGeom>
          <a:solidFill>
            <a:srgbClr val="FC9688"/>
          </a:solidFill>
          <a:ln w="19050">
            <a:solidFill>
              <a:schemeClr val="tx1"/>
            </a:solidFill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de-DE" dirty="0">
                <a:latin typeface="Times New Roman" panose="02020603050405020304" pitchFamily="18" charset="0"/>
                <a:cs typeface="Times New Roman" panose="02020603050405020304" pitchFamily="18" charset="0"/>
              </a:rPr>
              <a:t>High </a:t>
            </a:r>
            <a:r>
              <a:rPr lang="de-DE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isk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</a:p>
        </p:txBody>
      </p:sp>
      <p:sp>
        <p:nvSpPr>
          <p:cNvPr id="14" name="Textfeld 13">
            <a:extLst>
              <a:ext uri="{FF2B5EF4-FFF2-40B4-BE49-F238E27FC236}">
                <a16:creationId xmlns:a16="http://schemas.microsoft.com/office/drawing/2014/main" id="{C2900DC5-5352-4F41-BD3D-0F4170595D64}"/>
              </a:ext>
            </a:extLst>
          </p:cNvPr>
          <p:cNvSpPr txBox="1"/>
          <p:nvPr/>
        </p:nvSpPr>
        <p:spPr>
          <a:xfrm>
            <a:off x="3346396" y="1133154"/>
            <a:ext cx="2674188" cy="369332"/>
          </a:xfrm>
          <a:prstGeom prst="rect">
            <a:avLst/>
          </a:prstGeom>
          <a:solidFill>
            <a:schemeClr val="accent2">
              <a:lumMod val="40000"/>
              <a:lumOff val="60000"/>
            </a:schemeClr>
          </a:solidFill>
          <a:ln w="19050">
            <a:solidFill>
              <a:schemeClr val="tx1"/>
            </a:solidFill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de-DE" dirty="0">
                <a:latin typeface="Times New Roman" panose="02020603050405020304" pitchFamily="18" charset="0"/>
                <a:cs typeface="Times New Roman" panose="02020603050405020304" pitchFamily="18" charset="0"/>
              </a:rPr>
              <a:t>Moderate </a:t>
            </a:r>
            <a:r>
              <a:rPr lang="de-DE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isk</a:t>
            </a:r>
            <a:endParaRPr lang="de-DE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Textfeld 14">
            <a:extLst>
              <a:ext uri="{FF2B5EF4-FFF2-40B4-BE49-F238E27FC236}">
                <a16:creationId xmlns:a16="http://schemas.microsoft.com/office/drawing/2014/main" id="{DC4CA053-B75D-4E11-A0A1-B9FCA4E5A0AD}"/>
              </a:ext>
            </a:extLst>
          </p:cNvPr>
          <p:cNvSpPr txBox="1"/>
          <p:nvPr/>
        </p:nvSpPr>
        <p:spPr>
          <a:xfrm>
            <a:off x="6155206" y="1125561"/>
            <a:ext cx="2674188" cy="369332"/>
          </a:xfrm>
          <a:prstGeom prst="rect">
            <a:avLst/>
          </a:prstGeom>
          <a:solidFill>
            <a:schemeClr val="accent4">
              <a:lumMod val="40000"/>
              <a:lumOff val="60000"/>
            </a:schemeClr>
          </a:solidFill>
          <a:ln w="19050">
            <a:solidFill>
              <a:schemeClr val="tx1"/>
            </a:solidFill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de-DE" dirty="0">
                <a:latin typeface="Times New Roman" panose="02020603050405020304" pitchFamily="18" charset="0"/>
                <a:cs typeface="Times New Roman" panose="02020603050405020304" pitchFamily="18" charset="0"/>
              </a:rPr>
              <a:t>Low </a:t>
            </a:r>
            <a:r>
              <a:rPr lang="de-DE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isk</a:t>
            </a:r>
            <a:endParaRPr lang="de-DE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Textfeld 15">
            <a:extLst>
              <a:ext uri="{FF2B5EF4-FFF2-40B4-BE49-F238E27FC236}">
                <a16:creationId xmlns:a16="http://schemas.microsoft.com/office/drawing/2014/main" id="{033B26B4-781B-46C6-88BC-0591A77F1D24}"/>
              </a:ext>
            </a:extLst>
          </p:cNvPr>
          <p:cNvSpPr txBox="1"/>
          <p:nvPr/>
        </p:nvSpPr>
        <p:spPr>
          <a:xfrm>
            <a:off x="8962746" y="1128299"/>
            <a:ext cx="2679628" cy="369332"/>
          </a:xfrm>
          <a:prstGeom prst="rect">
            <a:avLst/>
          </a:prstGeom>
          <a:solidFill>
            <a:srgbClr val="009242"/>
          </a:solidFill>
          <a:ln w="19050">
            <a:solidFill>
              <a:schemeClr val="tx1"/>
            </a:solidFill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de-DE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o</a:t>
            </a:r>
            <a:r>
              <a:rPr lang="de-DE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risk</a:t>
            </a:r>
            <a:endParaRPr lang="de-DE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Textfeld 17">
            <a:extLst>
              <a:ext uri="{FF2B5EF4-FFF2-40B4-BE49-F238E27FC236}">
                <a16:creationId xmlns:a16="http://schemas.microsoft.com/office/drawing/2014/main" id="{776E6281-466B-4CD9-8020-700ACD2BFFB5}"/>
              </a:ext>
            </a:extLst>
          </p:cNvPr>
          <p:cNvSpPr txBox="1"/>
          <p:nvPr/>
        </p:nvSpPr>
        <p:spPr>
          <a:xfrm>
            <a:off x="4288470" y="4441886"/>
            <a:ext cx="3634559" cy="369332"/>
          </a:xfrm>
          <a:prstGeom prst="rect">
            <a:avLst/>
          </a:prstGeom>
          <a:solidFill>
            <a:schemeClr val="bg2">
              <a:lumMod val="75000"/>
            </a:schemeClr>
          </a:solidFill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de-DE" dirty="0">
                <a:latin typeface="Times New Roman" panose="02020603050405020304" pitchFamily="18" charset="0"/>
                <a:cs typeface="Times New Roman" panose="02020603050405020304" pitchFamily="18" charset="0"/>
              </a:rPr>
              <a:t>Stable</a:t>
            </a:r>
          </a:p>
        </p:txBody>
      </p:sp>
      <p:sp>
        <p:nvSpPr>
          <p:cNvPr id="19" name="Textfeld 18">
            <a:extLst>
              <a:ext uri="{FF2B5EF4-FFF2-40B4-BE49-F238E27FC236}">
                <a16:creationId xmlns:a16="http://schemas.microsoft.com/office/drawing/2014/main" id="{9EA29B3A-B1F4-4C3C-BBDC-08293C00B4F5}"/>
              </a:ext>
            </a:extLst>
          </p:cNvPr>
          <p:cNvSpPr txBox="1"/>
          <p:nvPr/>
        </p:nvSpPr>
        <p:spPr>
          <a:xfrm>
            <a:off x="8026404" y="4442644"/>
            <a:ext cx="3634556" cy="369332"/>
          </a:xfrm>
          <a:prstGeom prst="rect">
            <a:avLst/>
          </a:prstGeom>
          <a:solidFill>
            <a:schemeClr val="bg2">
              <a:lumMod val="90000"/>
            </a:schemeClr>
          </a:solidFill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de-DE" dirty="0">
                <a:latin typeface="Times New Roman" panose="02020603050405020304" pitchFamily="18" charset="0"/>
                <a:cs typeface="Times New Roman" panose="02020603050405020304" pitchFamily="18" charset="0"/>
              </a:rPr>
              <a:t>Decreasing</a:t>
            </a:r>
          </a:p>
        </p:txBody>
      </p:sp>
      <p:cxnSp>
        <p:nvCxnSpPr>
          <p:cNvPr id="20" name="Gerader Verbinder 19">
            <a:extLst>
              <a:ext uri="{FF2B5EF4-FFF2-40B4-BE49-F238E27FC236}">
                <a16:creationId xmlns:a16="http://schemas.microsoft.com/office/drawing/2014/main" id="{8C8364F0-7FB5-4DA1-94C8-70AE82DE27A5}"/>
              </a:ext>
            </a:extLst>
          </p:cNvPr>
          <p:cNvCxnSpPr>
            <a:cxnSpLocks/>
          </p:cNvCxnSpPr>
          <p:nvPr/>
        </p:nvCxnSpPr>
        <p:spPr>
          <a:xfrm>
            <a:off x="2254436" y="2933178"/>
            <a:ext cx="0" cy="556182"/>
          </a:xfrm>
          <a:prstGeom prst="line">
            <a:avLst/>
          </a:prstGeom>
          <a:ln w="57150">
            <a:solidFill>
              <a:schemeClr val="tx1">
                <a:lumMod val="75000"/>
                <a:lumOff val="2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Gerader Verbinder 20">
            <a:extLst>
              <a:ext uri="{FF2B5EF4-FFF2-40B4-BE49-F238E27FC236}">
                <a16:creationId xmlns:a16="http://schemas.microsoft.com/office/drawing/2014/main" id="{D9745944-0BE9-48E3-9CA1-15FA1F47CCEC}"/>
              </a:ext>
            </a:extLst>
          </p:cNvPr>
          <p:cNvCxnSpPr>
            <a:cxnSpLocks/>
          </p:cNvCxnSpPr>
          <p:nvPr/>
        </p:nvCxnSpPr>
        <p:spPr>
          <a:xfrm flipH="1">
            <a:off x="2256533" y="3461804"/>
            <a:ext cx="622692" cy="0"/>
          </a:xfrm>
          <a:prstGeom prst="line">
            <a:avLst/>
          </a:prstGeom>
          <a:ln w="57150">
            <a:solidFill>
              <a:schemeClr val="tx1">
                <a:lumMod val="75000"/>
                <a:lumOff val="2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Gerader Verbinder 21">
            <a:extLst>
              <a:ext uri="{FF2B5EF4-FFF2-40B4-BE49-F238E27FC236}">
                <a16:creationId xmlns:a16="http://schemas.microsoft.com/office/drawing/2014/main" id="{E87EC5FA-6D6C-4C74-B7DE-1D2BDE0B1003}"/>
              </a:ext>
            </a:extLst>
          </p:cNvPr>
          <p:cNvCxnSpPr>
            <a:cxnSpLocks/>
          </p:cNvCxnSpPr>
          <p:nvPr/>
        </p:nvCxnSpPr>
        <p:spPr>
          <a:xfrm flipH="1" flipV="1">
            <a:off x="5071842" y="3576961"/>
            <a:ext cx="660203" cy="1951"/>
          </a:xfrm>
          <a:prstGeom prst="line">
            <a:avLst/>
          </a:prstGeom>
          <a:ln w="57150">
            <a:solidFill>
              <a:schemeClr val="tx1">
                <a:lumMod val="75000"/>
                <a:lumOff val="2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" name="Rechteck 23">
            <a:extLst>
              <a:ext uri="{FF2B5EF4-FFF2-40B4-BE49-F238E27FC236}">
                <a16:creationId xmlns:a16="http://schemas.microsoft.com/office/drawing/2014/main" id="{9761A931-20AA-4DC7-A57A-75805550320A}"/>
              </a:ext>
            </a:extLst>
          </p:cNvPr>
          <p:cNvSpPr/>
          <p:nvPr/>
        </p:nvSpPr>
        <p:spPr>
          <a:xfrm>
            <a:off x="7772845" y="2932798"/>
            <a:ext cx="857839" cy="792877"/>
          </a:xfrm>
          <a:prstGeom prst="rect">
            <a:avLst/>
          </a:prstGeom>
          <a:solidFill>
            <a:schemeClr val="accent4">
              <a:lumMod val="40000"/>
              <a:lumOff val="60000"/>
            </a:schemeClr>
          </a:solidFill>
          <a:ln w="12700">
            <a:solidFill>
              <a:schemeClr val="tx1"/>
            </a:solidFill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5" name="Gerader Verbinder 24">
            <a:extLst>
              <a:ext uri="{FF2B5EF4-FFF2-40B4-BE49-F238E27FC236}">
                <a16:creationId xmlns:a16="http://schemas.microsoft.com/office/drawing/2014/main" id="{655B7996-2983-4EE6-B978-555EDE0790A5}"/>
              </a:ext>
            </a:extLst>
          </p:cNvPr>
          <p:cNvCxnSpPr>
            <a:cxnSpLocks/>
          </p:cNvCxnSpPr>
          <p:nvPr/>
        </p:nvCxnSpPr>
        <p:spPr>
          <a:xfrm>
            <a:off x="7914246" y="3047023"/>
            <a:ext cx="0" cy="556182"/>
          </a:xfrm>
          <a:prstGeom prst="line">
            <a:avLst/>
          </a:prstGeom>
          <a:ln w="57150">
            <a:solidFill>
              <a:schemeClr val="tx1">
                <a:lumMod val="75000"/>
                <a:lumOff val="2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Gerader Verbinder 25">
            <a:extLst>
              <a:ext uri="{FF2B5EF4-FFF2-40B4-BE49-F238E27FC236}">
                <a16:creationId xmlns:a16="http://schemas.microsoft.com/office/drawing/2014/main" id="{BEFC815A-2CB8-4213-B7ED-C13E102767DB}"/>
              </a:ext>
            </a:extLst>
          </p:cNvPr>
          <p:cNvCxnSpPr>
            <a:cxnSpLocks/>
          </p:cNvCxnSpPr>
          <p:nvPr/>
        </p:nvCxnSpPr>
        <p:spPr>
          <a:xfrm flipH="1">
            <a:off x="7894870" y="3585923"/>
            <a:ext cx="622692" cy="0"/>
          </a:xfrm>
          <a:prstGeom prst="line">
            <a:avLst/>
          </a:prstGeom>
          <a:ln w="57150">
            <a:solidFill>
              <a:schemeClr val="tx1">
                <a:lumMod val="75000"/>
                <a:lumOff val="2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" name="Rechteck 26">
            <a:extLst>
              <a:ext uri="{FF2B5EF4-FFF2-40B4-BE49-F238E27FC236}">
                <a16:creationId xmlns:a16="http://schemas.microsoft.com/office/drawing/2014/main" id="{EC0B6F34-D87E-49E1-8A46-D711971B2C25}"/>
              </a:ext>
            </a:extLst>
          </p:cNvPr>
          <p:cNvSpPr/>
          <p:nvPr/>
        </p:nvSpPr>
        <p:spPr>
          <a:xfrm>
            <a:off x="10597867" y="2924431"/>
            <a:ext cx="857839" cy="792877"/>
          </a:xfrm>
          <a:prstGeom prst="rect">
            <a:avLst/>
          </a:prstGeom>
          <a:solidFill>
            <a:srgbClr val="009242"/>
          </a:solidFill>
          <a:ln w="12700">
            <a:solidFill>
              <a:schemeClr val="tx1">
                <a:lumMod val="75000"/>
                <a:lumOff val="25000"/>
              </a:schemeClr>
            </a:solidFill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8" name="Gerader Verbinder 27">
            <a:extLst>
              <a:ext uri="{FF2B5EF4-FFF2-40B4-BE49-F238E27FC236}">
                <a16:creationId xmlns:a16="http://schemas.microsoft.com/office/drawing/2014/main" id="{F13443F2-4F7A-4C98-AD95-B2462AAD9D96}"/>
              </a:ext>
            </a:extLst>
          </p:cNvPr>
          <p:cNvCxnSpPr>
            <a:cxnSpLocks/>
          </p:cNvCxnSpPr>
          <p:nvPr/>
        </p:nvCxnSpPr>
        <p:spPr>
          <a:xfrm>
            <a:off x="10739268" y="3038656"/>
            <a:ext cx="0" cy="556182"/>
          </a:xfrm>
          <a:prstGeom prst="line">
            <a:avLst/>
          </a:prstGeom>
          <a:ln w="571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Gerader Verbinder 28">
            <a:extLst>
              <a:ext uri="{FF2B5EF4-FFF2-40B4-BE49-F238E27FC236}">
                <a16:creationId xmlns:a16="http://schemas.microsoft.com/office/drawing/2014/main" id="{8C2C734F-AF10-4AE3-A5AC-8FC1C952F2B7}"/>
              </a:ext>
            </a:extLst>
          </p:cNvPr>
          <p:cNvCxnSpPr>
            <a:cxnSpLocks/>
          </p:cNvCxnSpPr>
          <p:nvPr/>
        </p:nvCxnSpPr>
        <p:spPr>
          <a:xfrm flipH="1">
            <a:off x="10719892" y="3577556"/>
            <a:ext cx="622692" cy="0"/>
          </a:xfrm>
          <a:prstGeom prst="line">
            <a:avLst/>
          </a:prstGeom>
          <a:ln w="571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" name="Rechteck 29">
            <a:extLst>
              <a:ext uri="{FF2B5EF4-FFF2-40B4-BE49-F238E27FC236}">
                <a16:creationId xmlns:a16="http://schemas.microsoft.com/office/drawing/2014/main" id="{491E321C-6737-449B-921A-3B05D0F52883}"/>
              </a:ext>
            </a:extLst>
          </p:cNvPr>
          <p:cNvSpPr/>
          <p:nvPr/>
        </p:nvSpPr>
        <p:spPr>
          <a:xfrm>
            <a:off x="1948934" y="5844071"/>
            <a:ext cx="857839" cy="792877"/>
          </a:xfrm>
          <a:prstGeom prst="rect">
            <a:avLst/>
          </a:prstGeom>
          <a:solidFill>
            <a:schemeClr val="tx1">
              <a:lumMod val="50000"/>
              <a:lumOff val="50000"/>
            </a:schemeClr>
          </a:solidFill>
          <a:ln w="12700">
            <a:solidFill>
              <a:schemeClr val="tx1">
                <a:lumMod val="75000"/>
                <a:lumOff val="25000"/>
              </a:schemeClr>
            </a:solidFill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Rechteck 30">
            <a:extLst>
              <a:ext uri="{FF2B5EF4-FFF2-40B4-BE49-F238E27FC236}">
                <a16:creationId xmlns:a16="http://schemas.microsoft.com/office/drawing/2014/main" id="{FA485FA1-043B-4FC6-A533-E0B0694DFF84}"/>
              </a:ext>
            </a:extLst>
          </p:cNvPr>
          <p:cNvSpPr/>
          <p:nvPr/>
        </p:nvSpPr>
        <p:spPr>
          <a:xfrm>
            <a:off x="5726286" y="5844071"/>
            <a:ext cx="857839" cy="792877"/>
          </a:xfrm>
          <a:prstGeom prst="rect">
            <a:avLst/>
          </a:prstGeom>
          <a:solidFill>
            <a:schemeClr val="bg2">
              <a:lumMod val="75000"/>
            </a:schemeClr>
          </a:solidFill>
          <a:ln w="12700">
            <a:solidFill>
              <a:schemeClr val="tx1">
                <a:lumMod val="75000"/>
                <a:lumOff val="25000"/>
              </a:schemeClr>
            </a:solidFill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2" name="Gerader Verbinder 31">
            <a:extLst>
              <a:ext uri="{FF2B5EF4-FFF2-40B4-BE49-F238E27FC236}">
                <a16:creationId xmlns:a16="http://schemas.microsoft.com/office/drawing/2014/main" id="{CF661E54-75AC-4F65-A23D-A13739E66E53}"/>
              </a:ext>
            </a:extLst>
          </p:cNvPr>
          <p:cNvCxnSpPr>
            <a:cxnSpLocks/>
          </p:cNvCxnSpPr>
          <p:nvPr/>
        </p:nvCxnSpPr>
        <p:spPr>
          <a:xfrm flipH="1">
            <a:off x="5886017" y="6501832"/>
            <a:ext cx="622692" cy="0"/>
          </a:xfrm>
          <a:prstGeom prst="line">
            <a:avLst/>
          </a:prstGeom>
          <a:ln w="57150">
            <a:solidFill>
              <a:schemeClr val="tx1">
                <a:lumMod val="75000"/>
                <a:lumOff val="2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" name="Rechteck 32">
            <a:extLst>
              <a:ext uri="{FF2B5EF4-FFF2-40B4-BE49-F238E27FC236}">
                <a16:creationId xmlns:a16="http://schemas.microsoft.com/office/drawing/2014/main" id="{26BAD19A-5EE3-4193-AC4A-6B049B1571AD}"/>
              </a:ext>
            </a:extLst>
          </p:cNvPr>
          <p:cNvSpPr/>
          <p:nvPr/>
        </p:nvSpPr>
        <p:spPr>
          <a:xfrm>
            <a:off x="9442017" y="5849868"/>
            <a:ext cx="857839" cy="792877"/>
          </a:xfrm>
          <a:prstGeom prst="rect">
            <a:avLst/>
          </a:prstGeom>
          <a:solidFill>
            <a:schemeClr val="bg2">
              <a:lumMod val="90000"/>
            </a:schemeClr>
          </a:solidFill>
          <a:ln w="12700">
            <a:solidFill>
              <a:schemeClr val="tx1">
                <a:lumMod val="75000"/>
                <a:lumOff val="25000"/>
              </a:schemeClr>
            </a:solidFill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4" name="Gerader Verbinder 33">
            <a:extLst>
              <a:ext uri="{FF2B5EF4-FFF2-40B4-BE49-F238E27FC236}">
                <a16:creationId xmlns:a16="http://schemas.microsoft.com/office/drawing/2014/main" id="{C76E3FE3-9D8A-41C3-A2FE-D7EF4F28E842}"/>
              </a:ext>
            </a:extLst>
          </p:cNvPr>
          <p:cNvCxnSpPr>
            <a:cxnSpLocks/>
          </p:cNvCxnSpPr>
          <p:nvPr/>
        </p:nvCxnSpPr>
        <p:spPr>
          <a:xfrm flipH="1">
            <a:off x="9601748" y="6507629"/>
            <a:ext cx="622692" cy="0"/>
          </a:xfrm>
          <a:prstGeom prst="line">
            <a:avLst/>
          </a:prstGeom>
          <a:ln w="57150">
            <a:solidFill>
              <a:schemeClr val="tx1">
                <a:lumMod val="75000"/>
                <a:lumOff val="2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Gerade Verbindung mit Pfeil 34">
            <a:extLst>
              <a:ext uri="{FF2B5EF4-FFF2-40B4-BE49-F238E27FC236}">
                <a16:creationId xmlns:a16="http://schemas.microsoft.com/office/drawing/2014/main" id="{6422C414-C405-4BBC-BF4A-1EC099925B66}"/>
              </a:ext>
            </a:extLst>
          </p:cNvPr>
          <p:cNvCxnSpPr>
            <a:cxnSpLocks/>
          </p:cNvCxnSpPr>
          <p:nvPr/>
        </p:nvCxnSpPr>
        <p:spPr>
          <a:xfrm flipV="1">
            <a:off x="2118335" y="6017333"/>
            <a:ext cx="613022" cy="456945"/>
          </a:xfrm>
          <a:prstGeom prst="straightConnector1">
            <a:avLst/>
          </a:prstGeom>
          <a:ln w="57150">
            <a:solidFill>
              <a:schemeClr val="tx1">
                <a:lumMod val="65000"/>
                <a:lumOff val="35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" name="Gerade Verbindung mit Pfeil 35">
            <a:extLst>
              <a:ext uri="{FF2B5EF4-FFF2-40B4-BE49-F238E27FC236}">
                <a16:creationId xmlns:a16="http://schemas.microsoft.com/office/drawing/2014/main" id="{74D53DBD-3212-4DD0-9324-8E10C5CD90D5}"/>
              </a:ext>
            </a:extLst>
          </p:cNvPr>
          <p:cNvCxnSpPr>
            <a:cxnSpLocks/>
          </p:cNvCxnSpPr>
          <p:nvPr/>
        </p:nvCxnSpPr>
        <p:spPr>
          <a:xfrm flipV="1">
            <a:off x="5872943" y="6193374"/>
            <a:ext cx="635766" cy="8877"/>
          </a:xfrm>
          <a:prstGeom prst="straightConnector1">
            <a:avLst/>
          </a:prstGeom>
          <a:ln w="57150">
            <a:solidFill>
              <a:schemeClr val="bg2">
                <a:lumMod val="50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Gerade Verbindung mit Pfeil 36">
            <a:extLst>
              <a:ext uri="{FF2B5EF4-FFF2-40B4-BE49-F238E27FC236}">
                <a16:creationId xmlns:a16="http://schemas.microsoft.com/office/drawing/2014/main" id="{872674DF-5D7C-4DAE-88BD-2960E6249384}"/>
              </a:ext>
            </a:extLst>
          </p:cNvPr>
          <p:cNvCxnSpPr>
            <a:cxnSpLocks/>
          </p:cNvCxnSpPr>
          <p:nvPr/>
        </p:nvCxnSpPr>
        <p:spPr>
          <a:xfrm>
            <a:off x="9603078" y="6064456"/>
            <a:ext cx="474176" cy="383480"/>
          </a:xfrm>
          <a:prstGeom prst="straightConnector1">
            <a:avLst/>
          </a:prstGeom>
          <a:ln w="57150">
            <a:solidFill>
              <a:schemeClr val="bg2">
                <a:lumMod val="50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8" name="Textfeld 37">
            <a:extLst>
              <a:ext uri="{FF2B5EF4-FFF2-40B4-BE49-F238E27FC236}">
                <a16:creationId xmlns:a16="http://schemas.microsoft.com/office/drawing/2014/main" id="{94C7D4F5-2844-470F-B6C2-A74A76AD88AB}"/>
              </a:ext>
            </a:extLst>
          </p:cNvPr>
          <p:cNvSpPr txBox="1"/>
          <p:nvPr/>
        </p:nvSpPr>
        <p:spPr>
          <a:xfrm>
            <a:off x="541516" y="4965889"/>
            <a:ext cx="3634558" cy="830997"/>
          </a:xfrm>
          <a:prstGeom prst="rect">
            <a:avLst/>
          </a:prstGeom>
          <a:solidFill>
            <a:schemeClr val="tx1">
              <a:lumMod val="50000"/>
              <a:lumOff val="50000"/>
            </a:schemeClr>
          </a:solidFill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endParaRPr lang="de-DE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r>
              <a:rPr lang="de-DE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formation spreading rapidly</a:t>
            </a:r>
          </a:p>
          <a:p>
            <a:pPr algn="ctr"/>
            <a:endParaRPr lang="de-DE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9" name="Textfeld 38">
            <a:extLst>
              <a:ext uri="{FF2B5EF4-FFF2-40B4-BE49-F238E27FC236}">
                <a16:creationId xmlns:a16="http://schemas.microsoft.com/office/drawing/2014/main" id="{BB5881B2-76C6-4C6C-B8C8-91BA6CF81590}"/>
              </a:ext>
            </a:extLst>
          </p:cNvPr>
          <p:cNvSpPr txBox="1"/>
          <p:nvPr/>
        </p:nvSpPr>
        <p:spPr>
          <a:xfrm>
            <a:off x="541517" y="4442156"/>
            <a:ext cx="3634558" cy="369332"/>
          </a:xfrm>
          <a:prstGeom prst="rect">
            <a:avLst/>
          </a:prstGeom>
          <a:solidFill>
            <a:schemeClr val="tx1">
              <a:lumMod val="50000"/>
              <a:lumOff val="50000"/>
            </a:schemeClr>
          </a:solidFill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de-DE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creasing</a:t>
            </a:r>
          </a:p>
        </p:txBody>
      </p:sp>
      <p:cxnSp>
        <p:nvCxnSpPr>
          <p:cNvPr id="40" name="Gerader Verbinder 39">
            <a:extLst>
              <a:ext uri="{FF2B5EF4-FFF2-40B4-BE49-F238E27FC236}">
                <a16:creationId xmlns:a16="http://schemas.microsoft.com/office/drawing/2014/main" id="{0A27E83F-8A48-46D7-8136-7F9DFEF94906}"/>
              </a:ext>
            </a:extLst>
          </p:cNvPr>
          <p:cNvCxnSpPr>
            <a:cxnSpLocks/>
          </p:cNvCxnSpPr>
          <p:nvPr/>
        </p:nvCxnSpPr>
        <p:spPr>
          <a:xfrm>
            <a:off x="9599651" y="5979003"/>
            <a:ext cx="0" cy="556182"/>
          </a:xfrm>
          <a:prstGeom prst="line">
            <a:avLst/>
          </a:prstGeom>
          <a:ln w="57150">
            <a:solidFill>
              <a:schemeClr val="tx1">
                <a:lumMod val="75000"/>
                <a:lumOff val="2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" name="Gerader Verbinder 40">
            <a:extLst>
              <a:ext uri="{FF2B5EF4-FFF2-40B4-BE49-F238E27FC236}">
                <a16:creationId xmlns:a16="http://schemas.microsoft.com/office/drawing/2014/main" id="{51C386FF-42CE-4150-943D-6F2CFDBBEE2C}"/>
              </a:ext>
            </a:extLst>
          </p:cNvPr>
          <p:cNvCxnSpPr>
            <a:cxnSpLocks/>
          </p:cNvCxnSpPr>
          <p:nvPr/>
        </p:nvCxnSpPr>
        <p:spPr>
          <a:xfrm>
            <a:off x="5883920" y="5973206"/>
            <a:ext cx="0" cy="556182"/>
          </a:xfrm>
          <a:prstGeom prst="line">
            <a:avLst/>
          </a:prstGeom>
          <a:ln w="57150">
            <a:solidFill>
              <a:schemeClr val="tx1">
                <a:lumMod val="75000"/>
                <a:lumOff val="2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" name="Gerader Verbinder 41">
            <a:extLst>
              <a:ext uri="{FF2B5EF4-FFF2-40B4-BE49-F238E27FC236}">
                <a16:creationId xmlns:a16="http://schemas.microsoft.com/office/drawing/2014/main" id="{CAAFB946-6BD8-4ACB-B01B-788E226964A3}"/>
              </a:ext>
            </a:extLst>
          </p:cNvPr>
          <p:cNvCxnSpPr>
            <a:cxnSpLocks/>
          </p:cNvCxnSpPr>
          <p:nvPr/>
        </p:nvCxnSpPr>
        <p:spPr>
          <a:xfrm>
            <a:off x="2106568" y="5973206"/>
            <a:ext cx="0" cy="556182"/>
          </a:xfrm>
          <a:prstGeom prst="line">
            <a:avLst/>
          </a:prstGeom>
          <a:ln w="57150">
            <a:solidFill>
              <a:schemeClr val="tx1">
                <a:lumMod val="75000"/>
                <a:lumOff val="2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" name="Gerader Verbinder 42">
            <a:extLst>
              <a:ext uri="{FF2B5EF4-FFF2-40B4-BE49-F238E27FC236}">
                <a16:creationId xmlns:a16="http://schemas.microsoft.com/office/drawing/2014/main" id="{A5C673A8-C736-4ED0-8430-CC896D4B684F}"/>
              </a:ext>
            </a:extLst>
          </p:cNvPr>
          <p:cNvCxnSpPr>
            <a:cxnSpLocks/>
          </p:cNvCxnSpPr>
          <p:nvPr/>
        </p:nvCxnSpPr>
        <p:spPr>
          <a:xfrm flipH="1">
            <a:off x="2108665" y="6501832"/>
            <a:ext cx="622692" cy="0"/>
          </a:xfrm>
          <a:prstGeom prst="line">
            <a:avLst/>
          </a:prstGeom>
          <a:ln w="57150">
            <a:solidFill>
              <a:schemeClr val="tx1">
                <a:lumMod val="75000"/>
                <a:lumOff val="2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9" name="Rechteck 48">
            <a:extLst>
              <a:ext uri="{FF2B5EF4-FFF2-40B4-BE49-F238E27FC236}">
                <a16:creationId xmlns:a16="http://schemas.microsoft.com/office/drawing/2014/main" id="{0C7B23AA-6461-416E-BA5D-B4572E358C34}"/>
              </a:ext>
            </a:extLst>
          </p:cNvPr>
          <p:cNvSpPr/>
          <p:nvPr/>
        </p:nvSpPr>
        <p:spPr>
          <a:xfrm>
            <a:off x="2127511" y="2933801"/>
            <a:ext cx="857839" cy="792877"/>
          </a:xfrm>
          <a:prstGeom prst="rect">
            <a:avLst/>
          </a:prstGeom>
          <a:solidFill>
            <a:srgbClr val="FC9688"/>
          </a:solidFill>
          <a:ln w="12700">
            <a:solidFill>
              <a:schemeClr val="tx1">
                <a:lumMod val="75000"/>
                <a:lumOff val="25000"/>
              </a:schemeClr>
            </a:solidFill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50" name="Gerader Verbinder 49">
            <a:extLst>
              <a:ext uri="{FF2B5EF4-FFF2-40B4-BE49-F238E27FC236}">
                <a16:creationId xmlns:a16="http://schemas.microsoft.com/office/drawing/2014/main" id="{400B4B1A-92AA-403D-9273-D3745777F0D6}"/>
              </a:ext>
            </a:extLst>
          </p:cNvPr>
          <p:cNvCxnSpPr>
            <a:cxnSpLocks/>
          </p:cNvCxnSpPr>
          <p:nvPr/>
        </p:nvCxnSpPr>
        <p:spPr>
          <a:xfrm>
            <a:off x="2263863" y="3065099"/>
            <a:ext cx="0" cy="556182"/>
          </a:xfrm>
          <a:prstGeom prst="line">
            <a:avLst/>
          </a:prstGeom>
          <a:ln w="57150">
            <a:solidFill>
              <a:schemeClr val="tx1">
                <a:lumMod val="75000"/>
                <a:lumOff val="2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1" name="Gerader Verbinder 50">
            <a:extLst>
              <a:ext uri="{FF2B5EF4-FFF2-40B4-BE49-F238E27FC236}">
                <a16:creationId xmlns:a16="http://schemas.microsoft.com/office/drawing/2014/main" id="{B7BE32D5-BF90-4B11-B712-3ECCBC9A256F}"/>
              </a:ext>
            </a:extLst>
          </p:cNvPr>
          <p:cNvCxnSpPr>
            <a:cxnSpLocks/>
          </p:cNvCxnSpPr>
          <p:nvPr/>
        </p:nvCxnSpPr>
        <p:spPr>
          <a:xfrm flipH="1">
            <a:off x="2265960" y="3593725"/>
            <a:ext cx="622692" cy="0"/>
          </a:xfrm>
          <a:prstGeom prst="line">
            <a:avLst/>
          </a:prstGeom>
          <a:ln w="57150">
            <a:solidFill>
              <a:schemeClr val="tx1">
                <a:lumMod val="75000"/>
                <a:lumOff val="2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2" name="Gerader Verbinder 51">
            <a:extLst>
              <a:ext uri="{FF2B5EF4-FFF2-40B4-BE49-F238E27FC236}">
                <a16:creationId xmlns:a16="http://schemas.microsoft.com/office/drawing/2014/main" id="{D559A01B-579D-4522-A32C-408E122E5ED1}"/>
              </a:ext>
            </a:extLst>
          </p:cNvPr>
          <p:cNvCxnSpPr>
            <a:cxnSpLocks/>
          </p:cNvCxnSpPr>
          <p:nvPr/>
        </p:nvCxnSpPr>
        <p:spPr>
          <a:xfrm>
            <a:off x="5100123" y="3032100"/>
            <a:ext cx="0" cy="556182"/>
          </a:xfrm>
          <a:prstGeom prst="line">
            <a:avLst/>
          </a:prstGeom>
          <a:ln w="57150">
            <a:solidFill>
              <a:schemeClr val="tx1">
                <a:lumMod val="75000"/>
                <a:lumOff val="2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434197091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Diagramm 1">
            <a:extLst>
              <a:ext uri="{FF2B5EF4-FFF2-40B4-BE49-F238E27FC236}">
                <a16:creationId xmlns:a16="http://schemas.microsoft.com/office/drawing/2014/main" id="{D3F59B03-9F49-4BA1-854A-8BA8E6792467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3914189314"/>
              </p:ext>
            </p:extLst>
          </p:nvPr>
        </p:nvGraphicFramePr>
        <p:xfrm>
          <a:off x="241538" y="224286"/>
          <a:ext cx="11763107" cy="6210070"/>
        </p:xfrm>
        <a:graphic>
          <a:graphicData uri="http://schemas.openxmlformats.org/drawingml/2006/diagram">
            <dgm:relIds xmlns:dgm="http://schemas.openxmlformats.org/drawingml/2006/diagram" xmlns:r="http://schemas.openxmlformats.org/officeDocument/2006/relationships" r:dm="rId3" r:lo="rId4" r:qs="rId5" r:cs="rId6"/>
          </a:graphicData>
        </a:graphic>
      </p:graphicFrame>
    </p:spTree>
    <p:extLst>
      <p:ext uri="{BB962C8B-B14F-4D97-AF65-F5344CB8AC3E}">
        <p14:creationId xmlns:p14="http://schemas.microsoft.com/office/powerpoint/2010/main" val="89750109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Kantoorthema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014</TotalTime>
  <Words>697</Words>
  <Application>Microsoft Macintosh PowerPoint</Application>
  <PresentationFormat>Breedbeeld</PresentationFormat>
  <Paragraphs>172</Paragraphs>
  <Slides>6</Slides>
  <Notes>6</Notes>
  <HiddenSlides>0</HiddenSlides>
  <MMClips>0</MMClips>
  <ScaleCrop>false</ScaleCrop>
  <HeadingPairs>
    <vt:vector size="6" baseType="variant">
      <vt:variant>
        <vt:lpstr>Gebruikte lettertypen</vt:lpstr>
      </vt:variant>
      <vt:variant>
        <vt:i4>5</vt:i4>
      </vt:variant>
      <vt:variant>
        <vt:lpstr>Thema</vt:lpstr>
      </vt:variant>
      <vt:variant>
        <vt:i4>1</vt:i4>
      </vt:variant>
      <vt:variant>
        <vt:lpstr>Diatitels</vt:lpstr>
      </vt:variant>
      <vt:variant>
        <vt:i4>6</vt:i4>
      </vt:variant>
    </vt:vector>
  </HeadingPairs>
  <TitlesOfParts>
    <vt:vector size="12" baseType="lpstr">
      <vt:lpstr>Arial</vt:lpstr>
      <vt:lpstr>Calibri</vt:lpstr>
      <vt:lpstr>Calibri Light</vt:lpstr>
      <vt:lpstr>Times</vt:lpstr>
      <vt:lpstr>Times New Roman</vt:lpstr>
      <vt:lpstr>Office</vt:lpstr>
      <vt:lpstr>Boender et al. JMIR Infodemiology 2023;3:e43646  Multimedia Appendix 4  Editable versions of Figure 1, Figure 2, Figure 3 and Multimedia Appendix 2 </vt:lpstr>
      <vt:lpstr>PowerPoint-presentatie</vt:lpstr>
      <vt:lpstr>PowerPoint-presentatie</vt:lpstr>
      <vt:lpstr>PowerPoint-presentatie</vt:lpstr>
      <vt:lpstr>PowerPoint-presentatie</vt:lpstr>
      <vt:lpstr>PowerPoint-presentatie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Schneider, Paula</dc:creator>
  <cp:lastModifiedBy>Sonia Boender</cp:lastModifiedBy>
  <cp:revision>14</cp:revision>
  <dcterms:created xsi:type="dcterms:W3CDTF">2022-10-25T09:36:36Z</dcterms:created>
  <dcterms:modified xsi:type="dcterms:W3CDTF">2023-05-27T19:18:20Z</dcterms:modified>
</cp:coreProperties>
</file>